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5" r:id="rId3"/>
    <p:sldId id="276" r:id="rId4"/>
    <p:sldId id="274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239" autoAdjust="0"/>
  </p:normalViewPr>
  <p:slideViewPr>
    <p:cSldViewPr>
      <p:cViewPr varScale="1">
        <p:scale>
          <a:sx n="90" d="100"/>
          <a:sy n="90" d="100"/>
        </p:scale>
        <p:origin x="108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09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270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883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082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712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79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694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855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178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37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26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FA3CE-D4E6-4810-B37C-0D2649D27E02}" type="datetimeFigureOut">
              <a:rPr lang="en-US" smtClean="0"/>
              <a:pPr/>
              <a:t>1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ED998-D809-48B3-911E-ABCE52CC0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139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81000" y="990600"/>
            <a:ext cx="2560320" cy="3657600"/>
            <a:chOff x="457201" y="394293"/>
            <a:chExt cx="1828800" cy="2651760"/>
          </a:xfrm>
        </p:grpSpPr>
        <p:grpSp>
          <p:nvGrpSpPr>
            <p:cNvPr id="2" name="Group 1"/>
            <p:cNvGrpSpPr/>
            <p:nvPr/>
          </p:nvGrpSpPr>
          <p:grpSpPr>
            <a:xfrm>
              <a:off x="457201" y="394293"/>
              <a:ext cx="1828800" cy="2651760"/>
              <a:chOff x="457200" y="1155822"/>
              <a:chExt cx="3210373" cy="4601217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7200" y="1155822"/>
                <a:ext cx="3210373" cy="4601217"/>
              </a:xfrm>
              <a:prstGeom prst="rect">
                <a:avLst/>
              </a:prstGeom>
            </p:spPr>
          </p:pic>
          <p:sp>
            <p:nvSpPr>
              <p:cNvPr id="4" name="Freeform 3"/>
              <p:cNvSpPr/>
              <p:nvPr/>
            </p:nvSpPr>
            <p:spPr>
              <a:xfrm>
                <a:off x="1457325" y="4014788"/>
                <a:ext cx="1304925" cy="266700"/>
              </a:xfrm>
              <a:custGeom>
                <a:avLst/>
                <a:gdLst>
                  <a:gd name="connsiteX0" fmla="*/ 0 w 1304925"/>
                  <a:gd name="connsiteY0" fmla="*/ 0 h 266700"/>
                  <a:gd name="connsiteX1" fmla="*/ 28575 w 1304925"/>
                  <a:gd name="connsiteY1" fmla="*/ 4762 h 266700"/>
                  <a:gd name="connsiteX2" fmla="*/ 57150 w 1304925"/>
                  <a:gd name="connsiteY2" fmla="*/ 23812 h 266700"/>
                  <a:gd name="connsiteX3" fmla="*/ 66675 w 1304925"/>
                  <a:gd name="connsiteY3" fmla="*/ 38100 h 266700"/>
                  <a:gd name="connsiteX4" fmla="*/ 161925 w 1304925"/>
                  <a:gd name="connsiteY4" fmla="*/ 52387 h 266700"/>
                  <a:gd name="connsiteX5" fmla="*/ 185738 w 1304925"/>
                  <a:gd name="connsiteY5" fmla="*/ 57150 h 266700"/>
                  <a:gd name="connsiteX6" fmla="*/ 247650 w 1304925"/>
                  <a:gd name="connsiteY6" fmla="*/ 61912 h 266700"/>
                  <a:gd name="connsiteX7" fmla="*/ 276225 w 1304925"/>
                  <a:gd name="connsiteY7" fmla="*/ 71437 h 266700"/>
                  <a:gd name="connsiteX8" fmla="*/ 285750 w 1304925"/>
                  <a:gd name="connsiteY8" fmla="*/ 85725 h 266700"/>
                  <a:gd name="connsiteX9" fmla="*/ 314325 w 1304925"/>
                  <a:gd name="connsiteY9" fmla="*/ 95250 h 266700"/>
                  <a:gd name="connsiteX10" fmla="*/ 328613 w 1304925"/>
                  <a:gd name="connsiteY10" fmla="*/ 109537 h 266700"/>
                  <a:gd name="connsiteX11" fmla="*/ 357188 w 1304925"/>
                  <a:gd name="connsiteY11" fmla="*/ 128587 h 266700"/>
                  <a:gd name="connsiteX12" fmla="*/ 395288 w 1304925"/>
                  <a:gd name="connsiteY12" fmla="*/ 161925 h 266700"/>
                  <a:gd name="connsiteX13" fmla="*/ 423863 w 1304925"/>
                  <a:gd name="connsiteY13" fmla="*/ 190500 h 266700"/>
                  <a:gd name="connsiteX14" fmla="*/ 433388 w 1304925"/>
                  <a:gd name="connsiteY14" fmla="*/ 204787 h 266700"/>
                  <a:gd name="connsiteX15" fmla="*/ 447675 w 1304925"/>
                  <a:gd name="connsiteY15" fmla="*/ 209550 h 266700"/>
                  <a:gd name="connsiteX16" fmla="*/ 476250 w 1304925"/>
                  <a:gd name="connsiteY16" fmla="*/ 228600 h 266700"/>
                  <a:gd name="connsiteX17" fmla="*/ 514350 w 1304925"/>
                  <a:gd name="connsiteY17" fmla="*/ 238125 h 266700"/>
                  <a:gd name="connsiteX18" fmla="*/ 552450 w 1304925"/>
                  <a:gd name="connsiteY18" fmla="*/ 247650 h 266700"/>
                  <a:gd name="connsiteX19" fmla="*/ 566738 w 1304925"/>
                  <a:gd name="connsiteY19" fmla="*/ 252412 h 266700"/>
                  <a:gd name="connsiteX20" fmla="*/ 619125 w 1304925"/>
                  <a:gd name="connsiteY20" fmla="*/ 266700 h 266700"/>
                  <a:gd name="connsiteX21" fmla="*/ 690563 w 1304925"/>
                  <a:gd name="connsiteY21" fmla="*/ 261937 h 266700"/>
                  <a:gd name="connsiteX22" fmla="*/ 723900 w 1304925"/>
                  <a:gd name="connsiteY22" fmla="*/ 252412 h 266700"/>
                  <a:gd name="connsiteX23" fmla="*/ 752475 w 1304925"/>
                  <a:gd name="connsiteY23" fmla="*/ 238125 h 266700"/>
                  <a:gd name="connsiteX24" fmla="*/ 795338 w 1304925"/>
                  <a:gd name="connsiteY24" fmla="*/ 209550 h 266700"/>
                  <a:gd name="connsiteX25" fmla="*/ 809625 w 1304925"/>
                  <a:gd name="connsiteY25" fmla="*/ 200025 h 266700"/>
                  <a:gd name="connsiteX26" fmla="*/ 823913 w 1304925"/>
                  <a:gd name="connsiteY26" fmla="*/ 171450 h 266700"/>
                  <a:gd name="connsiteX27" fmla="*/ 838200 w 1304925"/>
                  <a:gd name="connsiteY27" fmla="*/ 157162 h 266700"/>
                  <a:gd name="connsiteX28" fmla="*/ 862013 w 1304925"/>
                  <a:gd name="connsiteY28" fmla="*/ 133350 h 266700"/>
                  <a:gd name="connsiteX29" fmla="*/ 871538 w 1304925"/>
                  <a:gd name="connsiteY29" fmla="*/ 119062 h 266700"/>
                  <a:gd name="connsiteX30" fmla="*/ 923925 w 1304925"/>
                  <a:gd name="connsiteY30" fmla="*/ 95250 h 266700"/>
                  <a:gd name="connsiteX31" fmla="*/ 938213 w 1304925"/>
                  <a:gd name="connsiteY31" fmla="*/ 90487 h 266700"/>
                  <a:gd name="connsiteX32" fmla="*/ 957263 w 1304925"/>
                  <a:gd name="connsiteY32" fmla="*/ 85725 h 266700"/>
                  <a:gd name="connsiteX33" fmla="*/ 981075 w 1304925"/>
                  <a:gd name="connsiteY33" fmla="*/ 80962 h 266700"/>
                  <a:gd name="connsiteX34" fmla="*/ 1009650 w 1304925"/>
                  <a:gd name="connsiteY34" fmla="*/ 71437 h 266700"/>
                  <a:gd name="connsiteX35" fmla="*/ 1023938 w 1304925"/>
                  <a:gd name="connsiteY35" fmla="*/ 66675 h 266700"/>
                  <a:gd name="connsiteX36" fmla="*/ 1038225 w 1304925"/>
                  <a:gd name="connsiteY36" fmla="*/ 61912 h 266700"/>
                  <a:gd name="connsiteX37" fmla="*/ 1062038 w 1304925"/>
                  <a:gd name="connsiteY37" fmla="*/ 57150 h 266700"/>
                  <a:gd name="connsiteX38" fmla="*/ 1147763 w 1304925"/>
                  <a:gd name="connsiteY38" fmla="*/ 47625 h 266700"/>
                  <a:gd name="connsiteX39" fmla="*/ 1162050 w 1304925"/>
                  <a:gd name="connsiteY39" fmla="*/ 42862 h 266700"/>
                  <a:gd name="connsiteX40" fmla="*/ 1190625 w 1304925"/>
                  <a:gd name="connsiteY40" fmla="*/ 38100 h 266700"/>
                  <a:gd name="connsiteX41" fmla="*/ 1214438 w 1304925"/>
                  <a:gd name="connsiteY41" fmla="*/ 33337 h 266700"/>
                  <a:gd name="connsiteX42" fmla="*/ 1262063 w 1304925"/>
                  <a:gd name="connsiteY42" fmla="*/ 19050 h 266700"/>
                  <a:gd name="connsiteX43" fmla="*/ 1290638 w 1304925"/>
                  <a:gd name="connsiteY43" fmla="*/ 9525 h 266700"/>
                  <a:gd name="connsiteX44" fmla="*/ 1304925 w 1304925"/>
                  <a:gd name="connsiteY44" fmla="*/ 4762 h 266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</a:cxnLst>
                <a:rect l="l" t="t" r="r" b="b"/>
                <a:pathLst>
                  <a:path w="1304925" h="266700">
                    <a:moveTo>
                      <a:pt x="0" y="0"/>
                    </a:moveTo>
                    <a:cubicBezTo>
                      <a:pt x="9525" y="1587"/>
                      <a:pt x="19661" y="1048"/>
                      <a:pt x="28575" y="4762"/>
                    </a:cubicBezTo>
                    <a:cubicBezTo>
                      <a:pt x="39142" y="9165"/>
                      <a:pt x="57150" y="23812"/>
                      <a:pt x="57150" y="23812"/>
                    </a:cubicBezTo>
                    <a:cubicBezTo>
                      <a:pt x="60325" y="28575"/>
                      <a:pt x="61821" y="35066"/>
                      <a:pt x="66675" y="38100"/>
                    </a:cubicBezTo>
                    <a:cubicBezTo>
                      <a:pt x="90195" y="52800"/>
                      <a:pt x="143364" y="51061"/>
                      <a:pt x="161925" y="52387"/>
                    </a:cubicBezTo>
                    <a:cubicBezTo>
                      <a:pt x="169863" y="53975"/>
                      <a:pt x="177693" y="56256"/>
                      <a:pt x="185738" y="57150"/>
                    </a:cubicBezTo>
                    <a:cubicBezTo>
                      <a:pt x="206310" y="59436"/>
                      <a:pt x="227205" y="58684"/>
                      <a:pt x="247650" y="61912"/>
                    </a:cubicBezTo>
                    <a:cubicBezTo>
                      <a:pt x="257567" y="63478"/>
                      <a:pt x="276225" y="71437"/>
                      <a:pt x="276225" y="71437"/>
                    </a:cubicBezTo>
                    <a:cubicBezTo>
                      <a:pt x="279400" y="76200"/>
                      <a:pt x="280896" y="82691"/>
                      <a:pt x="285750" y="85725"/>
                    </a:cubicBezTo>
                    <a:cubicBezTo>
                      <a:pt x="294264" y="91046"/>
                      <a:pt x="314325" y="95250"/>
                      <a:pt x="314325" y="95250"/>
                    </a:cubicBezTo>
                    <a:cubicBezTo>
                      <a:pt x="319088" y="100012"/>
                      <a:pt x="323297" y="105402"/>
                      <a:pt x="328613" y="109537"/>
                    </a:cubicBezTo>
                    <a:cubicBezTo>
                      <a:pt x="337649" y="116565"/>
                      <a:pt x="357188" y="128587"/>
                      <a:pt x="357188" y="128587"/>
                    </a:cubicBezTo>
                    <a:cubicBezTo>
                      <a:pt x="384174" y="169068"/>
                      <a:pt x="339728" y="106365"/>
                      <a:pt x="395288" y="161925"/>
                    </a:cubicBezTo>
                    <a:cubicBezTo>
                      <a:pt x="404813" y="171450"/>
                      <a:pt x="416391" y="179292"/>
                      <a:pt x="423863" y="190500"/>
                    </a:cubicBezTo>
                    <a:cubicBezTo>
                      <a:pt x="427038" y="195262"/>
                      <a:pt x="428919" y="201211"/>
                      <a:pt x="433388" y="204787"/>
                    </a:cubicBezTo>
                    <a:cubicBezTo>
                      <a:pt x="437308" y="207923"/>
                      <a:pt x="443287" y="207112"/>
                      <a:pt x="447675" y="209550"/>
                    </a:cubicBezTo>
                    <a:cubicBezTo>
                      <a:pt x="457682" y="215110"/>
                      <a:pt x="465390" y="224980"/>
                      <a:pt x="476250" y="228600"/>
                    </a:cubicBezTo>
                    <a:cubicBezTo>
                      <a:pt x="503564" y="237703"/>
                      <a:pt x="476994" y="229504"/>
                      <a:pt x="514350" y="238125"/>
                    </a:cubicBezTo>
                    <a:cubicBezTo>
                      <a:pt x="527106" y="241069"/>
                      <a:pt x="540031" y="243511"/>
                      <a:pt x="552450" y="247650"/>
                    </a:cubicBezTo>
                    <a:cubicBezTo>
                      <a:pt x="557213" y="249237"/>
                      <a:pt x="561895" y="251091"/>
                      <a:pt x="566738" y="252412"/>
                    </a:cubicBezTo>
                    <a:cubicBezTo>
                      <a:pt x="625798" y="268518"/>
                      <a:pt x="586249" y="255740"/>
                      <a:pt x="619125" y="266700"/>
                    </a:cubicBezTo>
                    <a:cubicBezTo>
                      <a:pt x="642938" y="265112"/>
                      <a:pt x="666829" y="264435"/>
                      <a:pt x="690563" y="261937"/>
                    </a:cubicBezTo>
                    <a:cubicBezTo>
                      <a:pt x="694433" y="261530"/>
                      <a:pt x="718781" y="254972"/>
                      <a:pt x="723900" y="252412"/>
                    </a:cubicBezTo>
                    <a:cubicBezTo>
                      <a:pt x="760821" y="233951"/>
                      <a:pt x="716572" y="250092"/>
                      <a:pt x="752475" y="238125"/>
                    </a:cubicBezTo>
                    <a:lnTo>
                      <a:pt x="795338" y="209550"/>
                    </a:lnTo>
                    <a:lnTo>
                      <a:pt x="809625" y="200025"/>
                    </a:lnTo>
                    <a:cubicBezTo>
                      <a:pt x="814399" y="185705"/>
                      <a:pt x="813655" y="183760"/>
                      <a:pt x="823913" y="171450"/>
                    </a:cubicBezTo>
                    <a:cubicBezTo>
                      <a:pt x="828225" y="166276"/>
                      <a:pt x="833888" y="162336"/>
                      <a:pt x="838200" y="157162"/>
                    </a:cubicBezTo>
                    <a:cubicBezTo>
                      <a:pt x="858041" y="133352"/>
                      <a:pt x="835821" y="150811"/>
                      <a:pt x="862013" y="133350"/>
                    </a:cubicBezTo>
                    <a:cubicBezTo>
                      <a:pt x="865188" y="128587"/>
                      <a:pt x="867230" y="122831"/>
                      <a:pt x="871538" y="119062"/>
                    </a:cubicBezTo>
                    <a:cubicBezTo>
                      <a:pt x="899043" y="94995"/>
                      <a:pt x="894407" y="102630"/>
                      <a:pt x="923925" y="95250"/>
                    </a:cubicBezTo>
                    <a:cubicBezTo>
                      <a:pt x="928795" y="94032"/>
                      <a:pt x="933386" y="91866"/>
                      <a:pt x="938213" y="90487"/>
                    </a:cubicBezTo>
                    <a:cubicBezTo>
                      <a:pt x="944507" y="88689"/>
                      <a:pt x="950873" y="87145"/>
                      <a:pt x="957263" y="85725"/>
                    </a:cubicBezTo>
                    <a:cubicBezTo>
                      <a:pt x="965165" y="83969"/>
                      <a:pt x="973266" y="83092"/>
                      <a:pt x="981075" y="80962"/>
                    </a:cubicBezTo>
                    <a:cubicBezTo>
                      <a:pt x="990761" y="78320"/>
                      <a:pt x="1000125" y="74612"/>
                      <a:pt x="1009650" y="71437"/>
                    </a:cubicBezTo>
                    <a:lnTo>
                      <a:pt x="1023938" y="66675"/>
                    </a:lnTo>
                    <a:cubicBezTo>
                      <a:pt x="1028700" y="65088"/>
                      <a:pt x="1033302" y="62896"/>
                      <a:pt x="1038225" y="61912"/>
                    </a:cubicBezTo>
                    <a:cubicBezTo>
                      <a:pt x="1046163" y="60325"/>
                      <a:pt x="1054011" y="58197"/>
                      <a:pt x="1062038" y="57150"/>
                    </a:cubicBezTo>
                    <a:cubicBezTo>
                      <a:pt x="1090547" y="53432"/>
                      <a:pt x="1147763" y="47625"/>
                      <a:pt x="1147763" y="47625"/>
                    </a:cubicBezTo>
                    <a:cubicBezTo>
                      <a:pt x="1152525" y="46037"/>
                      <a:pt x="1157150" y="43951"/>
                      <a:pt x="1162050" y="42862"/>
                    </a:cubicBezTo>
                    <a:cubicBezTo>
                      <a:pt x="1171476" y="40767"/>
                      <a:pt x="1181124" y="39827"/>
                      <a:pt x="1190625" y="38100"/>
                    </a:cubicBezTo>
                    <a:cubicBezTo>
                      <a:pt x="1198589" y="36652"/>
                      <a:pt x="1206536" y="35093"/>
                      <a:pt x="1214438" y="33337"/>
                    </a:cubicBezTo>
                    <a:cubicBezTo>
                      <a:pt x="1236035" y="28538"/>
                      <a:pt x="1238313" y="26967"/>
                      <a:pt x="1262063" y="19050"/>
                    </a:cubicBezTo>
                    <a:lnTo>
                      <a:pt x="1290638" y="9525"/>
                    </a:lnTo>
                    <a:lnTo>
                      <a:pt x="1304925" y="4762"/>
                    </a:ln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1352550" y="1028700"/>
              <a:ext cx="33338" cy="1347788"/>
              <a:chOff x="1352550" y="1028700"/>
              <a:chExt cx="33338" cy="1347788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1352550" y="1028700"/>
                <a:ext cx="33338" cy="1347788"/>
                <a:chOff x="1352550" y="1028700"/>
                <a:chExt cx="33338" cy="1347788"/>
              </a:xfrm>
            </p:grpSpPr>
            <p:sp>
              <p:nvSpPr>
                <p:cNvPr id="12" name="Freeform 11"/>
                <p:cNvSpPr/>
                <p:nvPr/>
              </p:nvSpPr>
              <p:spPr>
                <a:xfrm>
                  <a:off x="1352550" y="1028700"/>
                  <a:ext cx="33338" cy="1133475"/>
                </a:xfrm>
                <a:custGeom>
                  <a:avLst/>
                  <a:gdLst>
                    <a:gd name="connsiteX0" fmla="*/ 23813 w 33338"/>
                    <a:gd name="connsiteY0" fmla="*/ 0 h 1133475"/>
                    <a:gd name="connsiteX1" fmla="*/ 28575 w 33338"/>
                    <a:gd name="connsiteY1" fmla="*/ 71438 h 1133475"/>
                    <a:gd name="connsiteX2" fmla="*/ 33338 w 33338"/>
                    <a:gd name="connsiteY2" fmla="*/ 85725 h 1133475"/>
                    <a:gd name="connsiteX3" fmla="*/ 23813 w 33338"/>
                    <a:gd name="connsiteY3" fmla="*/ 152400 h 1133475"/>
                    <a:gd name="connsiteX4" fmla="*/ 28575 w 33338"/>
                    <a:gd name="connsiteY4" fmla="*/ 338138 h 1133475"/>
                    <a:gd name="connsiteX5" fmla="*/ 19050 w 33338"/>
                    <a:gd name="connsiteY5" fmla="*/ 409575 h 1133475"/>
                    <a:gd name="connsiteX6" fmla="*/ 14288 w 33338"/>
                    <a:gd name="connsiteY6" fmla="*/ 423863 h 1133475"/>
                    <a:gd name="connsiteX7" fmla="*/ 9525 w 33338"/>
                    <a:gd name="connsiteY7" fmla="*/ 471488 h 1133475"/>
                    <a:gd name="connsiteX8" fmla="*/ 4763 w 33338"/>
                    <a:gd name="connsiteY8" fmla="*/ 490538 h 1133475"/>
                    <a:gd name="connsiteX9" fmla="*/ 14288 w 33338"/>
                    <a:gd name="connsiteY9" fmla="*/ 566738 h 1133475"/>
                    <a:gd name="connsiteX10" fmla="*/ 9525 w 33338"/>
                    <a:gd name="connsiteY10" fmla="*/ 757238 h 1133475"/>
                    <a:gd name="connsiteX11" fmla="*/ 4763 w 33338"/>
                    <a:gd name="connsiteY11" fmla="*/ 771525 h 1133475"/>
                    <a:gd name="connsiteX12" fmla="*/ 0 w 33338"/>
                    <a:gd name="connsiteY12" fmla="*/ 838200 h 1133475"/>
                    <a:gd name="connsiteX13" fmla="*/ 4763 w 33338"/>
                    <a:gd name="connsiteY13" fmla="*/ 1009650 h 1133475"/>
                    <a:gd name="connsiteX14" fmla="*/ 9525 w 33338"/>
                    <a:gd name="connsiteY14" fmla="*/ 1023938 h 1133475"/>
                    <a:gd name="connsiteX15" fmla="*/ 4763 w 33338"/>
                    <a:gd name="connsiteY15" fmla="*/ 1104900 h 1133475"/>
                    <a:gd name="connsiteX16" fmla="*/ 4763 w 33338"/>
                    <a:gd name="connsiteY16" fmla="*/ 1133475 h 11334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33338" h="1133475">
                      <a:moveTo>
                        <a:pt x="23813" y="0"/>
                      </a:moveTo>
                      <a:cubicBezTo>
                        <a:pt x="25400" y="23813"/>
                        <a:pt x="25939" y="47718"/>
                        <a:pt x="28575" y="71438"/>
                      </a:cubicBezTo>
                      <a:cubicBezTo>
                        <a:pt x="29129" y="76427"/>
                        <a:pt x="33338" y="80705"/>
                        <a:pt x="33338" y="85725"/>
                      </a:cubicBezTo>
                      <a:cubicBezTo>
                        <a:pt x="33338" y="127459"/>
                        <a:pt x="32626" y="125959"/>
                        <a:pt x="23813" y="152400"/>
                      </a:cubicBezTo>
                      <a:cubicBezTo>
                        <a:pt x="25400" y="214313"/>
                        <a:pt x="28575" y="276205"/>
                        <a:pt x="28575" y="338138"/>
                      </a:cubicBezTo>
                      <a:cubicBezTo>
                        <a:pt x="28575" y="356002"/>
                        <a:pt x="24118" y="389305"/>
                        <a:pt x="19050" y="409575"/>
                      </a:cubicBezTo>
                      <a:cubicBezTo>
                        <a:pt x="17832" y="414445"/>
                        <a:pt x="15875" y="419100"/>
                        <a:pt x="14288" y="423863"/>
                      </a:cubicBezTo>
                      <a:cubicBezTo>
                        <a:pt x="12700" y="439738"/>
                        <a:pt x="11781" y="455694"/>
                        <a:pt x="9525" y="471488"/>
                      </a:cubicBezTo>
                      <a:cubicBezTo>
                        <a:pt x="8599" y="477968"/>
                        <a:pt x="4763" y="483993"/>
                        <a:pt x="4763" y="490538"/>
                      </a:cubicBezTo>
                      <a:cubicBezTo>
                        <a:pt x="4763" y="532991"/>
                        <a:pt x="6705" y="536409"/>
                        <a:pt x="14288" y="566738"/>
                      </a:cubicBezTo>
                      <a:cubicBezTo>
                        <a:pt x="12700" y="630238"/>
                        <a:pt x="12476" y="693787"/>
                        <a:pt x="9525" y="757238"/>
                      </a:cubicBezTo>
                      <a:cubicBezTo>
                        <a:pt x="9292" y="762252"/>
                        <a:pt x="5350" y="766539"/>
                        <a:pt x="4763" y="771525"/>
                      </a:cubicBezTo>
                      <a:cubicBezTo>
                        <a:pt x="2160" y="793654"/>
                        <a:pt x="1588" y="815975"/>
                        <a:pt x="0" y="838200"/>
                      </a:cubicBezTo>
                      <a:cubicBezTo>
                        <a:pt x="1588" y="895350"/>
                        <a:pt x="1835" y="952553"/>
                        <a:pt x="4763" y="1009650"/>
                      </a:cubicBezTo>
                      <a:cubicBezTo>
                        <a:pt x="5020" y="1014664"/>
                        <a:pt x="9525" y="1018918"/>
                        <a:pt x="9525" y="1023938"/>
                      </a:cubicBezTo>
                      <a:cubicBezTo>
                        <a:pt x="9525" y="1050972"/>
                        <a:pt x="5937" y="1077892"/>
                        <a:pt x="4763" y="1104900"/>
                      </a:cubicBezTo>
                      <a:cubicBezTo>
                        <a:pt x="4349" y="1114416"/>
                        <a:pt x="4763" y="1123950"/>
                        <a:pt x="4763" y="1133475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Freeform 12"/>
                <p:cNvSpPr/>
                <p:nvPr/>
              </p:nvSpPr>
              <p:spPr>
                <a:xfrm>
                  <a:off x="1362075" y="2214563"/>
                  <a:ext cx="4763" cy="161925"/>
                </a:xfrm>
                <a:custGeom>
                  <a:avLst/>
                  <a:gdLst>
                    <a:gd name="connsiteX0" fmla="*/ 0 w 4763"/>
                    <a:gd name="connsiteY0" fmla="*/ 0 h 161925"/>
                    <a:gd name="connsiteX1" fmla="*/ 4763 w 4763"/>
                    <a:gd name="connsiteY1" fmla="*/ 161925 h 1619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763" h="161925">
                      <a:moveTo>
                        <a:pt x="0" y="0"/>
                      </a:moveTo>
                      <a:lnTo>
                        <a:pt x="4763" y="161925"/>
                      </a:lnTo>
                    </a:path>
                  </a:pathLst>
                </a:custGeom>
                <a:noFill/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1" name="Freeform 10"/>
              <p:cNvSpPr/>
              <p:nvPr/>
            </p:nvSpPr>
            <p:spPr>
              <a:xfrm>
                <a:off x="1357313" y="2147888"/>
                <a:ext cx="14287" cy="85725"/>
              </a:xfrm>
              <a:custGeom>
                <a:avLst/>
                <a:gdLst>
                  <a:gd name="connsiteX0" fmla="*/ 0 w 14287"/>
                  <a:gd name="connsiteY0" fmla="*/ 0 h 85725"/>
                  <a:gd name="connsiteX1" fmla="*/ 4762 w 14287"/>
                  <a:gd name="connsiteY1" fmla="*/ 33337 h 85725"/>
                  <a:gd name="connsiteX2" fmla="*/ 14287 w 14287"/>
                  <a:gd name="connsiteY2" fmla="*/ 61912 h 85725"/>
                  <a:gd name="connsiteX3" fmla="*/ 4762 w 14287"/>
                  <a:gd name="connsiteY3" fmla="*/ 85725 h 857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4287" h="85725">
                    <a:moveTo>
                      <a:pt x="0" y="0"/>
                    </a:moveTo>
                    <a:cubicBezTo>
                      <a:pt x="1587" y="11112"/>
                      <a:pt x="2238" y="22399"/>
                      <a:pt x="4762" y="33337"/>
                    </a:cubicBezTo>
                    <a:cubicBezTo>
                      <a:pt x="7020" y="43120"/>
                      <a:pt x="14287" y="61912"/>
                      <a:pt x="14287" y="61912"/>
                    </a:cubicBezTo>
                    <a:cubicBezTo>
                      <a:pt x="8403" y="79568"/>
                      <a:pt x="11770" y="71710"/>
                      <a:pt x="4762" y="85725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8" name="Group 27"/>
          <p:cNvGrpSpPr/>
          <p:nvPr/>
        </p:nvGrpSpPr>
        <p:grpSpPr>
          <a:xfrm>
            <a:off x="3124200" y="990600"/>
            <a:ext cx="2560320" cy="3657600"/>
            <a:chOff x="2590800" y="394292"/>
            <a:chExt cx="1828800" cy="265176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90800" y="394292"/>
              <a:ext cx="1828800" cy="2651760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3486150" y="890588"/>
              <a:ext cx="52388" cy="1524000"/>
              <a:chOff x="3486150" y="890588"/>
              <a:chExt cx="52388" cy="1524000"/>
            </a:xfrm>
          </p:grpSpPr>
          <p:sp>
            <p:nvSpPr>
              <p:cNvPr id="7" name="Freeform 6"/>
              <p:cNvSpPr/>
              <p:nvPr/>
            </p:nvSpPr>
            <p:spPr>
              <a:xfrm>
                <a:off x="3490343" y="890588"/>
                <a:ext cx="48195" cy="1190625"/>
              </a:xfrm>
              <a:custGeom>
                <a:avLst/>
                <a:gdLst>
                  <a:gd name="connsiteX0" fmla="*/ 48195 w 48195"/>
                  <a:gd name="connsiteY0" fmla="*/ 0 h 1190625"/>
                  <a:gd name="connsiteX1" fmla="*/ 38670 w 48195"/>
                  <a:gd name="connsiteY1" fmla="*/ 23812 h 1190625"/>
                  <a:gd name="connsiteX2" fmla="*/ 29145 w 48195"/>
                  <a:gd name="connsiteY2" fmla="*/ 247650 h 1190625"/>
                  <a:gd name="connsiteX3" fmla="*/ 33907 w 48195"/>
                  <a:gd name="connsiteY3" fmla="*/ 323850 h 1190625"/>
                  <a:gd name="connsiteX4" fmla="*/ 38670 w 48195"/>
                  <a:gd name="connsiteY4" fmla="*/ 342900 h 1190625"/>
                  <a:gd name="connsiteX5" fmla="*/ 33907 w 48195"/>
                  <a:gd name="connsiteY5" fmla="*/ 414337 h 1190625"/>
                  <a:gd name="connsiteX6" fmla="*/ 19620 w 48195"/>
                  <a:gd name="connsiteY6" fmla="*/ 461962 h 1190625"/>
                  <a:gd name="connsiteX7" fmla="*/ 14857 w 48195"/>
                  <a:gd name="connsiteY7" fmla="*/ 476250 h 1190625"/>
                  <a:gd name="connsiteX8" fmla="*/ 10095 w 48195"/>
                  <a:gd name="connsiteY8" fmla="*/ 733425 h 1190625"/>
                  <a:gd name="connsiteX9" fmla="*/ 5332 w 48195"/>
                  <a:gd name="connsiteY9" fmla="*/ 747712 h 1190625"/>
                  <a:gd name="connsiteX10" fmla="*/ 14857 w 48195"/>
                  <a:gd name="connsiteY10" fmla="*/ 828675 h 1190625"/>
                  <a:gd name="connsiteX11" fmla="*/ 10095 w 48195"/>
                  <a:gd name="connsiteY11" fmla="*/ 938212 h 1190625"/>
                  <a:gd name="connsiteX12" fmla="*/ 570 w 48195"/>
                  <a:gd name="connsiteY12" fmla="*/ 966787 h 1190625"/>
                  <a:gd name="connsiteX13" fmla="*/ 5332 w 48195"/>
                  <a:gd name="connsiteY13" fmla="*/ 1014412 h 1190625"/>
                  <a:gd name="connsiteX14" fmla="*/ 10095 w 48195"/>
                  <a:gd name="connsiteY14" fmla="*/ 1028700 h 1190625"/>
                  <a:gd name="connsiteX15" fmla="*/ 5332 w 48195"/>
                  <a:gd name="connsiteY15" fmla="*/ 1090612 h 1190625"/>
                  <a:gd name="connsiteX16" fmla="*/ 570 w 48195"/>
                  <a:gd name="connsiteY16" fmla="*/ 1109662 h 1190625"/>
                  <a:gd name="connsiteX17" fmla="*/ 570 w 48195"/>
                  <a:gd name="connsiteY17" fmla="*/ 1190625 h 11906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8195" h="1190625">
                    <a:moveTo>
                      <a:pt x="48195" y="0"/>
                    </a:moveTo>
                    <a:cubicBezTo>
                      <a:pt x="45020" y="7937"/>
                      <a:pt x="39215" y="15281"/>
                      <a:pt x="38670" y="23812"/>
                    </a:cubicBezTo>
                    <a:cubicBezTo>
                      <a:pt x="21480" y="293107"/>
                      <a:pt x="48470" y="151013"/>
                      <a:pt x="29145" y="247650"/>
                    </a:cubicBezTo>
                    <a:cubicBezTo>
                      <a:pt x="30732" y="273050"/>
                      <a:pt x="31375" y="298527"/>
                      <a:pt x="33907" y="323850"/>
                    </a:cubicBezTo>
                    <a:cubicBezTo>
                      <a:pt x="34558" y="330363"/>
                      <a:pt x="38670" y="336355"/>
                      <a:pt x="38670" y="342900"/>
                    </a:cubicBezTo>
                    <a:cubicBezTo>
                      <a:pt x="38670" y="366765"/>
                      <a:pt x="36405" y="390603"/>
                      <a:pt x="33907" y="414337"/>
                    </a:cubicBezTo>
                    <a:cubicBezTo>
                      <a:pt x="32799" y="424860"/>
                      <a:pt x="21874" y="455199"/>
                      <a:pt x="19620" y="461962"/>
                    </a:cubicBezTo>
                    <a:lnTo>
                      <a:pt x="14857" y="476250"/>
                    </a:lnTo>
                    <a:cubicBezTo>
                      <a:pt x="13270" y="561975"/>
                      <a:pt x="13102" y="647738"/>
                      <a:pt x="10095" y="733425"/>
                    </a:cubicBezTo>
                    <a:cubicBezTo>
                      <a:pt x="9919" y="738442"/>
                      <a:pt x="5332" y="742692"/>
                      <a:pt x="5332" y="747712"/>
                    </a:cubicBezTo>
                    <a:cubicBezTo>
                      <a:pt x="5332" y="775889"/>
                      <a:pt x="10317" y="801433"/>
                      <a:pt x="14857" y="828675"/>
                    </a:cubicBezTo>
                    <a:cubicBezTo>
                      <a:pt x="13270" y="865187"/>
                      <a:pt x="13856" y="901859"/>
                      <a:pt x="10095" y="938212"/>
                    </a:cubicBezTo>
                    <a:cubicBezTo>
                      <a:pt x="9062" y="948199"/>
                      <a:pt x="570" y="966787"/>
                      <a:pt x="570" y="966787"/>
                    </a:cubicBezTo>
                    <a:cubicBezTo>
                      <a:pt x="2157" y="982662"/>
                      <a:pt x="2906" y="998643"/>
                      <a:pt x="5332" y="1014412"/>
                    </a:cubicBezTo>
                    <a:cubicBezTo>
                      <a:pt x="6095" y="1019374"/>
                      <a:pt x="10095" y="1023680"/>
                      <a:pt x="10095" y="1028700"/>
                    </a:cubicBezTo>
                    <a:cubicBezTo>
                      <a:pt x="10095" y="1049398"/>
                      <a:pt x="7750" y="1070055"/>
                      <a:pt x="5332" y="1090612"/>
                    </a:cubicBezTo>
                    <a:cubicBezTo>
                      <a:pt x="4567" y="1097113"/>
                      <a:pt x="881" y="1103124"/>
                      <a:pt x="570" y="1109662"/>
                    </a:cubicBezTo>
                    <a:cubicBezTo>
                      <a:pt x="-714" y="1136619"/>
                      <a:pt x="570" y="1163637"/>
                      <a:pt x="570" y="1190625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Freeform 7"/>
              <p:cNvSpPr/>
              <p:nvPr/>
            </p:nvSpPr>
            <p:spPr>
              <a:xfrm>
                <a:off x="3486150" y="2076450"/>
                <a:ext cx="9525" cy="338138"/>
              </a:xfrm>
              <a:custGeom>
                <a:avLst/>
                <a:gdLst>
                  <a:gd name="connsiteX0" fmla="*/ 9525 w 9525"/>
                  <a:gd name="connsiteY0" fmla="*/ 0 h 338138"/>
                  <a:gd name="connsiteX1" fmla="*/ 4763 w 9525"/>
                  <a:gd name="connsiteY1" fmla="*/ 238125 h 338138"/>
                  <a:gd name="connsiteX2" fmla="*/ 0 w 9525"/>
                  <a:gd name="connsiteY2" fmla="*/ 252413 h 338138"/>
                  <a:gd name="connsiteX3" fmla="*/ 4763 w 9525"/>
                  <a:gd name="connsiteY3" fmla="*/ 323850 h 338138"/>
                  <a:gd name="connsiteX4" fmla="*/ 9525 w 9525"/>
                  <a:gd name="connsiteY4" fmla="*/ 338138 h 3381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525" h="338138">
                    <a:moveTo>
                      <a:pt x="9525" y="0"/>
                    </a:moveTo>
                    <a:cubicBezTo>
                      <a:pt x="7938" y="79375"/>
                      <a:pt x="7757" y="158791"/>
                      <a:pt x="4763" y="238125"/>
                    </a:cubicBezTo>
                    <a:cubicBezTo>
                      <a:pt x="4574" y="243142"/>
                      <a:pt x="0" y="247393"/>
                      <a:pt x="0" y="252413"/>
                    </a:cubicBezTo>
                    <a:cubicBezTo>
                      <a:pt x="0" y="276278"/>
                      <a:pt x="2128" y="300131"/>
                      <a:pt x="4763" y="323850"/>
                    </a:cubicBezTo>
                    <a:cubicBezTo>
                      <a:pt x="5317" y="328840"/>
                      <a:pt x="9525" y="338138"/>
                      <a:pt x="9525" y="338138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2883801" y="1748278"/>
              <a:ext cx="1253094" cy="345664"/>
              <a:chOff x="2883801" y="1748278"/>
              <a:chExt cx="1253094" cy="345664"/>
            </a:xfrm>
          </p:grpSpPr>
          <p:sp>
            <p:nvSpPr>
              <p:cNvPr id="17" name="Freeform 16"/>
              <p:cNvSpPr/>
              <p:nvPr/>
            </p:nvSpPr>
            <p:spPr>
              <a:xfrm>
                <a:off x="2883801" y="1748278"/>
                <a:ext cx="423224" cy="321131"/>
              </a:xfrm>
              <a:custGeom>
                <a:avLst/>
                <a:gdLst>
                  <a:gd name="connsiteX0" fmla="*/ 0 w 742950"/>
                  <a:gd name="connsiteY0" fmla="*/ 0 h 557213"/>
                  <a:gd name="connsiteX1" fmla="*/ 19050 w 742950"/>
                  <a:gd name="connsiteY1" fmla="*/ 23813 h 557213"/>
                  <a:gd name="connsiteX2" fmla="*/ 28575 w 742950"/>
                  <a:gd name="connsiteY2" fmla="*/ 38100 h 557213"/>
                  <a:gd name="connsiteX3" fmla="*/ 57150 w 742950"/>
                  <a:gd name="connsiteY3" fmla="*/ 57150 h 557213"/>
                  <a:gd name="connsiteX4" fmla="*/ 80963 w 742950"/>
                  <a:gd name="connsiteY4" fmla="*/ 76200 h 557213"/>
                  <a:gd name="connsiteX5" fmla="*/ 109538 w 742950"/>
                  <a:gd name="connsiteY5" fmla="*/ 95250 h 557213"/>
                  <a:gd name="connsiteX6" fmla="*/ 123825 w 742950"/>
                  <a:gd name="connsiteY6" fmla="*/ 104775 h 557213"/>
                  <a:gd name="connsiteX7" fmla="*/ 152400 w 742950"/>
                  <a:gd name="connsiteY7" fmla="*/ 114300 h 557213"/>
                  <a:gd name="connsiteX8" fmla="*/ 166688 w 742950"/>
                  <a:gd name="connsiteY8" fmla="*/ 123825 h 557213"/>
                  <a:gd name="connsiteX9" fmla="*/ 180975 w 742950"/>
                  <a:gd name="connsiteY9" fmla="*/ 128588 h 557213"/>
                  <a:gd name="connsiteX10" fmla="*/ 209550 w 742950"/>
                  <a:gd name="connsiteY10" fmla="*/ 147638 h 557213"/>
                  <a:gd name="connsiteX11" fmla="*/ 223838 w 742950"/>
                  <a:gd name="connsiteY11" fmla="*/ 157163 h 557213"/>
                  <a:gd name="connsiteX12" fmla="*/ 238125 w 742950"/>
                  <a:gd name="connsiteY12" fmla="*/ 161925 h 557213"/>
                  <a:gd name="connsiteX13" fmla="*/ 266700 w 742950"/>
                  <a:gd name="connsiteY13" fmla="*/ 180975 h 557213"/>
                  <a:gd name="connsiteX14" fmla="*/ 280988 w 742950"/>
                  <a:gd name="connsiteY14" fmla="*/ 190500 h 557213"/>
                  <a:gd name="connsiteX15" fmla="*/ 295275 w 742950"/>
                  <a:gd name="connsiteY15" fmla="*/ 195263 h 557213"/>
                  <a:gd name="connsiteX16" fmla="*/ 323850 w 742950"/>
                  <a:gd name="connsiteY16" fmla="*/ 214313 h 557213"/>
                  <a:gd name="connsiteX17" fmla="*/ 290513 w 742950"/>
                  <a:gd name="connsiteY17" fmla="*/ 219075 h 557213"/>
                  <a:gd name="connsiteX18" fmla="*/ 266700 w 742950"/>
                  <a:gd name="connsiteY18" fmla="*/ 261938 h 557213"/>
                  <a:gd name="connsiteX19" fmla="*/ 257175 w 742950"/>
                  <a:gd name="connsiteY19" fmla="*/ 276225 h 557213"/>
                  <a:gd name="connsiteX20" fmla="*/ 247650 w 742950"/>
                  <a:gd name="connsiteY20" fmla="*/ 309563 h 557213"/>
                  <a:gd name="connsiteX21" fmla="*/ 238125 w 742950"/>
                  <a:gd name="connsiteY21" fmla="*/ 347663 h 557213"/>
                  <a:gd name="connsiteX22" fmla="*/ 242888 w 742950"/>
                  <a:gd name="connsiteY22" fmla="*/ 433388 h 557213"/>
                  <a:gd name="connsiteX23" fmla="*/ 247650 w 742950"/>
                  <a:gd name="connsiteY23" fmla="*/ 447675 h 557213"/>
                  <a:gd name="connsiteX24" fmla="*/ 261938 w 742950"/>
                  <a:gd name="connsiteY24" fmla="*/ 457200 h 557213"/>
                  <a:gd name="connsiteX25" fmla="*/ 290513 w 742950"/>
                  <a:gd name="connsiteY25" fmla="*/ 466725 h 557213"/>
                  <a:gd name="connsiteX26" fmla="*/ 319088 w 742950"/>
                  <a:gd name="connsiteY26" fmla="*/ 481013 h 557213"/>
                  <a:gd name="connsiteX27" fmla="*/ 347663 w 742950"/>
                  <a:gd name="connsiteY27" fmla="*/ 495300 h 557213"/>
                  <a:gd name="connsiteX28" fmla="*/ 428625 w 742950"/>
                  <a:gd name="connsiteY28" fmla="*/ 490538 h 557213"/>
                  <a:gd name="connsiteX29" fmla="*/ 457200 w 742950"/>
                  <a:gd name="connsiteY29" fmla="*/ 481013 h 557213"/>
                  <a:gd name="connsiteX30" fmla="*/ 495300 w 742950"/>
                  <a:gd name="connsiteY30" fmla="*/ 457200 h 557213"/>
                  <a:gd name="connsiteX31" fmla="*/ 509588 w 742950"/>
                  <a:gd name="connsiteY31" fmla="*/ 452438 h 557213"/>
                  <a:gd name="connsiteX32" fmla="*/ 533400 w 742950"/>
                  <a:gd name="connsiteY32" fmla="*/ 457200 h 557213"/>
                  <a:gd name="connsiteX33" fmla="*/ 542925 w 742950"/>
                  <a:gd name="connsiteY33" fmla="*/ 471488 h 557213"/>
                  <a:gd name="connsiteX34" fmla="*/ 571500 w 742950"/>
                  <a:gd name="connsiteY34" fmla="*/ 481013 h 557213"/>
                  <a:gd name="connsiteX35" fmla="*/ 600075 w 742950"/>
                  <a:gd name="connsiteY35" fmla="*/ 495300 h 557213"/>
                  <a:gd name="connsiteX36" fmla="*/ 614363 w 742950"/>
                  <a:gd name="connsiteY36" fmla="*/ 504825 h 557213"/>
                  <a:gd name="connsiteX37" fmla="*/ 642938 w 742950"/>
                  <a:gd name="connsiteY37" fmla="*/ 514350 h 557213"/>
                  <a:gd name="connsiteX38" fmla="*/ 657225 w 742950"/>
                  <a:gd name="connsiteY38" fmla="*/ 519113 h 557213"/>
                  <a:gd name="connsiteX39" fmla="*/ 685800 w 742950"/>
                  <a:gd name="connsiteY39" fmla="*/ 528638 h 557213"/>
                  <a:gd name="connsiteX40" fmla="*/ 700088 w 742950"/>
                  <a:gd name="connsiteY40" fmla="*/ 538163 h 557213"/>
                  <a:gd name="connsiteX41" fmla="*/ 728663 w 742950"/>
                  <a:gd name="connsiteY41" fmla="*/ 547688 h 557213"/>
                  <a:gd name="connsiteX42" fmla="*/ 742950 w 742950"/>
                  <a:gd name="connsiteY42" fmla="*/ 557213 h 5572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</a:cxnLst>
                <a:rect l="l" t="t" r="r" b="b"/>
                <a:pathLst>
                  <a:path w="742950" h="557213">
                    <a:moveTo>
                      <a:pt x="0" y="0"/>
                    </a:moveTo>
                    <a:cubicBezTo>
                      <a:pt x="6350" y="7938"/>
                      <a:pt x="12951" y="15681"/>
                      <a:pt x="19050" y="23813"/>
                    </a:cubicBezTo>
                    <a:cubicBezTo>
                      <a:pt x="22484" y="28392"/>
                      <a:pt x="24267" y="34331"/>
                      <a:pt x="28575" y="38100"/>
                    </a:cubicBezTo>
                    <a:cubicBezTo>
                      <a:pt x="37190" y="45638"/>
                      <a:pt x="57150" y="57150"/>
                      <a:pt x="57150" y="57150"/>
                    </a:cubicBezTo>
                    <a:cubicBezTo>
                      <a:pt x="74750" y="83551"/>
                      <a:pt x="56605" y="62668"/>
                      <a:pt x="80963" y="76200"/>
                    </a:cubicBezTo>
                    <a:cubicBezTo>
                      <a:pt x="90970" y="81759"/>
                      <a:pt x="100013" y="88900"/>
                      <a:pt x="109538" y="95250"/>
                    </a:cubicBezTo>
                    <a:cubicBezTo>
                      <a:pt x="114300" y="98425"/>
                      <a:pt x="118395" y="102965"/>
                      <a:pt x="123825" y="104775"/>
                    </a:cubicBezTo>
                    <a:lnTo>
                      <a:pt x="152400" y="114300"/>
                    </a:lnTo>
                    <a:cubicBezTo>
                      <a:pt x="157163" y="117475"/>
                      <a:pt x="161568" y="121265"/>
                      <a:pt x="166688" y="123825"/>
                    </a:cubicBezTo>
                    <a:cubicBezTo>
                      <a:pt x="171178" y="126070"/>
                      <a:pt x="176587" y="126150"/>
                      <a:pt x="180975" y="128588"/>
                    </a:cubicBezTo>
                    <a:cubicBezTo>
                      <a:pt x="190982" y="134148"/>
                      <a:pt x="200025" y="141288"/>
                      <a:pt x="209550" y="147638"/>
                    </a:cubicBezTo>
                    <a:cubicBezTo>
                      <a:pt x="214313" y="150813"/>
                      <a:pt x="218408" y="155353"/>
                      <a:pt x="223838" y="157163"/>
                    </a:cubicBezTo>
                    <a:lnTo>
                      <a:pt x="238125" y="161925"/>
                    </a:lnTo>
                    <a:lnTo>
                      <a:pt x="266700" y="180975"/>
                    </a:lnTo>
                    <a:cubicBezTo>
                      <a:pt x="271463" y="184150"/>
                      <a:pt x="275558" y="188690"/>
                      <a:pt x="280988" y="190500"/>
                    </a:cubicBezTo>
                    <a:cubicBezTo>
                      <a:pt x="285750" y="192088"/>
                      <a:pt x="290887" y="192825"/>
                      <a:pt x="295275" y="195263"/>
                    </a:cubicBezTo>
                    <a:cubicBezTo>
                      <a:pt x="305282" y="200823"/>
                      <a:pt x="323850" y="214313"/>
                      <a:pt x="323850" y="214313"/>
                    </a:cubicBezTo>
                    <a:cubicBezTo>
                      <a:pt x="312738" y="215900"/>
                      <a:pt x="299983" y="213049"/>
                      <a:pt x="290513" y="219075"/>
                    </a:cubicBezTo>
                    <a:cubicBezTo>
                      <a:pt x="268491" y="233089"/>
                      <a:pt x="275166" y="245007"/>
                      <a:pt x="266700" y="261938"/>
                    </a:cubicBezTo>
                    <a:cubicBezTo>
                      <a:pt x="264140" y="267057"/>
                      <a:pt x="260350" y="271463"/>
                      <a:pt x="257175" y="276225"/>
                    </a:cubicBezTo>
                    <a:cubicBezTo>
                      <a:pt x="251874" y="292130"/>
                      <a:pt x="251635" y="291631"/>
                      <a:pt x="247650" y="309563"/>
                    </a:cubicBezTo>
                    <a:cubicBezTo>
                      <a:pt x="239986" y="344049"/>
                      <a:pt x="246637" y="322129"/>
                      <a:pt x="238125" y="347663"/>
                    </a:cubicBezTo>
                    <a:cubicBezTo>
                      <a:pt x="239713" y="376238"/>
                      <a:pt x="240175" y="404898"/>
                      <a:pt x="242888" y="433388"/>
                    </a:cubicBezTo>
                    <a:cubicBezTo>
                      <a:pt x="243364" y="438385"/>
                      <a:pt x="244514" y="443755"/>
                      <a:pt x="247650" y="447675"/>
                    </a:cubicBezTo>
                    <a:cubicBezTo>
                      <a:pt x="251226" y="452145"/>
                      <a:pt x="256707" y="454875"/>
                      <a:pt x="261938" y="457200"/>
                    </a:cubicBezTo>
                    <a:cubicBezTo>
                      <a:pt x="271113" y="461278"/>
                      <a:pt x="290513" y="466725"/>
                      <a:pt x="290513" y="466725"/>
                    </a:cubicBezTo>
                    <a:cubicBezTo>
                      <a:pt x="331456" y="494021"/>
                      <a:pt x="279654" y="461295"/>
                      <a:pt x="319088" y="481013"/>
                    </a:cubicBezTo>
                    <a:cubicBezTo>
                      <a:pt x="356010" y="499474"/>
                      <a:pt x="311756" y="483333"/>
                      <a:pt x="347663" y="495300"/>
                    </a:cubicBezTo>
                    <a:cubicBezTo>
                      <a:pt x="374650" y="493713"/>
                      <a:pt x="401818" y="494034"/>
                      <a:pt x="428625" y="490538"/>
                    </a:cubicBezTo>
                    <a:cubicBezTo>
                      <a:pt x="438581" y="489239"/>
                      <a:pt x="457200" y="481013"/>
                      <a:pt x="457200" y="481013"/>
                    </a:cubicBezTo>
                    <a:cubicBezTo>
                      <a:pt x="472294" y="458371"/>
                      <a:pt x="461295" y="468534"/>
                      <a:pt x="495300" y="457200"/>
                    </a:cubicBezTo>
                    <a:lnTo>
                      <a:pt x="509588" y="452438"/>
                    </a:lnTo>
                    <a:cubicBezTo>
                      <a:pt x="517525" y="454025"/>
                      <a:pt x="526372" y="453184"/>
                      <a:pt x="533400" y="457200"/>
                    </a:cubicBezTo>
                    <a:cubicBezTo>
                      <a:pt x="538370" y="460040"/>
                      <a:pt x="538071" y="468454"/>
                      <a:pt x="542925" y="471488"/>
                    </a:cubicBezTo>
                    <a:cubicBezTo>
                      <a:pt x="551439" y="476809"/>
                      <a:pt x="563146" y="475444"/>
                      <a:pt x="571500" y="481013"/>
                    </a:cubicBezTo>
                    <a:cubicBezTo>
                      <a:pt x="589965" y="493322"/>
                      <a:pt x="580358" y="488728"/>
                      <a:pt x="600075" y="495300"/>
                    </a:cubicBezTo>
                    <a:cubicBezTo>
                      <a:pt x="604838" y="498475"/>
                      <a:pt x="609132" y="502500"/>
                      <a:pt x="614363" y="504825"/>
                    </a:cubicBezTo>
                    <a:cubicBezTo>
                      <a:pt x="623538" y="508903"/>
                      <a:pt x="633413" y="511175"/>
                      <a:pt x="642938" y="514350"/>
                    </a:cubicBezTo>
                    <a:lnTo>
                      <a:pt x="657225" y="519113"/>
                    </a:lnTo>
                    <a:cubicBezTo>
                      <a:pt x="657230" y="519115"/>
                      <a:pt x="685795" y="528634"/>
                      <a:pt x="685800" y="528638"/>
                    </a:cubicBezTo>
                    <a:cubicBezTo>
                      <a:pt x="690563" y="531813"/>
                      <a:pt x="694857" y="535838"/>
                      <a:pt x="700088" y="538163"/>
                    </a:cubicBezTo>
                    <a:cubicBezTo>
                      <a:pt x="709263" y="542241"/>
                      <a:pt x="720309" y="542119"/>
                      <a:pt x="728663" y="547688"/>
                    </a:cubicBezTo>
                    <a:lnTo>
                      <a:pt x="742950" y="557213"/>
                    </a:ln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Freeform 17"/>
              <p:cNvSpPr/>
              <p:nvPr/>
            </p:nvSpPr>
            <p:spPr>
              <a:xfrm>
                <a:off x="3300678" y="2063349"/>
                <a:ext cx="401112" cy="30593"/>
              </a:xfrm>
              <a:custGeom>
                <a:avLst/>
                <a:gdLst>
                  <a:gd name="connsiteX0" fmla="*/ 0 w 401112"/>
                  <a:gd name="connsiteY0" fmla="*/ 0 h 30593"/>
                  <a:gd name="connsiteX1" fmla="*/ 30593 w 401112"/>
                  <a:gd name="connsiteY1" fmla="*/ 3399 h 30593"/>
                  <a:gd name="connsiteX2" fmla="*/ 50989 w 401112"/>
                  <a:gd name="connsiteY2" fmla="*/ 10197 h 30593"/>
                  <a:gd name="connsiteX3" fmla="*/ 71384 w 401112"/>
                  <a:gd name="connsiteY3" fmla="*/ 16996 h 30593"/>
                  <a:gd name="connsiteX4" fmla="*/ 81582 w 401112"/>
                  <a:gd name="connsiteY4" fmla="*/ 20395 h 30593"/>
                  <a:gd name="connsiteX5" fmla="*/ 112176 w 401112"/>
                  <a:gd name="connsiteY5" fmla="*/ 27194 h 30593"/>
                  <a:gd name="connsiteX6" fmla="*/ 139370 w 401112"/>
                  <a:gd name="connsiteY6" fmla="*/ 30593 h 30593"/>
                  <a:gd name="connsiteX7" fmla="*/ 244747 w 401112"/>
                  <a:gd name="connsiteY7" fmla="*/ 27194 h 30593"/>
                  <a:gd name="connsiteX8" fmla="*/ 254944 w 401112"/>
                  <a:gd name="connsiteY8" fmla="*/ 23794 h 30593"/>
                  <a:gd name="connsiteX9" fmla="*/ 336526 w 401112"/>
                  <a:gd name="connsiteY9" fmla="*/ 20395 h 30593"/>
                  <a:gd name="connsiteX10" fmla="*/ 401112 w 401112"/>
                  <a:gd name="connsiteY10" fmla="*/ 13597 h 305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401112" h="30593">
                    <a:moveTo>
                      <a:pt x="0" y="0"/>
                    </a:moveTo>
                    <a:cubicBezTo>
                      <a:pt x="10198" y="1133"/>
                      <a:pt x="20532" y="1387"/>
                      <a:pt x="30593" y="3399"/>
                    </a:cubicBezTo>
                    <a:cubicBezTo>
                      <a:pt x="37620" y="4804"/>
                      <a:pt x="44190" y="7931"/>
                      <a:pt x="50989" y="10197"/>
                    </a:cubicBezTo>
                    <a:lnTo>
                      <a:pt x="71384" y="16996"/>
                    </a:lnTo>
                    <a:cubicBezTo>
                      <a:pt x="74783" y="18129"/>
                      <a:pt x="78106" y="19526"/>
                      <a:pt x="81582" y="20395"/>
                    </a:cubicBezTo>
                    <a:cubicBezTo>
                      <a:pt x="92403" y="23100"/>
                      <a:pt x="100964" y="25469"/>
                      <a:pt x="112176" y="27194"/>
                    </a:cubicBezTo>
                    <a:cubicBezTo>
                      <a:pt x="121205" y="28583"/>
                      <a:pt x="130305" y="29460"/>
                      <a:pt x="139370" y="30593"/>
                    </a:cubicBezTo>
                    <a:cubicBezTo>
                      <a:pt x="174496" y="29460"/>
                      <a:pt x="209664" y="29258"/>
                      <a:pt x="244747" y="27194"/>
                    </a:cubicBezTo>
                    <a:cubicBezTo>
                      <a:pt x="248324" y="26984"/>
                      <a:pt x="251371" y="24059"/>
                      <a:pt x="254944" y="23794"/>
                    </a:cubicBezTo>
                    <a:cubicBezTo>
                      <a:pt x="282087" y="21783"/>
                      <a:pt x="309341" y="21721"/>
                      <a:pt x="336526" y="20395"/>
                    </a:cubicBezTo>
                    <a:cubicBezTo>
                      <a:pt x="395501" y="17518"/>
                      <a:pt x="377231" y="25537"/>
                      <a:pt x="401112" y="13597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Freeform 18"/>
              <p:cNvSpPr/>
              <p:nvPr/>
            </p:nvSpPr>
            <p:spPr>
              <a:xfrm>
                <a:off x="3698391" y="1842370"/>
                <a:ext cx="438504" cy="244773"/>
              </a:xfrm>
              <a:custGeom>
                <a:avLst/>
                <a:gdLst>
                  <a:gd name="connsiteX0" fmla="*/ 0 w 438504"/>
                  <a:gd name="connsiteY0" fmla="*/ 244773 h 244773"/>
                  <a:gd name="connsiteX1" fmla="*/ 16996 w 438504"/>
                  <a:gd name="connsiteY1" fmla="*/ 237975 h 244773"/>
                  <a:gd name="connsiteX2" fmla="*/ 81582 w 438504"/>
                  <a:gd name="connsiteY2" fmla="*/ 227777 h 244773"/>
                  <a:gd name="connsiteX3" fmla="*/ 101978 w 438504"/>
                  <a:gd name="connsiteY3" fmla="*/ 220979 h 244773"/>
                  <a:gd name="connsiteX4" fmla="*/ 125773 w 438504"/>
                  <a:gd name="connsiteY4" fmla="*/ 197184 h 244773"/>
                  <a:gd name="connsiteX5" fmla="*/ 139370 w 438504"/>
                  <a:gd name="connsiteY5" fmla="*/ 176788 h 244773"/>
                  <a:gd name="connsiteX6" fmla="*/ 142769 w 438504"/>
                  <a:gd name="connsiteY6" fmla="*/ 166591 h 244773"/>
                  <a:gd name="connsiteX7" fmla="*/ 152967 w 438504"/>
                  <a:gd name="connsiteY7" fmla="*/ 163191 h 244773"/>
                  <a:gd name="connsiteX8" fmla="*/ 183560 w 438504"/>
                  <a:gd name="connsiteY8" fmla="*/ 166591 h 244773"/>
                  <a:gd name="connsiteX9" fmla="*/ 190358 w 438504"/>
                  <a:gd name="connsiteY9" fmla="*/ 176788 h 244773"/>
                  <a:gd name="connsiteX10" fmla="*/ 220952 w 438504"/>
                  <a:gd name="connsiteY10" fmla="*/ 190385 h 244773"/>
                  <a:gd name="connsiteX11" fmla="*/ 231150 w 438504"/>
                  <a:gd name="connsiteY11" fmla="*/ 193785 h 244773"/>
                  <a:gd name="connsiteX12" fmla="*/ 261743 w 438504"/>
                  <a:gd name="connsiteY12" fmla="*/ 186986 h 244773"/>
                  <a:gd name="connsiteX13" fmla="*/ 271941 w 438504"/>
                  <a:gd name="connsiteY13" fmla="*/ 166591 h 244773"/>
                  <a:gd name="connsiteX14" fmla="*/ 278739 w 438504"/>
                  <a:gd name="connsiteY14" fmla="*/ 156393 h 244773"/>
                  <a:gd name="connsiteX15" fmla="*/ 285538 w 438504"/>
                  <a:gd name="connsiteY15" fmla="*/ 129199 h 244773"/>
                  <a:gd name="connsiteX16" fmla="*/ 282138 w 438504"/>
                  <a:gd name="connsiteY16" fmla="*/ 98605 h 244773"/>
                  <a:gd name="connsiteX17" fmla="*/ 285538 w 438504"/>
                  <a:gd name="connsiteY17" fmla="*/ 57814 h 244773"/>
                  <a:gd name="connsiteX18" fmla="*/ 292336 w 438504"/>
                  <a:gd name="connsiteY18" fmla="*/ 47617 h 244773"/>
                  <a:gd name="connsiteX19" fmla="*/ 312732 w 438504"/>
                  <a:gd name="connsiteY19" fmla="*/ 44217 h 244773"/>
                  <a:gd name="connsiteX20" fmla="*/ 360321 w 438504"/>
                  <a:gd name="connsiteY20" fmla="*/ 37419 h 244773"/>
                  <a:gd name="connsiteX21" fmla="*/ 380717 w 438504"/>
                  <a:gd name="connsiteY21" fmla="*/ 30620 h 244773"/>
                  <a:gd name="connsiteX22" fmla="*/ 411310 w 438504"/>
                  <a:gd name="connsiteY22" fmla="*/ 17023 h 244773"/>
                  <a:gd name="connsiteX23" fmla="*/ 421508 w 438504"/>
                  <a:gd name="connsiteY23" fmla="*/ 13624 h 244773"/>
                  <a:gd name="connsiteX24" fmla="*/ 431706 w 438504"/>
                  <a:gd name="connsiteY24" fmla="*/ 10225 h 244773"/>
                  <a:gd name="connsiteX25" fmla="*/ 438504 w 438504"/>
                  <a:gd name="connsiteY25" fmla="*/ 27 h 2447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438504" h="244773">
                    <a:moveTo>
                      <a:pt x="0" y="244773"/>
                    </a:moveTo>
                    <a:cubicBezTo>
                      <a:pt x="5665" y="242507"/>
                      <a:pt x="11030" y="239253"/>
                      <a:pt x="16996" y="237975"/>
                    </a:cubicBezTo>
                    <a:cubicBezTo>
                      <a:pt x="51743" y="230530"/>
                      <a:pt x="45785" y="239708"/>
                      <a:pt x="81582" y="227777"/>
                    </a:cubicBezTo>
                    <a:lnTo>
                      <a:pt x="101978" y="220979"/>
                    </a:lnTo>
                    <a:cubicBezTo>
                      <a:pt x="139796" y="195766"/>
                      <a:pt x="113455" y="219356"/>
                      <a:pt x="125773" y="197184"/>
                    </a:cubicBezTo>
                    <a:cubicBezTo>
                      <a:pt x="129741" y="190041"/>
                      <a:pt x="139370" y="176788"/>
                      <a:pt x="139370" y="176788"/>
                    </a:cubicBezTo>
                    <a:cubicBezTo>
                      <a:pt x="140503" y="173389"/>
                      <a:pt x="140236" y="169124"/>
                      <a:pt x="142769" y="166591"/>
                    </a:cubicBezTo>
                    <a:cubicBezTo>
                      <a:pt x="145303" y="164057"/>
                      <a:pt x="149384" y="163191"/>
                      <a:pt x="152967" y="163191"/>
                    </a:cubicBezTo>
                    <a:cubicBezTo>
                      <a:pt x="163227" y="163191"/>
                      <a:pt x="173362" y="165458"/>
                      <a:pt x="183560" y="166591"/>
                    </a:cubicBezTo>
                    <a:cubicBezTo>
                      <a:pt x="185826" y="169990"/>
                      <a:pt x="187469" y="173899"/>
                      <a:pt x="190358" y="176788"/>
                    </a:cubicBezTo>
                    <a:cubicBezTo>
                      <a:pt x="198440" y="184870"/>
                      <a:pt x="210851" y="187018"/>
                      <a:pt x="220952" y="190385"/>
                    </a:cubicBezTo>
                    <a:lnTo>
                      <a:pt x="231150" y="193785"/>
                    </a:lnTo>
                    <a:cubicBezTo>
                      <a:pt x="231355" y="193751"/>
                      <a:pt x="257340" y="190508"/>
                      <a:pt x="261743" y="186986"/>
                    </a:cubicBezTo>
                    <a:cubicBezTo>
                      <a:pt x="269858" y="180494"/>
                      <a:pt x="267837" y="174798"/>
                      <a:pt x="271941" y="166591"/>
                    </a:cubicBezTo>
                    <a:cubicBezTo>
                      <a:pt x="273768" y="162937"/>
                      <a:pt x="276912" y="160047"/>
                      <a:pt x="278739" y="156393"/>
                    </a:cubicBezTo>
                    <a:cubicBezTo>
                      <a:pt x="282222" y="149426"/>
                      <a:pt x="284245" y="135660"/>
                      <a:pt x="285538" y="129199"/>
                    </a:cubicBezTo>
                    <a:cubicBezTo>
                      <a:pt x="284405" y="119001"/>
                      <a:pt x="282138" y="108866"/>
                      <a:pt x="282138" y="98605"/>
                    </a:cubicBezTo>
                    <a:cubicBezTo>
                      <a:pt x="282138" y="84961"/>
                      <a:pt x="282862" y="71193"/>
                      <a:pt x="285538" y="57814"/>
                    </a:cubicBezTo>
                    <a:cubicBezTo>
                      <a:pt x="286339" y="53808"/>
                      <a:pt x="288682" y="49444"/>
                      <a:pt x="292336" y="47617"/>
                    </a:cubicBezTo>
                    <a:cubicBezTo>
                      <a:pt x="298501" y="44535"/>
                      <a:pt x="305951" y="45450"/>
                      <a:pt x="312732" y="44217"/>
                    </a:cubicBezTo>
                    <a:cubicBezTo>
                      <a:pt x="346736" y="38034"/>
                      <a:pt x="311649" y="42827"/>
                      <a:pt x="360321" y="37419"/>
                    </a:cubicBezTo>
                    <a:cubicBezTo>
                      <a:pt x="367120" y="35153"/>
                      <a:pt x="374754" y="34595"/>
                      <a:pt x="380717" y="30620"/>
                    </a:cubicBezTo>
                    <a:cubicBezTo>
                      <a:pt x="396877" y="19848"/>
                      <a:pt x="387041" y="25113"/>
                      <a:pt x="411310" y="17023"/>
                    </a:cubicBezTo>
                    <a:lnTo>
                      <a:pt x="421508" y="13624"/>
                    </a:lnTo>
                    <a:lnTo>
                      <a:pt x="431706" y="10225"/>
                    </a:lnTo>
                    <a:cubicBezTo>
                      <a:pt x="435463" y="-1048"/>
                      <a:pt x="431522" y="27"/>
                      <a:pt x="438504" y="27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9" name="Group 28"/>
          <p:cNvGrpSpPr/>
          <p:nvPr/>
        </p:nvGrpSpPr>
        <p:grpSpPr>
          <a:xfrm>
            <a:off x="6202680" y="990600"/>
            <a:ext cx="2560320" cy="3657600"/>
            <a:chOff x="4761992" y="381000"/>
            <a:chExt cx="1828800" cy="2648531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1992" y="381000"/>
              <a:ext cx="1828800" cy="2648531"/>
            </a:xfrm>
            <a:prstGeom prst="rect">
              <a:avLst/>
            </a:prstGeom>
          </p:spPr>
        </p:pic>
        <p:sp>
          <p:nvSpPr>
            <p:cNvPr id="15" name="Freeform 14"/>
            <p:cNvSpPr/>
            <p:nvPr/>
          </p:nvSpPr>
          <p:spPr>
            <a:xfrm>
              <a:off x="5676900" y="1800225"/>
              <a:ext cx="9525" cy="71438"/>
            </a:xfrm>
            <a:custGeom>
              <a:avLst/>
              <a:gdLst>
                <a:gd name="connsiteX0" fmla="*/ 9525 w 9525"/>
                <a:gd name="connsiteY0" fmla="*/ 0 h 71438"/>
                <a:gd name="connsiteX1" fmla="*/ 0 w 9525"/>
                <a:gd name="connsiteY1" fmla="*/ 23813 h 71438"/>
                <a:gd name="connsiteX2" fmla="*/ 9525 w 9525"/>
                <a:gd name="connsiteY2" fmla="*/ 52388 h 71438"/>
                <a:gd name="connsiteX3" fmla="*/ 9525 w 9525"/>
                <a:gd name="connsiteY3" fmla="*/ 71438 h 714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525" h="71438">
                  <a:moveTo>
                    <a:pt x="9525" y="0"/>
                  </a:moveTo>
                  <a:cubicBezTo>
                    <a:pt x="6350" y="7938"/>
                    <a:pt x="0" y="15264"/>
                    <a:pt x="0" y="23813"/>
                  </a:cubicBezTo>
                  <a:cubicBezTo>
                    <a:pt x="0" y="33853"/>
                    <a:pt x="9525" y="42348"/>
                    <a:pt x="9525" y="52388"/>
                  </a:cubicBezTo>
                  <a:lnTo>
                    <a:pt x="9525" y="71438"/>
                  </a:lnTo>
                </a:path>
              </a:pathLst>
            </a:custGeom>
            <a:noFill/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Freeform 19"/>
            <p:cNvSpPr/>
            <p:nvPr/>
          </p:nvSpPr>
          <p:spPr>
            <a:xfrm>
              <a:off x="5643551" y="1857375"/>
              <a:ext cx="47637" cy="790575"/>
            </a:xfrm>
            <a:custGeom>
              <a:avLst/>
              <a:gdLst>
                <a:gd name="connsiteX0" fmla="*/ 42874 w 47637"/>
                <a:gd name="connsiteY0" fmla="*/ 0 h 790575"/>
                <a:gd name="connsiteX1" fmla="*/ 38112 w 47637"/>
                <a:gd name="connsiteY1" fmla="*/ 42863 h 790575"/>
                <a:gd name="connsiteX2" fmla="*/ 47637 w 47637"/>
                <a:gd name="connsiteY2" fmla="*/ 71438 h 790575"/>
                <a:gd name="connsiteX3" fmla="*/ 42874 w 47637"/>
                <a:gd name="connsiteY3" fmla="*/ 166688 h 790575"/>
                <a:gd name="connsiteX4" fmla="*/ 38112 w 47637"/>
                <a:gd name="connsiteY4" fmla="*/ 180975 h 790575"/>
                <a:gd name="connsiteX5" fmla="*/ 47637 w 47637"/>
                <a:gd name="connsiteY5" fmla="*/ 276225 h 790575"/>
                <a:gd name="connsiteX6" fmla="*/ 42874 w 47637"/>
                <a:gd name="connsiteY6" fmla="*/ 323850 h 790575"/>
                <a:gd name="connsiteX7" fmla="*/ 33349 w 47637"/>
                <a:gd name="connsiteY7" fmla="*/ 352425 h 790575"/>
                <a:gd name="connsiteX8" fmla="*/ 28587 w 47637"/>
                <a:gd name="connsiteY8" fmla="*/ 381000 h 790575"/>
                <a:gd name="connsiteX9" fmla="*/ 23824 w 47637"/>
                <a:gd name="connsiteY9" fmla="*/ 400050 h 790575"/>
                <a:gd name="connsiteX10" fmla="*/ 14299 w 47637"/>
                <a:gd name="connsiteY10" fmla="*/ 600075 h 790575"/>
                <a:gd name="connsiteX11" fmla="*/ 9537 w 47637"/>
                <a:gd name="connsiteY11" fmla="*/ 666750 h 790575"/>
                <a:gd name="connsiteX12" fmla="*/ 4774 w 47637"/>
                <a:gd name="connsiteY12" fmla="*/ 690563 h 790575"/>
                <a:gd name="connsiteX13" fmla="*/ 12 w 47637"/>
                <a:gd name="connsiteY13" fmla="*/ 790575 h 7905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47637" h="790575">
                  <a:moveTo>
                    <a:pt x="42874" y="0"/>
                  </a:moveTo>
                  <a:cubicBezTo>
                    <a:pt x="31938" y="27340"/>
                    <a:pt x="30494" y="17472"/>
                    <a:pt x="38112" y="42863"/>
                  </a:cubicBezTo>
                  <a:cubicBezTo>
                    <a:pt x="40997" y="52480"/>
                    <a:pt x="47637" y="71438"/>
                    <a:pt x="47637" y="71438"/>
                  </a:cubicBezTo>
                  <a:cubicBezTo>
                    <a:pt x="46049" y="103188"/>
                    <a:pt x="45628" y="135018"/>
                    <a:pt x="42874" y="166688"/>
                  </a:cubicBezTo>
                  <a:cubicBezTo>
                    <a:pt x="42439" y="171689"/>
                    <a:pt x="38112" y="175955"/>
                    <a:pt x="38112" y="180975"/>
                  </a:cubicBezTo>
                  <a:cubicBezTo>
                    <a:pt x="38112" y="243029"/>
                    <a:pt x="38031" y="237804"/>
                    <a:pt x="47637" y="276225"/>
                  </a:cubicBezTo>
                  <a:cubicBezTo>
                    <a:pt x="46049" y="292100"/>
                    <a:pt x="45814" y="308169"/>
                    <a:pt x="42874" y="323850"/>
                  </a:cubicBezTo>
                  <a:cubicBezTo>
                    <a:pt x="41024" y="333718"/>
                    <a:pt x="33349" y="352425"/>
                    <a:pt x="33349" y="352425"/>
                  </a:cubicBezTo>
                  <a:cubicBezTo>
                    <a:pt x="31762" y="361950"/>
                    <a:pt x="30481" y="371531"/>
                    <a:pt x="28587" y="381000"/>
                  </a:cubicBezTo>
                  <a:cubicBezTo>
                    <a:pt x="27303" y="387418"/>
                    <a:pt x="24135" y="393512"/>
                    <a:pt x="23824" y="400050"/>
                  </a:cubicBezTo>
                  <a:cubicBezTo>
                    <a:pt x="13955" y="607307"/>
                    <a:pt x="34235" y="520340"/>
                    <a:pt x="14299" y="600075"/>
                  </a:cubicBezTo>
                  <a:cubicBezTo>
                    <a:pt x="12712" y="622300"/>
                    <a:pt x="11870" y="644591"/>
                    <a:pt x="9537" y="666750"/>
                  </a:cubicBezTo>
                  <a:cubicBezTo>
                    <a:pt x="8690" y="674800"/>
                    <a:pt x="5541" y="682505"/>
                    <a:pt x="4774" y="690563"/>
                  </a:cubicBezTo>
                  <a:cubicBezTo>
                    <a:pt x="-483" y="745762"/>
                    <a:pt x="12" y="750334"/>
                    <a:pt x="12" y="790575"/>
                  </a:cubicBezTo>
                </a:path>
              </a:pathLst>
            </a:custGeom>
            <a:noFill/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Freeform 20"/>
            <p:cNvSpPr/>
            <p:nvPr/>
          </p:nvSpPr>
          <p:spPr>
            <a:xfrm>
              <a:off x="5676749" y="754635"/>
              <a:ext cx="40800" cy="492892"/>
            </a:xfrm>
            <a:custGeom>
              <a:avLst/>
              <a:gdLst>
                <a:gd name="connsiteX0" fmla="*/ 23804 w 40800"/>
                <a:gd name="connsiteY0" fmla="*/ 0 h 492892"/>
                <a:gd name="connsiteX1" fmla="*/ 23804 w 40800"/>
                <a:gd name="connsiteY1" fmla="*/ 81582 h 492892"/>
                <a:gd name="connsiteX2" fmla="*/ 27203 w 40800"/>
                <a:gd name="connsiteY2" fmla="*/ 91780 h 492892"/>
                <a:gd name="connsiteX3" fmla="*/ 30603 w 40800"/>
                <a:gd name="connsiteY3" fmla="*/ 108776 h 492892"/>
                <a:gd name="connsiteX4" fmla="*/ 34002 w 40800"/>
                <a:gd name="connsiteY4" fmla="*/ 135970 h 492892"/>
                <a:gd name="connsiteX5" fmla="*/ 40800 w 40800"/>
                <a:gd name="connsiteY5" fmla="*/ 159765 h 492892"/>
                <a:gd name="connsiteX6" fmla="*/ 37401 w 40800"/>
                <a:gd name="connsiteY6" fmla="*/ 214153 h 492892"/>
                <a:gd name="connsiteX7" fmla="*/ 34002 w 40800"/>
                <a:gd name="connsiteY7" fmla="*/ 248146 h 492892"/>
                <a:gd name="connsiteX8" fmla="*/ 30603 w 40800"/>
                <a:gd name="connsiteY8" fmla="*/ 316131 h 492892"/>
                <a:gd name="connsiteX9" fmla="*/ 27203 w 40800"/>
                <a:gd name="connsiteY9" fmla="*/ 326329 h 492892"/>
                <a:gd name="connsiteX10" fmla="*/ 13606 w 40800"/>
                <a:gd name="connsiteY10" fmla="*/ 346724 h 492892"/>
                <a:gd name="connsiteX11" fmla="*/ 10207 w 40800"/>
                <a:gd name="connsiteY11" fmla="*/ 356922 h 492892"/>
                <a:gd name="connsiteX12" fmla="*/ 3409 w 40800"/>
                <a:gd name="connsiteY12" fmla="*/ 411310 h 492892"/>
                <a:gd name="connsiteX13" fmla="*/ 6808 w 40800"/>
                <a:gd name="connsiteY13" fmla="*/ 452101 h 492892"/>
                <a:gd name="connsiteX14" fmla="*/ 3409 w 40800"/>
                <a:gd name="connsiteY14" fmla="*/ 479295 h 492892"/>
                <a:gd name="connsiteX15" fmla="*/ 9 w 40800"/>
                <a:gd name="connsiteY15" fmla="*/ 492892 h 4928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40800" h="492892">
                  <a:moveTo>
                    <a:pt x="23804" y="0"/>
                  </a:moveTo>
                  <a:cubicBezTo>
                    <a:pt x="17627" y="37065"/>
                    <a:pt x="18304" y="23827"/>
                    <a:pt x="23804" y="81582"/>
                  </a:cubicBezTo>
                  <a:cubicBezTo>
                    <a:pt x="24144" y="85149"/>
                    <a:pt x="26334" y="88304"/>
                    <a:pt x="27203" y="91780"/>
                  </a:cubicBezTo>
                  <a:cubicBezTo>
                    <a:pt x="28604" y="97385"/>
                    <a:pt x="29724" y="103066"/>
                    <a:pt x="30603" y="108776"/>
                  </a:cubicBezTo>
                  <a:cubicBezTo>
                    <a:pt x="31992" y="117805"/>
                    <a:pt x="32500" y="126959"/>
                    <a:pt x="34002" y="135970"/>
                  </a:cubicBezTo>
                  <a:cubicBezTo>
                    <a:pt x="35425" y="144506"/>
                    <a:pt x="38106" y="151683"/>
                    <a:pt x="40800" y="159765"/>
                  </a:cubicBezTo>
                  <a:cubicBezTo>
                    <a:pt x="39667" y="177894"/>
                    <a:pt x="38794" y="196042"/>
                    <a:pt x="37401" y="214153"/>
                  </a:cubicBezTo>
                  <a:cubicBezTo>
                    <a:pt x="36528" y="225507"/>
                    <a:pt x="34759" y="236784"/>
                    <a:pt x="34002" y="248146"/>
                  </a:cubicBezTo>
                  <a:cubicBezTo>
                    <a:pt x="32493" y="270786"/>
                    <a:pt x="32569" y="293526"/>
                    <a:pt x="30603" y="316131"/>
                  </a:cubicBezTo>
                  <a:cubicBezTo>
                    <a:pt x="30293" y="319701"/>
                    <a:pt x="28943" y="323197"/>
                    <a:pt x="27203" y="326329"/>
                  </a:cubicBezTo>
                  <a:cubicBezTo>
                    <a:pt x="23235" y="333471"/>
                    <a:pt x="13606" y="346724"/>
                    <a:pt x="13606" y="346724"/>
                  </a:cubicBezTo>
                  <a:cubicBezTo>
                    <a:pt x="12473" y="350123"/>
                    <a:pt x="10910" y="353408"/>
                    <a:pt x="10207" y="356922"/>
                  </a:cubicBezTo>
                  <a:cubicBezTo>
                    <a:pt x="7782" y="369047"/>
                    <a:pt x="4587" y="400705"/>
                    <a:pt x="3409" y="411310"/>
                  </a:cubicBezTo>
                  <a:cubicBezTo>
                    <a:pt x="4542" y="424907"/>
                    <a:pt x="6808" y="438457"/>
                    <a:pt x="6808" y="452101"/>
                  </a:cubicBezTo>
                  <a:cubicBezTo>
                    <a:pt x="6808" y="461236"/>
                    <a:pt x="5043" y="470307"/>
                    <a:pt x="3409" y="479295"/>
                  </a:cubicBezTo>
                  <a:cubicBezTo>
                    <a:pt x="-349" y="499965"/>
                    <a:pt x="9" y="482939"/>
                    <a:pt x="9" y="492892"/>
                  </a:cubicBezTo>
                </a:path>
              </a:pathLst>
            </a:custGeom>
            <a:noFill/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4956116" y="1641841"/>
              <a:ext cx="1441285" cy="185307"/>
              <a:chOff x="4956116" y="1641841"/>
              <a:chExt cx="1441285" cy="185307"/>
            </a:xfrm>
          </p:grpSpPr>
          <p:sp>
            <p:nvSpPr>
              <p:cNvPr id="23" name="Freeform 22"/>
              <p:cNvSpPr/>
              <p:nvPr/>
            </p:nvSpPr>
            <p:spPr>
              <a:xfrm>
                <a:off x="4956116" y="1686031"/>
                <a:ext cx="220952" cy="34627"/>
              </a:xfrm>
              <a:custGeom>
                <a:avLst/>
                <a:gdLst>
                  <a:gd name="connsiteX0" fmla="*/ 0 w 220952"/>
                  <a:gd name="connsiteY0" fmla="*/ 0 h 34627"/>
                  <a:gd name="connsiteX1" fmla="*/ 37392 w 220952"/>
                  <a:gd name="connsiteY1" fmla="*/ 3399 h 34627"/>
                  <a:gd name="connsiteX2" fmla="*/ 67985 w 220952"/>
                  <a:gd name="connsiteY2" fmla="*/ 13597 h 34627"/>
                  <a:gd name="connsiteX3" fmla="*/ 84981 w 220952"/>
                  <a:gd name="connsiteY3" fmla="*/ 16997 h 34627"/>
                  <a:gd name="connsiteX4" fmla="*/ 115575 w 220952"/>
                  <a:gd name="connsiteY4" fmla="*/ 27194 h 34627"/>
                  <a:gd name="connsiteX5" fmla="*/ 125772 w 220952"/>
                  <a:gd name="connsiteY5" fmla="*/ 30594 h 34627"/>
                  <a:gd name="connsiteX6" fmla="*/ 220952 w 220952"/>
                  <a:gd name="connsiteY6" fmla="*/ 33993 h 346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20952" h="34627">
                    <a:moveTo>
                      <a:pt x="0" y="0"/>
                    </a:moveTo>
                    <a:cubicBezTo>
                      <a:pt x="12464" y="1133"/>
                      <a:pt x="25067" y="1224"/>
                      <a:pt x="37392" y="3399"/>
                    </a:cubicBezTo>
                    <a:cubicBezTo>
                      <a:pt x="94975" y="13561"/>
                      <a:pt x="34093" y="6817"/>
                      <a:pt x="67985" y="13597"/>
                    </a:cubicBezTo>
                    <a:cubicBezTo>
                      <a:pt x="73650" y="14730"/>
                      <a:pt x="79407" y="15477"/>
                      <a:pt x="84981" y="16997"/>
                    </a:cubicBezTo>
                    <a:cubicBezTo>
                      <a:pt x="95352" y="19825"/>
                      <a:pt x="105377" y="23794"/>
                      <a:pt x="115575" y="27194"/>
                    </a:cubicBezTo>
                    <a:cubicBezTo>
                      <a:pt x="118974" y="28327"/>
                      <a:pt x="122217" y="30150"/>
                      <a:pt x="125772" y="30594"/>
                    </a:cubicBezTo>
                    <a:cubicBezTo>
                      <a:pt x="175454" y="36804"/>
                      <a:pt x="143831" y="33993"/>
                      <a:pt x="220952" y="33993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Freeform 23"/>
              <p:cNvSpPr/>
              <p:nvPr/>
            </p:nvSpPr>
            <p:spPr>
              <a:xfrm>
                <a:off x="6193445" y="1641841"/>
                <a:ext cx="203956" cy="146168"/>
              </a:xfrm>
              <a:custGeom>
                <a:avLst/>
                <a:gdLst>
                  <a:gd name="connsiteX0" fmla="*/ 0 w 203956"/>
                  <a:gd name="connsiteY0" fmla="*/ 146168 h 146168"/>
                  <a:gd name="connsiteX1" fmla="*/ 16997 w 203956"/>
                  <a:gd name="connsiteY1" fmla="*/ 142769 h 146168"/>
                  <a:gd name="connsiteX2" fmla="*/ 37392 w 203956"/>
                  <a:gd name="connsiteY2" fmla="*/ 135970 h 146168"/>
                  <a:gd name="connsiteX3" fmla="*/ 47590 w 203956"/>
                  <a:gd name="connsiteY3" fmla="*/ 132571 h 146168"/>
                  <a:gd name="connsiteX4" fmla="*/ 67985 w 203956"/>
                  <a:gd name="connsiteY4" fmla="*/ 125772 h 146168"/>
                  <a:gd name="connsiteX5" fmla="*/ 78183 w 203956"/>
                  <a:gd name="connsiteY5" fmla="*/ 118974 h 146168"/>
                  <a:gd name="connsiteX6" fmla="*/ 98579 w 203956"/>
                  <a:gd name="connsiteY6" fmla="*/ 112175 h 146168"/>
                  <a:gd name="connsiteX7" fmla="*/ 108777 w 203956"/>
                  <a:gd name="connsiteY7" fmla="*/ 108776 h 146168"/>
                  <a:gd name="connsiteX8" fmla="*/ 125773 w 203956"/>
                  <a:gd name="connsiteY8" fmla="*/ 91780 h 146168"/>
                  <a:gd name="connsiteX9" fmla="*/ 132571 w 203956"/>
                  <a:gd name="connsiteY9" fmla="*/ 81582 h 146168"/>
                  <a:gd name="connsiteX10" fmla="*/ 135971 w 203956"/>
                  <a:gd name="connsiteY10" fmla="*/ 37392 h 146168"/>
                  <a:gd name="connsiteX11" fmla="*/ 139370 w 203956"/>
                  <a:gd name="connsiteY11" fmla="*/ 27194 h 146168"/>
                  <a:gd name="connsiteX12" fmla="*/ 149568 w 203956"/>
                  <a:gd name="connsiteY12" fmla="*/ 20395 h 146168"/>
                  <a:gd name="connsiteX13" fmla="*/ 173362 w 203956"/>
                  <a:gd name="connsiteY13" fmla="*/ 13597 h 146168"/>
                  <a:gd name="connsiteX14" fmla="*/ 193758 w 203956"/>
                  <a:gd name="connsiteY14" fmla="*/ 6798 h 146168"/>
                  <a:gd name="connsiteX15" fmla="*/ 203956 w 203956"/>
                  <a:gd name="connsiteY15" fmla="*/ 0 h 1461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203956" h="146168">
                    <a:moveTo>
                      <a:pt x="0" y="146168"/>
                    </a:moveTo>
                    <a:cubicBezTo>
                      <a:pt x="5666" y="145035"/>
                      <a:pt x="11423" y="144289"/>
                      <a:pt x="16997" y="142769"/>
                    </a:cubicBezTo>
                    <a:cubicBezTo>
                      <a:pt x="23911" y="140883"/>
                      <a:pt x="30594" y="138236"/>
                      <a:pt x="37392" y="135970"/>
                    </a:cubicBezTo>
                    <a:lnTo>
                      <a:pt x="47590" y="132571"/>
                    </a:lnTo>
                    <a:cubicBezTo>
                      <a:pt x="47595" y="132569"/>
                      <a:pt x="67980" y="125776"/>
                      <a:pt x="67985" y="125772"/>
                    </a:cubicBezTo>
                    <a:cubicBezTo>
                      <a:pt x="71384" y="123506"/>
                      <a:pt x="74450" y="120633"/>
                      <a:pt x="78183" y="118974"/>
                    </a:cubicBezTo>
                    <a:cubicBezTo>
                      <a:pt x="84732" y="116063"/>
                      <a:pt x="91780" y="114441"/>
                      <a:pt x="98579" y="112175"/>
                    </a:cubicBezTo>
                    <a:lnTo>
                      <a:pt x="108777" y="108776"/>
                    </a:lnTo>
                    <a:cubicBezTo>
                      <a:pt x="126905" y="81581"/>
                      <a:pt x="103112" y="114441"/>
                      <a:pt x="125773" y="91780"/>
                    </a:cubicBezTo>
                    <a:cubicBezTo>
                      <a:pt x="128662" y="88891"/>
                      <a:pt x="130305" y="84981"/>
                      <a:pt x="132571" y="81582"/>
                    </a:cubicBezTo>
                    <a:cubicBezTo>
                      <a:pt x="133704" y="66852"/>
                      <a:pt x="134138" y="52051"/>
                      <a:pt x="135971" y="37392"/>
                    </a:cubicBezTo>
                    <a:cubicBezTo>
                      <a:pt x="136415" y="33836"/>
                      <a:pt x="137132" y="29992"/>
                      <a:pt x="139370" y="27194"/>
                    </a:cubicBezTo>
                    <a:cubicBezTo>
                      <a:pt x="141922" y="24004"/>
                      <a:pt x="145914" y="22222"/>
                      <a:pt x="149568" y="20395"/>
                    </a:cubicBezTo>
                    <a:cubicBezTo>
                      <a:pt x="155280" y="17539"/>
                      <a:pt x="167916" y="15231"/>
                      <a:pt x="173362" y="13597"/>
                    </a:cubicBezTo>
                    <a:cubicBezTo>
                      <a:pt x="180226" y="11538"/>
                      <a:pt x="187795" y="10773"/>
                      <a:pt x="193758" y="6798"/>
                    </a:cubicBezTo>
                    <a:lnTo>
                      <a:pt x="203956" y="0"/>
                    </a:ln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Freeform 24"/>
              <p:cNvSpPr/>
              <p:nvPr/>
            </p:nvSpPr>
            <p:spPr>
              <a:xfrm>
                <a:off x="5160071" y="1723423"/>
                <a:ext cx="1057169" cy="103725"/>
              </a:xfrm>
              <a:custGeom>
                <a:avLst/>
                <a:gdLst>
                  <a:gd name="connsiteX0" fmla="*/ 0 w 1057169"/>
                  <a:gd name="connsiteY0" fmla="*/ 0 h 103725"/>
                  <a:gd name="connsiteX1" fmla="*/ 258344 w 1057169"/>
                  <a:gd name="connsiteY1" fmla="*/ 3399 h 103725"/>
                  <a:gd name="connsiteX2" fmla="*/ 282139 w 1057169"/>
                  <a:gd name="connsiteY2" fmla="*/ 6799 h 103725"/>
                  <a:gd name="connsiteX3" fmla="*/ 309333 w 1057169"/>
                  <a:gd name="connsiteY3" fmla="*/ 13597 h 103725"/>
                  <a:gd name="connsiteX4" fmla="*/ 339926 w 1057169"/>
                  <a:gd name="connsiteY4" fmla="*/ 30593 h 103725"/>
                  <a:gd name="connsiteX5" fmla="*/ 370519 w 1057169"/>
                  <a:gd name="connsiteY5" fmla="*/ 44190 h 103725"/>
                  <a:gd name="connsiteX6" fmla="*/ 380717 w 1057169"/>
                  <a:gd name="connsiteY6" fmla="*/ 47590 h 103725"/>
                  <a:gd name="connsiteX7" fmla="*/ 390915 w 1057169"/>
                  <a:gd name="connsiteY7" fmla="*/ 54388 h 103725"/>
                  <a:gd name="connsiteX8" fmla="*/ 431706 w 1057169"/>
                  <a:gd name="connsiteY8" fmla="*/ 64586 h 103725"/>
                  <a:gd name="connsiteX9" fmla="*/ 506490 w 1057169"/>
                  <a:gd name="connsiteY9" fmla="*/ 71384 h 103725"/>
                  <a:gd name="connsiteX10" fmla="*/ 540482 w 1057169"/>
                  <a:gd name="connsiteY10" fmla="*/ 78183 h 103725"/>
                  <a:gd name="connsiteX11" fmla="*/ 554079 w 1057169"/>
                  <a:gd name="connsiteY11" fmla="*/ 81582 h 103725"/>
                  <a:gd name="connsiteX12" fmla="*/ 571075 w 1057169"/>
                  <a:gd name="connsiteY12" fmla="*/ 84981 h 103725"/>
                  <a:gd name="connsiteX13" fmla="*/ 594870 w 1057169"/>
                  <a:gd name="connsiteY13" fmla="*/ 88381 h 103725"/>
                  <a:gd name="connsiteX14" fmla="*/ 639061 w 1057169"/>
                  <a:gd name="connsiteY14" fmla="*/ 95179 h 103725"/>
                  <a:gd name="connsiteX15" fmla="*/ 649258 w 1057169"/>
                  <a:gd name="connsiteY15" fmla="*/ 98578 h 103725"/>
                  <a:gd name="connsiteX16" fmla="*/ 856613 w 1057169"/>
                  <a:gd name="connsiteY16" fmla="*/ 98578 h 103725"/>
                  <a:gd name="connsiteX17" fmla="*/ 900803 w 1057169"/>
                  <a:gd name="connsiteY17" fmla="*/ 91780 h 103725"/>
                  <a:gd name="connsiteX18" fmla="*/ 934796 w 1057169"/>
                  <a:gd name="connsiteY18" fmla="*/ 84981 h 103725"/>
                  <a:gd name="connsiteX19" fmla="*/ 1019777 w 1057169"/>
                  <a:gd name="connsiteY19" fmla="*/ 78183 h 103725"/>
                  <a:gd name="connsiteX20" fmla="*/ 1033374 w 1057169"/>
                  <a:gd name="connsiteY20" fmla="*/ 74784 h 103725"/>
                  <a:gd name="connsiteX21" fmla="*/ 1057169 w 1057169"/>
                  <a:gd name="connsiteY21" fmla="*/ 67985 h 1037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057169" h="103725">
                    <a:moveTo>
                      <a:pt x="0" y="0"/>
                    </a:moveTo>
                    <a:lnTo>
                      <a:pt x="258344" y="3399"/>
                    </a:lnTo>
                    <a:cubicBezTo>
                      <a:pt x="266354" y="3592"/>
                      <a:pt x="274236" y="5482"/>
                      <a:pt x="282139" y="6799"/>
                    </a:cubicBezTo>
                    <a:cubicBezTo>
                      <a:pt x="298549" y="9534"/>
                      <a:pt x="296197" y="9219"/>
                      <a:pt x="309333" y="13597"/>
                    </a:cubicBezTo>
                    <a:cubicBezTo>
                      <a:pt x="332709" y="29182"/>
                      <a:pt x="321977" y="24610"/>
                      <a:pt x="339926" y="30593"/>
                    </a:cubicBezTo>
                    <a:cubicBezTo>
                      <a:pt x="356088" y="41368"/>
                      <a:pt x="346246" y="36099"/>
                      <a:pt x="370519" y="44190"/>
                    </a:cubicBezTo>
                    <a:cubicBezTo>
                      <a:pt x="373918" y="45323"/>
                      <a:pt x="377735" y="45602"/>
                      <a:pt x="380717" y="47590"/>
                    </a:cubicBezTo>
                    <a:cubicBezTo>
                      <a:pt x="384116" y="49856"/>
                      <a:pt x="387182" y="52729"/>
                      <a:pt x="390915" y="54388"/>
                    </a:cubicBezTo>
                    <a:cubicBezTo>
                      <a:pt x="403941" y="60177"/>
                      <a:pt x="417618" y="63077"/>
                      <a:pt x="431706" y="64586"/>
                    </a:cubicBezTo>
                    <a:cubicBezTo>
                      <a:pt x="456594" y="67252"/>
                      <a:pt x="506490" y="71384"/>
                      <a:pt x="506490" y="71384"/>
                    </a:cubicBezTo>
                    <a:cubicBezTo>
                      <a:pt x="527429" y="78366"/>
                      <a:pt x="506115" y="71935"/>
                      <a:pt x="540482" y="78183"/>
                    </a:cubicBezTo>
                    <a:cubicBezTo>
                      <a:pt x="545078" y="79019"/>
                      <a:pt x="549518" y="80569"/>
                      <a:pt x="554079" y="81582"/>
                    </a:cubicBezTo>
                    <a:cubicBezTo>
                      <a:pt x="559719" y="82835"/>
                      <a:pt x="565376" y="84031"/>
                      <a:pt x="571075" y="84981"/>
                    </a:cubicBezTo>
                    <a:cubicBezTo>
                      <a:pt x="578978" y="86298"/>
                      <a:pt x="586951" y="87163"/>
                      <a:pt x="594870" y="88381"/>
                    </a:cubicBezTo>
                    <a:cubicBezTo>
                      <a:pt x="656058" y="97795"/>
                      <a:pt x="570210" y="85344"/>
                      <a:pt x="639061" y="95179"/>
                    </a:cubicBezTo>
                    <a:cubicBezTo>
                      <a:pt x="642460" y="96312"/>
                      <a:pt x="645733" y="97937"/>
                      <a:pt x="649258" y="98578"/>
                    </a:cubicBezTo>
                    <a:cubicBezTo>
                      <a:pt x="711486" y="109893"/>
                      <a:pt x="828840" y="99102"/>
                      <a:pt x="856613" y="98578"/>
                    </a:cubicBezTo>
                    <a:cubicBezTo>
                      <a:pt x="908616" y="88178"/>
                      <a:pt x="826688" y="104133"/>
                      <a:pt x="900803" y="91780"/>
                    </a:cubicBezTo>
                    <a:cubicBezTo>
                      <a:pt x="912201" y="89880"/>
                      <a:pt x="923270" y="85804"/>
                      <a:pt x="934796" y="84981"/>
                    </a:cubicBezTo>
                    <a:cubicBezTo>
                      <a:pt x="994869" y="80690"/>
                      <a:pt x="966548" y="83022"/>
                      <a:pt x="1019777" y="78183"/>
                    </a:cubicBezTo>
                    <a:cubicBezTo>
                      <a:pt x="1024309" y="77050"/>
                      <a:pt x="1028899" y="76126"/>
                      <a:pt x="1033374" y="74784"/>
                    </a:cubicBezTo>
                    <a:cubicBezTo>
                      <a:pt x="1057231" y="67627"/>
                      <a:pt x="1046226" y="67985"/>
                      <a:pt x="1057169" y="67985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6" name="Freeform 25"/>
            <p:cNvSpPr/>
            <p:nvPr/>
          </p:nvSpPr>
          <p:spPr>
            <a:xfrm>
              <a:off x="5680003" y="1245014"/>
              <a:ext cx="8935" cy="571872"/>
            </a:xfrm>
            <a:custGeom>
              <a:avLst/>
              <a:gdLst>
                <a:gd name="connsiteX0" fmla="*/ 0 w 8935"/>
                <a:gd name="connsiteY0" fmla="*/ 0 h 571872"/>
                <a:gd name="connsiteX1" fmla="*/ 2978 w 8935"/>
                <a:gd name="connsiteY1" fmla="*/ 32763 h 571872"/>
                <a:gd name="connsiteX2" fmla="*/ 5957 w 8935"/>
                <a:gd name="connsiteY2" fmla="*/ 44677 h 571872"/>
                <a:gd name="connsiteX3" fmla="*/ 8935 w 8935"/>
                <a:gd name="connsiteY3" fmla="*/ 74462 h 571872"/>
                <a:gd name="connsiteX4" fmla="*/ 5957 w 8935"/>
                <a:gd name="connsiteY4" fmla="*/ 494431 h 571872"/>
                <a:gd name="connsiteX5" fmla="*/ 2978 w 8935"/>
                <a:gd name="connsiteY5" fmla="*/ 518259 h 571872"/>
                <a:gd name="connsiteX6" fmla="*/ 2978 w 8935"/>
                <a:gd name="connsiteY6" fmla="*/ 571872 h 571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8935" h="571872">
                  <a:moveTo>
                    <a:pt x="0" y="0"/>
                  </a:moveTo>
                  <a:cubicBezTo>
                    <a:pt x="993" y="10921"/>
                    <a:pt x="1529" y="21893"/>
                    <a:pt x="2978" y="32763"/>
                  </a:cubicBezTo>
                  <a:cubicBezTo>
                    <a:pt x="3519" y="36821"/>
                    <a:pt x="5378" y="40625"/>
                    <a:pt x="5957" y="44677"/>
                  </a:cubicBezTo>
                  <a:cubicBezTo>
                    <a:pt x="7368" y="54555"/>
                    <a:pt x="7942" y="64534"/>
                    <a:pt x="8935" y="74462"/>
                  </a:cubicBezTo>
                  <a:cubicBezTo>
                    <a:pt x="7942" y="214452"/>
                    <a:pt x="7836" y="354450"/>
                    <a:pt x="5957" y="494431"/>
                  </a:cubicBezTo>
                  <a:cubicBezTo>
                    <a:pt x="5850" y="502435"/>
                    <a:pt x="3286" y="510260"/>
                    <a:pt x="2978" y="518259"/>
                  </a:cubicBezTo>
                  <a:cubicBezTo>
                    <a:pt x="2291" y="536117"/>
                    <a:pt x="2978" y="554001"/>
                    <a:pt x="2978" y="571872"/>
                  </a:cubicBezTo>
                </a:path>
              </a:pathLst>
            </a:custGeom>
            <a:noFill/>
            <a:ln>
              <a:solidFill>
                <a:schemeClr val="accent5">
                  <a:lumMod val="60000"/>
                  <a:lumOff val="40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0" name="Content Placeholder 2"/>
          <p:cNvSpPr txBox="1">
            <a:spLocks/>
          </p:cNvSpPr>
          <p:nvPr/>
        </p:nvSpPr>
        <p:spPr>
          <a:xfrm>
            <a:off x="685800" y="4495800"/>
            <a:ext cx="4648200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oloured</a:t>
            </a: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lines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accent5">
                    <a:lumMod val="60000"/>
                    <a:lumOff val="40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lx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accent5">
                  <a:lumMod val="60000"/>
                  <a:lumOff val="40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accent3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entral </a:t>
            </a: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accent3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ulcus</a:t>
            </a: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066800" y="2286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33800" y="2133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781800" y="1905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543800" y="1905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419600" y="2133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00200" y="2286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066800" y="34406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600200" y="34406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733800" y="3364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419600" y="3364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781800" y="3048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543800" y="3048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4" name="Content Placeholder 2"/>
          <p:cNvSpPr txBox="1">
            <a:spLocks/>
          </p:cNvSpPr>
          <p:nvPr/>
        </p:nvSpPr>
        <p:spPr>
          <a:xfrm>
            <a:off x="4076700" y="4536326"/>
            <a:ext cx="4648200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DF = left </a:t>
            </a: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dorsofrontal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dirty="0" smtClean="0">
                <a:solidFill>
                  <a:schemeClr val="bg1"/>
                </a:solidFill>
              </a:rPr>
              <a:t>RDF = right </a:t>
            </a:r>
            <a:r>
              <a:rPr lang="en-US" dirty="0" err="1" smtClean="0">
                <a:solidFill>
                  <a:schemeClr val="bg1"/>
                </a:solidFill>
              </a:rPr>
              <a:t>dorsofrontal</a:t>
            </a:r>
            <a:endParaRPr lang="en-US" dirty="0" smtClean="0">
              <a:solidFill>
                <a:schemeClr val="bg1"/>
              </a:solidFill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P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= left </a:t>
            </a:r>
            <a:r>
              <a:rPr kumimoji="0" lang="en-US" b="0" i="0" u="none" strike="noStrike" kern="1200" cap="none" spc="0" normalizeH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ariet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-occipi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baseline="0" dirty="0" smtClean="0">
                <a:solidFill>
                  <a:schemeClr val="bg1"/>
                </a:solidFill>
              </a:rPr>
              <a:t>RPO</a:t>
            </a:r>
            <a:r>
              <a:rPr lang="en-US" dirty="0" smtClean="0">
                <a:solidFill>
                  <a:schemeClr val="bg1"/>
                </a:solidFill>
              </a:rPr>
              <a:t> = right </a:t>
            </a:r>
            <a:r>
              <a:rPr lang="en-US" dirty="0" err="1" smtClean="0">
                <a:solidFill>
                  <a:schemeClr val="bg1"/>
                </a:solidFill>
              </a:rPr>
              <a:t>pareto</a:t>
            </a:r>
            <a:r>
              <a:rPr lang="en-US" dirty="0" smtClean="0">
                <a:solidFill>
                  <a:schemeClr val="bg1"/>
                </a:solidFill>
              </a:rPr>
              <a:t>-occipital</a:t>
            </a: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87999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377665" y="1143000"/>
            <a:ext cx="2560320" cy="3657600"/>
            <a:chOff x="6934200" y="381000"/>
            <a:chExt cx="1828800" cy="2651760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4200" y="381000"/>
              <a:ext cx="1828800" cy="2651760"/>
            </a:xfrm>
            <a:prstGeom prst="rect">
              <a:avLst/>
            </a:prstGeom>
          </p:spPr>
        </p:pic>
        <p:grpSp>
          <p:nvGrpSpPr>
            <p:cNvPr id="32" name="Group 31"/>
            <p:cNvGrpSpPr/>
            <p:nvPr/>
          </p:nvGrpSpPr>
          <p:grpSpPr>
            <a:xfrm>
              <a:off x="7630438" y="1362388"/>
              <a:ext cx="463684" cy="487993"/>
              <a:chOff x="7954751" y="2029621"/>
              <a:chExt cx="813975" cy="846744"/>
            </a:xfrm>
          </p:grpSpPr>
          <p:sp>
            <p:nvSpPr>
              <p:cNvPr id="42" name="Freeform 41"/>
              <p:cNvSpPr/>
              <p:nvPr/>
            </p:nvSpPr>
            <p:spPr>
              <a:xfrm>
                <a:off x="7954751" y="2029621"/>
                <a:ext cx="184995" cy="745292"/>
              </a:xfrm>
              <a:custGeom>
                <a:avLst/>
                <a:gdLst>
                  <a:gd name="connsiteX0" fmla="*/ 47570 w 184995"/>
                  <a:gd name="connsiteY0" fmla="*/ 30 h 745292"/>
                  <a:gd name="connsiteX1" fmla="*/ 42285 w 184995"/>
                  <a:gd name="connsiteY1" fmla="*/ 26458 h 745292"/>
                  <a:gd name="connsiteX2" fmla="*/ 26428 w 184995"/>
                  <a:gd name="connsiteY2" fmla="*/ 74028 h 745292"/>
                  <a:gd name="connsiteX3" fmla="*/ 21143 w 184995"/>
                  <a:gd name="connsiteY3" fmla="*/ 89884 h 745292"/>
                  <a:gd name="connsiteX4" fmla="*/ 15857 w 184995"/>
                  <a:gd name="connsiteY4" fmla="*/ 105741 h 745292"/>
                  <a:gd name="connsiteX5" fmla="*/ 15857 w 184995"/>
                  <a:gd name="connsiteY5" fmla="*/ 232594 h 745292"/>
                  <a:gd name="connsiteX6" fmla="*/ 10572 w 184995"/>
                  <a:gd name="connsiteY6" fmla="*/ 317163 h 745292"/>
                  <a:gd name="connsiteX7" fmla="*/ 5286 w 184995"/>
                  <a:gd name="connsiteY7" fmla="*/ 512728 h 745292"/>
                  <a:gd name="connsiteX8" fmla="*/ 0 w 184995"/>
                  <a:gd name="connsiteY8" fmla="*/ 533870 h 745292"/>
                  <a:gd name="connsiteX9" fmla="*/ 5286 w 184995"/>
                  <a:gd name="connsiteY9" fmla="*/ 655438 h 745292"/>
                  <a:gd name="connsiteX10" fmla="*/ 10572 w 184995"/>
                  <a:gd name="connsiteY10" fmla="*/ 681866 h 745292"/>
                  <a:gd name="connsiteX11" fmla="*/ 15857 w 184995"/>
                  <a:gd name="connsiteY11" fmla="*/ 713579 h 745292"/>
                  <a:gd name="connsiteX12" fmla="*/ 26428 w 184995"/>
                  <a:gd name="connsiteY12" fmla="*/ 745292 h 745292"/>
                  <a:gd name="connsiteX13" fmla="*/ 47570 w 184995"/>
                  <a:gd name="connsiteY13" fmla="*/ 740007 h 745292"/>
                  <a:gd name="connsiteX14" fmla="*/ 63427 w 184995"/>
                  <a:gd name="connsiteY14" fmla="*/ 734721 h 745292"/>
                  <a:gd name="connsiteX15" fmla="*/ 68713 w 184995"/>
                  <a:gd name="connsiteY15" fmla="*/ 703008 h 745292"/>
                  <a:gd name="connsiteX16" fmla="*/ 73998 w 184995"/>
                  <a:gd name="connsiteY16" fmla="*/ 666009 h 745292"/>
                  <a:gd name="connsiteX17" fmla="*/ 84569 w 184995"/>
                  <a:gd name="connsiteY17" fmla="*/ 634296 h 745292"/>
                  <a:gd name="connsiteX18" fmla="*/ 105711 w 184995"/>
                  <a:gd name="connsiteY18" fmla="*/ 570869 h 745292"/>
                  <a:gd name="connsiteX19" fmla="*/ 116283 w 184995"/>
                  <a:gd name="connsiteY19" fmla="*/ 539156 h 745292"/>
                  <a:gd name="connsiteX20" fmla="*/ 121568 w 184995"/>
                  <a:gd name="connsiteY20" fmla="*/ 523299 h 745292"/>
                  <a:gd name="connsiteX21" fmla="*/ 142710 w 184995"/>
                  <a:gd name="connsiteY21" fmla="*/ 475729 h 745292"/>
                  <a:gd name="connsiteX22" fmla="*/ 147996 w 184995"/>
                  <a:gd name="connsiteY22" fmla="*/ 454587 h 745292"/>
                  <a:gd name="connsiteX23" fmla="*/ 153281 w 184995"/>
                  <a:gd name="connsiteY23" fmla="*/ 438730 h 745292"/>
                  <a:gd name="connsiteX24" fmla="*/ 163852 w 184995"/>
                  <a:gd name="connsiteY24" fmla="*/ 385875 h 745292"/>
                  <a:gd name="connsiteX25" fmla="*/ 174424 w 184995"/>
                  <a:gd name="connsiteY25" fmla="*/ 354162 h 745292"/>
                  <a:gd name="connsiteX26" fmla="*/ 179709 w 184995"/>
                  <a:gd name="connsiteY26" fmla="*/ 338305 h 745292"/>
                  <a:gd name="connsiteX27" fmla="*/ 184995 w 184995"/>
                  <a:gd name="connsiteY27" fmla="*/ 290735 h 745292"/>
                  <a:gd name="connsiteX28" fmla="*/ 174424 w 184995"/>
                  <a:gd name="connsiteY28" fmla="*/ 163882 h 745292"/>
                  <a:gd name="connsiteX29" fmla="*/ 163852 w 184995"/>
                  <a:gd name="connsiteY29" fmla="*/ 132169 h 745292"/>
                  <a:gd name="connsiteX30" fmla="*/ 158567 w 184995"/>
                  <a:gd name="connsiteY30" fmla="*/ 116312 h 745292"/>
                  <a:gd name="connsiteX31" fmla="*/ 147996 w 184995"/>
                  <a:gd name="connsiteY31" fmla="*/ 100455 h 745292"/>
                  <a:gd name="connsiteX32" fmla="*/ 121568 w 184995"/>
                  <a:gd name="connsiteY32" fmla="*/ 63456 h 745292"/>
                  <a:gd name="connsiteX33" fmla="*/ 100426 w 184995"/>
                  <a:gd name="connsiteY33" fmla="*/ 31743 h 745292"/>
                  <a:gd name="connsiteX34" fmla="*/ 47570 w 184995"/>
                  <a:gd name="connsiteY34" fmla="*/ 30 h 7452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184995" h="745292">
                    <a:moveTo>
                      <a:pt x="47570" y="30"/>
                    </a:moveTo>
                    <a:cubicBezTo>
                      <a:pt x="37880" y="-851"/>
                      <a:pt x="44649" y="17791"/>
                      <a:pt x="42285" y="26458"/>
                    </a:cubicBezTo>
                    <a:cubicBezTo>
                      <a:pt x="42280" y="26476"/>
                      <a:pt x="29074" y="66091"/>
                      <a:pt x="26428" y="74028"/>
                    </a:cubicBezTo>
                    <a:lnTo>
                      <a:pt x="21143" y="89884"/>
                    </a:lnTo>
                    <a:lnTo>
                      <a:pt x="15857" y="105741"/>
                    </a:lnTo>
                    <a:cubicBezTo>
                      <a:pt x="3825" y="214043"/>
                      <a:pt x="15857" y="80271"/>
                      <a:pt x="15857" y="232594"/>
                    </a:cubicBezTo>
                    <a:cubicBezTo>
                      <a:pt x="15857" y="260839"/>
                      <a:pt x="12334" y="288973"/>
                      <a:pt x="10572" y="317163"/>
                    </a:cubicBezTo>
                    <a:cubicBezTo>
                      <a:pt x="8810" y="382351"/>
                      <a:pt x="8464" y="447593"/>
                      <a:pt x="5286" y="512728"/>
                    </a:cubicBezTo>
                    <a:cubicBezTo>
                      <a:pt x="4932" y="519984"/>
                      <a:pt x="0" y="526606"/>
                      <a:pt x="0" y="533870"/>
                    </a:cubicBezTo>
                    <a:cubicBezTo>
                      <a:pt x="0" y="574431"/>
                      <a:pt x="2396" y="614980"/>
                      <a:pt x="5286" y="655438"/>
                    </a:cubicBezTo>
                    <a:cubicBezTo>
                      <a:pt x="5926" y="664399"/>
                      <a:pt x="8965" y="673027"/>
                      <a:pt x="10572" y="681866"/>
                    </a:cubicBezTo>
                    <a:cubicBezTo>
                      <a:pt x="12489" y="692410"/>
                      <a:pt x="13258" y="703182"/>
                      <a:pt x="15857" y="713579"/>
                    </a:cubicBezTo>
                    <a:cubicBezTo>
                      <a:pt x="18559" y="724389"/>
                      <a:pt x="26428" y="745292"/>
                      <a:pt x="26428" y="745292"/>
                    </a:cubicBezTo>
                    <a:cubicBezTo>
                      <a:pt x="33475" y="743530"/>
                      <a:pt x="40585" y="742003"/>
                      <a:pt x="47570" y="740007"/>
                    </a:cubicBezTo>
                    <a:cubicBezTo>
                      <a:pt x="52927" y="738476"/>
                      <a:pt x="60663" y="739558"/>
                      <a:pt x="63427" y="734721"/>
                    </a:cubicBezTo>
                    <a:cubicBezTo>
                      <a:pt x="68744" y="725416"/>
                      <a:pt x="67083" y="713600"/>
                      <a:pt x="68713" y="703008"/>
                    </a:cubicBezTo>
                    <a:cubicBezTo>
                      <a:pt x="70607" y="690695"/>
                      <a:pt x="71197" y="678148"/>
                      <a:pt x="73998" y="666009"/>
                    </a:cubicBezTo>
                    <a:cubicBezTo>
                      <a:pt x="76503" y="655152"/>
                      <a:pt x="81045" y="644867"/>
                      <a:pt x="84569" y="634296"/>
                    </a:cubicBezTo>
                    <a:lnTo>
                      <a:pt x="105711" y="570869"/>
                    </a:lnTo>
                    <a:lnTo>
                      <a:pt x="116283" y="539156"/>
                    </a:lnTo>
                    <a:cubicBezTo>
                      <a:pt x="118045" y="533870"/>
                      <a:pt x="118477" y="527935"/>
                      <a:pt x="121568" y="523299"/>
                    </a:cubicBezTo>
                    <a:cubicBezTo>
                      <a:pt x="135453" y="502473"/>
                      <a:pt x="135160" y="505924"/>
                      <a:pt x="142710" y="475729"/>
                    </a:cubicBezTo>
                    <a:cubicBezTo>
                      <a:pt x="144472" y="468682"/>
                      <a:pt x="146000" y="461572"/>
                      <a:pt x="147996" y="454587"/>
                    </a:cubicBezTo>
                    <a:cubicBezTo>
                      <a:pt x="149527" y="449230"/>
                      <a:pt x="152028" y="444159"/>
                      <a:pt x="153281" y="438730"/>
                    </a:cubicBezTo>
                    <a:cubicBezTo>
                      <a:pt x="157321" y="421223"/>
                      <a:pt x="158170" y="402920"/>
                      <a:pt x="163852" y="385875"/>
                    </a:cubicBezTo>
                    <a:lnTo>
                      <a:pt x="174424" y="354162"/>
                    </a:lnTo>
                    <a:lnTo>
                      <a:pt x="179709" y="338305"/>
                    </a:lnTo>
                    <a:cubicBezTo>
                      <a:pt x="181471" y="322448"/>
                      <a:pt x="184995" y="306689"/>
                      <a:pt x="184995" y="290735"/>
                    </a:cubicBezTo>
                    <a:cubicBezTo>
                      <a:pt x="184995" y="261477"/>
                      <a:pt x="184739" y="201703"/>
                      <a:pt x="174424" y="163882"/>
                    </a:cubicBezTo>
                    <a:cubicBezTo>
                      <a:pt x="171492" y="153132"/>
                      <a:pt x="167376" y="142740"/>
                      <a:pt x="163852" y="132169"/>
                    </a:cubicBezTo>
                    <a:cubicBezTo>
                      <a:pt x="162090" y="126883"/>
                      <a:pt x="161657" y="120948"/>
                      <a:pt x="158567" y="116312"/>
                    </a:cubicBezTo>
                    <a:cubicBezTo>
                      <a:pt x="155043" y="111026"/>
                      <a:pt x="150576" y="106260"/>
                      <a:pt x="147996" y="100455"/>
                    </a:cubicBezTo>
                    <a:cubicBezTo>
                      <a:pt x="130837" y="61848"/>
                      <a:pt x="150409" y="73070"/>
                      <a:pt x="121568" y="63456"/>
                    </a:cubicBezTo>
                    <a:cubicBezTo>
                      <a:pt x="114521" y="52885"/>
                      <a:pt x="112479" y="35761"/>
                      <a:pt x="100426" y="31743"/>
                    </a:cubicBezTo>
                    <a:cubicBezTo>
                      <a:pt x="62027" y="18943"/>
                      <a:pt x="57260" y="911"/>
                      <a:pt x="47570" y="30"/>
                    </a:cubicBezTo>
                    <a:close/>
                  </a:path>
                </a:pathLst>
              </a:cu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Freeform 42"/>
              <p:cNvSpPr/>
              <p:nvPr/>
            </p:nvSpPr>
            <p:spPr>
              <a:xfrm>
                <a:off x="8578446" y="2060719"/>
                <a:ext cx="190280" cy="815646"/>
              </a:xfrm>
              <a:custGeom>
                <a:avLst/>
                <a:gdLst>
                  <a:gd name="connsiteX0" fmla="*/ 132139 w 190280"/>
                  <a:gd name="connsiteY0" fmla="*/ 645 h 815646"/>
                  <a:gd name="connsiteX1" fmla="*/ 153281 w 190280"/>
                  <a:gd name="connsiteY1" fmla="*/ 58786 h 815646"/>
                  <a:gd name="connsiteX2" fmla="*/ 169138 w 190280"/>
                  <a:gd name="connsiteY2" fmla="*/ 116927 h 815646"/>
                  <a:gd name="connsiteX3" fmla="*/ 174423 w 190280"/>
                  <a:gd name="connsiteY3" fmla="*/ 153926 h 815646"/>
                  <a:gd name="connsiteX4" fmla="*/ 174423 w 190280"/>
                  <a:gd name="connsiteY4" fmla="*/ 481630 h 815646"/>
                  <a:gd name="connsiteX5" fmla="*/ 163852 w 190280"/>
                  <a:gd name="connsiteY5" fmla="*/ 645482 h 815646"/>
                  <a:gd name="connsiteX6" fmla="*/ 169138 w 190280"/>
                  <a:gd name="connsiteY6" fmla="*/ 708909 h 815646"/>
                  <a:gd name="connsiteX7" fmla="*/ 179709 w 190280"/>
                  <a:gd name="connsiteY7" fmla="*/ 740622 h 815646"/>
                  <a:gd name="connsiteX8" fmla="*/ 190280 w 190280"/>
                  <a:gd name="connsiteY8" fmla="*/ 777621 h 815646"/>
                  <a:gd name="connsiteX9" fmla="*/ 184994 w 190280"/>
                  <a:gd name="connsiteY9" fmla="*/ 814620 h 815646"/>
                  <a:gd name="connsiteX10" fmla="*/ 174423 w 190280"/>
                  <a:gd name="connsiteY10" fmla="*/ 798763 h 815646"/>
                  <a:gd name="connsiteX11" fmla="*/ 163852 w 190280"/>
                  <a:gd name="connsiteY11" fmla="*/ 767050 h 815646"/>
                  <a:gd name="connsiteX12" fmla="*/ 147996 w 190280"/>
                  <a:gd name="connsiteY12" fmla="*/ 735336 h 815646"/>
                  <a:gd name="connsiteX13" fmla="*/ 142710 w 190280"/>
                  <a:gd name="connsiteY13" fmla="*/ 719480 h 815646"/>
                  <a:gd name="connsiteX14" fmla="*/ 126853 w 190280"/>
                  <a:gd name="connsiteY14" fmla="*/ 714194 h 815646"/>
                  <a:gd name="connsiteX15" fmla="*/ 100426 w 190280"/>
                  <a:gd name="connsiteY15" fmla="*/ 666624 h 815646"/>
                  <a:gd name="connsiteX16" fmla="*/ 89855 w 190280"/>
                  <a:gd name="connsiteY16" fmla="*/ 650768 h 815646"/>
                  <a:gd name="connsiteX17" fmla="*/ 68712 w 190280"/>
                  <a:gd name="connsiteY17" fmla="*/ 587341 h 815646"/>
                  <a:gd name="connsiteX18" fmla="*/ 63427 w 190280"/>
                  <a:gd name="connsiteY18" fmla="*/ 571484 h 815646"/>
                  <a:gd name="connsiteX19" fmla="*/ 52856 w 190280"/>
                  <a:gd name="connsiteY19" fmla="*/ 555628 h 815646"/>
                  <a:gd name="connsiteX20" fmla="*/ 42285 w 190280"/>
                  <a:gd name="connsiteY20" fmla="*/ 523915 h 815646"/>
                  <a:gd name="connsiteX21" fmla="*/ 31714 w 190280"/>
                  <a:gd name="connsiteY21" fmla="*/ 492201 h 815646"/>
                  <a:gd name="connsiteX22" fmla="*/ 26428 w 190280"/>
                  <a:gd name="connsiteY22" fmla="*/ 476345 h 815646"/>
                  <a:gd name="connsiteX23" fmla="*/ 21142 w 190280"/>
                  <a:gd name="connsiteY23" fmla="*/ 455202 h 815646"/>
                  <a:gd name="connsiteX24" fmla="*/ 5286 w 190280"/>
                  <a:gd name="connsiteY24" fmla="*/ 402347 h 815646"/>
                  <a:gd name="connsiteX25" fmla="*/ 0 w 190280"/>
                  <a:gd name="connsiteY25" fmla="*/ 360063 h 815646"/>
                  <a:gd name="connsiteX26" fmla="*/ 5286 w 190280"/>
                  <a:gd name="connsiteY26" fmla="*/ 169783 h 815646"/>
                  <a:gd name="connsiteX27" fmla="*/ 10571 w 190280"/>
                  <a:gd name="connsiteY27" fmla="*/ 153926 h 815646"/>
                  <a:gd name="connsiteX28" fmla="*/ 26428 w 190280"/>
                  <a:gd name="connsiteY28" fmla="*/ 143355 h 815646"/>
                  <a:gd name="connsiteX29" fmla="*/ 42285 w 190280"/>
                  <a:gd name="connsiteY29" fmla="*/ 111642 h 815646"/>
                  <a:gd name="connsiteX30" fmla="*/ 47570 w 190280"/>
                  <a:gd name="connsiteY30" fmla="*/ 95785 h 815646"/>
                  <a:gd name="connsiteX31" fmla="*/ 73998 w 190280"/>
                  <a:gd name="connsiteY31" fmla="*/ 64072 h 815646"/>
                  <a:gd name="connsiteX32" fmla="*/ 89855 w 190280"/>
                  <a:gd name="connsiteY32" fmla="*/ 53501 h 815646"/>
                  <a:gd name="connsiteX33" fmla="*/ 110997 w 190280"/>
                  <a:gd name="connsiteY33" fmla="*/ 27073 h 815646"/>
                  <a:gd name="connsiteX34" fmla="*/ 132139 w 190280"/>
                  <a:gd name="connsiteY34" fmla="*/ 645 h 8156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190280" h="815646">
                    <a:moveTo>
                      <a:pt x="132139" y="645"/>
                    </a:moveTo>
                    <a:cubicBezTo>
                      <a:pt x="139186" y="5931"/>
                      <a:pt x="139708" y="18068"/>
                      <a:pt x="153281" y="58786"/>
                    </a:cubicBezTo>
                    <a:cubicBezTo>
                      <a:pt x="159733" y="78140"/>
                      <a:pt x="166157" y="96058"/>
                      <a:pt x="169138" y="116927"/>
                    </a:cubicBezTo>
                    <a:lnTo>
                      <a:pt x="174423" y="153926"/>
                    </a:lnTo>
                    <a:cubicBezTo>
                      <a:pt x="161962" y="477950"/>
                      <a:pt x="174423" y="75007"/>
                      <a:pt x="174423" y="481630"/>
                    </a:cubicBezTo>
                    <a:cubicBezTo>
                      <a:pt x="174423" y="618744"/>
                      <a:pt x="184131" y="584653"/>
                      <a:pt x="163852" y="645482"/>
                    </a:cubicBezTo>
                    <a:cubicBezTo>
                      <a:pt x="165614" y="666624"/>
                      <a:pt x="165650" y="687982"/>
                      <a:pt x="169138" y="708909"/>
                    </a:cubicBezTo>
                    <a:cubicBezTo>
                      <a:pt x="170970" y="719900"/>
                      <a:pt x="177007" y="729812"/>
                      <a:pt x="179709" y="740622"/>
                    </a:cubicBezTo>
                    <a:cubicBezTo>
                      <a:pt x="186345" y="767169"/>
                      <a:pt x="182697" y="754873"/>
                      <a:pt x="190280" y="777621"/>
                    </a:cubicBezTo>
                    <a:cubicBezTo>
                      <a:pt x="188518" y="789954"/>
                      <a:pt x="192469" y="804654"/>
                      <a:pt x="184994" y="814620"/>
                    </a:cubicBezTo>
                    <a:cubicBezTo>
                      <a:pt x="181182" y="819702"/>
                      <a:pt x="177003" y="804568"/>
                      <a:pt x="174423" y="798763"/>
                    </a:cubicBezTo>
                    <a:cubicBezTo>
                      <a:pt x="169898" y="788581"/>
                      <a:pt x="167376" y="777621"/>
                      <a:pt x="163852" y="767050"/>
                    </a:cubicBezTo>
                    <a:cubicBezTo>
                      <a:pt x="150568" y="727197"/>
                      <a:pt x="168487" y="776318"/>
                      <a:pt x="147996" y="735336"/>
                    </a:cubicBezTo>
                    <a:cubicBezTo>
                      <a:pt x="145504" y="730353"/>
                      <a:pt x="146650" y="723419"/>
                      <a:pt x="142710" y="719480"/>
                    </a:cubicBezTo>
                    <a:cubicBezTo>
                      <a:pt x="138770" y="715540"/>
                      <a:pt x="132139" y="715956"/>
                      <a:pt x="126853" y="714194"/>
                    </a:cubicBezTo>
                    <a:cubicBezTo>
                      <a:pt x="117551" y="686286"/>
                      <a:pt x="124658" y="702972"/>
                      <a:pt x="100426" y="666624"/>
                    </a:cubicBezTo>
                    <a:cubicBezTo>
                      <a:pt x="96902" y="661339"/>
                      <a:pt x="91864" y="656794"/>
                      <a:pt x="89855" y="650768"/>
                    </a:cubicBezTo>
                    <a:lnTo>
                      <a:pt x="68712" y="587341"/>
                    </a:lnTo>
                    <a:cubicBezTo>
                      <a:pt x="66950" y="582055"/>
                      <a:pt x="66518" y="576120"/>
                      <a:pt x="63427" y="571484"/>
                    </a:cubicBezTo>
                    <a:cubicBezTo>
                      <a:pt x="59903" y="566199"/>
                      <a:pt x="55436" y="561433"/>
                      <a:pt x="52856" y="555628"/>
                    </a:cubicBezTo>
                    <a:cubicBezTo>
                      <a:pt x="48330" y="545446"/>
                      <a:pt x="45809" y="534486"/>
                      <a:pt x="42285" y="523915"/>
                    </a:cubicBezTo>
                    <a:lnTo>
                      <a:pt x="31714" y="492201"/>
                    </a:lnTo>
                    <a:cubicBezTo>
                      <a:pt x="29952" y="486916"/>
                      <a:pt x="27779" y="481750"/>
                      <a:pt x="26428" y="476345"/>
                    </a:cubicBezTo>
                    <a:cubicBezTo>
                      <a:pt x="24666" y="469297"/>
                      <a:pt x="23229" y="462160"/>
                      <a:pt x="21142" y="455202"/>
                    </a:cubicBezTo>
                    <a:cubicBezTo>
                      <a:pt x="15853" y="437571"/>
                      <a:pt x="8333" y="420626"/>
                      <a:pt x="5286" y="402347"/>
                    </a:cubicBezTo>
                    <a:cubicBezTo>
                      <a:pt x="2951" y="388336"/>
                      <a:pt x="1762" y="374158"/>
                      <a:pt x="0" y="360063"/>
                    </a:cubicBezTo>
                    <a:cubicBezTo>
                      <a:pt x="1762" y="296636"/>
                      <a:pt x="2036" y="233151"/>
                      <a:pt x="5286" y="169783"/>
                    </a:cubicBezTo>
                    <a:cubicBezTo>
                      <a:pt x="5571" y="164219"/>
                      <a:pt x="7091" y="158277"/>
                      <a:pt x="10571" y="153926"/>
                    </a:cubicBezTo>
                    <a:cubicBezTo>
                      <a:pt x="14539" y="148965"/>
                      <a:pt x="21142" y="146879"/>
                      <a:pt x="26428" y="143355"/>
                    </a:cubicBezTo>
                    <a:cubicBezTo>
                      <a:pt x="39717" y="103490"/>
                      <a:pt x="21789" y="152635"/>
                      <a:pt x="42285" y="111642"/>
                    </a:cubicBezTo>
                    <a:cubicBezTo>
                      <a:pt x="44777" y="106659"/>
                      <a:pt x="45078" y="100768"/>
                      <a:pt x="47570" y="95785"/>
                    </a:cubicBezTo>
                    <a:cubicBezTo>
                      <a:pt x="53510" y="83905"/>
                      <a:pt x="63977" y="72422"/>
                      <a:pt x="73998" y="64072"/>
                    </a:cubicBezTo>
                    <a:cubicBezTo>
                      <a:pt x="78878" y="60005"/>
                      <a:pt x="84569" y="57025"/>
                      <a:pt x="89855" y="53501"/>
                    </a:cubicBezTo>
                    <a:cubicBezTo>
                      <a:pt x="95485" y="36609"/>
                      <a:pt x="92401" y="35043"/>
                      <a:pt x="110997" y="27073"/>
                    </a:cubicBezTo>
                    <a:cubicBezTo>
                      <a:pt x="117674" y="24211"/>
                      <a:pt x="125092" y="-4641"/>
                      <a:pt x="132139" y="645"/>
                    </a:cubicBezTo>
                    <a:close/>
                  </a:path>
                </a:pathLst>
              </a:cu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7118043" y="1641841"/>
              <a:ext cx="1444684" cy="113002"/>
              <a:chOff x="7118043" y="1641841"/>
              <a:chExt cx="1444684" cy="113002"/>
            </a:xfrm>
          </p:grpSpPr>
          <p:sp>
            <p:nvSpPr>
              <p:cNvPr id="38" name="Freeform 37"/>
              <p:cNvSpPr/>
              <p:nvPr/>
            </p:nvSpPr>
            <p:spPr>
              <a:xfrm>
                <a:off x="7118043" y="1679233"/>
                <a:ext cx="200556" cy="44190"/>
              </a:xfrm>
              <a:custGeom>
                <a:avLst/>
                <a:gdLst>
                  <a:gd name="connsiteX0" fmla="*/ 0 w 200556"/>
                  <a:gd name="connsiteY0" fmla="*/ 0 h 44190"/>
                  <a:gd name="connsiteX1" fmla="*/ 37392 w 200556"/>
                  <a:gd name="connsiteY1" fmla="*/ 6798 h 44190"/>
                  <a:gd name="connsiteX2" fmla="*/ 47590 w 200556"/>
                  <a:gd name="connsiteY2" fmla="*/ 13597 h 44190"/>
                  <a:gd name="connsiteX3" fmla="*/ 67985 w 200556"/>
                  <a:gd name="connsiteY3" fmla="*/ 20395 h 44190"/>
                  <a:gd name="connsiteX4" fmla="*/ 98579 w 200556"/>
                  <a:gd name="connsiteY4" fmla="*/ 33992 h 44190"/>
                  <a:gd name="connsiteX5" fmla="*/ 118974 w 200556"/>
                  <a:gd name="connsiteY5" fmla="*/ 40791 h 44190"/>
                  <a:gd name="connsiteX6" fmla="*/ 156366 w 200556"/>
                  <a:gd name="connsiteY6" fmla="*/ 44190 h 44190"/>
                  <a:gd name="connsiteX7" fmla="*/ 200556 w 200556"/>
                  <a:gd name="connsiteY7" fmla="*/ 40791 h 441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00556" h="44190">
                    <a:moveTo>
                      <a:pt x="0" y="0"/>
                    </a:moveTo>
                    <a:cubicBezTo>
                      <a:pt x="9371" y="1171"/>
                      <a:pt x="26913" y="1559"/>
                      <a:pt x="37392" y="6798"/>
                    </a:cubicBezTo>
                    <a:cubicBezTo>
                      <a:pt x="41046" y="8625"/>
                      <a:pt x="43857" y="11938"/>
                      <a:pt x="47590" y="13597"/>
                    </a:cubicBezTo>
                    <a:cubicBezTo>
                      <a:pt x="54138" y="16507"/>
                      <a:pt x="67985" y="20395"/>
                      <a:pt x="67985" y="20395"/>
                    </a:cubicBezTo>
                    <a:cubicBezTo>
                      <a:pt x="84147" y="31171"/>
                      <a:pt x="74304" y="25900"/>
                      <a:pt x="98579" y="33992"/>
                    </a:cubicBezTo>
                    <a:cubicBezTo>
                      <a:pt x="98586" y="33994"/>
                      <a:pt x="118967" y="40790"/>
                      <a:pt x="118974" y="40791"/>
                    </a:cubicBezTo>
                    <a:lnTo>
                      <a:pt x="156366" y="44190"/>
                    </a:lnTo>
                    <a:cubicBezTo>
                      <a:pt x="189182" y="40088"/>
                      <a:pt x="174425" y="40791"/>
                      <a:pt x="200556" y="40791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Freeform 38"/>
              <p:cNvSpPr/>
              <p:nvPr/>
            </p:nvSpPr>
            <p:spPr>
              <a:xfrm>
                <a:off x="7298204" y="1716625"/>
                <a:ext cx="329728" cy="14074"/>
              </a:xfrm>
              <a:custGeom>
                <a:avLst/>
                <a:gdLst>
                  <a:gd name="connsiteX0" fmla="*/ 0 w 329728"/>
                  <a:gd name="connsiteY0" fmla="*/ 6798 h 14074"/>
                  <a:gd name="connsiteX1" fmla="*/ 16996 w 329728"/>
                  <a:gd name="connsiteY1" fmla="*/ 3399 h 14074"/>
                  <a:gd name="connsiteX2" fmla="*/ 27194 w 329728"/>
                  <a:gd name="connsiteY2" fmla="*/ 0 h 14074"/>
                  <a:gd name="connsiteX3" fmla="*/ 44190 w 329728"/>
                  <a:gd name="connsiteY3" fmla="*/ 3399 h 14074"/>
                  <a:gd name="connsiteX4" fmla="*/ 67985 w 329728"/>
                  <a:gd name="connsiteY4" fmla="*/ 10197 h 14074"/>
                  <a:gd name="connsiteX5" fmla="*/ 81582 w 329728"/>
                  <a:gd name="connsiteY5" fmla="*/ 13597 h 14074"/>
                  <a:gd name="connsiteX6" fmla="*/ 329728 w 329728"/>
                  <a:gd name="connsiteY6" fmla="*/ 13597 h 140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329728" h="14074">
                    <a:moveTo>
                      <a:pt x="0" y="6798"/>
                    </a:moveTo>
                    <a:cubicBezTo>
                      <a:pt x="5665" y="5665"/>
                      <a:pt x="11391" y="4800"/>
                      <a:pt x="16996" y="3399"/>
                    </a:cubicBezTo>
                    <a:cubicBezTo>
                      <a:pt x="20472" y="2530"/>
                      <a:pt x="23611" y="0"/>
                      <a:pt x="27194" y="0"/>
                    </a:cubicBezTo>
                    <a:cubicBezTo>
                      <a:pt x="32972" y="0"/>
                      <a:pt x="38550" y="2146"/>
                      <a:pt x="44190" y="3399"/>
                    </a:cubicBezTo>
                    <a:cubicBezTo>
                      <a:pt x="68082" y="8708"/>
                      <a:pt x="48125" y="4522"/>
                      <a:pt x="67985" y="10197"/>
                    </a:cubicBezTo>
                    <a:cubicBezTo>
                      <a:pt x="72477" y="11481"/>
                      <a:pt x="76911" y="13536"/>
                      <a:pt x="81582" y="13597"/>
                    </a:cubicBezTo>
                    <a:cubicBezTo>
                      <a:pt x="164290" y="14671"/>
                      <a:pt x="247013" y="13597"/>
                      <a:pt x="329728" y="13597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Freeform 39"/>
              <p:cNvSpPr/>
              <p:nvPr/>
            </p:nvSpPr>
            <p:spPr>
              <a:xfrm>
                <a:off x="8406361" y="1641841"/>
                <a:ext cx="156366" cy="101978"/>
              </a:xfrm>
              <a:custGeom>
                <a:avLst/>
                <a:gdLst>
                  <a:gd name="connsiteX0" fmla="*/ 156366 w 156366"/>
                  <a:gd name="connsiteY0" fmla="*/ 0 h 101978"/>
                  <a:gd name="connsiteX1" fmla="*/ 122374 w 156366"/>
                  <a:gd name="connsiteY1" fmla="*/ 10198 h 101978"/>
                  <a:gd name="connsiteX2" fmla="*/ 115575 w 156366"/>
                  <a:gd name="connsiteY2" fmla="*/ 20395 h 101978"/>
                  <a:gd name="connsiteX3" fmla="*/ 105377 w 156366"/>
                  <a:gd name="connsiteY3" fmla="*/ 23795 h 101978"/>
                  <a:gd name="connsiteX4" fmla="*/ 84982 w 156366"/>
                  <a:gd name="connsiteY4" fmla="*/ 37392 h 101978"/>
                  <a:gd name="connsiteX5" fmla="*/ 50989 w 156366"/>
                  <a:gd name="connsiteY5" fmla="*/ 47589 h 101978"/>
                  <a:gd name="connsiteX6" fmla="*/ 44191 w 156366"/>
                  <a:gd name="connsiteY6" fmla="*/ 57787 h 101978"/>
                  <a:gd name="connsiteX7" fmla="*/ 30594 w 156366"/>
                  <a:gd name="connsiteY7" fmla="*/ 88381 h 101978"/>
                  <a:gd name="connsiteX8" fmla="*/ 20396 w 156366"/>
                  <a:gd name="connsiteY8" fmla="*/ 95179 h 101978"/>
                  <a:gd name="connsiteX9" fmla="*/ 0 w 156366"/>
                  <a:gd name="connsiteY9" fmla="*/ 101978 h 1019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56366" h="101978">
                    <a:moveTo>
                      <a:pt x="156366" y="0"/>
                    </a:moveTo>
                    <a:cubicBezTo>
                      <a:pt x="141384" y="2140"/>
                      <a:pt x="132681" y="-109"/>
                      <a:pt x="122374" y="10198"/>
                    </a:cubicBezTo>
                    <a:cubicBezTo>
                      <a:pt x="119485" y="13087"/>
                      <a:pt x="118765" y="17843"/>
                      <a:pt x="115575" y="20395"/>
                    </a:cubicBezTo>
                    <a:cubicBezTo>
                      <a:pt x="112777" y="22633"/>
                      <a:pt x="108509" y="22055"/>
                      <a:pt x="105377" y="23795"/>
                    </a:cubicBezTo>
                    <a:cubicBezTo>
                      <a:pt x="98235" y="27763"/>
                      <a:pt x="92733" y="34808"/>
                      <a:pt x="84982" y="37392"/>
                    </a:cubicBezTo>
                    <a:cubicBezTo>
                      <a:pt x="60154" y="45667"/>
                      <a:pt x="71538" y="42452"/>
                      <a:pt x="50989" y="47589"/>
                    </a:cubicBezTo>
                    <a:cubicBezTo>
                      <a:pt x="48723" y="50988"/>
                      <a:pt x="45850" y="54054"/>
                      <a:pt x="44191" y="57787"/>
                    </a:cubicBezTo>
                    <a:cubicBezTo>
                      <a:pt x="38808" y="69899"/>
                      <a:pt x="39823" y="79152"/>
                      <a:pt x="30594" y="88381"/>
                    </a:cubicBezTo>
                    <a:cubicBezTo>
                      <a:pt x="27705" y="91270"/>
                      <a:pt x="24129" y="93520"/>
                      <a:pt x="20396" y="95179"/>
                    </a:cubicBezTo>
                    <a:cubicBezTo>
                      <a:pt x="13847" y="98090"/>
                      <a:pt x="0" y="101978"/>
                      <a:pt x="0" y="101978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Freeform 40"/>
              <p:cNvSpPr/>
              <p:nvPr/>
            </p:nvSpPr>
            <p:spPr>
              <a:xfrm>
                <a:off x="8078962" y="1738946"/>
                <a:ext cx="343561" cy="15897"/>
              </a:xfrm>
              <a:custGeom>
                <a:avLst/>
                <a:gdLst>
                  <a:gd name="connsiteX0" fmla="*/ 343561 w 343561"/>
                  <a:gd name="connsiteY0" fmla="*/ 0 h 15897"/>
                  <a:gd name="connsiteX1" fmla="*/ 272206 w 343561"/>
                  <a:gd name="connsiteY1" fmla="*/ 5285 h 15897"/>
                  <a:gd name="connsiteX2" fmla="*/ 248421 w 343561"/>
                  <a:gd name="connsiteY2" fmla="*/ 7928 h 15897"/>
                  <a:gd name="connsiteX3" fmla="*/ 52855 w 343561"/>
                  <a:gd name="connsiteY3" fmla="*/ 13214 h 15897"/>
                  <a:gd name="connsiteX4" fmla="*/ 0 w 343561"/>
                  <a:gd name="connsiteY4" fmla="*/ 15856 h 158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343561" h="15897">
                    <a:moveTo>
                      <a:pt x="343561" y="0"/>
                    </a:moveTo>
                    <a:cubicBezTo>
                      <a:pt x="277278" y="6626"/>
                      <a:pt x="368211" y="-2101"/>
                      <a:pt x="272206" y="5285"/>
                    </a:cubicBezTo>
                    <a:cubicBezTo>
                      <a:pt x="264252" y="5897"/>
                      <a:pt x="256388" y="7519"/>
                      <a:pt x="248421" y="7928"/>
                    </a:cubicBezTo>
                    <a:cubicBezTo>
                      <a:pt x="204581" y="10176"/>
                      <a:pt x="86790" y="12443"/>
                      <a:pt x="52855" y="13214"/>
                    </a:cubicBezTo>
                    <a:cubicBezTo>
                      <a:pt x="14119" y="16441"/>
                      <a:pt x="31750" y="15856"/>
                      <a:pt x="0" y="15856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7812212" y="741647"/>
              <a:ext cx="83796" cy="1894327"/>
              <a:chOff x="7812212" y="741647"/>
              <a:chExt cx="83796" cy="1894327"/>
            </a:xfrm>
          </p:grpSpPr>
          <p:sp>
            <p:nvSpPr>
              <p:cNvPr id="35" name="Freeform 34"/>
              <p:cNvSpPr/>
              <p:nvPr/>
            </p:nvSpPr>
            <p:spPr>
              <a:xfrm>
                <a:off x="7854303" y="741647"/>
                <a:ext cx="41705" cy="440818"/>
              </a:xfrm>
              <a:custGeom>
                <a:avLst/>
                <a:gdLst>
                  <a:gd name="connsiteX0" fmla="*/ 23834 w 41705"/>
                  <a:gd name="connsiteY0" fmla="*/ 0 h 440818"/>
                  <a:gd name="connsiteX1" fmla="*/ 26812 w 41705"/>
                  <a:gd name="connsiteY1" fmla="*/ 65527 h 440818"/>
                  <a:gd name="connsiteX2" fmla="*/ 29791 w 41705"/>
                  <a:gd name="connsiteY2" fmla="*/ 80419 h 440818"/>
                  <a:gd name="connsiteX3" fmla="*/ 32769 w 41705"/>
                  <a:gd name="connsiteY3" fmla="*/ 98290 h 440818"/>
                  <a:gd name="connsiteX4" fmla="*/ 35748 w 41705"/>
                  <a:gd name="connsiteY4" fmla="*/ 134032 h 440818"/>
                  <a:gd name="connsiteX5" fmla="*/ 38726 w 41705"/>
                  <a:gd name="connsiteY5" fmla="*/ 142968 h 440818"/>
                  <a:gd name="connsiteX6" fmla="*/ 41705 w 41705"/>
                  <a:gd name="connsiteY6" fmla="*/ 160839 h 440818"/>
                  <a:gd name="connsiteX7" fmla="*/ 32769 w 41705"/>
                  <a:gd name="connsiteY7" fmla="*/ 220409 h 440818"/>
                  <a:gd name="connsiteX8" fmla="*/ 26812 w 41705"/>
                  <a:gd name="connsiteY8" fmla="*/ 238280 h 440818"/>
                  <a:gd name="connsiteX9" fmla="*/ 23834 w 41705"/>
                  <a:gd name="connsiteY9" fmla="*/ 247216 h 440818"/>
                  <a:gd name="connsiteX10" fmla="*/ 26812 w 41705"/>
                  <a:gd name="connsiteY10" fmla="*/ 288915 h 440818"/>
                  <a:gd name="connsiteX11" fmla="*/ 32769 w 41705"/>
                  <a:gd name="connsiteY11" fmla="*/ 297850 h 440818"/>
                  <a:gd name="connsiteX12" fmla="*/ 23834 w 41705"/>
                  <a:gd name="connsiteY12" fmla="*/ 342528 h 440818"/>
                  <a:gd name="connsiteX13" fmla="*/ 17877 w 41705"/>
                  <a:gd name="connsiteY13" fmla="*/ 351463 h 440818"/>
                  <a:gd name="connsiteX14" fmla="*/ 11920 w 41705"/>
                  <a:gd name="connsiteY14" fmla="*/ 369334 h 440818"/>
                  <a:gd name="connsiteX15" fmla="*/ 5963 w 41705"/>
                  <a:gd name="connsiteY15" fmla="*/ 387205 h 440818"/>
                  <a:gd name="connsiteX16" fmla="*/ 2984 w 41705"/>
                  <a:gd name="connsiteY16" fmla="*/ 402098 h 440818"/>
                  <a:gd name="connsiteX17" fmla="*/ 6 w 41705"/>
                  <a:gd name="connsiteY17" fmla="*/ 440818 h 4408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1705" h="440818">
                    <a:moveTo>
                      <a:pt x="23834" y="0"/>
                    </a:moveTo>
                    <a:cubicBezTo>
                      <a:pt x="24827" y="21842"/>
                      <a:pt x="25197" y="43722"/>
                      <a:pt x="26812" y="65527"/>
                    </a:cubicBezTo>
                    <a:cubicBezTo>
                      <a:pt x="27186" y="70576"/>
                      <a:pt x="28885" y="75438"/>
                      <a:pt x="29791" y="80419"/>
                    </a:cubicBezTo>
                    <a:cubicBezTo>
                      <a:pt x="30871" y="86361"/>
                      <a:pt x="32102" y="92288"/>
                      <a:pt x="32769" y="98290"/>
                    </a:cubicBezTo>
                    <a:cubicBezTo>
                      <a:pt x="34089" y="110172"/>
                      <a:pt x="34168" y="122182"/>
                      <a:pt x="35748" y="134032"/>
                    </a:cubicBezTo>
                    <a:cubicBezTo>
                      <a:pt x="36163" y="137144"/>
                      <a:pt x="38045" y="139903"/>
                      <a:pt x="38726" y="142968"/>
                    </a:cubicBezTo>
                    <a:cubicBezTo>
                      <a:pt x="40036" y="148863"/>
                      <a:pt x="40712" y="154882"/>
                      <a:pt x="41705" y="160839"/>
                    </a:cubicBezTo>
                    <a:cubicBezTo>
                      <a:pt x="38278" y="208808"/>
                      <a:pt x="43133" y="189315"/>
                      <a:pt x="32769" y="220409"/>
                    </a:cubicBezTo>
                    <a:lnTo>
                      <a:pt x="26812" y="238280"/>
                    </a:lnTo>
                    <a:lnTo>
                      <a:pt x="23834" y="247216"/>
                    </a:lnTo>
                    <a:cubicBezTo>
                      <a:pt x="24827" y="261116"/>
                      <a:pt x="24390" y="275192"/>
                      <a:pt x="26812" y="288915"/>
                    </a:cubicBezTo>
                    <a:cubicBezTo>
                      <a:pt x="27434" y="292440"/>
                      <a:pt x="32472" y="294283"/>
                      <a:pt x="32769" y="297850"/>
                    </a:cubicBezTo>
                    <a:cubicBezTo>
                      <a:pt x="33409" y="305530"/>
                      <a:pt x="29623" y="333845"/>
                      <a:pt x="23834" y="342528"/>
                    </a:cubicBezTo>
                    <a:cubicBezTo>
                      <a:pt x="21848" y="345506"/>
                      <a:pt x="19331" y="348192"/>
                      <a:pt x="17877" y="351463"/>
                    </a:cubicBezTo>
                    <a:cubicBezTo>
                      <a:pt x="15327" y="357201"/>
                      <a:pt x="13906" y="363377"/>
                      <a:pt x="11920" y="369334"/>
                    </a:cubicBezTo>
                    <a:lnTo>
                      <a:pt x="5963" y="387205"/>
                    </a:lnTo>
                    <a:lnTo>
                      <a:pt x="2984" y="402098"/>
                    </a:lnTo>
                    <a:cubicBezTo>
                      <a:pt x="-290" y="434847"/>
                      <a:pt x="6" y="421905"/>
                      <a:pt x="6" y="440818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Freeform 35"/>
              <p:cNvSpPr/>
              <p:nvPr/>
            </p:nvSpPr>
            <p:spPr>
              <a:xfrm>
                <a:off x="7848352" y="1179487"/>
                <a:ext cx="20849" cy="679098"/>
              </a:xfrm>
              <a:custGeom>
                <a:avLst/>
                <a:gdLst>
                  <a:gd name="connsiteX0" fmla="*/ 2978 w 20849"/>
                  <a:gd name="connsiteY0" fmla="*/ 0 h 679098"/>
                  <a:gd name="connsiteX1" fmla="*/ 5957 w 20849"/>
                  <a:gd name="connsiteY1" fmla="*/ 26806 h 679098"/>
                  <a:gd name="connsiteX2" fmla="*/ 11914 w 20849"/>
                  <a:gd name="connsiteY2" fmla="*/ 157860 h 679098"/>
                  <a:gd name="connsiteX3" fmla="*/ 14892 w 20849"/>
                  <a:gd name="connsiteY3" fmla="*/ 175731 h 679098"/>
                  <a:gd name="connsiteX4" fmla="*/ 17871 w 20849"/>
                  <a:gd name="connsiteY4" fmla="*/ 220409 h 679098"/>
                  <a:gd name="connsiteX5" fmla="*/ 20849 w 20849"/>
                  <a:gd name="connsiteY5" fmla="*/ 235301 h 679098"/>
                  <a:gd name="connsiteX6" fmla="*/ 17871 w 20849"/>
                  <a:gd name="connsiteY6" fmla="*/ 306785 h 679098"/>
                  <a:gd name="connsiteX7" fmla="*/ 11914 w 20849"/>
                  <a:gd name="connsiteY7" fmla="*/ 378269 h 679098"/>
                  <a:gd name="connsiteX8" fmla="*/ 5957 w 20849"/>
                  <a:gd name="connsiteY8" fmla="*/ 446775 h 679098"/>
                  <a:gd name="connsiteX9" fmla="*/ 0 w 20849"/>
                  <a:gd name="connsiteY9" fmla="*/ 539108 h 679098"/>
                  <a:gd name="connsiteX10" fmla="*/ 2978 w 20849"/>
                  <a:gd name="connsiteY10" fmla="*/ 625485 h 679098"/>
                  <a:gd name="connsiteX11" fmla="*/ 5957 w 20849"/>
                  <a:gd name="connsiteY11" fmla="*/ 643356 h 679098"/>
                  <a:gd name="connsiteX12" fmla="*/ 8935 w 20849"/>
                  <a:gd name="connsiteY12" fmla="*/ 679098 h 6790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20849" h="679098">
                    <a:moveTo>
                      <a:pt x="2978" y="0"/>
                    </a:moveTo>
                    <a:cubicBezTo>
                      <a:pt x="3971" y="8935"/>
                      <a:pt x="5472" y="17829"/>
                      <a:pt x="5957" y="26806"/>
                    </a:cubicBezTo>
                    <a:cubicBezTo>
                      <a:pt x="8507" y="73976"/>
                      <a:pt x="7770" y="112271"/>
                      <a:pt x="11914" y="157860"/>
                    </a:cubicBezTo>
                    <a:cubicBezTo>
                      <a:pt x="12461" y="163874"/>
                      <a:pt x="13899" y="169774"/>
                      <a:pt x="14892" y="175731"/>
                    </a:cubicBezTo>
                    <a:cubicBezTo>
                      <a:pt x="15885" y="190624"/>
                      <a:pt x="16386" y="205557"/>
                      <a:pt x="17871" y="220409"/>
                    </a:cubicBezTo>
                    <a:cubicBezTo>
                      <a:pt x="18375" y="225446"/>
                      <a:pt x="20849" y="230239"/>
                      <a:pt x="20849" y="235301"/>
                    </a:cubicBezTo>
                    <a:cubicBezTo>
                      <a:pt x="20849" y="259150"/>
                      <a:pt x="18930" y="282960"/>
                      <a:pt x="17871" y="306785"/>
                    </a:cubicBezTo>
                    <a:cubicBezTo>
                      <a:pt x="14984" y="371746"/>
                      <a:pt x="21456" y="349640"/>
                      <a:pt x="11914" y="378269"/>
                    </a:cubicBezTo>
                    <a:cubicBezTo>
                      <a:pt x="7222" y="411111"/>
                      <a:pt x="8154" y="400645"/>
                      <a:pt x="5957" y="446775"/>
                    </a:cubicBezTo>
                    <a:cubicBezTo>
                      <a:pt x="1792" y="534230"/>
                      <a:pt x="8238" y="497914"/>
                      <a:pt x="0" y="539108"/>
                    </a:cubicBezTo>
                    <a:cubicBezTo>
                      <a:pt x="993" y="567900"/>
                      <a:pt x="1334" y="596722"/>
                      <a:pt x="2978" y="625485"/>
                    </a:cubicBezTo>
                    <a:cubicBezTo>
                      <a:pt x="3323" y="631514"/>
                      <a:pt x="5208" y="637363"/>
                      <a:pt x="5957" y="643356"/>
                    </a:cubicBezTo>
                    <a:cubicBezTo>
                      <a:pt x="9133" y="668760"/>
                      <a:pt x="8935" y="664428"/>
                      <a:pt x="8935" y="679098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Freeform 36"/>
              <p:cNvSpPr/>
              <p:nvPr/>
            </p:nvSpPr>
            <p:spPr>
              <a:xfrm>
                <a:off x="7812212" y="1852628"/>
                <a:ext cx="54011" cy="783346"/>
              </a:xfrm>
              <a:custGeom>
                <a:avLst/>
                <a:gdLst>
                  <a:gd name="connsiteX0" fmla="*/ 45075 w 54011"/>
                  <a:gd name="connsiteY0" fmla="*/ 0 h 783346"/>
                  <a:gd name="connsiteX1" fmla="*/ 48054 w 54011"/>
                  <a:gd name="connsiteY1" fmla="*/ 14893 h 783346"/>
                  <a:gd name="connsiteX2" fmla="*/ 51032 w 54011"/>
                  <a:gd name="connsiteY2" fmla="*/ 23828 h 783346"/>
                  <a:gd name="connsiteX3" fmla="*/ 54011 w 54011"/>
                  <a:gd name="connsiteY3" fmla="*/ 41699 h 783346"/>
                  <a:gd name="connsiteX4" fmla="*/ 51032 w 54011"/>
                  <a:gd name="connsiteY4" fmla="*/ 113183 h 783346"/>
                  <a:gd name="connsiteX5" fmla="*/ 45075 w 54011"/>
                  <a:gd name="connsiteY5" fmla="*/ 137011 h 783346"/>
                  <a:gd name="connsiteX6" fmla="*/ 36140 w 54011"/>
                  <a:gd name="connsiteY6" fmla="*/ 181689 h 783346"/>
                  <a:gd name="connsiteX7" fmla="*/ 33161 w 54011"/>
                  <a:gd name="connsiteY7" fmla="*/ 196581 h 783346"/>
                  <a:gd name="connsiteX8" fmla="*/ 24226 w 54011"/>
                  <a:gd name="connsiteY8" fmla="*/ 428904 h 783346"/>
                  <a:gd name="connsiteX9" fmla="*/ 18269 w 54011"/>
                  <a:gd name="connsiteY9" fmla="*/ 592722 h 783346"/>
                  <a:gd name="connsiteX10" fmla="*/ 15290 w 54011"/>
                  <a:gd name="connsiteY10" fmla="*/ 607614 h 783346"/>
                  <a:gd name="connsiteX11" fmla="*/ 9333 w 54011"/>
                  <a:gd name="connsiteY11" fmla="*/ 643356 h 783346"/>
                  <a:gd name="connsiteX12" fmla="*/ 3376 w 54011"/>
                  <a:gd name="connsiteY12" fmla="*/ 685055 h 783346"/>
                  <a:gd name="connsiteX13" fmla="*/ 3376 w 54011"/>
                  <a:gd name="connsiteY13" fmla="*/ 756539 h 783346"/>
                  <a:gd name="connsiteX14" fmla="*/ 9333 w 54011"/>
                  <a:gd name="connsiteY14" fmla="*/ 774410 h 783346"/>
                  <a:gd name="connsiteX15" fmla="*/ 12312 w 54011"/>
                  <a:gd name="connsiteY15" fmla="*/ 783346 h 7833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54011" h="783346">
                    <a:moveTo>
                      <a:pt x="45075" y="0"/>
                    </a:moveTo>
                    <a:cubicBezTo>
                      <a:pt x="46068" y="4964"/>
                      <a:pt x="46826" y="9981"/>
                      <a:pt x="48054" y="14893"/>
                    </a:cubicBezTo>
                    <a:cubicBezTo>
                      <a:pt x="48815" y="17939"/>
                      <a:pt x="50351" y="20763"/>
                      <a:pt x="51032" y="23828"/>
                    </a:cubicBezTo>
                    <a:cubicBezTo>
                      <a:pt x="52342" y="29723"/>
                      <a:pt x="53018" y="35742"/>
                      <a:pt x="54011" y="41699"/>
                    </a:cubicBezTo>
                    <a:cubicBezTo>
                      <a:pt x="53018" y="65527"/>
                      <a:pt x="52673" y="89391"/>
                      <a:pt x="51032" y="113183"/>
                    </a:cubicBezTo>
                    <a:cubicBezTo>
                      <a:pt x="49827" y="130655"/>
                      <a:pt x="48174" y="123583"/>
                      <a:pt x="45075" y="137011"/>
                    </a:cubicBezTo>
                    <a:cubicBezTo>
                      <a:pt x="45060" y="137076"/>
                      <a:pt x="37636" y="174210"/>
                      <a:pt x="36140" y="181689"/>
                    </a:cubicBezTo>
                    <a:lnTo>
                      <a:pt x="33161" y="196581"/>
                    </a:lnTo>
                    <a:cubicBezTo>
                      <a:pt x="31942" y="283115"/>
                      <a:pt x="49197" y="353983"/>
                      <a:pt x="24226" y="428904"/>
                    </a:cubicBezTo>
                    <a:cubicBezTo>
                      <a:pt x="23756" y="442997"/>
                      <a:pt x="19656" y="571910"/>
                      <a:pt x="18269" y="592722"/>
                    </a:cubicBezTo>
                    <a:cubicBezTo>
                      <a:pt x="17932" y="597773"/>
                      <a:pt x="16170" y="602629"/>
                      <a:pt x="15290" y="607614"/>
                    </a:cubicBezTo>
                    <a:cubicBezTo>
                      <a:pt x="13191" y="619509"/>
                      <a:pt x="10426" y="631327"/>
                      <a:pt x="9333" y="643356"/>
                    </a:cubicBezTo>
                    <a:cubicBezTo>
                      <a:pt x="6071" y="679247"/>
                      <a:pt x="9824" y="665717"/>
                      <a:pt x="3376" y="685055"/>
                    </a:cubicBezTo>
                    <a:cubicBezTo>
                      <a:pt x="-173" y="717000"/>
                      <a:pt x="-1988" y="718988"/>
                      <a:pt x="3376" y="756539"/>
                    </a:cubicBezTo>
                    <a:cubicBezTo>
                      <a:pt x="4264" y="762755"/>
                      <a:pt x="7347" y="768453"/>
                      <a:pt x="9333" y="774410"/>
                    </a:cubicBezTo>
                    <a:lnTo>
                      <a:pt x="12312" y="783346"/>
                    </a:ln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94" name="Group 93"/>
          <p:cNvGrpSpPr/>
          <p:nvPr/>
        </p:nvGrpSpPr>
        <p:grpSpPr>
          <a:xfrm>
            <a:off x="3304776" y="1143000"/>
            <a:ext cx="2560320" cy="3657600"/>
            <a:chOff x="3304776" y="1600200"/>
            <a:chExt cx="2560320" cy="3657600"/>
          </a:xfrm>
        </p:grpSpPr>
        <p:grpSp>
          <p:nvGrpSpPr>
            <p:cNvPr id="44" name="Group 43"/>
            <p:cNvGrpSpPr/>
            <p:nvPr/>
          </p:nvGrpSpPr>
          <p:grpSpPr>
            <a:xfrm>
              <a:off x="3304776" y="1600200"/>
              <a:ext cx="2560320" cy="3657600"/>
              <a:chOff x="457201" y="394255"/>
              <a:chExt cx="1828800" cy="2651760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1352550" y="1028700"/>
                <a:ext cx="33338" cy="1347788"/>
                <a:chOff x="1352550" y="1028700"/>
                <a:chExt cx="33338" cy="1347788"/>
              </a:xfrm>
            </p:grpSpPr>
            <p:grpSp>
              <p:nvGrpSpPr>
                <p:cNvPr id="64" name="Group 63"/>
                <p:cNvGrpSpPr/>
                <p:nvPr/>
              </p:nvGrpSpPr>
              <p:grpSpPr>
                <a:xfrm>
                  <a:off x="1352550" y="1028700"/>
                  <a:ext cx="33338" cy="1347788"/>
                  <a:chOff x="1352550" y="1028700"/>
                  <a:chExt cx="33338" cy="1347788"/>
                </a:xfrm>
              </p:grpSpPr>
              <p:sp>
                <p:nvSpPr>
                  <p:cNvPr id="66" name="Freeform 65"/>
                  <p:cNvSpPr/>
                  <p:nvPr/>
                </p:nvSpPr>
                <p:spPr>
                  <a:xfrm>
                    <a:off x="1352550" y="1028700"/>
                    <a:ext cx="33338" cy="1133475"/>
                  </a:xfrm>
                  <a:custGeom>
                    <a:avLst/>
                    <a:gdLst>
                      <a:gd name="connsiteX0" fmla="*/ 23813 w 33338"/>
                      <a:gd name="connsiteY0" fmla="*/ 0 h 1133475"/>
                      <a:gd name="connsiteX1" fmla="*/ 28575 w 33338"/>
                      <a:gd name="connsiteY1" fmla="*/ 71438 h 1133475"/>
                      <a:gd name="connsiteX2" fmla="*/ 33338 w 33338"/>
                      <a:gd name="connsiteY2" fmla="*/ 85725 h 1133475"/>
                      <a:gd name="connsiteX3" fmla="*/ 23813 w 33338"/>
                      <a:gd name="connsiteY3" fmla="*/ 152400 h 1133475"/>
                      <a:gd name="connsiteX4" fmla="*/ 28575 w 33338"/>
                      <a:gd name="connsiteY4" fmla="*/ 338138 h 1133475"/>
                      <a:gd name="connsiteX5" fmla="*/ 19050 w 33338"/>
                      <a:gd name="connsiteY5" fmla="*/ 409575 h 1133475"/>
                      <a:gd name="connsiteX6" fmla="*/ 14288 w 33338"/>
                      <a:gd name="connsiteY6" fmla="*/ 423863 h 1133475"/>
                      <a:gd name="connsiteX7" fmla="*/ 9525 w 33338"/>
                      <a:gd name="connsiteY7" fmla="*/ 471488 h 1133475"/>
                      <a:gd name="connsiteX8" fmla="*/ 4763 w 33338"/>
                      <a:gd name="connsiteY8" fmla="*/ 490538 h 1133475"/>
                      <a:gd name="connsiteX9" fmla="*/ 14288 w 33338"/>
                      <a:gd name="connsiteY9" fmla="*/ 566738 h 1133475"/>
                      <a:gd name="connsiteX10" fmla="*/ 9525 w 33338"/>
                      <a:gd name="connsiteY10" fmla="*/ 757238 h 1133475"/>
                      <a:gd name="connsiteX11" fmla="*/ 4763 w 33338"/>
                      <a:gd name="connsiteY11" fmla="*/ 771525 h 1133475"/>
                      <a:gd name="connsiteX12" fmla="*/ 0 w 33338"/>
                      <a:gd name="connsiteY12" fmla="*/ 838200 h 1133475"/>
                      <a:gd name="connsiteX13" fmla="*/ 4763 w 33338"/>
                      <a:gd name="connsiteY13" fmla="*/ 1009650 h 1133475"/>
                      <a:gd name="connsiteX14" fmla="*/ 9525 w 33338"/>
                      <a:gd name="connsiteY14" fmla="*/ 1023938 h 1133475"/>
                      <a:gd name="connsiteX15" fmla="*/ 4763 w 33338"/>
                      <a:gd name="connsiteY15" fmla="*/ 1104900 h 1133475"/>
                      <a:gd name="connsiteX16" fmla="*/ 4763 w 33338"/>
                      <a:gd name="connsiteY16" fmla="*/ 1133475 h 113347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</a:cxnLst>
                    <a:rect l="l" t="t" r="r" b="b"/>
                    <a:pathLst>
                      <a:path w="33338" h="1133475">
                        <a:moveTo>
                          <a:pt x="23813" y="0"/>
                        </a:moveTo>
                        <a:cubicBezTo>
                          <a:pt x="25400" y="23813"/>
                          <a:pt x="25939" y="47718"/>
                          <a:pt x="28575" y="71438"/>
                        </a:cubicBezTo>
                        <a:cubicBezTo>
                          <a:pt x="29129" y="76427"/>
                          <a:pt x="33338" y="80705"/>
                          <a:pt x="33338" y="85725"/>
                        </a:cubicBezTo>
                        <a:cubicBezTo>
                          <a:pt x="33338" y="127459"/>
                          <a:pt x="32626" y="125959"/>
                          <a:pt x="23813" y="152400"/>
                        </a:cubicBezTo>
                        <a:cubicBezTo>
                          <a:pt x="25400" y="214313"/>
                          <a:pt x="28575" y="276205"/>
                          <a:pt x="28575" y="338138"/>
                        </a:cubicBezTo>
                        <a:cubicBezTo>
                          <a:pt x="28575" y="356002"/>
                          <a:pt x="24118" y="389305"/>
                          <a:pt x="19050" y="409575"/>
                        </a:cubicBezTo>
                        <a:cubicBezTo>
                          <a:pt x="17832" y="414445"/>
                          <a:pt x="15875" y="419100"/>
                          <a:pt x="14288" y="423863"/>
                        </a:cubicBezTo>
                        <a:cubicBezTo>
                          <a:pt x="12700" y="439738"/>
                          <a:pt x="11781" y="455694"/>
                          <a:pt x="9525" y="471488"/>
                        </a:cubicBezTo>
                        <a:cubicBezTo>
                          <a:pt x="8599" y="477968"/>
                          <a:pt x="4763" y="483993"/>
                          <a:pt x="4763" y="490538"/>
                        </a:cubicBezTo>
                        <a:cubicBezTo>
                          <a:pt x="4763" y="532991"/>
                          <a:pt x="6705" y="536409"/>
                          <a:pt x="14288" y="566738"/>
                        </a:cubicBezTo>
                        <a:cubicBezTo>
                          <a:pt x="12700" y="630238"/>
                          <a:pt x="12476" y="693787"/>
                          <a:pt x="9525" y="757238"/>
                        </a:cubicBezTo>
                        <a:cubicBezTo>
                          <a:pt x="9292" y="762252"/>
                          <a:pt x="5350" y="766539"/>
                          <a:pt x="4763" y="771525"/>
                        </a:cubicBezTo>
                        <a:cubicBezTo>
                          <a:pt x="2160" y="793654"/>
                          <a:pt x="1588" y="815975"/>
                          <a:pt x="0" y="838200"/>
                        </a:cubicBezTo>
                        <a:cubicBezTo>
                          <a:pt x="1588" y="895350"/>
                          <a:pt x="1835" y="952553"/>
                          <a:pt x="4763" y="1009650"/>
                        </a:cubicBezTo>
                        <a:cubicBezTo>
                          <a:pt x="5020" y="1014664"/>
                          <a:pt x="9525" y="1018918"/>
                          <a:pt x="9525" y="1023938"/>
                        </a:cubicBezTo>
                        <a:cubicBezTo>
                          <a:pt x="9525" y="1050972"/>
                          <a:pt x="5937" y="1077892"/>
                          <a:pt x="4763" y="1104900"/>
                        </a:cubicBezTo>
                        <a:cubicBezTo>
                          <a:pt x="4349" y="1114416"/>
                          <a:pt x="4763" y="1123950"/>
                          <a:pt x="4763" y="1133475"/>
                        </a:cubicBezTo>
                      </a:path>
                    </a:pathLst>
                  </a:custGeom>
                  <a:noFill/>
                  <a:ln>
                    <a:solidFill>
                      <a:schemeClr val="accent5">
                        <a:lumMod val="60000"/>
                        <a:lumOff val="4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7" name="Freeform 66"/>
                  <p:cNvSpPr/>
                  <p:nvPr/>
                </p:nvSpPr>
                <p:spPr>
                  <a:xfrm>
                    <a:off x="1362075" y="2214563"/>
                    <a:ext cx="4763" cy="161925"/>
                  </a:xfrm>
                  <a:custGeom>
                    <a:avLst/>
                    <a:gdLst>
                      <a:gd name="connsiteX0" fmla="*/ 0 w 4763"/>
                      <a:gd name="connsiteY0" fmla="*/ 0 h 161925"/>
                      <a:gd name="connsiteX1" fmla="*/ 4763 w 4763"/>
                      <a:gd name="connsiteY1" fmla="*/ 161925 h 1619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763" h="161925">
                        <a:moveTo>
                          <a:pt x="0" y="0"/>
                        </a:moveTo>
                        <a:lnTo>
                          <a:pt x="4763" y="161925"/>
                        </a:lnTo>
                      </a:path>
                    </a:pathLst>
                  </a:custGeom>
                  <a:noFill/>
                  <a:ln>
                    <a:solidFill>
                      <a:schemeClr val="accent5">
                        <a:lumMod val="60000"/>
                        <a:lumOff val="4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65" name="Freeform 64"/>
                <p:cNvSpPr/>
                <p:nvPr/>
              </p:nvSpPr>
              <p:spPr>
                <a:xfrm>
                  <a:off x="1357313" y="2147888"/>
                  <a:ext cx="14287" cy="85725"/>
                </a:xfrm>
                <a:custGeom>
                  <a:avLst/>
                  <a:gdLst>
                    <a:gd name="connsiteX0" fmla="*/ 0 w 14287"/>
                    <a:gd name="connsiteY0" fmla="*/ 0 h 85725"/>
                    <a:gd name="connsiteX1" fmla="*/ 4762 w 14287"/>
                    <a:gd name="connsiteY1" fmla="*/ 33337 h 85725"/>
                    <a:gd name="connsiteX2" fmla="*/ 14287 w 14287"/>
                    <a:gd name="connsiteY2" fmla="*/ 61912 h 85725"/>
                    <a:gd name="connsiteX3" fmla="*/ 4762 w 14287"/>
                    <a:gd name="connsiteY3" fmla="*/ 85725 h 857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4287" h="85725">
                      <a:moveTo>
                        <a:pt x="0" y="0"/>
                      </a:moveTo>
                      <a:cubicBezTo>
                        <a:pt x="1587" y="11112"/>
                        <a:pt x="2238" y="22399"/>
                        <a:pt x="4762" y="33337"/>
                      </a:cubicBezTo>
                      <a:cubicBezTo>
                        <a:pt x="7020" y="43120"/>
                        <a:pt x="14287" y="61912"/>
                        <a:pt x="14287" y="61912"/>
                      </a:cubicBezTo>
                      <a:cubicBezTo>
                        <a:pt x="8403" y="79568"/>
                        <a:pt x="11770" y="71710"/>
                        <a:pt x="4762" y="85725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46" name="Picture 4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7201" y="394255"/>
                <a:ext cx="1828800" cy="2651760"/>
              </a:xfrm>
              <a:prstGeom prst="rect">
                <a:avLst/>
              </a:prstGeom>
            </p:spPr>
          </p:pic>
          <p:grpSp>
            <p:nvGrpSpPr>
              <p:cNvPr id="47" name="Group 46"/>
              <p:cNvGrpSpPr/>
              <p:nvPr/>
            </p:nvGrpSpPr>
            <p:grpSpPr>
              <a:xfrm>
                <a:off x="1076431" y="1304088"/>
                <a:ext cx="650261" cy="641033"/>
                <a:chOff x="3205309" y="2838734"/>
                <a:chExt cx="1141503" cy="1112293"/>
              </a:xfrm>
            </p:grpSpPr>
            <p:sp>
              <p:nvSpPr>
                <p:cNvPr id="62" name="Freeform 61"/>
                <p:cNvSpPr/>
                <p:nvPr/>
              </p:nvSpPr>
              <p:spPr>
                <a:xfrm>
                  <a:off x="3205309" y="2838734"/>
                  <a:ext cx="476295" cy="1072041"/>
                </a:xfrm>
                <a:custGeom>
                  <a:avLst/>
                  <a:gdLst>
                    <a:gd name="connsiteX0" fmla="*/ 97449 w 476295"/>
                    <a:gd name="connsiteY0" fmla="*/ 1071350 h 1072041"/>
                    <a:gd name="connsiteX1" fmla="*/ 90625 w 476295"/>
                    <a:gd name="connsiteY1" fmla="*/ 1037230 h 1072041"/>
                    <a:gd name="connsiteX2" fmla="*/ 76978 w 476295"/>
                    <a:gd name="connsiteY2" fmla="*/ 996287 h 1072041"/>
                    <a:gd name="connsiteX3" fmla="*/ 70154 w 476295"/>
                    <a:gd name="connsiteY3" fmla="*/ 975815 h 1072041"/>
                    <a:gd name="connsiteX4" fmla="*/ 63330 w 476295"/>
                    <a:gd name="connsiteY4" fmla="*/ 948520 h 1072041"/>
                    <a:gd name="connsiteX5" fmla="*/ 49682 w 476295"/>
                    <a:gd name="connsiteY5" fmla="*/ 907576 h 1072041"/>
                    <a:gd name="connsiteX6" fmla="*/ 42858 w 476295"/>
                    <a:gd name="connsiteY6" fmla="*/ 887105 h 1072041"/>
                    <a:gd name="connsiteX7" fmla="*/ 29210 w 476295"/>
                    <a:gd name="connsiteY7" fmla="*/ 825690 h 1072041"/>
                    <a:gd name="connsiteX8" fmla="*/ 22387 w 476295"/>
                    <a:gd name="connsiteY8" fmla="*/ 798394 h 1072041"/>
                    <a:gd name="connsiteX9" fmla="*/ 8739 w 476295"/>
                    <a:gd name="connsiteY9" fmla="*/ 736979 h 1072041"/>
                    <a:gd name="connsiteX10" fmla="*/ 8739 w 476295"/>
                    <a:gd name="connsiteY10" fmla="*/ 450376 h 1072041"/>
                    <a:gd name="connsiteX11" fmla="*/ 15563 w 476295"/>
                    <a:gd name="connsiteY11" fmla="*/ 429905 h 1072041"/>
                    <a:gd name="connsiteX12" fmla="*/ 22387 w 476295"/>
                    <a:gd name="connsiteY12" fmla="*/ 402609 h 1072041"/>
                    <a:gd name="connsiteX13" fmla="*/ 29210 w 476295"/>
                    <a:gd name="connsiteY13" fmla="*/ 382138 h 1072041"/>
                    <a:gd name="connsiteX14" fmla="*/ 36034 w 476295"/>
                    <a:gd name="connsiteY14" fmla="*/ 341194 h 1072041"/>
                    <a:gd name="connsiteX15" fmla="*/ 49682 w 476295"/>
                    <a:gd name="connsiteY15" fmla="*/ 300251 h 1072041"/>
                    <a:gd name="connsiteX16" fmla="*/ 63330 w 476295"/>
                    <a:gd name="connsiteY16" fmla="*/ 259308 h 1072041"/>
                    <a:gd name="connsiteX17" fmla="*/ 83801 w 476295"/>
                    <a:gd name="connsiteY17" fmla="*/ 197893 h 1072041"/>
                    <a:gd name="connsiteX18" fmla="*/ 97449 w 476295"/>
                    <a:gd name="connsiteY18" fmla="*/ 156950 h 1072041"/>
                    <a:gd name="connsiteX19" fmla="*/ 124745 w 476295"/>
                    <a:gd name="connsiteY19" fmla="*/ 95535 h 1072041"/>
                    <a:gd name="connsiteX20" fmla="*/ 131569 w 476295"/>
                    <a:gd name="connsiteY20" fmla="*/ 75063 h 1072041"/>
                    <a:gd name="connsiteX21" fmla="*/ 158864 w 476295"/>
                    <a:gd name="connsiteY21" fmla="*/ 34120 h 1072041"/>
                    <a:gd name="connsiteX22" fmla="*/ 165688 w 476295"/>
                    <a:gd name="connsiteY22" fmla="*/ 13648 h 1072041"/>
                    <a:gd name="connsiteX23" fmla="*/ 206631 w 476295"/>
                    <a:gd name="connsiteY23" fmla="*/ 0 h 1072041"/>
                    <a:gd name="connsiteX24" fmla="*/ 261222 w 476295"/>
                    <a:gd name="connsiteY24" fmla="*/ 13648 h 1072041"/>
                    <a:gd name="connsiteX25" fmla="*/ 274870 w 476295"/>
                    <a:gd name="connsiteY25" fmla="*/ 34120 h 1072041"/>
                    <a:gd name="connsiteX26" fmla="*/ 315813 w 476295"/>
                    <a:gd name="connsiteY26" fmla="*/ 61415 h 1072041"/>
                    <a:gd name="connsiteX27" fmla="*/ 329461 w 476295"/>
                    <a:gd name="connsiteY27" fmla="*/ 81887 h 1072041"/>
                    <a:gd name="connsiteX28" fmla="*/ 349933 w 476295"/>
                    <a:gd name="connsiteY28" fmla="*/ 95535 h 1072041"/>
                    <a:gd name="connsiteX29" fmla="*/ 377228 w 476295"/>
                    <a:gd name="connsiteY29" fmla="*/ 129654 h 1072041"/>
                    <a:gd name="connsiteX30" fmla="*/ 384052 w 476295"/>
                    <a:gd name="connsiteY30" fmla="*/ 150126 h 1072041"/>
                    <a:gd name="connsiteX31" fmla="*/ 397700 w 476295"/>
                    <a:gd name="connsiteY31" fmla="*/ 170597 h 1072041"/>
                    <a:gd name="connsiteX32" fmla="*/ 411348 w 476295"/>
                    <a:gd name="connsiteY32" fmla="*/ 211541 h 1072041"/>
                    <a:gd name="connsiteX33" fmla="*/ 411348 w 476295"/>
                    <a:gd name="connsiteY33" fmla="*/ 368490 h 1072041"/>
                    <a:gd name="connsiteX34" fmla="*/ 397700 w 476295"/>
                    <a:gd name="connsiteY34" fmla="*/ 409433 h 1072041"/>
                    <a:gd name="connsiteX35" fmla="*/ 384052 w 476295"/>
                    <a:gd name="connsiteY35" fmla="*/ 450376 h 1072041"/>
                    <a:gd name="connsiteX36" fmla="*/ 363581 w 476295"/>
                    <a:gd name="connsiteY36" fmla="*/ 511791 h 1072041"/>
                    <a:gd name="connsiteX37" fmla="*/ 356757 w 476295"/>
                    <a:gd name="connsiteY37" fmla="*/ 532263 h 1072041"/>
                    <a:gd name="connsiteX38" fmla="*/ 349933 w 476295"/>
                    <a:gd name="connsiteY38" fmla="*/ 552735 h 1072041"/>
                    <a:gd name="connsiteX39" fmla="*/ 363581 w 476295"/>
                    <a:gd name="connsiteY39" fmla="*/ 600502 h 1072041"/>
                    <a:gd name="connsiteX40" fmla="*/ 384052 w 476295"/>
                    <a:gd name="connsiteY40" fmla="*/ 607326 h 1072041"/>
                    <a:gd name="connsiteX41" fmla="*/ 424995 w 476295"/>
                    <a:gd name="connsiteY41" fmla="*/ 641445 h 1072041"/>
                    <a:gd name="connsiteX42" fmla="*/ 465939 w 476295"/>
                    <a:gd name="connsiteY42" fmla="*/ 668741 h 1072041"/>
                    <a:gd name="connsiteX43" fmla="*/ 465939 w 476295"/>
                    <a:gd name="connsiteY43" fmla="*/ 777923 h 1072041"/>
                    <a:gd name="connsiteX44" fmla="*/ 452291 w 476295"/>
                    <a:gd name="connsiteY44" fmla="*/ 818866 h 1072041"/>
                    <a:gd name="connsiteX45" fmla="*/ 431819 w 476295"/>
                    <a:gd name="connsiteY45" fmla="*/ 832514 h 1072041"/>
                    <a:gd name="connsiteX46" fmla="*/ 418172 w 476295"/>
                    <a:gd name="connsiteY46" fmla="*/ 852985 h 1072041"/>
                    <a:gd name="connsiteX47" fmla="*/ 397700 w 476295"/>
                    <a:gd name="connsiteY47" fmla="*/ 859809 h 1072041"/>
                    <a:gd name="connsiteX48" fmla="*/ 377228 w 476295"/>
                    <a:gd name="connsiteY48" fmla="*/ 873457 h 1072041"/>
                    <a:gd name="connsiteX49" fmla="*/ 356757 w 476295"/>
                    <a:gd name="connsiteY49" fmla="*/ 880281 h 1072041"/>
                    <a:gd name="connsiteX50" fmla="*/ 315813 w 476295"/>
                    <a:gd name="connsiteY50" fmla="*/ 907576 h 1072041"/>
                    <a:gd name="connsiteX51" fmla="*/ 274870 w 476295"/>
                    <a:gd name="connsiteY51" fmla="*/ 928048 h 1072041"/>
                    <a:gd name="connsiteX52" fmla="*/ 261222 w 476295"/>
                    <a:gd name="connsiteY52" fmla="*/ 948520 h 1072041"/>
                    <a:gd name="connsiteX53" fmla="*/ 240751 w 476295"/>
                    <a:gd name="connsiteY53" fmla="*/ 955344 h 1072041"/>
                    <a:gd name="connsiteX54" fmla="*/ 199807 w 476295"/>
                    <a:gd name="connsiteY54" fmla="*/ 975815 h 1072041"/>
                    <a:gd name="connsiteX55" fmla="*/ 192984 w 476295"/>
                    <a:gd name="connsiteY55" fmla="*/ 996287 h 1072041"/>
                    <a:gd name="connsiteX56" fmla="*/ 152040 w 476295"/>
                    <a:gd name="connsiteY56" fmla="*/ 1016759 h 1072041"/>
                    <a:gd name="connsiteX57" fmla="*/ 124745 w 476295"/>
                    <a:gd name="connsiteY57" fmla="*/ 1044054 h 1072041"/>
                    <a:gd name="connsiteX58" fmla="*/ 97449 w 476295"/>
                    <a:gd name="connsiteY58" fmla="*/ 1071350 h 1072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</a:cxnLst>
                  <a:rect l="l" t="t" r="r" b="b"/>
                  <a:pathLst>
                    <a:path w="476295" h="1072041">
                      <a:moveTo>
                        <a:pt x="97449" y="1071350"/>
                      </a:moveTo>
                      <a:cubicBezTo>
                        <a:pt x="91762" y="1070213"/>
                        <a:pt x="93677" y="1048420"/>
                        <a:pt x="90625" y="1037230"/>
                      </a:cubicBezTo>
                      <a:cubicBezTo>
                        <a:pt x="86840" y="1023351"/>
                        <a:pt x="81527" y="1009935"/>
                        <a:pt x="76978" y="996287"/>
                      </a:cubicBezTo>
                      <a:cubicBezTo>
                        <a:pt x="74703" y="989463"/>
                        <a:pt x="71899" y="982793"/>
                        <a:pt x="70154" y="975815"/>
                      </a:cubicBezTo>
                      <a:cubicBezTo>
                        <a:pt x="67879" y="966717"/>
                        <a:pt x="66025" y="957503"/>
                        <a:pt x="63330" y="948520"/>
                      </a:cubicBezTo>
                      <a:cubicBezTo>
                        <a:pt x="59196" y="934740"/>
                        <a:pt x="54231" y="921224"/>
                        <a:pt x="49682" y="907576"/>
                      </a:cubicBezTo>
                      <a:cubicBezTo>
                        <a:pt x="47407" y="900752"/>
                        <a:pt x="44603" y="894083"/>
                        <a:pt x="42858" y="887105"/>
                      </a:cubicBezTo>
                      <a:cubicBezTo>
                        <a:pt x="26225" y="820572"/>
                        <a:pt x="46525" y="903613"/>
                        <a:pt x="29210" y="825690"/>
                      </a:cubicBezTo>
                      <a:cubicBezTo>
                        <a:pt x="27176" y="816535"/>
                        <a:pt x="24226" y="807591"/>
                        <a:pt x="22387" y="798394"/>
                      </a:cubicBezTo>
                      <a:cubicBezTo>
                        <a:pt x="10379" y="738353"/>
                        <a:pt x="22018" y="776817"/>
                        <a:pt x="8739" y="736979"/>
                      </a:cubicBezTo>
                      <a:cubicBezTo>
                        <a:pt x="-3113" y="606608"/>
                        <a:pt x="-2712" y="645041"/>
                        <a:pt x="8739" y="450376"/>
                      </a:cubicBezTo>
                      <a:cubicBezTo>
                        <a:pt x="9161" y="443196"/>
                        <a:pt x="13587" y="436821"/>
                        <a:pt x="15563" y="429905"/>
                      </a:cubicBezTo>
                      <a:cubicBezTo>
                        <a:pt x="18140" y="420887"/>
                        <a:pt x="19811" y="411627"/>
                        <a:pt x="22387" y="402609"/>
                      </a:cubicBezTo>
                      <a:cubicBezTo>
                        <a:pt x="24363" y="395693"/>
                        <a:pt x="27650" y="389159"/>
                        <a:pt x="29210" y="382138"/>
                      </a:cubicBezTo>
                      <a:cubicBezTo>
                        <a:pt x="32211" y="368631"/>
                        <a:pt x="32678" y="354617"/>
                        <a:pt x="36034" y="341194"/>
                      </a:cubicBezTo>
                      <a:cubicBezTo>
                        <a:pt x="39523" y="327238"/>
                        <a:pt x="45133" y="313899"/>
                        <a:pt x="49682" y="300251"/>
                      </a:cubicBezTo>
                      <a:lnTo>
                        <a:pt x="63330" y="259308"/>
                      </a:lnTo>
                      <a:lnTo>
                        <a:pt x="83801" y="197893"/>
                      </a:lnTo>
                      <a:cubicBezTo>
                        <a:pt x="83801" y="197892"/>
                        <a:pt x="97448" y="156951"/>
                        <a:pt x="97449" y="156950"/>
                      </a:cubicBezTo>
                      <a:cubicBezTo>
                        <a:pt x="119077" y="124508"/>
                        <a:pt x="108504" y="144258"/>
                        <a:pt x="124745" y="95535"/>
                      </a:cubicBezTo>
                      <a:cubicBezTo>
                        <a:pt x="127020" y="88711"/>
                        <a:pt x="127579" y="81048"/>
                        <a:pt x="131569" y="75063"/>
                      </a:cubicBezTo>
                      <a:lnTo>
                        <a:pt x="158864" y="34120"/>
                      </a:lnTo>
                      <a:cubicBezTo>
                        <a:pt x="161139" y="27296"/>
                        <a:pt x="159835" y="17829"/>
                        <a:pt x="165688" y="13648"/>
                      </a:cubicBezTo>
                      <a:cubicBezTo>
                        <a:pt x="177394" y="5286"/>
                        <a:pt x="206631" y="0"/>
                        <a:pt x="206631" y="0"/>
                      </a:cubicBezTo>
                      <a:cubicBezTo>
                        <a:pt x="208330" y="340"/>
                        <a:pt x="254227" y="8052"/>
                        <a:pt x="261222" y="13648"/>
                      </a:cubicBezTo>
                      <a:cubicBezTo>
                        <a:pt x="267626" y="18771"/>
                        <a:pt x="268698" y="28719"/>
                        <a:pt x="274870" y="34120"/>
                      </a:cubicBezTo>
                      <a:cubicBezTo>
                        <a:pt x="287214" y="44921"/>
                        <a:pt x="315813" y="61415"/>
                        <a:pt x="315813" y="61415"/>
                      </a:cubicBezTo>
                      <a:cubicBezTo>
                        <a:pt x="320362" y="68239"/>
                        <a:pt x="323662" y="76088"/>
                        <a:pt x="329461" y="81887"/>
                      </a:cubicBezTo>
                      <a:cubicBezTo>
                        <a:pt x="335260" y="87686"/>
                        <a:pt x="344810" y="89131"/>
                        <a:pt x="349933" y="95535"/>
                      </a:cubicBezTo>
                      <a:cubicBezTo>
                        <a:pt x="387605" y="142623"/>
                        <a:pt x="318557" y="90538"/>
                        <a:pt x="377228" y="129654"/>
                      </a:cubicBezTo>
                      <a:cubicBezTo>
                        <a:pt x="379503" y="136478"/>
                        <a:pt x="380835" y="143692"/>
                        <a:pt x="384052" y="150126"/>
                      </a:cubicBezTo>
                      <a:cubicBezTo>
                        <a:pt x="387720" y="157461"/>
                        <a:pt x="394369" y="163103"/>
                        <a:pt x="397700" y="170597"/>
                      </a:cubicBezTo>
                      <a:cubicBezTo>
                        <a:pt x="403543" y="183743"/>
                        <a:pt x="411348" y="211541"/>
                        <a:pt x="411348" y="211541"/>
                      </a:cubicBezTo>
                      <a:cubicBezTo>
                        <a:pt x="417767" y="282150"/>
                        <a:pt x="423403" y="296159"/>
                        <a:pt x="411348" y="368490"/>
                      </a:cubicBezTo>
                      <a:cubicBezTo>
                        <a:pt x="408983" y="382680"/>
                        <a:pt x="402249" y="395785"/>
                        <a:pt x="397700" y="409433"/>
                      </a:cubicBezTo>
                      <a:lnTo>
                        <a:pt x="384052" y="450376"/>
                      </a:lnTo>
                      <a:lnTo>
                        <a:pt x="363581" y="511791"/>
                      </a:lnTo>
                      <a:lnTo>
                        <a:pt x="356757" y="532263"/>
                      </a:lnTo>
                      <a:lnTo>
                        <a:pt x="349933" y="552735"/>
                      </a:lnTo>
                      <a:cubicBezTo>
                        <a:pt x="349992" y="552971"/>
                        <a:pt x="360318" y="597239"/>
                        <a:pt x="363581" y="600502"/>
                      </a:cubicBezTo>
                      <a:cubicBezTo>
                        <a:pt x="368667" y="605588"/>
                        <a:pt x="377619" y="604109"/>
                        <a:pt x="384052" y="607326"/>
                      </a:cubicBezTo>
                      <a:cubicBezTo>
                        <a:pt x="413320" y="621959"/>
                        <a:pt x="397824" y="620312"/>
                        <a:pt x="424995" y="641445"/>
                      </a:cubicBezTo>
                      <a:cubicBezTo>
                        <a:pt x="437943" y="651515"/>
                        <a:pt x="465939" y="668741"/>
                        <a:pt x="465939" y="668741"/>
                      </a:cubicBezTo>
                      <a:cubicBezTo>
                        <a:pt x="480864" y="713515"/>
                        <a:pt x="478583" y="697845"/>
                        <a:pt x="465939" y="777923"/>
                      </a:cubicBezTo>
                      <a:cubicBezTo>
                        <a:pt x="463695" y="792133"/>
                        <a:pt x="464261" y="810886"/>
                        <a:pt x="452291" y="818866"/>
                      </a:cubicBezTo>
                      <a:lnTo>
                        <a:pt x="431819" y="832514"/>
                      </a:lnTo>
                      <a:cubicBezTo>
                        <a:pt x="427270" y="839338"/>
                        <a:pt x="424576" y="847862"/>
                        <a:pt x="418172" y="852985"/>
                      </a:cubicBezTo>
                      <a:cubicBezTo>
                        <a:pt x="412555" y="857478"/>
                        <a:pt x="404134" y="856592"/>
                        <a:pt x="397700" y="859809"/>
                      </a:cubicBezTo>
                      <a:cubicBezTo>
                        <a:pt x="390364" y="863477"/>
                        <a:pt x="384564" y="869789"/>
                        <a:pt x="377228" y="873457"/>
                      </a:cubicBezTo>
                      <a:cubicBezTo>
                        <a:pt x="370795" y="876674"/>
                        <a:pt x="363045" y="876788"/>
                        <a:pt x="356757" y="880281"/>
                      </a:cubicBezTo>
                      <a:cubicBezTo>
                        <a:pt x="342418" y="888247"/>
                        <a:pt x="331374" y="902389"/>
                        <a:pt x="315813" y="907576"/>
                      </a:cubicBezTo>
                      <a:cubicBezTo>
                        <a:pt x="287561" y="916994"/>
                        <a:pt x="301327" y="910410"/>
                        <a:pt x="274870" y="928048"/>
                      </a:cubicBezTo>
                      <a:cubicBezTo>
                        <a:pt x="270321" y="934872"/>
                        <a:pt x="267626" y="943397"/>
                        <a:pt x="261222" y="948520"/>
                      </a:cubicBezTo>
                      <a:cubicBezTo>
                        <a:pt x="255605" y="953013"/>
                        <a:pt x="247184" y="952127"/>
                        <a:pt x="240751" y="955344"/>
                      </a:cubicBezTo>
                      <a:cubicBezTo>
                        <a:pt x="187841" y="981799"/>
                        <a:pt x="251261" y="958664"/>
                        <a:pt x="199807" y="975815"/>
                      </a:cubicBezTo>
                      <a:cubicBezTo>
                        <a:pt x="197533" y="982639"/>
                        <a:pt x="197477" y="990670"/>
                        <a:pt x="192984" y="996287"/>
                      </a:cubicBezTo>
                      <a:cubicBezTo>
                        <a:pt x="183364" y="1008313"/>
                        <a:pt x="165526" y="1012264"/>
                        <a:pt x="152040" y="1016759"/>
                      </a:cubicBezTo>
                      <a:cubicBezTo>
                        <a:pt x="137151" y="1061424"/>
                        <a:pt x="157830" y="1017585"/>
                        <a:pt x="124745" y="1044054"/>
                      </a:cubicBezTo>
                      <a:cubicBezTo>
                        <a:pt x="84962" y="1075882"/>
                        <a:pt x="103136" y="1072487"/>
                        <a:pt x="97449" y="1071350"/>
                      </a:cubicBezTo>
                      <a:close/>
                    </a:path>
                  </a:pathLst>
                </a:custGeom>
                <a:noFill/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" name="Freeform 62"/>
                <p:cNvSpPr/>
                <p:nvPr/>
              </p:nvSpPr>
              <p:spPr>
                <a:xfrm>
                  <a:off x="3814549" y="2845558"/>
                  <a:ext cx="532263" cy="1105469"/>
                </a:xfrm>
                <a:custGeom>
                  <a:avLst/>
                  <a:gdLst>
                    <a:gd name="connsiteX0" fmla="*/ 286603 w 532263"/>
                    <a:gd name="connsiteY0" fmla="*/ 6824 h 1105469"/>
                    <a:gd name="connsiteX1" fmla="*/ 252484 w 532263"/>
                    <a:gd name="connsiteY1" fmla="*/ 27296 h 1105469"/>
                    <a:gd name="connsiteX2" fmla="*/ 232012 w 532263"/>
                    <a:gd name="connsiteY2" fmla="*/ 40943 h 1105469"/>
                    <a:gd name="connsiteX3" fmla="*/ 211541 w 532263"/>
                    <a:gd name="connsiteY3" fmla="*/ 47767 h 1105469"/>
                    <a:gd name="connsiteX4" fmla="*/ 170597 w 532263"/>
                    <a:gd name="connsiteY4" fmla="*/ 75063 h 1105469"/>
                    <a:gd name="connsiteX5" fmla="*/ 129654 w 532263"/>
                    <a:gd name="connsiteY5" fmla="*/ 136478 h 1105469"/>
                    <a:gd name="connsiteX6" fmla="*/ 116006 w 532263"/>
                    <a:gd name="connsiteY6" fmla="*/ 156949 h 1105469"/>
                    <a:gd name="connsiteX7" fmla="*/ 95535 w 532263"/>
                    <a:gd name="connsiteY7" fmla="*/ 163773 h 1105469"/>
                    <a:gd name="connsiteX8" fmla="*/ 88711 w 532263"/>
                    <a:gd name="connsiteY8" fmla="*/ 184245 h 1105469"/>
                    <a:gd name="connsiteX9" fmla="*/ 75063 w 532263"/>
                    <a:gd name="connsiteY9" fmla="*/ 204717 h 1105469"/>
                    <a:gd name="connsiteX10" fmla="*/ 81887 w 532263"/>
                    <a:gd name="connsiteY10" fmla="*/ 402609 h 1105469"/>
                    <a:gd name="connsiteX11" fmla="*/ 88711 w 532263"/>
                    <a:gd name="connsiteY11" fmla="*/ 423081 h 1105469"/>
                    <a:gd name="connsiteX12" fmla="*/ 95535 w 532263"/>
                    <a:gd name="connsiteY12" fmla="*/ 450376 h 1105469"/>
                    <a:gd name="connsiteX13" fmla="*/ 109182 w 532263"/>
                    <a:gd name="connsiteY13" fmla="*/ 491320 h 1105469"/>
                    <a:gd name="connsiteX14" fmla="*/ 116006 w 532263"/>
                    <a:gd name="connsiteY14" fmla="*/ 511791 h 1105469"/>
                    <a:gd name="connsiteX15" fmla="*/ 122830 w 532263"/>
                    <a:gd name="connsiteY15" fmla="*/ 545911 h 1105469"/>
                    <a:gd name="connsiteX16" fmla="*/ 116006 w 532263"/>
                    <a:gd name="connsiteY16" fmla="*/ 620973 h 1105469"/>
                    <a:gd name="connsiteX17" fmla="*/ 75063 w 532263"/>
                    <a:gd name="connsiteY17" fmla="*/ 648269 h 1105469"/>
                    <a:gd name="connsiteX18" fmla="*/ 54591 w 532263"/>
                    <a:gd name="connsiteY18" fmla="*/ 661917 h 1105469"/>
                    <a:gd name="connsiteX19" fmla="*/ 40944 w 532263"/>
                    <a:gd name="connsiteY19" fmla="*/ 682388 h 1105469"/>
                    <a:gd name="connsiteX20" fmla="*/ 20472 w 532263"/>
                    <a:gd name="connsiteY20" fmla="*/ 689212 h 1105469"/>
                    <a:gd name="connsiteX21" fmla="*/ 0 w 532263"/>
                    <a:gd name="connsiteY21" fmla="*/ 709684 h 1105469"/>
                    <a:gd name="connsiteX22" fmla="*/ 20472 w 532263"/>
                    <a:gd name="connsiteY22" fmla="*/ 777923 h 1105469"/>
                    <a:gd name="connsiteX23" fmla="*/ 40944 w 532263"/>
                    <a:gd name="connsiteY23" fmla="*/ 791570 h 1105469"/>
                    <a:gd name="connsiteX24" fmla="*/ 75063 w 532263"/>
                    <a:gd name="connsiteY24" fmla="*/ 852985 h 1105469"/>
                    <a:gd name="connsiteX25" fmla="*/ 88711 w 532263"/>
                    <a:gd name="connsiteY25" fmla="*/ 873457 h 1105469"/>
                    <a:gd name="connsiteX26" fmla="*/ 109182 w 532263"/>
                    <a:gd name="connsiteY26" fmla="*/ 914400 h 1105469"/>
                    <a:gd name="connsiteX27" fmla="*/ 150126 w 532263"/>
                    <a:gd name="connsiteY27" fmla="*/ 941696 h 1105469"/>
                    <a:gd name="connsiteX28" fmla="*/ 191069 w 532263"/>
                    <a:gd name="connsiteY28" fmla="*/ 955343 h 1105469"/>
                    <a:gd name="connsiteX29" fmla="*/ 232012 w 532263"/>
                    <a:gd name="connsiteY29" fmla="*/ 982639 h 1105469"/>
                    <a:gd name="connsiteX30" fmla="*/ 252484 w 532263"/>
                    <a:gd name="connsiteY30" fmla="*/ 996287 h 1105469"/>
                    <a:gd name="connsiteX31" fmla="*/ 266132 w 532263"/>
                    <a:gd name="connsiteY31" fmla="*/ 1016758 h 1105469"/>
                    <a:gd name="connsiteX32" fmla="*/ 286603 w 532263"/>
                    <a:gd name="connsiteY32" fmla="*/ 1023582 h 1105469"/>
                    <a:gd name="connsiteX33" fmla="*/ 307075 w 532263"/>
                    <a:gd name="connsiteY33" fmla="*/ 1037230 h 1105469"/>
                    <a:gd name="connsiteX34" fmla="*/ 327547 w 532263"/>
                    <a:gd name="connsiteY34" fmla="*/ 1078173 h 1105469"/>
                    <a:gd name="connsiteX35" fmla="*/ 368490 w 532263"/>
                    <a:gd name="connsiteY35" fmla="*/ 1105469 h 1105469"/>
                    <a:gd name="connsiteX36" fmla="*/ 395785 w 532263"/>
                    <a:gd name="connsiteY36" fmla="*/ 1098645 h 1105469"/>
                    <a:gd name="connsiteX37" fmla="*/ 409433 w 532263"/>
                    <a:gd name="connsiteY37" fmla="*/ 1057702 h 1105469"/>
                    <a:gd name="connsiteX38" fmla="*/ 450376 w 532263"/>
                    <a:gd name="connsiteY38" fmla="*/ 1023582 h 1105469"/>
                    <a:gd name="connsiteX39" fmla="*/ 470848 w 532263"/>
                    <a:gd name="connsiteY39" fmla="*/ 982639 h 1105469"/>
                    <a:gd name="connsiteX40" fmla="*/ 491320 w 532263"/>
                    <a:gd name="connsiteY40" fmla="*/ 941696 h 1105469"/>
                    <a:gd name="connsiteX41" fmla="*/ 511791 w 532263"/>
                    <a:gd name="connsiteY41" fmla="*/ 832514 h 1105469"/>
                    <a:gd name="connsiteX42" fmla="*/ 518615 w 532263"/>
                    <a:gd name="connsiteY42" fmla="*/ 812042 h 1105469"/>
                    <a:gd name="connsiteX43" fmla="*/ 532263 w 532263"/>
                    <a:gd name="connsiteY43" fmla="*/ 723332 h 1105469"/>
                    <a:gd name="connsiteX44" fmla="*/ 525439 w 532263"/>
                    <a:gd name="connsiteY44" fmla="*/ 593678 h 1105469"/>
                    <a:gd name="connsiteX45" fmla="*/ 511791 w 532263"/>
                    <a:gd name="connsiteY45" fmla="*/ 539087 h 1105469"/>
                    <a:gd name="connsiteX46" fmla="*/ 498144 w 532263"/>
                    <a:gd name="connsiteY46" fmla="*/ 470848 h 1105469"/>
                    <a:gd name="connsiteX47" fmla="*/ 484496 w 532263"/>
                    <a:gd name="connsiteY47" fmla="*/ 354842 h 1105469"/>
                    <a:gd name="connsiteX48" fmla="*/ 470848 w 532263"/>
                    <a:gd name="connsiteY48" fmla="*/ 286603 h 1105469"/>
                    <a:gd name="connsiteX49" fmla="*/ 450376 w 532263"/>
                    <a:gd name="connsiteY49" fmla="*/ 245660 h 1105469"/>
                    <a:gd name="connsiteX50" fmla="*/ 436729 w 532263"/>
                    <a:gd name="connsiteY50" fmla="*/ 204717 h 1105469"/>
                    <a:gd name="connsiteX51" fmla="*/ 416257 w 532263"/>
                    <a:gd name="connsiteY51" fmla="*/ 163773 h 1105469"/>
                    <a:gd name="connsiteX52" fmla="*/ 402609 w 532263"/>
                    <a:gd name="connsiteY52" fmla="*/ 143302 h 1105469"/>
                    <a:gd name="connsiteX53" fmla="*/ 382138 w 532263"/>
                    <a:gd name="connsiteY53" fmla="*/ 102358 h 1105469"/>
                    <a:gd name="connsiteX54" fmla="*/ 361666 w 532263"/>
                    <a:gd name="connsiteY54" fmla="*/ 88711 h 1105469"/>
                    <a:gd name="connsiteX55" fmla="*/ 334370 w 532263"/>
                    <a:gd name="connsiteY55" fmla="*/ 27296 h 1105469"/>
                    <a:gd name="connsiteX56" fmla="*/ 293427 w 532263"/>
                    <a:gd name="connsiteY56" fmla="*/ 0 h 1105469"/>
                    <a:gd name="connsiteX57" fmla="*/ 286603 w 532263"/>
                    <a:gd name="connsiteY57" fmla="*/ 6824 h 11054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</a:cxnLst>
                  <a:rect l="l" t="t" r="r" b="b"/>
                  <a:pathLst>
                    <a:path w="532263" h="1105469">
                      <a:moveTo>
                        <a:pt x="286603" y="6824"/>
                      </a:moveTo>
                      <a:cubicBezTo>
                        <a:pt x="275230" y="13648"/>
                        <a:pt x="263731" y="20267"/>
                        <a:pt x="252484" y="27296"/>
                      </a:cubicBezTo>
                      <a:cubicBezTo>
                        <a:pt x="245529" y="31643"/>
                        <a:pt x="239347" y="37275"/>
                        <a:pt x="232012" y="40943"/>
                      </a:cubicBezTo>
                      <a:cubicBezTo>
                        <a:pt x="225579" y="44160"/>
                        <a:pt x="217829" y="44274"/>
                        <a:pt x="211541" y="47767"/>
                      </a:cubicBezTo>
                      <a:cubicBezTo>
                        <a:pt x="197202" y="55733"/>
                        <a:pt x="170597" y="75063"/>
                        <a:pt x="170597" y="75063"/>
                      </a:cubicBezTo>
                      <a:lnTo>
                        <a:pt x="129654" y="136478"/>
                      </a:lnTo>
                      <a:cubicBezTo>
                        <a:pt x="125105" y="143302"/>
                        <a:pt x="123786" y="154355"/>
                        <a:pt x="116006" y="156949"/>
                      </a:cubicBezTo>
                      <a:lnTo>
                        <a:pt x="95535" y="163773"/>
                      </a:lnTo>
                      <a:cubicBezTo>
                        <a:pt x="93260" y="170597"/>
                        <a:pt x="91928" y="177811"/>
                        <a:pt x="88711" y="184245"/>
                      </a:cubicBezTo>
                      <a:cubicBezTo>
                        <a:pt x="85043" y="191581"/>
                        <a:pt x="75319" y="196520"/>
                        <a:pt x="75063" y="204717"/>
                      </a:cubicBezTo>
                      <a:cubicBezTo>
                        <a:pt x="73001" y="270688"/>
                        <a:pt x="77770" y="336734"/>
                        <a:pt x="81887" y="402609"/>
                      </a:cubicBezTo>
                      <a:cubicBezTo>
                        <a:pt x="82336" y="409788"/>
                        <a:pt x="86735" y="416165"/>
                        <a:pt x="88711" y="423081"/>
                      </a:cubicBezTo>
                      <a:cubicBezTo>
                        <a:pt x="91287" y="432099"/>
                        <a:pt x="92840" y="441393"/>
                        <a:pt x="95535" y="450376"/>
                      </a:cubicBezTo>
                      <a:cubicBezTo>
                        <a:pt x="99669" y="464155"/>
                        <a:pt x="104633" y="477672"/>
                        <a:pt x="109182" y="491320"/>
                      </a:cubicBezTo>
                      <a:cubicBezTo>
                        <a:pt x="111457" y="498144"/>
                        <a:pt x="114595" y="504738"/>
                        <a:pt x="116006" y="511791"/>
                      </a:cubicBezTo>
                      <a:lnTo>
                        <a:pt x="122830" y="545911"/>
                      </a:lnTo>
                      <a:cubicBezTo>
                        <a:pt x="120555" y="570932"/>
                        <a:pt x="126630" y="598206"/>
                        <a:pt x="116006" y="620973"/>
                      </a:cubicBezTo>
                      <a:cubicBezTo>
                        <a:pt x="109070" y="635837"/>
                        <a:pt x="88711" y="639170"/>
                        <a:pt x="75063" y="648269"/>
                      </a:cubicBezTo>
                      <a:lnTo>
                        <a:pt x="54591" y="661917"/>
                      </a:lnTo>
                      <a:cubicBezTo>
                        <a:pt x="50042" y="668741"/>
                        <a:pt x="47348" y="677265"/>
                        <a:pt x="40944" y="682388"/>
                      </a:cubicBezTo>
                      <a:cubicBezTo>
                        <a:pt x="35327" y="686881"/>
                        <a:pt x="26457" y="685222"/>
                        <a:pt x="20472" y="689212"/>
                      </a:cubicBezTo>
                      <a:cubicBezTo>
                        <a:pt x="12442" y="694565"/>
                        <a:pt x="6824" y="702860"/>
                        <a:pt x="0" y="709684"/>
                      </a:cubicBezTo>
                      <a:cubicBezTo>
                        <a:pt x="4295" y="739749"/>
                        <a:pt x="-217" y="757235"/>
                        <a:pt x="20472" y="777923"/>
                      </a:cubicBezTo>
                      <a:cubicBezTo>
                        <a:pt x="26271" y="783722"/>
                        <a:pt x="34120" y="787021"/>
                        <a:pt x="40944" y="791570"/>
                      </a:cubicBezTo>
                      <a:cubicBezTo>
                        <a:pt x="52953" y="827603"/>
                        <a:pt x="43777" y="806056"/>
                        <a:pt x="75063" y="852985"/>
                      </a:cubicBezTo>
                      <a:cubicBezTo>
                        <a:pt x="79612" y="859809"/>
                        <a:pt x="86117" y="865676"/>
                        <a:pt x="88711" y="873457"/>
                      </a:cubicBezTo>
                      <a:cubicBezTo>
                        <a:pt x="93578" y="888059"/>
                        <a:pt x="96733" y="903507"/>
                        <a:pt x="109182" y="914400"/>
                      </a:cubicBezTo>
                      <a:cubicBezTo>
                        <a:pt x="121526" y="925201"/>
                        <a:pt x="134565" y="936509"/>
                        <a:pt x="150126" y="941696"/>
                      </a:cubicBezTo>
                      <a:lnTo>
                        <a:pt x="191069" y="955343"/>
                      </a:lnTo>
                      <a:lnTo>
                        <a:pt x="232012" y="982639"/>
                      </a:lnTo>
                      <a:lnTo>
                        <a:pt x="252484" y="996287"/>
                      </a:lnTo>
                      <a:cubicBezTo>
                        <a:pt x="257033" y="1003111"/>
                        <a:pt x="259728" y="1011635"/>
                        <a:pt x="266132" y="1016758"/>
                      </a:cubicBezTo>
                      <a:cubicBezTo>
                        <a:pt x="271749" y="1021251"/>
                        <a:pt x="280170" y="1020365"/>
                        <a:pt x="286603" y="1023582"/>
                      </a:cubicBezTo>
                      <a:cubicBezTo>
                        <a:pt x="293939" y="1027250"/>
                        <a:pt x="300251" y="1032681"/>
                        <a:pt x="307075" y="1037230"/>
                      </a:cubicBezTo>
                      <a:cubicBezTo>
                        <a:pt x="311943" y="1051834"/>
                        <a:pt x="315096" y="1067278"/>
                        <a:pt x="327547" y="1078173"/>
                      </a:cubicBezTo>
                      <a:cubicBezTo>
                        <a:pt x="339891" y="1088974"/>
                        <a:pt x="368490" y="1105469"/>
                        <a:pt x="368490" y="1105469"/>
                      </a:cubicBezTo>
                      <a:cubicBezTo>
                        <a:pt x="377588" y="1103194"/>
                        <a:pt x="389682" y="1105766"/>
                        <a:pt x="395785" y="1098645"/>
                      </a:cubicBezTo>
                      <a:cubicBezTo>
                        <a:pt x="405147" y="1087722"/>
                        <a:pt x="399261" y="1067874"/>
                        <a:pt x="409433" y="1057702"/>
                      </a:cubicBezTo>
                      <a:cubicBezTo>
                        <a:pt x="435704" y="1031431"/>
                        <a:pt x="421875" y="1042583"/>
                        <a:pt x="450376" y="1023582"/>
                      </a:cubicBezTo>
                      <a:cubicBezTo>
                        <a:pt x="467529" y="972125"/>
                        <a:pt x="444390" y="1035555"/>
                        <a:pt x="470848" y="982639"/>
                      </a:cubicBezTo>
                      <a:cubicBezTo>
                        <a:pt x="499098" y="926140"/>
                        <a:pt x="452211" y="1000357"/>
                        <a:pt x="491320" y="941696"/>
                      </a:cubicBezTo>
                      <a:cubicBezTo>
                        <a:pt x="517391" y="863477"/>
                        <a:pt x="495279" y="939837"/>
                        <a:pt x="511791" y="832514"/>
                      </a:cubicBezTo>
                      <a:cubicBezTo>
                        <a:pt x="512885" y="825405"/>
                        <a:pt x="517055" y="819064"/>
                        <a:pt x="518615" y="812042"/>
                      </a:cubicBezTo>
                      <a:cubicBezTo>
                        <a:pt x="522402" y="794999"/>
                        <a:pt x="530086" y="738570"/>
                        <a:pt x="532263" y="723332"/>
                      </a:cubicBezTo>
                      <a:cubicBezTo>
                        <a:pt x="529988" y="680114"/>
                        <a:pt x="529033" y="636806"/>
                        <a:pt x="525439" y="593678"/>
                      </a:cubicBezTo>
                      <a:cubicBezTo>
                        <a:pt x="521780" y="549771"/>
                        <a:pt x="519445" y="572257"/>
                        <a:pt x="511791" y="539087"/>
                      </a:cubicBezTo>
                      <a:cubicBezTo>
                        <a:pt x="506575" y="516484"/>
                        <a:pt x="500706" y="493903"/>
                        <a:pt x="498144" y="470848"/>
                      </a:cubicBezTo>
                      <a:cubicBezTo>
                        <a:pt x="494562" y="438610"/>
                        <a:pt x="489185" y="387667"/>
                        <a:pt x="484496" y="354842"/>
                      </a:cubicBezTo>
                      <a:cubicBezTo>
                        <a:pt x="480666" y="328034"/>
                        <a:pt x="477953" y="311470"/>
                        <a:pt x="470848" y="286603"/>
                      </a:cubicBezTo>
                      <a:cubicBezTo>
                        <a:pt x="455916" y="234341"/>
                        <a:pt x="474302" y="299494"/>
                        <a:pt x="450376" y="245660"/>
                      </a:cubicBezTo>
                      <a:cubicBezTo>
                        <a:pt x="444533" y="232514"/>
                        <a:pt x="444709" y="216687"/>
                        <a:pt x="436729" y="204717"/>
                      </a:cubicBezTo>
                      <a:cubicBezTo>
                        <a:pt x="397613" y="146042"/>
                        <a:pt x="444512" y="220282"/>
                        <a:pt x="416257" y="163773"/>
                      </a:cubicBezTo>
                      <a:cubicBezTo>
                        <a:pt x="412589" y="156438"/>
                        <a:pt x="407158" y="150126"/>
                        <a:pt x="402609" y="143302"/>
                      </a:cubicBezTo>
                      <a:cubicBezTo>
                        <a:pt x="397060" y="126654"/>
                        <a:pt x="395365" y="115585"/>
                        <a:pt x="382138" y="102358"/>
                      </a:cubicBezTo>
                      <a:cubicBezTo>
                        <a:pt x="376339" y="96559"/>
                        <a:pt x="368490" y="93260"/>
                        <a:pt x="361666" y="88711"/>
                      </a:cubicBezTo>
                      <a:cubicBezTo>
                        <a:pt x="356582" y="73459"/>
                        <a:pt x="349638" y="40655"/>
                        <a:pt x="334370" y="27296"/>
                      </a:cubicBezTo>
                      <a:cubicBezTo>
                        <a:pt x="322026" y="16495"/>
                        <a:pt x="293427" y="0"/>
                        <a:pt x="293427" y="0"/>
                      </a:cubicBezTo>
                      <a:lnTo>
                        <a:pt x="286603" y="6824"/>
                      </a:lnTo>
                      <a:close/>
                    </a:path>
                  </a:pathLst>
                </a:custGeom>
                <a:noFill/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8" name="Freeform 47"/>
              <p:cNvSpPr/>
              <p:nvPr/>
            </p:nvSpPr>
            <p:spPr>
              <a:xfrm>
                <a:off x="949243" y="1842870"/>
                <a:ext cx="185131" cy="79053"/>
              </a:xfrm>
              <a:custGeom>
                <a:avLst/>
                <a:gdLst>
                  <a:gd name="connsiteX0" fmla="*/ 0 w 293427"/>
                  <a:gd name="connsiteY0" fmla="*/ 0 h 204930"/>
                  <a:gd name="connsiteX1" fmla="*/ 34119 w 293427"/>
                  <a:gd name="connsiteY1" fmla="*/ 34119 h 204930"/>
                  <a:gd name="connsiteX2" fmla="*/ 54591 w 293427"/>
                  <a:gd name="connsiteY2" fmla="*/ 40943 h 204930"/>
                  <a:gd name="connsiteX3" fmla="*/ 61415 w 293427"/>
                  <a:gd name="connsiteY3" fmla="*/ 61415 h 204930"/>
                  <a:gd name="connsiteX4" fmla="*/ 81886 w 293427"/>
                  <a:gd name="connsiteY4" fmla="*/ 68239 h 204930"/>
                  <a:gd name="connsiteX5" fmla="*/ 122830 w 293427"/>
                  <a:gd name="connsiteY5" fmla="*/ 95534 h 204930"/>
                  <a:gd name="connsiteX6" fmla="*/ 163773 w 293427"/>
                  <a:gd name="connsiteY6" fmla="*/ 129654 h 204930"/>
                  <a:gd name="connsiteX7" fmla="*/ 184245 w 293427"/>
                  <a:gd name="connsiteY7" fmla="*/ 136478 h 204930"/>
                  <a:gd name="connsiteX8" fmla="*/ 225188 w 293427"/>
                  <a:gd name="connsiteY8" fmla="*/ 163773 h 204930"/>
                  <a:gd name="connsiteX9" fmla="*/ 266131 w 293427"/>
                  <a:gd name="connsiteY9" fmla="*/ 184245 h 204930"/>
                  <a:gd name="connsiteX10" fmla="*/ 293427 w 293427"/>
                  <a:gd name="connsiteY10" fmla="*/ 204716 h 204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293427" h="204930">
                    <a:moveTo>
                      <a:pt x="0" y="0"/>
                    </a:moveTo>
                    <a:cubicBezTo>
                      <a:pt x="11373" y="11373"/>
                      <a:pt x="21252" y="24469"/>
                      <a:pt x="34119" y="34119"/>
                    </a:cubicBezTo>
                    <a:cubicBezTo>
                      <a:pt x="39874" y="38435"/>
                      <a:pt x="49505" y="35857"/>
                      <a:pt x="54591" y="40943"/>
                    </a:cubicBezTo>
                    <a:cubicBezTo>
                      <a:pt x="59677" y="46029"/>
                      <a:pt x="56329" y="56329"/>
                      <a:pt x="61415" y="61415"/>
                    </a:cubicBezTo>
                    <a:cubicBezTo>
                      <a:pt x="66501" y="66501"/>
                      <a:pt x="75598" y="64746"/>
                      <a:pt x="81886" y="68239"/>
                    </a:cubicBezTo>
                    <a:cubicBezTo>
                      <a:pt x="96225" y="76205"/>
                      <a:pt x="111232" y="83935"/>
                      <a:pt x="122830" y="95534"/>
                    </a:cubicBezTo>
                    <a:cubicBezTo>
                      <a:pt x="137922" y="110627"/>
                      <a:pt x="144771" y="120153"/>
                      <a:pt x="163773" y="129654"/>
                    </a:cubicBezTo>
                    <a:cubicBezTo>
                      <a:pt x="170207" y="132871"/>
                      <a:pt x="177421" y="134203"/>
                      <a:pt x="184245" y="136478"/>
                    </a:cubicBezTo>
                    <a:cubicBezTo>
                      <a:pt x="223051" y="175284"/>
                      <a:pt x="185685" y="144022"/>
                      <a:pt x="225188" y="163773"/>
                    </a:cubicBezTo>
                    <a:cubicBezTo>
                      <a:pt x="278104" y="190231"/>
                      <a:pt x="214674" y="167092"/>
                      <a:pt x="266131" y="184245"/>
                    </a:cubicBezTo>
                    <a:cubicBezTo>
                      <a:pt x="282303" y="208501"/>
                      <a:pt x="271578" y="204716"/>
                      <a:pt x="293427" y="204716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49" name="Group 48"/>
              <p:cNvGrpSpPr/>
              <p:nvPr/>
            </p:nvGrpSpPr>
            <p:grpSpPr>
              <a:xfrm>
                <a:off x="770429" y="1178241"/>
                <a:ext cx="1220596" cy="727553"/>
                <a:chOff x="2668137" y="2620370"/>
                <a:chExt cx="2142699" cy="1262418"/>
              </a:xfrm>
            </p:grpSpPr>
            <p:grpSp>
              <p:nvGrpSpPr>
                <p:cNvPr id="58" name="Group 57"/>
                <p:cNvGrpSpPr/>
                <p:nvPr/>
              </p:nvGrpSpPr>
              <p:grpSpPr>
                <a:xfrm>
                  <a:off x="2668137" y="2620370"/>
                  <a:ext cx="2142699" cy="1228299"/>
                  <a:chOff x="2668137" y="2620370"/>
                  <a:chExt cx="2142699" cy="1228299"/>
                </a:xfrm>
              </p:grpSpPr>
              <p:sp>
                <p:nvSpPr>
                  <p:cNvPr id="60" name="Freeform 59"/>
                  <p:cNvSpPr/>
                  <p:nvPr/>
                </p:nvSpPr>
                <p:spPr>
                  <a:xfrm>
                    <a:off x="2668137" y="2825087"/>
                    <a:ext cx="458145" cy="934871"/>
                  </a:xfrm>
                  <a:custGeom>
                    <a:avLst/>
                    <a:gdLst>
                      <a:gd name="connsiteX0" fmla="*/ 0 w 458145"/>
                      <a:gd name="connsiteY0" fmla="*/ 0 h 934871"/>
                      <a:gd name="connsiteX1" fmla="*/ 68239 w 458145"/>
                      <a:gd name="connsiteY1" fmla="*/ 6823 h 934871"/>
                      <a:gd name="connsiteX2" fmla="*/ 150126 w 458145"/>
                      <a:gd name="connsiteY2" fmla="*/ 20471 h 934871"/>
                      <a:gd name="connsiteX3" fmla="*/ 163773 w 458145"/>
                      <a:gd name="connsiteY3" fmla="*/ 40943 h 934871"/>
                      <a:gd name="connsiteX4" fmla="*/ 218364 w 458145"/>
                      <a:gd name="connsiteY4" fmla="*/ 34119 h 934871"/>
                      <a:gd name="connsiteX5" fmla="*/ 245660 w 458145"/>
                      <a:gd name="connsiteY5" fmla="*/ 40943 h 934871"/>
                      <a:gd name="connsiteX6" fmla="*/ 286603 w 458145"/>
                      <a:gd name="connsiteY6" fmla="*/ 54591 h 934871"/>
                      <a:gd name="connsiteX7" fmla="*/ 327547 w 458145"/>
                      <a:gd name="connsiteY7" fmla="*/ 81886 h 934871"/>
                      <a:gd name="connsiteX8" fmla="*/ 334370 w 458145"/>
                      <a:gd name="connsiteY8" fmla="*/ 102358 h 934871"/>
                      <a:gd name="connsiteX9" fmla="*/ 354842 w 458145"/>
                      <a:gd name="connsiteY9" fmla="*/ 143301 h 934871"/>
                      <a:gd name="connsiteX10" fmla="*/ 361666 w 458145"/>
                      <a:gd name="connsiteY10" fmla="*/ 191068 h 934871"/>
                      <a:gd name="connsiteX11" fmla="*/ 423081 w 458145"/>
                      <a:gd name="connsiteY11" fmla="*/ 225188 h 934871"/>
                      <a:gd name="connsiteX12" fmla="*/ 457200 w 458145"/>
                      <a:gd name="connsiteY12" fmla="*/ 286603 h 934871"/>
                      <a:gd name="connsiteX13" fmla="*/ 450376 w 458145"/>
                      <a:gd name="connsiteY13" fmla="*/ 348017 h 934871"/>
                      <a:gd name="connsiteX14" fmla="*/ 402609 w 458145"/>
                      <a:gd name="connsiteY14" fmla="*/ 402609 h 934871"/>
                      <a:gd name="connsiteX15" fmla="*/ 395785 w 458145"/>
                      <a:gd name="connsiteY15" fmla="*/ 504967 h 934871"/>
                      <a:gd name="connsiteX16" fmla="*/ 388962 w 458145"/>
                      <a:gd name="connsiteY16" fmla="*/ 525438 h 934871"/>
                      <a:gd name="connsiteX17" fmla="*/ 348018 w 458145"/>
                      <a:gd name="connsiteY17" fmla="*/ 539086 h 934871"/>
                      <a:gd name="connsiteX18" fmla="*/ 327547 w 458145"/>
                      <a:gd name="connsiteY18" fmla="*/ 559558 h 934871"/>
                      <a:gd name="connsiteX19" fmla="*/ 313899 w 458145"/>
                      <a:gd name="connsiteY19" fmla="*/ 580029 h 934871"/>
                      <a:gd name="connsiteX20" fmla="*/ 293427 w 458145"/>
                      <a:gd name="connsiteY20" fmla="*/ 593677 h 934871"/>
                      <a:gd name="connsiteX21" fmla="*/ 300251 w 458145"/>
                      <a:gd name="connsiteY21" fmla="*/ 641444 h 934871"/>
                      <a:gd name="connsiteX22" fmla="*/ 361666 w 458145"/>
                      <a:gd name="connsiteY22" fmla="*/ 675564 h 934871"/>
                      <a:gd name="connsiteX23" fmla="*/ 388962 w 458145"/>
                      <a:gd name="connsiteY23" fmla="*/ 716507 h 934871"/>
                      <a:gd name="connsiteX24" fmla="*/ 361666 w 458145"/>
                      <a:gd name="connsiteY24" fmla="*/ 798394 h 934871"/>
                      <a:gd name="connsiteX25" fmla="*/ 341194 w 458145"/>
                      <a:gd name="connsiteY25" fmla="*/ 812041 h 934871"/>
                      <a:gd name="connsiteX26" fmla="*/ 327547 w 458145"/>
                      <a:gd name="connsiteY26" fmla="*/ 852985 h 934871"/>
                      <a:gd name="connsiteX27" fmla="*/ 320723 w 458145"/>
                      <a:gd name="connsiteY27" fmla="*/ 873456 h 934871"/>
                      <a:gd name="connsiteX28" fmla="*/ 320723 w 458145"/>
                      <a:gd name="connsiteY28" fmla="*/ 934871 h 93487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</a:cxnLst>
                    <a:rect l="l" t="t" r="r" b="b"/>
                    <a:pathLst>
                      <a:path w="458145" h="934871">
                        <a:moveTo>
                          <a:pt x="0" y="0"/>
                        </a:moveTo>
                        <a:lnTo>
                          <a:pt x="68239" y="6823"/>
                        </a:lnTo>
                        <a:cubicBezTo>
                          <a:pt x="135043" y="13855"/>
                          <a:pt x="110728" y="7338"/>
                          <a:pt x="150126" y="20471"/>
                        </a:cubicBezTo>
                        <a:cubicBezTo>
                          <a:pt x="154675" y="27295"/>
                          <a:pt x="155731" y="39335"/>
                          <a:pt x="163773" y="40943"/>
                        </a:cubicBezTo>
                        <a:cubicBezTo>
                          <a:pt x="181755" y="44540"/>
                          <a:pt x="200025" y="34119"/>
                          <a:pt x="218364" y="34119"/>
                        </a:cubicBezTo>
                        <a:cubicBezTo>
                          <a:pt x="227743" y="34119"/>
                          <a:pt x="236677" y="38248"/>
                          <a:pt x="245660" y="40943"/>
                        </a:cubicBezTo>
                        <a:cubicBezTo>
                          <a:pt x="259439" y="45077"/>
                          <a:pt x="274633" y="46611"/>
                          <a:pt x="286603" y="54591"/>
                        </a:cubicBezTo>
                        <a:lnTo>
                          <a:pt x="327547" y="81886"/>
                        </a:lnTo>
                        <a:cubicBezTo>
                          <a:pt x="329821" y="88710"/>
                          <a:pt x="331153" y="95924"/>
                          <a:pt x="334370" y="102358"/>
                        </a:cubicBezTo>
                        <a:cubicBezTo>
                          <a:pt x="360830" y="155279"/>
                          <a:pt x="337687" y="91837"/>
                          <a:pt x="354842" y="143301"/>
                        </a:cubicBezTo>
                        <a:cubicBezTo>
                          <a:pt x="357117" y="159223"/>
                          <a:pt x="353031" y="177499"/>
                          <a:pt x="361666" y="191068"/>
                        </a:cubicBezTo>
                        <a:cubicBezTo>
                          <a:pt x="374301" y="210923"/>
                          <a:pt x="402087" y="218190"/>
                          <a:pt x="423081" y="225188"/>
                        </a:cubicBezTo>
                        <a:cubicBezTo>
                          <a:pt x="454366" y="272116"/>
                          <a:pt x="445189" y="250570"/>
                          <a:pt x="457200" y="286603"/>
                        </a:cubicBezTo>
                        <a:cubicBezTo>
                          <a:pt x="454925" y="307074"/>
                          <a:pt x="464155" y="332707"/>
                          <a:pt x="450376" y="348017"/>
                        </a:cubicBezTo>
                        <a:cubicBezTo>
                          <a:pt x="388402" y="416876"/>
                          <a:pt x="385669" y="284027"/>
                          <a:pt x="402609" y="402609"/>
                        </a:cubicBezTo>
                        <a:cubicBezTo>
                          <a:pt x="400334" y="436728"/>
                          <a:pt x="399561" y="470981"/>
                          <a:pt x="395785" y="504967"/>
                        </a:cubicBezTo>
                        <a:cubicBezTo>
                          <a:pt x="394991" y="512116"/>
                          <a:pt x="394815" y="521257"/>
                          <a:pt x="388962" y="525438"/>
                        </a:cubicBezTo>
                        <a:cubicBezTo>
                          <a:pt x="377255" y="533800"/>
                          <a:pt x="348018" y="539086"/>
                          <a:pt x="348018" y="539086"/>
                        </a:cubicBezTo>
                        <a:cubicBezTo>
                          <a:pt x="341194" y="545910"/>
                          <a:pt x="333725" y="552144"/>
                          <a:pt x="327547" y="559558"/>
                        </a:cubicBezTo>
                        <a:cubicBezTo>
                          <a:pt x="322297" y="565858"/>
                          <a:pt x="319698" y="574230"/>
                          <a:pt x="313899" y="580029"/>
                        </a:cubicBezTo>
                        <a:cubicBezTo>
                          <a:pt x="308100" y="585828"/>
                          <a:pt x="300251" y="589128"/>
                          <a:pt x="293427" y="593677"/>
                        </a:cubicBezTo>
                        <a:cubicBezTo>
                          <a:pt x="295702" y="609599"/>
                          <a:pt x="291616" y="627875"/>
                          <a:pt x="300251" y="641444"/>
                        </a:cubicBezTo>
                        <a:cubicBezTo>
                          <a:pt x="312886" y="661299"/>
                          <a:pt x="340672" y="668566"/>
                          <a:pt x="361666" y="675564"/>
                        </a:cubicBezTo>
                        <a:cubicBezTo>
                          <a:pt x="370765" y="689212"/>
                          <a:pt x="391659" y="700328"/>
                          <a:pt x="388962" y="716507"/>
                        </a:cubicBezTo>
                        <a:cubicBezTo>
                          <a:pt x="384412" y="743804"/>
                          <a:pt x="382931" y="777130"/>
                          <a:pt x="361666" y="798394"/>
                        </a:cubicBezTo>
                        <a:cubicBezTo>
                          <a:pt x="355867" y="804193"/>
                          <a:pt x="348018" y="807492"/>
                          <a:pt x="341194" y="812041"/>
                        </a:cubicBezTo>
                        <a:lnTo>
                          <a:pt x="327547" y="852985"/>
                        </a:lnTo>
                        <a:cubicBezTo>
                          <a:pt x="325272" y="859809"/>
                          <a:pt x="320723" y="866263"/>
                          <a:pt x="320723" y="873456"/>
                        </a:cubicBezTo>
                        <a:lnTo>
                          <a:pt x="320723" y="934871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60000"/>
                        <a:lumOff val="4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1" name="Freeform 60"/>
                  <p:cNvSpPr/>
                  <p:nvPr/>
                </p:nvSpPr>
                <p:spPr>
                  <a:xfrm>
                    <a:off x="4421875" y="2620370"/>
                    <a:ext cx="388961" cy="1228299"/>
                  </a:xfrm>
                  <a:custGeom>
                    <a:avLst/>
                    <a:gdLst>
                      <a:gd name="connsiteX0" fmla="*/ 388961 w 388961"/>
                      <a:gd name="connsiteY0" fmla="*/ 0 h 1228299"/>
                      <a:gd name="connsiteX1" fmla="*/ 368489 w 388961"/>
                      <a:gd name="connsiteY1" fmla="*/ 34120 h 1228299"/>
                      <a:gd name="connsiteX2" fmla="*/ 354841 w 388961"/>
                      <a:gd name="connsiteY2" fmla="*/ 95534 h 1228299"/>
                      <a:gd name="connsiteX3" fmla="*/ 341194 w 388961"/>
                      <a:gd name="connsiteY3" fmla="*/ 136478 h 1228299"/>
                      <a:gd name="connsiteX4" fmla="*/ 320722 w 388961"/>
                      <a:gd name="connsiteY4" fmla="*/ 150126 h 1228299"/>
                      <a:gd name="connsiteX5" fmla="*/ 252483 w 388961"/>
                      <a:gd name="connsiteY5" fmla="*/ 163773 h 1228299"/>
                      <a:gd name="connsiteX6" fmla="*/ 95534 w 388961"/>
                      <a:gd name="connsiteY6" fmla="*/ 170597 h 1228299"/>
                      <a:gd name="connsiteX7" fmla="*/ 122829 w 388961"/>
                      <a:gd name="connsiteY7" fmla="*/ 211540 h 1228299"/>
                      <a:gd name="connsiteX8" fmla="*/ 129653 w 388961"/>
                      <a:gd name="connsiteY8" fmla="*/ 232012 h 1228299"/>
                      <a:gd name="connsiteX9" fmla="*/ 143301 w 388961"/>
                      <a:gd name="connsiteY9" fmla="*/ 252484 h 1228299"/>
                      <a:gd name="connsiteX10" fmla="*/ 156949 w 388961"/>
                      <a:gd name="connsiteY10" fmla="*/ 293427 h 1228299"/>
                      <a:gd name="connsiteX11" fmla="*/ 116006 w 388961"/>
                      <a:gd name="connsiteY11" fmla="*/ 320723 h 1228299"/>
                      <a:gd name="connsiteX12" fmla="*/ 102358 w 388961"/>
                      <a:gd name="connsiteY12" fmla="*/ 361666 h 1228299"/>
                      <a:gd name="connsiteX13" fmla="*/ 109182 w 388961"/>
                      <a:gd name="connsiteY13" fmla="*/ 409433 h 1228299"/>
                      <a:gd name="connsiteX14" fmla="*/ 116006 w 388961"/>
                      <a:gd name="connsiteY14" fmla="*/ 457200 h 1228299"/>
                      <a:gd name="connsiteX15" fmla="*/ 88710 w 388961"/>
                      <a:gd name="connsiteY15" fmla="*/ 464024 h 1228299"/>
                      <a:gd name="connsiteX16" fmla="*/ 54591 w 388961"/>
                      <a:gd name="connsiteY16" fmla="*/ 470848 h 1228299"/>
                      <a:gd name="connsiteX17" fmla="*/ 40943 w 388961"/>
                      <a:gd name="connsiteY17" fmla="*/ 491320 h 1228299"/>
                      <a:gd name="connsiteX18" fmla="*/ 0 w 388961"/>
                      <a:gd name="connsiteY18" fmla="*/ 518615 h 1228299"/>
                      <a:gd name="connsiteX19" fmla="*/ 27295 w 388961"/>
                      <a:gd name="connsiteY19" fmla="*/ 552734 h 1228299"/>
                      <a:gd name="connsiteX20" fmla="*/ 34119 w 388961"/>
                      <a:gd name="connsiteY20" fmla="*/ 573206 h 1228299"/>
                      <a:gd name="connsiteX21" fmla="*/ 75062 w 388961"/>
                      <a:gd name="connsiteY21" fmla="*/ 586854 h 1228299"/>
                      <a:gd name="connsiteX22" fmla="*/ 95534 w 388961"/>
                      <a:gd name="connsiteY22" fmla="*/ 593678 h 1228299"/>
                      <a:gd name="connsiteX23" fmla="*/ 109182 w 388961"/>
                      <a:gd name="connsiteY23" fmla="*/ 614149 h 1228299"/>
                      <a:gd name="connsiteX24" fmla="*/ 109182 w 388961"/>
                      <a:gd name="connsiteY24" fmla="*/ 675564 h 1228299"/>
                      <a:gd name="connsiteX25" fmla="*/ 61415 w 388961"/>
                      <a:gd name="connsiteY25" fmla="*/ 696036 h 1228299"/>
                      <a:gd name="connsiteX26" fmla="*/ 61415 w 388961"/>
                      <a:gd name="connsiteY26" fmla="*/ 736979 h 1228299"/>
                      <a:gd name="connsiteX27" fmla="*/ 102358 w 388961"/>
                      <a:gd name="connsiteY27" fmla="*/ 750627 h 1228299"/>
                      <a:gd name="connsiteX28" fmla="*/ 143301 w 388961"/>
                      <a:gd name="connsiteY28" fmla="*/ 764275 h 1228299"/>
                      <a:gd name="connsiteX29" fmla="*/ 163773 w 388961"/>
                      <a:gd name="connsiteY29" fmla="*/ 771099 h 1228299"/>
                      <a:gd name="connsiteX30" fmla="*/ 204716 w 388961"/>
                      <a:gd name="connsiteY30" fmla="*/ 791570 h 1228299"/>
                      <a:gd name="connsiteX31" fmla="*/ 211540 w 388961"/>
                      <a:gd name="connsiteY31" fmla="*/ 812042 h 1228299"/>
                      <a:gd name="connsiteX32" fmla="*/ 177421 w 388961"/>
                      <a:gd name="connsiteY32" fmla="*/ 859809 h 1228299"/>
                      <a:gd name="connsiteX33" fmla="*/ 156949 w 388961"/>
                      <a:gd name="connsiteY33" fmla="*/ 873457 h 1228299"/>
                      <a:gd name="connsiteX34" fmla="*/ 150125 w 388961"/>
                      <a:gd name="connsiteY34" fmla="*/ 893929 h 1228299"/>
                      <a:gd name="connsiteX35" fmla="*/ 129653 w 388961"/>
                      <a:gd name="connsiteY35" fmla="*/ 900752 h 1228299"/>
                      <a:gd name="connsiteX36" fmla="*/ 88710 w 388961"/>
                      <a:gd name="connsiteY36" fmla="*/ 928048 h 1228299"/>
                      <a:gd name="connsiteX37" fmla="*/ 68238 w 388961"/>
                      <a:gd name="connsiteY37" fmla="*/ 941696 h 1228299"/>
                      <a:gd name="connsiteX38" fmla="*/ 54591 w 388961"/>
                      <a:gd name="connsiteY38" fmla="*/ 962167 h 1228299"/>
                      <a:gd name="connsiteX39" fmla="*/ 34119 w 388961"/>
                      <a:gd name="connsiteY39" fmla="*/ 968991 h 1228299"/>
                      <a:gd name="connsiteX40" fmla="*/ 61415 w 388961"/>
                      <a:gd name="connsiteY40" fmla="*/ 1030406 h 1228299"/>
                      <a:gd name="connsiteX41" fmla="*/ 75062 w 388961"/>
                      <a:gd name="connsiteY41" fmla="*/ 1050878 h 1228299"/>
                      <a:gd name="connsiteX42" fmla="*/ 116006 w 388961"/>
                      <a:gd name="connsiteY42" fmla="*/ 1064526 h 1228299"/>
                      <a:gd name="connsiteX43" fmla="*/ 122829 w 388961"/>
                      <a:gd name="connsiteY43" fmla="*/ 1166884 h 1228299"/>
                      <a:gd name="connsiteX44" fmla="*/ 109182 w 388961"/>
                      <a:gd name="connsiteY44" fmla="*/ 1187355 h 1228299"/>
                      <a:gd name="connsiteX45" fmla="*/ 68238 w 388961"/>
                      <a:gd name="connsiteY45" fmla="*/ 1214651 h 1228299"/>
                      <a:gd name="connsiteX46" fmla="*/ 27295 w 388961"/>
                      <a:gd name="connsiteY46" fmla="*/ 1228299 h 1228299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</a:cxnLst>
                    <a:rect l="l" t="t" r="r" b="b"/>
                    <a:pathLst>
                      <a:path w="388961" h="1228299">
                        <a:moveTo>
                          <a:pt x="388961" y="0"/>
                        </a:moveTo>
                        <a:cubicBezTo>
                          <a:pt x="382137" y="11373"/>
                          <a:pt x="373876" y="22000"/>
                          <a:pt x="368489" y="34120"/>
                        </a:cubicBezTo>
                        <a:cubicBezTo>
                          <a:pt x="364163" y="43852"/>
                          <a:pt x="356936" y="87854"/>
                          <a:pt x="354841" y="95534"/>
                        </a:cubicBezTo>
                        <a:cubicBezTo>
                          <a:pt x="351056" y="109413"/>
                          <a:pt x="353164" y="128498"/>
                          <a:pt x="341194" y="136478"/>
                        </a:cubicBezTo>
                        <a:cubicBezTo>
                          <a:pt x="334370" y="141027"/>
                          <a:pt x="328058" y="146458"/>
                          <a:pt x="320722" y="150126"/>
                        </a:cubicBezTo>
                        <a:cubicBezTo>
                          <a:pt x="303053" y="158960"/>
                          <a:pt x="266984" y="162806"/>
                          <a:pt x="252483" y="163773"/>
                        </a:cubicBezTo>
                        <a:cubicBezTo>
                          <a:pt x="200233" y="167256"/>
                          <a:pt x="147850" y="168322"/>
                          <a:pt x="95534" y="170597"/>
                        </a:cubicBezTo>
                        <a:cubicBezTo>
                          <a:pt x="111760" y="219275"/>
                          <a:pt x="88752" y="160424"/>
                          <a:pt x="122829" y="211540"/>
                        </a:cubicBezTo>
                        <a:cubicBezTo>
                          <a:pt x="126819" y="217525"/>
                          <a:pt x="126436" y="225578"/>
                          <a:pt x="129653" y="232012"/>
                        </a:cubicBezTo>
                        <a:cubicBezTo>
                          <a:pt x="133321" y="239348"/>
                          <a:pt x="139970" y="244989"/>
                          <a:pt x="143301" y="252484"/>
                        </a:cubicBezTo>
                        <a:cubicBezTo>
                          <a:pt x="149144" y="265630"/>
                          <a:pt x="156949" y="293427"/>
                          <a:pt x="156949" y="293427"/>
                        </a:cubicBezTo>
                        <a:cubicBezTo>
                          <a:pt x="143301" y="302526"/>
                          <a:pt x="121193" y="305162"/>
                          <a:pt x="116006" y="320723"/>
                        </a:cubicBezTo>
                        <a:lnTo>
                          <a:pt x="102358" y="361666"/>
                        </a:lnTo>
                        <a:cubicBezTo>
                          <a:pt x="104633" y="377588"/>
                          <a:pt x="104560" y="394027"/>
                          <a:pt x="109182" y="409433"/>
                        </a:cubicBezTo>
                        <a:cubicBezTo>
                          <a:pt x="114721" y="427897"/>
                          <a:pt x="140038" y="433168"/>
                          <a:pt x="116006" y="457200"/>
                        </a:cubicBezTo>
                        <a:cubicBezTo>
                          <a:pt x="109374" y="463832"/>
                          <a:pt x="97865" y="461989"/>
                          <a:pt x="88710" y="464024"/>
                        </a:cubicBezTo>
                        <a:cubicBezTo>
                          <a:pt x="77388" y="466540"/>
                          <a:pt x="65964" y="468573"/>
                          <a:pt x="54591" y="470848"/>
                        </a:cubicBezTo>
                        <a:cubicBezTo>
                          <a:pt x="50042" y="477672"/>
                          <a:pt x="47767" y="486771"/>
                          <a:pt x="40943" y="491320"/>
                        </a:cubicBezTo>
                        <a:cubicBezTo>
                          <a:pt x="-11933" y="526570"/>
                          <a:pt x="34260" y="467221"/>
                          <a:pt x="0" y="518615"/>
                        </a:cubicBezTo>
                        <a:cubicBezTo>
                          <a:pt x="17153" y="570073"/>
                          <a:pt x="-7980" y="508640"/>
                          <a:pt x="27295" y="552734"/>
                        </a:cubicBezTo>
                        <a:cubicBezTo>
                          <a:pt x="31788" y="558351"/>
                          <a:pt x="28266" y="569025"/>
                          <a:pt x="34119" y="573206"/>
                        </a:cubicBezTo>
                        <a:cubicBezTo>
                          <a:pt x="45825" y="581568"/>
                          <a:pt x="61414" y="582305"/>
                          <a:pt x="75062" y="586854"/>
                        </a:cubicBezTo>
                        <a:lnTo>
                          <a:pt x="95534" y="593678"/>
                        </a:lnTo>
                        <a:cubicBezTo>
                          <a:pt x="100083" y="600502"/>
                          <a:pt x="105514" y="606814"/>
                          <a:pt x="109182" y="614149"/>
                        </a:cubicBezTo>
                        <a:cubicBezTo>
                          <a:pt x="119019" y="633822"/>
                          <a:pt x="119809" y="654310"/>
                          <a:pt x="109182" y="675564"/>
                        </a:cubicBezTo>
                        <a:cubicBezTo>
                          <a:pt x="102450" y="689028"/>
                          <a:pt x="72032" y="693382"/>
                          <a:pt x="61415" y="696036"/>
                        </a:cubicBezTo>
                        <a:cubicBezTo>
                          <a:pt x="57916" y="706534"/>
                          <a:pt x="46717" y="726481"/>
                          <a:pt x="61415" y="736979"/>
                        </a:cubicBezTo>
                        <a:cubicBezTo>
                          <a:pt x="73121" y="745341"/>
                          <a:pt x="88710" y="746078"/>
                          <a:pt x="102358" y="750627"/>
                        </a:cubicBezTo>
                        <a:lnTo>
                          <a:pt x="143301" y="764275"/>
                        </a:lnTo>
                        <a:cubicBezTo>
                          <a:pt x="150125" y="766550"/>
                          <a:pt x="157788" y="767109"/>
                          <a:pt x="163773" y="771099"/>
                        </a:cubicBezTo>
                        <a:cubicBezTo>
                          <a:pt x="190229" y="788736"/>
                          <a:pt x="176464" y="782153"/>
                          <a:pt x="204716" y="791570"/>
                        </a:cubicBezTo>
                        <a:cubicBezTo>
                          <a:pt x="206991" y="798394"/>
                          <a:pt x="212334" y="804893"/>
                          <a:pt x="211540" y="812042"/>
                        </a:cubicBezTo>
                        <a:cubicBezTo>
                          <a:pt x="205519" y="866231"/>
                          <a:pt x="206589" y="845225"/>
                          <a:pt x="177421" y="859809"/>
                        </a:cubicBezTo>
                        <a:cubicBezTo>
                          <a:pt x="170085" y="863477"/>
                          <a:pt x="163773" y="868908"/>
                          <a:pt x="156949" y="873457"/>
                        </a:cubicBezTo>
                        <a:cubicBezTo>
                          <a:pt x="154674" y="880281"/>
                          <a:pt x="155211" y="888843"/>
                          <a:pt x="150125" y="893929"/>
                        </a:cubicBezTo>
                        <a:cubicBezTo>
                          <a:pt x="145039" y="899015"/>
                          <a:pt x="135941" y="897259"/>
                          <a:pt x="129653" y="900752"/>
                        </a:cubicBezTo>
                        <a:cubicBezTo>
                          <a:pt x="115315" y="908718"/>
                          <a:pt x="102358" y="918949"/>
                          <a:pt x="88710" y="928048"/>
                        </a:cubicBezTo>
                        <a:lnTo>
                          <a:pt x="68238" y="941696"/>
                        </a:lnTo>
                        <a:cubicBezTo>
                          <a:pt x="63689" y="948520"/>
                          <a:pt x="60995" y="957044"/>
                          <a:pt x="54591" y="962167"/>
                        </a:cubicBezTo>
                        <a:cubicBezTo>
                          <a:pt x="48974" y="966660"/>
                          <a:pt x="35864" y="962013"/>
                          <a:pt x="34119" y="968991"/>
                        </a:cubicBezTo>
                        <a:cubicBezTo>
                          <a:pt x="23284" y="1012331"/>
                          <a:pt x="37156" y="1014234"/>
                          <a:pt x="61415" y="1030406"/>
                        </a:cubicBezTo>
                        <a:cubicBezTo>
                          <a:pt x="65964" y="1037230"/>
                          <a:pt x="68107" y="1046531"/>
                          <a:pt x="75062" y="1050878"/>
                        </a:cubicBezTo>
                        <a:cubicBezTo>
                          <a:pt x="87261" y="1058503"/>
                          <a:pt x="116006" y="1064526"/>
                          <a:pt x="116006" y="1064526"/>
                        </a:cubicBezTo>
                        <a:cubicBezTo>
                          <a:pt x="131970" y="1112420"/>
                          <a:pt x="137250" y="1109198"/>
                          <a:pt x="122829" y="1166884"/>
                        </a:cubicBezTo>
                        <a:cubicBezTo>
                          <a:pt x="120840" y="1174840"/>
                          <a:pt x="115354" y="1181955"/>
                          <a:pt x="109182" y="1187355"/>
                        </a:cubicBezTo>
                        <a:cubicBezTo>
                          <a:pt x="96838" y="1198156"/>
                          <a:pt x="83799" y="1209464"/>
                          <a:pt x="68238" y="1214651"/>
                        </a:cubicBezTo>
                        <a:lnTo>
                          <a:pt x="27295" y="1228299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60000"/>
                        <a:lumOff val="4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59" name="Freeform 58"/>
                <p:cNvSpPr/>
                <p:nvPr/>
              </p:nvSpPr>
              <p:spPr>
                <a:xfrm>
                  <a:off x="4414996" y="3835021"/>
                  <a:ext cx="47822" cy="47767"/>
                </a:xfrm>
                <a:custGeom>
                  <a:avLst/>
                  <a:gdLst>
                    <a:gd name="connsiteX0" fmla="*/ 47822 w 47822"/>
                    <a:gd name="connsiteY0" fmla="*/ 0 h 47767"/>
                    <a:gd name="connsiteX1" fmla="*/ 20526 w 47822"/>
                    <a:gd name="connsiteY1" fmla="*/ 34119 h 47767"/>
                    <a:gd name="connsiteX2" fmla="*/ 55 w 47822"/>
                    <a:gd name="connsiteY2" fmla="*/ 47767 h 4776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47822" h="47767">
                      <a:moveTo>
                        <a:pt x="47822" y="0"/>
                      </a:moveTo>
                      <a:cubicBezTo>
                        <a:pt x="38723" y="11373"/>
                        <a:pt x="31584" y="24640"/>
                        <a:pt x="20526" y="34119"/>
                      </a:cubicBezTo>
                      <a:cubicBezTo>
                        <a:pt x="-2103" y="53515"/>
                        <a:pt x="55" y="30002"/>
                        <a:pt x="55" y="47767"/>
                      </a:cubicBezTo>
                    </a:path>
                  </a:pathLst>
                </a:custGeom>
                <a:noFill/>
                <a:ln>
                  <a:solidFill>
                    <a:schemeClr val="accent6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50" name="Freeform 49"/>
              <p:cNvSpPr/>
              <p:nvPr/>
            </p:nvSpPr>
            <p:spPr>
              <a:xfrm>
                <a:off x="1637934" y="1901860"/>
                <a:ext cx="131519" cy="43261"/>
              </a:xfrm>
              <a:custGeom>
                <a:avLst/>
                <a:gdLst>
                  <a:gd name="connsiteX0" fmla="*/ 218365 w 218365"/>
                  <a:gd name="connsiteY0" fmla="*/ 0 h 122830"/>
                  <a:gd name="connsiteX1" fmla="*/ 184245 w 218365"/>
                  <a:gd name="connsiteY1" fmla="*/ 13648 h 122830"/>
                  <a:gd name="connsiteX2" fmla="*/ 177421 w 218365"/>
                  <a:gd name="connsiteY2" fmla="*/ 34120 h 122830"/>
                  <a:gd name="connsiteX3" fmla="*/ 136478 w 218365"/>
                  <a:gd name="connsiteY3" fmla="*/ 47767 h 122830"/>
                  <a:gd name="connsiteX4" fmla="*/ 95535 w 218365"/>
                  <a:gd name="connsiteY4" fmla="*/ 68239 h 122830"/>
                  <a:gd name="connsiteX5" fmla="*/ 75063 w 218365"/>
                  <a:gd name="connsiteY5" fmla="*/ 81887 h 122830"/>
                  <a:gd name="connsiteX6" fmla="*/ 13648 w 218365"/>
                  <a:gd name="connsiteY6" fmla="*/ 109182 h 122830"/>
                  <a:gd name="connsiteX7" fmla="*/ 0 w 218365"/>
                  <a:gd name="connsiteY7" fmla="*/ 122830 h 1228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18365" h="122830">
                    <a:moveTo>
                      <a:pt x="218365" y="0"/>
                    </a:moveTo>
                    <a:cubicBezTo>
                      <a:pt x="206992" y="4549"/>
                      <a:pt x="193655" y="5806"/>
                      <a:pt x="184245" y="13648"/>
                    </a:cubicBezTo>
                    <a:cubicBezTo>
                      <a:pt x="178719" y="18253"/>
                      <a:pt x="183274" y="29939"/>
                      <a:pt x="177421" y="34120"/>
                    </a:cubicBezTo>
                    <a:cubicBezTo>
                      <a:pt x="165715" y="42482"/>
                      <a:pt x="148448" y="39787"/>
                      <a:pt x="136478" y="47767"/>
                    </a:cubicBezTo>
                    <a:cubicBezTo>
                      <a:pt x="77807" y="86881"/>
                      <a:pt x="152039" y="39986"/>
                      <a:pt x="95535" y="68239"/>
                    </a:cubicBezTo>
                    <a:cubicBezTo>
                      <a:pt x="88199" y="71907"/>
                      <a:pt x="82558" y="78556"/>
                      <a:pt x="75063" y="81887"/>
                    </a:cubicBezTo>
                    <a:cubicBezTo>
                      <a:pt x="32458" y="100823"/>
                      <a:pt x="42602" y="86019"/>
                      <a:pt x="13648" y="109182"/>
                    </a:cubicBezTo>
                    <a:cubicBezTo>
                      <a:pt x="8624" y="113201"/>
                      <a:pt x="4549" y="118281"/>
                      <a:pt x="0" y="122830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Freeform 50"/>
              <p:cNvSpPr/>
              <p:nvPr/>
            </p:nvSpPr>
            <p:spPr>
              <a:xfrm>
                <a:off x="665474" y="1622639"/>
                <a:ext cx="124392" cy="35450"/>
              </a:xfrm>
              <a:custGeom>
                <a:avLst/>
                <a:gdLst>
                  <a:gd name="connsiteX0" fmla="*/ 0 w 218364"/>
                  <a:gd name="connsiteY0" fmla="*/ 0 h 61511"/>
                  <a:gd name="connsiteX1" fmla="*/ 34119 w 218364"/>
                  <a:gd name="connsiteY1" fmla="*/ 20471 h 61511"/>
                  <a:gd name="connsiteX2" fmla="*/ 54591 w 218364"/>
                  <a:gd name="connsiteY2" fmla="*/ 34119 h 61511"/>
                  <a:gd name="connsiteX3" fmla="*/ 184244 w 218364"/>
                  <a:gd name="connsiteY3" fmla="*/ 54591 h 61511"/>
                  <a:gd name="connsiteX4" fmla="*/ 218364 w 218364"/>
                  <a:gd name="connsiteY4" fmla="*/ 61415 h 615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18364" h="61511">
                    <a:moveTo>
                      <a:pt x="0" y="0"/>
                    </a:moveTo>
                    <a:cubicBezTo>
                      <a:pt x="11373" y="6824"/>
                      <a:pt x="22872" y="13442"/>
                      <a:pt x="34119" y="20471"/>
                    </a:cubicBezTo>
                    <a:cubicBezTo>
                      <a:pt x="41074" y="24818"/>
                      <a:pt x="47096" y="30788"/>
                      <a:pt x="54591" y="34119"/>
                    </a:cubicBezTo>
                    <a:cubicBezTo>
                      <a:pt x="102786" y="55539"/>
                      <a:pt x="124243" y="49975"/>
                      <a:pt x="184244" y="54591"/>
                    </a:cubicBezTo>
                    <a:cubicBezTo>
                      <a:pt x="209032" y="62854"/>
                      <a:pt x="197523" y="61415"/>
                      <a:pt x="218364" y="61415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Freeform 51"/>
              <p:cNvSpPr/>
              <p:nvPr/>
            </p:nvSpPr>
            <p:spPr>
              <a:xfrm>
                <a:off x="1998800" y="1642302"/>
                <a:ext cx="85519" cy="47193"/>
              </a:xfrm>
              <a:custGeom>
                <a:avLst/>
                <a:gdLst>
                  <a:gd name="connsiteX0" fmla="*/ 150125 w 150125"/>
                  <a:gd name="connsiteY0" fmla="*/ 0 h 81887"/>
                  <a:gd name="connsiteX1" fmla="*/ 116006 w 150125"/>
                  <a:gd name="connsiteY1" fmla="*/ 6824 h 81887"/>
                  <a:gd name="connsiteX2" fmla="*/ 75062 w 150125"/>
                  <a:gd name="connsiteY2" fmla="*/ 34119 h 81887"/>
                  <a:gd name="connsiteX3" fmla="*/ 54591 w 150125"/>
                  <a:gd name="connsiteY3" fmla="*/ 47767 h 81887"/>
                  <a:gd name="connsiteX4" fmla="*/ 34119 w 150125"/>
                  <a:gd name="connsiteY4" fmla="*/ 54591 h 81887"/>
                  <a:gd name="connsiteX5" fmla="*/ 0 w 150125"/>
                  <a:gd name="connsiteY5" fmla="*/ 81887 h 818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50125" h="81887">
                    <a:moveTo>
                      <a:pt x="150125" y="0"/>
                    </a:moveTo>
                    <a:cubicBezTo>
                      <a:pt x="138752" y="2275"/>
                      <a:pt x="126565" y="2025"/>
                      <a:pt x="116006" y="6824"/>
                    </a:cubicBezTo>
                    <a:cubicBezTo>
                      <a:pt x="101074" y="13611"/>
                      <a:pt x="88710" y="25020"/>
                      <a:pt x="75062" y="34119"/>
                    </a:cubicBezTo>
                    <a:cubicBezTo>
                      <a:pt x="68238" y="38668"/>
                      <a:pt x="62371" y="45174"/>
                      <a:pt x="54591" y="47767"/>
                    </a:cubicBezTo>
                    <a:cubicBezTo>
                      <a:pt x="47767" y="50042"/>
                      <a:pt x="40553" y="51374"/>
                      <a:pt x="34119" y="54591"/>
                    </a:cubicBezTo>
                    <a:cubicBezTo>
                      <a:pt x="16901" y="63200"/>
                      <a:pt x="12694" y="69192"/>
                      <a:pt x="0" y="81887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Freeform 52"/>
              <p:cNvSpPr/>
              <p:nvPr/>
            </p:nvSpPr>
            <p:spPr>
              <a:xfrm>
                <a:off x="778628" y="1656132"/>
                <a:ext cx="207369" cy="64937"/>
              </a:xfrm>
              <a:custGeom>
                <a:avLst/>
                <a:gdLst>
                  <a:gd name="connsiteX0" fmla="*/ 0 w 364026"/>
                  <a:gd name="connsiteY0" fmla="*/ 0 h 112675"/>
                  <a:gd name="connsiteX1" fmla="*/ 65005 w 364026"/>
                  <a:gd name="connsiteY1" fmla="*/ 13001 h 112675"/>
                  <a:gd name="connsiteX2" fmla="*/ 91007 w 364026"/>
                  <a:gd name="connsiteY2" fmla="*/ 21668 h 112675"/>
                  <a:gd name="connsiteX3" fmla="*/ 104007 w 364026"/>
                  <a:gd name="connsiteY3" fmla="*/ 26002 h 112675"/>
                  <a:gd name="connsiteX4" fmla="*/ 134343 w 364026"/>
                  <a:gd name="connsiteY4" fmla="*/ 39003 h 112675"/>
                  <a:gd name="connsiteX5" fmla="*/ 177680 w 364026"/>
                  <a:gd name="connsiteY5" fmla="*/ 52004 h 112675"/>
                  <a:gd name="connsiteX6" fmla="*/ 212349 w 364026"/>
                  <a:gd name="connsiteY6" fmla="*/ 60671 h 112675"/>
                  <a:gd name="connsiteX7" fmla="*/ 238351 w 364026"/>
                  <a:gd name="connsiteY7" fmla="*/ 69338 h 112675"/>
                  <a:gd name="connsiteX8" fmla="*/ 303355 w 364026"/>
                  <a:gd name="connsiteY8" fmla="*/ 91006 h 112675"/>
                  <a:gd name="connsiteX9" fmla="*/ 329357 w 364026"/>
                  <a:gd name="connsiteY9" fmla="*/ 99674 h 112675"/>
                  <a:gd name="connsiteX10" fmla="*/ 355359 w 364026"/>
                  <a:gd name="connsiteY10" fmla="*/ 108341 h 112675"/>
                  <a:gd name="connsiteX11" fmla="*/ 364026 w 364026"/>
                  <a:gd name="connsiteY11" fmla="*/ 112675 h 1126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</a:cxnLst>
                <a:rect l="l" t="t" r="r" b="b"/>
                <a:pathLst>
                  <a:path w="364026" h="112675">
                    <a:moveTo>
                      <a:pt x="0" y="0"/>
                    </a:moveTo>
                    <a:cubicBezTo>
                      <a:pt x="48090" y="5342"/>
                      <a:pt x="26589" y="196"/>
                      <a:pt x="65005" y="13001"/>
                    </a:cubicBezTo>
                    <a:lnTo>
                      <a:pt x="91007" y="21668"/>
                    </a:lnTo>
                    <a:lnTo>
                      <a:pt x="104007" y="26002"/>
                    </a:lnTo>
                    <a:cubicBezTo>
                      <a:pt x="118290" y="40283"/>
                      <a:pt x="107936" y="33135"/>
                      <a:pt x="134343" y="39003"/>
                    </a:cubicBezTo>
                    <a:cubicBezTo>
                      <a:pt x="154004" y="43372"/>
                      <a:pt x="156055" y="44796"/>
                      <a:pt x="177680" y="52004"/>
                    </a:cubicBezTo>
                    <a:cubicBezTo>
                      <a:pt x="217107" y="65147"/>
                      <a:pt x="154854" y="44991"/>
                      <a:pt x="212349" y="60671"/>
                    </a:cubicBezTo>
                    <a:cubicBezTo>
                      <a:pt x="221163" y="63075"/>
                      <a:pt x="229684" y="66449"/>
                      <a:pt x="238351" y="69338"/>
                    </a:cubicBezTo>
                    <a:lnTo>
                      <a:pt x="303355" y="91006"/>
                    </a:lnTo>
                    <a:lnTo>
                      <a:pt x="329357" y="99674"/>
                    </a:lnTo>
                    <a:lnTo>
                      <a:pt x="355359" y="108341"/>
                    </a:lnTo>
                    <a:lnTo>
                      <a:pt x="364026" y="112675"/>
                    </a:ln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Freeform 53"/>
              <p:cNvSpPr/>
              <p:nvPr/>
            </p:nvSpPr>
            <p:spPr>
              <a:xfrm>
                <a:off x="1793255" y="1683605"/>
                <a:ext cx="212306" cy="64938"/>
              </a:xfrm>
              <a:custGeom>
                <a:avLst/>
                <a:gdLst>
                  <a:gd name="connsiteX0" fmla="*/ 372694 w 372694"/>
                  <a:gd name="connsiteY0" fmla="*/ 0 h 112678"/>
                  <a:gd name="connsiteX1" fmla="*/ 351025 w 372694"/>
                  <a:gd name="connsiteY1" fmla="*/ 13001 h 112678"/>
                  <a:gd name="connsiteX2" fmla="*/ 325023 w 372694"/>
                  <a:gd name="connsiteY2" fmla="*/ 21668 h 112678"/>
                  <a:gd name="connsiteX3" fmla="*/ 303355 w 372694"/>
                  <a:gd name="connsiteY3" fmla="*/ 39003 h 112678"/>
                  <a:gd name="connsiteX4" fmla="*/ 277353 w 372694"/>
                  <a:gd name="connsiteY4" fmla="*/ 47670 h 112678"/>
                  <a:gd name="connsiteX5" fmla="*/ 264352 w 372694"/>
                  <a:gd name="connsiteY5" fmla="*/ 56337 h 112678"/>
                  <a:gd name="connsiteX6" fmla="*/ 238350 w 372694"/>
                  <a:gd name="connsiteY6" fmla="*/ 65005 h 112678"/>
                  <a:gd name="connsiteX7" fmla="*/ 212349 w 372694"/>
                  <a:gd name="connsiteY7" fmla="*/ 73672 h 112678"/>
                  <a:gd name="connsiteX8" fmla="*/ 186347 w 372694"/>
                  <a:gd name="connsiteY8" fmla="*/ 82339 h 112678"/>
                  <a:gd name="connsiteX9" fmla="*/ 112675 w 372694"/>
                  <a:gd name="connsiteY9" fmla="*/ 86673 h 112678"/>
                  <a:gd name="connsiteX10" fmla="*/ 86673 w 372694"/>
                  <a:gd name="connsiteY10" fmla="*/ 95340 h 112678"/>
                  <a:gd name="connsiteX11" fmla="*/ 73672 w 372694"/>
                  <a:gd name="connsiteY11" fmla="*/ 99674 h 112678"/>
                  <a:gd name="connsiteX12" fmla="*/ 30335 w 372694"/>
                  <a:gd name="connsiteY12" fmla="*/ 104008 h 112678"/>
                  <a:gd name="connsiteX13" fmla="*/ 0 w 372694"/>
                  <a:gd name="connsiteY13" fmla="*/ 112675 h 1126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372694" h="112678">
                    <a:moveTo>
                      <a:pt x="372694" y="0"/>
                    </a:moveTo>
                    <a:cubicBezTo>
                      <a:pt x="365471" y="4334"/>
                      <a:pt x="358693" y="9515"/>
                      <a:pt x="351025" y="13001"/>
                    </a:cubicBezTo>
                    <a:cubicBezTo>
                      <a:pt x="342708" y="16781"/>
                      <a:pt x="325023" y="21668"/>
                      <a:pt x="325023" y="21668"/>
                    </a:cubicBezTo>
                    <a:cubicBezTo>
                      <a:pt x="317818" y="28873"/>
                      <a:pt x="313197" y="34629"/>
                      <a:pt x="303355" y="39003"/>
                    </a:cubicBezTo>
                    <a:cubicBezTo>
                      <a:pt x="295006" y="42713"/>
                      <a:pt x="284955" y="42602"/>
                      <a:pt x="277353" y="47670"/>
                    </a:cubicBezTo>
                    <a:cubicBezTo>
                      <a:pt x="273019" y="50559"/>
                      <a:pt x="269111" y="54222"/>
                      <a:pt x="264352" y="56337"/>
                    </a:cubicBezTo>
                    <a:cubicBezTo>
                      <a:pt x="256003" y="60048"/>
                      <a:pt x="247017" y="62116"/>
                      <a:pt x="238350" y="65005"/>
                    </a:cubicBezTo>
                    <a:lnTo>
                      <a:pt x="212349" y="73672"/>
                    </a:lnTo>
                    <a:cubicBezTo>
                      <a:pt x="212345" y="73673"/>
                      <a:pt x="186352" y="82339"/>
                      <a:pt x="186347" y="82339"/>
                    </a:cubicBezTo>
                    <a:lnTo>
                      <a:pt x="112675" y="86673"/>
                    </a:lnTo>
                    <a:lnTo>
                      <a:pt x="86673" y="95340"/>
                    </a:lnTo>
                    <a:cubicBezTo>
                      <a:pt x="82339" y="96785"/>
                      <a:pt x="78217" y="99219"/>
                      <a:pt x="73672" y="99674"/>
                    </a:cubicBezTo>
                    <a:lnTo>
                      <a:pt x="30335" y="104008"/>
                    </a:lnTo>
                    <a:cubicBezTo>
                      <a:pt x="2963" y="113132"/>
                      <a:pt x="13469" y="112675"/>
                      <a:pt x="0" y="112675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Freeform 54"/>
              <p:cNvSpPr/>
              <p:nvPr/>
            </p:nvSpPr>
            <p:spPr>
              <a:xfrm>
                <a:off x="1397310" y="755553"/>
                <a:ext cx="18065" cy="429507"/>
              </a:xfrm>
              <a:custGeom>
                <a:avLst/>
                <a:gdLst>
                  <a:gd name="connsiteX0" fmla="*/ 21142 w 31713"/>
                  <a:gd name="connsiteY0" fmla="*/ 0 h 745262"/>
                  <a:gd name="connsiteX1" fmla="*/ 15856 w 31713"/>
                  <a:gd name="connsiteY1" fmla="*/ 26428 h 745262"/>
                  <a:gd name="connsiteX2" fmla="*/ 5285 w 31713"/>
                  <a:gd name="connsiteY2" fmla="*/ 42284 h 745262"/>
                  <a:gd name="connsiteX3" fmla="*/ 0 w 31713"/>
                  <a:gd name="connsiteY3" fmla="*/ 58141 h 745262"/>
                  <a:gd name="connsiteX4" fmla="*/ 5285 w 31713"/>
                  <a:gd name="connsiteY4" fmla="*/ 137424 h 745262"/>
                  <a:gd name="connsiteX5" fmla="*/ 26427 w 31713"/>
                  <a:gd name="connsiteY5" fmla="*/ 184994 h 745262"/>
                  <a:gd name="connsiteX6" fmla="*/ 31713 w 31713"/>
                  <a:gd name="connsiteY6" fmla="*/ 200851 h 745262"/>
                  <a:gd name="connsiteX7" fmla="*/ 26427 w 31713"/>
                  <a:gd name="connsiteY7" fmla="*/ 391131 h 745262"/>
                  <a:gd name="connsiteX8" fmla="*/ 21142 w 31713"/>
                  <a:gd name="connsiteY8" fmla="*/ 412273 h 745262"/>
                  <a:gd name="connsiteX9" fmla="*/ 26427 w 31713"/>
                  <a:gd name="connsiteY9" fmla="*/ 560268 h 745262"/>
                  <a:gd name="connsiteX10" fmla="*/ 21142 w 31713"/>
                  <a:gd name="connsiteY10" fmla="*/ 671265 h 745262"/>
                  <a:gd name="connsiteX11" fmla="*/ 10571 w 31713"/>
                  <a:gd name="connsiteY11" fmla="*/ 702978 h 745262"/>
                  <a:gd name="connsiteX12" fmla="*/ 10571 w 31713"/>
                  <a:gd name="connsiteY12" fmla="*/ 745262 h 7452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31713" h="745262">
                    <a:moveTo>
                      <a:pt x="21142" y="0"/>
                    </a:moveTo>
                    <a:cubicBezTo>
                      <a:pt x="19380" y="8809"/>
                      <a:pt x="19011" y="18016"/>
                      <a:pt x="15856" y="26428"/>
                    </a:cubicBezTo>
                    <a:cubicBezTo>
                      <a:pt x="13626" y="32376"/>
                      <a:pt x="8126" y="36602"/>
                      <a:pt x="5285" y="42284"/>
                    </a:cubicBezTo>
                    <a:cubicBezTo>
                      <a:pt x="2793" y="47267"/>
                      <a:pt x="1762" y="52855"/>
                      <a:pt x="0" y="58141"/>
                    </a:cubicBezTo>
                    <a:cubicBezTo>
                      <a:pt x="1762" y="84569"/>
                      <a:pt x="1539" y="111204"/>
                      <a:pt x="5285" y="137424"/>
                    </a:cubicBezTo>
                    <a:cubicBezTo>
                      <a:pt x="10740" y="175607"/>
                      <a:pt x="13737" y="159614"/>
                      <a:pt x="26427" y="184994"/>
                    </a:cubicBezTo>
                    <a:cubicBezTo>
                      <a:pt x="28919" y="189977"/>
                      <a:pt x="29951" y="195565"/>
                      <a:pt x="31713" y="200851"/>
                    </a:cubicBezTo>
                    <a:cubicBezTo>
                      <a:pt x="29951" y="264278"/>
                      <a:pt x="29596" y="327759"/>
                      <a:pt x="26427" y="391131"/>
                    </a:cubicBezTo>
                    <a:cubicBezTo>
                      <a:pt x="26064" y="398386"/>
                      <a:pt x="21142" y="405009"/>
                      <a:pt x="21142" y="412273"/>
                    </a:cubicBezTo>
                    <a:cubicBezTo>
                      <a:pt x="21142" y="461636"/>
                      <a:pt x="24665" y="510936"/>
                      <a:pt x="26427" y="560268"/>
                    </a:cubicBezTo>
                    <a:cubicBezTo>
                      <a:pt x="24665" y="597267"/>
                      <a:pt x="25232" y="634451"/>
                      <a:pt x="21142" y="671265"/>
                    </a:cubicBezTo>
                    <a:cubicBezTo>
                      <a:pt x="19912" y="682340"/>
                      <a:pt x="10571" y="691835"/>
                      <a:pt x="10571" y="702978"/>
                    </a:cubicBezTo>
                    <a:lnTo>
                      <a:pt x="10571" y="745262"/>
                    </a:ln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Freeform 55"/>
              <p:cNvSpPr/>
              <p:nvPr/>
            </p:nvSpPr>
            <p:spPr>
              <a:xfrm>
                <a:off x="1370212" y="1182015"/>
                <a:ext cx="30109" cy="898615"/>
              </a:xfrm>
              <a:custGeom>
                <a:avLst/>
                <a:gdLst>
                  <a:gd name="connsiteX0" fmla="*/ 52855 w 52855"/>
                  <a:gd name="connsiteY0" fmla="*/ 0 h 1559237"/>
                  <a:gd name="connsiteX1" fmla="*/ 47570 w 52855"/>
                  <a:gd name="connsiteY1" fmla="*/ 126853 h 1559237"/>
                  <a:gd name="connsiteX2" fmla="*/ 42284 w 52855"/>
                  <a:gd name="connsiteY2" fmla="*/ 216707 h 1559237"/>
                  <a:gd name="connsiteX3" fmla="*/ 31713 w 52855"/>
                  <a:gd name="connsiteY3" fmla="*/ 523269 h 1559237"/>
                  <a:gd name="connsiteX4" fmla="*/ 26427 w 52855"/>
                  <a:gd name="connsiteY4" fmla="*/ 861544 h 1559237"/>
                  <a:gd name="connsiteX5" fmla="*/ 15856 w 52855"/>
                  <a:gd name="connsiteY5" fmla="*/ 1057110 h 1559237"/>
                  <a:gd name="connsiteX6" fmla="*/ 5285 w 52855"/>
                  <a:gd name="connsiteY6" fmla="*/ 1231533 h 1559237"/>
                  <a:gd name="connsiteX7" fmla="*/ 0 w 52855"/>
                  <a:gd name="connsiteY7" fmla="*/ 1416527 h 1559237"/>
                  <a:gd name="connsiteX8" fmla="*/ 5285 w 52855"/>
                  <a:gd name="connsiteY8" fmla="*/ 1559237 h 15592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2855" h="1559237">
                    <a:moveTo>
                      <a:pt x="52855" y="0"/>
                    </a:moveTo>
                    <a:cubicBezTo>
                      <a:pt x="51093" y="42284"/>
                      <a:pt x="49632" y="84582"/>
                      <a:pt x="47570" y="126853"/>
                    </a:cubicBezTo>
                    <a:cubicBezTo>
                      <a:pt x="46108" y="156820"/>
                      <a:pt x="43267" y="186720"/>
                      <a:pt x="42284" y="216707"/>
                    </a:cubicBezTo>
                    <a:cubicBezTo>
                      <a:pt x="31651" y="540996"/>
                      <a:pt x="44048" y="350560"/>
                      <a:pt x="31713" y="523269"/>
                    </a:cubicBezTo>
                    <a:cubicBezTo>
                      <a:pt x="29951" y="636027"/>
                      <a:pt x="29111" y="748804"/>
                      <a:pt x="26427" y="861544"/>
                    </a:cubicBezTo>
                    <a:cubicBezTo>
                      <a:pt x="25101" y="917247"/>
                      <a:pt x="18573" y="1000046"/>
                      <a:pt x="15856" y="1057110"/>
                    </a:cubicBezTo>
                    <a:cubicBezTo>
                      <a:pt x="8202" y="1217854"/>
                      <a:pt x="16620" y="1140863"/>
                      <a:pt x="5285" y="1231533"/>
                    </a:cubicBezTo>
                    <a:cubicBezTo>
                      <a:pt x="3523" y="1293198"/>
                      <a:pt x="0" y="1354837"/>
                      <a:pt x="0" y="1416527"/>
                    </a:cubicBezTo>
                    <a:cubicBezTo>
                      <a:pt x="0" y="1464130"/>
                      <a:pt x="5285" y="1511634"/>
                      <a:pt x="5285" y="1559237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Freeform 56"/>
              <p:cNvSpPr/>
              <p:nvPr/>
            </p:nvSpPr>
            <p:spPr>
              <a:xfrm>
                <a:off x="1346124" y="2077583"/>
                <a:ext cx="24088" cy="590954"/>
              </a:xfrm>
              <a:custGeom>
                <a:avLst/>
                <a:gdLst>
                  <a:gd name="connsiteX0" fmla="*/ 42285 w 42285"/>
                  <a:gd name="connsiteY0" fmla="*/ 0 h 1025397"/>
                  <a:gd name="connsiteX1" fmla="*/ 36999 w 42285"/>
                  <a:gd name="connsiteY1" fmla="*/ 121568 h 1025397"/>
                  <a:gd name="connsiteX2" fmla="*/ 31713 w 42285"/>
                  <a:gd name="connsiteY2" fmla="*/ 169138 h 1025397"/>
                  <a:gd name="connsiteX3" fmla="*/ 36999 w 42285"/>
                  <a:gd name="connsiteY3" fmla="*/ 243136 h 1025397"/>
                  <a:gd name="connsiteX4" fmla="*/ 31713 w 42285"/>
                  <a:gd name="connsiteY4" fmla="*/ 438701 h 1025397"/>
                  <a:gd name="connsiteX5" fmla="*/ 26428 w 42285"/>
                  <a:gd name="connsiteY5" fmla="*/ 454558 h 1025397"/>
                  <a:gd name="connsiteX6" fmla="*/ 21142 w 42285"/>
                  <a:gd name="connsiteY6" fmla="*/ 480985 h 1025397"/>
                  <a:gd name="connsiteX7" fmla="*/ 15857 w 42285"/>
                  <a:gd name="connsiteY7" fmla="*/ 576125 h 1025397"/>
                  <a:gd name="connsiteX8" fmla="*/ 10571 w 42285"/>
                  <a:gd name="connsiteY8" fmla="*/ 613124 h 1025397"/>
                  <a:gd name="connsiteX9" fmla="*/ 0 w 42285"/>
                  <a:gd name="connsiteY9" fmla="*/ 819260 h 1025397"/>
                  <a:gd name="connsiteX10" fmla="*/ 15857 w 42285"/>
                  <a:gd name="connsiteY10" fmla="*/ 951399 h 1025397"/>
                  <a:gd name="connsiteX11" fmla="*/ 26428 w 42285"/>
                  <a:gd name="connsiteY11" fmla="*/ 983113 h 1025397"/>
                  <a:gd name="connsiteX12" fmla="*/ 31713 w 42285"/>
                  <a:gd name="connsiteY12" fmla="*/ 998969 h 1025397"/>
                  <a:gd name="connsiteX13" fmla="*/ 36999 w 42285"/>
                  <a:gd name="connsiteY13" fmla="*/ 1025397 h 10253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42285" h="1025397">
                    <a:moveTo>
                      <a:pt x="42285" y="0"/>
                    </a:moveTo>
                    <a:cubicBezTo>
                      <a:pt x="40523" y="40523"/>
                      <a:pt x="39529" y="81086"/>
                      <a:pt x="36999" y="121568"/>
                    </a:cubicBezTo>
                    <a:cubicBezTo>
                      <a:pt x="36004" y="137491"/>
                      <a:pt x="31713" y="153184"/>
                      <a:pt x="31713" y="169138"/>
                    </a:cubicBezTo>
                    <a:cubicBezTo>
                      <a:pt x="31713" y="193867"/>
                      <a:pt x="35237" y="218470"/>
                      <a:pt x="36999" y="243136"/>
                    </a:cubicBezTo>
                    <a:cubicBezTo>
                      <a:pt x="35237" y="308324"/>
                      <a:pt x="34970" y="373570"/>
                      <a:pt x="31713" y="438701"/>
                    </a:cubicBezTo>
                    <a:cubicBezTo>
                      <a:pt x="31435" y="444266"/>
                      <a:pt x="27779" y="449153"/>
                      <a:pt x="26428" y="454558"/>
                    </a:cubicBezTo>
                    <a:cubicBezTo>
                      <a:pt x="24249" y="463273"/>
                      <a:pt x="22904" y="472176"/>
                      <a:pt x="21142" y="480985"/>
                    </a:cubicBezTo>
                    <a:cubicBezTo>
                      <a:pt x="19380" y="512698"/>
                      <a:pt x="18390" y="544464"/>
                      <a:pt x="15857" y="576125"/>
                    </a:cubicBezTo>
                    <a:cubicBezTo>
                      <a:pt x="14864" y="588544"/>
                      <a:pt x="11178" y="600681"/>
                      <a:pt x="10571" y="613124"/>
                    </a:cubicBezTo>
                    <a:cubicBezTo>
                      <a:pt x="188" y="825980"/>
                      <a:pt x="17765" y="730445"/>
                      <a:pt x="0" y="819260"/>
                    </a:cubicBezTo>
                    <a:cubicBezTo>
                      <a:pt x="5872" y="930823"/>
                      <a:pt x="-5315" y="887881"/>
                      <a:pt x="15857" y="951399"/>
                    </a:cubicBezTo>
                    <a:lnTo>
                      <a:pt x="26428" y="983113"/>
                    </a:lnTo>
                    <a:cubicBezTo>
                      <a:pt x="28190" y="988398"/>
                      <a:pt x="30620" y="993506"/>
                      <a:pt x="31713" y="998969"/>
                    </a:cubicBezTo>
                    <a:lnTo>
                      <a:pt x="36999" y="1025397"/>
                    </a:ln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9" name="Freeform 88"/>
            <p:cNvSpPr/>
            <p:nvPr/>
          </p:nvSpPr>
          <p:spPr>
            <a:xfrm>
              <a:off x="3504510" y="3963779"/>
              <a:ext cx="339280" cy="103439"/>
            </a:xfrm>
            <a:custGeom>
              <a:avLst/>
              <a:gdLst>
                <a:gd name="connsiteX0" fmla="*/ 0 w 339280"/>
                <a:gd name="connsiteY0" fmla="*/ 103439 h 103439"/>
                <a:gd name="connsiteX1" fmla="*/ 20688 w 339280"/>
                <a:gd name="connsiteY1" fmla="*/ 99302 h 103439"/>
                <a:gd name="connsiteX2" fmla="*/ 45514 w 339280"/>
                <a:gd name="connsiteY2" fmla="*/ 91026 h 103439"/>
                <a:gd name="connsiteX3" fmla="*/ 62064 w 339280"/>
                <a:gd name="connsiteY3" fmla="*/ 86889 h 103439"/>
                <a:gd name="connsiteX4" fmla="*/ 74476 w 339280"/>
                <a:gd name="connsiteY4" fmla="*/ 82751 h 103439"/>
                <a:gd name="connsiteX5" fmla="*/ 132402 w 339280"/>
                <a:gd name="connsiteY5" fmla="*/ 66201 h 103439"/>
                <a:gd name="connsiteX6" fmla="*/ 169640 w 339280"/>
                <a:gd name="connsiteY6" fmla="*/ 53788 h 103439"/>
                <a:gd name="connsiteX7" fmla="*/ 182053 w 339280"/>
                <a:gd name="connsiteY7" fmla="*/ 49651 h 103439"/>
                <a:gd name="connsiteX8" fmla="*/ 194466 w 339280"/>
                <a:gd name="connsiteY8" fmla="*/ 41376 h 103439"/>
                <a:gd name="connsiteX9" fmla="*/ 219291 w 339280"/>
                <a:gd name="connsiteY9" fmla="*/ 33101 h 103439"/>
                <a:gd name="connsiteX10" fmla="*/ 256529 w 339280"/>
                <a:gd name="connsiteY10" fmla="*/ 16550 h 103439"/>
                <a:gd name="connsiteX11" fmla="*/ 268942 w 339280"/>
                <a:gd name="connsiteY11" fmla="*/ 12413 h 103439"/>
                <a:gd name="connsiteX12" fmla="*/ 322730 w 339280"/>
                <a:gd name="connsiteY12" fmla="*/ 0 h 103439"/>
                <a:gd name="connsiteX13" fmla="*/ 339280 w 339280"/>
                <a:gd name="connsiteY13" fmla="*/ 0 h 103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339280" h="103439">
                  <a:moveTo>
                    <a:pt x="0" y="103439"/>
                  </a:moveTo>
                  <a:cubicBezTo>
                    <a:pt x="6896" y="102060"/>
                    <a:pt x="13903" y="101152"/>
                    <a:pt x="20688" y="99302"/>
                  </a:cubicBezTo>
                  <a:cubicBezTo>
                    <a:pt x="29104" y="97007"/>
                    <a:pt x="37051" y="93141"/>
                    <a:pt x="45514" y="91026"/>
                  </a:cubicBezTo>
                  <a:cubicBezTo>
                    <a:pt x="51031" y="89647"/>
                    <a:pt x="56596" y="88451"/>
                    <a:pt x="62064" y="86889"/>
                  </a:cubicBezTo>
                  <a:cubicBezTo>
                    <a:pt x="66257" y="85691"/>
                    <a:pt x="70268" y="83899"/>
                    <a:pt x="74476" y="82751"/>
                  </a:cubicBezTo>
                  <a:cubicBezTo>
                    <a:pt x="131656" y="67156"/>
                    <a:pt x="84810" y="82064"/>
                    <a:pt x="132402" y="66201"/>
                  </a:cubicBezTo>
                  <a:lnTo>
                    <a:pt x="169640" y="53788"/>
                  </a:lnTo>
                  <a:lnTo>
                    <a:pt x="182053" y="49651"/>
                  </a:lnTo>
                  <a:cubicBezTo>
                    <a:pt x="186191" y="46893"/>
                    <a:pt x="189922" y="43396"/>
                    <a:pt x="194466" y="41376"/>
                  </a:cubicBezTo>
                  <a:cubicBezTo>
                    <a:pt x="202437" y="37833"/>
                    <a:pt x="219291" y="33101"/>
                    <a:pt x="219291" y="33101"/>
                  </a:cubicBezTo>
                  <a:cubicBezTo>
                    <a:pt x="238960" y="19989"/>
                    <a:pt x="226989" y="26397"/>
                    <a:pt x="256529" y="16550"/>
                  </a:cubicBezTo>
                  <a:lnTo>
                    <a:pt x="268942" y="12413"/>
                  </a:lnTo>
                  <a:cubicBezTo>
                    <a:pt x="286208" y="6658"/>
                    <a:pt x="304455" y="0"/>
                    <a:pt x="322730" y="0"/>
                  </a:cubicBezTo>
                  <a:lnTo>
                    <a:pt x="339280" y="0"/>
                  </a:lnTo>
                </a:path>
              </a:pathLst>
            </a:cu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Freeform 89"/>
            <p:cNvSpPr/>
            <p:nvPr/>
          </p:nvSpPr>
          <p:spPr>
            <a:xfrm>
              <a:off x="5337448" y="4042393"/>
              <a:ext cx="277216" cy="140688"/>
            </a:xfrm>
            <a:custGeom>
              <a:avLst/>
              <a:gdLst>
                <a:gd name="connsiteX0" fmla="*/ 0 w 277216"/>
                <a:gd name="connsiteY0" fmla="*/ 12412 h 140688"/>
                <a:gd name="connsiteX1" fmla="*/ 20688 w 277216"/>
                <a:gd name="connsiteY1" fmla="*/ 8275 h 140688"/>
                <a:gd name="connsiteX2" fmla="*/ 33100 w 277216"/>
                <a:gd name="connsiteY2" fmla="*/ 4137 h 140688"/>
                <a:gd name="connsiteX3" fmla="*/ 49651 w 277216"/>
                <a:gd name="connsiteY3" fmla="*/ 0 h 140688"/>
                <a:gd name="connsiteX4" fmla="*/ 95164 w 277216"/>
                <a:gd name="connsiteY4" fmla="*/ 8275 h 140688"/>
                <a:gd name="connsiteX5" fmla="*/ 115852 w 277216"/>
                <a:gd name="connsiteY5" fmla="*/ 24825 h 140688"/>
                <a:gd name="connsiteX6" fmla="*/ 128264 w 277216"/>
                <a:gd name="connsiteY6" fmla="*/ 33100 h 140688"/>
                <a:gd name="connsiteX7" fmla="*/ 132402 w 277216"/>
                <a:gd name="connsiteY7" fmla="*/ 45513 h 140688"/>
                <a:gd name="connsiteX8" fmla="*/ 144814 w 277216"/>
                <a:gd name="connsiteY8" fmla="*/ 53788 h 140688"/>
                <a:gd name="connsiteX9" fmla="*/ 153090 w 277216"/>
                <a:gd name="connsiteY9" fmla="*/ 66201 h 140688"/>
                <a:gd name="connsiteX10" fmla="*/ 161365 w 277216"/>
                <a:gd name="connsiteY10" fmla="*/ 91026 h 140688"/>
                <a:gd name="connsiteX11" fmla="*/ 186190 w 277216"/>
                <a:gd name="connsiteY11" fmla="*/ 107576 h 140688"/>
                <a:gd name="connsiteX12" fmla="*/ 198603 w 277216"/>
                <a:gd name="connsiteY12" fmla="*/ 115851 h 140688"/>
                <a:gd name="connsiteX13" fmla="*/ 248253 w 277216"/>
                <a:gd name="connsiteY13" fmla="*/ 132402 h 140688"/>
                <a:gd name="connsiteX14" fmla="*/ 260666 w 277216"/>
                <a:gd name="connsiteY14" fmla="*/ 136539 h 140688"/>
                <a:gd name="connsiteX15" fmla="*/ 277216 w 277216"/>
                <a:gd name="connsiteY15" fmla="*/ 140677 h 1406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277216" h="140688">
                  <a:moveTo>
                    <a:pt x="0" y="12412"/>
                  </a:moveTo>
                  <a:cubicBezTo>
                    <a:pt x="6896" y="11033"/>
                    <a:pt x="13865" y="9981"/>
                    <a:pt x="20688" y="8275"/>
                  </a:cubicBezTo>
                  <a:cubicBezTo>
                    <a:pt x="24919" y="7217"/>
                    <a:pt x="28907" y="5335"/>
                    <a:pt x="33100" y="4137"/>
                  </a:cubicBezTo>
                  <a:cubicBezTo>
                    <a:pt x="38568" y="2575"/>
                    <a:pt x="44134" y="1379"/>
                    <a:pt x="49651" y="0"/>
                  </a:cubicBezTo>
                  <a:cubicBezTo>
                    <a:pt x="61066" y="1427"/>
                    <a:pt x="82406" y="1896"/>
                    <a:pt x="95164" y="8275"/>
                  </a:cubicBezTo>
                  <a:cubicBezTo>
                    <a:pt x="112138" y="16763"/>
                    <a:pt x="103027" y="14565"/>
                    <a:pt x="115852" y="24825"/>
                  </a:cubicBezTo>
                  <a:cubicBezTo>
                    <a:pt x="119735" y="27931"/>
                    <a:pt x="124127" y="30342"/>
                    <a:pt x="128264" y="33100"/>
                  </a:cubicBezTo>
                  <a:cubicBezTo>
                    <a:pt x="129643" y="37238"/>
                    <a:pt x="129677" y="42107"/>
                    <a:pt x="132402" y="45513"/>
                  </a:cubicBezTo>
                  <a:cubicBezTo>
                    <a:pt x="135508" y="49396"/>
                    <a:pt x="141298" y="50272"/>
                    <a:pt x="144814" y="53788"/>
                  </a:cubicBezTo>
                  <a:cubicBezTo>
                    <a:pt x="148330" y="57304"/>
                    <a:pt x="150331" y="62063"/>
                    <a:pt x="153090" y="66201"/>
                  </a:cubicBezTo>
                  <a:cubicBezTo>
                    <a:pt x="155848" y="74476"/>
                    <a:pt x="154107" y="86188"/>
                    <a:pt x="161365" y="91026"/>
                  </a:cubicBezTo>
                  <a:lnTo>
                    <a:pt x="186190" y="107576"/>
                  </a:lnTo>
                  <a:cubicBezTo>
                    <a:pt x="190328" y="110334"/>
                    <a:pt x="193885" y="114278"/>
                    <a:pt x="198603" y="115851"/>
                  </a:cubicBezTo>
                  <a:lnTo>
                    <a:pt x="248253" y="132402"/>
                  </a:lnTo>
                  <a:lnTo>
                    <a:pt x="260666" y="136539"/>
                  </a:lnTo>
                  <a:cubicBezTo>
                    <a:pt x="274389" y="141113"/>
                    <a:pt x="268717" y="140677"/>
                    <a:pt x="277216" y="140677"/>
                  </a:cubicBezTo>
                </a:path>
              </a:pathLst>
            </a:cu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2" name="Freeform 91"/>
            <p:cNvSpPr/>
            <p:nvPr/>
          </p:nvSpPr>
          <p:spPr>
            <a:xfrm>
              <a:off x="3529336" y="3769314"/>
              <a:ext cx="442718" cy="533745"/>
            </a:xfrm>
            <a:custGeom>
              <a:avLst/>
              <a:gdLst>
                <a:gd name="connsiteX0" fmla="*/ 0 w 442718"/>
                <a:gd name="connsiteY0" fmla="*/ 148952 h 533745"/>
                <a:gd name="connsiteX1" fmla="*/ 20688 w 442718"/>
                <a:gd name="connsiteY1" fmla="*/ 140677 h 533745"/>
                <a:gd name="connsiteX2" fmla="*/ 45513 w 442718"/>
                <a:gd name="connsiteY2" fmla="*/ 124127 h 533745"/>
                <a:gd name="connsiteX3" fmla="*/ 62063 w 442718"/>
                <a:gd name="connsiteY3" fmla="*/ 99301 h 533745"/>
                <a:gd name="connsiteX4" fmla="*/ 86888 w 442718"/>
                <a:gd name="connsiteY4" fmla="*/ 49651 h 533745"/>
                <a:gd name="connsiteX5" fmla="*/ 107576 w 442718"/>
                <a:gd name="connsiteY5" fmla="*/ 37238 h 533745"/>
                <a:gd name="connsiteX6" fmla="*/ 119989 w 442718"/>
                <a:gd name="connsiteY6" fmla="*/ 28963 h 533745"/>
                <a:gd name="connsiteX7" fmla="*/ 169640 w 442718"/>
                <a:gd name="connsiteY7" fmla="*/ 16550 h 533745"/>
                <a:gd name="connsiteX8" fmla="*/ 186190 w 442718"/>
                <a:gd name="connsiteY8" fmla="*/ 12413 h 533745"/>
                <a:gd name="connsiteX9" fmla="*/ 273078 w 442718"/>
                <a:gd name="connsiteY9" fmla="*/ 8275 h 533745"/>
                <a:gd name="connsiteX10" fmla="*/ 310316 w 442718"/>
                <a:gd name="connsiteY10" fmla="*/ 4138 h 533745"/>
                <a:gd name="connsiteX11" fmla="*/ 322729 w 442718"/>
                <a:gd name="connsiteY11" fmla="*/ 0 h 533745"/>
                <a:gd name="connsiteX12" fmla="*/ 384793 w 442718"/>
                <a:gd name="connsiteY12" fmla="*/ 4138 h 533745"/>
                <a:gd name="connsiteX13" fmla="*/ 397205 w 442718"/>
                <a:gd name="connsiteY13" fmla="*/ 8275 h 533745"/>
                <a:gd name="connsiteX14" fmla="*/ 405480 w 442718"/>
                <a:gd name="connsiteY14" fmla="*/ 33100 h 533745"/>
                <a:gd name="connsiteX15" fmla="*/ 413755 w 442718"/>
                <a:gd name="connsiteY15" fmla="*/ 41376 h 533745"/>
                <a:gd name="connsiteX16" fmla="*/ 426168 w 442718"/>
                <a:gd name="connsiteY16" fmla="*/ 66201 h 533745"/>
                <a:gd name="connsiteX17" fmla="*/ 438581 w 442718"/>
                <a:gd name="connsiteY17" fmla="*/ 111714 h 533745"/>
                <a:gd name="connsiteX18" fmla="*/ 442718 w 442718"/>
                <a:gd name="connsiteY18" fmla="*/ 148952 h 533745"/>
                <a:gd name="connsiteX19" fmla="*/ 438581 w 442718"/>
                <a:gd name="connsiteY19" fmla="*/ 231703 h 533745"/>
                <a:gd name="connsiteX20" fmla="*/ 434443 w 442718"/>
                <a:gd name="connsiteY20" fmla="*/ 244116 h 533745"/>
                <a:gd name="connsiteX21" fmla="*/ 426168 w 442718"/>
                <a:gd name="connsiteY21" fmla="*/ 281354 h 533745"/>
                <a:gd name="connsiteX22" fmla="*/ 417893 w 442718"/>
                <a:gd name="connsiteY22" fmla="*/ 306179 h 533745"/>
                <a:gd name="connsiteX23" fmla="*/ 397205 w 442718"/>
                <a:gd name="connsiteY23" fmla="*/ 368243 h 533745"/>
                <a:gd name="connsiteX24" fmla="*/ 388930 w 442718"/>
                <a:gd name="connsiteY24" fmla="*/ 393068 h 533745"/>
                <a:gd name="connsiteX25" fmla="*/ 380655 w 442718"/>
                <a:gd name="connsiteY25" fmla="*/ 405481 h 533745"/>
                <a:gd name="connsiteX26" fmla="*/ 372380 w 442718"/>
                <a:gd name="connsiteY26" fmla="*/ 430306 h 533745"/>
                <a:gd name="connsiteX27" fmla="*/ 364105 w 442718"/>
                <a:gd name="connsiteY27" fmla="*/ 442719 h 533745"/>
                <a:gd name="connsiteX28" fmla="*/ 347554 w 442718"/>
                <a:gd name="connsiteY28" fmla="*/ 475819 h 533745"/>
                <a:gd name="connsiteX29" fmla="*/ 335142 w 442718"/>
                <a:gd name="connsiteY29" fmla="*/ 500644 h 533745"/>
                <a:gd name="connsiteX30" fmla="*/ 331004 w 442718"/>
                <a:gd name="connsiteY30" fmla="*/ 513057 h 533745"/>
                <a:gd name="connsiteX31" fmla="*/ 318592 w 442718"/>
                <a:gd name="connsiteY31" fmla="*/ 521332 h 533745"/>
                <a:gd name="connsiteX32" fmla="*/ 293766 w 442718"/>
                <a:gd name="connsiteY32" fmla="*/ 533745 h 533745"/>
                <a:gd name="connsiteX33" fmla="*/ 231703 w 442718"/>
                <a:gd name="connsiteY33" fmla="*/ 529607 h 533745"/>
                <a:gd name="connsiteX34" fmla="*/ 219290 w 442718"/>
                <a:gd name="connsiteY34" fmla="*/ 521332 h 533745"/>
                <a:gd name="connsiteX35" fmla="*/ 206878 w 442718"/>
                <a:gd name="connsiteY35" fmla="*/ 517195 h 533745"/>
                <a:gd name="connsiteX36" fmla="*/ 124126 w 442718"/>
                <a:gd name="connsiteY36" fmla="*/ 513057 h 533745"/>
                <a:gd name="connsiteX37" fmla="*/ 99301 w 442718"/>
                <a:gd name="connsiteY37" fmla="*/ 521332 h 5337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</a:cxnLst>
              <a:rect l="l" t="t" r="r" b="b"/>
              <a:pathLst>
                <a:path w="442718" h="533745">
                  <a:moveTo>
                    <a:pt x="0" y="148952"/>
                  </a:moveTo>
                  <a:cubicBezTo>
                    <a:pt x="6896" y="146194"/>
                    <a:pt x="14168" y="144233"/>
                    <a:pt x="20688" y="140677"/>
                  </a:cubicBezTo>
                  <a:cubicBezTo>
                    <a:pt x="29419" y="135915"/>
                    <a:pt x="45513" y="124127"/>
                    <a:pt x="45513" y="124127"/>
                  </a:cubicBezTo>
                  <a:cubicBezTo>
                    <a:pt x="51030" y="115852"/>
                    <a:pt x="58918" y="108736"/>
                    <a:pt x="62063" y="99301"/>
                  </a:cubicBezTo>
                  <a:cubicBezTo>
                    <a:pt x="68792" y="79113"/>
                    <a:pt x="70848" y="65689"/>
                    <a:pt x="86888" y="49651"/>
                  </a:cubicBezTo>
                  <a:cubicBezTo>
                    <a:pt x="103053" y="33488"/>
                    <a:pt x="86092" y="47981"/>
                    <a:pt x="107576" y="37238"/>
                  </a:cubicBezTo>
                  <a:cubicBezTo>
                    <a:pt x="112024" y="35014"/>
                    <a:pt x="115445" y="30983"/>
                    <a:pt x="119989" y="28963"/>
                  </a:cubicBezTo>
                  <a:cubicBezTo>
                    <a:pt x="142609" y="18910"/>
                    <a:pt x="145986" y="21281"/>
                    <a:pt x="169640" y="16550"/>
                  </a:cubicBezTo>
                  <a:cubicBezTo>
                    <a:pt x="175216" y="15435"/>
                    <a:pt x="180522" y="12866"/>
                    <a:pt x="186190" y="12413"/>
                  </a:cubicBezTo>
                  <a:cubicBezTo>
                    <a:pt x="215093" y="10101"/>
                    <a:pt x="244115" y="9654"/>
                    <a:pt x="273078" y="8275"/>
                  </a:cubicBezTo>
                  <a:cubicBezTo>
                    <a:pt x="285491" y="6896"/>
                    <a:pt x="297997" y="6191"/>
                    <a:pt x="310316" y="4138"/>
                  </a:cubicBezTo>
                  <a:cubicBezTo>
                    <a:pt x="314618" y="3421"/>
                    <a:pt x="318367" y="0"/>
                    <a:pt x="322729" y="0"/>
                  </a:cubicBezTo>
                  <a:cubicBezTo>
                    <a:pt x="343463" y="0"/>
                    <a:pt x="364105" y="2759"/>
                    <a:pt x="384793" y="4138"/>
                  </a:cubicBezTo>
                  <a:cubicBezTo>
                    <a:pt x="388930" y="5517"/>
                    <a:pt x="394670" y="4726"/>
                    <a:pt x="397205" y="8275"/>
                  </a:cubicBezTo>
                  <a:cubicBezTo>
                    <a:pt x="402275" y="15373"/>
                    <a:pt x="399313" y="26932"/>
                    <a:pt x="405480" y="33100"/>
                  </a:cubicBezTo>
                  <a:lnTo>
                    <a:pt x="413755" y="41376"/>
                  </a:lnTo>
                  <a:cubicBezTo>
                    <a:pt x="428851" y="86656"/>
                    <a:pt x="404773" y="18061"/>
                    <a:pt x="426168" y="66201"/>
                  </a:cubicBezTo>
                  <a:cubicBezTo>
                    <a:pt x="431954" y="79220"/>
                    <a:pt x="436532" y="97371"/>
                    <a:pt x="438581" y="111714"/>
                  </a:cubicBezTo>
                  <a:cubicBezTo>
                    <a:pt x="440347" y="124078"/>
                    <a:pt x="441339" y="136539"/>
                    <a:pt x="442718" y="148952"/>
                  </a:cubicBezTo>
                  <a:cubicBezTo>
                    <a:pt x="441339" y="176536"/>
                    <a:pt x="440974" y="204189"/>
                    <a:pt x="438581" y="231703"/>
                  </a:cubicBezTo>
                  <a:cubicBezTo>
                    <a:pt x="438203" y="236048"/>
                    <a:pt x="435501" y="239885"/>
                    <a:pt x="434443" y="244116"/>
                  </a:cubicBezTo>
                  <a:cubicBezTo>
                    <a:pt x="428532" y="267762"/>
                    <a:pt x="432545" y="260098"/>
                    <a:pt x="426168" y="281354"/>
                  </a:cubicBezTo>
                  <a:cubicBezTo>
                    <a:pt x="423661" y="289709"/>
                    <a:pt x="420651" y="297904"/>
                    <a:pt x="417893" y="306179"/>
                  </a:cubicBezTo>
                  <a:lnTo>
                    <a:pt x="397205" y="368243"/>
                  </a:lnTo>
                  <a:cubicBezTo>
                    <a:pt x="397204" y="368247"/>
                    <a:pt x="388932" y="393065"/>
                    <a:pt x="388930" y="393068"/>
                  </a:cubicBezTo>
                  <a:cubicBezTo>
                    <a:pt x="386172" y="397206"/>
                    <a:pt x="382675" y="400937"/>
                    <a:pt x="380655" y="405481"/>
                  </a:cubicBezTo>
                  <a:cubicBezTo>
                    <a:pt x="377112" y="413452"/>
                    <a:pt x="377218" y="423048"/>
                    <a:pt x="372380" y="430306"/>
                  </a:cubicBezTo>
                  <a:cubicBezTo>
                    <a:pt x="369622" y="434444"/>
                    <a:pt x="366125" y="438175"/>
                    <a:pt x="364105" y="442719"/>
                  </a:cubicBezTo>
                  <a:cubicBezTo>
                    <a:pt x="348892" y="476948"/>
                    <a:pt x="364549" y="458826"/>
                    <a:pt x="347554" y="475819"/>
                  </a:cubicBezTo>
                  <a:cubicBezTo>
                    <a:pt x="337158" y="507013"/>
                    <a:pt x="351180" y="468569"/>
                    <a:pt x="335142" y="500644"/>
                  </a:cubicBezTo>
                  <a:cubicBezTo>
                    <a:pt x="333191" y="504545"/>
                    <a:pt x="333729" y="509651"/>
                    <a:pt x="331004" y="513057"/>
                  </a:cubicBezTo>
                  <a:cubicBezTo>
                    <a:pt x="327898" y="516940"/>
                    <a:pt x="322475" y="518226"/>
                    <a:pt x="318592" y="521332"/>
                  </a:cubicBezTo>
                  <a:cubicBezTo>
                    <a:pt x="301825" y="534745"/>
                    <a:pt x="320616" y="527032"/>
                    <a:pt x="293766" y="533745"/>
                  </a:cubicBezTo>
                  <a:cubicBezTo>
                    <a:pt x="273078" y="532366"/>
                    <a:pt x="252154" y="533016"/>
                    <a:pt x="231703" y="529607"/>
                  </a:cubicBezTo>
                  <a:cubicBezTo>
                    <a:pt x="226798" y="528789"/>
                    <a:pt x="223738" y="523556"/>
                    <a:pt x="219290" y="521332"/>
                  </a:cubicBezTo>
                  <a:cubicBezTo>
                    <a:pt x="215389" y="519382"/>
                    <a:pt x="211015" y="518574"/>
                    <a:pt x="206878" y="517195"/>
                  </a:cubicBezTo>
                  <a:cubicBezTo>
                    <a:pt x="181780" y="492097"/>
                    <a:pt x="197660" y="503865"/>
                    <a:pt x="124126" y="513057"/>
                  </a:cubicBezTo>
                  <a:cubicBezTo>
                    <a:pt x="115471" y="514139"/>
                    <a:pt x="99301" y="521332"/>
                    <a:pt x="99301" y="521332"/>
                  </a:cubicBezTo>
                </a:path>
              </a:pathLst>
            </a:custGeom>
            <a:noFill/>
            <a:ln>
              <a:solidFill>
                <a:srgbClr val="00B05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Freeform 92"/>
            <p:cNvSpPr/>
            <p:nvPr/>
          </p:nvSpPr>
          <p:spPr>
            <a:xfrm>
              <a:off x="5188496" y="3761039"/>
              <a:ext cx="455131" cy="633046"/>
            </a:xfrm>
            <a:custGeom>
              <a:avLst/>
              <a:gdLst>
                <a:gd name="connsiteX0" fmla="*/ 268941 w 455131"/>
                <a:gd name="connsiteY0" fmla="*/ 633046 h 633046"/>
                <a:gd name="connsiteX1" fmla="*/ 248253 w 455131"/>
                <a:gd name="connsiteY1" fmla="*/ 628909 h 633046"/>
                <a:gd name="connsiteX2" fmla="*/ 235841 w 455131"/>
                <a:gd name="connsiteY2" fmla="*/ 624771 h 633046"/>
                <a:gd name="connsiteX3" fmla="*/ 227566 w 455131"/>
                <a:gd name="connsiteY3" fmla="*/ 599946 h 633046"/>
                <a:gd name="connsiteX4" fmla="*/ 223428 w 455131"/>
                <a:gd name="connsiteY4" fmla="*/ 587533 h 633046"/>
                <a:gd name="connsiteX5" fmla="*/ 215153 w 455131"/>
                <a:gd name="connsiteY5" fmla="*/ 575120 h 633046"/>
                <a:gd name="connsiteX6" fmla="*/ 206878 w 455131"/>
                <a:gd name="connsiteY6" fmla="*/ 550295 h 633046"/>
                <a:gd name="connsiteX7" fmla="*/ 198603 w 455131"/>
                <a:gd name="connsiteY7" fmla="*/ 537882 h 633046"/>
                <a:gd name="connsiteX8" fmla="*/ 165502 w 455131"/>
                <a:gd name="connsiteY8" fmla="*/ 508919 h 633046"/>
                <a:gd name="connsiteX9" fmla="*/ 136539 w 455131"/>
                <a:gd name="connsiteY9" fmla="*/ 479956 h 633046"/>
                <a:gd name="connsiteX10" fmla="*/ 124127 w 455131"/>
                <a:gd name="connsiteY10" fmla="*/ 467544 h 633046"/>
                <a:gd name="connsiteX11" fmla="*/ 99301 w 455131"/>
                <a:gd name="connsiteY11" fmla="*/ 459269 h 633046"/>
                <a:gd name="connsiteX12" fmla="*/ 86889 w 455131"/>
                <a:gd name="connsiteY12" fmla="*/ 450994 h 633046"/>
                <a:gd name="connsiteX13" fmla="*/ 78614 w 455131"/>
                <a:gd name="connsiteY13" fmla="*/ 442718 h 633046"/>
                <a:gd name="connsiteX14" fmla="*/ 66201 w 455131"/>
                <a:gd name="connsiteY14" fmla="*/ 438581 h 633046"/>
                <a:gd name="connsiteX15" fmla="*/ 41375 w 455131"/>
                <a:gd name="connsiteY15" fmla="*/ 413756 h 633046"/>
                <a:gd name="connsiteX16" fmla="*/ 33100 w 455131"/>
                <a:gd name="connsiteY16" fmla="*/ 405480 h 633046"/>
                <a:gd name="connsiteX17" fmla="*/ 24825 w 455131"/>
                <a:gd name="connsiteY17" fmla="*/ 393068 h 633046"/>
                <a:gd name="connsiteX18" fmla="*/ 16550 w 455131"/>
                <a:gd name="connsiteY18" fmla="*/ 368242 h 633046"/>
                <a:gd name="connsiteX19" fmla="*/ 8275 w 455131"/>
                <a:gd name="connsiteY19" fmla="*/ 355830 h 633046"/>
                <a:gd name="connsiteX20" fmla="*/ 0 w 455131"/>
                <a:gd name="connsiteY20" fmla="*/ 322729 h 633046"/>
                <a:gd name="connsiteX21" fmla="*/ 4137 w 455131"/>
                <a:gd name="connsiteY21" fmla="*/ 223428 h 633046"/>
                <a:gd name="connsiteX22" fmla="*/ 12413 w 455131"/>
                <a:gd name="connsiteY22" fmla="*/ 198603 h 633046"/>
                <a:gd name="connsiteX23" fmla="*/ 24825 w 455131"/>
                <a:gd name="connsiteY23" fmla="*/ 161365 h 633046"/>
                <a:gd name="connsiteX24" fmla="*/ 28963 w 455131"/>
                <a:gd name="connsiteY24" fmla="*/ 148952 h 633046"/>
                <a:gd name="connsiteX25" fmla="*/ 33100 w 455131"/>
                <a:gd name="connsiteY25" fmla="*/ 136539 h 633046"/>
                <a:gd name="connsiteX26" fmla="*/ 41375 w 455131"/>
                <a:gd name="connsiteY26" fmla="*/ 124127 h 633046"/>
                <a:gd name="connsiteX27" fmla="*/ 57926 w 455131"/>
                <a:gd name="connsiteY27" fmla="*/ 86889 h 633046"/>
                <a:gd name="connsiteX28" fmla="*/ 66201 w 455131"/>
                <a:gd name="connsiteY28" fmla="*/ 78613 h 633046"/>
                <a:gd name="connsiteX29" fmla="*/ 103439 w 455131"/>
                <a:gd name="connsiteY29" fmla="*/ 62063 h 633046"/>
                <a:gd name="connsiteX30" fmla="*/ 115852 w 455131"/>
                <a:gd name="connsiteY30" fmla="*/ 57926 h 633046"/>
                <a:gd name="connsiteX31" fmla="*/ 128264 w 455131"/>
                <a:gd name="connsiteY31" fmla="*/ 53788 h 633046"/>
                <a:gd name="connsiteX32" fmla="*/ 144814 w 455131"/>
                <a:gd name="connsiteY32" fmla="*/ 49651 h 633046"/>
                <a:gd name="connsiteX33" fmla="*/ 186190 w 455131"/>
                <a:gd name="connsiteY33" fmla="*/ 41375 h 633046"/>
                <a:gd name="connsiteX34" fmla="*/ 211015 w 455131"/>
                <a:gd name="connsiteY34" fmla="*/ 33100 h 633046"/>
                <a:gd name="connsiteX35" fmla="*/ 223428 w 455131"/>
                <a:gd name="connsiteY35" fmla="*/ 28963 h 633046"/>
                <a:gd name="connsiteX36" fmla="*/ 235841 w 455131"/>
                <a:gd name="connsiteY36" fmla="*/ 20688 h 633046"/>
                <a:gd name="connsiteX37" fmla="*/ 260666 w 455131"/>
                <a:gd name="connsiteY37" fmla="*/ 12413 h 633046"/>
                <a:gd name="connsiteX38" fmla="*/ 273079 w 455131"/>
                <a:gd name="connsiteY38" fmla="*/ 8275 h 633046"/>
                <a:gd name="connsiteX39" fmla="*/ 285491 w 455131"/>
                <a:gd name="connsiteY39" fmla="*/ 4137 h 633046"/>
                <a:gd name="connsiteX40" fmla="*/ 297904 w 455131"/>
                <a:gd name="connsiteY40" fmla="*/ 0 h 633046"/>
                <a:gd name="connsiteX41" fmla="*/ 351692 w 455131"/>
                <a:gd name="connsiteY41" fmla="*/ 12413 h 633046"/>
                <a:gd name="connsiteX42" fmla="*/ 364105 w 455131"/>
                <a:gd name="connsiteY42" fmla="*/ 16550 h 633046"/>
                <a:gd name="connsiteX43" fmla="*/ 376518 w 455131"/>
                <a:gd name="connsiteY43" fmla="*/ 24825 h 633046"/>
                <a:gd name="connsiteX44" fmla="*/ 401343 w 455131"/>
                <a:gd name="connsiteY44" fmla="*/ 33100 h 633046"/>
                <a:gd name="connsiteX45" fmla="*/ 455131 w 455131"/>
                <a:gd name="connsiteY45" fmla="*/ 37238 h 6330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</a:cxnLst>
              <a:rect l="l" t="t" r="r" b="b"/>
              <a:pathLst>
                <a:path w="455131" h="633046">
                  <a:moveTo>
                    <a:pt x="268941" y="633046"/>
                  </a:moveTo>
                  <a:cubicBezTo>
                    <a:pt x="262045" y="631667"/>
                    <a:pt x="255076" y="630615"/>
                    <a:pt x="248253" y="628909"/>
                  </a:cubicBezTo>
                  <a:cubicBezTo>
                    <a:pt x="244022" y="627851"/>
                    <a:pt x="238376" y="628320"/>
                    <a:pt x="235841" y="624771"/>
                  </a:cubicBezTo>
                  <a:cubicBezTo>
                    <a:pt x="230771" y="617673"/>
                    <a:pt x="230324" y="608221"/>
                    <a:pt x="227566" y="599946"/>
                  </a:cubicBezTo>
                  <a:cubicBezTo>
                    <a:pt x="226187" y="595808"/>
                    <a:pt x="225847" y="591162"/>
                    <a:pt x="223428" y="587533"/>
                  </a:cubicBezTo>
                  <a:cubicBezTo>
                    <a:pt x="220670" y="583395"/>
                    <a:pt x="217173" y="579664"/>
                    <a:pt x="215153" y="575120"/>
                  </a:cubicBezTo>
                  <a:cubicBezTo>
                    <a:pt x="211610" y="567149"/>
                    <a:pt x="211716" y="557553"/>
                    <a:pt x="206878" y="550295"/>
                  </a:cubicBezTo>
                  <a:cubicBezTo>
                    <a:pt x="204120" y="546157"/>
                    <a:pt x="201878" y="541624"/>
                    <a:pt x="198603" y="537882"/>
                  </a:cubicBezTo>
                  <a:cubicBezTo>
                    <a:pt x="181660" y="518518"/>
                    <a:pt x="182327" y="520135"/>
                    <a:pt x="165502" y="508919"/>
                  </a:cubicBezTo>
                  <a:cubicBezTo>
                    <a:pt x="146533" y="480465"/>
                    <a:pt x="158387" y="487239"/>
                    <a:pt x="136539" y="479956"/>
                  </a:cubicBezTo>
                  <a:cubicBezTo>
                    <a:pt x="132402" y="475819"/>
                    <a:pt x="129242" y="470385"/>
                    <a:pt x="124127" y="467544"/>
                  </a:cubicBezTo>
                  <a:cubicBezTo>
                    <a:pt x="116502" y="463308"/>
                    <a:pt x="99301" y="459269"/>
                    <a:pt x="99301" y="459269"/>
                  </a:cubicBezTo>
                  <a:cubicBezTo>
                    <a:pt x="95164" y="456511"/>
                    <a:pt x="90772" y="454100"/>
                    <a:pt x="86889" y="450994"/>
                  </a:cubicBezTo>
                  <a:cubicBezTo>
                    <a:pt x="83843" y="448557"/>
                    <a:pt x="81959" y="444725"/>
                    <a:pt x="78614" y="442718"/>
                  </a:cubicBezTo>
                  <a:cubicBezTo>
                    <a:pt x="74874" y="440474"/>
                    <a:pt x="70339" y="439960"/>
                    <a:pt x="66201" y="438581"/>
                  </a:cubicBezTo>
                  <a:lnTo>
                    <a:pt x="41375" y="413756"/>
                  </a:lnTo>
                  <a:cubicBezTo>
                    <a:pt x="38616" y="410997"/>
                    <a:pt x="35264" y="408726"/>
                    <a:pt x="33100" y="405480"/>
                  </a:cubicBezTo>
                  <a:lnTo>
                    <a:pt x="24825" y="393068"/>
                  </a:lnTo>
                  <a:cubicBezTo>
                    <a:pt x="22067" y="384793"/>
                    <a:pt x="21389" y="375500"/>
                    <a:pt x="16550" y="368242"/>
                  </a:cubicBezTo>
                  <a:cubicBezTo>
                    <a:pt x="13792" y="364105"/>
                    <a:pt x="10499" y="360278"/>
                    <a:pt x="8275" y="355830"/>
                  </a:cubicBezTo>
                  <a:cubicBezTo>
                    <a:pt x="4033" y="347346"/>
                    <a:pt x="1574" y="330602"/>
                    <a:pt x="0" y="322729"/>
                  </a:cubicBezTo>
                  <a:cubicBezTo>
                    <a:pt x="1379" y="289629"/>
                    <a:pt x="840" y="256393"/>
                    <a:pt x="4137" y="223428"/>
                  </a:cubicBezTo>
                  <a:cubicBezTo>
                    <a:pt x="5005" y="214749"/>
                    <a:pt x="9655" y="206878"/>
                    <a:pt x="12413" y="198603"/>
                  </a:cubicBezTo>
                  <a:lnTo>
                    <a:pt x="24825" y="161365"/>
                  </a:lnTo>
                  <a:lnTo>
                    <a:pt x="28963" y="148952"/>
                  </a:lnTo>
                  <a:cubicBezTo>
                    <a:pt x="30342" y="144814"/>
                    <a:pt x="30681" y="140168"/>
                    <a:pt x="33100" y="136539"/>
                  </a:cubicBezTo>
                  <a:cubicBezTo>
                    <a:pt x="35858" y="132402"/>
                    <a:pt x="39355" y="128671"/>
                    <a:pt x="41375" y="124127"/>
                  </a:cubicBezTo>
                  <a:cubicBezTo>
                    <a:pt x="52860" y="98288"/>
                    <a:pt x="43880" y="104448"/>
                    <a:pt x="57926" y="86889"/>
                  </a:cubicBezTo>
                  <a:cubicBezTo>
                    <a:pt x="60363" y="83843"/>
                    <a:pt x="63155" y="81050"/>
                    <a:pt x="66201" y="78613"/>
                  </a:cubicBezTo>
                  <a:cubicBezTo>
                    <a:pt x="80249" y="67374"/>
                    <a:pt x="83759" y="68623"/>
                    <a:pt x="103439" y="62063"/>
                  </a:cubicBezTo>
                  <a:lnTo>
                    <a:pt x="115852" y="57926"/>
                  </a:lnTo>
                  <a:cubicBezTo>
                    <a:pt x="119989" y="56547"/>
                    <a:pt x="124033" y="54846"/>
                    <a:pt x="128264" y="53788"/>
                  </a:cubicBezTo>
                  <a:cubicBezTo>
                    <a:pt x="133781" y="52409"/>
                    <a:pt x="139254" y="50842"/>
                    <a:pt x="144814" y="49651"/>
                  </a:cubicBezTo>
                  <a:cubicBezTo>
                    <a:pt x="158567" y="46704"/>
                    <a:pt x="172847" y="45823"/>
                    <a:pt x="186190" y="41375"/>
                  </a:cubicBezTo>
                  <a:lnTo>
                    <a:pt x="211015" y="33100"/>
                  </a:lnTo>
                  <a:lnTo>
                    <a:pt x="223428" y="28963"/>
                  </a:lnTo>
                  <a:cubicBezTo>
                    <a:pt x="227566" y="26205"/>
                    <a:pt x="231297" y="22708"/>
                    <a:pt x="235841" y="20688"/>
                  </a:cubicBezTo>
                  <a:cubicBezTo>
                    <a:pt x="243812" y="17145"/>
                    <a:pt x="252391" y="15171"/>
                    <a:pt x="260666" y="12413"/>
                  </a:cubicBezTo>
                  <a:lnTo>
                    <a:pt x="273079" y="8275"/>
                  </a:lnTo>
                  <a:lnTo>
                    <a:pt x="285491" y="4137"/>
                  </a:lnTo>
                  <a:lnTo>
                    <a:pt x="297904" y="0"/>
                  </a:lnTo>
                  <a:cubicBezTo>
                    <a:pt x="335508" y="5371"/>
                    <a:pt x="317610" y="1052"/>
                    <a:pt x="351692" y="12413"/>
                  </a:cubicBezTo>
                  <a:lnTo>
                    <a:pt x="364105" y="16550"/>
                  </a:lnTo>
                  <a:cubicBezTo>
                    <a:pt x="368243" y="19308"/>
                    <a:pt x="371974" y="22805"/>
                    <a:pt x="376518" y="24825"/>
                  </a:cubicBezTo>
                  <a:cubicBezTo>
                    <a:pt x="384489" y="28368"/>
                    <a:pt x="393068" y="30342"/>
                    <a:pt x="401343" y="33100"/>
                  </a:cubicBezTo>
                  <a:cubicBezTo>
                    <a:pt x="426841" y="41600"/>
                    <a:pt x="409390" y="37238"/>
                    <a:pt x="455131" y="37238"/>
                  </a:cubicBezTo>
                </a:path>
              </a:pathLst>
            </a:custGeom>
            <a:noFill/>
            <a:ln>
              <a:solidFill>
                <a:srgbClr val="00B05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8" name="Content Placeholder 2"/>
          <p:cNvSpPr txBox="1">
            <a:spLocks/>
          </p:cNvSpPr>
          <p:nvPr/>
        </p:nvSpPr>
        <p:spPr>
          <a:xfrm>
            <a:off x="621190" y="4649973"/>
            <a:ext cx="4336612" cy="2721974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oloured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lines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accent5">
                    <a:lumMod val="60000"/>
                    <a:lumOff val="40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lx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accent5">
                  <a:lumMod val="60000"/>
                  <a:lumOff val="40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accent3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entral </a:t>
            </a: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accent3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ulcus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noProof="0" dirty="0" err="1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Sylvian</a:t>
            </a:r>
            <a:r>
              <a:rPr lang="en-US" noProof="0" dirty="0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 fissure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uperior</a:t>
            </a:r>
            <a:r>
              <a:rPr kumimoji="0" lang="en-US" b="0" i="0" u="none" strike="noStrike" kern="1200" cap="none" spc="0" normalizeH="0" dirty="0" smtClean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temporal sulcus (&amp; </a:t>
            </a:r>
            <a:r>
              <a:rPr kumimoji="0" lang="en-US" b="0" i="0" u="none" strike="noStrike" kern="1200" cap="none" spc="0" normalizeH="0" dirty="0" smtClean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yrus)</a:t>
            </a:r>
            <a:endParaRPr lang="en-US" dirty="0">
              <a:solidFill>
                <a:srgbClr val="00B050"/>
              </a:solidFill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066800" y="24384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600200" y="24384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990600" y="3593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676400" y="3593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990600" y="1905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676400" y="1905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038600" y="24384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572000" y="24384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962400" y="3593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648200" y="3593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962400" y="1905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648200" y="1905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505200" y="2514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105400" y="2514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429000" y="32882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105400" y="32882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1" name="Content Placeholder 2"/>
          <p:cNvSpPr txBox="1">
            <a:spLocks/>
          </p:cNvSpPr>
          <p:nvPr/>
        </p:nvSpPr>
        <p:spPr>
          <a:xfrm>
            <a:off x="6019800" y="4114800"/>
            <a:ext cx="3662402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DF = left </a:t>
            </a: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dorsofrontal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dirty="0" smtClean="0">
                <a:solidFill>
                  <a:schemeClr val="bg1"/>
                </a:solidFill>
              </a:rPr>
              <a:t>RDF = right </a:t>
            </a:r>
            <a:r>
              <a:rPr lang="en-US" dirty="0" err="1" smtClean="0">
                <a:solidFill>
                  <a:schemeClr val="bg1"/>
                </a:solidFill>
              </a:rPr>
              <a:t>dorsofrontal</a:t>
            </a:r>
            <a:endParaRPr lang="en-US" dirty="0" smtClean="0">
              <a:solidFill>
                <a:schemeClr val="bg1"/>
              </a:solidFill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P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= left </a:t>
            </a:r>
            <a:r>
              <a:rPr kumimoji="0" lang="en-US" b="0" i="0" u="none" strike="noStrike" kern="1200" cap="none" spc="0" normalizeH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ariet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-occipi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baseline="0" dirty="0" smtClean="0">
                <a:solidFill>
                  <a:schemeClr val="bg1"/>
                </a:solidFill>
              </a:rPr>
              <a:t>RPO</a:t>
            </a:r>
            <a:r>
              <a:rPr lang="en-US" dirty="0" smtClean="0">
                <a:solidFill>
                  <a:schemeClr val="bg1"/>
                </a:solidFill>
              </a:rPr>
              <a:t> = right </a:t>
            </a:r>
            <a:r>
              <a:rPr lang="en-US" dirty="0" err="1" smtClean="0">
                <a:solidFill>
                  <a:schemeClr val="bg1"/>
                </a:solidFill>
              </a:rPr>
              <a:t>pareto</a:t>
            </a:r>
            <a:r>
              <a:rPr lang="en-US" dirty="0" smtClean="0">
                <a:solidFill>
                  <a:schemeClr val="bg1"/>
                </a:solidFill>
              </a:rPr>
              <a:t>-occipi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C = subcortic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noProof="0" dirty="0" smtClean="0">
                <a:solidFill>
                  <a:schemeClr val="bg1"/>
                </a:solidFill>
              </a:rPr>
              <a:t>LT = left tempor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RT</a:t>
            </a:r>
            <a:r>
              <a:rPr kumimoji="0" lang="en-US" b="0" i="0" u="none" strike="noStrike" kern="1200" cap="none" spc="0" normalizeH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= right temporal</a:t>
            </a: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996651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370998" y="685800"/>
            <a:ext cx="2560320" cy="3657600"/>
            <a:chOff x="1295400" y="1897259"/>
            <a:chExt cx="2560320" cy="3657600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1897259"/>
              <a:ext cx="2560320" cy="3657600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32" name="Group 31"/>
            <p:cNvGrpSpPr/>
            <p:nvPr/>
          </p:nvGrpSpPr>
          <p:grpSpPr>
            <a:xfrm>
              <a:off x="2562999" y="2532073"/>
              <a:ext cx="103905" cy="2590842"/>
              <a:chOff x="3522787" y="2589291"/>
              <a:chExt cx="130286" cy="3259248"/>
            </a:xfrm>
          </p:grpSpPr>
          <p:sp>
            <p:nvSpPr>
              <p:cNvPr id="48" name="Freeform 47"/>
              <p:cNvSpPr/>
              <p:nvPr/>
            </p:nvSpPr>
            <p:spPr>
              <a:xfrm>
                <a:off x="3571592" y="2589291"/>
                <a:ext cx="81481" cy="1095469"/>
              </a:xfrm>
              <a:custGeom>
                <a:avLst/>
                <a:gdLst>
                  <a:gd name="connsiteX0" fmla="*/ 40741 w 81481"/>
                  <a:gd name="connsiteY0" fmla="*/ 0 h 1095469"/>
                  <a:gd name="connsiteX1" fmla="*/ 45267 w 81481"/>
                  <a:gd name="connsiteY1" fmla="*/ 22634 h 1095469"/>
                  <a:gd name="connsiteX2" fmla="*/ 49794 w 81481"/>
                  <a:gd name="connsiteY2" fmla="*/ 36214 h 1095469"/>
                  <a:gd name="connsiteX3" fmla="*/ 58848 w 81481"/>
                  <a:gd name="connsiteY3" fmla="*/ 181069 h 1095469"/>
                  <a:gd name="connsiteX4" fmla="*/ 63374 w 81481"/>
                  <a:gd name="connsiteY4" fmla="*/ 239917 h 1095469"/>
                  <a:gd name="connsiteX5" fmla="*/ 49794 w 81481"/>
                  <a:gd name="connsiteY5" fmla="*/ 339505 h 1095469"/>
                  <a:gd name="connsiteX6" fmla="*/ 36214 w 81481"/>
                  <a:gd name="connsiteY6" fmla="*/ 344032 h 1095469"/>
                  <a:gd name="connsiteX7" fmla="*/ 31687 w 81481"/>
                  <a:gd name="connsiteY7" fmla="*/ 384772 h 1095469"/>
                  <a:gd name="connsiteX8" fmla="*/ 40741 w 81481"/>
                  <a:gd name="connsiteY8" fmla="*/ 398353 h 1095469"/>
                  <a:gd name="connsiteX9" fmla="*/ 54321 w 81481"/>
                  <a:gd name="connsiteY9" fmla="*/ 407406 h 1095469"/>
                  <a:gd name="connsiteX10" fmla="*/ 58848 w 81481"/>
                  <a:gd name="connsiteY10" fmla="*/ 420986 h 1095469"/>
                  <a:gd name="connsiteX11" fmla="*/ 67901 w 81481"/>
                  <a:gd name="connsiteY11" fmla="*/ 430040 h 1095469"/>
                  <a:gd name="connsiteX12" fmla="*/ 76955 w 81481"/>
                  <a:gd name="connsiteY12" fmla="*/ 457200 h 1095469"/>
                  <a:gd name="connsiteX13" fmla="*/ 81481 w 81481"/>
                  <a:gd name="connsiteY13" fmla="*/ 543208 h 1095469"/>
                  <a:gd name="connsiteX14" fmla="*/ 76955 w 81481"/>
                  <a:gd name="connsiteY14" fmla="*/ 656376 h 1095469"/>
                  <a:gd name="connsiteX15" fmla="*/ 72428 w 81481"/>
                  <a:gd name="connsiteY15" fmla="*/ 669957 h 1095469"/>
                  <a:gd name="connsiteX16" fmla="*/ 63374 w 81481"/>
                  <a:gd name="connsiteY16" fmla="*/ 679010 h 1095469"/>
                  <a:gd name="connsiteX17" fmla="*/ 49794 w 81481"/>
                  <a:gd name="connsiteY17" fmla="*/ 701644 h 1095469"/>
                  <a:gd name="connsiteX18" fmla="*/ 45267 w 81481"/>
                  <a:gd name="connsiteY18" fmla="*/ 715224 h 1095469"/>
                  <a:gd name="connsiteX19" fmla="*/ 27160 w 81481"/>
                  <a:gd name="connsiteY19" fmla="*/ 742384 h 1095469"/>
                  <a:gd name="connsiteX20" fmla="*/ 13580 w 81481"/>
                  <a:gd name="connsiteY20" fmla="*/ 787652 h 1095469"/>
                  <a:gd name="connsiteX21" fmla="*/ 9054 w 81481"/>
                  <a:gd name="connsiteY21" fmla="*/ 810285 h 1095469"/>
                  <a:gd name="connsiteX22" fmla="*/ 4527 w 81481"/>
                  <a:gd name="connsiteY22" fmla="*/ 837446 h 1095469"/>
                  <a:gd name="connsiteX23" fmla="*/ 0 w 81481"/>
                  <a:gd name="connsiteY23" fmla="*/ 851026 h 1095469"/>
                  <a:gd name="connsiteX24" fmla="*/ 4527 w 81481"/>
                  <a:gd name="connsiteY24" fmla="*/ 896293 h 1095469"/>
                  <a:gd name="connsiteX25" fmla="*/ 13580 w 81481"/>
                  <a:gd name="connsiteY25" fmla="*/ 927980 h 1095469"/>
                  <a:gd name="connsiteX26" fmla="*/ 13580 w 81481"/>
                  <a:gd name="connsiteY26" fmla="*/ 1095469 h 10954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</a:cxnLst>
                <a:rect l="l" t="t" r="r" b="b"/>
                <a:pathLst>
                  <a:path w="81481" h="1095469">
                    <a:moveTo>
                      <a:pt x="40741" y="0"/>
                    </a:moveTo>
                    <a:cubicBezTo>
                      <a:pt x="42250" y="7545"/>
                      <a:pt x="43401" y="15170"/>
                      <a:pt x="45267" y="22634"/>
                    </a:cubicBezTo>
                    <a:cubicBezTo>
                      <a:pt x="46424" y="27263"/>
                      <a:pt x="49477" y="31453"/>
                      <a:pt x="49794" y="36214"/>
                    </a:cubicBezTo>
                    <a:cubicBezTo>
                      <a:pt x="60380" y="194992"/>
                      <a:pt x="45235" y="113011"/>
                      <a:pt x="58848" y="181069"/>
                    </a:cubicBezTo>
                    <a:cubicBezTo>
                      <a:pt x="60357" y="200685"/>
                      <a:pt x="63374" y="220243"/>
                      <a:pt x="63374" y="239917"/>
                    </a:cubicBezTo>
                    <a:cubicBezTo>
                      <a:pt x="63374" y="245740"/>
                      <a:pt x="79546" y="321654"/>
                      <a:pt x="49794" y="339505"/>
                    </a:cubicBezTo>
                    <a:cubicBezTo>
                      <a:pt x="45702" y="341960"/>
                      <a:pt x="40741" y="342523"/>
                      <a:pt x="36214" y="344032"/>
                    </a:cubicBezTo>
                    <a:cubicBezTo>
                      <a:pt x="28669" y="366666"/>
                      <a:pt x="22633" y="366665"/>
                      <a:pt x="31687" y="384772"/>
                    </a:cubicBezTo>
                    <a:cubicBezTo>
                      <a:pt x="34120" y="389638"/>
                      <a:pt x="36894" y="394506"/>
                      <a:pt x="40741" y="398353"/>
                    </a:cubicBezTo>
                    <a:cubicBezTo>
                      <a:pt x="44588" y="402200"/>
                      <a:pt x="49794" y="404388"/>
                      <a:pt x="54321" y="407406"/>
                    </a:cubicBezTo>
                    <a:cubicBezTo>
                      <a:pt x="55830" y="411933"/>
                      <a:pt x="56393" y="416894"/>
                      <a:pt x="58848" y="420986"/>
                    </a:cubicBezTo>
                    <a:cubicBezTo>
                      <a:pt x="61044" y="424646"/>
                      <a:pt x="65992" y="426223"/>
                      <a:pt x="67901" y="430040"/>
                    </a:cubicBezTo>
                    <a:cubicBezTo>
                      <a:pt x="72169" y="438576"/>
                      <a:pt x="76955" y="457200"/>
                      <a:pt x="76955" y="457200"/>
                    </a:cubicBezTo>
                    <a:cubicBezTo>
                      <a:pt x="78464" y="485869"/>
                      <a:pt x="81481" y="514499"/>
                      <a:pt x="81481" y="543208"/>
                    </a:cubicBezTo>
                    <a:cubicBezTo>
                      <a:pt x="81481" y="580961"/>
                      <a:pt x="79645" y="618719"/>
                      <a:pt x="76955" y="656376"/>
                    </a:cubicBezTo>
                    <a:cubicBezTo>
                      <a:pt x="76615" y="661136"/>
                      <a:pt x="74883" y="665865"/>
                      <a:pt x="72428" y="669957"/>
                    </a:cubicBezTo>
                    <a:cubicBezTo>
                      <a:pt x="70232" y="673617"/>
                      <a:pt x="66392" y="675992"/>
                      <a:pt x="63374" y="679010"/>
                    </a:cubicBezTo>
                    <a:cubicBezTo>
                      <a:pt x="50555" y="717472"/>
                      <a:pt x="68433" y="670581"/>
                      <a:pt x="49794" y="701644"/>
                    </a:cubicBezTo>
                    <a:cubicBezTo>
                      <a:pt x="47339" y="705736"/>
                      <a:pt x="47584" y="711053"/>
                      <a:pt x="45267" y="715224"/>
                    </a:cubicBezTo>
                    <a:cubicBezTo>
                      <a:pt x="39983" y="724735"/>
                      <a:pt x="27160" y="742384"/>
                      <a:pt x="27160" y="742384"/>
                    </a:cubicBezTo>
                    <a:cubicBezTo>
                      <a:pt x="19641" y="764943"/>
                      <a:pt x="18139" y="767134"/>
                      <a:pt x="13580" y="787652"/>
                    </a:cubicBezTo>
                    <a:cubicBezTo>
                      <a:pt x="11911" y="795163"/>
                      <a:pt x="10430" y="802715"/>
                      <a:pt x="9054" y="810285"/>
                    </a:cubicBezTo>
                    <a:cubicBezTo>
                      <a:pt x="7412" y="819316"/>
                      <a:pt x="6518" y="828486"/>
                      <a:pt x="4527" y="837446"/>
                    </a:cubicBezTo>
                    <a:cubicBezTo>
                      <a:pt x="3492" y="842104"/>
                      <a:pt x="1509" y="846499"/>
                      <a:pt x="0" y="851026"/>
                    </a:cubicBezTo>
                    <a:cubicBezTo>
                      <a:pt x="1509" y="866115"/>
                      <a:pt x="2221" y="881305"/>
                      <a:pt x="4527" y="896293"/>
                    </a:cubicBezTo>
                    <a:cubicBezTo>
                      <a:pt x="7006" y="912404"/>
                      <a:pt x="13133" y="909639"/>
                      <a:pt x="13580" y="927980"/>
                    </a:cubicBezTo>
                    <a:cubicBezTo>
                      <a:pt x="14941" y="983793"/>
                      <a:pt x="13580" y="1039639"/>
                      <a:pt x="13580" y="1095469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Freeform 48"/>
              <p:cNvSpPr/>
              <p:nvPr/>
            </p:nvSpPr>
            <p:spPr>
              <a:xfrm>
                <a:off x="3553473" y="4504099"/>
                <a:ext cx="4539" cy="208230"/>
              </a:xfrm>
              <a:custGeom>
                <a:avLst/>
                <a:gdLst>
                  <a:gd name="connsiteX0" fmla="*/ 4539 w 4539"/>
                  <a:gd name="connsiteY0" fmla="*/ 0 h 208230"/>
                  <a:gd name="connsiteX1" fmla="*/ 12 w 4539"/>
                  <a:gd name="connsiteY1" fmla="*/ 208230 h 2082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539" h="208230">
                    <a:moveTo>
                      <a:pt x="4539" y="0"/>
                    </a:moveTo>
                    <a:cubicBezTo>
                      <a:pt x="-462" y="175027"/>
                      <a:pt x="12" y="105602"/>
                      <a:pt x="12" y="208230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Freeform 49"/>
              <p:cNvSpPr/>
              <p:nvPr/>
            </p:nvSpPr>
            <p:spPr>
              <a:xfrm>
                <a:off x="3522787" y="4680642"/>
                <a:ext cx="44278" cy="1167897"/>
              </a:xfrm>
              <a:custGeom>
                <a:avLst/>
                <a:gdLst>
                  <a:gd name="connsiteX0" fmla="*/ 30698 w 44278"/>
                  <a:gd name="connsiteY0" fmla="*/ 0 h 1167897"/>
                  <a:gd name="connsiteX1" fmla="*/ 35225 w 44278"/>
                  <a:gd name="connsiteY1" fmla="*/ 244443 h 1167897"/>
                  <a:gd name="connsiteX2" fmla="*/ 39752 w 44278"/>
                  <a:gd name="connsiteY2" fmla="*/ 271604 h 1167897"/>
                  <a:gd name="connsiteX3" fmla="*/ 44278 w 44278"/>
                  <a:gd name="connsiteY3" fmla="*/ 362138 h 1167897"/>
                  <a:gd name="connsiteX4" fmla="*/ 39752 w 44278"/>
                  <a:gd name="connsiteY4" fmla="*/ 470780 h 1167897"/>
                  <a:gd name="connsiteX5" fmla="*/ 35225 w 44278"/>
                  <a:gd name="connsiteY5" fmla="*/ 488887 h 1167897"/>
                  <a:gd name="connsiteX6" fmla="*/ 21645 w 44278"/>
                  <a:gd name="connsiteY6" fmla="*/ 534154 h 1167897"/>
                  <a:gd name="connsiteX7" fmla="*/ 26171 w 44278"/>
                  <a:gd name="connsiteY7" fmla="*/ 593002 h 1167897"/>
                  <a:gd name="connsiteX8" fmla="*/ 35225 w 44278"/>
                  <a:gd name="connsiteY8" fmla="*/ 620162 h 1167897"/>
                  <a:gd name="connsiteX9" fmla="*/ 30698 w 44278"/>
                  <a:gd name="connsiteY9" fmla="*/ 719750 h 1167897"/>
                  <a:gd name="connsiteX10" fmla="*/ 17118 w 44278"/>
                  <a:gd name="connsiteY10" fmla="*/ 760491 h 1167897"/>
                  <a:gd name="connsiteX11" fmla="*/ 12591 w 44278"/>
                  <a:gd name="connsiteY11" fmla="*/ 774071 h 1167897"/>
                  <a:gd name="connsiteX12" fmla="*/ 8064 w 44278"/>
                  <a:gd name="connsiteY12" fmla="*/ 787651 h 1167897"/>
                  <a:gd name="connsiteX13" fmla="*/ 3538 w 44278"/>
                  <a:gd name="connsiteY13" fmla="*/ 986827 h 1167897"/>
                  <a:gd name="connsiteX14" fmla="*/ 17118 w 44278"/>
                  <a:gd name="connsiteY14" fmla="*/ 1077362 h 1167897"/>
                  <a:gd name="connsiteX15" fmla="*/ 21645 w 44278"/>
                  <a:gd name="connsiteY15" fmla="*/ 1167897 h 11678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44278" h="1167897">
                    <a:moveTo>
                      <a:pt x="30698" y="0"/>
                    </a:moveTo>
                    <a:cubicBezTo>
                      <a:pt x="32207" y="81481"/>
                      <a:pt x="32510" y="162993"/>
                      <a:pt x="35225" y="244443"/>
                    </a:cubicBezTo>
                    <a:cubicBezTo>
                      <a:pt x="35531" y="253616"/>
                      <a:pt x="39048" y="262452"/>
                      <a:pt x="39752" y="271604"/>
                    </a:cubicBezTo>
                    <a:cubicBezTo>
                      <a:pt x="42069" y="301731"/>
                      <a:pt x="42769" y="331960"/>
                      <a:pt x="44278" y="362138"/>
                    </a:cubicBezTo>
                    <a:cubicBezTo>
                      <a:pt x="42769" y="398352"/>
                      <a:pt x="42334" y="434627"/>
                      <a:pt x="39752" y="470780"/>
                    </a:cubicBezTo>
                    <a:cubicBezTo>
                      <a:pt x="39309" y="476986"/>
                      <a:pt x="37013" y="482928"/>
                      <a:pt x="35225" y="488887"/>
                    </a:cubicBezTo>
                    <a:cubicBezTo>
                      <a:pt x="18700" y="543967"/>
                      <a:pt x="32073" y="492435"/>
                      <a:pt x="21645" y="534154"/>
                    </a:cubicBezTo>
                    <a:cubicBezTo>
                      <a:pt x="23154" y="553770"/>
                      <a:pt x="23103" y="573569"/>
                      <a:pt x="26171" y="593002"/>
                    </a:cubicBezTo>
                    <a:cubicBezTo>
                      <a:pt x="27659" y="602428"/>
                      <a:pt x="35225" y="620162"/>
                      <a:pt x="35225" y="620162"/>
                    </a:cubicBezTo>
                    <a:cubicBezTo>
                      <a:pt x="33716" y="653358"/>
                      <a:pt x="34238" y="686709"/>
                      <a:pt x="30698" y="719750"/>
                    </a:cubicBezTo>
                    <a:cubicBezTo>
                      <a:pt x="30698" y="719751"/>
                      <a:pt x="19381" y="753701"/>
                      <a:pt x="17118" y="760491"/>
                    </a:cubicBezTo>
                    <a:lnTo>
                      <a:pt x="12591" y="774071"/>
                    </a:lnTo>
                    <a:lnTo>
                      <a:pt x="8064" y="787651"/>
                    </a:lnTo>
                    <a:cubicBezTo>
                      <a:pt x="6555" y="854043"/>
                      <a:pt x="3538" y="920418"/>
                      <a:pt x="3538" y="986827"/>
                    </a:cubicBezTo>
                    <a:cubicBezTo>
                      <a:pt x="3538" y="1067807"/>
                      <a:pt x="-10424" y="1049820"/>
                      <a:pt x="17118" y="1077362"/>
                    </a:cubicBezTo>
                    <a:cubicBezTo>
                      <a:pt x="29757" y="1115277"/>
                      <a:pt x="21645" y="1086170"/>
                      <a:pt x="21645" y="1167897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1746319" y="3129406"/>
              <a:ext cx="1653443" cy="967993"/>
              <a:chOff x="2498756" y="3340729"/>
              <a:chExt cx="2073244" cy="1217723"/>
            </a:xfrm>
          </p:grpSpPr>
          <p:sp>
            <p:nvSpPr>
              <p:cNvPr id="42" name="Freeform 41"/>
              <p:cNvSpPr/>
              <p:nvPr/>
            </p:nvSpPr>
            <p:spPr>
              <a:xfrm>
                <a:off x="2670772" y="3340729"/>
                <a:ext cx="212907" cy="932507"/>
              </a:xfrm>
              <a:custGeom>
                <a:avLst/>
                <a:gdLst>
                  <a:gd name="connsiteX0" fmla="*/ 172016 w 212907"/>
                  <a:gd name="connsiteY0" fmla="*/ 0 h 932507"/>
                  <a:gd name="connsiteX1" fmla="*/ 113169 w 212907"/>
                  <a:gd name="connsiteY1" fmla="*/ 4526 h 932507"/>
                  <a:gd name="connsiteX2" fmla="*/ 99588 w 212907"/>
                  <a:gd name="connsiteY2" fmla="*/ 9053 h 932507"/>
                  <a:gd name="connsiteX3" fmla="*/ 67901 w 212907"/>
                  <a:gd name="connsiteY3" fmla="*/ 31687 h 932507"/>
                  <a:gd name="connsiteX4" fmla="*/ 49794 w 212907"/>
                  <a:gd name="connsiteY4" fmla="*/ 54321 h 932507"/>
                  <a:gd name="connsiteX5" fmla="*/ 40741 w 212907"/>
                  <a:gd name="connsiteY5" fmla="*/ 67901 h 932507"/>
                  <a:gd name="connsiteX6" fmla="*/ 27161 w 212907"/>
                  <a:gd name="connsiteY6" fmla="*/ 76954 h 932507"/>
                  <a:gd name="connsiteX7" fmla="*/ 18107 w 212907"/>
                  <a:gd name="connsiteY7" fmla="*/ 86008 h 932507"/>
                  <a:gd name="connsiteX8" fmla="*/ 9054 w 212907"/>
                  <a:gd name="connsiteY8" fmla="*/ 113168 h 932507"/>
                  <a:gd name="connsiteX9" fmla="*/ 0 w 212907"/>
                  <a:gd name="connsiteY9" fmla="*/ 144855 h 932507"/>
                  <a:gd name="connsiteX10" fmla="*/ 13580 w 212907"/>
                  <a:gd name="connsiteY10" fmla="*/ 199176 h 932507"/>
                  <a:gd name="connsiteX11" fmla="*/ 18107 w 212907"/>
                  <a:gd name="connsiteY11" fmla="*/ 212756 h 932507"/>
                  <a:gd name="connsiteX12" fmla="*/ 22634 w 212907"/>
                  <a:gd name="connsiteY12" fmla="*/ 226336 h 932507"/>
                  <a:gd name="connsiteX13" fmla="*/ 49794 w 212907"/>
                  <a:gd name="connsiteY13" fmla="*/ 258023 h 932507"/>
                  <a:gd name="connsiteX14" fmla="*/ 63375 w 212907"/>
                  <a:gd name="connsiteY14" fmla="*/ 307818 h 932507"/>
                  <a:gd name="connsiteX15" fmla="*/ 67901 w 212907"/>
                  <a:gd name="connsiteY15" fmla="*/ 321398 h 932507"/>
                  <a:gd name="connsiteX16" fmla="*/ 58848 w 212907"/>
                  <a:gd name="connsiteY16" fmla="*/ 366665 h 932507"/>
                  <a:gd name="connsiteX17" fmla="*/ 49794 w 212907"/>
                  <a:gd name="connsiteY17" fmla="*/ 375719 h 932507"/>
                  <a:gd name="connsiteX18" fmla="*/ 45268 w 212907"/>
                  <a:gd name="connsiteY18" fmla="*/ 466253 h 932507"/>
                  <a:gd name="connsiteX19" fmla="*/ 40741 w 212907"/>
                  <a:gd name="connsiteY19" fmla="*/ 484360 h 932507"/>
                  <a:gd name="connsiteX20" fmla="*/ 31687 w 212907"/>
                  <a:gd name="connsiteY20" fmla="*/ 520574 h 932507"/>
                  <a:gd name="connsiteX21" fmla="*/ 45268 w 212907"/>
                  <a:gd name="connsiteY21" fmla="*/ 629216 h 932507"/>
                  <a:gd name="connsiteX22" fmla="*/ 54321 w 212907"/>
                  <a:gd name="connsiteY22" fmla="*/ 656376 h 932507"/>
                  <a:gd name="connsiteX23" fmla="*/ 72428 w 212907"/>
                  <a:gd name="connsiteY23" fmla="*/ 674483 h 932507"/>
                  <a:gd name="connsiteX24" fmla="*/ 86008 w 212907"/>
                  <a:gd name="connsiteY24" fmla="*/ 697117 h 932507"/>
                  <a:gd name="connsiteX25" fmla="*/ 90535 w 212907"/>
                  <a:gd name="connsiteY25" fmla="*/ 710697 h 932507"/>
                  <a:gd name="connsiteX26" fmla="*/ 104115 w 212907"/>
                  <a:gd name="connsiteY26" fmla="*/ 719750 h 932507"/>
                  <a:gd name="connsiteX27" fmla="*/ 122222 w 212907"/>
                  <a:gd name="connsiteY27" fmla="*/ 742384 h 932507"/>
                  <a:gd name="connsiteX28" fmla="*/ 140329 w 212907"/>
                  <a:gd name="connsiteY28" fmla="*/ 760491 h 932507"/>
                  <a:gd name="connsiteX29" fmla="*/ 149382 w 212907"/>
                  <a:gd name="connsiteY29" fmla="*/ 774071 h 932507"/>
                  <a:gd name="connsiteX30" fmla="*/ 167489 w 212907"/>
                  <a:gd name="connsiteY30" fmla="*/ 792178 h 932507"/>
                  <a:gd name="connsiteX31" fmla="*/ 172016 w 212907"/>
                  <a:gd name="connsiteY31" fmla="*/ 805758 h 932507"/>
                  <a:gd name="connsiteX32" fmla="*/ 181070 w 212907"/>
                  <a:gd name="connsiteY32" fmla="*/ 814812 h 932507"/>
                  <a:gd name="connsiteX33" fmla="*/ 190123 w 212907"/>
                  <a:gd name="connsiteY33" fmla="*/ 841972 h 932507"/>
                  <a:gd name="connsiteX34" fmla="*/ 194650 w 212907"/>
                  <a:gd name="connsiteY34" fmla="*/ 855552 h 932507"/>
                  <a:gd name="connsiteX35" fmla="*/ 203703 w 212907"/>
                  <a:gd name="connsiteY35" fmla="*/ 882713 h 932507"/>
                  <a:gd name="connsiteX36" fmla="*/ 208230 w 212907"/>
                  <a:gd name="connsiteY36" fmla="*/ 905346 h 932507"/>
                  <a:gd name="connsiteX37" fmla="*/ 212757 w 212907"/>
                  <a:gd name="connsiteY37" fmla="*/ 932507 h 9325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</a:cxnLst>
                <a:rect l="l" t="t" r="r" b="b"/>
                <a:pathLst>
                  <a:path w="212907" h="932507">
                    <a:moveTo>
                      <a:pt x="172016" y="0"/>
                    </a:moveTo>
                    <a:cubicBezTo>
                      <a:pt x="152400" y="1509"/>
                      <a:pt x="132691" y="2086"/>
                      <a:pt x="113169" y="4526"/>
                    </a:cubicBezTo>
                    <a:cubicBezTo>
                      <a:pt x="108434" y="5118"/>
                      <a:pt x="103471" y="6279"/>
                      <a:pt x="99588" y="9053"/>
                    </a:cubicBezTo>
                    <a:cubicBezTo>
                      <a:pt x="61994" y="35905"/>
                      <a:pt x="98586" y="21458"/>
                      <a:pt x="67901" y="31687"/>
                    </a:cubicBezTo>
                    <a:cubicBezTo>
                      <a:pt x="40038" y="73483"/>
                      <a:pt x="75594" y="22070"/>
                      <a:pt x="49794" y="54321"/>
                    </a:cubicBezTo>
                    <a:cubicBezTo>
                      <a:pt x="46395" y="58569"/>
                      <a:pt x="44588" y="64054"/>
                      <a:pt x="40741" y="67901"/>
                    </a:cubicBezTo>
                    <a:cubicBezTo>
                      <a:pt x="36894" y="71748"/>
                      <a:pt x="31409" y="73555"/>
                      <a:pt x="27161" y="76954"/>
                    </a:cubicBezTo>
                    <a:cubicBezTo>
                      <a:pt x="23828" y="79620"/>
                      <a:pt x="21125" y="82990"/>
                      <a:pt x="18107" y="86008"/>
                    </a:cubicBezTo>
                    <a:cubicBezTo>
                      <a:pt x="15089" y="95061"/>
                      <a:pt x="11369" y="103910"/>
                      <a:pt x="9054" y="113168"/>
                    </a:cubicBezTo>
                    <a:cubicBezTo>
                      <a:pt x="3370" y="135904"/>
                      <a:pt x="6495" y="125373"/>
                      <a:pt x="0" y="144855"/>
                    </a:cubicBezTo>
                    <a:cubicBezTo>
                      <a:pt x="6095" y="181427"/>
                      <a:pt x="1625" y="163311"/>
                      <a:pt x="13580" y="199176"/>
                    </a:cubicBezTo>
                    <a:lnTo>
                      <a:pt x="18107" y="212756"/>
                    </a:lnTo>
                    <a:cubicBezTo>
                      <a:pt x="19616" y="217283"/>
                      <a:pt x="19260" y="222962"/>
                      <a:pt x="22634" y="226336"/>
                    </a:cubicBezTo>
                    <a:cubicBezTo>
                      <a:pt x="31609" y="235311"/>
                      <a:pt x="44278" y="245613"/>
                      <a:pt x="49794" y="258023"/>
                    </a:cubicBezTo>
                    <a:cubicBezTo>
                      <a:pt x="60892" y="282994"/>
                      <a:pt x="57290" y="283476"/>
                      <a:pt x="63375" y="307818"/>
                    </a:cubicBezTo>
                    <a:cubicBezTo>
                      <a:pt x="64532" y="312447"/>
                      <a:pt x="66392" y="316871"/>
                      <a:pt x="67901" y="321398"/>
                    </a:cubicBezTo>
                    <a:cubicBezTo>
                      <a:pt x="67116" y="326896"/>
                      <a:pt x="64775" y="356788"/>
                      <a:pt x="58848" y="366665"/>
                    </a:cubicBezTo>
                    <a:cubicBezTo>
                      <a:pt x="56652" y="370325"/>
                      <a:pt x="52812" y="372701"/>
                      <a:pt x="49794" y="375719"/>
                    </a:cubicBezTo>
                    <a:cubicBezTo>
                      <a:pt x="48285" y="405897"/>
                      <a:pt x="47777" y="436142"/>
                      <a:pt x="45268" y="466253"/>
                    </a:cubicBezTo>
                    <a:cubicBezTo>
                      <a:pt x="44751" y="472453"/>
                      <a:pt x="42091" y="478287"/>
                      <a:pt x="40741" y="484360"/>
                    </a:cubicBezTo>
                    <a:cubicBezTo>
                      <a:pt x="33457" y="517135"/>
                      <a:pt x="39777" y="496307"/>
                      <a:pt x="31687" y="520574"/>
                    </a:cubicBezTo>
                    <a:cubicBezTo>
                      <a:pt x="34759" y="569730"/>
                      <a:pt x="31494" y="587893"/>
                      <a:pt x="45268" y="629216"/>
                    </a:cubicBezTo>
                    <a:cubicBezTo>
                      <a:pt x="48286" y="638269"/>
                      <a:pt x="47573" y="649628"/>
                      <a:pt x="54321" y="656376"/>
                    </a:cubicBezTo>
                    <a:lnTo>
                      <a:pt x="72428" y="674483"/>
                    </a:lnTo>
                    <a:cubicBezTo>
                      <a:pt x="85252" y="712953"/>
                      <a:pt x="67367" y="666048"/>
                      <a:pt x="86008" y="697117"/>
                    </a:cubicBezTo>
                    <a:cubicBezTo>
                      <a:pt x="88463" y="701209"/>
                      <a:pt x="87554" y="706971"/>
                      <a:pt x="90535" y="710697"/>
                    </a:cubicBezTo>
                    <a:cubicBezTo>
                      <a:pt x="93934" y="714945"/>
                      <a:pt x="99867" y="716351"/>
                      <a:pt x="104115" y="719750"/>
                    </a:cubicBezTo>
                    <a:cubicBezTo>
                      <a:pt x="118125" y="730958"/>
                      <a:pt x="109388" y="727411"/>
                      <a:pt x="122222" y="742384"/>
                    </a:cubicBezTo>
                    <a:cubicBezTo>
                      <a:pt x="127777" y="748865"/>
                      <a:pt x="135594" y="753389"/>
                      <a:pt x="140329" y="760491"/>
                    </a:cubicBezTo>
                    <a:cubicBezTo>
                      <a:pt x="143347" y="765018"/>
                      <a:pt x="145842" y="769940"/>
                      <a:pt x="149382" y="774071"/>
                    </a:cubicBezTo>
                    <a:cubicBezTo>
                      <a:pt x="154937" y="780552"/>
                      <a:pt x="167489" y="792178"/>
                      <a:pt x="167489" y="792178"/>
                    </a:cubicBezTo>
                    <a:cubicBezTo>
                      <a:pt x="168998" y="796705"/>
                      <a:pt x="169561" y="801666"/>
                      <a:pt x="172016" y="805758"/>
                    </a:cubicBezTo>
                    <a:cubicBezTo>
                      <a:pt x="174212" y="809418"/>
                      <a:pt x="179161" y="810994"/>
                      <a:pt x="181070" y="814812"/>
                    </a:cubicBezTo>
                    <a:cubicBezTo>
                      <a:pt x="185338" y="823348"/>
                      <a:pt x="187105" y="832919"/>
                      <a:pt x="190123" y="841972"/>
                    </a:cubicBezTo>
                    <a:lnTo>
                      <a:pt x="194650" y="855552"/>
                    </a:lnTo>
                    <a:cubicBezTo>
                      <a:pt x="194654" y="855565"/>
                      <a:pt x="203700" y="882700"/>
                      <a:pt x="203703" y="882713"/>
                    </a:cubicBezTo>
                    <a:cubicBezTo>
                      <a:pt x="205212" y="890257"/>
                      <a:pt x="206364" y="897882"/>
                      <a:pt x="208230" y="905346"/>
                    </a:cubicBezTo>
                    <a:cubicBezTo>
                      <a:pt x="214189" y="929179"/>
                      <a:pt x="212757" y="908502"/>
                      <a:pt x="212757" y="932507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Freeform 42"/>
              <p:cNvSpPr/>
              <p:nvPr/>
            </p:nvSpPr>
            <p:spPr>
              <a:xfrm>
                <a:off x="2498756" y="3662127"/>
                <a:ext cx="208230" cy="212756"/>
              </a:xfrm>
              <a:custGeom>
                <a:avLst/>
                <a:gdLst>
                  <a:gd name="connsiteX0" fmla="*/ 0 w 208230"/>
                  <a:gd name="connsiteY0" fmla="*/ 0 h 212756"/>
                  <a:gd name="connsiteX1" fmla="*/ 31688 w 208230"/>
                  <a:gd name="connsiteY1" fmla="*/ 40740 h 212756"/>
                  <a:gd name="connsiteX2" fmla="*/ 45268 w 208230"/>
                  <a:gd name="connsiteY2" fmla="*/ 45267 h 212756"/>
                  <a:gd name="connsiteX3" fmla="*/ 76955 w 208230"/>
                  <a:gd name="connsiteY3" fmla="*/ 72427 h 212756"/>
                  <a:gd name="connsiteX4" fmla="*/ 81482 w 208230"/>
                  <a:gd name="connsiteY4" fmla="*/ 86008 h 212756"/>
                  <a:gd name="connsiteX5" fmla="*/ 99589 w 208230"/>
                  <a:gd name="connsiteY5" fmla="*/ 108641 h 212756"/>
                  <a:gd name="connsiteX6" fmla="*/ 117695 w 208230"/>
                  <a:gd name="connsiteY6" fmla="*/ 149382 h 212756"/>
                  <a:gd name="connsiteX7" fmla="*/ 131276 w 208230"/>
                  <a:gd name="connsiteY7" fmla="*/ 153909 h 212756"/>
                  <a:gd name="connsiteX8" fmla="*/ 153909 w 208230"/>
                  <a:gd name="connsiteY8" fmla="*/ 172016 h 212756"/>
                  <a:gd name="connsiteX9" fmla="*/ 162963 w 208230"/>
                  <a:gd name="connsiteY9" fmla="*/ 181069 h 212756"/>
                  <a:gd name="connsiteX10" fmla="*/ 190123 w 208230"/>
                  <a:gd name="connsiteY10" fmla="*/ 190123 h 212756"/>
                  <a:gd name="connsiteX11" fmla="*/ 199177 w 208230"/>
                  <a:gd name="connsiteY11" fmla="*/ 199176 h 212756"/>
                  <a:gd name="connsiteX12" fmla="*/ 208230 w 208230"/>
                  <a:gd name="connsiteY12" fmla="*/ 212756 h 21275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208230" h="212756">
                    <a:moveTo>
                      <a:pt x="0" y="0"/>
                    </a:moveTo>
                    <a:cubicBezTo>
                      <a:pt x="5433" y="9055"/>
                      <a:pt x="19525" y="36685"/>
                      <a:pt x="31688" y="40740"/>
                    </a:cubicBezTo>
                    <a:lnTo>
                      <a:pt x="45268" y="45267"/>
                    </a:lnTo>
                    <a:cubicBezTo>
                      <a:pt x="67222" y="67221"/>
                      <a:pt x="56273" y="58639"/>
                      <a:pt x="76955" y="72427"/>
                    </a:cubicBezTo>
                    <a:cubicBezTo>
                      <a:pt x="78464" y="76954"/>
                      <a:pt x="79348" y="81740"/>
                      <a:pt x="81482" y="86008"/>
                    </a:cubicBezTo>
                    <a:cubicBezTo>
                      <a:pt x="87193" y="97430"/>
                      <a:pt x="91167" y="100220"/>
                      <a:pt x="99589" y="108641"/>
                    </a:cubicBezTo>
                    <a:cubicBezTo>
                      <a:pt x="102355" y="116939"/>
                      <a:pt x="107913" y="141557"/>
                      <a:pt x="117695" y="149382"/>
                    </a:cubicBezTo>
                    <a:cubicBezTo>
                      <a:pt x="121421" y="152363"/>
                      <a:pt x="126749" y="152400"/>
                      <a:pt x="131276" y="153909"/>
                    </a:cubicBezTo>
                    <a:cubicBezTo>
                      <a:pt x="149305" y="180954"/>
                      <a:pt x="129616" y="157441"/>
                      <a:pt x="153909" y="172016"/>
                    </a:cubicBezTo>
                    <a:cubicBezTo>
                      <a:pt x="157569" y="174212"/>
                      <a:pt x="159146" y="179160"/>
                      <a:pt x="162963" y="181069"/>
                    </a:cubicBezTo>
                    <a:cubicBezTo>
                      <a:pt x="171499" y="185337"/>
                      <a:pt x="190123" y="190123"/>
                      <a:pt x="190123" y="190123"/>
                    </a:cubicBezTo>
                    <a:cubicBezTo>
                      <a:pt x="193141" y="193141"/>
                      <a:pt x="196511" y="195843"/>
                      <a:pt x="199177" y="199176"/>
                    </a:cubicBezTo>
                    <a:cubicBezTo>
                      <a:pt x="202576" y="203424"/>
                      <a:pt x="208230" y="212756"/>
                      <a:pt x="208230" y="212756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Freeform 43"/>
              <p:cNvSpPr/>
              <p:nvPr/>
            </p:nvSpPr>
            <p:spPr>
              <a:xfrm>
                <a:off x="2883529" y="4268709"/>
                <a:ext cx="153909" cy="249342"/>
              </a:xfrm>
              <a:custGeom>
                <a:avLst/>
                <a:gdLst>
                  <a:gd name="connsiteX0" fmla="*/ 0 w 153909"/>
                  <a:gd name="connsiteY0" fmla="*/ 0 h 249342"/>
                  <a:gd name="connsiteX1" fmla="*/ 9053 w 153909"/>
                  <a:gd name="connsiteY1" fmla="*/ 40741 h 249342"/>
                  <a:gd name="connsiteX2" fmla="*/ 18107 w 153909"/>
                  <a:gd name="connsiteY2" fmla="*/ 49794 h 249342"/>
                  <a:gd name="connsiteX3" fmla="*/ 27160 w 153909"/>
                  <a:gd name="connsiteY3" fmla="*/ 76954 h 249342"/>
                  <a:gd name="connsiteX4" fmla="*/ 45267 w 153909"/>
                  <a:gd name="connsiteY4" fmla="*/ 99588 h 249342"/>
                  <a:gd name="connsiteX5" fmla="*/ 58847 w 153909"/>
                  <a:gd name="connsiteY5" fmla="*/ 122222 h 249342"/>
                  <a:gd name="connsiteX6" fmla="*/ 76954 w 153909"/>
                  <a:gd name="connsiteY6" fmla="*/ 149382 h 249342"/>
                  <a:gd name="connsiteX7" fmla="*/ 90534 w 153909"/>
                  <a:gd name="connsiteY7" fmla="*/ 172016 h 249342"/>
                  <a:gd name="connsiteX8" fmla="*/ 95061 w 153909"/>
                  <a:gd name="connsiteY8" fmla="*/ 185596 h 249342"/>
                  <a:gd name="connsiteX9" fmla="*/ 113168 w 153909"/>
                  <a:gd name="connsiteY9" fmla="*/ 203703 h 249342"/>
                  <a:gd name="connsiteX10" fmla="*/ 131275 w 153909"/>
                  <a:gd name="connsiteY10" fmla="*/ 226337 h 249342"/>
                  <a:gd name="connsiteX11" fmla="*/ 149382 w 153909"/>
                  <a:gd name="connsiteY11" fmla="*/ 248970 h 249342"/>
                  <a:gd name="connsiteX12" fmla="*/ 153909 w 153909"/>
                  <a:gd name="connsiteY12" fmla="*/ 248970 h 2493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153909" h="249342">
                    <a:moveTo>
                      <a:pt x="0" y="0"/>
                    </a:moveTo>
                    <a:cubicBezTo>
                      <a:pt x="914" y="5487"/>
                      <a:pt x="3909" y="32168"/>
                      <a:pt x="9053" y="40741"/>
                    </a:cubicBezTo>
                    <a:cubicBezTo>
                      <a:pt x="11249" y="44401"/>
                      <a:pt x="15089" y="46776"/>
                      <a:pt x="18107" y="49794"/>
                    </a:cubicBezTo>
                    <a:cubicBezTo>
                      <a:pt x="21125" y="58847"/>
                      <a:pt x="20412" y="70206"/>
                      <a:pt x="27160" y="76954"/>
                    </a:cubicBezTo>
                    <a:cubicBezTo>
                      <a:pt x="35582" y="85376"/>
                      <a:pt x="39556" y="88166"/>
                      <a:pt x="45267" y="99588"/>
                    </a:cubicBezTo>
                    <a:cubicBezTo>
                      <a:pt x="57020" y="123094"/>
                      <a:pt x="41164" y="104537"/>
                      <a:pt x="58847" y="122222"/>
                    </a:cubicBezTo>
                    <a:cubicBezTo>
                      <a:pt x="69611" y="154512"/>
                      <a:pt x="54348" y="115474"/>
                      <a:pt x="76954" y="149382"/>
                    </a:cubicBezTo>
                    <a:cubicBezTo>
                      <a:pt x="100463" y="184645"/>
                      <a:pt x="62336" y="143815"/>
                      <a:pt x="90534" y="172016"/>
                    </a:cubicBezTo>
                    <a:cubicBezTo>
                      <a:pt x="92043" y="176543"/>
                      <a:pt x="92288" y="181713"/>
                      <a:pt x="95061" y="185596"/>
                    </a:cubicBezTo>
                    <a:cubicBezTo>
                      <a:pt x="100022" y="192542"/>
                      <a:pt x="108433" y="196601"/>
                      <a:pt x="113168" y="203703"/>
                    </a:cubicBezTo>
                    <a:cubicBezTo>
                      <a:pt x="141031" y="245499"/>
                      <a:pt x="105475" y="194086"/>
                      <a:pt x="131275" y="226337"/>
                    </a:cubicBezTo>
                    <a:cubicBezTo>
                      <a:pt x="138195" y="234987"/>
                      <a:pt x="140011" y="242724"/>
                      <a:pt x="149382" y="248970"/>
                    </a:cubicBezTo>
                    <a:cubicBezTo>
                      <a:pt x="150638" y="249807"/>
                      <a:pt x="152400" y="248970"/>
                      <a:pt x="153909" y="248970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Freeform 44"/>
              <p:cNvSpPr/>
              <p:nvPr/>
            </p:nvSpPr>
            <p:spPr>
              <a:xfrm>
                <a:off x="4209861" y="3390523"/>
                <a:ext cx="289711" cy="887239"/>
              </a:xfrm>
              <a:custGeom>
                <a:avLst/>
                <a:gdLst>
                  <a:gd name="connsiteX0" fmla="*/ 0 w 289711"/>
                  <a:gd name="connsiteY0" fmla="*/ 0 h 887239"/>
                  <a:gd name="connsiteX1" fmla="*/ 54321 w 289711"/>
                  <a:gd name="connsiteY1" fmla="*/ 4527 h 887239"/>
                  <a:gd name="connsiteX2" fmla="*/ 95062 w 289711"/>
                  <a:gd name="connsiteY2" fmla="*/ 22633 h 887239"/>
                  <a:gd name="connsiteX3" fmla="*/ 113169 w 289711"/>
                  <a:gd name="connsiteY3" fmla="*/ 40740 h 887239"/>
                  <a:gd name="connsiteX4" fmla="*/ 140329 w 289711"/>
                  <a:gd name="connsiteY4" fmla="*/ 49794 h 887239"/>
                  <a:gd name="connsiteX5" fmla="*/ 149383 w 289711"/>
                  <a:gd name="connsiteY5" fmla="*/ 58847 h 887239"/>
                  <a:gd name="connsiteX6" fmla="*/ 176543 w 289711"/>
                  <a:gd name="connsiteY6" fmla="*/ 72427 h 887239"/>
                  <a:gd name="connsiteX7" fmla="*/ 203703 w 289711"/>
                  <a:gd name="connsiteY7" fmla="*/ 108641 h 887239"/>
                  <a:gd name="connsiteX8" fmla="*/ 226337 w 289711"/>
                  <a:gd name="connsiteY8" fmla="*/ 126748 h 887239"/>
                  <a:gd name="connsiteX9" fmla="*/ 239917 w 289711"/>
                  <a:gd name="connsiteY9" fmla="*/ 149382 h 887239"/>
                  <a:gd name="connsiteX10" fmla="*/ 253497 w 289711"/>
                  <a:gd name="connsiteY10" fmla="*/ 172016 h 887239"/>
                  <a:gd name="connsiteX11" fmla="*/ 262551 w 289711"/>
                  <a:gd name="connsiteY11" fmla="*/ 199176 h 887239"/>
                  <a:gd name="connsiteX12" fmla="*/ 276131 w 289711"/>
                  <a:gd name="connsiteY12" fmla="*/ 226336 h 887239"/>
                  <a:gd name="connsiteX13" fmla="*/ 271604 w 289711"/>
                  <a:gd name="connsiteY13" fmla="*/ 366665 h 887239"/>
                  <a:gd name="connsiteX14" fmla="*/ 267078 w 289711"/>
                  <a:gd name="connsiteY14" fmla="*/ 384772 h 887239"/>
                  <a:gd name="connsiteX15" fmla="*/ 276131 w 289711"/>
                  <a:gd name="connsiteY15" fmla="*/ 461727 h 887239"/>
                  <a:gd name="connsiteX16" fmla="*/ 289711 w 289711"/>
                  <a:gd name="connsiteY16" fmla="*/ 511521 h 887239"/>
                  <a:gd name="connsiteX17" fmla="*/ 276131 w 289711"/>
                  <a:gd name="connsiteY17" fmla="*/ 651849 h 887239"/>
                  <a:gd name="connsiteX18" fmla="*/ 276131 w 289711"/>
                  <a:gd name="connsiteY18" fmla="*/ 651849 h 887239"/>
                  <a:gd name="connsiteX19" fmla="*/ 267078 w 289711"/>
                  <a:gd name="connsiteY19" fmla="*/ 697117 h 887239"/>
                  <a:gd name="connsiteX20" fmla="*/ 258024 w 289711"/>
                  <a:gd name="connsiteY20" fmla="*/ 706170 h 887239"/>
                  <a:gd name="connsiteX21" fmla="*/ 244444 w 289711"/>
                  <a:gd name="connsiteY21" fmla="*/ 728804 h 887239"/>
                  <a:gd name="connsiteX22" fmla="*/ 239917 w 289711"/>
                  <a:gd name="connsiteY22" fmla="*/ 742384 h 887239"/>
                  <a:gd name="connsiteX23" fmla="*/ 226337 w 289711"/>
                  <a:gd name="connsiteY23" fmla="*/ 751437 h 887239"/>
                  <a:gd name="connsiteX24" fmla="*/ 208230 w 289711"/>
                  <a:gd name="connsiteY24" fmla="*/ 769544 h 887239"/>
                  <a:gd name="connsiteX25" fmla="*/ 199177 w 289711"/>
                  <a:gd name="connsiteY25" fmla="*/ 778598 h 887239"/>
                  <a:gd name="connsiteX26" fmla="*/ 185596 w 289711"/>
                  <a:gd name="connsiteY26" fmla="*/ 787651 h 887239"/>
                  <a:gd name="connsiteX27" fmla="*/ 172016 w 289711"/>
                  <a:gd name="connsiteY27" fmla="*/ 792178 h 887239"/>
                  <a:gd name="connsiteX28" fmla="*/ 158436 w 289711"/>
                  <a:gd name="connsiteY28" fmla="*/ 805758 h 887239"/>
                  <a:gd name="connsiteX29" fmla="*/ 135802 w 289711"/>
                  <a:gd name="connsiteY29" fmla="*/ 819338 h 887239"/>
                  <a:gd name="connsiteX30" fmla="*/ 122222 w 289711"/>
                  <a:gd name="connsiteY30" fmla="*/ 841972 h 887239"/>
                  <a:gd name="connsiteX31" fmla="*/ 117695 w 289711"/>
                  <a:gd name="connsiteY31" fmla="*/ 855552 h 887239"/>
                  <a:gd name="connsiteX32" fmla="*/ 108642 w 289711"/>
                  <a:gd name="connsiteY32" fmla="*/ 864606 h 887239"/>
                  <a:gd name="connsiteX33" fmla="*/ 99589 w 289711"/>
                  <a:gd name="connsiteY33" fmla="*/ 878186 h 887239"/>
                  <a:gd name="connsiteX34" fmla="*/ 90535 w 289711"/>
                  <a:gd name="connsiteY34" fmla="*/ 887239 h 8872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289711" h="887239">
                    <a:moveTo>
                      <a:pt x="0" y="0"/>
                    </a:moveTo>
                    <a:cubicBezTo>
                      <a:pt x="18107" y="1509"/>
                      <a:pt x="36398" y="1540"/>
                      <a:pt x="54321" y="4527"/>
                    </a:cubicBezTo>
                    <a:cubicBezTo>
                      <a:pt x="68427" y="6878"/>
                      <a:pt x="83926" y="13088"/>
                      <a:pt x="95062" y="22633"/>
                    </a:cubicBezTo>
                    <a:cubicBezTo>
                      <a:pt x="101543" y="28188"/>
                      <a:pt x="105071" y="38041"/>
                      <a:pt x="113169" y="40740"/>
                    </a:cubicBezTo>
                    <a:lnTo>
                      <a:pt x="140329" y="49794"/>
                    </a:lnTo>
                    <a:cubicBezTo>
                      <a:pt x="143347" y="52812"/>
                      <a:pt x="145723" y="56651"/>
                      <a:pt x="149383" y="58847"/>
                    </a:cubicBezTo>
                    <a:cubicBezTo>
                      <a:pt x="182839" y="78920"/>
                      <a:pt x="142215" y="44964"/>
                      <a:pt x="176543" y="72427"/>
                    </a:cubicBezTo>
                    <a:cubicBezTo>
                      <a:pt x="196612" y="88483"/>
                      <a:pt x="174757" y="79695"/>
                      <a:pt x="203703" y="108641"/>
                    </a:cubicBezTo>
                    <a:cubicBezTo>
                      <a:pt x="216604" y="121542"/>
                      <a:pt x="209206" y="115328"/>
                      <a:pt x="226337" y="126748"/>
                    </a:cubicBezTo>
                    <a:cubicBezTo>
                      <a:pt x="239161" y="165218"/>
                      <a:pt x="221276" y="118313"/>
                      <a:pt x="239917" y="149382"/>
                    </a:cubicBezTo>
                    <a:cubicBezTo>
                      <a:pt x="257546" y="178764"/>
                      <a:pt x="230559" y="149075"/>
                      <a:pt x="253497" y="172016"/>
                    </a:cubicBezTo>
                    <a:cubicBezTo>
                      <a:pt x="256515" y="181069"/>
                      <a:pt x="257258" y="191236"/>
                      <a:pt x="262551" y="199176"/>
                    </a:cubicBezTo>
                    <a:cubicBezTo>
                      <a:pt x="274251" y="216726"/>
                      <a:pt x="269884" y="207595"/>
                      <a:pt x="276131" y="226336"/>
                    </a:cubicBezTo>
                    <a:cubicBezTo>
                      <a:pt x="274622" y="273112"/>
                      <a:pt x="274274" y="319941"/>
                      <a:pt x="271604" y="366665"/>
                    </a:cubicBezTo>
                    <a:cubicBezTo>
                      <a:pt x="271249" y="372876"/>
                      <a:pt x="267078" y="378551"/>
                      <a:pt x="267078" y="384772"/>
                    </a:cubicBezTo>
                    <a:cubicBezTo>
                      <a:pt x="267078" y="411642"/>
                      <a:pt x="270228" y="436147"/>
                      <a:pt x="276131" y="461727"/>
                    </a:cubicBezTo>
                    <a:cubicBezTo>
                      <a:pt x="283787" y="494903"/>
                      <a:pt x="282231" y="489076"/>
                      <a:pt x="289711" y="511521"/>
                    </a:cubicBezTo>
                    <a:cubicBezTo>
                      <a:pt x="284645" y="628066"/>
                      <a:pt x="293611" y="581935"/>
                      <a:pt x="276131" y="651849"/>
                    </a:cubicBezTo>
                    <a:lnTo>
                      <a:pt x="276131" y="651849"/>
                    </a:lnTo>
                    <a:cubicBezTo>
                      <a:pt x="275347" y="657335"/>
                      <a:pt x="273001" y="687244"/>
                      <a:pt x="267078" y="697117"/>
                    </a:cubicBezTo>
                    <a:cubicBezTo>
                      <a:pt x="264882" y="700777"/>
                      <a:pt x="261042" y="703152"/>
                      <a:pt x="258024" y="706170"/>
                    </a:cubicBezTo>
                    <a:cubicBezTo>
                      <a:pt x="245200" y="744640"/>
                      <a:pt x="263085" y="697735"/>
                      <a:pt x="244444" y="728804"/>
                    </a:cubicBezTo>
                    <a:cubicBezTo>
                      <a:pt x="241989" y="732896"/>
                      <a:pt x="242898" y="738658"/>
                      <a:pt x="239917" y="742384"/>
                    </a:cubicBezTo>
                    <a:cubicBezTo>
                      <a:pt x="236518" y="746632"/>
                      <a:pt x="230468" y="747897"/>
                      <a:pt x="226337" y="751437"/>
                    </a:cubicBezTo>
                    <a:cubicBezTo>
                      <a:pt x="219856" y="756992"/>
                      <a:pt x="214266" y="763508"/>
                      <a:pt x="208230" y="769544"/>
                    </a:cubicBezTo>
                    <a:cubicBezTo>
                      <a:pt x="205212" y="772562"/>
                      <a:pt x="202728" y="776231"/>
                      <a:pt x="199177" y="778598"/>
                    </a:cubicBezTo>
                    <a:cubicBezTo>
                      <a:pt x="194650" y="781616"/>
                      <a:pt x="190462" y="785218"/>
                      <a:pt x="185596" y="787651"/>
                    </a:cubicBezTo>
                    <a:cubicBezTo>
                      <a:pt x="181328" y="789785"/>
                      <a:pt x="176543" y="790669"/>
                      <a:pt x="172016" y="792178"/>
                    </a:cubicBezTo>
                    <a:cubicBezTo>
                      <a:pt x="167489" y="796705"/>
                      <a:pt x="163762" y="802207"/>
                      <a:pt x="158436" y="805758"/>
                    </a:cubicBezTo>
                    <a:cubicBezTo>
                      <a:pt x="123173" y="829267"/>
                      <a:pt x="164003" y="791140"/>
                      <a:pt x="135802" y="819338"/>
                    </a:cubicBezTo>
                    <a:cubicBezTo>
                      <a:pt x="122983" y="857802"/>
                      <a:pt x="140860" y="810911"/>
                      <a:pt x="122222" y="841972"/>
                    </a:cubicBezTo>
                    <a:cubicBezTo>
                      <a:pt x="119767" y="846063"/>
                      <a:pt x="120150" y="851460"/>
                      <a:pt x="117695" y="855552"/>
                    </a:cubicBezTo>
                    <a:cubicBezTo>
                      <a:pt x="115499" y="859212"/>
                      <a:pt x="111308" y="861273"/>
                      <a:pt x="108642" y="864606"/>
                    </a:cubicBezTo>
                    <a:cubicBezTo>
                      <a:pt x="105244" y="868854"/>
                      <a:pt x="102988" y="873938"/>
                      <a:pt x="99589" y="878186"/>
                    </a:cubicBezTo>
                    <a:cubicBezTo>
                      <a:pt x="96923" y="881519"/>
                      <a:pt x="90535" y="887239"/>
                      <a:pt x="90535" y="887239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Freeform 45"/>
              <p:cNvSpPr/>
              <p:nvPr/>
            </p:nvSpPr>
            <p:spPr>
              <a:xfrm>
                <a:off x="4128380" y="4268709"/>
                <a:ext cx="181070" cy="289743"/>
              </a:xfrm>
              <a:custGeom>
                <a:avLst/>
                <a:gdLst>
                  <a:gd name="connsiteX0" fmla="*/ 181070 w 181070"/>
                  <a:gd name="connsiteY0" fmla="*/ 0 h 289743"/>
                  <a:gd name="connsiteX1" fmla="*/ 167489 w 181070"/>
                  <a:gd name="connsiteY1" fmla="*/ 22634 h 289743"/>
                  <a:gd name="connsiteX2" fmla="*/ 149382 w 181070"/>
                  <a:gd name="connsiteY2" fmla="*/ 58847 h 289743"/>
                  <a:gd name="connsiteX3" fmla="*/ 131275 w 181070"/>
                  <a:gd name="connsiteY3" fmla="*/ 95061 h 289743"/>
                  <a:gd name="connsiteX4" fmla="*/ 122222 w 181070"/>
                  <a:gd name="connsiteY4" fmla="*/ 122222 h 289743"/>
                  <a:gd name="connsiteX5" fmla="*/ 95062 w 181070"/>
                  <a:gd name="connsiteY5" fmla="*/ 158436 h 289743"/>
                  <a:gd name="connsiteX6" fmla="*/ 81481 w 181070"/>
                  <a:gd name="connsiteY6" fmla="*/ 181069 h 289743"/>
                  <a:gd name="connsiteX7" fmla="*/ 67901 w 181070"/>
                  <a:gd name="connsiteY7" fmla="*/ 203703 h 289743"/>
                  <a:gd name="connsiteX8" fmla="*/ 54321 w 181070"/>
                  <a:gd name="connsiteY8" fmla="*/ 226337 h 289743"/>
                  <a:gd name="connsiteX9" fmla="*/ 49794 w 181070"/>
                  <a:gd name="connsiteY9" fmla="*/ 239917 h 289743"/>
                  <a:gd name="connsiteX10" fmla="*/ 22634 w 181070"/>
                  <a:gd name="connsiteY10" fmla="*/ 271604 h 289743"/>
                  <a:gd name="connsiteX11" fmla="*/ 13580 w 181070"/>
                  <a:gd name="connsiteY11" fmla="*/ 280657 h 289743"/>
                  <a:gd name="connsiteX12" fmla="*/ 0 w 181070"/>
                  <a:gd name="connsiteY12" fmla="*/ 289711 h 2897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181070" h="289743">
                    <a:moveTo>
                      <a:pt x="181070" y="0"/>
                    </a:moveTo>
                    <a:cubicBezTo>
                      <a:pt x="176543" y="7545"/>
                      <a:pt x="171130" y="14624"/>
                      <a:pt x="167489" y="22634"/>
                    </a:cubicBezTo>
                    <a:cubicBezTo>
                      <a:pt x="150151" y="60778"/>
                      <a:pt x="168286" y="39945"/>
                      <a:pt x="149382" y="58847"/>
                    </a:cubicBezTo>
                    <a:cubicBezTo>
                      <a:pt x="138979" y="90057"/>
                      <a:pt x="147078" y="79260"/>
                      <a:pt x="131275" y="95061"/>
                    </a:cubicBezTo>
                    <a:cubicBezTo>
                      <a:pt x="128257" y="104115"/>
                      <a:pt x="127516" y="114282"/>
                      <a:pt x="122222" y="122222"/>
                    </a:cubicBezTo>
                    <a:cubicBezTo>
                      <a:pt x="101748" y="152933"/>
                      <a:pt x="111808" y="141688"/>
                      <a:pt x="95062" y="158436"/>
                    </a:cubicBezTo>
                    <a:cubicBezTo>
                      <a:pt x="82236" y="196912"/>
                      <a:pt x="100125" y="149996"/>
                      <a:pt x="81481" y="181069"/>
                    </a:cubicBezTo>
                    <a:cubicBezTo>
                      <a:pt x="63850" y="210454"/>
                      <a:pt x="90844" y="180760"/>
                      <a:pt x="67901" y="203703"/>
                    </a:cubicBezTo>
                    <a:cubicBezTo>
                      <a:pt x="55077" y="242173"/>
                      <a:pt x="72962" y="195268"/>
                      <a:pt x="54321" y="226337"/>
                    </a:cubicBezTo>
                    <a:cubicBezTo>
                      <a:pt x="51866" y="230429"/>
                      <a:pt x="51928" y="235649"/>
                      <a:pt x="49794" y="239917"/>
                    </a:cubicBezTo>
                    <a:cubicBezTo>
                      <a:pt x="42900" y="253706"/>
                      <a:pt x="33772" y="260466"/>
                      <a:pt x="22634" y="271604"/>
                    </a:cubicBezTo>
                    <a:lnTo>
                      <a:pt x="13580" y="280657"/>
                    </a:lnTo>
                    <a:cubicBezTo>
                      <a:pt x="3459" y="290778"/>
                      <a:pt x="8795" y="289711"/>
                      <a:pt x="0" y="289711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Freeform 46"/>
              <p:cNvSpPr/>
              <p:nvPr/>
            </p:nvSpPr>
            <p:spPr>
              <a:xfrm>
                <a:off x="4476733" y="3512745"/>
                <a:ext cx="95267" cy="86007"/>
              </a:xfrm>
              <a:custGeom>
                <a:avLst/>
                <a:gdLst>
                  <a:gd name="connsiteX0" fmla="*/ 95267 w 95267"/>
                  <a:gd name="connsiteY0" fmla="*/ 0 h 86007"/>
                  <a:gd name="connsiteX1" fmla="*/ 36419 w 95267"/>
                  <a:gd name="connsiteY1" fmla="*/ 4526 h 86007"/>
                  <a:gd name="connsiteX2" fmla="*/ 22839 w 95267"/>
                  <a:gd name="connsiteY2" fmla="*/ 9053 h 86007"/>
                  <a:gd name="connsiteX3" fmla="*/ 18313 w 95267"/>
                  <a:gd name="connsiteY3" fmla="*/ 22633 h 86007"/>
                  <a:gd name="connsiteX4" fmla="*/ 9259 w 95267"/>
                  <a:gd name="connsiteY4" fmla="*/ 36213 h 86007"/>
                  <a:gd name="connsiteX5" fmla="*/ 206 w 95267"/>
                  <a:gd name="connsiteY5" fmla="*/ 86007 h 860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95267" h="86007">
                    <a:moveTo>
                      <a:pt x="95267" y="0"/>
                    </a:moveTo>
                    <a:cubicBezTo>
                      <a:pt x="75651" y="1509"/>
                      <a:pt x="55941" y="2086"/>
                      <a:pt x="36419" y="4526"/>
                    </a:cubicBezTo>
                    <a:cubicBezTo>
                      <a:pt x="31684" y="5118"/>
                      <a:pt x="26213" y="5679"/>
                      <a:pt x="22839" y="9053"/>
                    </a:cubicBezTo>
                    <a:cubicBezTo>
                      <a:pt x="19465" y="12427"/>
                      <a:pt x="20447" y="18365"/>
                      <a:pt x="18313" y="22633"/>
                    </a:cubicBezTo>
                    <a:cubicBezTo>
                      <a:pt x="15880" y="27499"/>
                      <a:pt x="12277" y="31686"/>
                      <a:pt x="9259" y="36213"/>
                    </a:cubicBezTo>
                    <a:cubicBezTo>
                      <a:pt x="-2180" y="70531"/>
                      <a:pt x="206" y="53831"/>
                      <a:pt x="206" y="86007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2107333" y="3176185"/>
              <a:ext cx="1064992" cy="885204"/>
              <a:chOff x="3552800" y="3480536"/>
              <a:chExt cx="1335388" cy="1113576"/>
            </a:xfrm>
          </p:grpSpPr>
          <p:sp>
            <p:nvSpPr>
              <p:cNvPr id="40" name="Freeform 39"/>
              <p:cNvSpPr/>
              <p:nvPr/>
            </p:nvSpPr>
            <p:spPr>
              <a:xfrm>
                <a:off x="4209176" y="3507697"/>
                <a:ext cx="679012" cy="1086415"/>
              </a:xfrm>
              <a:custGeom>
                <a:avLst/>
                <a:gdLst>
                  <a:gd name="connsiteX0" fmla="*/ 90535 w 679012"/>
                  <a:gd name="connsiteY0" fmla="*/ 416459 h 1086415"/>
                  <a:gd name="connsiteX1" fmla="*/ 86008 w 679012"/>
                  <a:gd name="connsiteY1" fmla="*/ 393825 h 1086415"/>
                  <a:gd name="connsiteX2" fmla="*/ 67901 w 679012"/>
                  <a:gd name="connsiteY2" fmla="*/ 375718 h 1086415"/>
                  <a:gd name="connsiteX3" fmla="*/ 49794 w 679012"/>
                  <a:gd name="connsiteY3" fmla="*/ 353085 h 1086415"/>
                  <a:gd name="connsiteX4" fmla="*/ 40741 w 679012"/>
                  <a:gd name="connsiteY4" fmla="*/ 325924 h 1086415"/>
                  <a:gd name="connsiteX5" fmla="*/ 36214 w 679012"/>
                  <a:gd name="connsiteY5" fmla="*/ 312344 h 1086415"/>
                  <a:gd name="connsiteX6" fmla="*/ 31687 w 679012"/>
                  <a:gd name="connsiteY6" fmla="*/ 298764 h 1086415"/>
                  <a:gd name="connsiteX7" fmla="*/ 36214 w 679012"/>
                  <a:gd name="connsiteY7" fmla="*/ 267077 h 1086415"/>
                  <a:gd name="connsiteX8" fmla="*/ 40741 w 679012"/>
                  <a:gd name="connsiteY8" fmla="*/ 253497 h 1086415"/>
                  <a:gd name="connsiteX9" fmla="*/ 45267 w 679012"/>
                  <a:gd name="connsiteY9" fmla="*/ 212756 h 1086415"/>
                  <a:gd name="connsiteX10" fmla="*/ 58847 w 679012"/>
                  <a:gd name="connsiteY10" fmla="*/ 162962 h 1086415"/>
                  <a:gd name="connsiteX11" fmla="*/ 67901 w 679012"/>
                  <a:gd name="connsiteY11" fmla="*/ 135802 h 1086415"/>
                  <a:gd name="connsiteX12" fmla="*/ 72428 w 679012"/>
                  <a:gd name="connsiteY12" fmla="*/ 122221 h 1086415"/>
                  <a:gd name="connsiteX13" fmla="*/ 86008 w 679012"/>
                  <a:gd name="connsiteY13" fmla="*/ 95061 h 1086415"/>
                  <a:gd name="connsiteX14" fmla="*/ 95061 w 679012"/>
                  <a:gd name="connsiteY14" fmla="*/ 81481 h 1086415"/>
                  <a:gd name="connsiteX15" fmla="*/ 99588 w 679012"/>
                  <a:gd name="connsiteY15" fmla="*/ 67901 h 1086415"/>
                  <a:gd name="connsiteX16" fmla="*/ 108642 w 679012"/>
                  <a:gd name="connsiteY16" fmla="*/ 58847 h 1086415"/>
                  <a:gd name="connsiteX17" fmla="*/ 126748 w 679012"/>
                  <a:gd name="connsiteY17" fmla="*/ 36213 h 1086415"/>
                  <a:gd name="connsiteX18" fmla="*/ 140329 w 679012"/>
                  <a:gd name="connsiteY18" fmla="*/ 31687 h 1086415"/>
                  <a:gd name="connsiteX19" fmla="*/ 176543 w 679012"/>
                  <a:gd name="connsiteY19" fmla="*/ 13580 h 1086415"/>
                  <a:gd name="connsiteX20" fmla="*/ 190123 w 679012"/>
                  <a:gd name="connsiteY20" fmla="*/ 9053 h 1086415"/>
                  <a:gd name="connsiteX21" fmla="*/ 203703 w 679012"/>
                  <a:gd name="connsiteY21" fmla="*/ 4526 h 1086415"/>
                  <a:gd name="connsiteX22" fmla="*/ 221810 w 679012"/>
                  <a:gd name="connsiteY22" fmla="*/ 0 h 1086415"/>
                  <a:gd name="connsiteX23" fmla="*/ 303291 w 679012"/>
                  <a:gd name="connsiteY23" fmla="*/ 4526 h 1086415"/>
                  <a:gd name="connsiteX24" fmla="*/ 330451 w 679012"/>
                  <a:gd name="connsiteY24" fmla="*/ 13580 h 1086415"/>
                  <a:gd name="connsiteX25" fmla="*/ 344032 w 679012"/>
                  <a:gd name="connsiteY25" fmla="*/ 18107 h 1086415"/>
                  <a:gd name="connsiteX26" fmla="*/ 371192 w 679012"/>
                  <a:gd name="connsiteY26" fmla="*/ 36213 h 1086415"/>
                  <a:gd name="connsiteX27" fmla="*/ 384772 w 679012"/>
                  <a:gd name="connsiteY27" fmla="*/ 45267 h 1086415"/>
                  <a:gd name="connsiteX28" fmla="*/ 411933 w 679012"/>
                  <a:gd name="connsiteY28" fmla="*/ 58847 h 1086415"/>
                  <a:gd name="connsiteX29" fmla="*/ 430040 w 679012"/>
                  <a:gd name="connsiteY29" fmla="*/ 76954 h 1086415"/>
                  <a:gd name="connsiteX30" fmla="*/ 439093 w 679012"/>
                  <a:gd name="connsiteY30" fmla="*/ 86008 h 1086415"/>
                  <a:gd name="connsiteX31" fmla="*/ 452673 w 679012"/>
                  <a:gd name="connsiteY31" fmla="*/ 95061 h 1086415"/>
                  <a:gd name="connsiteX32" fmla="*/ 470780 w 679012"/>
                  <a:gd name="connsiteY32" fmla="*/ 113168 h 1086415"/>
                  <a:gd name="connsiteX33" fmla="*/ 479834 w 679012"/>
                  <a:gd name="connsiteY33" fmla="*/ 122221 h 1086415"/>
                  <a:gd name="connsiteX34" fmla="*/ 493414 w 679012"/>
                  <a:gd name="connsiteY34" fmla="*/ 126748 h 1086415"/>
                  <a:gd name="connsiteX35" fmla="*/ 511521 w 679012"/>
                  <a:gd name="connsiteY35" fmla="*/ 144855 h 1086415"/>
                  <a:gd name="connsiteX36" fmla="*/ 520574 w 679012"/>
                  <a:gd name="connsiteY36" fmla="*/ 153909 h 1086415"/>
                  <a:gd name="connsiteX37" fmla="*/ 534154 w 679012"/>
                  <a:gd name="connsiteY37" fmla="*/ 158435 h 1086415"/>
                  <a:gd name="connsiteX38" fmla="*/ 543208 w 679012"/>
                  <a:gd name="connsiteY38" fmla="*/ 167489 h 1086415"/>
                  <a:gd name="connsiteX39" fmla="*/ 556788 w 679012"/>
                  <a:gd name="connsiteY39" fmla="*/ 176542 h 1086415"/>
                  <a:gd name="connsiteX40" fmla="*/ 574895 w 679012"/>
                  <a:gd name="connsiteY40" fmla="*/ 194649 h 1086415"/>
                  <a:gd name="connsiteX41" fmla="*/ 597529 w 679012"/>
                  <a:gd name="connsiteY41" fmla="*/ 226336 h 1086415"/>
                  <a:gd name="connsiteX42" fmla="*/ 606582 w 679012"/>
                  <a:gd name="connsiteY42" fmla="*/ 235390 h 1086415"/>
                  <a:gd name="connsiteX43" fmla="*/ 611109 w 679012"/>
                  <a:gd name="connsiteY43" fmla="*/ 248970 h 1086415"/>
                  <a:gd name="connsiteX44" fmla="*/ 624689 w 679012"/>
                  <a:gd name="connsiteY44" fmla="*/ 258023 h 1086415"/>
                  <a:gd name="connsiteX45" fmla="*/ 638269 w 679012"/>
                  <a:gd name="connsiteY45" fmla="*/ 298764 h 1086415"/>
                  <a:gd name="connsiteX46" fmla="*/ 642796 w 679012"/>
                  <a:gd name="connsiteY46" fmla="*/ 312344 h 1086415"/>
                  <a:gd name="connsiteX47" fmla="*/ 651849 w 679012"/>
                  <a:gd name="connsiteY47" fmla="*/ 321398 h 1086415"/>
                  <a:gd name="connsiteX48" fmla="*/ 665430 w 679012"/>
                  <a:gd name="connsiteY48" fmla="*/ 366665 h 1086415"/>
                  <a:gd name="connsiteX49" fmla="*/ 669956 w 679012"/>
                  <a:gd name="connsiteY49" fmla="*/ 380245 h 1086415"/>
                  <a:gd name="connsiteX50" fmla="*/ 674483 w 679012"/>
                  <a:gd name="connsiteY50" fmla="*/ 402879 h 1086415"/>
                  <a:gd name="connsiteX51" fmla="*/ 674483 w 679012"/>
                  <a:gd name="connsiteY51" fmla="*/ 565841 h 1086415"/>
                  <a:gd name="connsiteX52" fmla="*/ 660903 w 679012"/>
                  <a:gd name="connsiteY52" fmla="*/ 615635 h 1086415"/>
                  <a:gd name="connsiteX53" fmla="*/ 656376 w 679012"/>
                  <a:gd name="connsiteY53" fmla="*/ 633742 h 1086415"/>
                  <a:gd name="connsiteX54" fmla="*/ 651849 w 679012"/>
                  <a:gd name="connsiteY54" fmla="*/ 656376 h 1086415"/>
                  <a:gd name="connsiteX55" fmla="*/ 642796 w 679012"/>
                  <a:gd name="connsiteY55" fmla="*/ 683536 h 1086415"/>
                  <a:gd name="connsiteX56" fmla="*/ 638269 w 679012"/>
                  <a:gd name="connsiteY56" fmla="*/ 701643 h 1086415"/>
                  <a:gd name="connsiteX57" fmla="*/ 629216 w 679012"/>
                  <a:gd name="connsiteY57" fmla="*/ 728804 h 1086415"/>
                  <a:gd name="connsiteX58" fmla="*/ 611109 w 679012"/>
                  <a:gd name="connsiteY58" fmla="*/ 792178 h 1086415"/>
                  <a:gd name="connsiteX59" fmla="*/ 588475 w 679012"/>
                  <a:gd name="connsiteY59" fmla="*/ 860079 h 1086415"/>
                  <a:gd name="connsiteX60" fmla="*/ 583948 w 679012"/>
                  <a:gd name="connsiteY60" fmla="*/ 873659 h 1086415"/>
                  <a:gd name="connsiteX61" fmla="*/ 579422 w 679012"/>
                  <a:gd name="connsiteY61" fmla="*/ 887239 h 1086415"/>
                  <a:gd name="connsiteX62" fmla="*/ 570368 w 679012"/>
                  <a:gd name="connsiteY62" fmla="*/ 896293 h 1086415"/>
                  <a:gd name="connsiteX63" fmla="*/ 556788 w 679012"/>
                  <a:gd name="connsiteY63" fmla="*/ 937033 h 1086415"/>
                  <a:gd name="connsiteX64" fmla="*/ 552261 w 679012"/>
                  <a:gd name="connsiteY64" fmla="*/ 950613 h 1086415"/>
                  <a:gd name="connsiteX65" fmla="*/ 534154 w 679012"/>
                  <a:gd name="connsiteY65" fmla="*/ 973247 h 1086415"/>
                  <a:gd name="connsiteX66" fmla="*/ 529628 w 679012"/>
                  <a:gd name="connsiteY66" fmla="*/ 986827 h 1086415"/>
                  <a:gd name="connsiteX67" fmla="*/ 493414 w 679012"/>
                  <a:gd name="connsiteY67" fmla="*/ 1032095 h 1086415"/>
                  <a:gd name="connsiteX68" fmla="*/ 484360 w 679012"/>
                  <a:gd name="connsiteY68" fmla="*/ 1041148 h 1086415"/>
                  <a:gd name="connsiteX69" fmla="*/ 475307 w 679012"/>
                  <a:gd name="connsiteY69" fmla="*/ 1050202 h 1086415"/>
                  <a:gd name="connsiteX70" fmla="*/ 439093 w 679012"/>
                  <a:gd name="connsiteY70" fmla="*/ 1059255 h 1086415"/>
                  <a:gd name="connsiteX71" fmla="*/ 425513 w 679012"/>
                  <a:gd name="connsiteY71" fmla="*/ 1063782 h 1086415"/>
                  <a:gd name="connsiteX72" fmla="*/ 407406 w 679012"/>
                  <a:gd name="connsiteY72" fmla="*/ 1068309 h 1086415"/>
                  <a:gd name="connsiteX73" fmla="*/ 384772 w 679012"/>
                  <a:gd name="connsiteY73" fmla="*/ 1072835 h 1086415"/>
                  <a:gd name="connsiteX74" fmla="*/ 357612 w 679012"/>
                  <a:gd name="connsiteY74" fmla="*/ 1081889 h 1086415"/>
                  <a:gd name="connsiteX75" fmla="*/ 339505 w 679012"/>
                  <a:gd name="connsiteY75" fmla="*/ 1086415 h 1086415"/>
                  <a:gd name="connsiteX76" fmla="*/ 267077 w 679012"/>
                  <a:gd name="connsiteY76" fmla="*/ 1081889 h 1086415"/>
                  <a:gd name="connsiteX77" fmla="*/ 248970 w 679012"/>
                  <a:gd name="connsiteY77" fmla="*/ 1077362 h 1086415"/>
                  <a:gd name="connsiteX78" fmla="*/ 194649 w 679012"/>
                  <a:gd name="connsiteY78" fmla="*/ 1068309 h 1086415"/>
                  <a:gd name="connsiteX79" fmla="*/ 153909 w 679012"/>
                  <a:gd name="connsiteY79" fmla="*/ 1054728 h 1086415"/>
                  <a:gd name="connsiteX80" fmla="*/ 140329 w 679012"/>
                  <a:gd name="connsiteY80" fmla="*/ 1050202 h 1086415"/>
                  <a:gd name="connsiteX81" fmla="*/ 131275 w 679012"/>
                  <a:gd name="connsiteY81" fmla="*/ 1041148 h 1086415"/>
                  <a:gd name="connsiteX82" fmla="*/ 117695 w 679012"/>
                  <a:gd name="connsiteY82" fmla="*/ 1036621 h 1086415"/>
                  <a:gd name="connsiteX83" fmla="*/ 104115 w 679012"/>
                  <a:gd name="connsiteY83" fmla="*/ 1009461 h 1086415"/>
                  <a:gd name="connsiteX84" fmla="*/ 95061 w 679012"/>
                  <a:gd name="connsiteY84" fmla="*/ 1000408 h 1086415"/>
                  <a:gd name="connsiteX85" fmla="*/ 81481 w 679012"/>
                  <a:gd name="connsiteY85" fmla="*/ 959667 h 1086415"/>
                  <a:gd name="connsiteX86" fmla="*/ 76954 w 679012"/>
                  <a:gd name="connsiteY86" fmla="*/ 946087 h 1086415"/>
                  <a:gd name="connsiteX87" fmla="*/ 72428 w 679012"/>
                  <a:gd name="connsiteY87" fmla="*/ 932507 h 1086415"/>
                  <a:gd name="connsiteX88" fmla="*/ 63374 w 679012"/>
                  <a:gd name="connsiteY88" fmla="*/ 923453 h 1086415"/>
                  <a:gd name="connsiteX89" fmla="*/ 45267 w 679012"/>
                  <a:gd name="connsiteY89" fmla="*/ 887239 h 1086415"/>
                  <a:gd name="connsiteX90" fmla="*/ 40741 w 679012"/>
                  <a:gd name="connsiteY90" fmla="*/ 873659 h 1086415"/>
                  <a:gd name="connsiteX91" fmla="*/ 31687 w 679012"/>
                  <a:gd name="connsiteY91" fmla="*/ 864606 h 1086415"/>
                  <a:gd name="connsiteX92" fmla="*/ 22634 w 679012"/>
                  <a:gd name="connsiteY92" fmla="*/ 837445 h 1086415"/>
                  <a:gd name="connsiteX93" fmla="*/ 13580 w 679012"/>
                  <a:gd name="connsiteY93" fmla="*/ 810285 h 1086415"/>
                  <a:gd name="connsiteX94" fmla="*/ 9053 w 679012"/>
                  <a:gd name="connsiteY94" fmla="*/ 796705 h 1086415"/>
                  <a:gd name="connsiteX95" fmla="*/ 0 w 679012"/>
                  <a:gd name="connsiteY95" fmla="*/ 751437 h 1086415"/>
                  <a:gd name="connsiteX96" fmla="*/ 4527 w 679012"/>
                  <a:gd name="connsiteY96" fmla="*/ 615635 h 1086415"/>
                  <a:gd name="connsiteX97" fmla="*/ 9053 w 679012"/>
                  <a:gd name="connsiteY97" fmla="*/ 593002 h 1086415"/>
                  <a:gd name="connsiteX98" fmla="*/ 18107 w 679012"/>
                  <a:gd name="connsiteY98" fmla="*/ 529627 h 1086415"/>
                  <a:gd name="connsiteX99" fmla="*/ 27160 w 679012"/>
                  <a:gd name="connsiteY99" fmla="*/ 502467 h 1086415"/>
                  <a:gd name="connsiteX100" fmla="*/ 31687 w 679012"/>
                  <a:gd name="connsiteY100" fmla="*/ 488887 h 1086415"/>
                  <a:gd name="connsiteX101" fmla="*/ 40741 w 679012"/>
                  <a:gd name="connsiteY101" fmla="*/ 479833 h 1086415"/>
                  <a:gd name="connsiteX102" fmla="*/ 54321 w 679012"/>
                  <a:gd name="connsiteY102" fmla="*/ 457200 h 1086415"/>
                  <a:gd name="connsiteX103" fmla="*/ 67901 w 679012"/>
                  <a:gd name="connsiteY103" fmla="*/ 434566 h 1086415"/>
                  <a:gd name="connsiteX104" fmla="*/ 90535 w 679012"/>
                  <a:gd name="connsiteY104" fmla="*/ 416459 h 10864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</a:cxnLst>
                <a:rect l="l" t="t" r="r" b="b"/>
                <a:pathLst>
                  <a:path w="679012" h="1086415">
                    <a:moveTo>
                      <a:pt x="90535" y="416459"/>
                    </a:moveTo>
                    <a:cubicBezTo>
                      <a:pt x="93553" y="409669"/>
                      <a:pt x="89745" y="400551"/>
                      <a:pt x="86008" y="393825"/>
                    </a:cubicBezTo>
                    <a:cubicBezTo>
                      <a:pt x="81863" y="386363"/>
                      <a:pt x="73937" y="381754"/>
                      <a:pt x="67901" y="375718"/>
                    </a:cubicBezTo>
                    <a:cubicBezTo>
                      <a:pt x="60374" y="368192"/>
                      <a:pt x="54363" y="363367"/>
                      <a:pt x="49794" y="353085"/>
                    </a:cubicBezTo>
                    <a:cubicBezTo>
                      <a:pt x="45918" y="344364"/>
                      <a:pt x="43759" y="334978"/>
                      <a:pt x="40741" y="325924"/>
                    </a:cubicBezTo>
                    <a:lnTo>
                      <a:pt x="36214" y="312344"/>
                    </a:lnTo>
                    <a:lnTo>
                      <a:pt x="31687" y="298764"/>
                    </a:lnTo>
                    <a:cubicBezTo>
                      <a:pt x="33196" y="288202"/>
                      <a:pt x="34121" y="277539"/>
                      <a:pt x="36214" y="267077"/>
                    </a:cubicBezTo>
                    <a:cubicBezTo>
                      <a:pt x="37150" y="262398"/>
                      <a:pt x="39957" y="258204"/>
                      <a:pt x="40741" y="253497"/>
                    </a:cubicBezTo>
                    <a:cubicBezTo>
                      <a:pt x="42987" y="240019"/>
                      <a:pt x="43335" y="226283"/>
                      <a:pt x="45267" y="212756"/>
                    </a:cubicBezTo>
                    <a:cubicBezTo>
                      <a:pt x="48465" y="190366"/>
                      <a:pt x="51330" y="185512"/>
                      <a:pt x="58847" y="162962"/>
                    </a:cubicBezTo>
                    <a:lnTo>
                      <a:pt x="67901" y="135802"/>
                    </a:lnTo>
                    <a:cubicBezTo>
                      <a:pt x="69410" y="131275"/>
                      <a:pt x="69781" y="126191"/>
                      <a:pt x="72428" y="122221"/>
                    </a:cubicBezTo>
                    <a:cubicBezTo>
                      <a:pt x="98372" y="83303"/>
                      <a:pt x="67267" y="132543"/>
                      <a:pt x="86008" y="95061"/>
                    </a:cubicBezTo>
                    <a:cubicBezTo>
                      <a:pt x="88441" y="90195"/>
                      <a:pt x="92628" y="86347"/>
                      <a:pt x="95061" y="81481"/>
                    </a:cubicBezTo>
                    <a:cubicBezTo>
                      <a:pt x="97195" y="77213"/>
                      <a:pt x="97133" y="71993"/>
                      <a:pt x="99588" y="67901"/>
                    </a:cubicBezTo>
                    <a:cubicBezTo>
                      <a:pt x="101784" y="64241"/>
                      <a:pt x="105976" y="62180"/>
                      <a:pt x="108642" y="58847"/>
                    </a:cubicBezTo>
                    <a:cubicBezTo>
                      <a:pt x="114333" y="51733"/>
                      <a:pt x="118343" y="41256"/>
                      <a:pt x="126748" y="36213"/>
                    </a:cubicBezTo>
                    <a:cubicBezTo>
                      <a:pt x="130840" y="33758"/>
                      <a:pt x="135802" y="33196"/>
                      <a:pt x="140329" y="31687"/>
                    </a:cubicBezTo>
                    <a:cubicBezTo>
                      <a:pt x="156130" y="15884"/>
                      <a:pt x="145332" y="23983"/>
                      <a:pt x="176543" y="13580"/>
                    </a:cubicBezTo>
                    <a:lnTo>
                      <a:pt x="190123" y="9053"/>
                    </a:lnTo>
                    <a:cubicBezTo>
                      <a:pt x="194650" y="7544"/>
                      <a:pt x="199074" y="5683"/>
                      <a:pt x="203703" y="4526"/>
                    </a:cubicBezTo>
                    <a:lnTo>
                      <a:pt x="221810" y="0"/>
                    </a:lnTo>
                    <a:cubicBezTo>
                      <a:pt x="248970" y="1509"/>
                      <a:pt x="276299" y="1152"/>
                      <a:pt x="303291" y="4526"/>
                    </a:cubicBezTo>
                    <a:cubicBezTo>
                      <a:pt x="312760" y="5710"/>
                      <a:pt x="321398" y="10562"/>
                      <a:pt x="330451" y="13580"/>
                    </a:cubicBezTo>
                    <a:cubicBezTo>
                      <a:pt x="334978" y="15089"/>
                      <a:pt x="340062" y="15460"/>
                      <a:pt x="344032" y="18107"/>
                    </a:cubicBezTo>
                    <a:lnTo>
                      <a:pt x="371192" y="36213"/>
                    </a:lnTo>
                    <a:cubicBezTo>
                      <a:pt x="375719" y="39231"/>
                      <a:pt x="379611" y="43546"/>
                      <a:pt x="384772" y="45267"/>
                    </a:cubicBezTo>
                    <a:cubicBezTo>
                      <a:pt x="397914" y="49648"/>
                      <a:pt x="400766" y="49276"/>
                      <a:pt x="411933" y="58847"/>
                    </a:cubicBezTo>
                    <a:cubicBezTo>
                      <a:pt x="418414" y="64402"/>
                      <a:pt x="424004" y="70918"/>
                      <a:pt x="430040" y="76954"/>
                    </a:cubicBezTo>
                    <a:cubicBezTo>
                      <a:pt x="433058" y="79972"/>
                      <a:pt x="435542" y="83641"/>
                      <a:pt x="439093" y="86008"/>
                    </a:cubicBezTo>
                    <a:cubicBezTo>
                      <a:pt x="443620" y="89026"/>
                      <a:pt x="448542" y="91521"/>
                      <a:pt x="452673" y="95061"/>
                    </a:cubicBezTo>
                    <a:cubicBezTo>
                      <a:pt x="459154" y="100616"/>
                      <a:pt x="464744" y="107132"/>
                      <a:pt x="470780" y="113168"/>
                    </a:cubicBezTo>
                    <a:cubicBezTo>
                      <a:pt x="473798" y="116186"/>
                      <a:pt x="475785" y="120871"/>
                      <a:pt x="479834" y="122221"/>
                    </a:cubicBezTo>
                    <a:lnTo>
                      <a:pt x="493414" y="126748"/>
                    </a:lnTo>
                    <a:lnTo>
                      <a:pt x="511521" y="144855"/>
                    </a:lnTo>
                    <a:cubicBezTo>
                      <a:pt x="514539" y="147873"/>
                      <a:pt x="516525" y="152560"/>
                      <a:pt x="520574" y="153909"/>
                    </a:cubicBezTo>
                    <a:lnTo>
                      <a:pt x="534154" y="158435"/>
                    </a:lnTo>
                    <a:cubicBezTo>
                      <a:pt x="537172" y="161453"/>
                      <a:pt x="539875" y="164823"/>
                      <a:pt x="543208" y="167489"/>
                    </a:cubicBezTo>
                    <a:cubicBezTo>
                      <a:pt x="547456" y="170888"/>
                      <a:pt x="553389" y="172294"/>
                      <a:pt x="556788" y="176542"/>
                    </a:cubicBezTo>
                    <a:cubicBezTo>
                      <a:pt x="574347" y="198490"/>
                      <a:pt x="545265" y="184772"/>
                      <a:pt x="574895" y="194649"/>
                    </a:cubicBezTo>
                    <a:cubicBezTo>
                      <a:pt x="582122" y="216327"/>
                      <a:pt x="576048" y="204854"/>
                      <a:pt x="597529" y="226336"/>
                    </a:cubicBezTo>
                    <a:lnTo>
                      <a:pt x="606582" y="235390"/>
                    </a:lnTo>
                    <a:cubicBezTo>
                      <a:pt x="608091" y="239917"/>
                      <a:pt x="608128" y="245244"/>
                      <a:pt x="611109" y="248970"/>
                    </a:cubicBezTo>
                    <a:cubicBezTo>
                      <a:pt x="614508" y="253218"/>
                      <a:pt x="621806" y="253410"/>
                      <a:pt x="624689" y="258023"/>
                    </a:cubicBezTo>
                    <a:cubicBezTo>
                      <a:pt x="624694" y="258031"/>
                      <a:pt x="636004" y="291969"/>
                      <a:pt x="638269" y="298764"/>
                    </a:cubicBezTo>
                    <a:cubicBezTo>
                      <a:pt x="639778" y="303291"/>
                      <a:pt x="639422" y="308970"/>
                      <a:pt x="642796" y="312344"/>
                    </a:cubicBezTo>
                    <a:lnTo>
                      <a:pt x="651849" y="321398"/>
                    </a:lnTo>
                    <a:cubicBezTo>
                      <a:pt x="673349" y="385893"/>
                      <a:pt x="651757" y="318808"/>
                      <a:pt x="665430" y="366665"/>
                    </a:cubicBezTo>
                    <a:cubicBezTo>
                      <a:pt x="666741" y="371253"/>
                      <a:pt x="668799" y="375616"/>
                      <a:pt x="669956" y="380245"/>
                    </a:cubicBezTo>
                    <a:cubicBezTo>
                      <a:pt x="671822" y="387709"/>
                      <a:pt x="672974" y="395334"/>
                      <a:pt x="674483" y="402879"/>
                    </a:cubicBezTo>
                    <a:cubicBezTo>
                      <a:pt x="678774" y="488689"/>
                      <a:pt x="682051" y="486380"/>
                      <a:pt x="674483" y="565841"/>
                    </a:cubicBezTo>
                    <a:cubicBezTo>
                      <a:pt x="672074" y="591132"/>
                      <a:pt x="667440" y="589487"/>
                      <a:pt x="660903" y="615635"/>
                    </a:cubicBezTo>
                    <a:cubicBezTo>
                      <a:pt x="659394" y="621671"/>
                      <a:pt x="657726" y="627669"/>
                      <a:pt x="656376" y="633742"/>
                    </a:cubicBezTo>
                    <a:cubicBezTo>
                      <a:pt x="654707" y="641253"/>
                      <a:pt x="653873" y="648953"/>
                      <a:pt x="651849" y="656376"/>
                    </a:cubicBezTo>
                    <a:cubicBezTo>
                      <a:pt x="649338" y="665583"/>
                      <a:pt x="645111" y="674278"/>
                      <a:pt x="642796" y="683536"/>
                    </a:cubicBezTo>
                    <a:cubicBezTo>
                      <a:pt x="641287" y="689572"/>
                      <a:pt x="640057" y="695684"/>
                      <a:pt x="638269" y="701643"/>
                    </a:cubicBezTo>
                    <a:cubicBezTo>
                      <a:pt x="635527" y="710784"/>
                      <a:pt x="631531" y="719546"/>
                      <a:pt x="629216" y="728804"/>
                    </a:cubicBezTo>
                    <a:cubicBezTo>
                      <a:pt x="617850" y="774265"/>
                      <a:pt x="624095" y="753221"/>
                      <a:pt x="611109" y="792178"/>
                    </a:cubicBezTo>
                    <a:lnTo>
                      <a:pt x="588475" y="860079"/>
                    </a:lnTo>
                    <a:lnTo>
                      <a:pt x="583948" y="873659"/>
                    </a:lnTo>
                    <a:cubicBezTo>
                      <a:pt x="582439" y="878186"/>
                      <a:pt x="582796" y="883865"/>
                      <a:pt x="579422" y="887239"/>
                    </a:cubicBezTo>
                    <a:lnTo>
                      <a:pt x="570368" y="896293"/>
                    </a:lnTo>
                    <a:lnTo>
                      <a:pt x="556788" y="937033"/>
                    </a:lnTo>
                    <a:cubicBezTo>
                      <a:pt x="555279" y="941560"/>
                      <a:pt x="555635" y="947239"/>
                      <a:pt x="552261" y="950613"/>
                    </a:cubicBezTo>
                    <a:cubicBezTo>
                      <a:pt x="539361" y="963514"/>
                      <a:pt x="545576" y="956116"/>
                      <a:pt x="534154" y="973247"/>
                    </a:cubicBezTo>
                    <a:cubicBezTo>
                      <a:pt x="532645" y="977774"/>
                      <a:pt x="531945" y="982656"/>
                      <a:pt x="529628" y="986827"/>
                    </a:cubicBezTo>
                    <a:cubicBezTo>
                      <a:pt x="515354" y="1012522"/>
                      <a:pt x="512494" y="1013015"/>
                      <a:pt x="493414" y="1032095"/>
                    </a:cubicBezTo>
                    <a:lnTo>
                      <a:pt x="484360" y="1041148"/>
                    </a:lnTo>
                    <a:cubicBezTo>
                      <a:pt x="481342" y="1044166"/>
                      <a:pt x="479356" y="1048853"/>
                      <a:pt x="475307" y="1050202"/>
                    </a:cubicBezTo>
                    <a:cubicBezTo>
                      <a:pt x="444256" y="1060551"/>
                      <a:pt x="482807" y="1048326"/>
                      <a:pt x="439093" y="1059255"/>
                    </a:cubicBezTo>
                    <a:cubicBezTo>
                      <a:pt x="434464" y="1060412"/>
                      <a:pt x="430101" y="1062471"/>
                      <a:pt x="425513" y="1063782"/>
                    </a:cubicBezTo>
                    <a:cubicBezTo>
                      <a:pt x="419531" y="1065491"/>
                      <a:pt x="413479" y="1066959"/>
                      <a:pt x="407406" y="1068309"/>
                    </a:cubicBezTo>
                    <a:cubicBezTo>
                      <a:pt x="399895" y="1069978"/>
                      <a:pt x="392195" y="1070811"/>
                      <a:pt x="384772" y="1072835"/>
                    </a:cubicBezTo>
                    <a:cubicBezTo>
                      <a:pt x="375565" y="1075346"/>
                      <a:pt x="366870" y="1079575"/>
                      <a:pt x="357612" y="1081889"/>
                    </a:cubicBezTo>
                    <a:lnTo>
                      <a:pt x="339505" y="1086415"/>
                    </a:lnTo>
                    <a:cubicBezTo>
                      <a:pt x="315362" y="1084906"/>
                      <a:pt x="291147" y="1084296"/>
                      <a:pt x="267077" y="1081889"/>
                    </a:cubicBezTo>
                    <a:cubicBezTo>
                      <a:pt x="260886" y="1081270"/>
                      <a:pt x="255043" y="1078712"/>
                      <a:pt x="248970" y="1077362"/>
                    </a:cubicBezTo>
                    <a:cubicBezTo>
                      <a:pt x="225136" y="1072065"/>
                      <a:pt x="221110" y="1072088"/>
                      <a:pt x="194649" y="1068309"/>
                    </a:cubicBezTo>
                    <a:lnTo>
                      <a:pt x="153909" y="1054728"/>
                    </a:lnTo>
                    <a:lnTo>
                      <a:pt x="140329" y="1050202"/>
                    </a:lnTo>
                    <a:cubicBezTo>
                      <a:pt x="137311" y="1047184"/>
                      <a:pt x="134935" y="1043344"/>
                      <a:pt x="131275" y="1041148"/>
                    </a:cubicBezTo>
                    <a:cubicBezTo>
                      <a:pt x="127183" y="1038693"/>
                      <a:pt x="121421" y="1039602"/>
                      <a:pt x="117695" y="1036621"/>
                    </a:cubicBezTo>
                    <a:cubicBezTo>
                      <a:pt x="104487" y="1026054"/>
                      <a:pt x="111685" y="1022077"/>
                      <a:pt x="104115" y="1009461"/>
                    </a:cubicBezTo>
                    <a:cubicBezTo>
                      <a:pt x="101919" y="1005801"/>
                      <a:pt x="98079" y="1003426"/>
                      <a:pt x="95061" y="1000408"/>
                    </a:cubicBezTo>
                    <a:lnTo>
                      <a:pt x="81481" y="959667"/>
                    </a:lnTo>
                    <a:lnTo>
                      <a:pt x="76954" y="946087"/>
                    </a:lnTo>
                    <a:cubicBezTo>
                      <a:pt x="75445" y="941560"/>
                      <a:pt x="75802" y="935881"/>
                      <a:pt x="72428" y="932507"/>
                    </a:cubicBezTo>
                    <a:lnTo>
                      <a:pt x="63374" y="923453"/>
                    </a:lnTo>
                    <a:cubicBezTo>
                      <a:pt x="52971" y="892244"/>
                      <a:pt x="61069" y="903041"/>
                      <a:pt x="45267" y="887239"/>
                    </a:cubicBezTo>
                    <a:cubicBezTo>
                      <a:pt x="43758" y="882712"/>
                      <a:pt x="43196" y="877750"/>
                      <a:pt x="40741" y="873659"/>
                    </a:cubicBezTo>
                    <a:cubicBezTo>
                      <a:pt x="38545" y="869999"/>
                      <a:pt x="33596" y="868423"/>
                      <a:pt x="31687" y="864606"/>
                    </a:cubicBezTo>
                    <a:cubicBezTo>
                      <a:pt x="27419" y="856070"/>
                      <a:pt x="25652" y="846499"/>
                      <a:pt x="22634" y="837445"/>
                    </a:cubicBezTo>
                    <a:lnTo>
                      <a:pt x="13580" y="810285"/>
                    </a:lnTo>
                    <a:cubicBezTo>
                      <a:pt x="12071" y="805758"/>
                      <a:pt x="9989" y="801384"/>
                      <a:pt x="9053" y="796705"/>
                    </a:cubicBezTo>
                    <a:lnTo>
                      <a:pt x="0" y="751437"/>
                    </a:lnTo>
                    <a:cubicBezTo>
                      <a:pt x="1509" y="706170"/>
                      <a:pt x="1943" y="660854"/>
                      <a:pt x="4527" y="615635"/>
                    </a:cubicBezTo>
                    <a:cubicBezTo>
                      <a:pt x="4966" y="607954"/>
                      <a:pt x="8036" y="600628"/>
                      <a:pt x="9053" y="593002"/>
                    </a:cubicBezTo>
                    <a:cubicBezTo>
                      <a:pt x="14087" y="555246"/>
                      <a:pt x="9948" y="556824"/>
                      <a:pt x="18107" y="529627"/>
                    </a:cubicBezTo>
                    <a:cubicBezTo>
                      <a:pt x="20849" y="520486"/>
                      <a:pt x="24142" y="511520"/>
                      <a:pt x="27160" y="502467"/>
                    </a:cubicBezTo>
                    <a:cubicBezTo>
                      <a:pt x="28669" y="497940"/>
                      <a:pt x="28313" y="492261"/>
                      <a:pt x="31687" y="488887"/>
                    </a:cubicBezTo>
                    <a:lnTo>
                      <a:pt x="40741" y="479833"/>
                    </a:lnTo>
                    <a:cubicBezTo>
                      <a:pt x="53563" y="441360"/>
                      <a:pt x="35679" y="488271"/>
                      <a:pt x="54321" y="457200"/>
                    </a:cubicBezTo>
                    <a:cubicBezTo>
                      <a:pt x="71950" y="427818"/>
                      <a:pt x="44961" y="457504"/>
                      <a:pt x="67901" y="434566"/>
                    </a:cubicBezTo>
                    <a:cubicBezTo>
                      <a:pt x="73495" y="417785"/>
                      <a:pt x="87517" y="423249"/>
                      <a:pt x="90535" y="416459"/>
                    </a:cubicBezTo>
                    <a:close/>
                  </a:path>
                </a:pathLst>
              </a:cu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Freeform 40"/>
              <p:cNvSpPr/>
              <p:nvPr/>
            </p:nvSpPr>
            <p:spPr>
              <a:xfrm>
                <a:off x="3552800" y="3480536"/>
                <a:ext cx="611109" cy="1072836"/>
              </a:xfrm>
              <a:custGeom>
                <a:avLst/>
                <a:gdLst>
                  <a:gd name="connsiteX0" fmla="*/ 380245 w 611109"/>
                  <a:gd name="connsiteY0" fmla="*/ 0 h 1072836"/>
                  <a:gd name="connsiteX1" fmla="*/ 411932 w 611109"/>
                  <a:gd name="connsiteY1" fmla="*/ 4527 h 1072836"/>
                  <a:gd name="connsiteX2" fmla="*/ 430039 w 611109"/>
                  <a:gd name="connsiteY2" fmla="*/ 22634 h 1072836"/>
                  <a:gd name="connsiteX3" fmla="*/ 443620 w 611109"/>
                  <a:gd name="connsiteY3" fmla="*/ 27161 h 1072836"/>
                  <a:gd name="connsiteX4" fmla="*/ 452673 w 611109"/>
                  <a:gd name="connsiteY4" fmla="*/ 40741 h 1072836"/>
                  <a:gd name="connsiteX5" fmla="*/ 466253 w 611109"/>
                  <a:gd name="connsiteY5" fmla="*/ 45268 h 1072836"/>
                  <a:gd name="connsiteX6" fmla="*/ 475307 w 611109"/>
                  <a:gd name="connsiteY6" fmla="*/ 54321 h 1072836"/>
                  <a:gd name="connsiteX7" fmla="*/ 479833 w 611109"/>
                  <a:gd name="connsiteY7" fmla="*/ 67901 h 1072836"/>
                  <a:gd name="connsiteX8" fmla="*/ 488887 w 611109"/>
                  <a:gd name="connsiteY8" fmla="*/ 76955 h 1072836"/>
                  <a:gd name="connsiteX9" fmla="*/ 506994 w 611109"/>
                  <a:gd name="connsiteY9" fmla="*/ 99588 h 1072836"/>
                  <a:gd name="connsiteX10" fmla="*/ 520574 w 611109"/>
                  <a:gd name="connsiteY10" fmla="*/ 140329 h 1072836"/>
                  <a:gd name="connsiteX11" fmla="*/ 525101 w 611109"/>
                  <a:gd name="connsiteY11" fmla="*/ 153909 h 1072836"/>
                  <a:gd name="connsiteX12" fmla="*/ 529627 w 611109"/>
                  <a:gd name="connsiteY12" fmla="*/ 167489 h 1072836"/>
                  <a:gd name="connsiteX13" fmla="*/ 538681 w 611109"/>
                  <a:gd name="connsiteY13" fmla="*/ 176543 h 1072836"/>
                  <a:gd name="connsiteX14" fmla="*/ 547734 w 611109"/>
                  <a:gd name="connsiteY14" fmla="*/ 203703 h 1072836"/>
                  <a:gd name="connsiteX15" fmla="*/ 552261 w 611109"/>
                  <a:gd name="connsiteY15" fmla="*/ 221810 h 1072836"/>
                  <a:gd name="connsiteX16" fmla="*/ 561315 w 611109"/>
                  <a:gd name="connsiteY16" fmla="*/ 248971 h 1072836"/>
                  <a:gd name="connsiteX17" fmla="*/ 579421 w 611109"/>
                  <a:gd name="connsiteY17" fmla="*/ 276131 h 1072836"/>
                  <a:gd name="connsiteX18" fmla="*/ 588475 w 611109"/>
                  <a:gd name="connsiteY18" fmla="*/ 303291 h 1072836"/>
                  <a:gd name="connsiteX19" fmla="*/ 583948 w 611109"/>
                  <a:gd name="connsiteY19" fmla="*/ 362139 h 1072836"/>
                  <a:gd name="connsiteX20" fmla="*/ 570368 w 611109"/>
                  <a:gd name="connsiteY20" fmla="*/ 384773 h 1072836"/>
                  <a:gd name="connsiteX21" fmla="*/ 552261 w 611109"/>
                  <a:gd name="connsiteY21" fmla="*/ 407406 h 1072836"/>
                  <a:gd name="connsiteX22" fmla="*/ 538681 w 611109"/>
                  <a:gd name="connsiteY22" fmla="*/ 411933 h 1072836"/>
                  <a:gd name="connsiteX23" fmla="*/ 529627 w 611109"/>
                  <a:gd name="connsiteY23" fmla="*/ 420986 h 1072836"/>
                  <a:gd name="connsiteX24" fmla="*/ 529627 w 611109"/>
                  <a:gd name="connsiteY24" fmla="*/ 457200 h 1072836"/>
                  <a:gd name="connsiteX25" fmla="*/ 538681 w 611109"/>
                  <a:gd name="connsiteY25" fmla="*/ 466254 h 1072836"/>
                  <a:gd name="connsiteX26" fmla="*/ 547734 w 611109"/>
                  <a:gd name="connsiteY26" fmla="*/ 479834 h 1072836"/>
                  <a:gd name="connsiteX27" fmla="*/ 561315 w 611109"/>
                  <a:gd name="connsiteY27" fmla="*/ 484361 h 1072836"/>
                  <a:gd name="connsiteX28" fmla="*/ 593002 w 611109"/>
                  <a:gd name="connsiteY28" fmla="*/ 511521 h 1072836"/>
                  <a:gd name="connsiteX29" fmla="*/ 602055 w 611109"/>
                  <a:gd name="connsiteY29" fmla="*/ 525101 h 1072836"/>
                  <a:gd name="connsiteX30" fmla="*/ 611109 w 611109"/>
                  <a:gd name="connsiteY30" fmla="*/ 552262 h 1072836"/>
                  <a:gd name="connsiteX31" fmla="*/ 602055 w 611109"/>
                  <a:gd name="connsiteY31" fmla="*/ 660903 h 1072836"/>
                  <a:gd name="connsiteX32" fmla="*/ 597528 w 611109"/>
                  <a:gd name="connsiteY32" fmla="*/ 679010 h 1072836"/>
                  <a:gd name="connsiteX33" fmla="*/ 593002 w 611109"/>
                  <a:gd name="connsiteY33" fmla="*/ 855553 h 1072836"/>
                  <a:gd name="connsiteX34" fmla="*/ 579421 w 611109"/>
                  <a:gd name="connsiteY34" fmla="*/ 878186 h 1072836"/>
                  <a:gd name="connsiteX35" fmla="*/ 565841 w 611109"/>
                  <a:gd name="connsiteY35" fmla="*/ 882713 h 1072836"/>
                  <a:gd name="connsiteX36" fmla="*/ 547734 w 611109"/>
                  <a:gd name="connsiteY36" fmla="*/ 900820 h 1072836"/>
                  <a:gd name="connsiteX37" fmla="*/ 534154 w 611109"/>
                  <a:gd name="connsiteY37" fmla="*/ 941561 h 1072836"/>
                  <a:gd name="connsiteX38" fmla="*/ 529627 w 611109"/>
                  <a:gd name="connsiteY38" fmla="*/ 955141 h 1072836"/>
                  <a:gd name="connsiteX39" fmla="*/ 520574 w 611109"/>
                  <a:gd name="connsiteY39" fmla="*/ 968721 h 1072836"/>
                  <a:gd name="connsiteX40" fmla="*/ 502467 w 611109"/>
                  <a:gd name="connsiteY40" fmla="*/ 1004935 h 1072836"/>
                  <a:gd name="connsiteX41" fmla="*/ 497940 w 611109"/>
                  <a:gd name="connsiteY41" fmla="*/ 1018515 h 1072836"/>
                  <a:gd name="connsiteX42" fmla="*/ 466253 w 611109"/>
                  <a:gd name="connsiteY42" fmla="*/ 1041149 h 1072836"/>
                  <a:gd name="connsiteX43" fmla="*/ 457200 w 611109"/>
                  <a:gd name="connsiteY43" fmla="*/ 1054729 h 1072836"/>
                  <a:gd name="connsiteX44" fmla="*/ 384772 w 611109"/>
                  <a:gd name="connsiteY44" fmla="*/ 1068309 h 1072836"/>
                  <a:gd name="connsiteX45" fmla="*/ 280657 w 611109"/>
                  <a:gd name="connsiteY45" fmla="*/ 1072836 h 1072836"/>
                  <a:gd name="connsiteX46" fmla="*/ 194649 w 611109"/>
                  <a:gd name="connsiteY46" fmla="*/ 1063782 h 1072836"/>
                  <a:gd name="connsiteX47" fmla="*/ 167489 w 611109"/>
                  <a:gd name="connsiteY47" fmla="*/ 1054729 h 1072836"/>
                  <a:gd name="connsiteX48" fmla="*/ 158435 w 611109"/>
                  <a:gd name="connsiteY48" fmla="*/ 1045675 h 1072836"/>
                  <a:gd name="connsiteX49" fmla="*/ 131275 w 611109"/>
                  <a:gd name="connsiteY49" fmla="*/ 1036622 h 1072836"/>
                  <a:gd name="connsiteX50" fmla="*/ 122221 w 611109"/>
                  <a:gd name="connsiteY50" fmla="*/ 1027569 h 1072836"/>
                  <a:gd name="connsiteX51" fmla="*/ 113168 w 611109"/>
                  <a:gd name="connsiteY51" fmla="*/ 1000408 h 1072836"/>
                  <a:gd name="connsiteX52" fmla="*/ 104115 w 611109"/>
                  <a:gd name="connsiteY52" fmla="*/ 986828 h 1072836"/>
                  <a:gd name="connsiteX53" fmla="*/ 95061 w 611109"/>
                  <a:gd name="connsiteY53" fmla="*/ 955141 h 1072836"/>
                  <a:gd name="connsiteX54" fmla="*/ 86008 w 611109"/>
                  <a:gd name="connsiteY54" fmla="*/ 946087 h 1072836"/>
                  <a:gd name="connsiteX55" fmla="*/ 72427 w 611109"/>
                  <a:gd name="connsiteY55" fmla="*/ 905347 h 1072836"/>
                  <a:gd name="connsiteX56" fmla="*/ 63374 w 611109"/>
                  <a:gd name="connsiteY56" fmla="*/ 878186 h 1072836"/>
                  <a:gd name="connsiteX57" fmla="*/ 54320 w 611109"/>
                  <a:gd name="connsiteY57" fmla="*/ 869133 h 1072836"/>
                  <a:gd name="connsiteX58" fmla="*/ 45267 w 611109"/>
                  <a:gd name="connsiteY58" fmla="*/ 819339 h 1072836"/>
                  <a:gd name="connsiteX59" fmla="*/ 31687 w 611109"/>
                  <a:gd name="connsiteY59" fmla="*/ 778598 h 1072836"/>
                  <a:gd name="connsiteX60" fmla="*/ 22633 w 611109"/>
                  <a:gd name="connsiteY60" fmla="*/ 751438 h 1072836"/>
                  <a:gd name="connsiteX61" fmla="*/ 18107 w 611109"/>
                  <a:gd name="connsiteY61" fmla="*/ 737858 h 1072836"/>
                  <a:gd name="connsiteX62" fmla="*/ 9053 w 611109"/>
                  <a:gd name="connsiteY62" fmla="*/ 728804 h 1072836"/>
                  <a:gd name="connsiteX63" fmla="*/ 0 w 611109"/>
                  <a:gd name="connsiteY63" fmla="*/ 660903 h 1072836"/>
                  <a:gd name="connsiteX64" fmla="*/ 4526 w 611109"/>
                  <a:gd name="connsiteY64" fmla="*/ 452674 h 1072836"/>
                  <a:gd name="connsiteX65" fmla="*/ 13580 w 611109"/>
                  <a:gd name="connsiteY65" fmla="*/ 407406 h 1072836"/>
                  <a:gd name="connsiteX66" fmla="*/ 22633 w 611109"/>
                  <a:gd name="connsiteY66" fmla="*/ 362139 h 1072836"/>
                  <a:gd name="connsiteX67" fmla="*/ 27160 w 611109"/>
                  <a:gd name="connsiteY67" fmla="*/ 348559 h 1072836"/>
                  <a:gd name="connsiteX68" fmla="*/ 40740 w 611109"/>
                  <a:gd name="connsiteY68" fmla="*/ 289711 h 1072836"/>
                  <a:gd name="connsiteX69" fmla="*/ 54320 w 611109"/>
                  <a:gd name="connsiteY69" fmla="*/ 248971 h 1072836"/>
                  <a:gd name="connsiteX70" fmla="*/ 63374 w 611109"/>
                  <a:gd name="connsiteY70" fmla="*/ 221810 h 1072836"/>
                  <a:gd name="connsiteX71" fmla="*/ 99588 w 611109"/>
                  <a:gd name="connsiteY71" fmla="*/ 167489 h 1072836"/>
                  <a:gd name="connsiteX72" fmla="*/ 108641 w 611109"/>
                  <a:gd name="connsiteY72" fmla="*/ 153909 h 1072836"/>
                  <a:gd name="connsiteX73" fmla="*/ 113168 w 611109"/>
                  <a:gd name="connsiteY73" fmla="*/ 140329 h 1072836"/>
                  <a:gd name="connsiteX74" fmla="*/ 122221 w 611109"/>
                  <a:gd name="connsiteY74" fmla="*/ 131275 h 1072836"/>
                  <a:gd name="connsiteX75" fmla="*/ 140328 w 611109"/>
                  <a:gd name="connsiteY75" fmla="*/ 108642 h 1072836"/>
                  <a:gd name="connsiteX76" fmla="*/ 149382 w 611109"/>
                  <a:gd name="connsiteY76" fmla="*/ 95062 h 1072836"/>
                  <a:gd name="connsiteX77" fmla="*/ 167489 w 611109"/>
                  <a:gd name="connsiteY77" fmla="*/ 76955 h 1072836"/>
                  <a:gd name="connsiteX78" fmla="*/ 176542 w 611109"/>
                  <a:gd name="connsiteY78" fmla="*/ 67901 h 1072836"/>
                  <a:gd name="connsiteX79" fmla="*/ 190122 w 611109"/>
                  <a:gd name="connsiteY79" fmla="*/ 63374 h 1072836"/>
                  <a:gd name="connsiteX80" fmla="*/ 212756 w 611109"/>
                  <a:gd name="connsiteY80" fmla="*/ 45268 h 1072836"/>
                  <a:gd name="connsiteX81" fmla="*/ 221810 w 611109"/>
                  <a:gd name="connsiteY81" fmla="*/ 36214 h 1072836"/>
                  <a:gd name="connsiteX82" fmla="*/ 235390 w 611109"/>
                  <a:gd name="connsiteY82" fmla="*/ 31687 h 1072836"/>
                  <a:gd name="connsiteX83" fmla="*/ 276130 w 611109"/>
                  <a:gd name="connsiteY83" fmla="*/ 13580 h 1072836"/>
                  <a:gd name="connsiteX84" fmla="*/ 289711 w 611109"/>
                  <a:gd name="connsiteY84" fmla="*/ 9054 h 1072836"/>
                  <a:gd name="connsiteX85" fmla="*/ 303291 w 611109"/>
                  <a:gd name="connsiteY85" fmla="*/ 4527 h 1072836"/>
                  <a:gd name="connsiteX86" fmla="*/ 380245 w 611109"/>
                  <a:gd name="connsiteY86" fmla="*/ 0 h 10728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</a:cxnLst>
                <a:rect l="l" t="t" r="r" b="b"/>
                <a:pathLst>
                  <a:path w="611109" h="1072836">
                    <a:moveTo>
                      <a:pt x="380245" y="0"/>
                    </a:moveTo>
                    <a:cubicBezTo>
                      <a:pt x="390807" y="1509"/>
                      <a:pt x="402219" y="112"/>
                      <a:pt x="411932" y="4527"/>
                    </a:cubicBezTo>
                    <a:cubicBezTo>
                      <a:pt x="419703" y="8059"/>
                      <a:pt x="421941" y="19935"/>
                      <a:pt x="430039" y="22634"/>
                    </a:cubicBezTo>
                    <a:lnTo>
                      <a:pt x="443620" y="27161"/>
                    </a:lnTo>
                    <a:cubicBezTo>
                      <a:pt x="446638" y="31688"/>
                      <a:pt x="448425" y="37342"/>
                      <a:pt x="452673" y="40741"/>
                    </a:cubicBezTo>
                    <a:cubicBezTo>
                      <a:pt x="456399" y="43722"/>
                      <a:pt x="462161" y="42813"/>
                      <a:pt x="466253" y="45268"/>
                    </a:cubicBezTo>
                    <a:cubicBezTo>
                      <a:pt x="469913" y="47464"/>
                      <a:pt x="472289" y="51303"/>
                      <a:pt x="475307" y="54321"/>
                    </a:cubicBezTo>
                    <a:cubicBezTo>
                      <a:pt x="476816" y="58848"/>
                      <a:pt x="477378" y="63809"/>
                      <a:pt x="479833" y="67901"/>
                    </a:cubicBezTo>
                    <a:cubicBezTo>
                      <a:pt x="482029" y="71561"/>
                      <a:pt x="486221" y="73622"/>
                      <a:pt x="488887" y="76955"/>
                    </a:cubicBezTo>
                    <a:cubicBezTo>
                      <a:pt x="511724" y="105501"/>
                      <a:pt x="485137" y="77733"/>
                      <a:pt x="506994" y="99588"/>
                    </a:cubicBezTo>
                    <a:lnTo>
                      <a:pt x="520574" y="140329"/>
                    </a:lnTo>
                    <a:lnTo>
                      <a:pt x="525101" y="153909"/>
                    </a:lnTo>
                    <a:cubicBezTo>
                      <a:pt x="526610" y="158436"/>
                      <a:pt x="526253" y="164115"/>
                      <a:pt x="529627" y="167489"/>
                    </a:cubicBezTo>
                    <a:lnTo>
                      <a:pt x="538681" y="176543"/>
                    </a:lnTo>
                    <a:cubicBezTo>
                      <a:pt x="541699" y="185596"/>
                      <a:pt x="545419" y="194445"/>
                      <a:pt x="547734" y="203703"/>
                    </a:cubicBezTo>
                    <a:cubicBezTo>
                      <a:pt x="549243" y="209739"/>
                      <a:pt x="550473" y="215851"/>
                      <a:pt x="552261" y="221810"/>
                    </a:cubicBezTo>
                    <a:cubicBezTo>
                      <a:pt x="555003" y="230951"/>
                      <a:pt x="556021" y="241030"/>
                      <a:pt x="561315" y="248971"/>
                    </a:cubicBezTo>
                    <a:cubicBezTo>
                      <a:pt x="567350" y="258024"/>
                      <a:pt x="575980" y="265809"/>
                      <a:pt x="579421" y="276131"/>
                    </a:cubicBezTo>
                    <a:lnTo>
                      <a:pt x="588475" y="303291"/>
                    </a:lnTo>
                    <a:cubicBezTo>
                      <a:pt x="586966" y="322907"/>
                      <a:pt x="586388" y="342617"/>
                      <a:pt x="583948" y="362139"/>
                    </a:cubicBezTo>
                    <a:cubicBezTo>
                      <a:pt x="581910" y="378442"/>
                      <a:pt x="579361" y="373531"/>
                      <a:pt x="570368" y="384773"/>
                    </a:cubicBezTo>
                    <a:cubicBezTo>
                      <a:pt x="564673" y="391893"/>
                      <a:pt x="560671" y="402360"/>
                      <a:pt x="552261" y="407406"/>
                    </a:cubicBezTo>
                    <a:cubicBezTo>
                      <a:pt x="548169" y="409861"/>
                      <a:pt x="543208" y="410424"/>
                      <a:pt x="538681" y="411933"/>
                    </a:cubicBezTo>
                    <a:cubicBezTo>
                      <a:pt x="535663" y="414951"/>
                      <a:pt x="531823" y="417326"/>
                      <a:pt x="529627" y="420986"/>
                    </a:cubicBezTo>
                    <a:cubicBezTo>
                      <a:pt x="522607" y="432687"/>
                      <a:pt x="524265" y="444688"/>
                      <a:pt x="529627" y="457200"/>
                    </a:cubicBezTo>
                    <a:cubicBezTo>
                      <a:pt x="531308" y="461123"/>
                      <a:pt x="536015" y="462921"/>
                      <a:pt x="538681" y="466254"/>
                    </a:cubicBezTo>
                    <a:cubicBezTo>
                      <a:pt x="542080" y="470502"/>
                      <a:pt x="543486" y="476435"/>
                      <a:pt x="547734" y="479834"/>
                    </a:cubicBezTo>
                    <a:cubicBezTo>
                      <a:pt x="551460" y="482815"/>
                      <a:pt x="557047" y="482227"/>
                      <a:pt x="561315" y="484361"/>
                    </a:cubicBezTo>
                    <a:cubicBezTo>
                      <a:pt x="571554" y="489480"/>
                      <a:pt x="587433" y="503167"/>
                      <a:pt x="593002" y="511521"/>
                    </a:cubicBezTo>
                    <a:cubicBezTo>
                      <a:pt x="596020" y="516048"/>
                      <a:pt x="599845" y="520130"/>
                      <a:pt x="602055" y="525101"/>
                    </a:cubicBezTo>
                    <a:cubicBezTo>
                      <a:pt x="605931" y="533822"/>
                      <a:pt x="611109" y="552262"/>
                      <a:pt x="611109" y="552262"/>
                    </a:cubicBezTo>
                    <a:cubicBezTo>
                      <a:pt x="608817" y="588936"/>
                      <a:pt x="608077" y="624773"/>
                      <a:pt x="602055" y="660903"/>
                    </a:cubicBezTo>
                    <a:cubicBezTo>
                      <a:pt x="601032" y="667040"/>
                      <a:pt x="599037" y="672974"/>
                      <a:pt x="597528" y="679010"/>
                    </a:cubicBezTo>
                    <a:cubicBezTo>
                      <a:pt x="596019" y="737858"/>
                      <a:pt x="595802" y="796753"/>
                      <a:pt x="593002" y="855553"/>
                    </a:cubicBezTo>
                    <a:cubicBezTo>
                      <a:pt x="592583" y="864351"/>
                      <a:pt x="586968" y="873658"/>
                      <a:pt x="579421" y="878186"/>
                    </a:cubicBezTo>
                    <a:cubicBezTo>
                      <a:pt x="575329" y="880641"/>
                      <a:pt x="570368" y="881204"/>
                      <a:pt x="565841" y="882713"/>
                    </a:cubicBezTo>
                    <a:cubicBezTo>
                      <a:pt x="559805" y="888749"/>
                      <a:pt x="550433" y="892722"/>
                      <a:pt x="547734" y="900820"/>
                    </a:cubicBezTo>
                    <a:lnTo>
                      <a:pt x="534154" y="941561"/>
                    </a:lnTo>
                    <a:cubicBezTo>
                      <a:pt x="532645" y="946088"/>
                      <a:pt x="532274" y="951171"/>
                      <a:pt x="529627" y="955141"/>
                    </a:cubicBezTo>
                    <a:cubicBezTo>
                      <a:pt x="526609" y="959668"/>
                      <a:pt x="522784" y="963750"/>
                      <a:pt x="520574" y="968721"/>
                    </a:cubicBezTo>
                    <a:cubicBezTo>
                      <a:pt x="503929" y="1006172"/>
                      <a:pt x="521059" y="986341"/>
                      <a:pt x="502467" y="1004935"/>
                    </a:cubicBezTo>
                    <a:cubicBezTo>
                      <a:pt x="500958" y="1009462"/>
                      <a:pt x="500713" y="1014632"/>
                      <a:pt x="497940" y="1018515"/>
                    </a:cubicBezTo>
                    <a:cubicBezTo>
                      <a:pt x="484514" y="1037311"/>
                      <a:pt x="483428" y="1035424"/>
                      <a:pt x="466253" y="1041149"/>
                    </a:cubicBezTo>
                    <a:cubicBezTo>
                      <a:pt x="463235" y="1045676"/>
                      <a:pt x="461813" y="1051846"/>
                      <a:pt x="457200" y="1054729"/>
                    </a:cubicBezTo>
                    <a:cubicBezTo>
                      <a:pt x="439531" y="1065772"/>
                      <a:pt x="401593" y="1067289"/>
                      <a:pt x="384772" y="1068309"/>
                    </a:cubicBezTo>
                    <a:cubicBezTo>
                      <a:pt x="350098" y="1070411"/>
                      <a:pt x="315362" y="1071327"/>
                      <a:pt x="280657" y="1072836"/>
                    </a:cubicBezTo>
                    <a:cubicBezTo>
                      <a:pt x="252764" y="1070844"/>
                      <a:pt x="222372" y="1071343"/>
                      <a:pt x="194649" y="1063782"/>
                    </a:cubicBezTo>
                    <a:cubicBezTo>
                      <a:pt x="185442" y="1061271"/>
                      <a:pt x="167489" y="1054729"/>
                      <a:pt x="167489" y="1054729"/>
                    </a:cubicBezTo>
                    <a:cubicBezTo>
                      <a:pt x="164471" y="1051711"/>
                      <a:pt x="162253" y="1047584"/>
                      <a:pt x="158435" y="1045675"/>
                    </a:cubicBezTo>
                    <a:cubicBezTo>
                      <a:pt x="149899" y="1041407"/>
                      <a:pt x="131275" y="1036622"/>
                      <a:pt x="131275" y="1036622"/>
                    </a:cubicBezTo>
                    <a:cubicBezTo>
                      <a:pt x="128257" y="1033604"/>
                      <a:pt x="124130" y="1031386"/>
                      <a:pt x="122221" y="1027569"/>
                    </a:cubicBezTo>
                    <a:cubicBezTo>
                      <a:pt x="117953" y="1019033"/>
                      <a:pt x="118462" y="1008349"/>
                      <a:pt x="113168" y="1000408"/>
                    </a:cubicBezTo>
                    <a:lnTo>
                      <a:pt x="104115" y="986828"/>
                    </a:lnTo>
                    <a:cubicBezTo>
                      <a:pt x="103269" y="983444"/>
                      <a:pt x="97845" y="959781"/>
                      <a:pt x="95061" y="955141"/>
                    </a:cubicBezTo>
                    <a:cubicBezTo>
                      <a:pt x="92865" y="951481"/>
                      <a:pt x="89026" y="949105"/>
                      <a:pt x="86008" y="946087"/>
                    </a:cubicBezTo>
                    <a:lnTo>
                      <a:pt x="72427" y="905347"/>
                    </a:lnTo>
                    <a:cubicBezTo>
                      <a:pt x="72426" y="905345"/>
                      <a:pt x="63375" y="878187"/>
                      <a:pt x="63374" y="878186"/>
                    </a:cubicBezTo>
                    <a:lnTo>
                      <a:pt x="54320" y="869133"/>
                    </a:lnTo>
                    <a:cubicBezTo>
                      <a:pt x="52840" y="860249"/>
                      <a:pt x="47981" y="829290"/>
                      <a:pt x="45267" y="819339"/>
                    </a:cubicBezTo>
                    <a:cubicBezTo>
                      <a:pt x="45260" y="819313"/>
                      <a:pt x="33955" y="785401"/>
                      <a:pt x="31687" y="778598"/>
                    </a:cubicBezTo>
                    <a:lnTo>
                      <a:pt x="22633" y="751438"/>
                    </a:lnTo>
                    <a:cubicBezTo>
                      <a:pt x="21124" y="746911"/>
                      <a:pt x="21481" y="741232"/>
                      <a:pt x="18107" y="737858"/>
                    </a:cubicBezTo>
                    <a:lnTo>
                      <a:pt x="9053" y="728804"/>
                    </a:lnTo>
                    <a:cubicBezTo>
                      <a:pt x="72" y="701864"/>
                      <a:pt x="0" y="705214"/>
                      <a:pt x="0" y="660903"/>
                    </a:cubicBezTo>
                    <a:cubicBezTo>
                      <a:pt x="0" y="591477"/>
                      <a:pt x="1908" y="522051"/>
                      <a:pt x="4526" y="452674"/>
                    </a:cubicBezTo>
                    <a:cubicBezTo>
                      <a:pt x="6215" y="407924"/>
                      <a:pt x="7250" y="434837"/>
                      <a:pt x="13580" y="407406"/>
                    </a:cubicBezTo>
                    <a:cubicBezTo>
                      <a:pt x="17040" y="392412"/>
                      <a:pt x="17767" y="376737"/>
                      <a:pt x="22633" y="362139"/>
                    </a:cubicBezTo>
                    <a:cubicBezTo>
                      <a:pt x="24142" y="357612"/>
                      <a:pt x="26003" y="353188"/>
                      <a:pt x="27160" y="348559"/>
                    </a:cubicBezTo>
                    <a:cubicBezTo>
                      <a:pt x="34340" y="319841"/>
                      <a:pt x="29477" y="323497"/>
                      <a:pt x="40740" y="289711"/>
                    </a:cubicBezTo>
                    <a:lnTo>
                      <a:pt x="54320" y="248971"/>
                    </a:lnTo>
                    <a:cubicBezTo>
                      <a:pt x="54320" y="248970"/>
                      <a:pt x="63373" y="221811"/>
                      <a:pt x="63374" y="221810"/>
                    </a:cubicBezTo>
                    <a:lnTo>
                      <a:pt x="99588" y="167489"/>
                    </a:lnTo>
                    <a:cubicBezTo>
                      <a:pt x="102606" y="162962"/>
                      <a:pt x="106921" y="159070"/>
                      <a:pt x="108641" y="153909"/>
                    </a:cubicBezTo>
                    <a:cubicBezTo>
                      <a:pt x="110150" y="149382"/>
                      <a:pt x="110713" y="144421"/>
                      <a:pt x="113168" y="140329"/>
                    </a:cubicBezTo>
                    <a:cubicBezTo>
                      <a:pt x="115364" y="136669"/>
                      <a:pt x="119203" y="134293"/>
                      <a:pt x="122221" y="131275"/>
                    </a:cubicBezTo>
                    <a:cubicBezTo>
                      <a:pt x="131034" y="104838"/>
                      <a:pt x="119853" y="129116"/>
                      <a:pt x="140328" y="108642"/>
                    </a:cubicBezTo>
                    <a:cubicBezTo>
                      <a:pt x="144175" y="104795"/>
                      <a:pt x="145841" y="99193"/>
                      <a:pt x="149382" y="95062"/>
                    </a:cubicBezTo>
                    <a:cubicBezTo>
                      <a:pt x="154937" y="88581"/>
                      <a:pt x="161453" y="82991"/>
                      <a:pt x="167489" y="76955"/>
                    </a:cubicBezTo>
                    <a:cubicBezTo>
                      <a:pt x="170507" y="73937"/>
                      <a:pt x="172493" y="69251"/>
                      <a:pt x="176542" y="67901"/>
                    </a:cubicBezTo>
                    <a:lnTo>
                      <a:pt x="190122" y="63374"/>
                    </a:lnTo>
                    <a:cubicBezTo>
                      <a:pt x="211988" y="41510"/>
                      <a:pt x="184197" y="68115"/>
                      <a:pt x="212756" y="45268"/>
                    </a:cubicBezTo>
                    <a:cubicBezTo>
                      <a:pt x="216089" y="42602"/>
                      <a:pt x="218150" y="38410"/>
                      <a:pt x="221810" y="36214"/>
                    </a:cubicBezTo>
                    <a:cubicBezTo>
                      <a:pt x="225902" y="33759"/>
                      <a:pt x="231122" y="33821"/>
                      <a:pt x="235390" y="31687"/>
                    </a:cubicBezTo>
                    <a:cubicBezTo>
                      <a:pt x="278423" y="10170"/>
                      <a:pt x="206073" y="36932"/>
                      <a:pt x="276130" y="13580"/>
                    </a:cubicBezTo>
                    <a:lnTo>
                      <a:pt x="289711" y="9054"/>
                    </a:lnTo>
                    <a:cubicBezTo>
                      <a:pt x="294238" y="7545"/>
                      <a:pt x="298519" y="4527"/>
                      <a:pt x="303291" y="4527"/>
                    </a:cubicBezTo>
                    <a:lnTo>
                      <a:pt x="380245" y="0"/>
                    </a:lnTo>
                    <a:close/>
                  </a:path>
                </a:pathLst>
              </a:cu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1626653" y="4316800"/>
              <a:ext cx="1900663" cy="322325"/>
              <a:chOff x="2950078" y="4915417"/>
              <a:chExt cx="2383232" cy="405481"/>
            </a:xfrm>
          </p:grpSpPr>
          <p:sp>
            <p:nvSpPr>
              <p:cNvPr id="36" name="Freeform 35"/>
              <p:cNvSpPr/>
              <p:nvPr/>
            </p:nvSpPr>
            <p:spPr>
              <a:xfrm>
                <a:off x="2950078" y="5014719"/>
                <a:ext cx="442718" cy="219290"/>
              </a:xfrm>
              <a:custGeom>
                <a:avLst/>
                <a:gdLst>
                  <a:gd name="connsiteX0" fmla="*/ 0 w 442718"/>
                  <a:gd name="connsiteY0" fmla="*/ 219290 h 219290"/>
                  <a:gd name="connsiteX1" fmla="*/ 20688 w 442718"/>
                  <a:gd name="connsiteY1" fmla="*/ 211015 h 219290"/>
                  <a:gd name="connsiteX2" fmla="*/ 57926 w 442718"/>
                  <a:gd name="connsiteY2" fmla="*/ 198602 h 219290"/>
                  <a:gd name="connsiteX3" fmla="*/ 70338 w 442718"/>
                  <a:gd name="connsiteY3" fmla="*/ 194465 h 219290"/>
                  <a:gd name="connsiteX4" fmla="*/ 82751 w 442718"/>
                  <a:gd name="connsiteY4" fmla="*/ 190327 h 219290"/>
                  <a:gd name="connsiteX5" fmla="*/ 124127 w 442718"/>
                  <a:gd name="connsiteY5" fmla="*/ 177914 h 219290"/>
                  <a:gd name="connsiteX6" fmla="*/ 148952 w 442718"/>
                  <a:gd name="connsiteY6" fmla="*/ 169639 h 219290"/>
                  <a:gd name="connsiteX7" fmla="*/ 173777 w 442718"/>
                  <a:gd name="connsiteY7" fmla="*/ 157227 h 219290"/>
                  <a:gd name="connsiteX8" fmla="*/ 182052 w 442718"/>
                  <a:gd name="connsiteY8" fmla="*/ 144814 h 219290"/>
                  <a:gd name="connsiteX9" fmla="*/ 206878 w 442718"/>
                  <a:gd name="connsiteY9" fmla="*/ 124126 h 219290"/>
                  <a:gd name="connsiteX10" fmla="*/ 211015 w 442718"/>
                  <a:gd name="connsiteY10" fmla="*/ 107576 h 219290"/>
                  <a:gd name="connsiteX11" fmla="*/ 215153 w 442718"/>
                  <a:gd name="connsiteY11" fmla="*/ 95163 h 219290"/>
                  <a:gd name="connsiteX12" fmla="*/ 252391 w 442718"/>
                  <a:gd name="connsiteY12" fmla="*/ 82751 h 219290"/>
                  <a:gd name="connsiteX13" fmla="*/ 277216 w 442718"/>
                  <a:gd name="connsiteY13" fmla="*/ 74476 h 219290"/>
                  <a:gd name="connsiteX14" fmla="*/ 289629 w 442718"/>
                  <a:gd name="connsiteY14" fmla="*/ 70338 h 219290"/>
                  <a:gd name="connsiteX15" fmla="*/ 314454 w 442718"/>
                  <a:gd name="connsiteY15" fmla="*/ 57925 h 219290"/>
                  <a:gd name="connsiteX16" fmla="*/ 339279 w 442718"/>
                  <a:gd name="connsiteY16" fmla="*/ 41375 h 219290"/>
                  <a:gd name="connsiteX17" fmla="*/ 347555 w 442718"/>
                  <a:gd name="connsiteY17" fmla="*/ 33100 h 219290"/>
                  <a:gd name="connsiteX18" fmla="*/ 359967 w 442718"/>
                  <a:gd name="connsiteY18" fmla="*/ 28962 h 219290"/>
                  <a:gd name="connsiteX19" fmla="*/ 372380 w 442718"/>
                  <a:gd name="connsiteY19" fmla="*/ 20687 h 219290"/>
                  <a:gd name="connsiteX20" fmla="*/ 397205 w 442718"/>
                  <a:gd name="connsiteY20" fmla="*/ 12412 h 219290"/>
                  <a:gd name="connsiteX21" fmla="*/ 422031 w 442718"/>
                  <a:gd name="connsiteY21" fmla="*/ 4137 h 219290"/>
                  <a:gd name="connsiteX22" fmla="*/ 434443 w 442718"/>
                  <a:gd name="connsiteY22" fmla="*/ 0 h 219290"/>
                  <a:gd name="connsiteX23" fmla="*/ 442718 w 442718"/>
                  <a:gd name="connsiteY23" fmla="*/ 0 h 2192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442718" h="219290">
                    <a:moveTo>
                      <a:pt x="0" y="219290"/>
                    </a:moveTo>
                    <a:cubicBezTo>
                      <a:pt x="6896" y="216532"/>
                      <a:pt x="13708" y="213553"/>
                      <a:pt x="20688" y="211015"/>
                    </a:cubicBezTo>
                    <a:cubicBezTo>
                      <a:pt x="32984" y="206544"/>
                      <a:pt x="45513" y="202740"/>
                      <a:pt x="57926" y="198602"/>
                    </a:cubicBezTo>
                    <a:lnTo>
                      <a:pt x="70338" y="194465"/>
                    </a:lnTo>
                    <a:cubicBezTo>
                      <a:pt x="74476" y="193086"/>
                      <a:pt x="78520" y="191385"/>
                      <a:pt x="82751" y="190327"/>
                    </a:cubicBezTo>
                    <a:cubicBezTo>
                      <a:pt x="107768" y="184074"/>
                      <a:pt x="93900" y="187990"/>
                      <a:pt x="124127" y="177914"/>
                    </a:cubicBezTo>
                    <a:cubicBezTo>
                      <a:pt x="124131" y="177913"/>
                      <a:pt x="148949" y="169641"/>
                      <a:pt x="148952" y="169639"/>
                    </a:cubicBezTo>
                    <a:cubicBezTo>
                      <a:pt x="164994" y="158945"/>
                      <a:pt x="156647" y="162936"/>
                      <a:pt x="173777" y="157227"/>
                    </a:cubicBezTo>
                    <a:cubicBezTo>
                      <a:pt x="176535" y="153089"/>
                      <a:pt x="178869" y="148634"/>
                      <a:pt x="182052" y="144814"/>
                    </a:cubicBezTo>
                    <a:cubicBezTo>
                      <a:pt x="192008" y="132867"/>
                      <a:pt x="194673" y="132263"/>
                      <a:pt x="206878" y="124126"/>
                    </a:cubicBezTo>
                    <a:cubicBezTo>
                      <a:pt x="208257" y="118609"/>
                      <a:pt x="209453" y="113044"/>
                      <a:pt x="211015" y="107576"/>
                    </a:cubicBezTo>
                    <a:cubicBezTo>
                      <a:pt x="212213" y="103382"/>
                      <a:pt x="211604" y="97698"/>
                      <a:pt x="215153" y="95163"/>
                    </a:cubicBezTo>
                    <a:cubicBezTo>
                      <a:pt x="215159" y="95159"/>
                      <a:pt x="246182" y="84821"/>
                      <a:pt x="252391" y="82751"/>
                    </a:cubicBezTo>
                    <a:lnTo>
                      <a:pt x="277216" y="74476"/>
                    </a:lnTo>
                    <a:cubicBezTo>
                      <a:pt x="281354" y="73097"/>
                      <a:pt x="286000" y="72757"/>
                      <a:pt x="289629" y="70338"/>
                    </a:cubicBezTo>
                    <a:cubicBezTo>
                      <a:pt x="305670" y="59644"/>
                      <a:pt x="297324" y="63636"/>
                      <a:pt x="314454" y="57925"/>
                    </a:cubicBezTo>
                    <a:cubicBezTo>
                      <a:pt x="346019" y="26363"/>
                      <a:pt x="309340" y="59339"/>
                      <a:pt x="339279" y="41375"/>
                    </a:cubicBezTo>
                    <a:cubicBezTo>
                      <a:pt x="342624" y="39368"/>
                      <a:pt x="344210" y="35107"/>
                      <a:pt x="347555" y="33100"/>
                    </a:cubicBezTo>
                    <a:cubicBezTo>
                      <a:pt x="351295" y="30856"/>
                      <a:pt x="356066" y="30912"/>
                      <a:pt x="359967" y="28962"/>
                    </a:cubicBezTo>
                    <a:cubicBezTo>
                      <a:pt x="364415" y="26738"/>
                      <a:pt x="367836" y="22707"/>
                      <a:pt x="372380" y="20687"/>
                    </a:cubicBezTo>
                    <a:cubicBezTo>
                      <a:pt x="380351" y="17144"/>
                      <a:pt x="388930" y="15170"/>
                      <a:pt x="397205" y="12412"/>
                    </a:cubicBezTo>
                    <a:lnTo>
                      <a:pt x="422031" y="4137"/>
                    </a:lnTo>
                    <a:cubicBezTo>
                      <a:pt x="426168" y="2758"/>
                      <a:pt x="430082" y="0"/>
                      <a:pt x="434443" y="0"/>
                    </a:cubicBezTo>
                    <a:lnTo>
                      <a:pt x="442718" y="0"/>
                    </a:lnTo>
                  </a:path>
                </a:pathLst>
              </a:cu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Freeform 36"/>
              <p:cNvSpPr/>
              <p:nvPr/>
            </p:nvSpPr>
            <p:spPr>
              <a:xfrm>
                <a:off x="3384521" y="4915417"/>
                <a:ext cx="211016" cy="99302"/>
              </a:xfrm>
              <a:custGeom>
                <a:avLst/>
                <a:gdLst>
                  <a:gd name="connsiteX0" fmla="*/ 0 w 211016"/>
                  <a:gd name="connsiteY0" fmla="*/ 99302 h 99302"/>
                  <a:gd name="connsiteX1" fmla="*/ 20688 w 211016"/>
                  <a:gd name="connsiteY1" fmla="*/ 95164 h 99302"/>
                  <a:gd name="connsiteX2" fmla="*/ 28963 w 211016"/>
                  <a:gd name="connsiteY2" fmla="*/ 82751 h 99302"/>
                  <a:gd name="connsiteX3" fmla="*/ 53789 w 211016"/>
                  <a:gd name="connsiteY3" fmla="*/ 74476 h 99302"/>
                  <a:gd name="connsiteX4" fmla="*/ 66201 w 211016"/>
                  <a:gd name="connsiteY4" fmla="*/ 70339 h 99302"/>
                  <a:gd name="connsiteX5" fmla="*/ 78614 w 211016"/>
                  <a:gd name="connsiteY5" fmla="*/ 62064 h 99302"/>
                  <a:gd name="connsiteX6" fmla="*/ 86889 w 211016"/>
                  <a:gd name="connsiteY6" fmla="*/ 53788 h 99302"/>
                  <a:gd name="connsiteX7" fmla="*/ 99302 w 211016"/>
                  <a:gd name="connsiteY7" fmla="*/ 49651 h 99302"/>
                  <a:gd name="connsiteX8" fmla="*/ 124127 w 211016"/>
                  <a:gd name="connsiteY8" fmla="*/ 37238 h 99302"/>
                  <a:gd name="connsiteX9" fmla="*/ 148952 w 211016"/>
                  <a:gd name="connsiteY9" fmla="*/ 24826 h 99302"/>
                  <a:gd name="connsiteX10" fmla="*/ 186190 w 211016"/>
                  <a:gd name="connsiteY10" fmla="*/ 8275 h 99302"/>
                  <a:gd name="connsiteX11" fmla="*/ 198603 w 211016"/>
                  <a:gd name="connsiteY11" fmla="*/ 4138 h 99302"/>
                  <a:gd name="connsiteX12" fmla="*/ 211016 w 211016"/>
                  <a:gd name="connsiteY12" fmla="*/ 0 h 9930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211016" h="99302">
                    <a:moveTo>
                      <a:pt x="0" y="99302"/>
                    </a:moveTo>
                    <a:cubicBezTo>
                      <a:pt x="6896" y="97923"/>
                      <a:pt x="14582" y="98653"/>
                      <a:pt x="20688" y="95164"/>
                    </a:cubicBezTo>
                    <a:cubicBezTo>
                      <a:pt x="25006" y="92697"/>
                      <a:pt x="24746" y="85387"/>
                      <a:pt x="28963" y="82751"/>
                    </a:cubicBezTo>
                    <a:cubicBezTo>
                      <a:pt x="36360" y="78128"/>
                      <a:pt x="45514" y="77234"/>
                      <a:pt x="53789" y="74476"/>
                    </a:cubicBezTo>
                    <a:lnTo>
                      <a:pt x="66201" y="70339"/>
                    </a:lnTo>
                    <a:cubicBezTo>
                      <a:pt x="70339" y="67581"/>
                      <a:pt x="74731" y="65171"/>
                      <a:pt x="78614" y="62064"/>
                    </a:cubicBezTo>
                    <a:cubicBezTo>
                      <a:pt x="81660" y="59627"/>
                      <a:pt x="83544" y="55795"/>
                      <a:pt x="86889" y="53788"/>
                    </a:cubicBezTo>
                    <a:cubicBezTo>
                      <a:pt x="90629" y="51544"/>
                      <a:pt x="95164" y="51030"/>
                      <a:pt x="99302" y="49651"/>
                    </a:cubicBezTo>
                    <a:cubicBezTo>
                      <a:pt x="134867" y="25940"/>
                      <a:pt x="89872" y="54366"/>
                      <a:pt x="124127" y="37238"/>
                    </a:cubicBezTo>
                    <a:cubicBezTo>
                      <a:pt x="156205" y="21199"/>
                      <a:pt x="117758" y="35223"/>
                      <a:pt x="148952" y="24826"/>
                    </a:cubicBezTo>
                    <a:cubicBezTo>
                      <a:pt x="168622" y="11712"/>
                      <a:pt x="156649" y="18122"/>
                      <a:pt x="186190" y="8275"/>
                    </a:cubicBezTo>
                    <a:lnTo>
                      <a:pt x="198603" y="4138"/>
                    </a:lnTo>
                    <a:lnTo>
                      <a:pt x="211016" y="0"/>
                    </a:lnTo>
                  </a:path>
                </a:pathLst>
              </a:custGeom>
              <a:noFill/>
              <a:ln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Freeform 37"/>
              <p:cNvSpPr/>
              <p:nvPr/>
            </p:nvSpPr>
            <p:spPr>
              <a:xfrm>
                <a:off x="4985756" y="5118157"/>
                <a:ext cx="347554" cy="202741"/>
              </a:xfrm>
              <a:custGeom>
                <a:avLst/>
                <a:gdLst>
                  <a:gd name="connsiteX0" fmla="*/ 0 w 347554"/>
                  <a:gd name="connsiteY0" fmla="*/ 0 h 202741"/>
                  <a:gd name="connsiteX1" fmla="*/ 41375 w 347554"/>
                  <a:gd name="connsiteY1" fmla="*/ 4138 h 202741"/>
                  <a:gd name="connsiteX2" fmla="*/ 53788 w 347554"/>
                  <a:gd name="connsiteY2" fmla="*/ 8276 h 202741"/>
                  <a:gd name="connsiteX3" fmla="*/ 62063 w 347554"/>
                  <a:gd name="connsiteY3" fmla="*/ 20688 h 202741"/>
                  <a:gd name="connsiteX4" fmla="*/ 74476 w 347554"/>
                  <a:gd name="connsiteY4" fmla="*/ 33101 h 202741"/>
                  <a:gd name="connsiteX5" fmla="*/ 82751 w 347554"/>
                  <a:gd name="connsiteY5" fmla="*/ 45514 h 202741"/>
                  <a:gd name="connsiteX6" fmla="*/ 95163 w 347554"/>
                  <a:gd name="connsiteY6" fmla="*/ 53789 h 202741"/>
                  <a:gd name="connsiteX7" fmla="*/ 103439 w 347554"/>
                  <a:gd name="connsiteY7" fmla="*/ 62064 h 202741"/>
                  <a:gd name="connsiteX8" fmla="*/ 107576 w 347554"/>
                  <a:gd name="connsiteY8" fmla="*/ 74476 h 202741"/>
                  <a:gd name="connsiteX9" fmla="*/ 132401 w 347554"/>
                  <a:gd name="connsiteY9" fmla="*/ 82752 h 202741"/>
                  <a:gd name="connsiteX10" fmla="*/ 165502 w 347554"/>
                  <a:gd name="connsiteY10" fmla="*/ 99302 h 202741"/>
                  <a:gd name="connsiteX11" fmla="*/ 165502 w 347554"/>
                  <a:gd name="connsiteY11" fmla="*/ 99302 h 202741"/>
                  <a:gd name="connsiteX12" fmla="*/ 190327 w 347554"/>
                  <a:gd name="connsiteY12" fmla="*/ 111714 h 202741"/>
                  <a:gd name="connsiteX13" fmla="*/ 211015 w 347554"/>
                  <a:gd name="connsiteY13" fmla="*/ 124127 h 202741"/>
                  <a:gd name="connsiteX14" fmla="*/ 223428 w 347554"/>
                  <a:gd name="connsiteY14" fmla="*/ 132402 h 202741"/>
                  <a:gd name="connsiteX15" fmla="*/ 235840 w 347554"/>
                  <a:gd name="connsiteY15" fmla="*/ 136540 h 202741"/>
                  <a:gd name="connsiteX16" fmla="*/ 260666 w 347554"/>
                  <a:gd name="connsiteY16" fmla="*/ 153090 h 202741"/>
                  <a:gd name="connsiteX17" fmla="*/ 273078 w 347554"/>
                  <a:gd name="connsiteY17" fmla="*/ 161365 h 202741"/>
                  <a:gd name="connsiteX18" fmla="*/ 297904 w 347554"/>
                  <a:gd name="connsiteY18" fmla="*/ 169640 h 202741"/>
                  <a:gd name="connsiteX19" fmla="*/ 310316 w 347554"/>
                  <a:gd name="connsiteY19" fmla="*/ 177915 h 202741"/>
                  <a:gd name="connsiteX20" fmla="*/ 318592 w 347554"/>
                  <a:gd name="connsiteY20" fmla="*/ 186191 h 202741"/>
                  <a:gd name="connsiteX21" fmla="*/ 331004 w 347554"/>
                  <a:gd name="connsiteY21" fmla="*/ 190328 h 202741"/>
                  <a:gd name="connsiteX22" fmla="*/ 347554 w 347554"/>
                  <a:gd name="connsiteY22" fmla="*/ 202741 h 2027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347554" h="202741">
                    <a:moveTo>
                      <a:pt x="0" y="0"/>
                    </a:moveTo>
                    <a:cubicBezTo>
                      <a:pt x="13792" y="1379"/>
                      <a:pt x="27676" y="2030"/>
                      <a:pt x="41375" y="4138"/>
                    </a:cubicBezTo>
                    <a:cubicBezTo>
                      <a:pt x="45686" y="4801"/>
                      <a:pt x="50382" y="5551"/>
                      <a:pt x="53788" y="8276"/>
                    </a:cubicBezTo>
                    <a:cubicBezTo>
                      <a:pt x="57671" y="11382"/>
                      <a:pt x="58880" y="16868"/>
                      <a:pt x="62063" y="20688"/>
                    </a:cubicBezTo>
                    <a:cubicBezTo>
                      <a:pt x="65809" y="25183"/>
                      <a:pt x="70730" y="28606"/>
                      <a:pt x="74476" y="33101"/>
                    </a:cubicBezTo>
                    <a:cubicBezTo>
                      <a:pt x="77659" y="36921"/>
                      <a:pt x="79235" y="41998"/>
                      <a:pt x="82751" y="45514"/>
                    </a:cubicBezTo>
                    <a:cubicBezTo>
                      <a:pt x="86267" y="49030"/>
                      <a:pt x="91280" y="50683"/>
                      <a:pt x="95163" y="53789"/>
                    </a:cubicBezTo>
                    <a:cubicBezTo>
                      <a:pt x="98209" y="56226"/>
                      <a:pt x="100680" y="59306"/>
                      <a:pt x="103439" y="62064"/>
                    </a:cubicBezTo>
                    <a:cubicBezTo>
                      <a:pt x="104818" y="66201"/>
                      <a:pt x="104027" y="71941"/>
                      <a:pt x="107576" y="74476"/>
                    </a:cubicBezTo>
                    <a:cubicBezTo>
                      <a:pt x="114674" y="79546"/>
                      <a:pt x="132401" y="82752"/>
                      <a:pt x="132401" y="82752"/>
                    </a:cubicBezTo>
                    <a:cubicBezTo>
                      <a:pt x="146845" y="97194"/>
                      <a:pt x="136976" y="89793"/>
                      <a:pt x="165502" y="99302"/>
                    </a:cubicBezTo>
                    <a:lnTo>
                      <a:pt x="165502" y="99302"/>
                    </a:lnTo>
                    <a:cubicBezTo>
                      <a:pt x="181544" y="109996"/>
                      <a:pt x="173197" y="106005"/>
                      <a:pt x="190327" y="111714"/>
                    </a:cubicBezTo>
                    <a:cubicBezTo>
                      <a:pt x="206489" y="127878"/>
                      <a:pt x="189531" y="113386"/>
                      <a:pt x="211015" y="124127"/>
                    </a:cubicBezTo>
                    <a:cubicBezTo>
                      <a:pt x="215463" y="126351"/>
                      <a:pt x="218980" y="130178"/>
                      <a:pt x="223428" y="132402"/>
                    </a:cubicBezTo>
                    <a:cubicBezTo>
                      <a:pt x="227329" y="134352"/>
                      <a:pt x="232028" y="134422"/>
                      <a:pt x="235840" y="136540"/>
                    </a:cubicBezTo>
                    <a:cubicBezTo>
                      <a:pt x="244534" y="141370"/>
                      <a:pt x="252391" y="147573"/>
                      <a:pt x="260666" y="153090"/>
                    </a:cubicBezTo>
                    <a:cubicBezTo>
                      <a:pt x="264803" y="155848"/>
                      <a:pt x="268361" y="159793"/>
                      <a:pt x="273078" y="161365"/>
                    </a:cubicBezTo>
                    <a:lnTo>
                      <a:pt x="297904" y="169640"/>
                    </a:lnTo>
                    <a:cubicBezTo>
                      <a:pt x="302041" y="172398"/>
                      <a:pt x="306433" y="174809"/>
                      <a:pt x="310316" y="177915"/>
                    </a:cubicBezTo>
                    <a:cubicBezTo>
                      <a:pt x="313362" y="180352"/>
                      <a:pt x="315247" y="184184"/>
                      <a:pt x="318592" y="186191"/>
                    </a:cubicBezTo>
                    <a:cubicBezTo>
                      <a:pt x="322332" y="188435"/>
                      <a:pt x="326867" y="188949"/>
                      <a:pt x="331004" y="190328"/>
                    </a:cubicBezTo>
                    <a:cubicBezTo>
                      <a:pt x="345040" y="199685"/>
                      <a:pt x="339901" y="195086"/>
                      <a:pt x="347554" y="202741"/>
                    </a:cubicBezTo>
                  </a:path>
                </a:pathLst>
              </a:cu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Freeform 38"/>
              <p:cNvSpPr/>
              <p:nvPr/>
            </p:nvSpPr>
            <p:spPr>
              <a:xfrm>
                <a:off x="4737502" y="5051957"/>
                <a:ext cx="264804" cy="66200"/>
              </a:xfrm>
              <a:custGeom>
                <a:avLst/>
                <a:gdLst>
                  <a:gd name="connsiteX0" fmla="*/ 264804 w 264804"/>
                  <a:gd name="connsiteY0" fmla="*/ 66200 h 66200"/>
                  <a:gd name="connsiteX1" fmla="*/ 244116 w 264804"/>
                  <a:gd name="connsiteY1" fmla="*/ 62063 h 66200"/>
                  <a:gd name="connsiteX2" fmla="*/ 202741 w 264804"/>
                  <a:gd name="connsiteY2" fmla="*/ 49650 h 66200"/>
                  <a:gd name="connsiteX3" fmla="*/ 173778 w 264804"/>
                  <a:gd name="connsiteY3" fmla="*/ 45513 h 66200"/>
                  <a:gd name="connsiteX4" fmla="*/ 161365 w 264804"/>
                  <a:gd name="connsiteY4" fmla="*/ 41375 h 66200"/>
                  <a:gd name="connsiteX5" fmla="*/ 119989 w 264804"/>
                  <a:gd name="connsiteY5" fmla="*/ 33100 h 66200"/>
                  <a:gd name="connsiteX6" fmla="*/ 82751 w 264804"/>
                  <a:gd name="connsiteY6" fmla="*/ 24825 h 66200"/>
                  <a:gd name="connsiteX7" fmla="*/ 33101 w 264804"/>
                  <a:gd name="connsiteY7" fmla="*/ 8275 h 66200"/>
                  <a:gd name="connsiteX8" fmla="*/ 8275 w 264804"/>
                  <a:gd name="connsiteY8" fmla="*/ 0 h 66200"/>
                  <a:gd name="connsiteX9" fmla="*/ 0 w 264804"/>
                  <a:gd name="connsiteY9" fmla="*/ 0 h 66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64804" h="66200">
                    <a:moveTo>
                      <a:pt x="264804" y="66200"/>
                    </a:moveTo>
                    <a:cubicBezTo>
                      <a:pt x="257908" y="64821"/>
                      <a:pt x="250901" y="63913"/>
                      <a:pt x="244116" y="62063"/>
                    </a:cubicBezTo>
                    <a:cubicBezTo>
                      <a:pt x="222535" y="56178"/>
                      <a:pt x="222121" y="53174"/>
                      <a:pt x="202741" y="49650"/>
                    </a:cubicBezTo>
                    <a:cubicBezTo>
                      <a:pt x="193146" y="47905"/>
                      <a:pt x="183432" y="46892"/>
                      <a:pt x="173778" y="45513"/>
                    </a:cubicBezTo>
                    <a:cubicBezTo>
                      <a:pt x="169640" y="44134"/>
                      <a:pt x="165615" y="42356"/>
                      <a:pt x="161365" y="41375"/>
                    </a:cubicBezTo>
                    <a:cubicBezTo>
                      <a:pt x="147660" y="38212"/>
                      <a:pt x="133332" y="37548"/>
                      <a:pt x="119989" y="33100"/>
                    </a:cubicBezTo>
                    <a:cubicBezTo>
                      <a:pt x="99618" y="26309"/>
                      <a:pt x="111879" y="29679"/>
                      <a:pt x="82751" y="24825"/>
                    </a:cubicBezTo>
                    <a:lnTo>
                      <a:pt x="33101" y="8275"/>
                    </a:lnTo>
                    <a:lnTo>
                      <a:pt x="8275" y="0"/>
                    </a:lnTo>
                    <a:lnTo>
                      <a:pt x="0" y="0"/>
                    </a:lnTo>
                  </a:path>
                </a:pathLst>
              </a:custGeom>
              <a:noFill/>
              <a:ln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01" name="Group 100"/>
          <p:cNvGrpSpPr/>
          <p:nvPr/>
        </p:nvGrpSpPr>
        <p:grpSpPr>
          <a:xfrm>
            <a:off x="6211506" y="685800"/>
            <a:ext cx="2560320" cy="3657600"/>
            <a:chOff x="5813443" y="1658089"/>
            <a:chExt cx="3210373" cy="4601217"/>
          </a:xfrm>
        </p:grpSpPr>
        <p:pic>
          <p:nvPicPr>
            <p:cNvPr id="102" name="Picture 10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3443" y="1658089"/>
              <a:ext cx="3210373" cy="4601217"/>
            </a:xfrm>
            <a:prstGeom prst="rect">
              <a:avLst/>
            </a:prstGeom>
          </p:spPr>
        </p:pic>
        <p:grpSp>
          <p:nvGrpSpPr>
            <p:cNvPr id="103" name="Group 102"/>
            <p:cNvGrpSpPr/>
            <p:nvPr/>
          </p:nvGrpSpPr>
          <p:grpSpPr>
            <a:xfrm>
              <a:off x="6971639" y="3773882"/>
              <a:ext cx="1157536" cy="1384814"/>
              <a:chOff x="6971639" y="3773882"/>
              <a:chExt cx="1157536" cy="1384814"/>
            </a:xfrm>
          </p:grpSpPr>
          <p:sp>
            <p:nvSpPr>
              <p:cNvPr id="110" name="Freeform 109"/>
              <p:cNvSpPr/>
              <p:nvPr/>
            </p:nvSpPr>
            <p:spPr>
              <a:xfrm>
                <a:off x="6971639" y="4117443"/>
                <a:ext cx="1104680" cy="1041253"/>
              </a:xfrm>
              <a:custGeom>
                <a:avLst/>
                <a:gdLst>
                  <a:gd name="connsiteX0" fmla="*/ 184995 w 1104680"/>
                  <a:gd name="connsiteY0" fmla="*/ 0 h 1041253"/>
                  <a:gd name="connsiteX1" fmla="*/ 95140 w 1104680"/>
                  <a:gd name="connsiteY1" fmla="*/ 5285 h 1041253"/>
                  <a:gd name="connsiteX2" fmla="*/ 84569 w 1104680"/>
                  <a:gd name="connsiteY2" fmla="*/ 21142 h 1041253"/>
                  <a:gd name="connsiteX3" fmla="*/ 79284 w 1104680"/>
                  <a:gd name="connsiteY3" fmla="*/ 68712 h 1041253"/>
                  <a:gd name="connsiteX4" fmla="*/ 73998 w 1104680"/>
                  <a:gd name="connsiteY4" fmla="*/ 84569 h 1041253"/>
                  <a:gd name="connsiteX5" fmla="*/ 58141 w 1104680"/>
                  <a:gd name="connsiteY5" fmla="*/ 95140 h 1041253"/>
                  <a:gd name="connsiteX6" fmla="*/ 36999 w 1104680"/>
                  <a:gd name="connsiteY6" fmla="*/ 158566 h 1041253"/>
                  <a:gd name="connsiteX7" fmla="*/ 31714 w 1104680"/>
                  <a:gd name="connsiteY7" fmla="*/ 174423 h 1041253"/>
                  <a:gd name="connsiteX8" fmla="*/ 10571 w 1104680"/>
                  <a:gd name="connsiteY8" fmla="*/ 200851 h 1041253"/>
                  <a:gd name="connsiteX9" fmla="*/ 0 w 1104680"/>
                  <a:gd name="connsiteY9" fmla="*/ 274848 h 1041253"/>
                  <a:gd name="connsiteX10" fmla="*/ 5286 w 1104680"/>
                  <a:gd name="connsiteY10" fmla="*/ 322418 h 1041253"/>
                  <a:gd name="connsiteX11" fmla="*/ 10571 w 1104680"/>
                  <a:gd name="connsiteY11" fmla="*/ 544411 h 1041253"/>
                  <a:gd name="connsiteX12" fmla="*/ 21143 w 1104680"/>
                  <a:gd name="connsiteY12" fmla="*/ 576125 h 1041253"/>
                  <a:gd name="connsiteX13" fmla="*/ 31714 w 1104680"/>
                  <a:gd name="connsiteY13" fmla="*/ 613123 h 1041253"/>
                  <a:gd name="connsiteX14" fmla="*/ 42285 w 1104680"/>
                  <a:gd name="connsiteY14" fmla="*/ 687121 h 1041253"/>
                  <a:gd name="connsiteX15" fmla="*/ 52856 w 1104680"/>
                  <a:gd name="connsiteY15" fmla="*/ 718834 h 1041253"/>
                  <a:gd name="connsiteX16" fmla="*/ 58141 w 1104680"/>
                  <a:gd name="connsiteY16" fmla="*/ 734691 h 1041253"/>
                  <a:gd name="connsiteX17" fmla="*/ 79284 w 1104680"/>
                  <a:gd name="connsiteY17" fmla="*/ 761119 h 1041253"/>
                  <a:gd name="connsiteX18" fmla="*/ 100426 w 1104680"/>
                  <a:gd name="connsiteY18" fmla="*/ 787547 h 1041253"/>
                  <a:gd name="connsiteX19" fmla="*/ 116282 w 1104680"/>
                  <a:gd name="connsiteY19" fmla="*/ 792832 h 1041253"/>
                  <a:gd name="connsiteX20" fmla="*/ 132139 w 1104680"/>
                  <a:gd name="connsiteY20" fmla="*/ 808689 h 1041253"/>
                  <a:gd name="connsiteX21" fmla="*/ 163852 w 1104680"/>
                  <a:gd name="connsiteY21" fmla="*/ 824545 h 1041253"/>
                  <a:gd name="connsiteX22" fmla="*/ 200851 w 1104680"/>
                  <a:gd name="connsiteY22" fmla="*/ 850973 h 1041253"/>
                  <a:gd name="connsiteX23" fmla="*/ 216708 w 1104680"/>
                  <a:gd name="connsiteY23" fmla="*/ 861544 h 1041253"/>
                  <a:gd name="connsiteX24" fmla="*/ 232564 w 1104680"/>
                  <a:gd name="connsiteY24" fmla="*/ 866830 h 1041253"/>
                  <a:gd name="connsiteX25" fmla="*/ 243136 w 1104680"/>
                  <a:gd name="connsiteY25" fmla="*/ 877401 h 1041253"/>
                  <a:gd name="connsiteX26" fmla="*/ 258992 w 1104680"/>
                  <a:gd name="connsiteY26" fmla="*/ 887972 h 1041253"/>
                  <a:gd name="connsiteX27" fmla="*/ 269563 w 1104680"/>
                  <a:gd name="connsiteY27" fmla="*/ 903829 h 1041253"/>
                  <a:gd name="connsiteX28" fmla="*/ 301277 w 1104680"/>
                  <a:gd name="connsiteY28" fmla="*/ 919685 h 1041253"/>
                  <a:gd name="connsiteX29" fmla="*/ 317133 w 1104680"/>
                  <a:gd name="connsiteY29" fmla="*/ 930256 h 1041253"/>
                  <a:gd name="connsiteX30" fmla="*/ 327704 w 1104680"/>
                  <a:gd name="connsiteY30" fmla="*/ 940828 h 1041253"/>
                  <a:gd name="connsiteX31" fmla="*/ 343561 w 1104680"/>
                  <a:gd name="connsiteY31" fmla="*/ 946113 h 1041253"/>
                  <a:gd name="connsiteX32" fmla="*/ 359418 w 1104680"/>
                  <a:gd name="connsiteY32" fmla="*/ 956684 h 1041253"/>
                  <a:gd name="connsiteX33" fmla="*/ 391131 w 1104680"/>
                  <a:gd name="connsiteY33" fmla="*/ 967255 h 1041253"/>
                  <a:gd name="connsiteX34" fmla="*/ 406988 w 1104680"/>
                  <a:gd name="connsiteY34" fmla="*/ 977826 h 1041253"/>
                  <a:gd name="connsiteX35" fmla="*/ 443986 w 1104680"/>
                  <a:gd name="connsiteY35" fmla="*/ 988397 h 1041253"/>
                  <a:gd name="connsiteX36" fmla="*/ 475700 w 1104680"/>
                  <a:gd name="connsiteY36" fmla="*/ 998969 h 1041253"/>
                  <a:gd name="connsiteX37" fmla="*/ 491556 w 1104680"/>
                  <a:gd name="connsiteY37" fmla="*/ 1004254 h 1041253"/>
                  <a:gd name="connsiteX38" fmla="*/ 523270 w 1104680"/>
                  <a:gd name="connsiteY38" fmla="*/ 1009540 h 1041253"/>
                  <a:gd name="connsiteX39" fmla="*/ 539126 w 1104680"/>
                  <a:gd name="connsiteY39" fmla="*/ 1020111 h 1041253"/>
                  <a:gd name="connsiteX40" fmla="*/ 560269 w 1104680"/>
                  <a:gd name="connsiteY40" fmla="*/ 1041253 h 1041253"/>
                  <a:gd name="connsiteX41" fmla="*/ 634266 w 1104680"/>
                  <a:gd name="connsiteY41" fmla="*/ 1035967 h 1041253"/>
                  <a:gd name="connsiteX42" fmla="*/ 650123 w 1104680"/>
                  <a:gd name="connsiteY42" fmla="*/ 1025396 h 1041253"/>
                  <a:gd name="connsiteX43" fmla="*/ 665979 w 1104680"/>
                  <a:gd name="connsiteY43" fmla="*/ 1020111 h 1041253"/>
                  <a:gd name="connsiteX44" fmla="*/ 692407 w 1104680"/>
                  <a:gd name="connsiteY44" fmla="*/ 1004254 h 1041253"/>
                  <a:gd name="connsiteX45" fmla="*/ 798118 w 1104680"/>
                  <a:gd name="connsiteY45" fmla="*/ 977826 h 1041253"/>
                  <a:gd name="connsiteX46" fmla="*/ 819260 w 1104680"/>
                  <a:gd name="connsiteY46" fmla="*/ 951399 h 1041253"/>
                  <a:gd name="connsiteX47" fmla="*/ 840403 w 1104680"/>
                  <a:gd name="connsiteY47" fmla="*/ 930256 h 1041253"/>
                  <a:gd name="connsiteX48" fmla="*/ 882687 w 1104680"/>
                  <a:gd name="connsiteY48" fmla="*/ 893258 h 1041253"/>
                  <a:gd name="connsiteX49" fmla="*/ 898544 w 1104680"/>
                  <a:gd name="connsiteY49" fmla="*/ 887972 h 1041253"/>
                  <a:gd name="connsiteX50" fmla="*/ 951399 w 1104680"/>
                  <a:gd name="connsiteY50" fmla="*/ 877401 h 1041253"/>
                  <a:gd name="connsiteX51" fmla="*/ 967256 w 1104680"/>
                  <a:gd name="connsiteY51" fmla="*/ 872115 h 1041253"/>
                  <a:gd name="connsiteX52" fmla="*/ 993684 w 1104680"/>
                  <a:gd name="connsiteY52" fmla="*/ 850973 h 1041253"/>
                  <a:gd name="connsiteX53" fmla="*/ 1009540 w 1104680"/>
                  <a:gd name="connsiteY53" fmla="*/ 840402 h 1041253"/>
                  <a:gd name="connsiteX54" fmla="*/ 1030682 w 1104680"/>
                  <a:gd name="connsiteY54" fmla="*/ 819260 h 1041253"/>
                  <a:gd name="connsiteX55" fmla="*/ 1041253 w 1104680"/>
                  <a:gd name="connsiteY55" fmla="*/ 803403 h 1041253"/>
                  <a:gd name="connsiteX56" fmla="*/ 1051825 w 1104680"/>
                  <a:gd name="connsiteY56" fmla="*/ 792832 h 1041253"/>
                  <a:gd name="connsiteX57" fmla="*/ 1072967 w 1104680"/>
                  <a:gd name="connsiteY57" fmla="*/ 761119 h 1041253"/>
                  <a:gd name="connsiteX58" fmla="*/ 1083538 w 1104680"/>
                  <a:gd name="connsiteY58" fmla="*/ 745262 h 1041253"/>
                  <a:gd name="connsiteX59" fmla="*/ 1104680 w 1104680"/>
                  <a:gd name="connsiteY59" fmla="*/ 697692 h 1041253"/>
                  <a:gd name="connsiteX60" fmla="*/ 1104680 w 1104680"/>
                  <a:gd name="connsiteY60" fmla="*/ 687121 h 10412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</a:cxnLst>
                <a:rect l="l" t="t" r="r" b="b"/>
                <a:pathLst>
                  <a:path w="1104680" h="1041253">
                    <a:moveTo>
                      <a:pt x="184995" y="0"/>
                    </a:moveTo>
                    <a:cubicBezTo>
                      <a:pt x="155043" y="1762"/>
                      <a:pt x="124500" y="-896"/>
                      <a:pt x="95140" y="5285"/>
                    </a:cubicBezTo>
                    <a:cubicBezTo>
                      <a:pt x="88924" y="6594"/>
                      <a:pt x="86110" y="14979"/>
                      <a:pt x="84569" y="21142"/>
                    </a:cubicBezTo>
                    <a:cubicBezTo>
                      <a:pt x="80700" y="36620"/>
                      <a:pt x="81907" y="52975"/>
                      <a:pt x="79284" y="68712"/>
                    </a:cubicBezTo>
                    <a:cubicBezTo>
                      <a:pt x="78368" y="74208"/>
                      <a:pt x="77479" y="80218"/>
                      <a:pt x="73998" y="84569"/>
                    </a:cubicBezTo>
                    <a:cubicBezTo>
                      <a:pt x="70030" y="89529"/>
                      <a:pt x="63427" y="91616"/>
                      <a:pt x="58141" y="95140"/>
                    </a:cubicBezTo>
                    <a:lnTo>
                      <a:pt x="36999" y="158566"/>
                    </a:lnTo>
                    <a:cubicBezTo>
                      <a:pt x="35237" y="163852"/>
                      <a:pt x="34804" y="169787"/>
                      <a:pt x="31714" y="174423"/>
                    </a:cubicBezTo>
                    <a:cubicBezTo>
                      <a:pt x="18379" y="194427"/>
                      <a:pt x="25635" y="185788"/>
                      <a:pt x="10571" y="200851"/>
                    </a:cubicBezTo>
                    <a:cubicBezTo>
                      <a:pt x="790" y="230195"/>
                      <a:pt x="0" y="228531"/>
                      <a:pt x="0" y="274848"/>
                    </a:cubicBezTo>
                    <a:cubicBezTo>
                      <a:pt x="0" y="290802"/>
                      <a:pt x="3524" y="306561"/>
                      <a:pt x="5286" y="322418"/>
                    </a:cubicBezTo>
                    <a:cubicBezTo>
                      <a:pt x="7048" y="396416"/>
                      <a:pt x="5954" y="470537"/>
                      <a:pt x="10571" y="544411"/>
                    </a:cubicBezTo>
                    <a:cubicBezTo>
                      <a:pt x="11266" y="555533"/>
                      <a:pt x="17619" y="565554"/>
                      <a:pt x="21143" y="576125"/>
                    </a:cubicBezTo>
                    <a:cubicBezTo>
                      <a:pt x="28723" y="598865"/>
                      <a:pt x="25079" y="586586"/>
                      <a:pt x="31714" y="613123"/>
                    </a:cubicBezTo>
                    <a:cubicBezTo>
                      <a:pt x="34256" y="636008"/>
                      <a:pt x="35973" y="663977"/>
                      <a:pt x="42285" y="687121"/>
                    </a:cubicBezTo>
                    <a:cubicBezTo>
                      <a:pt x="45217" y="697871"/>
                      <a:pt x="49332" y="708263"/>
                      <a:pt x="52856" y="718834"/>
                    </a:cubicBezTo>
                    <a:cubicBezTo>
                      <a:pt x="54618" y="724120"/>
                      <a:pt x="55051" y="730055"/>
                      <a:pt x="58141" y="734691"/>
                    </a:cubicBezTo>
                    <a:cubicBezTo>
                      <a:pt x="90670" y="783486"/>
                      <a:pt x="49163" y="723470"/>
                      <a:pt x="79284" y="761119"/>
                    </a:cubicBezTo>
                    <a:cubicBezTo>
                      <a:pt x="85931" y="769427"/>
                      <a:pt x="90611" y="781658"/>
                      <a:pt x="100426" y="787547"/>
                    </a:cubicBezTo>
                    <a:cubicBezTo>
                      <a:pt x="105203" y="790413"/>
                      <a:pt x="110997" y="791070"/>
                      <a:pt x="116282" y="792832"/>
                    </a:cubicBezTo>
                    <a:cubicBezTo>
                      <a:pt x="121568" y="798118"/>
                      <a:pt x="125919" y="804543"/>
                      <a:pt x="132139" y="808689"/>
                    </a:cubicBezTo>
                    <a:cubicBezTo>
                      <a:pt x="174344" y="836825"/>
                      <a:pt x="120191" y="787121"/>
                      <a:pt x="163852" y="824545"/>
                    </a:cubicBezTo>
                    <a:cubicBezTo>
                      <a:pt x="195774" y="851907"/>
                      <a:pt x="171716" y="841262"/>
                      <a:pt x="200851" y="850973"/>
                    </a:cubicBezTo>
                    <a:cubicBezTo>
                      <a:pt x="206137" y="854497"/>
                      <a:pt x="211026" y="858703"/>
                      <a:pt x="216708" y="861544"/>
                    </a:cubicBezTo>
                    <a:cubicBezTo>
                      <a:pt x="221691" y="864036"/>
                      <a:pt x="227787" y="863964"/>
                      <a:pt x="232564" y="866830"/>
                    </a:cubicBezTo>
                    <a:cubicBezTo>
                      <a:pt x="236837" y="869394"/>
                      <a:pt x="239245" y="874288"/>
                      <a:pt x="243136" y="877401"/>
                    </a:cubicBezTo>
                    <a:cubicBezTo>
                      <a:pt x="248096" y="881369"/>
                      <a:pt x="253707" y="884448"/>
                      <a:pt x="258992" y="887972"/>
                    </a:cubicBezTo>
                    <a:cubicBezTo>
                      <a:pt x="262516" y="893258"/>
                      <a:pt x="265071" y="899337"/>
                      <a:pt x="269563" y="903829"/>
                    </a:cubicBezTo>
                    <a:cubicBezTo>
                      <a:pt x="279809" y="914075"/>
                      <a:pt x="288380" y="915387"/>
                      <a:pt x="301277" y="919685"/>
                    </a:cubicBezTo>
                    <a:cubicBezTo>
                      <a:pt x="306562" y="923209"/>
                      <a:pt x="312173" y="926288"/>
                      <a:pt x="317133" y="930256"/>
                    </a:cubicBezTo>
                    <a:cubicBezTo>
                      <a:pt x="321024" y="933369"/>
                      <a:pt x="323431" y="938264"/>
                      <a:pt x="327704" y="940828"/>
                    </a:cubicBezTo>
                    <a:cubicBezTo>
                      <a:pt x="332482" y="943695"/>
                      <a:pt x="338275" y="944351"/>
                      <a:pt x="343561" y="946113"/>
                    </a:cubicBezTo>
                    <a:cubicBezTo>
                      <a:pt x="348847" y="949637"/>
                      <a:pt x="353613" y="954104"/>
                      <a:pt x="359418" y="956684"/>
                    </a:cubicBezTo>
                    <a:cubicBezTo>
                      <a:pt x="369600" y="961209"/>
                      <a:pt x="391131" y="967255"/>
                      <a:pt x="391131" y="967255"/>
                    </a:cubicBezTo>
                    <a:cubicBezTo>
                      <a:pt x="396417" y="970779"/>
                      <a:pt x="401306" y="974985"/>
                      <a:pt x="406988" y="977826"/>
                    </a:cubicBezTo>
                    <a:cubicBezTo>
                      <a:pt x="415876" y="982270"/>
                      <a:pt x="435510" y="985854"/>
                      <a:pt x="443986" y="988397"/>
                    </a:cubicBezTo>
                    <a:cubicBezTo>
                      <a:pt x="454659" y="991599"/>
                      <a:pt x="465129" y="995445"/>
                      <a:pt x="475700" y="998969"/>
                    </a:cubicBezTo>
                    <a:cubicBezTo>
                      <a:pt x="480985" y="1000731"/>
                      <a:pt x="486061" y="1003338"/>
                      <a:pt x="491556" y="1004254"/>
                    </a:cubicBezTo>
                    <a:lnTo>
                      <a:pt x="523270" y="1009540"/>
                    </a:lnTo>
                    <a:cubicBezTo>
                      <a:pt x="528555" y="1013064"/>
                      <a:pt x="535158" y="1015151"/>
                      <a:pt x="539126" y="1020111"/>
                    </a:cubicBezTo>
                    <a:cubicBezTo>
                      <a:pt x="559627" y="1045737"/>
                      <a:pt x="525672" y="1029720"/>
                      <a:pt x="560269" y="1041253"/>
                    </a:cubicBezTo>
                    <a:cubicBezTo>
                      <a:pt x="584935" y="1039491"/>
                      <a:pt x="609914" y="1040265"/>
                      <a:pt x="634266" y="1035967"/>
                    </a:cubicBezTo>
                    <a:cubicBezTo>
                      <a:pt x="640522" y="1034863"/>
                      <a:pt x="644441" y="1028237"/>
                      <a:pt x="650123" y="1025396"/>
                    </a:cubicBezTo>
                    <a:cubicBezTo>
                      <a:pt x="655106" y="1022905"/>
                      <a:pt x="660694" y="1021873"/>
                      <a:pt x="665979" y="1020111"/>
                    </a:cubicBezTo>
                    <a:cubicBezTo>
                      <a:pt x="679073" y="1007018"/>
                      <a:pt x="673408" y="1009532"/>
                      <a:pt x="692407" y="1004254"/>
                    </a:cubicBezTo>
                    <a:cubicBezTo>
                      <a:pt x="767795" y="983313"/>
                      <a:pt x="749001" y="987650"/>
                      <a:pt x="798118" y="977826"/>
                    </a:cubicBezTo>
                    <a:cubicBezTo>
                      <a:pt x="836758" y="952067"/>
                      <a:pt x="796051" y="983891"/>
                      <a:pt x="819260" y="951399"/>
                    </a:cubicBezTo>
                    <a:cubicBezTo>
                      <a:pt x="825053" y="943289"/>
                      <a:pt x="834874" y="938549"/>
                      <a:pt x="840403" y="930256"/>
                    </a:cubicBezTo>
                    <a:cubicBezTo>
                      <a:pt x="852736" y="911757"/>
                      <a:pt x="856260" y="902068"/>
                      <a:pt x="882687" y="893258"/>
                    </a:cubicBezTo>
                    <a:cubicBezTo>
                      <a:pt x="887973" y="891496"/>
                      <a:pt x="893105" y="889181"/>
                      <a:pt x="898544" y="887972"/>
                    </a:cubicBezTo>
                    <a:cubicBezTo>
                      <a:pt x="945258" y="877590"/>
                      <a:pt x="914549" y="887930"/>
                      <a:pt x="951399" y="877401"/>
                    </a:cubicBezTo>
                    <a:cubicBezTo>
                      <a:pt x="956756" y="875870"/>
                      <a:pt x="962273" y="874607"/>
                      <a:pt x="967256" y="872115"/>
                    </a:cubicBezTo>
                    <a:cubicBezTo>
                      <a:pt x="988942" y="861272"/>
                      <a:pt x="977300" y="864080"/>
                      <a:pt x="993684" y="850973"/>
                    </a:cubicBezTo>
                    <a:cubicBezTo>
                      <a:pt x="998644" y="847005"/>
                      <a:pt x="1004255" y="843926"/>
                      <a:pt x="1009540" y="840402"/>
                    </a:cubicBezTo>
                    <a:cubicBezTo>
                      <a:pt x="1021074" y="805803"/>
                      <a:pt x="1005055" y="839762"/>
                      <a:pt x="1030682" y="819260"/>
                    </a:cubicBezTo>
                    <a:cubicBezTo>
                      <a:pt x="1035642" y="815292"/>
                      <a:pt x="1037285" y="808363"/>
                      <a:pt x="1041253" y="803403"/>
                    </a:cubicBezTo>
                    <a:cubicBezTo>
                      <a:pt x="1044366" y="799512"/>
                      <a:pt x="1048835" y="796819"/>
                      <a:pt x="1051825" y="792832"/>
                    </a:cubicBezTo>
                    <a:cubicBezTo>
                      <a:pt x="1059448" y="782668"/>
                      <a:pt x="1065920" y="771690"/>
                      <a:pt x="1072967" y="761119"/>
                    </a:cubicBezTo>
                    <a:lnTo>
                      <a:pt x="1083538" y="745262"/>
                    </a:lnTo>
                    <a:cubicBezTo>
                      <a:pt x="1093119" y="730890"/>
                      <a:pt x="1104680" y="716564"/>
                      <a:pt x="1104680" y="697692"/>
                    </a:cubicBezTo>
                    <a:lnTo>
                      <a:pt x="1104680" y="687121"/>
                    </a:lnTo>
                  </a:path>
                </a:pathLst>
              </a:custGeom>
              <a:noFill/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1" name="Freeform 110"/>
              <p:cNvSpPr/>
              <p:nvPr/>
            </p:nvSpPr>
            <p:spPr>
              <a:xfrm>
                <a:off x="7135491" y="3773882"/>
                <a:ext cx="993684" cy="1051824"/>
              </a:xfrm>
              <a:custGeom>
                <a:avLst/>
                <a:gdLst>
                  <a:gd name="connsiteX0" fmla="*/ 0 w 993684"/>
                  <a:gd name="connsiteY0" fmla="*/ 348846 h 1051824"/>
                  <a:gd name="connsiteX1" fmla="*/ 26428 w 993684"/>
                  <a:gd name="connsiteY1" fmla="*/ 332990 h 1051824"/>
                  <a:gd name="connsiteX2" fmla="*/ 15857 w 993684"/>
                  <a:gd name="connsiteY2" fmla="*/ 317133 h 1051824"/>
                  <a:gd name="connsiteX3" fmla="*/ 10571 w 993684"/>
                  <a:gd name="connsiteY3" fmla="*/ 290705 h 1051824"/>
                  <a:gd name="connsiteX4" fmla="*/ 15857 w 993684"/>
                  <a:gd name="connsiteY4" fmla="*/ 221993 h 1051824"/>
                  <a:gd name="connsiteX5" fmla="*/ 47570 w 993684"/>
                  <a:gd name="connsiteY5" fmla="*/ 158567 h 1051824"/>
                  <a:gd name="connsiteX6" fmla="*/ 58141 w 993684"/>
                  <a:gd name="connsiteY6" fmla="*/ 147995 h 1051824"/>
                  <a:gd name="connsiteX7" fmla="*/ 68712 w 993684"/>
                  <a:gd name="connsiteY7" fmla="*/ 132139 h 1051824"/>
                  <a:gd name="connsiteX8" fmla="*/ 84569 w 993684"/>
                  <a:gd name="connsiteY8" fmla="*/ 126853 h 1051824"/>
                  <a:gd name="connsiteX9" fmla="*/ 100426 w 993684"/>
                  <a:gd name="connsiteY9" fmla="*/ 116282 h 1051824"/>
                  <a:gd name="connsiteX10" fmla="*/ 126854 w 993684"/>
                  <a:gd name="connsiteY10" fmla="*/ 95140 h 1051824"/>
                  <a:gd name="connsiteX11" fmla="*/ 147996 w 993684"/>
                  <a:gd name="connsiteY11" fmla="*/ 63427 h 1051824"/>
                  <a:gd name="connsiteX12" fmla="*/ 163852 w 993684"/>
                  <a:gd name="connsiteY12" fmla="*/ 52856 h 1051824"/>
                  <a:gd name="connsiteX13" fmla="*/ 174423 w 993684"/>
                  <a:gd name="connsiteY13" fmla="*/ 42284 h 1051824"/>
                  <a:gd name="connsiteX14" fmla="*/ 190280 w 993684"/>
                  <a:gd name="connsiteY14" fmla="*/ 36999 h 1051824"/>
                  <a:gd name="connsiteX15" fmla="*/ 301277 w 993684"/>
                  <a:gd name="connsiteY15" fmla="*/ 31713 h 1051824"/>
                  <a:gd name="connsiteX16" fmla="*/ 354132 w 993684"/>
                  <a:gd name="connsiteY16" fmla="*/ 15857 h 1051824"/>
                  <a:gd name="connsiteX17" fmla="*/ 369989 w 993684"/>
                  <a:gd name="connsiteY17" fmla="*/ 10571 h 1051824"/>
                  <a:gd name="connsiteX18" fmla="*/ 422844 w 993684"/>
                  <a:gd name="connsiteY18" fmla="*/ 0 h 1051824"/>
                  <a:gd name="connsiteX19" fmla="*/ 512699 w 993684"/>
                  <a:gd name="connsiteY19" fmla="*/ 5286 h 1051824"/>
                  <a:gd name="connsiteX20" fmla="*/ 528555 w 993684"/>
                  <a:gd name="connsiteY20" fmla="*/ 10571 h 1051824"/>
                  <a:gd name="connsiteX21" fmla="*/ 560269 w 993684"/>
                  <a:gd name="connsiteY21" fmla="*/ 31713 h 1051824"/>
                  <a:gd name="connsiteX22" fmla="*/ 576125 w 993684"/>
                  <a:gd name="connsiteY22" fmla="*/ 42284 h 1051824"/>
                  <a:gd name="connsiteX23" fmla="*/ 586696 w 993684"/>
                  <a:gd name="connsiteY23" fmla="*/ 52856 h 1051824"/>
                  <a:gd name="connsiteX24" fmla="*/ 602553 w 993684"/>
                  <a:gd name="connsiteY24" fmla="*/ 58141 h 1051824"/>
                  <a:gd name="connsiteX25" fmla="*/ 613124 w 993684"/>
                  <a:gd name="connsiteY25" fmla="*/ 73998 h 1051824"/>
                  <a:gd name="connsiteX26" fmla="*/ 639552 w 993684"/>
                  <a:gd name="connsiteY26" fmla="*/ 100426 h 1051824"/>
                  <a:gd name="connsiteX27" fmla="*/ 655408 w 993684"/>
                  <a:gd name="connsiteY27" fmla="*/ 132139 h 1051824"/>
                  <a:gd name="connsiteX28" fmla="*/ 660694 w 993684"/>
                  <a:gd name="connsiteY28" fmla="*/ 147995 h 1051824"/>
                  <a:gd name="connsiteX29" fmla="*/ 671265 w 993684"/>
                  <a:gd name="connsiteY29" fmla="*/ 163852 h 1051824"/>
                  <a:gd name="connsiteX30" fmla="*/ 681836 w 993684"/>
                  <a:gd name="connsiteY30" fmla="*/ 195565 h 1051824"/>
                  <a:gd name="connsiteX31" fmla="*/ 687122 w 993684"/>
                  <a:gd name="connsiteY31" fmla="*/ 211422 h 1051824"/>
                  <a:gd name="connsiteX32" fmla="*/ 702978 w 993684"/>
                  <a:gd name="connsiteY32" fmla="*/ 258992 h 1051824"/>
                  <a:gd name="connsiteX33" fmla="*/ 708264 w 993684"/>
                  <a:gd name="connsiteY33" fmla="*/ 274849 h 1051824"/>
                  <a:gd name="connsiteX34" fmla="*/ 697693 w 993684"/>
                  <a:gd name="connsiteY34" fmla="*/ 385845 h 1051824"/>
                  <a:gd name="connsiteX35" fmla="*/ 687122 w 993684"/>
                  <a:gd name="connsiteY35" fmla="*/ 401702 h 1051824"/>
                  <a:gd name="connsiteX36" fmla="*/ 655408 w 993684"/>
                  <a:gd name="connsiteY36" fmla="*/ 412273 h 1051824"/>
                  <a:gd name="connsiteX37" fmla="*/ 628981 w 993684"/>
                  <a:gd name="connsiteY37" fmla="*/ 443986 h 1051824"/>
                  <a:gd name="connsiteX38" fmla="*/ 634266 w 993684"/>
                  <a:gd name="connsiteY38" fmla="*/ 475700 h 1051824"/>
                  <a:gd name="connsiteX39" fmla="*/ 681836 w 993684"/>
                  <a:gd name="connsiteY39" fmla="*/ 449272 h 1051824"/>
                  <a:gd name="connsiteX40" fmla="*/ 697693 w 993684"/>
                  <a:gd name="connsiteY40" fmla="*/ 438701 h 1051824"/>
                  <a:gd name="connsiteX41" fmla="*/ 713549 w 993684"/>
                  <a:gd name="connsiteY41" fmla="*/ 422844 h 1051824"/>
                  <a:gd name="connsiteX42" fmla="*/ 729406 w 993684"/>
                  <a:gd name="connsiteY42" fmla="*/ 417558 h 1051824"/>
                  <a:gd name="connsiteX43" fmla="*/ 745263 w 993684"/>
                  <a:gd name="connsiteY43" fmla="*/ 406987 h 1051824"/>
                  <a:gd name="connsiteX44" fmla="*/ 776976 w 993684"/>
                  <a:gd name="connsiteY44" fmla="*/ 396416 h 1051824"/>
                  <a:gd name="connsiteX45" fmla="*/ 792833 w 993684"/>
                  <a:gd name="connsiteY45" fmla="*/ 391131 h 1051824"/>
                  <a:gd name="connsiteX46" fmla="*/ 850974 w 993684"/>
                  <a:gd name="connsiteY46" fmla="*/ 396416 h 1051824"/>
                  <a:gd name="connsiteX47" fmla="*/ 882687 w 993684"/>
                  <a:gd name="connsiteY47" fmla="*/ 417558 h 1051824"/>
                  <a:gd name="connsiteX48" fmla="*/ 903829 w 993684"/>
                  <a:gd name="connsiteY48" fmla="*/ 443986 h 1051824"/>
                  <a:gd name="connsiteX49" fmla="*/ 909115 w 993684"/>
                  <a:gd name="connsiteY49" fmla="*/ 459843 h 1051824"/>
                  <a:gd name="connsiteX50" fmla="*/ 919686 w 993684"/>
                  <a:gd name="connsiteY50" fmla="*/ 475700 h 1051824"/>
                  <a:gd name="connsiteX51" fmla="*/ 930257 w 993684"/>
                  <a:gd name="connsiteY51" fmla="*/ 507413 h 1051824"/>
                  <a:gd name="connsiteX52" fmla="*/ 940828 w 993684"/>
                  <a:gd name="connsiteY52" fmla="*/ 523269 h 1051824"/>
                  <a:gd name="connsiteX53" fmla="*/ 951399 w 993684"/>
                  <a:gd name="connsiteY53" fmla="*/ 554983 h 1051824"/>
                  <a:gd name="connsiteX54" fmla="*/ 956685 w 993684"/>
                  <a:gd name="connsiteY54" fmla="*/ 570839 h 1051824"/>
                  <a:gd name="connsiteX55" fmla="*/ 961970 w 993684"/>
                  <a:gd name="connsiteY55" fmla="*/ 586696 h 1051824"/>
                  <a:gd name="connsiteX56" fmla="*/ 972541 w 993684"/>
                  <a:gd name="connsiteY56" fmla="*/ 660694 h 1051824"/>
                  <a:gd name="connsiteX57" fmla="*/ 983112 w 993684"/>
                  <a:gd name="connsiteY57" fmla="*/ 692407 h 1051824"/>
                  <a:gd name="connsiteX58" fmla="*/ 988398 w 993684"/>
                  <a:gd name="connsiteY58" fmla="*/ 745263 h 1051824"/>
                  <a:gd name="connsiteX59" fmla="*/ 993684 w 993684"/>
                  <a:gd name="connsiteY59" fmla="*/ 761119 h 1051824"/>
                  <a:gd name="connsiteX60" fmla="*/ 983112 w 993684"/>
                  <a:gd name="connsiteY60" fmla="*/ 808689 h 1051824"/>
                  <a:gd name="connsiteX61" fmla="*/ 972541 w 993684"/>
                  <a:gd name="connsiteY61" fmla="*/ 824546 h 1051824"/>
                  <a:gd name="connsiteX62" fmla="*/ 967256 w 993684"/>
                  <a:gd name="connsiteY62" fmla="*/ 840402 h 1051824"/>
                  <a:gd name="connsiteX63" fmla="*/ 951399 w 993684"/>
                  <a:gd name="connsiteY63" fmla="*/ 872116 h 1051824"/>
                  <a:gd name="connsiteX64" fmla="*/ 956685 w 993684"/>
                  <a:gd name="connsiteY64" fmla="*/ 903829 h 1051824"/>
                  <a:gd name="connsiteX65" fmla="*/ 967256 w 993684"/>
                  <a:gd name="connsiteY65" fmla="*/ 935542 h 1051824"/>
                  <a:gd name="connsiteX66" fmla="*/ 951399 w 993684"/>
                  <a:gd name="connsiteY66" fmla="*/ 1014826 h 1051824"/>
                  <a:gd name="connsiteX67" fmla="*/ 940828 w 993684"/>
                  <a:gd name="connsiteY67" fmla="*/ 1046539 h 1051824"/>
                  <a:gd name="connsiteX68" fmla="*/ 935543 w 993684"/>
                  <a:gd name="connsiteY68" fmla="*/ 1051824 h 10518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</a:cxnLst>
                <a:rect l="l" t="t" r="r" b="b"/>
                <a:pathLst>
                  <a:path w="993684" h="1051824">
                    <a:moveTo>
                      <a:pt x="0" y="348846"/>
                    </a:moveTo>
                    <a:cubicBezTo>
                      <a:pt x="8809" y="343561"/>
                      <a:pt x="21834" y="342179"/>
                      <a:pt x="26428" y="332990"/>
                    </a:cubicBezTo>
                    <a:cubicBezTo>
                      <a:pt x="29269" y="327308"/>
                      <a:pt x="18088" y="323081"/>
                      <a:pt x="15857" y="317133"/>
                    </a:cubicBezTo>
                    <a:cubicBezTo>
                      <a:pt x="12703" y="308721"/>
                      <a:pt x="12333" y="299514"/>
                      <a:pt x="10571" y="290705"/>
                    </a:cubicBezTo>
                    <a:cubicBezTo>
                      <a:pt x="12333" y="267801"/>
                      <a:pt x="12274" y="244684"/>
                      <a:pt x="15857" y="221993"/>
                    </a:cubicBezTo>
                    <a:cubicBezTo>
                      <a:pt x="19081" y="201572"/>
                      <a:pt x="33204" y="172934"/>
                      <a:pt x="47570" y="158567"/>
                    </a:cubicBezTo>
                    <a:cubicBezTo>
                      <a:pt x="51094" y="155043"/>
                      <a:pt x="55028" y="151886"/>
                      <a:pt x="58141" y="147995"/>
                    </a:cubicBezTo>
                    <a:cubicBezTo>
                      <a:pt x="62109" y="143035"/>
                      <a:pt x="63752" y="136107"/>
                      <a:pt x="68712" y="132139"/>
                    </a:cubicBezTo>
                    <a:cubicBezTo>
                      <a:pt x="73063" y="128658"/>
                      <a:pt x="79586" y="129345"/>
                      <a:pt x="84569" y="126853"/>
                    </a:cubicBezTo>
                    <a:cubicBezTo>
                      <a:pt x="90251" y="124012"/>
                      <a:pt x="95140" y="119806"/>
                      <a:pt x="100426" y="116282"/>
                    </a:cubicBezTo>
                    <a:cubicBezTo>
                      <a:pt x="147355" y="45890"/>
                      <a:pt x="75791" y="146203"/>
                      <a:pt x="126854" y="95140"/>
                    </a:cubicBezTo>
                    <a:cubicBezTo>
                      <a:pt x="135838" y="86156"/>
                      <a:pt x="137425" y="70474"/>
                      <a:pt x="147996" y="63427"/>
                    </a:cubicBezTo>
                    <a:cubicBezTo>
                      <a:pt x="153281" y="59903"/>
                      <a:pt x="158892" y="56824"/>
                      <a:pt x="163852" y="52856"/>
                    </a:cubicBezTo>
                    <a:cubicBezTo>
                      <a:pt x="167743" y="49743"/>
                      <a:pt x="170150" y="44848"/>
                      <a:pt x="174423" y="42284"/>
                    </a:cubicBezTo>
                    <a:cubicBezTo>
                      <a:pt x="179201" y="39417"/>
                      <a:pt x="184728" y="37462"/>
                      <a:pt x="190280" y="36999"/>
                    </a:cubicBezTo>
                    <a:cubicBezTo>
                      <a:pt x="227193" y="33923"/>
                      <a:pt x="264278" y="33475"/>
                      <a:pt x="301277" y="31713"/>
                    </a:cubicBezTo>
                    <a:cubicBezTo>
                      <a:pt x="333227" y="23726"/>
                      <a:pt x="315531" y="28724"/>
                      <a:pt x="354132" y="15857"/>
                    </a:cubicBezTo>
                    <a:cubicBezTo>
                      <a:pt x="359418" y="14095"/>
                      <a:pt x="364493" y="11487"/>
                      <a:pt x="369989" y="10571"/>
                    </a:cubicBezTo>
                    <a:cubicBezTo>
                      <a:pt x="408867" y="4092"/>
                      <a:pt x="391305" y="7885"/>
                      <a:pt x="422844" y="0"/>
                    </a:cubicBezTo>
                    <a:cubicBezTo>
                      <a:pt x="452796" y="1762"/>
                      <a:pt x="482844" y="2301"/>
                      <a:pt x="512699" y="5286"/>
                    </a:cubicBezTo>
                    <a:cubicBezTo>
                      <a:pt x="518243" y="5840"/>
                      <a:pt x="523685" y="7865"/>
                      <a:pt x="528555" y="10571"/>
                    </a:cubicBezTo>
                    <a:cubicBezTo>
                      <a:pt x="539661" y="16741"/>
                      <a:pt x="549698" y="24666"/>
                      <a:pt x="560269" y="31713"/>
                    </a:cubicBezTo>
                    <a:cubicBezTo>
                      <a:pt x="565554" y="35237"/>
                      <a:pt x="571633" y="37792"/>
                      <a:pt x="576125" y="42284"/>
                    </a:cubicBezTo>
                    <a:cubicBezTo>
                      <a:pt x="579649" y="45808"/>
                      <a:pt x="582423" y="50292"/>
                      <a:pt x="586696" y="52856"/>
                    </a:cubicBezTo>
                    <a:cubicBezTo>
                      <a:pt x="591474" y="55723"/>
                      <a:pt x="597267" y="56379"/>
                      <a:pt x="602553" y="58141"/>
                    </a:cubicBezTo>
                    <a:cubicBezTo>
                      <a:pt x="606077" y="63427"/>
                      <a:pt x="608941" y="69217"/>
                      <a:pt x="613124" y="73998"/>
                    </a:cubicBezTo>
                    <a:cubicBezTo>
                      <a:pt x="621328" y="83374"/>
                      <a:pt x="639552" y="100426"/>
                      <a:pt x="639552" y="100426"/>
                    </a:cubicBezTo>
                    <a:cubicBezTo>
                      <a:pt x="652833" y="140273"/>
                      <a:pt x="634919" y="91163"/>
                      <a:pt x="655408" y="132139"/>
                    </a:cubicBezTo>
                    <a:cubicBezTo>
                      <a:pt x="657900" y="137122"/>
                      <a:pt x="658202" y="143012"/>
                      <a:pt x="660694" y="147995"/>
                    </a:cubicBezTo>
                    <a:cubicBezTo>
                      <a:pt x="663535" y="153677"/>
                      <a:pt x="668685" y="158047"/>
                      <a:pt x="671265" y="163852"/>
                    </a:cubicBezTo>
                    <a:cubicBezTo>
                      <a:pt x="675790" y="174034"/>
                      <a:pt x="678312" y="184994"/>
                      <a:pt x="681836" y="195565"/>
                    </a:cubicBezTo>
                    <a:lnTo>
                      <a:pt x="687122" y="211422"/>
                    </a:lnTo>
                    <a:lnTo>
                      <a:pt x="702978" y="258992"/>
                    </a:lnTo>
                    <a:lnTo>
                      <a:pt x="708264" y="274849"/>
                    </a:lnTo>
                    <a:cubicBezTo>
                      <a:pt x="708132" y="277224"/>
                      <a:pt x="712063" y="357104"/>
                      <a:pt x="697693" y="385845"/>
                    </a:cubicBezTo>
                    <a:cubicBezTo>
                      <a:pt x="694852" y="391527"/>
                      <a:pt x="692509" y="398335"/>
                      <a:pt x="687122" y="401702"/>
                    </a:cubicBezTo>
                    <a:cubicBezTo>
                      <a:pt x="677673" y="407608"/>
                      <a:pt x="655408" y="412273"/>
                      <a:pt x="655408" y="412273"/>
                    </a:cubicBezTo>
                    <a:cubicBezTo>
                      <a:pt x="651296" y="416385"/>
                      <a:pt x="629901" y="435709"/>
                      <a:pt x="628981" y="443986"/>
                    </a:cubicBezTo>
                    <a:cubicBezTo>
                      <a:pt x="627797" y="454638"/>
                      <a:pt x="632504" y="465129"/>
                      <a:pt x="634266" y="475700"/>
                    </a:cubicBezTo>
                    <a:cubicBezTo>
                      <a:pt x="662176" y="466396"/>
                      <a:pt x="645486" y="473505"/>
                      <a:pt x="681836" y="449272"/>
                    </a:cubicBezTo>
                    <a:cubicBezTo>
                      <a:pt x="687122" y="445748"/>
                      <a:pt x="693201" y="443193"/>
                      <a:pt x="697693" y="438701"/>
                    </a:cubicBezTo>
                    <a:cubicBezTo>
                      <a:pt x="702978" y="433415"/>
                      <a:pt x="707330" y="426990"/>
                      <a:pt x="713549" y="422844"/>
                    </a:cubicBezTo>
                    <a:cubicBezTo>
                      <a:pt x="718185" y="419753"/>
                      <a:pt x="724423" y="420050"/>
                      <a:pt x="729406" y="417558"/>
                    </a:cubicBezTo>
                    <a:cubicBezTo>
                      <a:pt x="735088" y="414717"/>
                      <a:pt x="739458" y="409567"/>
                      <a:pt x="745263" y="406987"/>
                    </a:cubicBezTo>
                    <a:cubicBezTo>
                      <a:pt x="755445" y="402462"/>
                      <a:pt x="766405" y="399940"/>
                      <a:pt x="776976" y="396416"/>
                    </a:cubicBezTo>
                    <a:lnTo>
                      <a:pt x="792833" y="391131"/>
                    </a:lnTo>
                    <a:cubicBezTo>
                      <a:pt x="812213" y="392893"/>
                      <a:pt x="832304" y="390925"/>
                      <a:pt x="850974" y="396416"/>
                    </a:cubicBezTo>
                    <a:cubicBezTo>
                      <a:pt x="863163" y="400001"/>
                      <a:pt x="882687" y="417558"/>
                      <a:pt x="882687" y="417558"/>
                    </a:cubicBezTo>
                    <a:cubicBezTo>
                      <a:pt x="895974" y="457416"/>
                      <a:pt x="876506" y="409831"/>
                      <a:pt x="903829" y="443986"/>
                    </a:cubicBezTo>
                    <a:cubicBezTo>
                      <a:pt x="907310" y="448337"/>
                      <a:pt x="906623" y="454860"/>
                      <a:pt x="909115" y="459843"/>
                    </a:cubicBezTo>
                    <a:cubicBezTo>
                      <a:pt x="911956" y="465525"/>
                      <a:pt x="916162" y="470414"/>
                      <a:pt x="919686" y="475700"/>
                    </a:cubicBezTo>
                    <a:cubicBezTo>
                      <a:pt x="923210" y="486271"/>
                      <a:pt x="924076" y="498142"/>
                      <a:pt x="930257" y="507413"/>
                    </a:cubicBezTo>
                    <a:cubicBezTo>
                      <a:pt x="933781" y="512698"/>
                      <a:pt x="938248" y="517464"/>
                      <a:pt x="940828" y="523269"/>
                    </a:cubicBezTo>
                    <a:cubicBezTo>
                      <a:pt x="945354" y="533452"/>
                      <a:pt x="947875" y="544412"/>
                      <a:pt x="951399" y="554983"/>
                    </a:cubicBezTo>
                    <a:lnTo>
                      <a:pt x="956685" y="570839"/>
                    </a:lnTo>
                    <a:lnTo>
                      <a:pt x="961970" y="586696"/>
                    </a:lnTo>
                    <a:cubicBezTo>
                      <a:pt x="964511" y="609563"/>
                      <a:pt x="966232" y="637560"/>
                      <a:pt x="972541" y="660694"/>
                    </a:cubicBezTo>
                    <a:cubicBezTo>
                      <a:pt x="975473" y="671444"/>
                      <a:pt x="983112" y="692407"/>
                      <a:pt x="983112" y="692407"/>
                    </a:cubicBezTo>
                    <a:cubicBezTo>
                      <a:pt x="984874" y="710026"/>
                      <a:pt x="985705" y="727762"/>
                      <a:pt x="988398" y="745263"/>
                    </a:cubicBezTo>
                    <a:cubicBezTo>
                      <a:pt x="989245" y="750770"/>
                      <a:pt x="993684" y="755548"/>
                      <a:pt x="993684" y="761119"/>
                    </a:cubicBezTo>
                    <a:cubicBezTo>
                      <a:pt x="993684" y="769240"/>
                      <a:pt x="988563" y="797788"/>
                      <a:pt x="983112" y="808689"/>
                    </a:cubicBezTo>
                    <a:cubicBezTo>
                      <a:pt x="980271" y="814371"/>
                      <a:pt x="976065" y="819260"/>
                      <a:pt x="972541" y="824546"/>
                    </a:cubicBezTo>
                    <a:cubicBezTo>
                      <a:pt x="970779" y="829831"/>
                      <a:pt x="969747" y="835419"/>
                      <a:pt x="967256" y="840402"/>
                    </a:cubicBezTo>
                    <a:cubicBezTo>
                      <a:pt x="946762" y="881392"/>
                      <a:pt x="964687" y="832255"/>
                      <a:pt x="951399" y="872116"/>
                    </a:cubicBezTo>
                    <a:cubicBezTo>
                      <a:pt x="953161" y="882687"/>
                      <a:pt x="954086" y="893432"/>
                      <a:pt x="956685" y="903829"/>
                    </a:cubicBezTo>
                    <a:cubicBezTo>
                      <a:pt x="959388" y="914639"/>
                      <a:pt x="967256" y="935542"/>
                      <a:pt x="967256" y="935542"/>
                    </a:cubicBezTo>
                    <a:cubicBezTo>
                      <a:pt x="960739" y="994188"/>
                      <a:pt x="967015" y="967976"/>
                      <a:pt x="951399" y="1014826"/>
                    </a:cubicBezTo>
                    <a:cubicBezTo>
                      <a:pt x="951398" y="1014828"/>
                      <a:pt x="940829" y="1046538"/>
                      <a:pt x="940828" y="1046539"/>
                    </a:cubicBezTo>
                    <a:lnTo>
                      <a:pt x="935543" y="1051824"/>
                    </a:lnTo>
                  </a:path>
                </a:pathLst>
              </a:custGeom>
              <a:noFill/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04" name="Freeform 103"/>
            <p:cNvSpPr/>
            <p:nvPr/>
          </p:nvSpPr>
          <p:spPr>
            <a:xfrm>
              <a:off x="7457910" y="5148125"/>
              <a:ext cx="42284" cy="586696"/>
            </a:xfrm>
            <a:custGeom>
              <a:avLst/>
              <a:gdLst>
                <a:gd name="connsiteX0" fmla="*/ 42284 w 42284"/>
                <a:gd name="connsiteY0" fmla="*/ 0 h 586696"/>
                <a:gd name="connsiteX1" fmla="*/ 36999 w 42284"/>
                <a:gd name="connsiteY1" fmla="*/ 42284 h 586696"/>
                <a:gd name="connsiteX2" fmla="*/ 31713 w 42284"/>
                <a:gd name="connsiteY2" fmla="*/ 58141 h 586696"/>
                <a:gd name="connsiteX3" fmla="*/ 26428 w 42284"/>
                <a:gd name="connsiteY3" fmla="*/ 79283 h 586696"/>
                <a:gd name="connsiteX4" fmla="*/ 15856 w 42284"/>
                <a:gd name="connsiteY4" fmla="*/ 110996 h 586696"/>
                <a:gd name="connsiteX5" fmla="*/ 10571 w 42284"/>
                <a:gd name="connsiteY5" fmla="*/ 126853 h 586696"/>
                <a:gd name="connsiteX6" fmla="*/ 0 w 42284"/>
                <a:gd name="connsiteY6" fmla="*/ 169137 h 586696"/>
                <a:gd name="connsiteX7" fmla="*/ 5285 w 42284"/>
                <a:gd name="connsiteY7" fmla="*/ 359417 h 586696"/>
                <a:gd name="connsiteX8" fmla="*/ 10571 w 42284"/>
                <a:gd name="connsiteY8" fmla="*/ 385845 h 586696"/>
                <a:gd name="connsiteX9" fmla="*/ 15856 w 42284"/>
                <a:gd name="connsiteY9" fmla="*/ 533840 h 586696"/>
                <a:gd name="connsiteX10" fmla="*/ 21142 w 42284"/>
                <a:gd name="connsiteY10" fmla="*/ 549697 h 586696"/>
                <a:gd name="connsiteX11" fmla="*/ 26428 w 42284"/>
                <a:gd name="connsiteY11" fmla="*/ 586696 h 5866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42284" h="586696">
                  <a:moveTo>
                    <a:pt x="42284" y="0"/>
                  </a:moveTo>
                  <a:cubicBezTo>
                    <a:pt x="40522" y="14095"/>
                    <a:pt x="39540" y="28309"/>
                    <a:pt x="36999" y="42284"/>
                  </a:cubicBezTo>
                  <a:cubicBezTo>
                    <a:pt x="36002" y="47766"/>
                    <a:pt x="33244" y="52784"/>
                    <a:pt x="31713" y="58141"/>
                  </a:cubicBezTo>
                  <a:cubicBezTo>
                    <a:pt x="29717" y="65126"/>
                    <a:pt x="28515" y="72325"/>
                    <a:pt x="26428" y="79283"/>
                  </a:cubicBezTo>
                  <a:cubicBezTo>
                    <a:pt x="23226" y="89956"/>
                    <a:pt x="19380" y="100425"/>
                    <a:pt x="15856" y="110996"/>
                  </a:cubicBezTo>
                  <a:cubicBezTo>
                    <a:pt x="14094" y="116282"/>
                    <a:pt x="11664" y="121390"/>
                    <a:pt x="10571" y="126853"/>
                  </a:cubicBezTo>
                  <a:cubicBezTo>
                    <a:pt x="4192" y="158744"/>
                    <a:pt x="8126" y="144758"/>
                    <a:pt x="0" y="169137"/>
                  </a:cubicBezTo>
                  <a:cubicBezTo>
                    <a:pt x="1762" y="232564"/>
                    <a:pt x="2194" y="296041"/>
                    <a:pt x="5285" y="359417"/>
                  </a:cubicBezTo>
                  <a:cubicBezTo>
                    <a:pt x="5723" y="368390"/>
                    <a:pt x="10028" y="376878"/>
                    <a:pt x="10571" y="385845"/>
                  </a:cubicBezTo>
                  <a:cubicBezTo>
                    <a:pt x="13557" y="435118"/>
                    <a:pt x="12678" y="484579"/>
                    <a:pt x="15856" y="533840"/>
                  </a:cubicBezTo>
                  <a:cubicBezTo>
                    <a:pt x="16215" y="539400"/>
                    <a:pt x="19611" y="544340"/>
                    <a:pt x="21142" y="549697"/>
                  </a:cubicBezTo>
                  <a:cubicBezTo>
                    <a:pt x="27710" y="572683"/>
                    <a:pt x="26428" y="565964"/>
                    <a:pt x="26428" y="586696"/>
                  </a:cubicBezTo>
                </a:path>
              </a:pathLst>
            </a:custGeom>
            <a:noFill/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5" name="Group 104"/>
            <p:cNvGrpSpPr/>
            <p:nvPr/>
          </p:nvGrpSpPr>
          <p:grpSpPr>
            <a:xfrm>
              <a:off x="6453655" y="4915561"/>
              <a:ext cx="1934511" cy="322418"/>
              <a:chOff x="6453655" y="4915561"/>
              <a:chExt cx="1934511" cy="322418"/>
            </a:xfrm>
          </p:grpSpPr>
          <p:sp>
            <p:nvSpPr>
              <p:cNvPr id="106" name="Freeform 105"/>
              <p:cNvSpPr/>
              <p:nvPr/>
            </p:nvSpPr>
            <p:spPr>
              <a:xfrm>
                <a:off x="6453655" y="5058271"/>
                <a:ext cx="126854" cy="58141"/>
              </a:xfrm>
              <a:custGeom>
                <a:avLst/>
                <a:gdLst>
                  <a:gd name="connsiteX0" fmla="*/ 0 w 126854"/>
                  <a:gd name="connsiteY0" fmla="*/ 58141 h 58141"/>
                  <a:gd name="connsiteX1" fmla="*/ 26428 w 126854"/>
                  <a:gd name="connsiteY1" fmla="*/ 47569 h 58141"/>
                  <a:gd name="connsiteX2" fmla="*/ 42285 w 126854"/>
                  <a:gd name="connsiteY2" fmla="*/ 42284 h 58141"/>
                  <a:gd name="connsiteX3" fmla="*/ 58142 w 126854"/>
                  <a:gd name="connsiteY3" fmla="*/ 31713 h 58141"/>
                  <a:gd name="connsiteX4" fmla="*/ 89855 w 126854"/>
                  <a:gd name="connsiteY4" fmla="*/ 21142 h 58141"/>
                  <a:gd name="connsiteX5" fmla="*/ 105711 w 126854"/>
                  <a:gd name="connsiteY5" fmla="*/ 15856 h 58141"/>
                  <a:gd name="connsiteX6" fmla="*/ 121568 w 126854"/>
                  <a:gd name="connsiteY6" fmla="*/ 10571 h 58141"/>
                  <a:gd name="connsiteX7" fmla="*/ 126854 w 126854"/>
                  <a:gd name="connsiteY7" fmla="*/ 0 h 581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26854" h="58141">
                    <a:moveTo>
                      <a:pt x="0" y="58141"/>
                    </a:moveTo>
                    <a:cubicBezTo>
                      <a:pt x="8809" y="54617"/>
                      <a:pt x="17544" y="50900"/>
                      <a:pt x="26428" y="47569"/>
                    </a:cubicBezTo>
                    <a:cubicBezTo>
                      <a:pt x="31645" y="45613"/>
                      <a:pt x="37302" y="44776"/>
                      <a:pt x="42285" y="42284"/>
                    </a:cubicBezTo>
                    <a:cubicBezTo>
                      <a:pt x="47967" y="39443"/>
                      <a:pt x="52337" y="34293"/>
                      <a:pt x="58142" y="31713"/>
                    </a:cubicBezTo>
                    <a:cubicBezTo>
                      <a:pt x="68324" y="27188"/>
                      <a:pt x="79284" y="24666"/>
                      <a:pt x="89855" y="21142"/>
                    </a:cubicBezTo>
                    <a:lnTo>
                      <a:pt x="105711" y="15856"/>
                    </a:lnTo>
                    <a:cubicBezTo>
                      <a:pt x="110997" y="14094"/>
                      <a:pt x="119076" y="15554"/>
                      <a:pt x="121568" y="10571"/>
                    </a:cubicBezTo>
                    <a:lnTo>
                      <a:pt x="126854" y="0"/>
                    </a:lnTo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Freeform 106"/>
              <p:cNvSpPr/>
              <p:nvPr/>
            </p:nvSpPr>
            <p:spPr>
              <a:xfrm>
                <a:off x="7975894" y="4984273"/>
                <a:ext cx="311847" cy="195565"/>
              </a:xfrm>
              <a:custGeom>
                <a:avLst/>
                <a:gdLst>
                  <a:gd name="connsiteX0" fmla="*/ 0 w 311847"/>
                  <a:gd name="connsiteY0" fmla="*/ 0 h 195565"/>
                  <a:gd name="connsiteX1" fmla="*/ 10571 w 311847"/>
                  <a:gd name="connsiteY1" fmla="*/ 26428 h 195565"/>
                  <a:gd name="connsiteX2" fmla="*/ 31713 w 311847"/>
                  <a:gd name="connsiteY2" fmla="*/ 31713 h 195565"/>
                  <a:gd name="connsiteX3" fmla="*/ 63426 w 311847"/>
                  <a:gd name="connsiteY3" fmla="*/ 52855 h 195565"/>
                  <a:gd name="connsiteX4" fmla="*/ 79283 w 311847"/>
                  <a:gd name="connsiteY4" fmla="*/ 63426 h 195565"/>
                  <a:gd name="connsiteX5" fmla="*/ 89854 w 311847"/>
                  <a:gd name="connsiteY5" fmla="*/ 73998 h 195565"/>
                  <a:gd name="connsiteX6" fmla="*/ 121567 w 311847"/>
                  <a:gd name="connsiteY6" fmla="*/ 84569 h 195565"/>
                  <a:gd name="connsiteX7" fmla="*/ 200851 w 311847"/>
                  <a:gd name="connsiteY7" fmla="*/ 137424 h 195565"/>
                  <a:gd name="connsiteX8" fmla="*/ 232564 w 311847"/>
                  <a:gd name="connsiteY8" fmla="*/ 158566 h 195565"/>
                  <a:gd name="connsiteX9" fmla="*/ 248420 w 311847"/>
                  <a:gd name="connsiteY9" fmla="*/ 169137 h 195565"/>
                  <a:gd name="connsiteX10" fmla="*/ 264277 w 311847"/>
                  <a:gd name="connsiteY10" fmla="*/ 174423 h 195565"/>
                  <a:gd name="connsiteX11" fmla="*/ 280134 w 311847"/>
                  <a:gd name="connsiteY11" fmla="*/ 184994 h 195565"/>
                  <a:gd name="connsiteX12" fmla="*/ 311847 w 311847"/>
                  <a:gd name="connsiteY12" fmla="*/ 195565 h 1955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311847" h="195565">
                    <a:moveTo>
                      <a:pt x="0" y="0"/>
                    </a:moveTo>
                    <a:cubicBezTo>
                      <a:pt x="3524" y="8809"/>
                      <a:pt x="3862" y="19719"/>
                      <a:pt x="10571" y="26428"/>
                    </a:cubicBezTo>
                    <a:cubicBezTo>
                      <a:pt x="15708" y="31565"/>
                      <a:pt x="25216" y="28464"/>
                      <a:pt x="31713" y="31713"/>
                    </a:cubicBezTo>
                    <a:cubicBezTo>
                      <a:pt x="43077" y="37395"/>
                      <a:pt x="52855" y="45808"/>
                      <a:pt x="63426" y="52855"/>
                    </a:cubicBezTo>
                    <a:cubicBezTo>
                      <a:pt x="68712" y="56379"/>
                      <a:pt x="74791" y="58934"/>
                      <a:pt x="79283" y="63426"/>
                    </a:cubicBezTo>
                    <a:cubicBezTo>
                      <a:pt x="82807" y="66950"/>
                      <a:pt x="85397" y="71769"/>
                      <a:pt x="89854" y="73998"/>
                    </a:cubicBezTo>
                    <a:cubicBezTo>
                      <a:pt x="99820" y="78981"/>
                      <a:pt x="112296" y="78388"/>
                      <a:pt x="121567" y="84569"/>
                    </a:cubicBezTo>
                    <a:lnTo>
                      <a:pt x="200851" y="137424"/>
                    </a:lnTo>
                    <a:lnTo>
                      <a:pt x="232564" y="158566"/>
                    </a:lnTo>
                    <a:cubicBezTo>
                      <a:pt x="237849" y="162090"/>
                      <a:pt x="242394" y="167128"/>
                      <a:pt x="248420" y="169137"/>
                    </a:cubicBezTo>
                    <a:cubicBezTo>
                      <a:pt x="253706" y="170899"/>
                      <a:pt x="259294" y="171931"/>
                      <a:pt x="264277" y="174423"/>
                    </a:cubicBezTo>
                    <a:cubicBezTo>
                      <a:pt x="269959" y="177264"/>
                      <a:pt x="274329" y="182414"/>
                      <a:pt x="280134" y="184994"/>
                    </a:cubicBezTo>
                    <a:cubicBezTo>
                      <a:pt x="290316" y="189519"/>
                      <a:pt x="311847" y="195565"/>
                      <a:pt x="311847" y="195565"/>
                    </a:cubicBezTo>
                  </a:path>
                </a:pathLst>
              </a:custGeom>
              <a:noFill/>
              <a:ln>
                <a:solidFill>
                  <a:srgbClr val="FFFF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8" name="Freeform 107"/>
              <p:cNvSpPr/>
              <p:nvPr/>
            </p:nvSpPr>
            <p:spPr>
              <a:xfrm>
                <a:off x="8266599" y="5185124"/>
                <a:ext cx="121567" cy="52855"/>
              </a:xfrm>
              <a:custGeom>
                <a:avLst/>
                <a:gdLst>
                  <a:gd name="connsiteX0" fmla="*/ 0 w 121567"/>
                  <a:gd name="connsiteY0" fmla="*/ 0 h 52855"/>
                  <a:gd name="connsiteX1" fmla="*/ 26428 w 121567"/>
                  <a:gd name="connsiteY1" fmla="*/ 10571 h 52855"/>
                  <a:gd name="connsiteX2" fmla="*/ 42284 w 121567"/>
                  <a:gd name="connsiteY2" fmla="*/ 21142 h 52855"/>
                  <a:gd name="connsiteX3" fmla="*/ 73998 w 121567"/>
                  <a:gd name="connsiteY3" fmla="*/ 31713 h 52855"/>
                  <a:gd name="connsiteX4" fmla="*/ 89854 w 121567"/>
                  <a:gd name="connsiteY4" fmla="*/ 36999 h 52855"/>
                  <a:gd name="connsiteX5" fmla="*/ 105711 w 121567"/>
                  <a:gd name="connsiteY5" fmla="*/ 42284 h 52855"/>
                  <a:gd name="connsiteX6" fmla="*/ 121567 w 121567"/>
                  <a:gd name="connsiteY6" fmla="*/ 52855 h 528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21567" h="52855">
                    <a:moveTo>
                      <a:pt x="0" y="0"/>
                    </a:moveTo>
                    <a:cubicBezTo>
                      <a:pt x="8809" y="3524"/>
                      <a:pt x="17942" y="6328"/>
                      <a:pt x="26428" y="10571"/>
                    </a:cubicBezTo>
                    <a:cubicBezTo>
                      <a:pt x="32110" y="13412"/>
                      <a:pt x="36479" y="18562"/>
                      <a:pt x="42284" y="21142"/>
                    </a:cubicBezTo>
                    <a:cubicBezTo>
                      <a:pt x="52467" y="25668"/>
                      <a:pt x="63427" y="28189"/>
                      <a:pt x="73998" y="31713"/>
                    </a:cubicBezTo>
                    <a:lnTo>
                      <a:pt x="89854" y="36999"/>
                    </a:lnTo>
                    <a:lnTo>
                      <a:pt x="105711" y="42284"/>
                    </a:lnTo>
                    <a:lnTo>
                      <a:pt x="121567" y="52855"/>
                    </a:lnTo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9" name="Freeform 108"/>
              <p:cNvSpPr/>
              <p:nvPr/>
            </p:nvSpPr>
            <p:spPr>
              <a:xfrm>
                <a:off x="6559366" y="4915561"/>
                <a:ext cx="470414" cy="169137"/>
              </a:xfrm>
              <a:custGeom>
                <a:avLst/>
                <a:gdLst>
                  <a:gd name="connsiteX0" fmla="*/ 0 w 470414"/>
                  <a:gd name="connsiteY0" fmla="*/ 169137 h 169137"/>
                  <a:gd name="connsiteX1" fmla="*/ 26428 w 470414"/>
                  <a:gd name="connsiteY1" fmla="*/ 153281 h 169137"/>
                  <a:gd name="connsiteX2" fmla="*/ 58142 w 470414"/>
                  <a:gd name="connsiteY2" fmla="*/ 142710 h 169137"/>
                  <a:gd name="connsiteX3" fmla="*/ 73998 w 470414"/>
                  <a:gd name="connsiteY3" fmla="*/ 137424 h 169137"/>
                  <a:gd name="connsiteX4" fmla="*/ 89855 w 470414"/>
                  <a:gd name="connsiteY4" fmla="*/ 126853 h 169137"/>
                  <a:gd name="connsiteX5" fmla="*/ 121568 w 470414"/>
                  <a:gd name="connsiteY5" fmla="*/ 116282 h 169137"/>
                  <a:gd name="connsiteX6" fmla="*/ 153281 w 470414"/>
                  <a:gd name="connsiteY6" fmla="*/ 105711 h 169137"/>
                  <a:gd name="connsiteX7" fmla="*/ 184995 w 470414"/>
                  <a:gd name="connsiteY7" fmla="*/ 95140 h 169137"/>
                  <a:gd name="connsiteX8" fmla="*/ 200851 w 470414"/>
                  <a:gd name="connsiteY8" fmla="*/ 89854 h 169137"/>
                  <a:gd name="connsiteX9" fmla="*/ 243136 w 470414"/>
                  <a:gd name="connsiteY9" fmla="*/ 79283 h 169137"/>
                  <a:gd name="connsiteX10" fmla="*/ 258992 w 470414"/>
                  <a:gd name="connsiteY10" fmla="*/ 73997 h 169137"/>
                  <a:gd name="connsiteX11" fmla="*/ 332990 w 470414"/>
                  <a:gd name="connsiteY11" fmla="*/ 52855 h 169137"/>
                  <a:gd name="connsiteX12" fmla="*/ 412273 w 470414"/>
                  <a:gd name="connsiteY12" fmla="*/ 26427 h 169137"/>
                  <a:gd name="connsiteX13" fmla="*/ 443987 w 470414"/>
                  <a:gd name="connsiteY13" fmla="*/ 15856 h 169137"/>
                  <a:gd name="connsiteX14" fmla="*/ 459843 w 470414"/>
                  <a:gd name="connsiteY14" fmla="*/ 10571 h 169137"/>
                  <a:gd name="connsiteX15" fmla="*/ 470414 w 470414"/>
                  <a:gd name="connsiteY15" fmla="*/ 0 h 1691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470414" h="169137">
                    <a:moveTo>
                      <a:pt x="0" y="169137"/>
                    </a:moveTo>
                    <a:cubicBezTo>
                      <a:pt x="8809" y="163852"/>
                      <a:pt x="17076" y="157532"/>
                      <a:pt x="26428" y="153281"/>
                    </a:cubicBezTo>
                    <a:cubicBezTo>
                      <a:pt x="36572" y="148670"/>
                      <a:pt x="47571" y="146234"/>
                      <a:pt x="58142" y="142710"/>
                    </a:cubicBezTo>
                    <a:cubicBezTo>
                      <a:pt x="63427" y="140948"/>
                      <a:pt x="69362" y="140514"/>
                      <a:pt x="73998" y="137424"/>
                    </a:cubicBezTo>
                    <a:cubicBezTo>
                      <a:pt x="79284" y="133900"/>
                      <a:pt x="84050" y="129433"/>
                      <a:pt x="89855" y="126853"/>
                    </a:cubicBezTo>
                    <a:cubicBezTo>
                      <a:pt x="100037" y="122328"/>
                      <a:pt x="110997" y="119806"/>
                      <a:pt x="121568" y="116282"/>
                    </a:cubicBezTo>
                    <a:lnTo>
                      <a:pt x="153281" y="105711"/>
                    </a:lnTo>
                    <a:lnTo>
                      <a:pt x="184995" y="95140"/>
                    </a:lnTo>
                    <a:cubicBezTo>
                      <a:pt x="190280" y="93378"/>
                      <a:pt x="195446" y="91205"/>
                      <a:pt x="200851" y="89854"/>
                    </a:cubicBezTo>
                    <a:cubicBezTo>
                      <a:pt x="214946" y="86330"/>
                      <a:pt x="229353" y="83878"/>
                      <a:pt x="243136" y="79283"/>
                    </a:cubicBezTo>
                    <a:cubicBezTo>
                      <a:pt x="248421" y="77521"/>
                      <a:pt x="253617" y="75463"/>
                      <a:pt x="258992" y="73997"/>
                    </a:cubicBezTo>
                    <a:cubicBezTo>
                      <a:pt x="332029" y="54077"/>
                      <a:pt x="272200" y="73118"/>
                      <a:pt x="332990" y="52855"/>
                    </a:cubicBezTo>
                    <a:lnTo>
                      <a:pt x="412273" y="26427"/>
                    </a:lnTo>
                    <a:lnTo>
                      <a:pt x="443987" y="15856"/>
                    </a:lnTo>
                    <a:cubicBezTo>
                      <a:pt x="449272" y="14094"/>
                      <a:pt x="455904" y="14510"/>
                      <a:pt x="459843" y="10571"/>
                    </a:cubicBezTo>
                    <a:lnTo>
                      <a:pt x="470414" y="0"/>
                    </a:lnTo>
                  </a:path>
                </a:pathLst>
              </a:custGeom>
              <a:noFill/>
              <a:ln>
                <a:solidFill>
                  <a:srgbClr val="FFFF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63" name="Content Placeholder 2"/>
          <p:cNvSpPr txBox="1">
            <a:spLocks/>
          </p:cNvSpPr>
          <p:nvPr/>
        </p:nvSpPr>
        <p:spPr>
          <a:xfrm>
            <a:off x="172194" y="4203791"/>
            <a:ext cx="4648200" cy="26670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oloured</a:t>
            </a: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lines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accent5">
                    <a:lumMod val="60000"/>
                    <a:lumOff val="40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lx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accent5">
                  <a:lumMod val="60000"/>
                  <a:lumOff val="40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Sylvian</a:t>
            </a:r>
            <a:r>
              <a:rPr lang="en-US" dirty="0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 fissure</a:t>
            </a: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smtClean="0">
                <a:solidFill>
                  <a:srgbClr val="0070C0"/>
                </a:solidFill>
              </a:rPr>
              <a:t>Transverse occipital </a:t>
            </a:r>
            <a:r>
              <a:rPr lang="en-US" dirty="0" err="1" smtClean="0">
                <a:solidFill>
                  <a:srgbClr val="0070C0"/>
                </a:solidFill>
              </a:rPr>
              <a:t>sulcus</a:t>
            </a:r>
            <a:endParaRPr lang="en-US" dirty="0" smtClean="0">
              <a:solidFill>
                <a:srgbClr val="0070C0"/>
              </a:solidFill>
            </a:endParaRP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rgbClr val="FFCCFF"/>
                </a:solidFill>
              </a:rPr>
              <a:t>Calcarine</a:t>
            </a:r>
            <a:r>
              <a:rPr lang="en-US" dirty="0" smtClean="0">
                <a:solidFill>
                  <a:srgbClr val="FFCCFF"/>
                </a:solidFill>
              </a:rPr>
              <a:t> </a:t>
            </a:r>
            <a:r>
              <a:rPr lang="en-US" dirty="0" err="1" smtClean="0">
                <a:solidFill>
                  <a:srgbClr val="FFCCFF"/>
                </a:solidFill>
              </a:rPr>
              <a:t>sulcus</a:t>
            </a:r>
            <a:r>
              <a:rPr lang="en-US" dirty="0" smtClean="0">
                <a:solidFill>
                  <a:srgbClr val="FFCCFF"/>
                </a:solidFill>
              </a:rPr>
              <a:t> </a:t>
            </a:r>
            <a:endParaRPr lang="en-US" dirty="0" smtClean="0">
              <a:solidFill>
                <a:schemeClr val="bg1"/>
              </a:solidFill>
            </a:endParaRP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rgbClr val="FF33CC"/>
                </a:solidFill>
              </a:rPr>
              <a:t>Parietooccipital</a:t>
            </a:r>
            <a:r>
              <a:rPr lang="en-US" dirty="0" smtClean="0">
                <a:solidFill>
                  <a:srgbClr val="FF33CC"/>
                </a:solidFill>
              </a:rPr>
              <a:t> </a:t>
            </a:r>
            <a:r>
              <a:rPr lang="en-US" dirty="0" err="1" smtClean="0">
                <a:solidFill>
                  <a:srgbClr val="FF33CC"/>
                </a:solidFill>
              </a:rPr>
              <a:t>sulcus</a:t>
            </a:r>
            <a:endParaRPr lang="en-US" dirty="0" smtClean="0">
              <a:solidFill>
                <a:srgbClr val="FF33CC"/>
              </a:solidFill>
            </a:endParaRP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rgbClr val="FFFF00"/>
                </a:solidFill>
              </a:rPr>
              <a:t>Preoccipital</a:t>
            </a:r>
            <a:r>
              <a:rPr lang="en-US" dirty="0" smtClean="0">
                <a:solidFill>
                  <a:srgbClr val="FFFF00"/>
                </a:solidFill>
              </a:rPr>
              <a:t> </a:t>
            </a:r>
            <a:r>
              <a:rPr lang="en-US" dirty="0" smtClean="0">
                <a:solidFill>
                  <a:srgbClr val="FFFF00"/>
                </a:solidFill>
              </a:rPr>
              <a:t>notch</a:t>
            </a: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066800" y="21452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600200" y="21452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990600" y="3364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676400" y="3364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990600" y="1512332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V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676400" y="1512332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V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457200" y="2754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2133600" y="2754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grpSp>
        <p:nvGrpSpPr>
          <p:cNvPr id="175" name="Group 174"/>
          <p:cNvGrpSpPr/>
          <p:nvPr/>
        </p:nvGrpSpPr>
        <p:grpSpPr>
          <a:xfrm>
            <a:off x="3383280" y="685800"/>
            <a:ext cx="2560320" cy="3657600"/>
            <a:chOff x="4103083" y="1166102"/>
            <a:chExt cx="3210373" cy="4601217"/>
          </a:xfrm>
        </p:grpSpPr>
        <p:pic>
          <p:nvPicPr>
            <p:cNvPr id="176" name="Picture 17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3083" y="1166102"/>
              <a:ext cx="3210373" cy="4601217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77" name="Group 73"/>
            <p:cNvGrpSpPr/>
            <p:nvPr/>
          </p:nvGrpSpPr>
          <p:grpSpPr>
            <a:xfrm>
              <a:off x="4583220" y="4274680"/>
              <a:ext cx="2271975" cy="426346"/>
              <a:chOff x="4583220" y="4274680"/>
              <a:chExt cx="2271975" cy="426346"/>
            </a:xfrm>
          </p:grpSpPr>
          <p:sp>
            <p:nvSpPr>
              <p:cNvPr id="200" name="Freeform 199"/>
              <p:cNvSpPr/>
              <p:nvPr/>
            </p:nvSpPr>
            <p:spPr>
              <a:xfrm>
                <a:off x="4583220" y="4336388"/>
                <a:ext cx="403906" cy="196343"/>
              </a:xfrm>
              <a:custGeom>
                <a:avLst/>
                <a:gdLst>
                  <a:gd name="connsiteX0" fmla="*/ 0 w 403906"/>
                  <a:gd name="connsiteY0" fmla="*/ 173904 h 196343"/>
                  <a:gd name="connsiteX1" fmla="*/ 39268 w 403906"/>
                  <a:gd name="connsiteY1" fmla="*/ 179514 h 196343"/>
                  <a:gd name="connsiteX2" fmla="*/ 72927 w 403906"/>
                  <a:gd name="connsiteY2" fmla="*/ 190733 h 196343"/>
                  <a:gd name="connsiteX3" fmla="*/ 112196 w 403906"/>
                  <a:gd name="connsiteY3" fmla="*/ 196343 h 196343"/>
                  <a:gd name="connsiteX4" fmla="*/ 185124 w 403906"/>
                  <a:gd name="connsiteY4" fmla="*/ 190733 h 196343"/>
                  <a:gd name="connsiteX5" fmla="*/ 218782 w 403906"/>
                  <a:gd name="connsiteY5" fmla="*/ 179514 h 196343"/>
                  <a:gd name="connsiteX6" fmla="*/ 235612 w 403906"/>
                  <a:gd name="connsiteY6" fmla="*/ 162684 h 196343"/>
                  <a:gd name="connsiteX7" fmla="*/ 252441 w 403906"/>
                  <a:gd name="connsiteY7" fmla="*/ 157075 h 196343"/>
                  <a:gd name="connsiteX8" fmla="*/ 263661 w 403906"/>
                  <a:gd name="connsiteY8" fmla="*/ 140245 h 196343"/>
                  <a:gd name="connsiteX9" fmla="*/ 297320 w 403906"/>
                  <a:gd name="connsiteY9" fmla="*/ 117806 h 196343"/>
                  <a:gd name="connsiteX10" fmla="*/ 347808 w 403906"/>
                  <a:gd name="connsiteY10" fmla="*/ 72927 h 196343"/>
                  <a:gd name="connsiteX11" fmla="*/ 370247 w 403906"/>
                  <a:gd name="connsiteY11" fmla="*/ 39268 h 196343"/>
                  <a:gd name="connsiteX12" fmla="*/ 381467 w 403906"/>
                  <a:gd name="connsiteY12" fmla="*/ 22439 h 196343"/>
                  <a:gd name="connsiteX13" fmla="*/ 403906 w 403906"/>
                  <a:gd name="connsiteY13" fmla="*/ 0 h 1963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403906" h="196343">
                    <a:moveTo>
                      <a:pt x="0" y="173904"/>
                    </a:moveTo>
                    <a:cubicBezTo>
                      <a:pt x="13089" y="175774"/>
                      <a:pt x="26384" y="176541"/>
                      <a:pt x="39268" y="179514"/>
                    </a:cubicBezTo>
                    <a:cubicBezTo>
                      <a:pt x="50792" y="182173"/>
                      <a:pt x="61219" y="189060"/>
                      <a:pt x="72927" y="190733"/>
                    </a:cubicBezTo>
                    <a:lnTo>
                      <a:pt x="112196" y="196343"/>
                    </a:lnTo>
                    <a:cubicBezTo>
                      <a:pt x="136505" y="194473"/>
                      <a:pt x="161041" y="194535"/>
                      <a:pt x="185124" y="190733"/>
                    </a:cubicBezTo>
                    <a:cubicBezTo>
                      <a:pt x="196805" y="188889"/>
                      <a:pt x="218782" y="179514"/>
                      <a:pt x="218782" y="179514"/>
                    </a:cubicBezTo>
                    <a:cubicBezTo>
                      <a:pt x="224392" y="173904"/>
                      <a:pt x="229011" y="167085"/>
                      <a:pt x="235612" y="162684"/>
                    </a:cubicBezTo>
                    <a:cubicBezTo>
                      <a:pt x="240532" y="159404"/>
                      <a:pt x="247824" y="160769"/>
                      <a:pt x="252441" y="157075"/>
                    </a:cubicBezTo>
                    <a:cubicBezTo>
                      <a:pt x="257706" y="152863"/>
                      <a:pt x="258587" y="144685"/>
                      <a:pt x="263661" y="140245"/>
                    </a:cubicBezTo>
                    <a:cubicBezTo>
                      <a:pt x="273809" y="131366"/>
                      <a:pt x="286100" y="125286"/>
                      <a:pt x="297320" y="117806"/>
                    </a:cubicBezTo>
                    <a:cubicBezTo>
                      <a:pt x="317553" y="104317"/>
                      <a:pt x="332441" y="95978"/>
                      <a:pt x="347808" y="72927"/>
                    </a:cubicBezTo>
                    <a:lnTo>
                      <a:pt x="370247" y="39268"/>
                    </a:lnTo>
                    <a:cubicBezTo>
                      <a:pt x="373987" y="33658"/>
                      <a:pt x="375857" y="26179"/>
                      <a:pt x="381467" y="22439"/>
                    </a:cubicBezTo>
                    <a:cubicBezTo>
                      <a:pt x="401776" y="8900"/>
                      <a:pt x="395282" y="17250"/>
                      <a:pt x="403906" y="0"/>
                    </a:cubicBezTo>
                  </a:path>
                </a:pathLst>
              </a:cu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1" name="Freeform 200"/>
              <p:cNvSpPr/>
              <p:nvPr/>
            </p:nvSpPr>
            <p:spPr>
              <a:xfrm>
                <a:off x="4981517" y="4274680"/>
                <a:ext cx="129025" cy="67318"/>
              </a:xfrm>
              <a:custGeom>
                <a:avLst/>
                <a:gdLst>
                  <a:gd name="connsiteX0" fmla="*/ 0 w 129025"/>
                  <a:gd name="connsiteY0" fmla="*/ 67318 h 67318"/>
                  <a:gd name="connsiteX1" fmla="*/ 28049 w 129025"/>
                  <a:gd name="connsiteY1" fmla="*/ 56098 h 67318"/>
                  <a:gd name="connsiteX2" fmla="*/ 44878 w 129025"/>
                  <a:gd name="connsiteY2" fmla="*/ 44878 h 67318"/>
                  <a:gd name="connsiteX3" fmla="*/ 61708 w 129025"/>
                  <a:gd name="connsiteY3" fmla="*/ 39268 h 67318"/>
                  <a:gd name="connsiteX4" fmla="*/ 78537 w 129025"/>
                  <a:gd name="connsiteY4" fmla="*/ 28049 h 67318"/>
                  <a:gd name="connsiteX5" fmla="*/ 129025 w 129025"/>
                  <a:gd name="connsiteY5" fmla="*/ 5610 h 67318"/>
                  <a:gd name="connsiteX6" fmla="*/ 129025 w 129025"/>
                  <a:gd name="connsiteY6" fmla="*/ 0 h 673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29025" h="67318">
                    <a:moveTo>
                      <a:pt x="0" y="67318"/>
                    </a:moveTo>
                    <a:cubicBezTo>
                      <a:pt x="9350" y="63578"/>
                      <a:pt x="19042" y="60602"/>
                      <a:pt x="28049" y="56098"/>
                    </a:cubicBezTo>
                    <a:cubicBezTo>
                      <a:pt x="34079" y="53083"/>
                      <a:pt x="38848" y="47893"/>
                      <a:pt x="44878" y="44878"/>
                    </a:cubicBezTo>
                    <a:cubicBezTo>
                      <a:pt x="50167" y="42233"/>
                      <a:pt x="56419" y="41913"/>
                      <a:pt x="61708" y="39268"/>
                    </a:cubicBezTo>
                    <a:cubicBezTo>
                      <a:pt x="67738" y="36253"/>
                      <a:pt x="72376" y="30787"/>
                      <a:pt x="78537" y="28049"/>
                    </a:cubicBezTo>
                    <a:cubicBezTo>
                      <a:pt x="98531" y="19163"/>
                      <a:pt x="113792" y="20843"/>
                      <a:pt x="129025" y="5610"/>
                    </a:cubicBezTo>
                    <a:lnTo>
                      <a:pt x="129025" y="0"/>
                    </a:lnTo>
                  </a:path>
                </a:pathLst>
              </a:custGeom>
              <a:noFill/>
              <a:ln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2" name="Freeform 201"/>
              <p:cNvSpPr/>
              <p:nvPr/>
            </p:nvSpPr>
            <p:spPr>
              <a:xfrm>
                <a:off x="6456898" y="4555171"/>
                <a:ext cx="398297" cy="145855"/>
              </a:xfrm>
              <a:custGeom>
                <a:avLst/>
                <a:gdLst>
                  <a:gd name="connsiteX0" fmla="*/ 398297 w 398297"/>
                  <a:gd name="connsiteY0" fmla="*/ 145855 h 145855"/>
                  <a:gd name="connsiteX1" fmla="*/ 336589 w 398297"/>
                  <a:gd name="connsiteY1" fmla="*/ 100976 h 145855"/>
                  <a:gd name="connsiteX2" fmla="*/ 319760 w 398297"/>
                  <a:gd name="connsiteY2" fmla="*/ 89757 h 145855"/>
                  <a:gd name="connsiteX3" fmla="*/ 302930 w 398297"/>
                  <a:gd name="connsiteY3" fmla="*/ 78537 h 145855"/>
                  <a:gd name="connsiteX4" fmla="*/ 291711 w 398297"/>
                  <a:gd name="connsiteY4" fmla="*/ 61708 h 145855"/>
                  <a:gd name="connsiteX5" fmla="*/ 274881 w 398297"/>
                  <a:gd name="connsiteY5" fmla="*/ 50488 h 145855"/>
                  <a:gd name="connsiteX6" fmla="*/ 252442 w 398297"/>
                  <a:gd name="connsiteY6" fmla="*/ 16829 h 145855"/>
                  <a:gd name="connsiteX7" fmla="*/ 218783 w 398297"/>
                  <a:gd name="connsiteY7" fmla="*/ 0 h 145855"/>
                  <a:gd name="connsiteX8" fmla="*/ 61708 w 398297"/>
                  <a:gd name="connsiteY8" fmla="*/ 5609 h 145855"/>
                  <a:gd name="connsiteX9" fmla="*/ 28049 w 398297"/>
                  <a:gd name="connsiteY9" fmla="*/ 28049 h 145855"/>
                  <a:gd name="connsiteX10" fmla="*/ 0 w 398297"/>
                  <a:gd name="connsiteY10" fmla="*/ 33658 h 1458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398297" h="145855">
                    <a:moveTo>
                      <a:pt x="398297" y="145855"/>
                    </a:moveTo>
                    <a:cubicBezTo>
                      <a:pt x="359722" y="114995"/>
                      <a:pt x="380206" y="130054"/>
                      <a:pt x="336589" y="100976"/>
                    </a:cubicBezTo>
                    <a:lnTo>
                      <a:pt x="319760" y="89757"/>
                    </a:lnTo>
                    <a:lnTo>
                      <a:pt x="302930" y="78537"/>
                    </a:lnTo>
                    <a:cubicBezTo>
                      <a:pt x="299190" y="72927"/>
                      <a:pt x="296478" y="66475"/>
                      <a:pt x="291711" y="61708"/>
                    </a:cubicBezTo>
                    <a:cubicBezTo>
                      <a:pt x="286943" y="56940"/>
                      <a:pt x="279321" y="55562"/>
                      <a:pt x="274881" y="50488"/>
                    </a:cubicBezTo>
                    <a:cubicBezTo>
                      <a:pt x="266002" y="40340"/>
                      <a:pt x="265234" y="21093"/>
                      <a:pt x="252442" y="16829"/>
                    </a:cubicBezTo>
                    <a:cubicBezTo>
                      <a:pt x="229216" y="9087"/>
                      <a:pt x="240532" y="14499"/>
                      <a:pt x="218783" y="0"/>
                    </a:cubicBezTo>
                    <a:cubicBezTo>
                      <a:pt x="166425" y="1870"/>
                      <a:pt x="113991" y="2236"/>
                      <a:pt x="61708" y="5609"/>
                    </a:cubicBezTo>
                    <a:cubicBezTo>
                      <a:pt x="37029" y="7201"/>
                      <a:pt x="49494" y="15795"/>
                      <a:pt x="28049" y="28049"/>
                    </a:cubicBezTo>
                    <a:cubicBezTo>
                      <a:pt x="17439" y="34111"/>
                      <a:pt x="10011" y="33658"/>
                      <a:pt x="0" y="33658"/>
                    </a:cubicBezTo>
                  </a:path>
                </a:pathLst>
              </a:cu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3" name="Freeform 202"/>
              <p:cNvSpPr/>
              <p:nvPr/>
            </p:nvSpPr>
            <p:spPr>
              <a:xfrm>
                <a:off x="6299823" y="4566390"/>
                <a:ext cx="168295" cy="44879"/>
              </a:xfrm>
              <a:custGeom>
                <a:avLst/>
                <a:gdLst>
                  <a:gd name="connsiteX0" fmla="*/ 168295 w 168295"/>
                  <a:gd name="connsiteY0" fmla="*/ 44879 h 44879"/>
                  <a:gd name="connsiteX1" fmla="*/ 95367 w 168295"/>
                  <a:gd name="connsiteY1" fmla="*/ 39269 h 44879"/>
                  <a:gd name="connsiteX2" fmla="*/ 78538 w 168295"/>
                  <a:gd name="connsiteY2" fmla="*/ 28049 h 44879"/>
                  <a:gd name="connsiteX3" fmla="*/ 44879 w 168295"/>
                  <a:gd name="connsiteY3" fmla="*/ 16830 h 44879"/>
                  <a:gd name="connsiteX4" fmla="*/ 11220 w 168295"/>
                  <a:gd name="connsiteY4" fmla="*/ 5610 h 44879"/>
                  <a:gd name="connsiteX5" fmla="*/ 0 w 168295"/>
                  <a:gd name="connsiteY5" fmla="*/ 0 h 448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68295" h="44879">
                    <a:moveTo>
                      <a:pt x="168295" y="44879"/>
                    </a:moveTo>
                    <a:cubicBezTo>
                      <a:pt x="143986" y="43009"/>
                      <a:pt x="119331" y="43762"/>
                      <a:pt x="95367" y="39269"/>
                    </a:cubicBezTo>
                    <a:cubicBezTo>
                      <a:pt x="88740" y="38026"/>
                      <a:pt x="84699" y="30787"/>
                      <a:pt x="78538" y="28049"/>
                    </a:cubicBezTo>
                    <a:cubicBezTo>
                      <a:pt x="67731" y="23246"/>
                      <a:pt x="56099" y="20570"/>
                      <a:pt x="44879" y="16830"/>
                    </a:cubicBezTo>
                    <a:cubicBezTo>
                      <a:pt x="44877" y="16829"/>
                      <a:pt x="11223" y="5611"/>
                      <a:pt x="11220" y="5610"/>
                    </a:cubicBezTo>
                    <a:lnTo>
                      <a:pt x="0" y="0"/>
                    </a:lnTo>
                  </a:path>
                </a:pathLst>
              </a:custGeom>
              <a:noFill/>
              <a:ln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78" name="Freeform 177"/>
            <p:cNvSpPr/>
            <p:nvPr/>
          </p:nvSpPr>
          <p:spPr>
            <a:xfrm>
              <a:off x="5102294" y="2939544"/>
              <a:ext cx="619810" cy="907016"/>
            </a:xfrm>
            <a:custGeom>
              <a:avLst/>
              <a:gdLst>
                <a:gd name="connsiteX0" fmla="*/ 602889 w 619810"/>
                <a:gd name="connsiteY0" fmla="*/ 493663 h 907016"/>
                <a:gd name="connsiteX1" fmla="*/ 619718 w 619810"/>
                <a:gd name="connsiteY1" fmla="*/ 465614 h 907016"/>
                <a:gd name="connsiteX2" fmla="*/ 608499 w 619810"/>
                <a:gd name="connsiteY2" fmla="*/ 431955 h 907016"/>
                <a:gd name="connsiteX3" fmla="*/ 586059 w 619810"/>
                <a:gd name="connsiteY3" fmla="*/ 398296 h 907016"/>
                <a:gd name="connsiteX4" fmla="*/ 569230 w 619810"/>
                <a:gd name="connsiteY4" fmla="*/ 392687 h 907016"/>
                <a:gd name="connsiteX5" fmla="*/ 541181 w 619810"/>
                <a:gd name="connsiteY5" fmla="*/ 347808 h 907016"/>
                <a:gd name="connsiteX6" fmla="*/ 501912 w 619810"/>
                <a:gd name="connsiteY6" fmla="*/ 302930 h 907016"/>
                <a:gd name="connsiteX7" fmla="*/ 457034 w 619810"/>
                <a:gd name="connsiteY7" fmla="*/ 263661 h 907016"/>
                <a:gd name="connsiteX8" fmla="*/ 440204 w 619810"/>
                <a:gd name="connsiteY8" fmla="*/ 252441 h 907016"/>
                <a:gd name="connsiteX9" fmla="*/ 434594 w 619810"/>
                <a:gd name="connsiteY9" fmla="*/ 235612 h 907016"/>
                <a:gd name="connsiteX10" fmla="*/ 457034 w 619810"/>
                <a:gd name="connsiteY10" fmla="*/ 207563 h 907016"/>
                <a:gd name="connsiteX11" fmla="*/ 462643 w 619810"/>
                <a:gd name="connsiteY11" fmla="*/ 168294 h 907016"/>
                <a:gd name="connsiteX12" fmla="*/ 479473 w 619810"/>
                <a:gd name="connsiteY12" fmla="*/ 134635 h 907016"/>
                <a:gd name="connsiteX13" fmla="*/ 490693 w 619810"/>
                <a:gd name="connsiteY13" fmla="*/ 100976 h 907016"/>
                <a:gd name="connsiteX14" fmla="*/ 496302 w 619810"/>
                <a:gd name="connsiteY14" fmla="*/ 84147 h 907016"/>
                <a:gd name="connsiteX15" fmla="*/ 501912 w 619810"/>
                <a:gd name="connsiteY15" fmla="*/ 67317 h 907016"/>
                <a:gd name="connsiteX16" fmla="*/ 496302 w 619810"/>
                <a:gd name="connsiteY16" fmla="*/ 28049 h 907016"/>
                <a:gd name="connsiteX17" fmla="*/ 479473 w 619810"/>
                <a:gd name="connsiteY17" fmla="*/ 16829 h 907016"/>
                <a:gd name="connsiteX18" fmla="*/ 406545 w 619810"/>
                <a:gd name="connsiteY18" fmla="*/ 0 h 907016"/>
                <a:gd name="connsiteX19" fmla="*/ 350447 w 619810"/>
                <a:gd name="connsiteY19" fmla="*/ 5609 h 907016"/>
                <a:gd name="connsiteX20" fmla="*/ 333618 w 619810"/>
                <a:gd name="connsiteY20" fmla="*/ 16829 h 907016"/>
                <a:gd name="connsiteX21" fmla="*/ 299959 w 619810"/>
                <a:gd name="connsiteY21" fmla="*/ 33658 h 907016"/>
                <a:gd name="connsiteX22" fmla="*/ 266300 w 619810"/>
                <a:gd name="connsiteY22" fmla="*/ 56098 h 907016"/>
                <a:gd name="connsiteX23" fmla="*/ 249470 w 619810"/>
                <a:gd name="connsiteY23" fmla="*/ 72927 h 907016"/>
                <a:gd name="connsiteX24" fmla="*/ 232641 w 619810"/>
                <a:gd name="connsiteY24" fmla="*/ 78537 h 907016"/>
                <a:gd name="connsiteX25" fmla="*/ 198982 w 619810"/>
                <a:gd name="connsiteY25" fmla="*/ 100976 h 907016"/>
                <a:gd name="connsiteX26" fmla="*/ 182153 w 619810"/>
                <a:gd name="connsiteY26" fmla="*/ 112196 h 907016"/>
                <a:gd name="connsiteX27" fmla="*/ 165323 w 619810"/>
                <a:gd name="connsiteY27" fmla="*/ 123416 h 907016"/>
                <a:gd name="connsiteX28" fmla="*/ 131664 w 619810"/>
                <a:gd name="connsiteY28" fmla="*/ 151465 h 907016"/>
                <a:gd name="connsiteX29" fmla="*/ 114835 w 619810"/>
                <a:gd name="connsiteY29" fmla="*/ 185123 h 907016"/>
                <a:gd name="connsiteX30" fmla="*/ 103615 w 619810"/>
                <a:gd name="connsiteY30" fmla="*/ 201953 h 907016"/>
                <a:gd name="connsiteX31" fmla="*/ 98005 w 619810"/>
                <a:gd name="connsiteY31" fmla="*/ 218782 h 907016"/>
                <a:gd name="connsiteX32" fmla="*/ 86786 w 619810"/>
                <a:gd name="connsiteY32" fmla="*/ 235612 h 907016"/>
                <a:gd name="connsiteX33" fmla="*/ 64346 w 619810"/>
                <a:gd name="connsiteY33" fmla="*/ 286100 h 907016"/>
                <a:gd name="connsiteX34" fmla="*/ 53127 w 619810"/>
                <a:gd name="connsiteY34" fmla="*/ 325369 h 907016"/>
                <a:gd name="connsiteX35" fmla="*/ 47517 w 619810"/>
                <a:gd name="connsiteY35" fmla="*/ 342198 h 907016"/>
                <a:gd name="connsiteX36" fmla="*/ 41907 w 619810"/>
                <a:gd name="connsiteY36" fmla="*/ 398296 h 907016"/>
                <a:gd name="connsiteX37" fmla="*/ 25078 w 619810"/>
                <a:gd name="connsiteY37" fmla="*/ 471224 h 907016"/>
                <a:gd name="connsiteX38" fmla="*/ 13858 w 619810"/>
                <a:gd name="connsiteY38" fmla="*/ 549762 h 907016"/>
                <a:gd name="connsiteX39" fmla="*/ 8248 w 619810"/>
                <a:gd name="connsiteY39" fmla="*/ 566591 h 907016"/>
                <a:gd name="connsiteX40" fmla="*/ 8248 w 619810"/>
                <a:gd name="connsiteY40" fmla="*/ 740495 h 907016"/>
                <a:gd name="connsiteX41" fmla="*/ 13858 w 619810"/>
                <a:gd name="connsiteY41" fmla="*/ 757325 h 907016"/>
                <a:gd name="connsiteX42" fmla="*/ 25078 w 619810"/>
                <a:gd name="connsiteY42" fmla="*/ 774154 h 907016"/>
                <a:gd name="connsiteX43" fmla="*/ 41907 w 619810"/>
                <a:gd name="connsiteY43" fmla="*/ 807813 h 907016"/>
                <a:gd name="connsiteX44" fmla="*/ 47517 w 619810"/>
                <a:gd name="connsiteY44" fmla="*/ 824643 h 907016"/>
                <a:gd name="connsiteX45" fmla="*/ 69956 w 619810"/>
                <a:gd name="connsiteY45" fmla="*/ 858301 h 907016"/>
                <a:gd name="connsiteX46" fmla="*/ 98005 w 619810"/>
                <a:gd name="connsiteY46" fmla="*/ 886350 h 907016"/>
                <a:gd name="connsiteX47" fmla="*/ 114835 w 619810"/>
                <a:gd name="connsiteY47" fmla="*/ 891960 h 907016"/>
                <a:gd name="connsiteX48" fmla="*/ 243861 w 619810"/>
                <a:gd name="connsiteY48" fmla="*/ 897570 h 907016"/>
                <a:gd name="connsiteX49" fmla="*/ 350447 w 619810"/>
                <a:gd name="connsiteY49" fmla="*/ 897570 h 907016"/>
                <a:gd name="connsiteX50" fmla="*/ 384106 w 619810"/>
                <a:gd name="connsiteY50" fmla="*/ 886350 h 907016"/>
                <a:gd name="connsiteX51" fmla="*/ 406545 w 619810"/>
                <a:gd name="connsiteY51" fmla="*/ 852692 h 907016"/>
                <a:gd name="connsiteX52" fmla="*/ 423375 w 619810"/>
                <a:gd name="connsiteY52" fmla="*/ 835862 h 907016"/>
                <a:gd name="connsiteX53" fmla="*/ 434594 w 619810"/>
                <a:gd name="connsiteY53" fmla="*/ 819033 h 907016"/>
                <a:gd name="connsiteX54" fmla="*/ 440204 w 619810"/>
                <a:gd name="connsiteY54" fmla="*/ 802203 h 9070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</a:cxnLst>
              <a:rect l="l" t="t" r="r" b="b"/>
              <a:pathLst>
                <a:path w="619810" h="907016">
                  <a:moveTo>
                    <a:pt x="602889" y="493663"/>
                  </a:moveTo>
                  <a:cubicBezTo>
                    <a:pt x="608499" y="484313"/>
                    <a:pt x="618731" y="476473"/>
                    <a:pt x="619718" y="465614"/>
                  </a:cubicBezTo>
                  <a:cubicBezTo>
                    <a:pt x="620789" y="453836"/>
                    <a:pt x="612239" y="443175"/>
                    <a:pt x="608499" y="431955"/>
                  </a:cubicBezTo>
                  <a:cubicBezTo>
                    <a:pt x="602618" y="414312"/>
                    <a:pt x="604068" y="410301"/>
                    <a:pt x="586059" y="398296"/>
                  </a:cubicBezTo>
                  <a:cubicBezTo>
                    <a:pt x="581139" y="395016"/>
                    <a:pt x="574840" y="394557"/>
                    <a:pt x="569230" y="392687"/>
                  </a:cubicBezTo>
                  <a:cubicBezTo>
                    <a:pt x="528858" y="365772"/>
                    <a:pt x="578566" y="403886"/>
                    <a:pt x="541181" y="347808"/>
                  </a:cubicBezTo>
                  <a:cubicBezTo>
                    <a:pt x="515002" y="308539"/>
                    <a:pt x="529962" y="321628"/>
                    <a:pt x="501912" y="302930"/>
                  </a:cubicBezTo>
                  <a:cubicBezTo>
                    <a:pt x="483214" y="274880"/>
                    <a:pt x="496303" y="289840"/>
                    <a:pt x="457034" y="263661"/>
                  </a:cubicBezTo>
                  <a:lnTo>
                    <a:pt x="440204" y="252441"/>
                  </a:lnTo>
                  <a:cubicBezTo>
                    <a:pt x="438334" y="246831"/>
                    <a:pt x="434594" y="241525"/>
                    <a:pt x="434594" y="235612"/>
                  </a:cubicBezTo>
                  <a:cubicBezTo>
                    <a:pt x="434594" y="217547"/>
                    <a:pt x="444111" y="216178"/>
                    <a:pt x="457034" y="207563"/>
                  </a:cubicBezTo>
                  <a:cubicBezTo>
                    <a:pt x="458904" y="194473"/>
                    <a:pt x="460050" y="181260"/>
                    <a:pt x="462643" y="168294"/>
                  </a:cubicBezTo>
                  <a:cubicBezTo>
                    <a:pt x="468221" y="140400"/>
                    <a:pt x="467440" y="161708"/>
                    <a:pt x="479473" y="134635"/>
                  </a:cubicBezTo>
                  <a:cubicBezTo>
                    <a:pt x="484276" y="123828"/>
                    <a:pt x="486953" y="112196"/>
                    <a:pt x="490693" y="100976"/>
                  </a:cubicBezTo>
                  <a:lnTo>
                    <a:pt x="496302" y="84147"/>
                  </a:lnTo>
                  <a:lnTo>
                    <a:pt x="501912" y="67317"/>
                  </a:lnTo>
                  <a:cubicBezTo>
                    <a:pt x="500042" y="54228"/>
                    <a:pt x="501672" y="40132"/>
                    <a:pt x="496302" y="28049"/>
                  </a:cubicBezTo>
                  <a:cubicBezTo>
                    <a:pt x="493564" y="21888"/>
                    <a:pt x="485634" y="19567"/>
                    <a:pt x="479473" y="16829"/>
                  </a:cubicBezTo>
                  <a:cubicBezTo>
                    <a:pt x="450291" y="3859"/>
                    <a:pt x="438492" y="4563"/>
                    <a:pt x="406545" y="0"/>
                  </a:cubicBezTo>
                  <a:cubicBezTo>
                    <a:pt x="387846" y="1870"/>
                    <a:pt x="368758" y="1383"/>
                    <a:pt x="350447" y="5609"/>
                  </a:cubicBezTo>
                  <a:cubicBezTo>
                    <a:pt x="343878" y="7125"/>
                    <a:pt x="339648" y="13814"/>
                    <a:pt x="333618" y="16829"/>
                  </a:cubicBezTo>
                  <a:cubicBezTo>
                    <a:pt x="308317" y="29480"/>
                    <a:pt x="324074" y="13562"/>
                    <a:pt x="299959" y="33658"/>
                  </a:cubicBezTo>
                  <a:cubicBezTo>
                    <a:pt x="271943" y="57004"/>
                    <a:pt x="295876" y="46239"/>
                    <a:pt x="266300" y="56098"/>
                  </a:cubicBezTo>
                  <a:cubicBezTo>
                    <a:pt x="260690" y="61708"/>
                    <a:pt x="256071" y="68526"/>
                    <a:pt x="249470" y="72927"/>
                  </a:cubicBezTo>
                  <a:cubicBezTo>
                    <a:pt x="244550" y="76207"/>
                    <a:pt x="237810" y="75665"/>
                    <a:pt x="232641" y="78537"/>
                  </a:cubicBezTo>
                  <a:cubicBezTo>
                    <a:pt x="220854" y="85086"/>
                    <a:pt x="210202" y="93496"/>
                    <a:pt x="198982" y="100976"/>
                  </a:cubicBezTo>
                  <a:lnTo>
                    <a:pt x="182153" y="112196"/>
                  </a:lnTo>
                  <a:cubicBezTo>
                    <a:pt x="176543" y="115936"/>
                    <a:pt x="170091" y="118648"/>
                    <a:pt x="165323" y="123416"/>
                  </a:cubicBezTo>
                  <a:cubicBezTo>
                    <a:pt x="143726" y="145013"/>
                    <a:pt x="155095" y="135844"/>
                    <a:pt x="131664" y="151465"/>
                  </a:cubicBezTo>
                  <a:cubicBezTo>
                    <a:pt x="99509" y="199699"/>
                    <a:pt x="138063" y="138669"/>
                    <a:pt x="114835" y="185123"/>
                  </a:cubicBezTo>
                  <a:cubicBezTo>
                    <a:pt x="111820" y="191154"/>
                    <a:pt x="106630" y="195922"/>
                    <a:pt x="103615" y="201953"/>
                  </a:cubicBezTo>
                  <a:cubicBezTo>
                    <a:pt x="100970" y="207242"/>
                    <a:pt x="100649" y="213493"/>
                    <a:pt x="98005" y="218782"/>
                  </a:cubicBezTo>
                  <a:cubicBezTo>
                    <a:pt x="94990" y="224812"/>
                    <a:pt x="89524" y="229451"/>
                    <a:pt x="86786" y="235612"/>
                  </a:cubicBezTo>
                  <a:cubicBezTo>
                    <a:pt x="60087" y="295686"/>
                    <a:pt x="89735" y="248018"/>
                    <a:pt x="64346" y="286100"/>
                  </a:cubicBezTo>
                  <a:cubicBezTo>
                    <a:pt x="50889" y="326479"/>
                    <a:pt x="67226" y="276026"/>
                    <a:pt x="53127" y="325369"/>
                  </a:cubicBezTo>
                  <a:cubicBezTo>
                    <a:pt x="51502" y="331055"/>
                    <a:pt x="49387" y="336588"/>
                    <a:pt x="47517" y="342198"/>
                  </a:cubicBezTo>
                  <a:cubicBezTo>
                    <a:pt x="45647" y="360897"/>
                    <a:pt x="44695" y="379711"/>
                    <a:pt x="41907" y="398296"/>
                  </a:cubicBezTo>
                  <a:cubicBezTo>
                    <a:pt x="35154" y="443318"/>
                    <a:pt x="34974" y="441537"/>
                    <a:pt x="25078" y="471224"/>
                  </a:cubicBezTo>
                  <a:cubicBezTo>
                    <a:pt x="22652" y="490633"/>
                    <a:pt x="18480" y="528964"/>
                    <a:pt x="13858" y="549762"/>
                  </a:cubicBezTo>
                  <a:cubicBezTo>
                    <a:pt x="12575" y="555534"/>
                    <a:pt x="10118" y="560981"/>
                    <a:pt x="8248" y="566591"/>
                  </a:cubicBezTo>
                  <a:cubicBezTo>
                    <a:pt x="-4240" y="641533"/>
                    <a:pt x="-1151" y="608901"/>
                    <a:pt x="8248" y="740495"/>
                  </a:cubicBezTo>
                  <a:cubicBezTo>
                    <a:pt x="8669" y="746393"/>
                    <a:pt x="11213" y="752036"/>
                    <a:pt x="13858" y="757325"/>
                  </a:cubicBezTo>
                  <a:cubicBezTo>
                    <a:pt x="16873" y="763355"/>
                    <a:pt x="21338" y="768544"/>
                    <a:pt x="25078" y="774154"/>
                  </a:cubicBezTo>
                  <a:cubicBezTo>
                    <a:pt x="39179" y="816458"/>
                    <a:pt x="20158" y="764313"/>
                    <a:pt x="41907" y="807813"/>
                  </a:cubicBezTo>
                  <a:cubicBezTo>
                    <a:pt x="44552" y="813102"/>
                    <a:pt x="44645" y="819474"/>
                    <a:pt x="47517" y="824643"/>
                  </a:cubicBezTo>
                  <a:cubicBezTo>
                    <a:pt x="54065" y="836430"/>
                    <a:pt x="62476" y="847082"/>
                    <a:pt x="69956" y="858301"/>
                  </a:cubicBezTo>
                  <a:cubicBezTo>
                    <a:pt x="81176" y="875131"/>
                    <a:pt x="79305" y="877001"/>
                    <a:pt x="98005" y="886350"/>
                  </a:cubicBezTo>
                  <a:cubicBezTo>
                    <a:pt x="103294" y="888995"/>
                    <a:pt x="108939" y="891506"/>
                    <a:pt x="114835" y="891960"/>
                  </a:cubicBezTo>
                  <a:cubicBezTo>
                    <a:pt x="157757" y="895262"/>
                    <a:pt x="200852" y="895700"/>
                    <a:pt x="243861" y="897570"/>
                  </a:cubicBezTo>
                  <a:cubicBezTo>
                    <a:pt x="286162" y="911671"/>
                    <a:pt x="269831" y="908563"/>
                    <a:pt x="350447" y="897570"/>
                  </a:cubicBezTo>
                  <a:cubicBezTo>
                    <a:pt x="362165" y="895972"/>
                    <a:pt x="384106" y="886350"/>
                    <a:pt x="384106" y="886350"/>
                  </a:cubicBezTo>
                  <a:cubicBezTo>
                    <a:pt x="391586" y="875131"/>
                    <a:pt x="397010" y="862227"/>
                    <a:pt x="406545" y="852692"/>
                  </a:cubicBezTo>
                  <a:cubicBezTo>
                    <a:pt x="412155" y="847082"/>
                    <a:pt x="418296" y="841957"/>
                    <a:pt x="423375" y="835862"/>
                  </a:cubicBezTo>
                  <a:cubicBezTo>
                    <a:pt x="427691" y="830683"/>
                    <a:pt x="431579" y="825063"/>
                    <a:pt x="434594" y="819033"/>
                  </a:cubicBezTo>
                  <a:cubicBezTo>
                    <a:pt x="437239" y="813744"/>
                    <a:pt x="440204" y="802203"/>
                    <a:pt x="440204" y="802203"/>
                  </a:cubicBezTo>
                </a:path>
              </a:pathLst>
            </a:cu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" name="Freeform 178"/>
            <p:cNvSpPr/>
            <p:nvPr/>
          </p:nvSpPr>
          <p:spPr>
            <a:xfrm>
              <a:off x="5800550" y="2961144"/>
              <a:ext cx="618180" cy="887190"/>
            </a:xfrm>
            <a:custGeom>
              <a:avLst/>
              <a:gdLst>
                <a:gd name="connsiteX0" fmla="*/ 22439 w 618180"/>
                <a:gd name="connsiteY0" fmla="*/ 472063 h 887190"/>
                <a:gd name="connsiteX1" fmla="*/ 11219 w 618180"/>
                <a:gd name="connsiteY1" fmla="*/ 444014 h 887190"/>
                <a:gd name="connsiteX2" fmla="*/ 0 w 618180"/>
                <a:gd name="connsiteY2" fmla="*/ 410355 h 887190"/>
                <a:gd name="connsiteX3" fmla="*/ 5610 w 618180"/>
                <a:gd name="connsiteY3" fmla="*/ 382306 h 887190"/>
                <a:gd name="connsiteX4" fmla="*/ 11219 w 618180"/>
                <a:gd name="connsiteY4" fmla="*/ 365477 h 887190"/>
                <a:gd name="connsiteX5" fmla="*/ 33659 w 618180"/>
                <a:gd name="connsiteY5" fmla="*/ 359867 h 887190"/>
                <a:gd name="connsiteX6" fmla="*/ 67317 w 618180"/>
                <a:gd name="connsiteY6" fmla="*/ 348647 h 887190"/>
                <a:gd name="connsiteX7" fmla="*/ 84147 w 618180"/>
                <a:gd name="connsiteY7" fmla="*/ 343038 h 887190"/>
                <a:gd name="connsiteX8" fmla="*/ 117806 w 618180"/>
                <a:gd name="connsiteY8" fmla="*/ 320598 h 887190"/>
                <a:gd name="connsiteX9" fmla="*/ 140245 w 618180"/>
                <a:gd name="connsiteY9" fmla="*/ 270110 h 887190"/>
                <a:gd name="connsiteX10" fmla="*/ 190733 w 618180"/>
                <a:gd name="connsiteY10" fmla="*/ 253281 h 887190"/>
                <a:gd name="connsiteX11" fmla="*/ 207563 w 618180"/>
                <a:gd name="connsiteY11" fmla="*/ 247671 h 887190"/>
                <a:gd name="connsiteX12" fmla="*/ 224392 w 618180"/>
                <a:gd name="connsiteY12" fmla="*/ 242061 h 887190"/>
                <a:gd name="connsiteX13" fmla="*/ 230002 w 618180"/>
                <a:gd name="connsiteY13" fmla="*/ 225231 h 887190"/>
                <a:gd name="connsiteX14" fmla="*/ 207563 w 618180"/>
                <a:gd name="connsiteY14" fmla="*/ 185963 h 887190"/>
                <a:gd name="connsiteX15" fmla="*/ 173904 w 618180"/>
                <a:gd name="connsiteY15" fmla="*/ 174743 h 887190"/>
                <a:gd name="connsiteX16" fmla="*/ 157075 w 618180"/>
                <a:gd name="connsiteY16" fmla="*/ 163523 h 887190"/>
                <a:gd name="connsiteX17" fmla="*/ 140245 w 618180"/>
                <a:gd name="connsiteY17" fmla="*/ 146694 h 887190"/>
                <a:gd name="connsiteX18" fmla="*/ 123416 w 618180"/>
                <a:gd name="connsiteY18" fmla="*/ 141084 h 887190"/>
                <a:gd name="connsiteX19" fmla="*/ 100976 w 618180"/>
                <a:gd name="connsiteY19" fmla="*/ 90596 h 887190"/>
                <a:gd name="connsiteX20" fmla="*/ 95367 w 618180"/>
                <a:gd name="connsiteY20" fmla="*/ 73766 h 887190"/>
                <a:gd name="connsiteX21" fmla="*/ 100976 w 618180"/>
                <a:gd name="connsiteY21" fmla="*/ 17668 h 887190"/>
                <a:gd name="connsiteX22" fmla="*/ 112196 w 618180"/>
                <a:gd name="connsiteY22" fmla="*/ 839 h 887190"/>
                <a:gd name="connsiteX23" fmla="*/ 185124 w 618180"/>
                <a:gd name="connsiteY23" fmla="*/ 6449 h 887190"/>
                <a:gd name="connsiteX24" fmla="*/ 218783 w 618180"/>
                <a:gd name="connsiteY24" fmla="*/ 17668 h 887190"/>
                <a:gd name="connsiteX25" fmla="*/ 235612 w 618180"/>
                <a:gd name="connsiteY25" fmla="*/ 23278 h 887190"/>
                <a:gd name="connsiteX26" fmla="*/ 286100 w 618180"/>
                <a:gd name="connsiteY26" fmla="*/ 45717 h 887190"/>
                <a:gd name="connsiteX27" fmla="*/ 319759 w 618180"/>
                <a:gd name="connsiteY27" fmla="*/ 56937 h 887190"/>
                <a:gd name="connsiteX28" fmla="*/ 336589 w 618180"/>
                <a:gd name="connsiteY28" fmla="*/ 62547 h 887190"/>
                <a:gd name="connsiteX29" fmla="*/ 381467 w 618180"/>
                <a:gd name="connsiteY29" fmla="*/ 101816 h 887190"/>
                <a:gd name="connsiteX30" fmla="*/ 398297 w 618180"/>
                <a:gd name="connsiteY30" fmla="*/ 113035 h 887190"/>
                <a:gd name="connsiteX31" fmla="*/ 409516 w 618180"/>
                <a:gd name="connsiteY31" fmla="*/ 129865 h 887190"/>
                <a:gd name="connsiteX32" fmla="*/ 443175 w 618180"/>
                <a:gd name="connsiteY32" fmla="*/ 141084 h 887190"/>
                <a:gd name="connsiteX33" fmla="*/ 460005 w 618180"/>
                <a:gd name="connsiteY33" fmla="*/ 157914 h 887190"/>
                <a:gd name="connsiteX34" fmla="*/ 493663 w 618180"/>
                <a:gd name="connsiteY34" fmla="*/ 180353 h 887190"/>
                <a:gd name="connsiteX35" fmla="*/ 521713 w 618180"/>
                <a:gd name="connsiteY35" fmla="*/ 208402 h 887190"/>
                <a:gd name="connsiteX36" fmla="*/ 538542 w 618180"/>
                <a:gd name="connsiteY36" fmla="*/ 242061 h 887190"/>
                <a:gd name="connsiteX37" fmla="*/ 549762 w 618180"/>
                <a:gd name="connsiteY37" fmla="*/ 258890 h 887190"/>
                <a:gd name="connsiteX38" fmla="*/ 566591 w 618180"/>
                <a:gd name="connsiteY38" fmla="*/ 292549 h 887190"/>
                <a:gd name="connsiteX39" fmla="*/ 577811 w 618180"/>
                <a:gd name="connsiteY39" fmla="*/ 326208 h 887190"/>
                <a:gd name="connsiteX40" fmla="*/ 589030 w 618180"/>
                <a:gd name="connsiteY40" fmla="*/ 371087 h 887190"/>
                <a:gd name="connsiteX41" fmla="*/ 594640 w 618180"/>
                <a:gd name="connsiteY41" fmla="*/ 387916 h 887190"/>
                <a:gd name="connsiteX42" fmla="*/ 605860 w 618180"/>
                <a:gd name="connsiteY42" fmla="*/ 438404 h 887190"/>
                <a:gd name="connsiteX43" fmla="*/ 611470 w 618180"/>
                <a:gd name="connsiteY43" fmla="*/ 455234 h 887190"/>
                <a:gd name="connsiteX44" fmla="*/ 611470 w 618180"/>
                <a:gd name="connsiteY44" fmla="*/ 640358 h 887190"/>
                <a:gd name="connsiteX45" fmla="*/ 605860 w 618180"/>
                <a:gd name="connsiteY45" fmla="*/ 657187 h 887190"/>
                <a:gd name="connsiteX46" fmla="*/ 600250 w 618180"/>
                <a:gd name="connsiteY46" fmla="*/ 690846 h 887190"/>
                <a:gd name="connsiteX47" fmla="*/ 594640 w 618180"/>
                <a:gd name="connsiteY47" fmla="*/ 780603 h 887190"/>
                <a:gd name="connsiteX48" fmla="*/ 583421 w 618180"/>
                <a:gd name="connsiteY48" fmla="*/ 814262 h 887190"/>
                <a:gd name="connsiteX49" fmla="*/ 572201 w 618180"/>
                <a:gd name="connsiteY49" fmla="*/ 853531 h 887190"/>
                <a:gd name="connsiteX50" fmla="*/ 521713 w 618180"/>
                <a:gd name="connsiteY50" fmla="*/ 881580 h 887190"/>
                <a:gd name="connsiteX51" fmla="*/ 353418 w 618180"/>
                <a:gd name="connsiteY51" fmla="*/ 887190 h 887190"/>
                <a:gd name="connsiteX52" fmla="*/ 235612 w 618180"/>
                <a:gd name="connsiteY52" fmla="*/ 881580 h 887190"/>
                <a:gd name="connsiteX53" fmla="*/ 201953 w 618180"/>
                <a:gd name="connsiteY53" fmla="*/ 859141 h 887190"/>
                <a:gd name="connsiteX54" fmla="*/ 185124 w 618180"/>
                <a:gd name="connsiteY54" fmla="*/ 853531 h 887190"/>
                <a:gd name="connsiteX55" fmla="*/ 151465 w 618180"/>
                <a:gd name="connsiteY55" fmla="*/ 831092 h 887190"/>
                <a:gd name="connsiteX56" fmla="*/ 145855 w 618180"/>
                <a:gd name="connsiteY56" fmla="*/ 814262 h 8871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</a:cxnLst>
              <a:rect l="l" t="t" r="r" b="b"/>
              <a:pathLst>
                <a:path w="618180" h="887190">
                  <a:moveTo>
                    <a:pt x="22439" y="472063"/>
                  </a:moveTo>
                  <a:cubicBezTo>
                    <a:pt x="18699" y="462713"/>
                    <a:pt x="14660" y="453478"/>
                    <a:pt x="11219" y="444014"/>
                  </a:cubicBezTo>
                  <a:cubicBezTo>
                    <a:pt x="7177" y="432900"/>
                    <a:pt x="0" y="410355"/>
                    <a:pt x="0" y="410355"/>
                  </a:cubicBezTo>
                  <a:cubicBezTo>
                    <a:pt x="1870" y="401005"/>
                    <a:pt x="3298" y="391556"/>
                    <a:pt x="5610" y="382306"/>
                  </a:cubicBezTo>
                  <a:cubicBezTo>
                    <a:pt x="7044" y="376569"/>
                    <a:pt x="6602" y="369171"/>
                    <a:pt x="11219" y="365477"/>
                  </a:cubicBezTo>
                  <a:cubicBezTo>
                    <a:pt x="17240" y="360660"/>
                    <a:pt x="26274" y="362083"/>
                    <a:pt x="33659" y="359867"/>
                  </a:cubicBezTo>
                  <a:cubicBezTo>
                    <a:pt x="44986" y="356469"/>
                    <a:pt x="56098" y="352387"/>
                    <a:pt x="67317" y="348647"/>
                  </a:cubicBezTo>
                  <a:lnTo>
                    <a:pt x="84147" y="343038"/>
                  </a:lnTo>
                  <a:cubicBezTo>
                    <a:pt x="95367" y="335558"/>
                    <a:pt x="113542" y="333391"/>
                    <a:pt x="117806" y="320598"/>
                  </a:cubicBezTo>
                  <a:cubicBezTo>
                    <a:pt x="119668" y="315011"/>
                    <a:pt x="129014" y="277129"/>
                    <a:pt x="140245" y="270110"/>
                  </a:cubicBezTo>
                  <a:cubicBezTo>
                    <a:pt x="140253" y="270105"/>
                    <a:pt x="182314" y="256087"/>
                    <a:pt x="190733" y="253281"/>
                  </a:cubicBezTo>
                  <a:lnTo>
                    <a:pt x="207563" y="247671"/>
                  </a:lnTo>
                  <a:lnTo>
                    <a:pt x="224392" y="242061"/>
                  </a:lnTo>
                  <a:cubicBezTo>
                    <a:pt x="226262" y="236451"/>
                    <a:pt x="230002" y="231144"/>
                    <a:pt x="230002" y="225231"/>
                  </a:cubicBezTo>
                  <a:cubicBezTo>
                    <a:pt x="230002" y="208905"/>
                    <a:pt x="222091" y="194034"/>
                    <a:pt x="207563" y="185963"/>
                  </a:cubicBezTo>
                  <a:cubicBezTo>
                    <a:pt x="197225" y="180219"/>
                    <a:pt x="183744" y="181303"/>
                    <a:pt x="173904" y="174743"/>
                  </a:cubicBezTo>
                  <a:cubicBezTo>
                    <a:pt x="168294" y="171003"/>
                    <a:pt x="162254" y="167839"/>
                    <a:pt x="157075" y="163523"/>
                  </a:cubicBezTo>
                  <a:cubicBezTo>
                    <a:pt x="150980" y="158444"/>
                    <a:pt x="146846" y="151095"/>
                    <a:pt x="140245" y="146694"/>
                  </a:cubicBezTo>
                  <a:cubicBezTo>
                    <a:pt x="135325" y="143414"/>
                    <a:pt x="129026" y="142954"/>
                    <a:pt x="123416" y="141084"/>
                  </a:cubicBezTo>
                  <a:cubicBezTo>
                    <a:pt x="105637" y="114416"/>
                    <a:pt x="114326" y="130648"/>
                    <a:pt x="100976" y="90596"/>
                  </a:cubicBezTo>
                  <a:lnTo>
                    <a:pt x="95367" y="73766"/>
                  </a:lnTo>
                  <a:cubicBezTo>
                    <a:pt x="97237" y="55067"/>
                    <a:pt x="96750" y="35979"/>
                    <a:pt x="100976" y="17668"/>
                  </a:cubicBezTo>
                  <a:cubicBezTo>
                    <a:pt x="102492" y="11099"/>
                    <a:pt x="105513" y="1730"/>
                    <a:pt x="112196" y="839"/>
                  </a:cubicBezTo>
                  <a:cubicBezTo>
                    <a:pt x="136363" y="-2383"/>
                    <a:pt x="160815" y="4579"/>
                    <a:pt x="185124" y="6449"/>
                  </a:cubicBezTo>
                  <a:lnTo>
                    <a:pt x="218783" y="17668"/>
                  </a:lnTo>
                  <a:cubicBezTo>
                    <a:pt x="224393" y="19538"/>
                    <a:pt x="230692" y="19998"/>
                    <a:pt x="235612" y="23278"/>
                  </a:cubicBezTo>
                  <a:cubicBezTo>
                    <a:pt x="262282" y="41059"/>
                    <a:pt x="246044" y="32366"/>
                    <a:pt x="286100" y="45717"/>
                  </a:cubicBezTo>
                  <a:lnTo>
                    <a:pt x="319759" y="56937"/>
                  </a:lnTo>
                  <a:lnTo>
                    <a:pt x="336589" y="62547"/>
                  </a:lnTo>
                  <a:cubicBezTo>
                    <a:pt x="355287" y="90595"/>
                    <a:pt x="342200" y="75638"/>
                    <a:pt x="381467" y="101816"/>
                  </a:cubicBezTo>
                  <a:lnTo>
                    <a:pt x="398297" y="113035"/>
                  </a:lnTo>
                  <a:cubicBezTo>
                    <a:pt x="402037" y="118645"/>
                    <a:pt x="403799" y="126292"/>
                    <a:pt x="409516" y="129865"/>
                  </a:cubicBezTo>
                  <a:cubicBezTo>
                    <a:pt x="419545" y="136133"/>
                    <a:pt x="443175" y="141084"/>
                    <a:pt x="443175" y="141084"/>
                  </a:cubicBezTo>
                  <a:cubicBezTo>
                    <a:pt x="448785" y="146694"/>
                    <a:pt x="453743" y="153043"/>
                    <a:pt x="460005" y="157914"/>
                  </a:cubicBezTo>
                  <a:cubicBezTo>
                    <a:pt x="470649" y="166192"/>
                    <a:pt x="493663" y="180353"/>
                    <a:pt x="493663" y="180353"/>
                  </a:cubicBezTo>
                  <a:cubicBezTo>
                    <a:pt x="523585" y="225233"/>
                    <a:pt x="484311" y="171000"/>
                    <a:pt x="521713" y="208402"/>
                  </a:cubicBezTo>
                  <a:cubicBezTo>
                    <a:pt x="537789" y="224478"/>
                    <a:pt x="529417" y="223811"/>
                    <a:pt x="538542" y="242061"/>
                  </a:cubicBezTo>
                  <a:cubicBezTo>
                    <a:pt x="541557" y="248091"/>
                    <a:pt x="546022" y="253280"/>
                    <a:pt x="549762" y="258890"/>
                  </a:cubicBezTo>
                  <a:cubicBezTo>
                    <a:pt x="570210" y="320245"/>
                    <a:pt x="537603" y="227327"/>
                    <a:pt x="566591" y="292549"/>
                  </a:cubicBezTo>
                  <a:cubicBezTo>
                    <a:pt x="571394" y="303356"/>
                    <a:pt x="574943" y="314734"/>
                    <a:pt x="577811" y="326208"/>
                  </a:cubicBezTo>
                  <a:cubicBezTo>
                    <a:pt x="581551" y="341168"/>
                    <a:pt x="584154" y="356458"/>
                    <a:pt x="589030" y="371087"/>
                  </a:cubicBezTo>
                  <a:cubicBezTo>
                    <a:pt x="590900" y="376697"/>
                    <a:pt x="593015" y="382230"/>
                    <a:pt x="594640" y="387916"/>
                  </a:cubicBezTo>
                  <a:cubicBezTo>
                    <a:pt x="606156" y="428221"/>
                    <a:pt x="594294" y="392140"/>
                    <a:pt x="605860" y="438404"/>
                  </a:cubicBezTo>
                  <a:cubicBezTo>
                    <a:pt x="607294" y="444141"/>
                    <a:pt x="609600" y="449624"/>
                    <a:pt x="611470" y="455234"/>
                  </a:cubicBezTo>
                  <a:cubicBezTo>
                    <a:pt x="620142" y="541969"/>
                    <a:pt x="620689" y="520502"/>
                    <a:pt x="611470" y="640358"/>
                  </a:cubicBezTo>
                  <a:cubicBezTo>
                    <a:pt x="611017" y="646254"/>
                    <a:pt x="607730" y="651577"/>
                    <a:pt x="605860" y="657187"/>
                  </a:cubicBezTo>
                  <a:cubicBezTo>
                    <a:pt x="603990" y="668407"/>
                    <a:pt x="601280" y="679518"/>
                    <a:pt x="600250" y="690846"/>
                  </a:cubicBezTo>
                  <a:cubicBezTo>
                    <a:pt x="597536" y="720700"/>
                    <a:pt x="598690" y="750900"/>
                    <a:pt x="594640" y="780603"/>
                  </a:cubicBezTo>
                  <a:cubicBezTo>
                    <a:pt x="593042" y="792321"/>
                    <a:pt x="586289" y="802789"/>
                    <a:pt x="583421" y="814262"/>
                  </a:cubicBezTo>
                  <a:cubicBezTo>
                    <a:pt x="583372" y="814456"/>
                    <a:pt x="574883" y="850849"/>
                    <a:pt x="572201" y="853531"/>
                  </a:cubicBezTo>
                  <a:cubicBezTo>
                    <a:pt x="566924" y="858808"/>
                    <a:pt x="536731" y="880670"/>
                    <a:pt x="521713" y="881580"/>
                  </a:cubicBezTo>
                  <a:cubicBezTo>
                    <a:pt x="465686" y="884976"/>
                    <a:pt x="409516" y="885320"/>
                    <a:pt x="353418" y="887190"/>
                  </a:cubicBezTo>
                  <a:cubicBezTo>
                    <a:pt x="314149" y="885320"/>
                    <a:pt x="274268" y="888738"/>
                    <a:pt x="235612" y="881580"/>
                  </a:cubicBezTo>
                  <a:cubicBezTo>
                    <a:pt x="222353" y="879125"/>
                    <a:pt x="214745" y="863405"/>
                    <a:pt x="201953" y="859141"/>
                  </a:cubicBezTo>
                  <a:cubicBezTo>
                    <a:pt x="196343" y="857271"/>
                    <a:pt x="190293" y="856403"/>
                    <a:pt x="185124" y="853531"/>
                  </a:cubicBezTo>
                  <a:cubicBezTo>
                    <a:pt x="173337" y="846982"/>
                    <a:pt x="151465" y="831092"/>
                    <a:pt x="151465" y="831092"/>
                  </a:cubicBezTo>
                  <a:lnTo>
                    <a:pt x="145855" y="814262"/>
                  </a:lnTo>
                </a:path>
              </a:pathLst>
            </a:cu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80" name="Group 76"/>
            <p:cNvGrpSpPr/>
            <p:nvPr/>
          </p:nvGrpSpPr>
          <p:grpSpPr>
            <a:xfrm>
              <a:off x="5682744" y="2103681"/>
              <a:ext cx="100976" cy="3130277"/>
              <a:chOff x="5682744" y="2103681"/>
              <a:chExt cx="100976" cy="3130277"/>
            </a:xfrm>
          </p:grpSpPr>
          <p:sp>
            <p:nvSpPr>
              <p:cNvPr id="196" name="Freeform 195"/>
              <p:cNvSpPr/>
              <p:nvPr/>
            </p:nvSpPr>
            <p:spPr>
              <a:xfrm>
                <a:off x="5733213" y="2103681"/>
                <a:ext cx="50507" cy="1525870"/>
              </a:xfrm>
              <a:custGeom>
                <a:avLst/>
                <a:gdLst>
                  <a:gd name="connsiteX0" fmla="*/ 33678 w 50507"/>
                  <a:gd name="connsiteY0" fmla="*/ 0 h 1525870"/>
                  <a:gd name="connsiteX1" fmla="*/ 39288 w 50507"/>
                  <a:gd name="connsiteY1" fmla="*/ 61708 h 1525870"/>
                  <a:gd name="connsiteX2" fmla="*/ 50507 w 50507"/>
                  <a:gd name="connsiteY2" fmla="*/ 100977 h 1525870"/>
                  <a:gd name="connsiteX3" fmla="*/ 44897 w 50507"/>
                  <a:gd name="connsiteY3" fmla="*/ 415126 h 1525870"/>
                  <a:gd name="connsiteX4" fmla="*/ 33678 w 50507"/>
                  <a:gd name="connsiteY4" fmla="*/ 448785 h 1525870"/>
                  <a:gd name="connsiteX5" fmla="*/ 16848 w 50507"/>
                  <a:gd name="connsiteY5" fmla="*/ 504883 h 1525870"/>
                  <a:gd name="connsiteX6" fmla="*/ 5629 w 50507"/>
                  <a:gd name="connsiteY6" fmla="*/ 583421 h 1525870"/>
                  <a:gd name="connsiteX7" fmla="*/ 5629 w 50507"/>
                  <a:gd name="connsiteY7" fmla="*/ 858302 h 1525870"/>
                  <a:gd name="connsiteX8" fmla="*/ 11239 w 50507"/>
                  <a:gd name="connsiteY8" fmla="*/ 875131 h 1525870"/>
                  <a:gd name="connsiteX9" fmla="*/ 22458 w 50507"/>
                  <a:gd name="connsiteY9" fmla="*/ 942449 h 1525870"/>
                  <a:gd name="connsiteX10" fmla="*/ 33678 w 50507"/>
                  <a:gd name="connsiteY10" fmla="*/ 1043426 h 1525870"/>
                  <a:gd name="connsiteX11" fmla="*/ 28068 w 50507"/>
                  <a:gd name="connsiteY11" fmla="*/ 1245379 h 1525870"/>
                  <a:gd name="connsiteX12" fmla="*/ 22458 w 50507"/>
                  <a:gd name="connsiteY12" fmla="*/ 1279038 h 1525870"/>
                  <a:gd name="connsiteX13" fmla="*/ 28068 w 50507"/>
                  <a:gd name="connsiteY13" fmla="*/ 1424893 h 1525870"/>
                  <a:gd name="connsiteX14" fmla="*/ 28068 w 50507"/>
                  <a:gd name="connsiteY14" fmla="*/ 1525870 h 15258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50507" h="1525870">
                    <a:moveTo>
                      <a:pt x="33678" y="0"/>
                    </a:moveTo>
                    <a:cubicBezTo>
                      <a:pt x="35548" y="20569"/>
                      <a:pt x="36558" y="41235"/>
                      <a:pt x="39288" y="61708"/>
                    </a:cubicBezTo>
                    <a:cubicBezTo>
                      <a:pt x="40854" y="73452"/>
                      <a:pt x="46660" y="89436"/>
                      <a:pt x="50507" y="100977"/>
                    </a:cubicBezTo>
                    <a:cubicBezTo>
                      <a:pt x="48637" y="205693"/>
                      <a:pt x="49959" y="310515"/>
                      <a:pt x="44897" y="415126"/>
                    </a:cubicBezTo>
                    <a:cubicBezTo>
                      <a:pt x="44325" y="426939"/>
                      <a:pt x="37418" y="437565"/>
                      <a:pt x="33678" y="448785"/>
                    </a:cubicBezTo>
                    <a:cubicBezTo>
                      <a:pt x="27578" y="467086"/>
                      <a:pt x="20039" y="485734"/>
                      <a:pt x="16848" y="504883"/>
                    </a:cubicBezTo>
                    <a:cubicBezTo>
                      <a:pt x="12501" y="530968"/>
                      <a:pt x="5629" y="583421"/>
                      <a:pt x="5629" y="583421"/>
                    </a:cubicBezTo>
                    <a:cubicBezTo>
                      <a:pt x="827" y="713070"/>
                      <a:pt x="-4176" y="735741"/>
                      <a:pt x="5629" y="858302"/>
                    </a:cubicBezTo>
                    <a:cubicBezTo>
                      <a:pt x="6101" y="864196"/>
                      <a:pt x="9805" y="869394"/>
                      <a:pt x="11239" y="875131"/>
                    </a:cubicBezTo>
                    <a:cubicBezTo>
                      <a:pt x="15564" y="892432"/>
                      <a:pt x="20876" y="926627"/>
                      <a:pt x="22458" y="942449"/>
                    </a:cubicBezTo>
                    <a:cubicBezTo>
                      <a:pt x="32604" y="1043907"/>
                      <a:pt x="21798" y="984030"/>
                      <a:pt x="33678" y="1043426"/>
                    </a:cubicBezTo>
                    <a:cubicBezTo>
                      <a:pt x="31808" y="1110744"/>
                      <a:pt x="31271" y="1178112"/>
                      <a:pt x="28068" y="1245379"/>
                    </a:cubicBezTo>
                    <a:cubicBezTo>
                      <a:pt x="27527" y="1256741"/>
                      <a:pt x="22458" y="1267664"/>
                      <a:pt x="22458" y="1279038"/>
                    </a:cubicBezTo>
                    <a:cubicBezTo>
                      <a:pt x="22458" y="1327692"/>
                      <a:pt x="26962" y="1376251"/>
                      <a:pt x="28068" y="1424893"/>
                    </a:cubicBezTo>
                    <a:cubicBezTo>
                      <a:pt x="28833" y="1458543"/>
                      <a:pt x="28068" y="1492211"/>
                      <a:pt x="28068" y="1525870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7" name="Freeform 196"/>
              <p:cNvSpPr/>
              <p:nvPr/>
            </p:nvSpPr>
            <p:spPr>
              <a:xfrm>
                <a:off x="5682744" y="4392486"/>
                <a:ext cx="67317" cy="841472"/>
              </a:xfrm>
              <a:custGeom>
                <a:avLst/>
                <a:gdLst>
                  <a:gd name="connsiteX0" fmla="*/ 67317 w 67317"/>
                  <a:gd name="connsiteY0" fmla="*/ 0 h 841472"/>
                  <a:gd name="connsiteX1" fmla="*/ 61708 w 67317"/>
                  <a:gd name="connsiteY1" fmla="*/ 28049 h 841472"/>
                  <a:gd name="connsiteX2" fmla="*/ 56098 w 67317"/>
                  <a:gd name="connsiteY2" fmla="*/ 50488 h 841472"/>
                  <a:gd name="connsiteX3" fmla="*/ 50488 w 67317"/>
                  <a:gd name="connsiteY3" fmla="*/ 134635 h 841472"/>
                  <a:gd name="connsiteX4" fmla="*/ 44878 w 67317"/>
                  <a:gd name="connsiteY4" fmla="*/ 157075 h 841472"/>
                  <a:gd name="connsiteX5" fmla="*/ 33658 w 67317"/>
                  <a:gd name="connsiteY5" fmla="*/ 190734 h 841472"/>
                  <a:gd name="connsiteX6" fmla="*/ 22439 w 67317"/>
                  <a:gd name="connsiteY6" fmla="*/ 420736 h 841472"/>
                  <a:gd name="connsiteX7" fmla="*/ 16829 w 67317"/>
                  <a:gd name="connsiteY7" fmla="*/ 460005 h 841472"/>
                  <a:gd name="connsiteX8" fmla="*/ 0 w 67317"/>
                  <a:gd name="connsiteY8" fmla="*/ 577811 h 841472"/>
                  <a:gd name="connsiteX9" fmla="*/ 5609 w 67317"/>
                  <a:gd name="connsiteY9" fmla="*/ 678788 h 841472"/>
                  <a:gd name="connsiteX10" fmla="*/ 22439 w 67317"/>
                  <a:gd name="connsiteY10" fmla="*/ 729276 h 841472"/>
                  <a:gd name="connsiteX11" fmla="*/ 28049 w 67317"/>
                  <a:gd name="connsiteY11" fmla="*/ 746105 h 841472"/>
                  <a:gd name="connsiteX12" fmla="*/ 22439 w 67317"/>
                  <a:gd name="connsiteY12" fmla="*/ 841472 h 84147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67317" h="841472">
                    <a:moveTo>
                      <a:pt x="67317" y="0"/>
                    </a:moveTo>
                    <a:cubicBezTo>
                      <a:pt x="65447" y="9350"/>
                      <a:pt x="63776" y="18741"/>
                      <a:pt x="61708" y="28049"/>
                    </a:cubicBezTo>
                    <a:cubicBezTo>
                      <a:pt x="60036" y="35575"/>
                      <a:pt x="56905" y="42820"/>
                      <a:pt x="56098" y="50488"/>
                    </a:cubicBezTo>
                    <a:cubicBezTo>
                      <a:pt x="53155" y="78445"/>
                      <a:pt x="53431" y="106678"/>
                      <a:pt x="50488" y="134635"/>
                    </a:cubicBezTo>
                    <a:cubicBezTo>
                      <a:pt x="49681" y="142303"/>
                      <a:pt x="47094" y="149690"/>
                      <a:pt x="44878" y="157075"/>
                    </a:cubicBezTo>
                    <a:cubicBezTo>
                      <a:pt x="41480" y="168403"/>
                      <a:pt x="33658" y="190734"/>
                      <a:pt x="33658" y="190734"/>
                    </a:cubicBezTo>
                    <a:cubicBezTo>
                      <a:pt x="19414" y="347446"/>
                      <a:pt x="38397" y="125528"/>
                      <a:pt x="22439" y="420736"/>
                    </a:cubicBezTo>
                    <a:cubicBezTo>
                      <a:pt x="21725" y="433939"/>
                      <a:pt x="18539" y="446894"/>
                      <a:pt x="16829" y="460005"/>
                    </a:cubicBezTo>
                    <a:cubicBezTo>
                      <a:pt x="2876" y="566978"/>
                      <a:pt x="12012" y="517743"/>
                      <a:pt x="0" y="577811"/>
                    </a:cubicBezTo>
                    <a:cubicBezTo>
                      <a:pt x="1870" y="611470"/>
                      <a:pt x="1428" y="645337"/>
                      <a:pt x="5609" y="678788"/>
                    </a:cubicBezTo>
                    <a:cubicBezTo>
                      <a:pt x="5609" y="678790"/>
                      <a:pt x="19634" y="720860"/>
                      <a:pt x="22439" y="729276"/>
                    </a:cubicBezTo>
                    <a:lnTo>
                      <a:pt x="28049" y="746105"/>
                    </a:lnTo>
                    <a:lnTo>
                      <a:pt x="22439" y="841472"/>
                    </a:ln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8" name="Freeform 197"/>
              <p:cNvSpPr/>
              <p:nvPr/>
            </p:nvSpPr>
            <p:spPr>
              <a:xfrm>
                <a:off x="5749939" y="3612721"/>
                <a:ext cx="11342" cy="173905"/>
              </a:xfrm>
              <a:custGeom>
                <a:avLst/>
                <a:gdLst>
                  <a:gd name="connsiteX0" fmla="*/ 11342 w 11342"/>
                  <a:gd name="connsiteY0" fmla="*/ 0 h 173905"/>
                  <a:gd name="connsiteX1" fmla="*/ 5732 w 11342"/>
                  <a:gd name="connsiteY1" fmla="*/ 84148 h 173905"/>
                  <a:gd name="connsiteX2" fmla="*/ 122 w 11342"/>
                  <a:gd name="connsiteY2" fmla="*/ 173905 h 1739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342" h="173905">
                    <a:moveTo>
                      <a:pt x="11342" y="0"/>
                    </a:moveTo>
                    <a:cubicBezTo>
                      <a:pt x="9472" y="28049"/>
                      <a:pt x="8067" y="56134"/>
                      <a:pt x="5732" y="84148"/>
                    </a:cubicBezTo>
                    <a:cubicBezTo>
                      <a:pt x="-1324" y="168812"/>
                      <a:pt x="122" y="101341"/>
                      <a:pt x="122" y="173905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9" name="Freeform 198"/>
              <p:cNvSpPr/>
              <p:nvPr/>
            </p:nvSpPr>
            <p:spPr>
              <a:xfrm>
                <a:off x="5720288" y="3769796"/>
                <a:ext cx="29773" cy="645129"/>
              </a:xfrm>
              <a:custGeom>
                <a:avLst/>
                <a:gdLst>
                  <a:gd name="connsiteX0" fmla="*/ 29773 w 29773"/>
                  <a:gd name="connsiteY0" fmla="*/ 0 h 645129"/>
                  <a:gd name="connsiteX1" fmla="*/ 24164 w 29773"/>
                  <a:gd name="connsiteY1" fmla="*/ 117806 h 645129"/>
                  <a:gd name="connsiteX2" fmla="*/ 7334 w 29773"/>
                  <a:gd name="connsiteY2" fmla="*/ 190734 h 645129"/>
                  <a:gd name="connsiteX3" fmla="*/ 7334 w 29773"/>
                  <a:gd name="connsiteY3" fmla="*/ 381468 h 645129"/>
                  <a:gd name="connsiteX4" fmla="*/ 18554 w 29773"/>
                  <a:gd name="connsiteY4" fmla="*/ 465615 h 645129"/>
                  <a:gd name="connsiteX5" fmla="*/ 18554 w 29773"/>
                  <a:gd name="connsiteY5" fmla="*/ 645129 h 6451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29773" h="645129">
                    <a:moveTo>
                      <a:pt x="29773" y="0"/>
                    </a:moveTo>
                    <a:cubicBezTo>
                      <a:pt x="27903" y="39269"/>
                      <a:pt x="27951" y="78676"/>
                      <a:pt x="24164" y="117806"/>
                    </a:cubicBezTo>
                    <a:cubicBezTo>
                      <a:pt x="20788" y="152694"/>
                      <a:pt x="16183" y="164188"/>
                      <a:pt x="7334" y="190734"/>
                    </a:cubicBezTo>
                    <a:cubicBezTo>
                      <a:pt x="-3567" y="277942"/>
                      <a:pt x="-1255" y="239747"/>
                      <a:pt x="7334" y="381468"/>
                    </a:cubicBezTo>
                    <a:cubicBezTo>
                      <a:pt x="9547" y="417980"/>
                      <a:pt x="17608" y="427776"/>
                      <a:pt x="18554" y="465615"/>
                    </a:cubicBezTo>
                    <a:cubicBezTo>
                      <a:pt x="20050" y="525434"/>
                      <a:pt x="18554" y="585291"/>
                      <a:pt x="18554" y="645129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81" name="Freeform 180"/>
            <p:cNvSpPr/>
            <p:nvPr/>
          </p:nvSpPr>
          <p:spPr>
            <a:xfrm>
              <a:off x="5463759" y="3421985"/>
              <a:ext cx="589427" cy="370251"/>
            </a:xfrm>
            <a:custGeom>
              <a:avLst/>
              <a:gdLst>
                <a:gd name="connsiteX0" fmla="*/ 275083 w 589427"/>
                <a:gd name="connsiteY0" fmla="*/ 230005 h 370251"/>
                <a:gd name="connsiteX1" fmla="*/ 252643 w 589427"/>
                <a:gd name="connsiteY1" fmla="*/ 201956 h 370251"/>
                <a:gd name="connsiteX2" fmla="*/ 258253 w 589427"/>
                <a:gd name="connsiteY2" fmla="*/ 84150 h 370251"/>
                <a:gd name="connsiteX3" fmla="*/ 252643 w 589427"/>
                <a:gd name="connsiteY3" fmla="*/ 50491 h 370251"/>
                <a:gd name="connsiteX4" fmla="*/ 207765 w 589427"/>
                <a:gd name="connsiteY4" fmla="*/ 11222 h 370251"/>
                <a:gd name="connsiteX5" fmla="*/ 174106 w 589427"/>
                <a:gd name="connsiteY5" fmla="*/ 3 h 370251"/>
                <a:gd name="connsiteX6" fmla="*/ 67520 w 589427"/>
                <a:gd name="connsiteY6" fmla="*/ 11222 h 370251"/>
                <a:gd name="connsiteX7" fmla="*/ 50690 w 589427"/>
                <a:gd name="connsiteY7" fmla="*/ 22442 h 370251"/>
                <a:gd name="connsiteX8" fmla="*/ 22641 w 589427"/>
                <a:gd name="connsiteY8" fmla="*/ 56101 h 370251"/>
                <a:gd name="connsiteX9" fmla="*/ 11421 w 589427"/>
                <a:gd name="connsiteY9" fmla="*/ 72930 h 370251"/>
                <a:gd name="connsiteX10" fmla="*/ 202 w 589427"/>
                <a:gd name="connsiteY10" fmla="*/ 106589 h 370251"/>
                <a:gd name="connsiteX11" fmla="*/ 11421 w 589427"/>
                <a:gd name="connsiteY11" fmla="*/ 162687 h 370251"/>
                <a:gd name="connsiteX12" fmla="*/ 22641 w 589427"/>
                <a:gd name="connsiteY12" fmla="*/ 179517 h 370251"/>
                <a:gd name="connsiteX13" fmla="*/ 28251 w 589427"/>
                <a:gd name="connsiteY13" fmla="*/ 196346 h 370251"/>
                <a:gd name="connsiteX14" fmla="*/ 39470 w 589427"/>
                <a:gd name="connsiteY14" fmla="*/ 213176 h 370251"/>
                <a:gd name="connsiteX15" fmla="*/ 45080 w 589427"/>
                <a:gd name="connsiteY15" fmla="*/ 230005 h 370251"/>
                <a:gd name="connsiteX16" fmla="*/ 67520 w 589427"/>
                <a:gd name="connsiteY16" fmla="*/ 263664 h 370251"/>
                <a:gd name="connsiteX17" fmla="*/ 78739 w 589427"/>
                <a:gd name="connsiteY17" fmla="*/ 280494 h 370251"/>
                <a:gd name="connsiteX18" fmla="*/ 95569 w 589427"/>
                <a:gd name="connsiteY18" fmla="*/ 291713 h 370251"/>
                <a:gd name="connsiteX19" fmla="*/ 106788 w 589427"/>
                <a:gd name="connsiteY19" fmla="*/ 308543 h 370251"/>
                <a:gd name="connsiteX20" fmla="*/ 140447 w 589427"/>
                <a:gd name="connsiteY20" fmla="*/ 330982 h 370251"/>
                <a:gd name="connsiteX21" fmla="*/ 157277 w 589427"/>
                <a:gd name="connsiteY21" fmla="*/ 342202 h 370251"/>
                <a:gd name="connsiteX22" fmla="*/ 174106 w 589427"/>
                <a:gd name="connsiteY22" fmla="*/ 353421 h 370251"/>
                <a:gd name="connsiteX23" fmla="*/ 190935 w 589427"/>
                <a:gd name="connsiteY23" fmla="*/ 364641 h 370251"/>
                <a:gd name="connsiteX24" fmla="*/ 241424 w 589427"/>
                <a:gd name="connsiteY24" fmla="*/ 359031 h 370251"/>
                <a:gd name="connsiteX25" fmla="*/ 258253 w 589427"/>
                <a:gd name="connsiteY25" fmla="*/ 353421 h 370251"/>
                <a:gd name="connsiteX26" fmla="*/ 263863 w 589427"/>
                <a:gd name="connsiteY26" fmla="*/ 336592 h 370251"/>
                <a:gd name="connsiteX27" fmla="*/ 297522 w 589427"/>
                <a:gd name="connsiteY27" fmla="*/ 325372 h 370251"/>
                <a:gd name="connsiteX28" fmla="*/ 348010 w 589427"/>
                <a:gd name="connsiteY28" fmla="*/ 364641 h 370251"/>
                <a:gd name="connsiteX29" fmla="*/ 364840 w 589427"/>
                <a:gd name="connsiteY29" fmla="*/ 370251 h 370251"/>
                <a:gd name="connsiteX30" fmla="*/ 432158 w 589427"/>
                <a:gd name="connsiteY30" fmla="*/ 364641 h 370251"/>
                <a:gd name="connsiteX31" fmla="*/ 443377 w 589427"/>
                <a:gd name="connsiteY31" fmla="*/ 347811 h 370251"/>
                <a:gd name="connsiteX32" fmla="*/ 477036 w 589427"/>
                <a:gd name="connsiteY32" fmla="*/ 330982 h 370251"/>
                <a:gd name="connsiteX33" fmla="*/ 493866 w 589427"/>
                <a:gd name="connsiteY33" fmla="*/ 319762 h 370251"/>
                <a:gd name="connsiteX34" fmla="*/ 516305 w 589427"/>
                <a:gd name="connsiteY34" fmla="*/ 252444 h 370251"/>
                <a:gd name="connsiteX35" fmla="*/ 533134 w 589427"/>
                <a:gd name="connsiteY35" fmla="*/ 218786 h 370251"/>
                <a:gd name="connsiteX36" fmla="*/ 566793 w 589427"/>
                <a:gd name="connsiteY36" fmla="*/ 201956 h 370251"/>
                <a:gd name="connsiteX37" fmla="*/ 589232 w 589427"/>
                <a:gd name="connsiteY37" fmla="*/ 168297 h 370251"/>
                <a:gd name="connsiteX38" fmla="*/ 572403 w 589427"/>
                <a:gd name="connsiteY38" fmla="*/ 100979 h 370251"/>
                <a:gd name="connsiteX39" fmla="*/ 471426 w 589427"/>
                <a:gd name="connsiteY39" fmla="*/ 33662 h 370251"/>
                <a:gd name="connsiteX40" fmla="*/ 420938 w 589427"/>
                <a:gd name="connsiteY40" fmla="*/ 11222 h 370251"/>
                <a:gd name="connsiteX41" fmla="*/ 404108 w 589427"/>
                <a:gd name="connsiteY41" fmla="*/ 5613 h 370251"/>
                <a:gd name="connsiteX42" fmla="*/ 387279 w 589427"/>
                <a:gd name="connsiteY42" fmla="*/ 3 h 370251"/>
                <a:gd name="connsiteX43" fmla="*/ 353620 w 589427"/>
                <a:gd name="connsiteY43" fmla="*/ 16832 h 370251"/>
                <a:gd name="connsiteX44" fmla="*/ 342401 w 589427"/>
                <a:gd name="connsiteY44" fmla="*/ 33662 h 370251"/>
                <a:gd name="connsiteX45" fmla="*/ 325571 w 589427"/>
                <a:gd name="connsiteY45" fmla="*/ 95370 h 370251"/>
                <a:gd name="connsiteX46" fmla="*/ 325571 w 589427"/>
                <a:gd name="connsiteY46" fmla="*/ 218786 h 370251"/>
                <a:gd name="connsiteX47" fmla="*/ 308742 w 589427"/>
                <a:gd name="connsiteY47" fmla="*/ 230005 h 370251"/>
                <a:gd name="connsiteX48" fmla="*/ 275083 w 589427"/>
                <a:gd name="connsiteY48" fmla="*/ 230005 h 3702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</a:cxnLst>
              <a:rect l="l" t="t" r="r" b="b"/>
              <a:pathLst>
                <a:path w="589427" h="370251">
                  <a:moveTo>
                    <a:pt x="275083" y="230005"/>
                  </a:moveTo>
                  <a:cubicBezTo>
                    <a:pt x="265733" y="225330"/>
                    <a:pt x="254016" y="213851"/>
                    <a:pt x="252643" y="201956"/>
                  </a:cubicBezTo>
                  <a:cubicBezTo>
                    <a:pt x="248137" y="162902"/>
                    <a:pt x="258253" y="123463"/>
                    <a:pt x="258253" y="84150"/>
                  </a:cubicBezTo>
                  <a:cubicBezTo>
                    <a:pt x="258253" y="72776"/>
                    <a:pt x="257018" y="60990"/>
                    <a:pt x="252643" y="50491"/>
                  </a:cubicBezTo>
                  <a:cubicBezTo>
                    <a:pt x="235898" y="10303"/>
                    <a:pt x="237585" y="20168"/>
                    <a:pt x="207765" y="11222"/>
                  </a:cubicBezTo>
                  <a:cubicBezTo>
                    <a:pt x="196437" y="7824"/>
                    <a:pt x="174106" y="3"/>
                    <a:pt x="174106" y="3"/>
                  </a:cubicBezTo>
                  <a:cubicBezTo>
                    <a:pt x="165891" y="516"/>
                    <a:pt x="95540" y="-2788"/>
                    <a:pt x="67520" y="11222"/>
                  </a:cubicBezTo>
                  <a:cubicBezTo>
                    <a:pt x="61489" y="14237"/>
                    <a:pt x="56300" y="18702"/>
                    <a:pt x="50690" y="22442"/>
                  </a:cubicBezTo>
                  <a:cubicBezTo>
                    <a:pt x="22833" y="64225"/>
                    <a:pt x="58636" y="12907"/>
                    <a:pt x="22641" y="56101"/>
                  </a:cubicBezTo>
                  <a:cubicBezTo>
                    <a:pt x="18325" y="61280"/>
                    <a:pt x="15161" y="67320"/>
                    <a:pt x="11421" y="72930"/>
                  </a:cubicBezTo>
                  <a:cubicBezTo>
                    <a:pt x="7681" y="84150"/>
                    <a:pt x="-1471" y="94881"/>
                    <a:pt x="202" y="106589"/>
                  </a:cubicBezTo>
                  <a:cubicBezTo>
                    <a:pt x="2268" y="121053"/>
                    <a:pt x="3590" y="147024"/>
                    <a:pt x="11421" y="162687"/>
                  </a:cubicBezTo>
                  <a:cubicBezTo>
                    <a:pt x="14436" y="168718"/>
                    <a:pt x="19626" y="173486"/>
                    <a:pt x="22641" y="179517"/>
                  </a:cubicBezTo>
                  <a:cubicBezTo>
                    <a:pt x="25286" y="184806"/>
                    <a:pt x="25607" y="191057"/>
                    <a:pt x="28251" y="196346"/>
                  </a:cubicBezTo>
                  <a:cubicBezTo>
                    <a:pt x="31266" y="202376"/>
                    <a:pt x="36455" y="207146"/>
                    <a:pt x="39470" y="213176"/>
                  </a:cubicBezTo>
                  <a:cubicBezTo>
                    <a:pt x="42114" y="218465"/>
                    <a:pt x="42208" y="224836"/>
                    <a:pt x="45080" y="230005"/>
                  </a:cubicBezTo>
                  <a:cubicBezTo>
                    <a:pt x="51629" y="241792"/>
                    <a:pt x="60040" y="252444"/>
                    <a:pt x="67520" y="263664"/>
                  </a:cubicBezTo>
                  <a:cubicBezTo>
                    <a:pt x="71260" y="269274"/>
                    <a:pt x="73129" y="276754"/>
                    <a:pt x="78739" y="280494"/>
                  </a:cubicBezTo>
                  <a:lnTo>
                    <a:pt x="95569" y="291713"/>
                  </a:lnTo>
                  <a:cubicBezTo>
                    <a:pt x="99309" y="297323"/>
                    <a:pt x="101714" y="304103"/>
                    <a:pt x="106788" y="308543"/>
                  </a:cubicBezTo>
                  <a:cubicBezTo>
                    <a:pt x="116936" y="317423"/>
                    <a:pt x="129227" y="323502"/>
                    <a:pt x="140447" y="330982"/>
                  </a:cubicBezTo>
                  <a:lnTo>
                    <a:pt x="157277" y="342202"/>
                  </a:lnTo>
                  <a:lnTo>
                    <a:pt x="174106" y="353421"/>
                  </a:lnTo>
                  <a:lnTo>
                    <a:pt x="190935" y="364641"/>
                  </a:lnTo>
                  <a:cubicBezTo>
                    <a:pt x="207765" y="362771"/>
                    <a:pt x="224721" y="361815"/>
                    <a:pt x="241424" y="359031"/>
                  </a:cubicBezTo>
                  <a:cubicBezTo>
                    <a:pt x="247257" y="358059"/>
                    <a:pt x="254072" y="357602"/>
                    <a:pt x="258253" y="353421"/>
                  </a:cubicBezTo>
                  <a:cubicBezTo>
                    <a:pt x="262434" y="349240"/>
                    <a:pt x="259051" y="340029"/>
                    <a:pt x="263863" y="336592"/>
                  </a:cubicBezTo>
                  <a:cubicBezTo>
                    <a:pt x="273487" y="329718"/>
                    <a:pt x="297522" y="325372"/>
                    <a:pt x="297522" y="325372"/>
                  </a:cubicBezTo>
                  <a:cubicBezTo>
                    <a:pt x="312043" y="339894"/>
                    <a:pt x="327878" y="357930"/>
                    <a:pt x="348010" y="364641"/>
                  </a:cubicBezTo>
                  <a:lnTo>
                    <a:pt x="364840" y="370251"/>
                  </a:lnTo>
                  <a:cubicBezTo>
                    <a:pt x="387279" y="368381"/>
                    <a:pt x="410507" y="370827"/>
                    <a:pt x="432158" y="364641"/>
                  </a:cubicBezTo>
                  <a:cubicBezTo>
                    <a:pt x="438641" y="362789"/>
                    <a:pt x="438610" y="352578"/>
                    <a:pt x="443377" y="347811"/>
                  </a:cubicBezTo>
                  <a:cubicBezTo>
                    <a:pt x="459451" y="331737"/>
                    <a:pt x="458789" y="340106"/>
                    <a:pt x="477036" y="330982"/>
                  </a:cubicBezTo>
                  <a:cubicBezTo>
                    <a:pt x="483067" y="327967"/>
                    <a:pt x="488256" y="323502"/>
                    <a:pt x="493866" y="319762"/>
                  </a:cubicBezTo>
                  <a:lnTo>
                    <a:pt x="516305" y="252444"/>
                  </a:lnTo>
                  <a:cubicBezTo>
                    <a:pt x="520867" y="238758"/>
                    <a:pt x="522261" y="229659"/>
                    <a:pt x="533134" y="218786"/>
                  </a:cubicBezTo>
                  <a:cubicBezTo>
                    <a:pt x="544009" y="207911"/>
                    <a:pt x="553105" y="206519"/>
                    <a:pt x="566793" y="201956"/>
                  </a:cubicBezTo>
                  <a:cubicBezTo>
                    <a:pt x="574273" y="190736"/>
                    <a:pt x="591448" y="181598"/>
                    <a:pt x="589232" y="168297"/>
                  </a:cubicBezTo>
                  <a:cubicBezTo>
                    <a:pt x="587912" y="160378"/>
                    <a:pt x="580739" y="106536"/>
                    <a:pt x="572403" y="100979"/>
                  </a:cubicBezTo>
                  <a:lnTo>
                    <a:pt x="471426" y="33662"/>
                  </a:lnTo>
                  <a:cubicBezTo>
                    <a:pt x="444754" y="15881"/>
                    <a:pt x="460997" y="24575"/>
                    <a:pt x="420938" y="11222"/>
                  </a:cubicBezTo>
                  <a:lnTo>
                    <a:pt x="404108" y="5613"/>
                  </a:lnTo>
                  <a:lnTo>
                    <a:pt x="387279" y="3"/>
                  </a:lnTo>
                  <a:cubicBezTo>
                    <a:pt x="373594" y="4565"/>
                    <a:pt x="364493" y="5959"/>
                    <a:pt x="353620" y="16832"/>
                  </a:cubicBezTo>
                  <a:cubicBezTo>
                    <a:pt x="348853" y="21599"/>
                    <a:pt x="345139" y="27501"/>
                    <a:pt x="342401" y="33662"/>
                  </a:cubicBezTo>
                  <a:cubicBezTo>
                    <a:pt x="332048" y="56958"/>
                    <a:pt x="330371" y="71372"/>
                    <a:pt x="325571" y="95370"/>
                  </a:cubicBezTo>
                  <a:cubicBezTo>
                    <a:pt x="325719" y="97732"/>
                    <a:pt x="338451" y="193026"/>
                    <a:pt x="325571" y="218786"/>
                  </a:cubicBezTo>
                  <a:cubicBezTo>
                    <a:pt x="322556" y="224816"/>
                    <a:pt x="315225" y="228153"/>
                    <a:pt x="308742" y="230005"/>
                  </a:cubicBezTo>
                  <a:cubicBezTo>
                    <a:pt x="301550" y="232060"/>
                    <a:pt x="284433" y="234680"/>
                    <a:pt x="275083" y="230005"/>
                  </a:cubicBezTo>
                  <a:close/>
                </a:path>
              </a:pathLst>
            </a:custGeom>
            <a:noFill/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82" name="Group 78"/>
            <p:cNvGrpSpPr/>
            <p:nvPr/>
          </p:nvGrpSpPr>
          <p:grpSpPr>
            <a:xfrm>
              <a:off x="4863710" y="2664663"/>
              <a:ext cx="1783922" cy="880744"/>
              <a:chOff x="4863710" y="2664663"/>
              <a:chExt cx="1783922" cy="880744"/>
            </a:xfrm>
          </p:grpSpPr>
          <p:sp>
            <p:nvSpPr>
              <p:cNvPr id="192" name="Freeform 191"/>
              <p:cNvSpPr/>
              <p:nvPr/>
            </p:nvSpPr>
            <p:spPr>
              <a:xfrm>
                <a:off x="4863710" y="2720761"/>
                <a:ext cx="162685" cy="762935"/>
              </a:xfrm>
              <a:custGeom>
                <a:avLst/>
                <a:gdLst>
                  <a:gd name="connsiteX0" fmla="*/ 33659 w 162685"/>
                  <a:gd name="connsiteY0" fmla="*/ 0 h 762935"/>
                  <a:gd name="connsiteX1" fmla="*/ 50489 w 162685"/>
                  <a:gd name="connsiteY1" fmla="*/ 44878 h 762935"/>
                  <a:gd name="connsiteX2" fmla="*/ 67318 w 162685"/>
                  <a:gd name="connsiteY2" fmla="*/ 106586 h 762935"/>
                  <a:gd name="connsiteX3" fmla="*/ 61708 w 162685"/>
                  <a:gd name="connsiteY3" fmla="*/ 185124 h 762935"/>
                  <a:gd name="connsiteX4" fmla="*/ 56099 w 162685"/>
                  <a:gd name="connsiteY4" fmla="*/ 201953 h 762935"/>
                  <a:gd name="connsiteX5" fmla="*/ 33659 w 162685"/>
                  <a:gd name="connsiteY5" fmla="*/ 235612 h 762935"/>
                  <a:gd name="connsiteX6" fmla="*/ 16830 w 162685"/>
                  <a:gd name="connsiteY6" fmla="*/ 269271 h 762935"/>
                  <a:gd name="connsiteX7" fmla="*/ 0 w 162685"/>
                  <a:gd name="connsiteY7" fmla="*/ 336589 h 762935"/>
                  <a:gd name="connsiteX8" fmla="*/ 11220 w 162685"/>
                  <a:gd name="connsiteY8" fmla="*/ 415126 h 762935"/>
                  <a:gd name="connsiteX9" fmla="*/ 22440 w 162685"/>
                  <a:gd name="connsiteY9" fmla="*/ 431956 h 762935"/>
                  <a:gd name="connsiteX10" fmla="*/ 39269 w 162685"/>
                  <a:gd name="connsiteY10" fmla="*/ 443175 h 762935"/>
                  <a:gd name="connsiteX11" fmla="*/ 67318 w 162685"/>
                  <a:gd name="connsiteY11" fmla="*/ 493664 h 762935"/>
                  <a:gd name="connsiteX12" fmla="*/ 78538 w 162685"/>
                  <a:gd name="connsiteY12" fmla="*/ 510493 h 762935"/>
                  <a:gd name="connsiteX13" fmla="*/ 84148 w 162685"/>
                  <a:gd name="connsiteY13" fmla="*/ 527322 h 762935"/>
                  <a:gd name="connsiteX14" fmla="*/ 95367 w 162685"/>
                  <a:gd name="connsiteY14" fmla="*/ 544152 h 762935"/>
                  <a:gd name="connsiteX15" fmla="*/ 106587 w 162685"/>
                  <a:gd name="connsiteY15" fmla="*/ 577811 h 762935"/>
                  <a:gd name="connsiteX16" fmla="*/ 112197 w 162685"/>
                  <a:gd name="connsiteY16" fmla="*/ 594640 h 762935"/>
                  <a:gd name="connsiteX17" fmla="*/ 117807 w 162685"/>
                  <a:gd name="connsiteY17" fmla="*/ 611470 h 762935"/>
                  <a:gd name="connsiteX18" fmla="*/ 123416 w 162685"/>
                  <a:gd name="connsiteY18" fmla="*/ 656348 h 762935"/>
                  <a:gd name="connsiteX19" fmla="*/ 134636 w 162685"/>
                  <a:gd name="connsiteY19" fmla="*/ 718056 h 762935"/>
                  <a:gd name="connsiteX20" fmla="*/ 145856 w 162685"/>
                  <a:gd name="connsiteY20" fmla="*/ 751715 h 762935"/>
                  <a:gd name="connsiteX21" fmla="*/ 162685 w 162685"/>
                  <a:gd name="connsiteY21" fmla="*/ 762935 h 7629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62685" h="762935">
                    <a:moveTo>
                      <a:pt x="33659" y="0"/>
                    </a:moveTo>
                    <a:cubicBezTo>
                      <a:pt x="46960" y="66503"/>
                      <a:pt x="29476" y="-2401"/>
                      <a:pt x="50489" y="44878"/>
                    </a:cubicBezTo>
                    <a:cubicBezTo>
                      <a:pt x="60840" y="68168"/>
                      <a:pt x="62519" y="82593"/>
                      <a:pt x="67318" y="106586"/>
                    </a:cubicBezTo>
                    <a:cubicBezTo>
                      <a:pt x="65448" y="132765"/>
                      <a:pt x="64774" y="159058"/>
                      <a:pt x="61708" y="185124"/>
                    </a:cubicBezTo>
                    <a:cubicBezTo>
                      <a:pt x="61017" y="190997"/>
                      <a:pt x="58971" y="196784"/>
                      <a:pt x="56099" y="201953"/>
                    </a:cubicBezTo>
                    <a:cubicBezTo>
                      <a:pt x="49550" y="213741"/>
                      <a:pt x="33659" y="235612"/>
                      <a:pt x="33659" y="235612"/>
                    </a:cubicBezTo>
                    <a:cubicBezTo>
                      <a:pt x="13209" y="296969"/>
                      <a:pt x="45821" y="204042"/>
                      <a:pt x="16830" y="269271"/>
                    </a:cubicBezTo>
                    <a:cubicBezTo>
                      <a:pt x="4976" y="295941"/>
                      <a:pt x="4704" y="308364"/>
                      <a:pt x="0" y="336589"/>
                    </a:cubicBezTo>
                    <a:cubicBezTo>
                      <a:pt x="1434" y="352357"/>
                      <a:pt x="427" y="393541"/>
                      <a:pt x="11220" y="415126"/>
                    </a:cubicBezTo>
                    <a:cubicBezTo>
                      <a:pt x="14235" y="421157"/>
                      <a:pt x="17672" y="427188"/>
                      <a:pt x="22440" y="431956"/>
                    </a:cubicBezTo>
                    <a:cubicBezTo>
                      <a:pt x="27207" y="436723"/>
                      <a:pt x="33659" y="439435"/>
                      <a:pt x="39269" y="443175"/>
                    </a:cubicBezTo>
                    <a:cubicBezTo>
                      <a:pt x="49143" y="472796"/>
                      <a:pt x="41599" y="455087"/>
                      <a:pt x="67318" y="493664"/>
                    </a:cubicBezTo>
                    <a:cubicBezTo>
                      <a:pt x="71058" y="499274"/>
                      <a:pt x="76406" y="504097"/>
                      <a:pt x="78538" y="510493"/>
                    </a:cubicBezTo>
                    <a:cubicBezTo>
                      <a:pt x="80408" y="516103"/>
                      <a:pt x="81504" y="522033"/>
                      <a:pt x="84148" y="527322"/>
                    </a:cubicBezTo>
                    <a:cubicBezTo>
                      <a:pt x="87163" y="533352"/>
                      <a:pt x="92629" y="537991"/>
                      <a:pt x="95367" y="544152"/>
                    </a:cubicBezTo>
                    <a:cubicBezTo>
                      <a:pt x="100170" y="554959"/>
                      <a:pt x="102847" y="566591"/>
                      <a:pt x="106587" y="577811"/>
                    </a:cubicBezTo>
                    <a:lnTo>
                      <a:pt x="112197" y="594640"/>
                    </a:lnTo>
                    <a:lnTo>
                      <a:pt x="117807" y="611470"/>
                    </a:lnTo>
                    <a:cubicBezTo>
                      <a:pt x="119677" y="626429"/>
                      <a:pt x="121424" y="641405"/>
                      <a:pt x="123416" y="656348"/>
                    </a:cubicBezTo>
                    <a:cubicBezTo>
                      <a:pt x="126893" y="682424"/>
                      <a:pt x="127699" y="694932"/>
                      <a:pt x="134636" y="718056"/>
                    </a:cubicBezTo>
                    <a:cubicBezTo>
                      <a:pt x="138034" y="729384"/>
                      <a:pt x="136016" y="745155"/>
                      <a:pt x="145856" y="751715"/>
                    </a:cubicBezTo>
                    <a:lnTo>
                      <a:pt x="162685" y="762935"/>
                    </a:ln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3" name="Freeform 192"/>
              <p:cNvSpPr/>
              <p:nvPr/>
            </p:nvSpPr>
            <p:spPr>
              <a:xfrm>
                <a:off x="6524216" y="2664663"/>
                <a:ext cx="123416" cy="847082"/>
              </a:xfrm>
              <a:custGeom>
                <a:avLst/>
                <a:gdLst>
                  <a:gd name="connsiteX0" fmla="*/ 123416 w 123416"/>
                  <a:gd name="connsiteY0" fmla="*/ 0 h 847082"/>
                  <a:gd name="connsiteX1" fmla="*/ 67318 w 123416"/>
                  <a:gd name="connsiteY1" fmla="*/ 11219 h 847082"/>
                  <a:gd name="connsiteX2" fmla="*/ 33659 w 123416"/>
                  <a:gd name="connsiteY2" fmla="*/ 33658 h 847082"/>
                  <a:gd name="connsiteX3" fmla="*/ 28049 w 123416"/>
                  <a:gd name="connsiteY3" fmla="*/ 50488 h 847082"/>
                  <a:gd name="connsiteX4" fmla="*/ 5610 w 123416"/>
                  <a:gd name="connsiteY4" fmla="*/ 84147 h 847082"/>
                  <a:gd name="connsiteX5" fmla="*/ 16829 w 123416"/>
                  <a:gd name="connsiteY5" fmla="*/ 157074 h 847082"/>
                  <a:gd name="connsiteX6" fmla="*/ 39269 w 123416"/>
                  <a:gd name="connsiteY6" fmla="*/ 190733 h 847082"/>
                  <a:gd name="connsiteX7" fmla="*/ 56098 w 123416"/>
                  <a:gd name="connsiteY7" fmla="*/ 201953 h 847082"/>
                  <a:gd name="connsiteX8" fmla="*/ 89757 w 123416"/>
                  <a:gd name="connsiteY8" fmla="*/ 269271 h 847082"/>
                  <a:gd name="connsiteX9" fmla="*/ 95367 w 123416"/>
                  <a:gd name="connsiteY9" fmla="*/ 286100 h 847082"/>
                  <a:gd name="connsiteX10" fmla="*/ 100977 w 123416"/>
                  <a:gd name="connsiteY10" fmla="*/ 302930 h 847082"/>
                  <a:gd name="connsiteX11" fmla="*/ 89757 w 123416"/>
                  <a:gd name="connsiteY11" fmla="*/ 482444 h 847082"/>
                  <a:gd name="connsiteX12" fmla="*/ 78537 w 123416"/>
                  <a:gd name="connsiteY12" fmla="*/ 516103 h 847082"/>
                  <a:gd name="connsiteX13" fmla="*/ 67318 w 123416"/>
                  <a:gd name="connsiteY13" fmla="*/ 532932 h 847082"/>
                  <a:gd name="connsiteX14" fmla="*/ 61708 w 123416"/>
                  <a:gd name="connsiteY14" fmla="*/ 549762 h 847082"/>
                  <a:gd name="connsiteX15" fmla="*/ 50488 w 123416"/>
                  <a:gd name="connsiteY15" fmla="*/ 605860 h 847082"/>
                  <a:gd name="connsiteX16" fmla="*/ 39269 w 123416"/>
                  <a:gd name="connsiteY16" fmla="*/ 639519 h 847082"/>
                  <a:gd name="connsiteX17" fmla="*/ 33659 w 123416"/>
                  <a:gd name="connsiteY17" fmla="*/ 723666 h 847082"/>
                  <a:gd name="connsiteX18" fmla="*/ 28049 w 123416"/>
                  <a:gd name="connsiteY18" fmla="*/ 740495 h 847082"/>
                  <a:gd name="connsiteX19" fmla="*/ 5610 w 123416"/>
                  <a:gd name="connsiteY19" fmla="*/ 835862 h 847082"/>
                  <a:gd name="connsiteX20" fmla="*/ 0 w 123416"/>
                  <a:gd name="connsiteY20" fmla="*/ 847082 h 8470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123416" h="847082">
                    <a:moveTo>
                      <a:pt x="123416" y="0"/>
                    </a:moveTo>
                    <a:cubicBezTo>
                      <a:pt x="113655" y="1394"/>
                      <a:pt x="80877" y="3686"/>
                      <a:pt x="67318" y="11219"/>
                    </a:cubicBezTo>
                    <a:cubicBezTo>
                      <a:pt x="55531" y="17768"/>
                      <a:pt x="33659" y="33658"/>
                      <a:pt x="33659" y="33658"/>
                    </a:cubicBezTo>
                    <a:cubicBezTo>
                      <a:pt x="31789" y="39268"/>
                      <a:pt x="30921" y="45319"/>
                      <a:pt x="28049" y="50488"/>
                    </a:cubicBezTo>
                    <a:cubicBezTo>
                      <a:pt x="21501" y="62275"/>
                      <a:pt x="5610" y="84147"/>
                      <a:pt x="5610" y="84147"/>
                    </a:cubicBezTo>
                    <a:cubicBezTo>
                      <a:pt x="6434" y="92388"/>
                      <a:pt x="6969" y="139326"/>
                      <a:pt x="16829" y="157074"/>
                    </a:cubicBezTo>
                    <a:cubicBezTo>
                      <a:pt x="23378" y="168862"/>
                      <a:pt x="28049" y="183253"/>
                      <a:pt x="39269" y="190733"/>
                    </a:cubicBezTo>
                    <a:lnTo>
                      <a:pt x="56098" y="201953"/>
                    </a:lnTo>
                    <a:cubicBezTo>
                      <a:pt x="85098" y="245453"/>
                      <a:pt x="74272" y="222819"/>
                      <a:pt x="89757" y="269271"/>
                    </a:cubicBezTo>
                    <a:lnTo>
                      <a:pt x="95367" y="286100"/>
                    </a:lnTo>
                    <a:lnTo>
                      <a:pt x="100977" y="302930"/>
                    </a:lnTo>
                    <a:cubicBezTo>
                      <a:pt x="98456" y="373512"/>
                      <a:pt x="107579" y="423040"/>
                      <a:pt x="89757" y="482444"/>
                    </a:cubicBezTo>
                    <a:cubicBezTo>
                      <a:pt x="86359" y="493772"/>
                      <a:pt x="85097" y="506263"/>
                      <a:pt x="78537" y="516103"/>
                    </a:cubicBezTo>
                    <a:cubicBezTo>
                      <a:pt x="74797" y="521713"/>
                      <a:pt x="70333" y="526902"/>
                      <a:pt x="67318" y="532932"/>
                    </a:cubicBezTo>
                    <a:cubicBezTo>
                      <a:pt x="64673" y="538221"/>
                      <a:pt x="63038" y="544000"/>
                      <a:pt x="61708" y="549762"/>
                    </a:cubicBezTo>
                    <a:cubicBezTo>
                      <a:pt x="57420" y="568343"/>
                      <a:pt x="56518" y="587769"/>
                      <a:pt x="50488" y="605860"/>
                    </a:cubicBezTo>
                    <a:lnTo>
                      <a:pt x="39269" y="639519"/>
                    </a:lnTo>
                    <a:cubicBezTo>
                      <a:pt x="37399" y="667568"/>
                      <a:pt x="36763" y="695727"/>
                      <a:pt x="33659" y="723666"/>
                    </a:cubicBezTo>
                    <a:cubicBezTo>
                      <a:pt x="33006" y="729543"/>
                      <a:pt x="29379" y="734733"/>
                      <a:pt x="28049" y="740495"/>
                    </a:cubicBezTo>
                    <a:cubicBezTo>
                      <a:pt x="21150" y="770390"/>
                      <a:pt x="17352" y="806508"/>
                      <a:pt x="5610" y="835862"/>
                    </a:cubicBezTo>
                    <a:cubicBezTo>
                      <a:pt x="4057" y="839744"/>
                      <a:pt x="1870" y="843342"/>
                      <a:pt x="0" y="847082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4" name="Freeform 193"/>
              <p:cNvSpPr/>
              <p:nvPr/>
            </p:nvSpPr>
            <p:spPr>
              <a:xfrm>
                <a:off x="5009566" y="3483696"/>
                <a:ext cx="100976" cy="22439"/>
              </a:xfrm>
              <a:custGeom>
                <a:avLst/>
                <a:gdLst>
                  <a:gd name="connsiteX0" fmla="*/ 0 w 100976"/>
                  <a:gd name="connsiteY0" fmla="*/ 0 h 22439"/>
                  <a:gd name="connsiteX1" fmla="*/ 56098 w 100976"/>
                  <a:gd name="connsiteY1" fmla="*/ 5610 h 22439"/>
                  <a:gd name="connsiteX2" fmla="*/ 100976 w 100976"/>
                  <a:gd name="connsiteY2" fmla="*/ 22439 h 22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0976" h="22439">
                    <a:moveTo>
                      <a:pt x="0" y="0"/>
                    </a:moveTo>
                    <a:cubicBezTo>
                      <a:pt x="18699" y="1870"/>
                      <a:pt x="37627" y="2147"/>
                      <a:pt x="56098" y="5610"/>
                    </a:cubicBezTo>
                    <a:cubicBezTo>
                      <a:pt x="76170" y="9373"/>
                      <a:pt x="85385" y="14643"/>
                      <a:pt x="100976" y="22439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5" name="Freeform 194"/>
              <p:cNvSpPr/>
              <p:nvPr/>
            </p:nvSpPr>
            <p:spPr>
              <a:xfrm>
                <a:off x="6417629" y="3522964"/>
                <a:ext cx="100977" cy="22443"/>
              </a:xfrm>
              <a:custGeom>
                <a:avLst/>
                <a:gdLst>
                  <a:gd name="connsiteX0" fmla="*/ 100977 w 100977"/>
                  <a:gd name="connsiteY0" fmla="*/ 0 h 22443"/>
                  <a:gd name="connsiteX1" fmla="*/ 72928 w 100977"/>
                  <a:gd name="connsiteY1" fmla="*/ 16830 h 22443"/>
                  <a:gd name="connsiteX2" fmla="*/ 0 w 100977"/>
                  <a:gd name="connsiteY2" fmla="*/ 22440 h 224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0977" h="22443">
                    <a:moveTo>
                      <a:pt x="100977" y="0"/>
                    </a:moveTo>
                    <a:cubicBezTo>
                      <a:pt x="91627" y="5610"/>
                      <a:pt x="83506" y="14185"/>
                      <a:pt x="72928" y="16830"/>
                    </a:cubicBezTo>
                    <a:cubicBezTo>
                      <a:pt x="49134" y="22779"/>
                      <a:pt x="24334" y="22440"/>
                      <a:pt x="0" y="22440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83" name="Freeform 182"/>
            <p:cNvSpPr/>
            <p:nvPr/>
          </p:nvSpPr>
          <p:spPr>
            <a:xfrm>
              <a:off x="5486400" y="4201752"/>
              <a:ext cx="539000" cy="213173"/>
            </a:xfrm>
            <a:custGeom>
              <a:avLst/>
              <a:gdLst>
                <a:gd name="connsiteX0" fmla="*/ 11220 w 539000"/>
                <a:gd name="connsiteY0" fmla="*/ 0 h 213173"/>
                <a:gd name="connsiteX1" fmla="*/ 5610 w 539000"/>
                <a:gd name="connsiteY1" fmla="*/ 33659 h 213173"/>
                <a:gd name="connsiteX2" fmla="*/ 0 w 539000"/>
                <a:gd name="connsiteY2" fmla="*/ 50488 h 213173"/>
                <a:gd name="connsiteX3" fmla="*/ 5610 w 539000"/>
                <a:gd name="connsiteY3" fmla="*/ 112196 h 213173"/>
                <a:gd name="connsiteX4" fmla="*/ 11220 w 539000"/>
                <a:gd name="connsiteY4" fmla="*/ 129026 h 213173"/>
                <a:gd name="connsiteX5" fmla="*/ 28049 w 539000"/>
                <a:gd name="connsiteY5" fmla="*/ 134636 h 213173"/>
                <a:gd name="connsiteX6" fmla="*/ 44879 w 539000"/>
                <a:gd name="connsiteY6" fmla="*/ 145855 h 213173"/>
                <a:gd name="connsiteX7" fmla="*/ 162685 w 539000"/>
                <a:gd name="connsiteY7" fmla="*/ 157075 h 213173"/>
                <a:gd name="connsiteX8" fmla="*/ 213173 w 539000"/>
                <a:gd name="connsiteY8" fmla="*/ 173904 h 213173"/>
                <a:gd name="connsiteX9" fmla="*/ 230002 w 539000"/>
                <a:gd name="connsiteY9" fmla="*/ 179514 h 213173"/>
                <a:gd name="connsiteX10" fmla="*/ 280491 w 539000"/>
                <a:gd name="connsiteY10" fmla="*/ 201954 h 213173"/>
                <a:gd name="connsiteX11" fmla="*/ 297320 w 539000"/>
                <a:gd name="connsiteY11" fmla="*/ 207563 h 213173"/>
                <a:gd name="connsiteX12" fmla="*/ 342199 w 539000"/>
                <a:gd name="connsiteY12" fmla="*/ 213173 h 213173"/>
                <a:gd name="connsiteX13" fmla="*/ 443175 w 539000"/>
                <a:gd name="connsiteY13" fmla="*/ 207563 h 213173"/>
                <a:gd name="connsiteX14" fmla="*/ 460005 w 539000"/>
                <a:gd name="connsiteY14" fmla="*/ 196344 h 213173"/>
                <a:gd name="connsiteX15" fmla="*/ 476834 w 539000"/>
                <a:gd name="connsiteY15" fmla="*/ 190734 h 213173"/>
                <a:gd name="connsiteX16" fmla="*/ 510493 w 539000"/>
                <a:gd name="connsiteY16" fmla="*/ 168295 h 213173"/>
                <a:gd name="connsiteX17" fmla="*/ 527323 w 539000"/>
                <a:gd name="connsiteY17" fmla="*/ 134636 h 213173"/>
                <a:gd name="connsiteX18" fmla="*/ 538542 w 539000"/>
                <a:gd name="connsiteY18" fmla="*/ 95367 h 213173"/>
                <a:gd name="connsiteX19" fmla="*/ 538542 w 539000"/>
                <a:gd name="connsiteY19" fmla="*/ 67318 h 21317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539000" h="213173">
                  <a:moveTo>
                    <a:pt x="11220" y="0"/>
                  </a:moveTo>
                  <a:cubicBezTo>
                    <a:pt x="9350" y="11220"/>
                    <a:pt x="8078" y="22555"/>
                    <a:pt x="5610" y="33659"/>
                  </a:cubicBezTo>
                  <a:cubicBezTo>
                    <a:pt x="4327" y="39431"/>
                    <a:pt x="0" y="44575"/>
                    <a:pt x="0" y="50488"/>
                  </a:cubicBezTo>
                  <a:cubicBezTo>
                    <a:pt x="0" y="71142"/>
                    <a:pt x="2689" y="91749"/>
                    <a:pt x="5610" y="112196"/>
                  </a:cubicBezTo>
                  <a:cubicBezTo>
                    <a:pt x="6446" y="118050"/>
                    <a:pt x="7039" y="124844"/>
                    <a:pt x="11220" y="129026"/>
                  </a:cubicBezTo>
                  <a:cubicBezTo>
                    <a:pt x="15401" y="133207"/>
                    <a:pt x="22760" y="131992"/>
                    <a:pt x="28049" y="134636"/>
                  </a:cubicBezTo>
                  <a:cubicBezTo>
                    <a:pt x="34079" y="137651"/>
                    <a:pt x="38849" y="142840"/>
                    <a:pt x="44879" y="145855"/>
                  </a:cubicBezTo>
                  <a:cubicBezTo>
                    <a:pt x="75388" y="161109"/>
                    <a:pt x="160136" y="156933"/>
                    <a:pt x="162685" y="157075"/>
                  </a:cubicBezTo>
                  <a:lnTo>
                    <a:pt x="213173" y="173904"/>
                  </a:lnTo>
                  <a:cubicBezTo>
                    <a:pt x="218783" y="175774"/>
                    <a:pt x="225082" y="176234"/>
                    <a:pt x="230002" y="179514"/>
                  </a:cubicBezTo>
                  <a:cubicBezTo>
                    <a:pt x="256671" y="197293"/>
                    <a:pt x="240438" y="188603"/>
                    <a:pt x="280491" y="201954"/>
                  </a:cubicBezTo>
                  <a:cubicBezTo>
                    <a:pt x="286101" y="203824"/>
                    <a:pt x="291453" y="206830"/>
                    <a:pt x="297320" y="207563"/>
                  </a:cubicBezTo>
                  <a:lnTo>
                    <a:pt x="342199" y="213173"/>
                  </a:lnTo>
                  <a:cubicBezTo>
                    <a:pt x="375858" y="211303"/>
                    <a:pt x="409803" y="212330"/>
                    <a:pt x="443175" y="207563"/>
                  </a:cubicBezTo>
                  <a:cubicBezTo>
                    <a:pt x="449849" y="206610"/>
                    <a:pt x="453975" y="199359"/>
                    <a:pt x="460005" y="196344"/>
                  </a:cubicBezTo>
                  <a:cubicBezTo>
                    <a:pt x="465294" y="193700"/>
                    <a:pt x="471665" y="193606"/>
                    <a:pt x="476834" y="190734"/>
                  </a:cubicBezTo>
                  <a:cubicBezTo>
                    <a:pt x="488621" y="184185"/>
                    <a:pt x="510493" y="168295"/>
                    <a:pt x="510493" y="168295"/>
                  </a:cubicBezTo>
                  <a:cubicBezTo>
                    <a:pt x="524594" y="125992"/>
                    <a:pt x="505573" y="178136"/>
                    <a:pt x="527323" y="134636"/>
                  </a:cubicBezTo>
                  <a:cubicBezTo>
                    <a:pt x="530363" y="128556"/>
                    <a:pt x="538028" y="99991"/>
                    <a:pt x="538542" y="95367"/>
                  </a:cubicBezTo>
                  <a:cubicBezTo>
                    <a:pt x="539574" y="86075"/>
                    <a:pt x="538542" y="76668"/>
                    <a:pt x="538542" y="67318"/>
                  </a:cubicBezTo>
                </a:path>
              </a:pathLst>
            </a:custGeom>
            <a:noFill/>
            <a:ln>
              <a:solidFill>
                <a:srgbClr val="FF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84" name="Group 80"/>
            <p:cNvGrpSpPr/>
            <p:nvPr/>
          </p:nvGrpSpPr>
          <p:grpSpPr>
            <a:xfrm>
              <a:off x="5323715" y="4083946"/>
              <a:ext cx="779765" cy="718056"/>
              <a:chOff x="5323715" y="4083946"/>
              <a:chExt cx="779765" cy="718056"/>
            </a:xfrm>
          </p:grpSpPr>
          <p:sp>
            <p:nvSpPr>
              <p:cNvPr id="185" name="Freeform 184"/>
              <p:cNvSpPr/>
              <p:nvPr/>
            </p:nvSpPr>
            <p:spPr>
              <a:xfrm>
                <a:off x="5458351" y="4083946"/>
                <a:ext cx="28053" cy="151465"/>
              </a:xfrm>
              <a:custGeom>
                <a:avLst/>
                <a:gdLst>
                  <a:gd name="connsiteX0" fmla="*/ 0 w 28053"/>
                  <a:gd name="connsiteY0" fmla="*/ 0 h 151465"/>
                  <a:gd name="connsiteX1" fmla="*/ 11220 w 28053"/>
                  <a:gd name="connsiteY1" fmla="*/ 67318 h 151465"/>
                  <a:gd name="connsiteX2" fmla="*/ 16829 w 28053"/>
                  <a:gd name="connsiteY2" fmla="*/ 100977 h 151465"/>
                  <a:gd name="connsiteX3" fmla="*/ 22439 w 28053"/>
                  <a:gd name="connsiteY3" fmla="*/ 117806 h 151465"/>
                  <a:gd name="connsiteX4" fmla="*/ 28049 w 28053"/>
                  <a:gd name="connsiteY4" fmla="*/ 151465 h 1514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8053" h="151465">
                    <a:moveTo>
                      <a:pt x="0" y="0"/>
                    </a:moveTo>
                    <a:cubicBezTo>
                      <a:pt x="10755" y="75286"/>
                      <a:pt x="279" y="7138"/>
                      <a:pt x="11220" y="67318"/>
                    </a:cubicBezTo>
                    <a:cubicBezTo>
                      <a:pt x="13255" y="78509"/>
                      <a:pt x="14362" y="89873"/>
                      <a:pt x="16829" y="100977"/>
                    </a:cubicBezTo>
                    <a:cubicBezTo>
                      <a:pt x="18112" y="106749"/>
                      <a:pt x="21005" y="112069"/>
                      <a:pt x="22439" y="117806"/>
                    </a:cubicBezTo>
                    <a:cubicBezTo>
                      <a:pt x="28416" y="141712"/>
                      <a:pt x="28049" y="137492"/>
                      <a:pt x="28049" y="151465"/>
                    </a:cubicBezTo>
                  </a:path>
                </a:pathLst>
              </a:custGeom>
              <a:noFill/>
              <a:ln>
                <a:solidFill>
                  <a:srgbClr val="FFCCFF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6" name="Freeform 185"/>
              <p:cNvSpPr/>
              <p:nvPr/>
            </p:nvSpPr>
            <p:spPr>
              <a:xfrm>
                <a:off x="5935467" y="4117605"/>
                <a:ext cx="89933" cy="168295"/>
              </a:xfrm>
              <a:custGeom>
                <a:avLst/>
                <a:gdLst>
                  <a:gd name="connsiteX0" fmla="*/ 0 w 89933"/>
                  <a:gd name="connsiteY0" fmla="*/ 0 h 168295"/>
                  <a:gd name="connsiteX1" fmla="*/ 11219 w 89933"/>
                  <a:gd name="connsiteY1" fmla="*/ 28049 h 168295"/>
                  <a:gd name="connsiteX2" fmla="*/ 22439 w 89933"/>
                  <a:gd name="connsiteY2" fmla="*/ 44879 h 168295"/>
                  <a:gd name="connsiteX3" fmla="*/ 28049 w 89933"/>
                  <a:gd name="connsiteY3" fmla="*/ 61708 h 168295"/>
                  <a:gd name="connsiteX4" fmla="*/ 39268 w 89933"/>
                  <a:gd name="connsiteY4" fmla="*/ 78538 h 168295"/>
                  <a:gd name="connsiteX5" fmla="*/ 44878 w 89933"/>
                  <a:gd name="connsiteY5" fmla="*/ 95367 h 168295"/>
                  <a:gd name="connsiteX6" fmla="*/ 67317 w 89933"/>
                  <a:gd name="connsiteY6" fmla="*/ 129026 h 168295"/>
                  <a:gd name="connsiteX7" fmla="*/ 72927 w 89933"/>
                  <a:gd name="connsiteY7" fmla="*/ 145855 h 168295"/>
                  <a:gd name="connsiteX8" fmla="*/ 89757 w 89933"/>
                  <a:gd name="connsiteY8" fmla="*/ 168295 h 1682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89933" h="168295">
                    <a:moveTo>
                      <a:pt x="0" y="0"/>
                    </a:moveTo>
                    <a:cubicBezTo>
                      <a:pt x="3740" y="9350"/>
                      <a:pt x="6716" y="19042"/>
                      <a:pt x="11219" y="28049"/>
                    </a:cubicBezTo>
                    <a:cubicBezTo>
                      <a:pt x="14234" y="34080"/>
                      <a:pt x="19424" y="38848"/>
                      <a:pt x="22439" y="44879"/>
                    </a:cubicBezTo>
                    <a:cubicBezTo>
                      <a:pt x="25084" y="50168"/>
                      <a:pt x="25405" y="56419"/>
                      <a:pt x="28049" y="61708"/>
                    </a:cubicBezTo>
                    <a:cubicBezTo>
                      <a:pt x="31064" y="67738"/>
                      <a:pt x="36253" y="72508"/>
                      <a:pt x="39268" y="78538"/>
                    </a:cubicBezTo>
                    <a:cubicBezTo>
                      <a:pt x="41912" y="83827"/>
                      <a:pt x="42006" y="90198"/>
                      <a:pt x="44878" y="95367"/>
                    </a:cubicBezTo>
                    <a:cubicBezTo>
                      <a:pt x="51427" y="107154"/>
                      <a:pt x="63053" y="116234"/>
                      <a:pt x="67317" y="129026"/>
                    </a:cubicBezTo>
                    <a:cubicBezTo>
                      <a:pt x="69187" y="134636"/>
                      <a:pt x="69233" y="141238"/>
                      <a:pt x="72927" y="145855"/>
                    </a:cubicBezTo>
                    <a:cubicBezTo>
                      <a:pt x="92869" y="170781"/>
                      <a:pt x="89757" y="143880"/>
                      <a:pt x="89757" y="168295"/>
                    </a:cubicBezTo>
                  </a:path>
                </a:pathLst>
              </a:custGeom>
              <a:noFill/>
              <a:ln>
                <a:solidFill>
                  <a:srgbClr val="FFCCFF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87" name="Group 83"/>
              <p:cNvGrpSpPr/>
              <p:nvPr/>
            </p:nvGrpSpPr>
            <p:grpSpPr>
              <a:xfrm>
                <a:off x="5323715" y="4095166"/>
                <a:ext cx="779765" cy="706836"/>
                <a:chOff x="5323715" y="4095166"/>
                <a:chExt cx="779765" cy="706836"/>
              </a:xfrm>
            </p:grpSpPr>
            <p:sp>
              <p:nvSpPr>
                <p:cNvPr id="188" name="Freeform 187"/>
                <p:cNvSpPr/>
                <p:nvPr/>
              </p:nvSpPr>
              <p:spPr>
                <a:xfrm>
                  <a:off x="5323715" y="4095166"/>
                  <a:ext cx="134636" cy="589030"/>
                </a:xfrm>
                <a:custGeom>
                  <a:avLst/>
                  <a:gdLst>
                    <a:gd name="connsiteX0" fmla="*/ 134636 w 134636"/>
                    <a:gd name="connsiteY0" fmla="*/ 0 h 589030"/>
                    <a:gd name="connsiteX1" fmla="*/ 106587 w 134636"/>
                    <a:gd name="connsiteY1" fmla="*/ 11219 h 589030"/>
                    <a:gd name="connsiteX2" fmla="*/ 89757 w 134636"/>
                    <a:gd name="connsiteY2" fmla="*/ 44878 h 589030"/>
                    <a:gd name="connsiteX3" fmla="*/ 67318 w 134636"/>
                    <a:gd name="connsiteY3" fmla="*/ 78537 h 589030"/>
                    <a:gd name="connsiteX4" fmla="*/ 56098 w 134636"/>
                    <a:gd name="connsiteY4" fmla="*/ 95367 h 589030"/>
                    <a:gd name="connsiteX5" fmla="*/ 39269 w 134636"/>
                    <a:gd name="connsiteY5" fmla="*/ 100976 h 589030"/>
                    <a:gd name="connsiteX6" fmla="*/ 16830 w 134636"/>
                    <a:gd name="connsiteY6" fmla="*/ 151465 h 589030"/>
                    <a:gd name="connsiteX7" fmla="*/ 5610 w 134636"/>
                    <a:gd name="connsiteY7" fmla="*/ 185124 h 589030"/>
                    <a:gd name="connsiteX8" fmla="*/ 0 w 134636"/>
                    <a:gd name="connsiteY8" fmla="*/ 218782 h 589030"/>
                    <a:gd name="connsiteX9" fmla="*/ 5610 w 134636"/>
                    <a:gd name="connsiteY9" fmla="*/ 291710 h 589030"/>
                    <a:gd name="connsiteX10" fmla="*/ 16830 w 134636"/>
                    <a:gd name="connsiteY10" fmla="*/ 325369 h 589030"/>
                    <a:gd name="connsiteX11" fmla="*/ 33659 w 134636"/>
                    <a:gd name="connsiteY11" fmla="*/ 336589 h 589030"/>
                    <a:gd name="connsiteX12" fmla="*/ 44879 w 134636"/>
                    <a:gd name="connsiteY12" fmla="*/ 353418 h 589030"/>
                    <a:gd name="connsiteX13" fmla="*/ 61708 w 134636"/>
                    <a:gd name="connsiteY13" fmla="*/ 359028 h 589030"/>
                    <a:gd name="connsiteX14" fmla="*/ 84148 w 134636"/>
                    <a:gd name="connsiteY14" fmla="*/ 392687 h 589030"/>
                    <a:gd name="connsiteX15" fmla="*/ 95367 w 134636"/>
                    <a:gd name="connsiteY15" fmla="*/ 409516 h 589030"/>
                    <a:gd name="connsiteX16" fmla="*/ 89757 w 134636"/>
                    <a:gd name="connsiteY16" fmla="*/ 454395 h 589030"/>
                    <a:gd name="connsiteX17" fmla="*/ 78538 w 134636"/>
                    <a:gd name="connsiteY17" fmla="*/ 488054 h 589030"/>
                    <a:gd name="connsiteX18" fmla="*/ 67318 w 134636"/>
                    <a:gd name="connsiteY18" fmla="*/ 527322 h 589030"/>
                    <a:gd name="connsiteX19" fmla="*/ 72928 w 134636"/>
                    <a:gd name="connsiteY19" fmla="*/ 589030 h 58903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134636" h="589030">
                      <a:moveTo>
                        <a:pt x="134636" y="0"/>
                      </a:moveTo>
                      <a:cubicBezTo>
                        <a:pt x="125286" y="3740"/>
                        <a:pt x="114781" y="5366"/>
                        <a:pt x="106587" y="11219"/>
                      </a:cubicBezTo>
                      <a:cubicBezTo>
                        <a:pt x="92825" y="21049"/>
                        <a:pt x="96852" y="32107"/>
                        <a:pt x="89757" y="44878"/>
                      </a:cubicBezTo>
                      <a:cubicBezTo>
                        <a:pt x="83208" y="56665"/>
                        <a:pt x="74798" y="67317"/>
                        <a:pt x="67318" y="78537"/>
                      </a:cubicBezTo>
                      <a:cubicBezTo>
                        <a:pt x="63578" y="84147"/>
                        <a:pt x="62494" y="93235"/>
                        <a:pt x="56098" y="95367"/>
                      </a:cubicBezTo>
                      <a:lnTo>
                        <a:pt x="39269" y="100976"/>
                      </a:lnTo>
                      <a:cubicBezTo>
                        <a:pt x="21488" y="127647"/>
                        <a:pt x="30182" y="111408"/>
                        <a:pt x="16830" y="151465"/>
                      </a:cubicBezTo>
                      <a:lnTo>
                        <a:pt x="5610" y="185124"/>
                      </a:lnTo>
                      <a:lnTo>
                        <a:pt x="0" y="218782"/>
                      </a:lnTo>
                      <a:cubicBezTo>
                        <a:pt x="1870" y="243091"/>
                        <a:pt x="1807" y="267627"/>
                        <a:pt x="5610" y="291710"/>
                      </a:cubicBezTo>
                      <a:cubicBezTo>
                        <a:pt x="7455" y="303392"/>
                        <a:pt x="6990" y="318809"/>
                        <a:pt x="16830" y="325369"/>
                      </a:cubicBezTo>
                      <a:lnTo>
                        <a:pt x="33659" y="336589"/>
                      </a:lnTo>
                      <a:cubicBezTo>
                        <a:pt x="37399" y="342199"/>
                        <a:pt x="39614" y="349206"/>
                        <a:pt x="44879" y="353418"/>
                      </a:cubicBezTo>
                      <a:cubicBezTo>
                        <a:pt x="49496" y="357112"/>
                        <a:pt x="57527" y="354847"/>
                        <a:pt x="61708" y="359028"/>
                      </a:cubicBezTo>
                      <a:cubicBezTo>
                        <a:pt x="71243" y="368563"/>
                        <a:pt x="76668" y="381467"/>
                        <a:pt x="84148" y="392687"/>
                      </a:cubicBezTo>
                      <a:lnTo>
                        <a:pt x="95367" y="409516"/>
                      </a:lnTo>
                      <a:cubicBezTo>
                        <a:pt x="93497" y="424476"/>
                        <a:pt x="92916" y="439654"/>
                        <a:pt x="89757" y="454395"/>
                      </a:cubicBezTo>
                      <a:cubicBezTo>
                        <a:pt x="87279" y="465959"/>
                        <a:pt x="81406" y="476581"/>
                        <a:pt x="78538" y="488054"/>
                      </a:cubicBezTo>
                      <a:cubicBezTo>
                        <a:pt x="71494" y="516230"/>
                        <a:pt x="75366" y="503179"/>
                        <a:pt x="67318" y="527322"/>
                      </a:cubicBezTo>
                      <a:cubicBezTo>
                        <a:pt x="73114" y="585281"/>
                        <a:pt x="72928" y="564628"/>
                        <a:pt x="72928" y="589030"/>
                      </a:cubicBezTo>
                    </a:path>
                  </a:pathLst>
                </a:custGeom>
                <a:noFill/>
                <a:ln>
                  <a:solidFill>
                    <a:srgbClr val="FFCC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9" name="Freeform 188"/>
                <p:cNvSpPr/>
                <p:nvPr/>
              </p:nvSpPr>
              <p:spPr>
                <a:xfrm>
                  <a:off x="5929575" y="4123215"/>
                  <a:ext cx="157075" cy="622689"/>
                </a:xfrm>
                <a:custGeom>
                  <a:avLst/>
                  <a:gdLst>
                    <a:gd name="connsiteX0" fmla="*/ 0 w 157075"/>
                    <a:gd name="connsiteY0" fmla="*/ 0 h 622689"/>
                    <a:gd name="connsiteX1" fmla="*/ 28050 w 157075"/>
                    <a:gd name="connsiteY1" fmla="*/ 16829 h 622689"/>
                    <a:gd name="connsiteX2" fmla="*/ 39269 w 157075"/>
                    <a:gd name="connsiteY2" fmla="*/ 33659 h 622689"/>
                    <a:gd name="connsiteX3" fmla="*/ 72928 w 157075"/>
                    <a:gd name="connsiteY3" fmla="*/ 56098 h 622689"/>
                    <a:gd name="connsiteX4" fmla="*/ 95367 w 157075"/>
                    <a:gd name="connsiteY4" fmla="*/ 89757 h 622689"/>
                    <a:gd name="connsiteX5" fmla="*/ 106587 w 157075"/>
                    <a:gd name="connsiteY5" fmla="*/ 123416 h 622689"/>
                    <a:gd name="connsiteX6" fmla="*/ 112197 w 157075"/>
                    <a:gd name="connsiteY6" fmla="*/ 207563 h 622689"/>
                    <a:gd name="connsiteX7" fmla="*/ 129026 w 157075"/>
                    <a:gd name="connsiteY7" fmla="*/ 263661 h 622689"/>
                    <a:gd name="connsiteX8" fmla="*/ 140246 w 157075"/>
                    <a:gd name="connsiteY8" fmla="*/ 297320 h 622689"/>
                    <a:gd name="connsiteX9" fmla="*/ 145856 w 157075"/>
                    <a:gd name="connsiteY9" fmla="*/ 314149 h 622689"/>
                    <a:gd name="connsiteX10" fmla="*/ 157075 w 157075"/>
                    <a:gd name="connsiteY10" fmla="*/ 364638 h 622689"/>
                    <a:gd name="connsiteX11" fmla="*/ 151465 w 157075"/>
                    <a:gd name="connsiteY11" fmla="*/ 409516 h 622689"/>
                    <a:gd name="connsiteX12" fmla="*/ 100977 w 157075"/>
                    <a:gd name="connsiteY12" fmla="*/ 426346 h 622689"/>
                    <a:gd name="connsiteX13" fmla="*/ 95367 w 157075"/>
                    <a:gd name="connsiteY13" fmla="*/ 443175 h 622689"/>
                    <a:gd name="connsiteX14" fmla="*/ 123416 w 157075"/>
                    <a:gd name="connsiteY14" fmla="*/ 504883 h 622689"/>
                    <a:gd name="connsiteX15" fmla="*/ 145856 w 157075"/>
                    <a:gd name="connsiteY15" fmla="*/ 555372 h 622689"/>
                    <a:gd name="connsiteX16" fmla="*/ 140246 w 157075"/>
                    <a:gd name="connsiteY16" fmla="*/ 622689 h 62268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157075" h="622689">
                      <a:moveTo>
                        <a:pt x="0" y="0"/>
                      </a:moveTo>
                      <a:cubicBezTo>
                        <a:pt x="9350" y="5610"/>
                        <a:pt x="19771" y="9733"/>
                        <a:pt x="28050" y="16829"/>
                      </a:cubicBezTo>
                      <a:cubicBezTo>
                        <a:pt x="33169" y="21217"/>
                        <a:pt x="34195" y="29219"/>
                        <a:pt x="39269" y="33659"/>
                      </a:cubicBezTo>
                      <a:cubicBezTo>
                        <a:pt x="49417" y="42539"/>
                        <a:pt x="72928" y="56098"/>
                        <a:pt x="72928" y="56098"/>
                      </a:cubicBezTo>
                      <a:cubicBezTo>
                        <a:pt x="91488" y="111775"/>
                        <a:pt x="60348" y="26722"/>
                        <a:pt x="95367" y="89757"/>
                      </a:cubicBezTo>
                      <a:cubicBezTo>
                        <a:pt x="101110" y="100095"/>
                        <a:pt x="106587" y="123416"/>
                        <a:pt x="106587" y="123416"/>
                      </a:cubicBezTo>
                      <a:cubicBezTo>
                        <a:pt x="108457" y="151465"/>
                        <a:pt x="109254" y="179606"/>
                        <a:pt x="112197" y="207563"/>
                      </a:cubicBezTo>
                      <a:cubicBezTo>
                        <a:pt x="113501" y="219951"/>
                        <a:pt x="126374" y="255705"/>
                        <a:pt x="129026" y="263661"/>
                      </a:cubicBezTo>
                      <a:lnTo>
                        <a:pt x="140246" y="297320"/>
                      </a:lnTo>
                      <a:cubicBezTo>
                        <a:pt x="142116" y="302930"/>
                        <a:pt x="144422" y="308412"/>
                        <a:pt x="145856" y="314149"/>
                      </a:cubicBezTo>
                      <a:cubicBezTo>
                        <a:pt x="153777" y="345839"/>
                        <a:pt x="149953" y="329029"/>
                        <a:pt x="157075" y="364638"/>
                      </a:cubicBezTo>
                      <a:cubicBezTo>
                        <a:pt x="155205" y="379597"/>
                        <a:pt x="157064" y="395518"/>
                        <a:pt x="151465" y="409516"/>
                      </a:cubicBezTo>
                      <a:cubicBezTo>
                        <a:pt x="145830" y="423602"/>
                        <a:pt x="106434" y="425436"/>
                        <a:pt x="100977" y="426346"/>
                      </a:cubicBezTo>
                      <a:cubicBezTo>
                        <a:pt x="99107" y="431956"/>
                        <a:pt x="95367" y="437262"/>
                        <a:pt x="95367" y="443175"/>
                      </a:cubicBezTo>
                      <a:cubicBezTo>
                        <a:pt x="95367" y="489091"/>
                        <a:pt x="107362" y="456722"/>
                        <a:pt x="123416" y="504883"/>
                      </a:cubicBezTo>
                      <a:cubicBezTo>
                        <a:pt x="136768" y="544938"/>
                        <a:pt x="128076" y="528702"/>
                        <a:pt x="145856" y="555372"/>
                      </a:cubicBezTo>
                      <a:cubicBezTo>
                        <a:pt x="139874" y="615191"/>
                        <a:pt x="140246" y="592677"/>
                        <a:pt x="140246" y="622689"/>
                      </a:cubicBezTo>
                    </a:path>
                  </a:pathLst>
                </a:custGeom>
                <a:noFill/>
                <a:ln>
                  <a:solidFill>
                    <a:srgbClr val="FFCC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0" name="Freeform 189"/>
                <p:cNvSpPr/>
                <p:nvPr/>
              </p:nvSpPr>
              <p:spPr>
                <a:xfrm>
                  <a:off x="5323715" y="4678587"/>
                  <a:ext cx="78538" cy="33658"/>
                </a:xfrm>
                <a:custGeom>
                  <a:avLst/>
                  <a:gdLst>
                    <a:gd name="connsiteX0" fmla="*/ 0 w 78538"/>
                    <a:gd name="connsiteY0" fmla="*/ 33658 h 33658"/>
                    <a:gd name="connsiteX1" fmla="*/ 28049 w 78538"/>
                    <a:gd name="connsiteY1" fmla="*/ 22439 h 33658"/>
                    <a:gd name="connsiteX2" fmla="*/ 61708 w 78538"/>
                    <a:gd name="connsiteY2" fmla="*/ 11219 h 33658"/>
                    <a:gd name="connsiteX3" fmla="*/ 78538 w 78538"/>
                    <a:gd name="connsiteY3" fmla="*/ 0 h 3365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538" h="33658">
                      <a:moveTo>
                        <a:pt x="0" y="33658"/>
                      </a:moveTo>
                      <a:cubicBezTo>
                        <a:pt x="9350" y="29918"/>
                        <a:pt x="18585" y="25880"/>
                        <a:pt x="28049" y="22439"/>
                      </a:cubicBezTo>
                      <a:cubicBezTo>
                        <a:pt x="39164" y="18397"/>
                        <a:pt x="51867" y="17779"/>
                        <a:pt x="61708" y="11219"/>
                      </a:cubicBezTo>
                      <a:lnTo>
                        <a:pt x="78538" y="0"/>
                      </a:lnTo>
                    </a:path>
                  </a:pathLst>
                </a:custGeom>
                <a:noFill/>
                <a:ln>
                  <a:solidFill>
                    <a:srgbClr val="FFCCFF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1" name="Freeform 190"/>
                <p:cNvSpPr/>
                <p:nvPr/>
              </p:nvSpPr>
              <p:spPr>
                <a:xfrm>
                  <a:off x="6052991" y="4745904"/>
                  <a:ext cx="50489" cy="56098"/>
                </a:xfrm>
                <a:custGeom>
                  <a:avLst/>
                  <a:gdLst>
                    <a:gd name="connsiteX0" fmla="*/ 0 w 50489"/>
                    <a:gd name="connsiteY0" fmla="*/ 0 h 56098"/>
                    <a:gd name="connsiteX1" fmla="*/ 28049 w 50489"/>
                    <a:gd name="connsiteY1" fmla="*/ 22440 h 56098"/>
                    <a:gd name="connsiteX2" fmla="*/ 50489 w 50489"/>
                    <a:gd name="connsiteY2" fmla="*/ 56098 h 5609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50489" h="56098">
                      <a:moveTo>
                        <a:pt x="0" y="0"/>
                      </a:moveTo>
                      <a:cubicBezTo>
                        <a:pt x="9350" y="7480"/>
                        <a:pt x="20039" y="13540"/>
                        <a:pt x="28049" y="22440"/>
                      </a:cubicBezTo>
                      <a:cubicBezTo>
                        <a:pt x="37070" y="32463"/>
                        <a:pt x="50489" y="56098"/>
                        <a:pt x="50489" y="56098"/>
                      </a:cubicBezTo>
                    </a:path>
                  </a:pathLst>
                </a:custGeom>
                <a:noFill/>
                <a:ln>
                  <a:solidFill>
                    <a:srgbClr val="FFCCFF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  <p:sp>
        <p:nvSpPr>
          <p:cNvPr id="204" name="TextBox 203"/>
          <p:cNvSpPr txBox="1"/>
          <p:nvPr/>
        </p:nvSpPr>
        <p:spPr>
          <a:xfrm>
            <a:off x="4130040" y="2156936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4663440" y="2156936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4053840" y="3516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4739640" y="3516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4053840" y="1688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V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4739640" y="1688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V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3520440" y="2766536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5196840" y="2766536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4130040" y="2743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4587240" y="2743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4358640" y="2450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B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6858000" y="3505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7543800" y="3505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6553200" y="2362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7924800" y="2362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7239000" y="2754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B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8" name="Content Placeholder 2"/>
          <p:cNvSpPr txBox="1">
            <a:spLocks/>
          </p:cNvSpPr>
          <p:nvPr/>
        </p:nvSpPr>
        <p:spPr>
          <a:xfrm>
            <a:off x="3278223" y="4243219"/>
            <a:ext cx="3662402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VF = left ventral fron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dirty="0" smtClean="0">
                <a:solidFill>
                  <a:schemeClr val="bg1"/>
                </a:solidFill>
              </a:rPr>
              <a:t>RVF = right ventral fron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P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= left </a:t>
            </a:r>
            <a:r>
              <a:rPr kumimoji="0" lang="en-US" b="0" i="0" u="none" strike="noStrike" kern="1200" cap="none" spc="0" normalizeH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ariet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-occipi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baseline="0" dirty="0" smtClean="0">
                <a:solidFill>
                  <a:schemeClr val="bg1"/>
                </a:solidFill>
              </a:rPr>
              <a:t>RPO</a:t>
            </a:r>
            <a:r>
              <a:rPr lang="en-US" dirty="0" smtClean="0">
                <a:solidFill>
                  <a:schemeClr val="bg1"/>
                </a:solidFill>
              </a:rPr>
              <a:t> = right </a:t>
            </a:r>
            <a:r>
              <a:rPr lang="en-US" dirty="0" err="1" smtClean="0">
                <a:solidFill>
                  <a:schemeClr val="bg1"/>
                </a:solidFill>
              </a:rPr>
              <a:t>pareto</a:t>
            </a:r>
            <a:r>
              <a:rPr lang="en-US" dirty="0" smtClean="0">
                <a:solidFill>
                  <a:schemeClr val="bg1"/>
                </a:solidFill>
              </a:rPr>
              <a:t>-occipital</a:t>
            </a:r>
          </a:p>
        </p:txBody>
      </p:sp>
      <p:sp>
        <p:nvSpPr>
          <p:cNvPr id="89" name="Content Placeholder 2"/>
          <p:cNvSpPr txBox="1">
            <a:spLocks/>
          </p:cNvSpPr>
          <p:nvPr/>
        </p:nvSpPr>
        <p:spPr>
          <a:xfrm>
            <a:off x="6211506" y="4243289"/>
            <a:ext cx="3662402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BC = brainstem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&amp; cerebellum</a:t>
            </a:r>
          </a:p>
          <a:p>
            <a:pPr lvl="0">
              <a:spcBef>
                <a:spcPct val="20000"/>
              </a:spcBef>
              <a:defRPr/>
            </a:pPr>
            <a:r>
              <a:rPr lang="en-US" dirty="0">
                <a:solidFill>
                  <a:schemeClr val="bg1"/>
                </a:solidFill>
              </a:rPr>
              <a:t>SC = subcortical</a:t>
            </a:r>
          </a:p>
          <a:p>
            <a:pPr lvl="0">
              <a:spcBef>
                <a:spcPct val="20000"/>
              </a:spcBef>
              <a:defRPr/>
            </a:pPr>
            <a:r>
              <a:rPr lang="en-US" dirty="0">
                <a:solidFill>
                  <a:schemeClr val="bg1"/>
                </a:solidFill>
              </a:rPr>
              <a:t>LT = left temporal</a:t>
            </a:r>
          </a:p>
          <a:p>
            <a:pPr lvl="0">
              <a:spcBef>
                <a:spcPct val="20000"/>
              </a:spcBef>
              <a:defRPr/>
            </a:pPr>
            <a:r>
              <a:rPr lang="en-US" dirty="0">
                <a:solidFill>
                  <a:schemeClr val="bg1"/>
                </a:solidFill>
              </a:rPr>
              <a:t>RT = right temporal</a:t>
            </a:r>
            <a:endParaRPr lang="en-US" dirty="0">
              <a:solidFill>
                <a:schemeClr val="accent3"/>
              </a:solidFill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627474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657600" y="990600"/>
            <a:ext cx="2560320" cy="3657600"/>
            <a:chOff x="2883801" y="2245519"/>
            <a:chExt cx="3210373" cy="460121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3801" y="2245519"/>
              <a:ext cx="3210373" cy="4601217"/>
            </a:xfrm>
            <a:prstGeom prst="rect">
              <a:avLst/>
            </a:prstGeom>
          </p:spPr>
        </p:pic>
        <p:grpSp>
          <p:nvGrpSpPr>
            <p:cNvPr id="4" name="Group 3"/>
            <p:cNvGrpSpPr/>
            <p:nvPr/>
          </p:nvGrpSpPr>
          <p:grpSpPr>
            <a:xfrm>
              <a:off x="4446254" y="2984360"/>
              <a:ext cx="70688" cy="939521"/>
              <a:chOff x="4446254" y="2984360"/>
              <a:chExt cx="70688" cy="939521"/>
            </a:xfrm>
          </p:grpSpPr>
          <p:sp>
            <p:nvSpPr>
              <p:cNvPr id="19" name="Freeform 18"/>
              <p:cNvSpPr/>
              <p:nvPr/>
            </p:nvSpPr>
            <p:spPr>
              <a:xfrm>
                <a:off x="4446254" y="2984360"/>
                <a:ext cx="70688" cy="773724"/>
              </a:xfrm>
              <a:custGeom>
                <a:avLst/>
                <a:gdLst>
                  <a:gd name="connsiteX0" fmla="*/ 5166 w 70688"/>
                  <a:gd name="connsiteY0" fmla="*/ 0 h 773724"/>
                  <a:gd name="connsiteX1" fmla="*/ 142 w 70688"/>
                  <a:gd name="connsiteY1" fmla="*/ 195943 h 773724"/>
                  <a:gd name="connsiteX2" fmla="*/ 5166 w 70688"/>
                  <a:gd name="connsiteY2" fmla="*/ 251209 h 773724"/>
                  <a:gd name="connsiteX3" fmla="*/ 50383 w 70688"/>
                  <a:gd name="connsiteY3" fmla="*/ 281354 h 773724"/>
                  <a:gd name="connsiteX4" fmla="*/ 70480 w 70688"/>
                  <a:gd name="connsiteY4" fmla="*/ 306475 h 773724"/>
                  <a:gd name="connsiteX5" fmla="*/ 65456 w 70688"/>
                  <a:gd name="connsiteY5" fmla="*/ 336620 h 773724"/>
                  <a:gd name="connsiteX6" fmla="*/ 55408 w 70688"/>
                  <a:gd name="connsiteY6" fmla="*/ 366765 h 773724"/>
                  <a:gd name="connsiteX7" fmla="*/ 50383 w 70688"/>
                  <a:gd name="connsiteY7" fmla="*/ 381838 h 773724"/>
                  <a:gd name="connsiteX8" fmla="*/ 40335 w 70688"/>
                  <a:gd name="connsiteY8" fmla="*/ 396910 h 773724"/>
                  <a:gd name="connsiteX9" fmla="*/ 35311 w 70688"/>
                  <a:gd name="connsiteY9" fmla="*/ 411983 h 773724"/>
                  <a:gd name="connsiteX10" fmla="*/ 40335 w 70688"/>
                  <a:gd name="connsiteY10" fmla="*/ 482321 h 773724"/>
                  <a:gd name="connsiteX11" fmla="*/ 50383 w 70688"/>
                  <a:gd name="connsiteY11" fmla="*/ 512466 h 773724"/>
                  <a:gd name="connsiteX12" fmla="*/ 55408 w 70688"/>
                  <a:gd name="connsiteY12" fmla="*/ 537587 h 773724"/>
                  <a:gd name="connsiteX13" fmla="*/ 65456 w 70688"/>
                  <a:gd name="connsiteY13" fmla="*/ 773724 h 7737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688" h="773724">
                    <a:moveTo>
                      <a:pt x="5166" y="0"/>
                    </a:moveTo>
                    <a:cubicBezTo>
                      <a:pt x="3491" y="65314"/>
                      <a:pt x="142" y="130607"/>
                      <a:pt x="142" y="195943"/>
                    </a:cubicBezTo>
                    <a:cubicBezTo>
                      <a:pt x="142" y="214441"/>
                      <a:pt x="-1329" y="233889"/>
                      <a:pt x="5166" y="251209"/>
                    </a:cubicBezTo>
                    <a:cubicBezTo>
                      <a:pt x="14477" y="276039"/>
                      <a:pt x="30863" y="276474"/>
                      <a:pt x="50383" y="281354"/>
                    </a:cubicBezTo>
                    <a:cubicBezTo>
                      <a:pt x="55378" y="286349"/>
                      <a:pt x="69688" y="299345"/>
                      <a:pt x="70480" y="306475"/>
                    </a:cubicBezTo>
                    <a:cubicBezTo>
                      <a:pt x="71605" y="316600"/>
                      <a:pt x="67927" y="326737"/>
                      <a:pt x="65456" y="336620"/>
                    </a:cubicBezTo>
                    <a:cubicBezTo>
                      <a:pt x="62887" y="346896"/>
                      <a:pt x="58757" y="356717"/>
                      <a:pt x="55408" y="366765"/>
                    </a:cubicBezTo>
                    <a:cubicBezTo>
                      <a:pt x="53733" y="371789"/>
                      <a:pt x="53321" y="377431"/>
                      <a:pt x="50383" y="381838"/>
                    </a:cubicBezTo>
                    <a:lnTo>
                      <a:pt x="40335" y="396910"/>
                    </a:lnTo>
                    <a:cubicBezTo>
                      <a:pt x="38660" y="401934"/>
                      <a:pt x="35311" y="406687"/>
                      <a:pt x="35311" y="411983"/>
                    </a:cubicBezTo>
                    <a:cubicBezTo>
                      <a:pt x="35311" y="435489"/>
                      <a:pt x="36848" y="459075"/>
                      <a:pt x="40335" y="482321"/>
                    </a:cubicBezTo>
                    <a:cubicBezTo>
                      <a:pt x="41906" y="492796"/>
                      <a:pt x="48305" y="502080"/>
                      <a:pt x="50383" y="512466"/>
                    </a:cubicBezTo>
                    <a:lnTo>
                      <a:pt x="55408" y="537587"/>
                    </a:lnTo>
                    <a:cubicBezTo>
                      <a:pt x="68655" y="696553"/>
                      <a:pt x="65456" y="617834"/>
                      <a:pt x="65456" y="773724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Freeform 19"/>
              <p:cNvSpPr/>
              <p:nvPr/>
            </p:nvSpPr>
            <p:spPr>
              <a:xfrm>
                <a:off x="4506686" y="3753059"/>
                <a:ext cx="10231" cy="170822"/>
              </a:xfrm>
              <a:custGeom>
                <a:avLst/>
                <a:gdLst>
                  <a:gd name="connsiteX0" fmla="*/ 0 w 10231"/>
                  <a:gd name="connsiteY0" fmla="*/ 0 h 170822"/>
                  <a:gd name="connsiteX1" fmla="*/ 5024 w 10231"/>
                  <a:gd name="connsiteY1" fmla="*/ 90436 h 170822"/>
                  <a:gd name="connsiteX2" fmla="*/ 10048 w 10231"/>
                  <a:gd name="connsiteY2" fmla="*/ 170822 h 1708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231" h="170822">
                    <a:moveTo>
                      <a:pt x="0" y="0"/>
                    </a:moveTo>
                    <a:cubicBezTo>
                      <a:pt x="1675" y="30145"/>
                      <a:pt x="2708" y="60333"/>
                      <a:pt x="5024" y="90436"/>
                    </a:cubicBezTo>
                    <a:cubicBezTo>
                      <a:pt x="11710" y="177354"/>
                      <a:pt x="10048" y="83955"/>
                      <a:pt x="10048" y="170822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" name="Freeform 4"/>
            <p:cNvSpPr/>
            <p:nvPr/>
          </p:nvSpPr>
          <p:spPr>
            <a:xfrm>
              <a:off x="3235569" y="3913833"/>
              <a:ext cx="301451" cy="65314"/>
            </a:xfrm>
            <a:custGeom>
              <a:avLst/>
              <a:gdLst>
                <a:gd name="connsiteX0" fmla="*/ 0 w 301451"/>
                <a:gd name="connsiteY0" fmla="*/ 0 h 65314"/>
                <a:gd name="connsiteX1" fmla="*/ 30145 w 301451"/>
                <a:gd name="connsiteY1" fmla="*/ 5024 h 65314"/>
                <a:gd name="connsiteX2" fmla="*/ 40194 w 301451"/>
                <a:gd name="connsiteY2" fmla="*/ 15072 h 65314"/>
                <a:gd name="connsiteX3" fmla="*/ 55266 w 301451"/>
                <a:gd name="connsiteY3" fmla="*/ 20097 h 65314"/>
                <a:gd name="connsiteX4" fmla="*/ 65315 w 301451"/>
                <a:gd name="connsiteY4" fmla="*/ 30145 h 65314"/>
                <a:gd name="connsiteX5" fmla="*/ 95460 w 301451"/>
                <a:gd name="connsiteY5" fmla="*/ 40193 h 65314"/>
                <a:gd name="connsiteX6" fmla="*/ 105508 w 301451"/>
                <a:gd name="connsiteY6" fmla="*/ 50242 h 65314"/>
                <a:gd name="connsiteX7" fmla="*/ 120580 w 301451"/>
                <a:gd name="connsiteY7" fmla="*/ 55266 h 65314"/>
                <a:gd name="connsiteX8" fmla="*/ 185895 w 301451"/>
                <a:gd name="connsiteY8" fmla="*/ 65314 h 65314"/>
                <a:gd name="connsiteX9" fmla="*/ 226088 w 301451"/>
                <a:gd name="connsiteY9" fmla="*/ 55266 h 65314"/>
                <a:gd name="connsiteX10" fmla="*/ 241161 w 301451"/>
                <a:gd name="connsiteY10" fmla="*/ 45218 h 65314"/>
                <a:gd name="connsiteX11" fmla="*/ 271306 w 301451"/>
                <a:gd name="connsiteY11" fmla="*/ 35169 h 65314"/>
                <a:gd name="connsiteX12" fmla="*/ 281354 w 301451"/>
                <a:gd name="connsiteY12" fmla="*/ 20097 h 65314"/>
                <a:gd name="connsiteX13" fmla="*/ 301451 w 301451"/>
                <a:gd name="connsiteY13" fmla="*/ 5024 h 653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301451" h="65314">
                  <a:moveTo>
                    <a:pt x="0" y="0"/>
                  </a:moveTo>
                  <a:cubicBezTo>
                    <a:pt x="10048" y="1675"/>
                    <a:pt x="20607" y="1447"/>
                    <a:pt x="30145" y="5024"/>
                  </a:cubicBezTo>
                  <a:cubicBezTo>
                    <a:pt x="34580" y="6687"/>
                    <a:pt x="36132" y="12635"/>
                    <a:pt x="40194" y="15072"/>
                  </a:cubicBezTo>
                  <a:cubicBezTo>
                    <a:pt x="44735" y="17797"/>
                    <a:pt x="50242" y="18422"/>
                    <a:pt x="55266" y="20097"/>
                  </a:cubicBezTo>
                  <a:cubicBezTo>
                    <a:pt x="58616" y="23446"/>
                    <a:pt x="61078" y="28027"/>
                    <a:pt x="65315" y="30145"/>
                  </a:cubicBezTo>
                  <a:cubicBezTo>
                    <a:pt x="74789" y="34882"/>
                    <a:pt x="95460" y="40193"/>
                    <a:pt x="95460" y="40193"/>
                  </a:cubicBezTo>
                  <a:cubicBezTo>
                    <a:pt x="98809" y="43543"/>
                    <a:pt x="101446" y="47805"/>
                    <a:pt x="105508" y="50242"/>
                  </a:cubicBezTo>
                  <a:cubicBezTo>
                    <a:pt x="110049" y="52967"/>
                    <a:pt x="115442" y="53982"/>
                    <a:pt x="120580" y="55266"/>
                  </a:cubicBezTo>
                  <a:cubicBezTo>
                    <a:pt x="143596" y="61020"/>
                    <a:pt x="161490" y="62264"/>
                    <a:pt x="185895" y="65314"/>
                  </a:cubicBezTo>
                  <a:cubicBezTo>
                    <a:pt x="195451" y="63403"/>
                    <a:pt x="215788" y="60416"/>
                    <a:pt x="226088" y="55266"/>
                  </a:cubicBezTo>
                  <a:cubicBezTo>
                    <a:pt x="231489" y="52566"/>
                    <a:pt x="235643" y="47670"/>
                    <a:pt x="241161" y="45218"/>
                  </a:cubicBezTo>
                  <a:cubicBezTo>
                    <a:pt x="250840" y="40916"/>
                    <a:pt x="271306" y="35169"/>
                    <a:pt x="271306" y="35169"/>
                  </a:cubicBezTo>
                  <a:cubicBezTo>
                    <a:pt x="274655" y="30145"/>
                    <a:pt x="276639" y="23869"/>
                    <a:pt x="281354" y="20097"/>
                  </a:cubicBezTo>
                  <a:cubicBezTo>
                    <a:pt x="307222" y="-598"/>
                    <a:pt x="288938" y="30051"/>
                    <a:pt x="301451" y="5024"/>
                  </a:cubicBezTo>
                </a:path>
              </a:pathLst>
            </a:custGeom>
            <a:noFill/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Freeform 5"/>
            <p:cNvSpPr/>
            <p:nvPr/>
          </p:nvSpPr>
          <p:spPr>
            <a:xfrm>
              <a:off x="5511521" y="3783204"/>
              <a:ext cx="200986" cy="160774"/>
            </a:xfrm>
            <a:custGeom>
              <a:avLst/>
              <a:gdLst>
                <a:gd name="connsiteX0" fmla="*/ 0 w 200986"/>
                <a:gd name="connsiteY0" fmla="*/ 160774 h 160774"/>
                <a:gd name="connsiteX1" fmla="*/ 25121 w 200986"/>
                <a:gd name="connsiteY1" fmla="*/ 145701 h 160774"/>
                <a:gd name="connsiteX2" fmla="*/ 40193 w 200986"/>
                <a:gd name="connsiteY2" fmla="*/ 140677 h 160774"/>
                <a:gd name="connsiteX3" fmla="*/ 65314 w 200986"/>
                <a:gd name="connsiteY3" fmla="*/ 125605 h 160774"/>
                <a:gd name="connsiteX4" fmla="*/ 75363 w 200986"/>
                <a:gd name="connsiteY4" fmla="*/ 115556 h 160774"/>
                <a:gd name="connsiteX5" fmla="*/ 105508 w 200986"/>
                <a:gd name="connsiteY5" fmla="*/ 105508 h 160774"/>
                <a:gd name="connsiteX6" fmla="*/ 120580 w 200986"/>
                <a:gd name="connsiteY6" fmla="*/ 95460 h 160774"/>
                <a:gd name="connsiteX7" fmla="*/ 135653 w 200986"/>
                <a:gd name="connsiteY7" fmla="*/ 90436 h 160774"/>
                <a:gd name="connsiteX8" fmla="*/ 155749 w 200986"/>
                <a:gd name="connsiteY8" fmla="*/ 65315 h 160774"/>
                <a:gd name="connsiteX9" fmla="*/ 170822 w 200986"/>
                <a:gd name="connsiteY9" fmla="*/ 60291 h 160774"/>
                <a:gd name="connsiteX10" fmla="*/ 190919 w 200986"/>
                <a:gd name="connsiteY10" fmla="*/ 20097 h 160774"/>
                <a:gd name="connsiteX11" fmla="*/ 190919 w 200986"/>
                <a:gd name="connsiteY11" fmla="*/ 20097 h 160774"/>
                <a:gd name="connsiteX12" fmla="*/ 200967 w 200986"/>
                <a:gd name="connsiteY12" fmla="*/ 0 h 1607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200986" h="160774">
                  <a:moveTo>
                    <a:pt x="0" y="160774"/>
                  </a:moveTo>
                  <a:cubicBezTo>
                    <a:pt x="8374" y="155750"/>
                    <a:pt x="16387" y="150068"/>
                    <a:pt x="25121" y="145701"/>
                  </a:cubicBezTo>
                  <a:cubicBezTo>
                    <a:pt x="29858" y="143333"/>
                    <a:pt x="35652" y="143402"/>
                    <a:pt x="40193" y="140677"/>
                  </a:cubicBezTo>
                  <a:cubicBezTo>
                    <a:pt x="74676" y="119988"/>
                    <a:pt x="22619" y="139837"/>
                    <a:pt x="65314" y="125605"/>
                  </a:cubicBezTo>
                  <a:cubicBezTo>
                    <a:pt x="68664" y="122255"/>
                    <a:pt x="71126" y="117675"/>
                    <a:pt x="75363" y="115556"/>
                  </a:cubicBezTo>
                  <a:cubicBezTo>
                    <a:pt x="84837" y="110819"/>
                    <a:pt x="105508" y="105508"/>
                    <a:pt x="105508" y="105508"/>
                  </a:cubicBezTo>
                  <a:cubicBezTo>
                    <a:pt x="110532" y="102159"/>
                    <a:pt x="115179" y="98160"/>
                    <a:pt x="120580" y="95460"/>
                  </a:cubicBezTo>
                  <a:cubicBezTo>
                    <a:pt x="125317" y="93092"/>
                    <a:pt x="131112" y="93161"/>
                    <a:pt x="135653" y="90436"/>
                  </a:cubicBezTo>
                  <a:cubicBezTo>
                    <a:pt x="156137" y="78145"/>
                    <a:pt x="135213" y="81743"/>
                    <a:pt x="155749" y="65315"/>
                  </a:cubicBezTo>
                  <a:cubicBezTo>
                    <a:pt x="159885" y="62007"/>
                    <a:pt x="165798" y="61966"/>
                    <a:pt x="170822" y="60291"/>
                  </a:cubicBezTo>
                  <a:cubicBezTo>
                    <a:pt x="188359" y="42752"/>
                    <a:pt x="179372" y="54736"/>
                    <a:pt x="190919" y="20097"/>
                  </a:cubicBezTo>
                  <a:lnTo>
                    <a:pt x="190919" y="20097"/>
                  </a:lnTo>
                  <a:cubicBezTo>
                    <a:pt x="201896" y="3631"/>
                    <a:pt x="200967" y="11063"/>
                    <a:pt x="200967" y="0"/>
                  </a:cubicBezTo>
                </a:path>
              </a:pathLst>
            </a:custGeom>
            <a:noFill/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Freeform 6"/>
            <p:cNvSpPr/>
            <p:nvPr/>
          </p:nvSpPr>
          <p:spPr>
            <a:xfrm>
              <a:off x="3898760" y="3877480"/>
              <a:ext cx="622998" cy="704568"/>
            </a:xfrm>
            <a:custGeom>
              <a:avLst/>
              <a:gdLst>
                <a:gd name="connsiteX0" fmla="*/ 231113 w 622998"/>
                <a:gd name="connsiteY0" fmla="*/ 704568 h 704568"/>
                <a:gd name="connsiteX1" fmla="*/ 216040 w 622998"/>
                <a:gd name="connsiteY1" fmla="*/ 679447 h 704568"/>
                <a:gd name="connsiteX2" fmla="*/ 185895 w 622998"/>
                <a:gd name="connsiteY2" fmla="*/ 669399 h 704568"/>
                <a:gd name="connsiteX3" fmla="*/ 170822 w 622998"/>
                <a:gd name="connsiteY3" fmla="*/ 664375 h 704568"/>
                <a:gd name="connsiteX4" fmla="*/ 145702 w 622998"/>
                <a:gd name="connsiteY4" fmla="*/ 639254 h 704568"/>
                <a:gd name="connsiteX5" fmla="*/ 120581 w 622998"/>
                <a:gd name="connsiteY5" fmla="*/ 624182 h 704568"/>
                <a:gd name="connsiteX6" fmla="*/ 95460 w 622998"/>
                <a:gd name="connsiteY6" fmla="*/ 609109 h 704568"/>
                <a:gd name="connsiteX7" fmla="*/ 85411 w 622998"/>
                <a:gd name="connsiteY7" fmla="*/ 599061 h 704568"/>
                <a:gd name="connsiteX8" fmla="*/ 70339 w 622998"/>
                <a:gd name="connsiteY8" fmla="*/ 594036 h 704568"/>
                <a:gd name="connsiteX9" fmla="*/ 40194 w 622998"/>
                <a:gd name="connsiteY9" fmla="*/ 578964 h 704568"/>
                <a:gd name="connsiteX10" fmla="*/ 30145 w 622998"/>
                <a:gd name="connsiteY10" fmla="*/ 568916 h 704568"/>
                <a:gd name="connsiteX11" fmla="*/ 25121 w 622998"/>
                <a:gd name="connsiteY11" fmla="*/ 553843 h 704568"/>
                <a:gd name="connsiteX12" fmla="*/ 15073 w 622998"/>
                <a:gd name="connsiteY12" fmla="*/ 538771 h 704568"/>
                <a:gd name="connsiteX13" fmla="*/ 5025 w 622998"/>
                <a:gd name="connsiteY13" fmla="*/ 508625 h 704568"/>
                <a:gd name="connsiteX14" fmla="*/ 0 w 622998"/>
                <a:gd name="connsiteY14" fmla="*/ 493553 h 704568"/>
                <a:gd name="connsiteX15" fmla="*/ 5025 w 622998"/>
                <a:gd name="connsiteY15" fmla="*/ 347852 h 704568"/>
                <a:gd name="connsiteX16" fmla="*/ 15073 w 622998"/>
                <a:gd name="connsiteY16" fmla="*/ 317707 h 704568"/>
                <a:gd name="connsiteX17" fmla="*/ 25121 w 622998"/>
                <a:gd name="connsiteY17" fmla="*/ 287562 h 704568"/>
                <a:gd name="connsiteX18" fmla="*/ 35170 w 622998"/>
                <a:gd name="connsiteY18" fmla="*/ 257417 h 704568"/>
                <a:gd name="connsiteX19" fmla="*/ 45218 w 622998"/>
                <a:gd name="connsiteY19" fmla="*/ 247368 h 704568"/>
                <a:gd name="connsiteX20" fmla="*/ 60291 w 622998"/>
                <a:gd name="connsiteY20" fmla="*/ 222247 h 704568"/>
                <a:gd name="connsiteX21" fmla="*/ 80387 w 622998"/>
                <a:gd name="connsiteY21" fmla="*/ 197127 h 704568"/>
                <a:gd name="connsiteX22" fmla="*/ 105508 w 622998"/>
                <a:gd name="connsiteY22" fmla="*/ 161957 h 704568"/>
                <a:gd name="connsiteX23" fmla="*/ 125605 w 622998"/>
                <a:gd name="connsiteY23" fmla="*/ 136836 h 704568"/>
                <a:gd name="connsiteX24" fmla="*/ 145702 w 622998"/>
                <a:gd name="connsiteY24" fmla="*/ 106691 h 704568"/>
                <a:gd name="connsiteX25" fmla="*/ 155750 w 622998"/>
                <a:gd name="connsiteY25" fmla="*/ 91619 h 704568"/>
                <a:gd name="connsiteX26" fmla="*/ 170822 w 622998"/>
                <a:gd name="connsiteY26" fmla="*/ 86595 h 704568"/>
                <a:gd name="connsiteX27" fmla="*/ 190919 w 622998"/>
                <a:gd name="connsiteY27" fmla="*/ 61474 h 704568"/>
                <a:gd name="connsiteX28" fmla="*/ 211016 w 622998"/>
                <a:gd name="connsiteY28" fmla="*/ 41377 h 704568"/>
                <a:gd name="connsiteX29" fmla="*/ 226088 w 622998"/>
                <a:gd name="connsiteY29" fmla="*/ 31329 h 704568"/>
                <a:gd name="connsiteX30" fmla="*/ 236137 w 622998"/>
                <a:gd name="connsiteY30" fmla="*/ 21280 h 704568"/>
                <a:gd name="connsiteX31" fmla="*/ 251209 w 622998"/>
                <a:gd name="connsiteY31" fmla="*/ 16256 h 704568"/>
                <a:gd name="connsiteX32" fmla="*/ 256233 w 622998"/>
                <a:gd name="connsiteY32" fmla="*/ 1184 h 704568"/>
                <a:gd name="connsiteX33" fmla="*/ 316524 w 622998"/>
                <a:gd name="connsiteY33" fmla="*/ 11232 h 704568"/>
                <a:gd name="connsiteX34" fmla="*/ 331596 w 622998"/>
                <a:gd name="connsiteY34" fmla="*/ 41377 h 704568"/>
                <a:gd name="connsiteX35" fmla="*/ 346669 w 622998"/>
                <a:gd name="connsiteY35" fmla="*/ 51425 h 704568"/>
                <a:gd name="connsiteX36" fmla="*/ 366765 w 622998"/>
                <a:gd name="connsiteY36" fmla="*/ 96643 h 704568"/>
                <a:gd name="connsiteX37" fmla="*/ 371789 w 622998"/>
                <a:gd name="connsiteY37" fmla="*/ 111716 h 704568"/>
                <a:gd name="connsiteX38" fmla="*/ 381838 w 622998"/>
                <a:gd name="connsiteY38" fmla="*/ 121764 h 704568"/>
                <a:gd name="connsiteX39" fmla="*/ 401935 w 622998"/>
                <a:gd name="connsiteY39" fmla="*/ 161957 h 704568"/>
                <a:gd name="connsiteX40" fmla="*/ 432080 w 622998"/>
                <a:gd name="connsiteY40" fmla="*/ 172006 h 704568"/>
                <a:gd name="connsiteX41" fmla="*/ 472273 w 622998"/>
                <a:gd name="connsiteY41" fmla="*/ 182054 h 704568"/>
                <a:gd name="connsiteX42" fmla="*/ 517491 w 622998"/>
                <a:gd name="connsiteY42" fmla="*/ 177030 h 704568"/>
                <a:gd name="connsiteX43" fmla="*/ 547636 w 622998"/>
                <a:gd name="connsiteY43" fmla="*/ 187078 h 704568"/>
                <a:gd name="connsiteX44" fmla="*/ 552660 w 622998"/>
                <a:gd name="connsiteY44" fmla="*/ 202151 h 704568"/>
                <a:gd name="connsiteX45" fmla="*/ 572756 w 622998"/>
                <a:gd name="connsiteY45" fmla="*/ 227272 h 704568"/>
                <a:gd name="connsiteX46" fmla="*/ 592853 w 622998"/>
                <a:gd name="connsiteY46" fmla="*/ 272489 h 704568"/>
                <a:gd name="connsiteX47" fmla="*/ 597877 w 622998"/>
                <a:gd name="connsiteY47" fmla="*/ 287562 h 704568"/>
                <a:gd name="connsiteX48" fmla="*/ 607926 w 622998"/>
                <a:gd name="connsiteY48" fmla="*/ 297610 h 704568"/>
                <a:gd name="connsiteX49" fmla="*/ 622998 w 622998"/>
                <a:gd name="connsiteY49" fmla="*/ 327755 h 704568"/>
                <a:gd name="connsiteX50" fmla="*/ 607926 w 622998"/>
                <a:gd name="connsiteY50" fmla="*/ 443311 h 704568"/>
                <a:gd name="connsiteX51" fmla="*/ 597877 w 622998"/>
                <a:gd name="connsiteY51" fmla="*/ 458384 h 704568"/>
                <a:gd name="connsiteX52" fmla="*/ 587829 w 622998"/>
                <a:gd name="connsiteY52" fmla="*/ 523698 h 704568"/>
                <a:gd name="connsiteX53" fmla="*/ 572756 w 622998"/>
                <a:gd name="connsiteY53" fmla="*/ 538771 h 7045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</a:cxnLst>
              <a:rect l="l" t="t" r="r" b="b"/>
              <a:pathLst>
                <a:path w="622998" h="704568">
                  <a:moveTo>
                    <a:pt x="231113" y="704568"/>
                  </a:moveTo>
                  <a:cubicBezTo>
                    <a:pt x="226089" y="696194"/>
                    <a:pt x="223748" y="685442"/>
                    <a:pt x="216040" y="679447"/>
                  </a:cubicBezTo>
                  <a:cubicBezTo>
                    <a:pt x="207679" y="672944"/>
                    <a:pt x="195943" y="672748"/>
                    <a:pt x="185895" y="669399"/>
                  </a:cubicBezTo>
                  <a:lnTo>
                    <a:pt x="170822" y="664375"/>
                  </a:lnTo>
                  <a:cubicBezTo>
                    <a:pt x="153598" y="638538"/>
                    <a:pt x="169624" y="658391"/>
                    <a:pt x="145702" y="639254"/>
                  </a:cubicBezTo>
                  <a:cubicBezTo>
                    <a:pt x="125998" y="623491"/>
                    <a:pt x="146754" y="632906"/>
                    <a:pt x="120581" y="624182"/>
                  </a:cubicBezTo>
                  <a:cubicBezTo>
                    <a:pt x="95121" y="598722"/>
                    <a:pt x="128068" y="628673"/>
                    <a:pt x="95460" y="609109"/>
                  </a:cubicBezTo>
                  <a:cubicBezTo>
                    <a:pt x="91398" y="606672"/>
                    <a:pt x="89473" y="601498"/>
                    <a:pt x="85411" y="599061"/>
                  </a:cubicBezTo>
                  <a:cubicBezTo>
                    <a:pt x="80870" y="596336"/>
                    <a:pt x="75076" y="596404"/>
                    <a:pt x="70339" y="594036"/>
                  </a:cubicBezTo>
                  <a:cubicBezTo>
                    <a:pt x="31389" y="574560"/>
                    <a:pt x="78070" y="591589"/>
                    <a:pt x="40194" y="578964"/>
                  </a:cubicBezTo>
                  <a:cubicBezTo>
                    <a:pt x="36844" y="575615"/>
                    <a:pt x="32582" y="572978"/>
                    <a:pt x="30145" y="568916"/>
                  </a:cubicBezTo>
                  <a:cubicBezTo>
                    <a:pt x="27420" y="564375"/>
                    <a:pt x="27489" y="558580"/>
                    <a:pt x="25121" y="553843"/>
                  </a:cubicBezTo>
                  <a:cubicBezTo>
                    <a:pt x="22421" y="548442"/>
                    <a:pt x="18422" y="543795"/>
                    <a:pt x="15073" y="538771"/>
                  </a:cubicBezTo>
                  <a:lnTo>
                    <a:pt x="5025" y="508625"/>
                  </a:lnTo>
                  <a:lnTo>
                    <a:pt x="0" y="493553"/>
                  </a:lnTo>
                  <a:cubicBezTo>
                    <a:pt x="1675" y="444986"/>
                    <a:pt x="875" y="396270"/>
                    <a:pt x="5025" y="347852"/>
                  </a:cubicBezTo>
                  <a:cubicBezTo>
                    <a:pt x="5930" y="337299"/>
                    <a:pt x="11724" y="327755"/>
                    <a:pt x="15073" y="317707"/>
                  </a:cubicBezTo>
                  <a:lnTo>
                    <a:pt x="25121" y="287562"/>
                  </a:lnTo>
                  <a:lnTo>
                    <a:pt x="35170" y="257417"/>
                  </a:lnTo>
                  <a:lnTo>
                    <a:pt x="45218" y="247368"/>
                  </a:lnTo>
                  <a:cubicBezTo>
                    <a:pt x="59449" y="204674"/>
                    <a:pt x="39601" y="256729"/>
                    <a:pt x="60291" y="222247"/>
                  </a:cubicBezTo>
                  <a:cubicBezTo>
                    <a:pt x="76470" y="195283"/>
                    <a:pt x="50367" y="217140"/>
                    <a:pt x="80387" y="197127"/>
                  </a:cubicBezTo>
                  <a:cubicBezTo>
                    <a:pt x="92849" y="159739"/>
                    <a:pt x="73720" y="209639"/>
                    <a:pt x="105508" y="161957"/>
                  </a:cubicBezTo>
                  <a:cubicBezTo>
                    <a:pt x="118184" y="142943"/>
                    <a:pt x="111286" y="151155"/>
                    <a:pt x="125605" y="136836"/>
                  </a:cubicBezTo>
                  <a:cubicBezTo>
                    <a:pt x="134434" y="110348"/>
                    <a:pt x="124794" y="131781"/>
                    <a:pt x="145702" y="106691"/>
                  </a:cubicBezTo>
                  <a:cubicBezTo>
                    <a:pt x="149568" y="102052"/>
                    <a:pt x="151035" y="95391"/>
                    <a:pt x="155750" y="91619"/>
                  </a:cubicBezTo>
                  <a:cubicBezTo>
                    <a:pt x="159885" y="88311"/>
                    <a:pt x="165798" y="88270"/>
                    <a:pt x="170822" y="86595"/>
                  </a:cubicBezTo>
                  <a:cubicBezTo>
                    <a:pt x="179276" y="61237"/>
                    <a:pt x="169709" y="79655"/>
                    <a:pt x="190919" y="61474"/>
                  </a:cubicBezTo>
                  <a:cubicBezTo>
                    <a:pt x="198112" y="55309"/>
                    <a:pt x="204317" y="48076"/>
                    <a:pt x="211016" y="41377"/>
                  </a:cubicBezTo>
                  <a:cubicBezTo>
                    <a:pt x="215286" y="37107"/>
                    <a:pt x="221373" y="35101"/>
                    <a:pt x="226088" y="31329"/>
                  </a:cubicBezTo>
                  <a:cubicBezTo>
                    <a:pt x="229787" y="28370"/>
                    <a:pt x="232075" y="23717"/>
                    <a:pt x="236137" y="21280"/>
                  </a:cubicBezTo>
                  <a:cubicBezTo>
                    <a:pt x="240678" y="18555"/>
                    <a:pt x="246185" y="17931"/>
                    <a:pt x="251209" y="16256"/>
                  </a:cubicBezTo>
                  <a:cubicBezTo>
                    <a:pt x="252884" y="11232"/>
                    <a:pt x="251040" y="2223"/>
                    <a:pt x="256233" y="1184"/>
                  </a:cubicBezTo>
                  <a:cubicBezTo>
                    <a:pt x="277267" y="-3023"/>
                    <a:pt x="297348" y="4840"/>
                    <a:pt x="316524" y="11232"/>
                  </a:cubicBezTo>
                  <a:cubicBezTo>
                    <a:pt x="320610" y="23491"/>
                    <a:pt x="321857" y="31638"/>
                    <a:pt x="331596" y="41377"/>
                  </a:cubicBezTo>
                  <a:cubicBezTo>
                    <a:pt x="335866" y="45647"/>
                    <a:pt x="341645" y="48076"/>
                    <a:pt x="346669" y="51425"/>
                  </a:cubicBezTo>
                  <a:cubicBezTo>
                    <a:pt x="358626" y="87299"/>
                    <a:pt x="350842" y="72758"/>
                    <a:pt x="366765" y="96643"/>
                  </a:cubicBezTo>
                  <a:cubicBezTo>
                    <a:pt x="368440" y="101667"/>
                    <a:pt x="369064" y="107175"/>
                    <a:pt x="371789" y="111716"/>
                  </a:cubicBezTo>
                  <a:cubicBezTo>
                    <a:pt x="374226" y="115778"/>
                    <a:pt x="379720" y="117527"/>
                    <a:pt x="381838" y="121764"/>
                  </a:cubicBezTo>
                  <a:cubicBezTo>
                    <a:pt x="388012" y="134112"/>
                    <a:pt x="386798" y="154389"/>
                    <a:pt x="401935" y="161957"/>
                  </a:cubicBezTo>
                  <a:cubicBezTo>
                    <a:pt x="411409" y="166694"/>
                    <a:pt x="421804" y="169437"/>
                    <a:pt x="432080" y="172006"/>
                  </a:cubicBezTo>
                  <a:lnTo>
                    <a:pt x="472273" y="182054"/>
                  </a:lnTo>
                  <a:cubicBezTo>
                    <a:pt x="487346" y="180379"/>
                    <a:pt x="502359" y="176021"/>
                    <a:pt x="517491" y="177030"/>
                  </a:cubicBezTo>
                  <a:cubicBezTo>
                    <a:pt x="528059" y="177735"/>
                    <a:pt x="547636" y="187078"/>
                    <a:pt x="547636" y="187078"/>
                  </a:cubicBezTo>
                  <a:cubicBezTo>
                    <a:pt x="549311" y="192102"/>
                    <a:pt x="550292" y="197414"/>
                    <a:pt x="552660" y="202151"/>
                  </a:cubicBezTo>
                  <a:cubicBezTo>
                    <a:pt x="558997" y="214825"/>
                    <a:pt x="563411" y="217927"/>
                    <a:pt x="572756" y="227272"/>
                  </a:cubicBezTo>
                  <a:cubicBezTo>
                    <a:pt x="584715" y="263145"/>
                    <a:pt x="576930" y="248604"/>
                    <a:pt x="592853" y="272489"/>
                  </a:cubicBezTo>
                  <a:cubicBezTo>
                    <a:pt x="594528" y="277513"/>
                    <a:pt x="595152" y="283021"/>
                    <a:pt x="597877" y="287562"/>
                  </a:cubicBezTo>
                  <a:cubicBezTo>
                    <a:pt x="600314" y="291624"/>
                    <a:pt x="604967" y="293911"/>
                    <a:pt x="607926" y="297610"/>
                  </a:cubicBezTo>
                  <a:cubicBezTo>
                    <a:pt x="619056" y="311522"/>
                    <a:pt x="617692" y="311837"/>
                    <a:pt x="622998" y="327755"/>
                  </a:cubicBezTo>
                  <a:cubicBezTo>
                    <a:pt x="622321" y="339272"/>
                    <a:pt x="625147" y="417480"/>
                    <a:pt x="607926" y="443311"/>
                  </a:cubicBezTo>
                  <a:lnTo>
                    <a:pt x="597877" y="458384"/>
                  </a:lnTo>
                  <a:cubicBezTo>
                    <a:pt x="585784" y="494663"/>
                    <a:pt x="598931" y="451535"/>
                    <a:pt x="587829" y="523698"/>
                  </a:cubicBezTo>
                  <a:cubicBezTo>
                    <a:pt x="585021" y="541949"/>
                    <a:pt x="586029" y="538771"/>
                    <a:pt x="572756" y="538771"/>
                  </a:cubicBezTo>
                </a:path>
              </a:pathLst>
            </a:cu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Freeform 7"/>
            <p:cNvSpPr/>
            <p:nvPr/>
          </p:nvSpPr>
          <p:spPr>
            <a:xfrm>
              <a:off x="4561952" y="3888712"/>
              <a:ext cx="648576" cy="582804"/>
            </a:xfrm>
            <a:custGeom>
              <a:avLst/>
              <a:gdLst>
                <a:gd name="connsiteX0" fmla="*/ 35169 w 648576"/>
                <a:gd name="connsiteY0" fmla="*/ 512466 h 582804"/>
                <a:gd name="connsiteX1" fmla="*/ 10048 w 648576"/>
                <a:gd name="connsiteY1" fmla="*/ 492369 h 582804"/>
                <a:gd name="connsiteX2" fmla="*/ 0 w 648576"/>
                <a:gd name="connsiteY2" fmla="*/ 452176 h 582804"/>
                <a:gd name="connsiteX3" fmla="*/ 10048 w 648576"/>
                <a:gd name="connsiteY3" fmla="*/ 321547 h 582804"/>
                <a:gd name="connsiteX4" fmla="*/ 20096 w 648576"/>
                <a:gd name="connsiteY4" fmla="*/ 281354 h 582804"/>
                <a:gd name="connsiteX5" fmla="*/ 35169 w 648576"/>
                <a:gd name="connsiteY5" fmla="*/ 236136 h 582804"/>
                <a:gd name="connsiteX6" fmla="*/ 40193 w 648576"/>
                <a:gd name="connsiteY6" fmla="*/ 221064 h 582804"/>
                <a:gd name="connsiteX7" fmla="*/ 45217 w 648576"/>
                <a:gd name="connsiteY7" fmla="*/ 205991 h 582804"/>
                <a:gd name="connsiteX8" fmla="*/ 55266 w 648576"/>
                <a:gd name="connsiteY8" fmla="*/ 195943 h 582804"/>
                <a:gd name="connsiteX9" fmla="*/ 70338 w 648576"/>
                <a:gd name="connsiteY9" fmla="*/ 185895 h 582804"/>
                <a:gd name="connsiteX10" fmla="*/ 100483 w 648576"/>
                <a:gd name="connsiteY10" fmla="*/ 175846 h 582804"/>
                <a:gd name="connsiteX11" fmla="*/ 140677 w 648576"/>
                <a:gd name="connsiteY11" fmla="*/ 155750 h 582804"/>
                <a:gd name="connsiteX12" fmla="*/ 155749 w 648576"/>
                <a:gd name="connsiteY12" fmla="*/ 150725 h 582804"/>
                <a:gd name="connsiteX13" fmla="*/ 170822 w 648576"/>
                <a:gd name="connsiteY13" fmla="*/ 145701 h 582804"/>
                <a:gd name="connsiteX14" fmla="*/ 175846 w 648576"/>
                <a:gd name="connsiteY14" fmla="*/ 125604 h 582804"/>
                <a:gd name="connsiteX15" fmla="*/ 180870 w 648576"/>
                <a:gd name="connsiteY15" fmla="*/ 110532 h 582804"/>
                <a:gd name="connsiteX16" fmla="*/ 185894 w 648576"/>
                <a:gd name="connsiteY16" fmla="*/ 70339 h 582804"/>
                <a:gd name="connsiteX17" fmla="*/ 190918 w 648576"/>
                <a:gd name="connsiteY17" fmla="*/ 55266 h 582804"/>
                <a:gd name="connsiteX18" fmla="*/ 211015 w 648576"/>
                <a:gd name="connsiteY18" fmla="*/ 35169 h 582804"/>
                <a:gd name="connsiteX19" fmla="*/ 226088 w 648576"/>
                <a:gd name="connsiteY19" fmla="*/ 20097 h 582804"/>
                <a:gd name="connsiteX20" fmla="*/ 256233 w 648576"/>
                <a:gd name="connsiteY20" fmla="*/ 10048 h 582804"/>
                <a:gd name="connsiteX21" fmla="*/ 271305 w 648576"/>
                <a:gd name="connsiteY21" fmla="*/ 5024 h 582804"/>
                <a:gd name="connsiteX22" fmla="*/ 316523 w 648576"/>
                <a:gd name="connsiteY22" fmla="*/ 0 h 582804"/>
                <a:gd name="connsiteX23" fmla="*/ 336619 w 648576"/>
                <a:gd name="connsiteY23" fmla="*/ 5024 h 582804"/>
                <a:gd name="connsiteX24" fmla="*/ 346668 w 648576"/>
                <a:gd name="connsiteY24" fmla="*/ 15073 h 582804"/>
                <a:gd name="connsiteX25" fmla="*/ 361740 w 648576"/>
                <a:gd name="connsiteY25" fmla="*/ 20097 h 582804"/>
                <a:gd name="connsiteX26" fmla="*/ 371789 w 648576"/>
                <a:gd name="connsiteY26" fmla="*/ 30145 h 582804"/>
                <a:gd name="connsiteX27" fmla="*/ 381837 w 648576"/>
                <a:gd name="connsiteY27" fmla="*/ 45218 h 582804"/>
                <a:gd name="connsiteX28" fmla="*/ 411982 w 648576"/>
                <a:gd name="connsiteY28" fmla="*/ 65314 h 582804"/>
                <a:gd name="connsiteX29" fmla="*/ 447151 w 648576"/>
                <a:gd name="connsiteY29" fmla="*/ 90435 h 582804"/>
                <a:gd name="connsiteX30" fmla="*/ 472272 w 648576"/>
                <a:gd name="connsiteY30" fmla="*/ 110532 h 582804"/>
                <a:gd name="connsiteX31" fmla="*/ 482321 w 648576"/>
                <a:gd name="connsiteY31" fmla="*/ 120580 h 582804"/>
                <a:gd name="connsiteX32" fmla="*/ 497393 w 648576"/>
                <a:gd name="connsiteY32" fmla="*/ 125604 h 582804"/>
                <a:gd name="connsiteX33" fmla="*/ 507441 w 648576"/>
                <a:gd name="connsiteY33" fmla="*/ 140677 h 582804"/>
                <a:gd name="connsiteX34" fmla="*/ 527538 w 648576"/>
                <a:gd name="connsiteY34" fmla="*/ 160774 h 582804"/>
                <a:gd name="connsiteX35" fmla="*/ 532562 w 648576"/>
                <a:gd name="connsiteY35" fmla="*/ 175846 h 582804"/>
                <a:gd name="connsiteX36" fmla="*/ 552659 w 648576"/>
                <a:gd name="connsiteY36" fmla="*/ 205991 h 582804"/>
                <a:gd name="connsiteX37" fmla="*/ 557683 w 648576"/>
                <a:gd name="connsiteY37" fmla="*/ 221064 h 582804"/>
                <a:gd name="connsiteX38" fmla="*/ 567732 w 648576"/>
                <a:gd name="connsiteY38" fmla="*/ 231112 h 582804"/>
                <a:gd name="connsiteX39" fmla="*/ 577780 w 648576"/>
                <a:gd name="connsiteY39" fmla="*/ 261257 h 582804"/>
                <a:gd name="connsiteX40" fmla="*/ 582804 w 648576"/>
                <a:gd name="connsiteY40" fmla="*/ 276330 h 582804"/>
                <a:gd name="connsiteX41" fmla="*/ 592852 w 648576"/>
                <a:gd name="connsiteY41" fmla="*/ 291402 h 582804"/>
                <a:gd name="connsiteX42" fmla="*/ 607925 w 648576"/>
                <a:gd name="connsiteY42" fmla="*/ 336620 h 582804"/>
                <a:gd name="connsiteX43" fmla="*/ 612949 w 648576"/>
                <a:gd name="connsiteY43" fmla="*/ 351692 h 582804"/>
                <a:gd name="connsiteX44" fmla="*/ 622997 w 648576"/>
                <a:gd name="connsiteY44" fmla="*/ 361741 h 582804"/>
                <a:gd name="connsiteX45" fmla="*/ 638070 w 648576"/>
                <a:gd name="connsiteY45" fmla="*/ 411983 h 582804"/>
                <a:gd name="connsiteX46" fmla="*/ 643094 w 648576"/>
                <a:gd name="connsiteY46" fmla="*/ 427055 h 582804"/>
                <a:gd name="connsiteX47" fmla="*/ 648118 w 648576"/>
                <a:gd name="connsiteY47" fmla="*/ 462224 h 582804"/>
                <a:gd name="connsiteX48" fmla="*/ 643094 w 648576"/>
                <a:gd name="connsiteY48" fmla="*/ 557684 h 582804"/>
                <a:gd name="connsiteX49" fmla="*/ 622997 w 648576"/>
                <a:gd name="connsiteY49" fmla="*/ 562708 h 582804"/>
                <a:gd name="connsiteX50" fmla="*/ 492369 w 648576"/>
                <a:gd name="connsiteY50" fmla="*/ 567732 h 582804"/>
                <a:gd name="connsiteX51" fmla="*/ 462224 w 648576"/>
                <a:gd name="connsiteY51" fmla="*/ 577780 h 582804"/>
                <a:gd name="connsiteX52" fmla="*/ 447151 w 648576"/>
                <a:gd name="connsiteY52" fmla="*/ 582804 h 582804"/>
                <a:gd name="connsiteX53" fmla="*/ 411982 w 648576"/>
                <a:gd name="connsiteY53" fmla="*/ 582804 h 5828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</a:cxnLst>
              <a:rect l="l" t="t" r="r" b="b"/>
              <a:pathLst>
                <a:path w="648576" h="582804">
                  <a:moveTo>
                    <a:pt x="35169" y="512466"/>
                  </a:moveTo>
                  <a:cubicBezTo>
                    <a:pt x="26795" y="505767"/>
                    <a:pt x="17027" y="500511"/>
                    <a:pt x="10048" y="492369"/>
                  </a:cubicBezTo>
                  <a:cubicBezTo>
                    <a:pt x="6018" y="487667"/>
                    <a:pt x="106" y="452705"/>
                    <a:pt x="0" y="452176"/>
                  </a:cubicBezTo>
                  <a:cubicBezTo>
                    <a:pt x="902" y="438645"/>
                    <a:pt x="6677" y="342896"/>
                    <a:pt x="10048" y="321547"/>
                  </a:cubicBezTo>
                  <a:cubicBezTo>
                    <a:pt x="12202" y="307906"/>
                    <a:pt x="15729" y="294455"/>
                    <a:pt x="20096" y="281354"/>
                  </a:cubicBezTo>
                  <a:lnTo>
                    <a:pt x="35169" y="236136"/>
                  </a:lnTo>
                  <a:lnTo>
                    <a:pt x="40193" y="221064"/>
                  </a:lnTo>
                  <a:cubicBezTo>
                    <a:pt x="41868" y="216040"/>
                    <a:pt x="41472" y="209736"/>
                    <a:pt x="45217" y="205991"/>
                  </a:cubicBezTo>
                  <a:cubicBezTo>
                    <a:pt x="48567" y="202642"/>
                    <a:pt x="51567" y="198902"/>
                    <a:pt x="55266" y="195943"/>
                  </a:cubicBezTo>
                  <a:cubicBezTo>
                    <a:pt x="59981" y="192171"/>
                    <a:pt x="64820" y="188347"/>
                    <a:pt x="70338" y="185895"/>
                  </a:cubicBezTo>
                  <a:cubicBezTo>
                    <a:pt x="80017" y="181593"/>
                    <a:pt x="100483" y="175846"/>
                    <a:pt x="100483" y="175846"/>
                  </a:cubicBezTo>
                  <a:cubicBezTo>
                    <a:pt x="118023" y="158308"/>
                    <a:pt x="106037" y="167297"/>
                    <a:pt x="140677" y="155750"/>
                  </a:cubicBezTo>
                  <a:lnTo>
                    <a:pt x="155749" y="150725"/>
                  </a:lnTo>
                  <a:lnTo>
                    <a:pt x="170822" y="145701"/>
                  </a:lnTo>
                  <a:cubicBezTo>
                    <a:pt x="172497" y="139002"/>
                    <a:pt x="173949" y="132243"/>
                    <a:pt x="175846" y="125604"/>
                  </a:cubicBezTo>
                  <a:cubicBezTo>
                    <a:pt x="177301" y="120512"/>
                    <a:pt x="179923" y="115742"/>
                    <a:pt x="180870" y="110532"/>
                  </a:cubicBezTo>
                  <a:cubicBezTo>
                    <a:pt x="183285" y="97248"/>
                    <a:pt x="183479" y="83623"/>
                    <a:pt x="185894" y="70339"/>
                  </a:cubicBezTo>
                  <a:cubicBezTo>
                    <a:pt x="186841" y="65128"/>
                    <a:pt x="187840" y="59576"/>
                    <a:pt x="190918" y="55266"/>
                  </a:cubicBezTo>
                  <a:cubicBezTo>
                    <a:pt x="196424" y="47557"/>
                    <a:pt x="204316" y="41868"/>
                    <a:pt x="211015" y="35169"/>
                  </a:cubicBezTo>
                  <a:cubicBezTo>
                    <a:pt x="216039" y="30145"/>
                    <a:pt x="219347" y="22344"/>
                    <a:pt x="226088" y="20097"/>
                  </a:cubicBezTo>
                  <a:lnTo>
                    <a:pt x="256233" y="10048"/>
                  </a:lnTo>
                  <a:cubicBezTo>
                    <a:pt x="261257" y="8373"/>
                    <a:pt x="266042" y="5609"/>
                    <a:pt x="271305" y="5024"/>
                  </a:cubicBezTo>
                  <a:lnTo>
                    <a:pt x="316523" y="0"/>
                  </a:lnTo>
                  <a:cubicBezTo>
                    <a:pt x="323222" y="1675"/>
                    <a:pt x="330443" y="1936"/>
                    <a:pt x="336619" y="5024"/>
                  </a:cubicBezTo>
                  <a:cubicBezTo>
                    <a:pt x="340856" y="7143"/>
                    <a:pt x="342606" y="12636"/>
                    <a:pt x="346668" y="15073"/>
                  </a:cubicBezTo>
                  <a:cubicBezTo>
                    <a:pt x="351209" y="17798"/>
                    <a:pt x="356716" y="18422"/>
                    <a:pt x="361740" y="20097"/>
                  </a:cubicBezTo>
                  <a:cubicBezTo>
                    <a:pt x="365090" y="23446"/>
                    <a:pt x="368830" y="26446"/>
                    <a:pt x="371789" y="30145"/>
                  </a:cubicBezTo>
                  <a:cubicBezTo>
                    <a:pt x="375561" y="34860"/>
                    <a:pt x="377293" y="41242"/>
                    <a:pt x="381837" y="45218"/>
                  </a:cubicBezTo>
                  <a:cubicBezTo>
                    <a:pt x="390925" y="53170"/>
                    <a:pt x="403443" y="56775"/>
                    <a:pt x="411982" y="65314"/>
                  </a:cubicBezTo>
                  <a:cubicBezTo>
                    <a:pt x="435824" y="89156"/>
                    <a:pt x="423091" y="82415"/>
                    <a:pt x="447151" y="90435"/>
                  </a:cubicBezTo>
                  <a:cubicBezTo>
                    <a:pt x="471410" y="114694"/>
                    <a:pt x="440588" y="85186"/>
                    <a:pt x="472272" y="110532"/>
                  </a:cubicBezTo>
                  <a:cubicBezTo>
                    <a:pt x="475971" y="113491"/>
                    <a:pt x="478259" y="118143"/>
                    <a:pt x="482321" y="120580"/>
                  </a:cubicBezTo>
                  <a:cubicBezTo>
                    <a:pt x="486862" y="123305"/>
                    <a:pt x="492369" y="123929"/>
                    <a:pt x="497393" y="125604"/>
                  </a:cubicBezTo>
                  <a:cubicBezTo>
                    <a:pt x="500742" y="130628"/>
                    <a:pt x="503511" y="136092"/>
                    <a:pt x="507441" y="140677"/>
                  </a:cubicBezTo>
                  <a:cubicBezTo>
                    <a:pt x="513606" y="147870"/>
                    <a:pt x="527538" y="160774"/>
                    <a:pt x="527538" y="160774"/>
                  </a:cubicBezTo>
                  <a:cubicBezTo>
                    <a:pt x="529213" y="165798"/>
                    <a:pt x="529990" y="171217"/>
                    <a:pt x="532562" y="175846"/>
                  </a:cubicBezTo>
                  <a:cubicBezTo>
                    <a:pt x="538427" y="186403"/>
                    <a:pt x="552659" y="205991"/>
                    <a:pt x="552659" y="205991"/>
                  </a:cubicBezTo>
                  <a:cubicBezTo>
                    <a:pt x="554334" y="211015"/>
                    <a:pt x="554958" y="216523"/>
                    <a:pt x="557683" y="221064"/>
                  </a:cubicBezTo>
                  <a:cubicBezTo>
                    <a:pt x="560120" y="225126"/>
                    <a:pt x="565614" y="226875"/>
                    <a:pt x="567732" y="231112"/>
                  </a:cubicBezTo>
                  <a:cubicBezTo>
                    <a:pt x="572469" y="240586"/>
                    <a:pt x="574431" y="251209"/>
                    <a:pt x="577780" y="261257"/>
                  </a:cubicBezTo>
                  <a:cubicBezTo>
                    <a:pt x="579455" y="266281"/>
                    <a:pt x="579866" y="271923"/>
                    <a:pt x="582804" y="276330"/>
                  </a:cubicBezTo>
                  <a:cubicBezTo>
                    <a:pt x="586153" y="281354"/>
                    <a:pt x="590400" y="285884"/>
                    <a:pt x="592852" y="291402"/>
                  </a:cubicBezTo>
                  <a:cubicBezTo>
                    <a:pt x="592859" y="291417"/>
                    <a:pt x="605410" y="329076"/>
                    <a:pt x="607925" y="336620"/>
                  </a:cubicBezTo>
                  <a:cubicBezTo>
                    <a:pt x="609600" y="341644"/>
                    <a:pt x="609205" y="347947"/>
                    <a:pt x="612949" y="351692"/>
                  </a:cubicBezTo>
                  <a:lnTo>
                    <a:pt x="622997" y="361741"/>
                  </a:lnTo>
                  <a:cubicBezTo>
                    <a:pt x="630591" y="392111"/>
                    <a:pt x="625839" y="375290"/>
                    <a:pt x="638070" y="411983"/>
                  </a:cubicBezTo>
                  <a:lnTo>
                    <a:pt x="643094" y="427055"/>
                  </a:lnTo>
                  <a:cubicBezTo>
                    <a:pt x="644769" y="438778"/>
                    <a:pt x="648118" y="450382"/>
                    <a:pt x="648118" y="462224"/>
                  </a:cubicBezTo>
                  <a:cubicBezTo>
                    <a:pt x="648118" y="494088"/>
                    <a:pt x="650822" y="526771"/>
                    <a:pt x="643094" y="557684"/>
                  </a:cubicBezTo>
                  <a:cubicBezTo>
                    <a:pt x="641419" y="564383"/>
                    <a:pt x="629887" y="562249"/>
                    <a:pt x="622997" y="562708"/>
                  </a:cubicBezTo>
                  <a:cubicBezTo>
                    <a:pt x="579519" y="565606"/>
                    <a:pt x="535912" y="566057"/>
                    <a:pt x="492369" y="567732"/>
                  </a:cubicBezTo>
                  <a:lnTo>
                    <a:pt x="462224" y="577780"/>
                  </a:lnTo>
                  <a:cubicBezTo>
                    <a:pt x="457200" y="579455"/>
                    <a:pt x="452447" y="582804"/>
                    <a:pt x="447151" y="582804"/>
                  </a:cubicBezTo>
                  <a:lnTo>
                    <a:pt x="411982" y="582804"/>
                  </a:lnTo>
                </a:path>
              </a:pathLst>
            </a:cu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Freeform 8"/>
            <p:cNvSpPr/>
            <p:nvPr/>
          </p:nvSpPr>
          <p:spPr>
            <a:xfrm>
              <a:off x="4124848" y="4396154"/>
              <a:ext cx="855022" cy="836807"/>
            </a:xfrm>
            <a:custGeom>
              <a:avLst/>
              <a:gdLst>
                <a:gd name="connsiteX0" fmla="*/ 0 w 855022"/>
                <a:gd name="connsiteY0" fmla="*/ 190919 h 836807"/>
                <a:gd name="connsiteX1" fmla="*/ 55266 w 855022"/>
                <a:gd name="connsiteY1" fmla="*/ 175846 h 836807"/>
                <a:gd name="connsiteX2" fmla="*/ 70339 w 855022"/>
                <a:gd name="connsiteY2" fmla="*/ 170822 h 836807"/>
                <a:gd name="connsiteX3" fmla="*/ 80387 w 855022"/>
                <a:gd name="connsiteY3" fmla="*/ 160773 h 836807"/>
                <a:gd name="connsiteX4" fmla="*/ 110532 w 855022"/>
                <a:gd name="connsiteY4" fmla="*/ 150725 h 836807"/>
                <a:gd name="connsiteX5" fmla="*/ 135653 w 855022"/>
                <a:gd name="connsiteY5" fmla="*/ 135653 h 836807"/>
                <a:gd name="connsiteX6" fmla="*/ 145701 w 855022"/>
                <a:gd name="connsiteY6" fmla="*/ 125604 h 836807"/>
                <a:gd name="connsiteX7" fmla="*/ 160774 w 855022"/>
                <a:gd name="connsiteY7" fmla="*/ 80387 h 836807"/>
                <a:gd name="connsiteX8" fmla="*/ 165798 w 855022"/>
                <a:gd name="connsiteY8" fmla="*/ 65314 h 836807"/>
                <a:gd name="connsiteX9" fmla="*/ 185895 w 855022"/>
                <a:gd name="connsiteY9" fmla="*/ 45217 h 836807"/>
                <a:gd name="connsiteX10" fmla="*/ 195943 w 855022"/>
                <a:gd name="connsiteY10" fmla="*/ 30145 h 836807"/>
                <a:gd name="connsiteX11" fmla="*/ 211016 w 855022"/>
                <a:gd name="connsiteY11" fmla="*/ 20097 h 836807"/>
                <a:gd name="connsiteX12" fmla="*/ 221064 w 855022"/>
                <a:gd name="connsiteY12" fmla="*/ 10048 h 836807"/>
                <a:gd name="connsiteX13" fmla="*/ 251209 w 855022"/>
                <a:gd name="connsiteY13" fmla="*/ 0 h 836807"/>
                <a:gd name="connsiteX14" fmla="*/ 331596 w 855022"/>
                <a:gd name="connsiteY14" fmla="*/ 5024 h 836807"/>
                <a:gd name="connsiteX15" fmla="*/ 341644 w 855022"/>
                <a:gd name="connsiteY15" fmla="*/ 20097 h 836807"/>
                <a:gd name="connsiteX16" fmla="*/ 351693 w 855022"/>
                <a:gd name="connsiteY16" fmla="*/ 30145 h 836807"/>
                <a:gd name="connsiteX17" fmla="*/ 361741 w 855022"/>
                <a:gd name="connsiteY17" fmla="*/ 45217 h 836807"/>
                <a:gd name="connsiteX18" fmla="*/ 381838 w 855022"/>
                <a:gd name="connsiteY18" fmla="*/ 65314 h 836807"/>
                <a:gd name="connsiteX19" fmla="*/ 396910 w 855022"/>
                <a:gd name="connsiteY19" fmla="*/ 95459 h 836807"/>
                <a:gd name="connsiteX20" fmla="*/ 401934 w 855022"/>
                <a:gd name="connsiteY20" fmla="*/ 110532 h 836807"/>
                <a:gd name="connsiteX21" fmla="*/ 396910 w 855022"/>
                <a:gd name="connsiteY21" fmla="*/ 155749 h 836807"/>
                <a:gd name="connsiteX22" fmla="*/ 386862 w 855022"/>
                <a:gd name="connsiteY22" fmla="*/ 165798 h 836807"/>
                <a:gd name="connsiteX23" fmla="*/ 376814 w 855022"/>
                <a:gd name="connsiteY23" fmla="*/ 180870 h 836807"/>
                <a:gd name="connsiteX24" fmla="*/ 366765 w 855022"/>
                <a:gd name="connsiteY24" fmla="*/ 211015 h 836807"/>
                <a:gd name="connsiteX25" fmla="*/ 361741 w 855022"/>
                <a:gd name="connsiteY25" fmla="*/ 226088 h 836807"/>
                <a:gd name="connsiteX26" fmla="*/ 356717 w 855022"/>
                <a:gd name="connsiteY26" fmla="*/ 241160 h 836807"/>
                <a:gd name="connsiteX27" fmla="*/ 346668 w 855022"/>
                <a:gd name="connsiteY27" fmla="*/ 286378 h 836807"/>
                <a:gd name="connsiteX28" fmla="*/ 336620 w 855022"/>
                <a:gd name="connsiteY28" fmla="*/ 301450 h 836807"/>
                <a:gd name="connsiteX29" fmla="*/ 341644 w 855022"/>
                <a:gd name="connsiteY29" fmla="*/ 326571 h 836807"/>
                <a:gd name="connsiteX30" fmla="*/ 371789 w 855022"/>
                <a:gd name="connsiteY30" fmla="*/ 336620 h 836807"/>
                <a:gd name="connsiteX31" fmla="*/ 386862 w 855022"/>
                <a:gd name="connsiteY31" fmla="*/ 341644 h 836807"/>
                <a:gd name="connsiteX32" fmla="*/ 487345 w 855022"/>
                <a:gd name="connsiteY32" fmla="*/ 336620 h 836807"/>
                <a:gd name="connsiteX33" fmla="*/ 502418 w 855022"/>
                <a:gd name="connsiteY33" fmla="*/ 331595 h 836807"/>
                <a:gd name="connsiteX34" fmla="*/ 507442 w 855022"/>
                <a:gd name="connsiteY34" fmla="*/ 316523 h 836807"/>
                <a:gd name="connsiteX35" fmla="*/ 517490 w 855022"/>
                <a:gd name="connsiteY35" fmla="*/ 301450 h 836807"/>
                <a:gd name="connsiteX36" fmla="*/ 517490 w 855022"/>
                <a:gd name="connsiteY36" fmla="*/ 205991 h 836807"/>
                <a:gd name="connsiteX37" fmla="*/ 507442 w 855022"/>
                <a:gd name="connsiteY37" fmla="*/ 175846 h 836807"/>
                <a:gd name="connsiteX38" fmla="*/ 457200 w 855022"/>
                <a:gd name="connsiteY38" fmla="*/ 150725 h 836807"/>
                <a:gd name="connsiteX39" fmla="*/ 427055 w 855022"/>
                <a:gd name="connsiteY39" fmla="*/ 140677 h 836807"/>
                <a:gd name="connsiteX40" fmla="*/ 432079 w 855022"/>
                <a:gd name="connsiteY40" fmla="*/ 105508 h 836807"/>
                <a:gd name="connsiteX41" fmla="*/ 437104 w 855022"/>
                <a:gd name="connsiteY41" fmla="*/ 90435 h 836807"/>
                <a:gd name="connsiteX42" fmla="*/ 467249 w 855022"/>
                <a:gd name="connsiteY42" fmla="*/ 80387 h 836807"/>
                <a:gd name="connsiteX43" fmla="*/ 477297 w 855022"/>
                <a:gd name="connsiteY43" fmla="*/ 30145 h 836807"/>
                <a:gd name="connsiteX44" fmla="*/ 487345 w 855022"/>
                <a:gd name="connsiteY44" fmla="*/ 0 h 836807"/>
                <a:gd name="connsiteX45" fmla="*/ 602901 w 855022"/>
                <a:gd name="connsiteY45" fmla="*/ 5024 h 836807"/>
                <a:gd name="connsiteX46" fmla="*/ 633047 w 855022"/>
                <a:gd name="connsiteY46" fmla="*/ 20097 h 836807"/>
                <a:gd name="connsiteX47" fmla="*/ 678264 w 855022"/>
                <a:gd name="connsiteY47" fmla="*/ 45217 h 836807"/>
                <a:gd name="connsiteX48" fmla="*/ 713433 w 855022"/>
                <a:gd name="connsiteY48" fmla="*/ 75362 h 836807"/>
                <a:gd name="connsiteX49" fmla="*/ 718457 w 855022"/>
                <a:gd name="connsiteY49" fmla="*/ 90435 h 836807"/>
                <a:gd name="connsiteX50" fmla="*/ 733530 w 855022"/>
                <a:gd name="connsiteY50" fmla="*/ 95459 h 836807"/>
                <a:gd name="connsiteX51" fmla="*/ 793820 w 855022"/>
                <a:gd name="connsiteY51" fmla="*/ 85411 h 836807"/>
                <a:gd name="connsiteX52" fmla="*/ 823965 w 855022"/>
                <a:gd name="connsiteY52" fmla="*/ 75362 h 836807"/>
                <a:gd name="connsiteX53" fmla="*/ 839038 w 855022"/>
                <a:gd name="connsiteY53" fmla="*/ 70338 h 836807"/>
                <a:gd name="connsiteX54" fmla="*/ 854110 w 855022"/>
                <a:gd name="connsiteY54" fmla="*/ 75362 h 836807"/>
                <a:gd name="connsiteX55" fmla="*/ 849086 w 855022"/>
                <a:gd name="connsiteY55" fmla="*/ 135653 h 836807"/>
                <a:gd name="connsiteX56" fmla="*/ 844062 w 855022"/>
                <a:gd name="connsiteY56" fmla="*/ 150725 h 836807"/>
                <a:gd name="connsiteX57" fmla="*/ 828989 w 855022"/>
                <a:gd name="connsiteY57" fmla="*/ 155749 h 836807"/>
                <a:gd name="connsiteX58" fmla="*/ 818941 w 855022"/>
                <a:gd name="connsiteY58" fmla="*/ 165798 h 836807"/>
                <a:gd name="connsiteX59" fmla="*/ 813917 w 855022"/>
                <a:gd name="connsiteY59" fmla="*/ 180870 h 836807"/>
                <a:gd name="connsiteX60" fmla="*/ 798844 w 855022"/>
                <a:gd name="connsiteY60" fmla="*/ 185894 h 836807"/>
                <a:gd name="connsiteX61" fmla="*/ 788796 w 855022"/>
                <a:gd name="connsiteY61" fmla="*/ 195943 h 836807"/>
                <a:gd name="connsiteX62" fmla="*/ 778748 w 855022"/>
                <a:gd name="connsiteY62" fmla="*/ 226088 h 836807"/>
                <a:gd name="connsiteX63" fmla="*/ 773723 w 855022"/>
                <a:gd name="connsiteY63" fmla="*/ 241160 h 836807"/>
                <a:gd name="connsiteX64" fmla="*/ 763675 w 855022"/>
                <a:gd name="connsiteY64" fmla="*/ 271305 h 836807"/>
                <a:gd name="connsiteX65" fmla="*/ 733530 w 855022"/>
                <a:gd name="connsiteY65" fmla="*/ 311499 h 836807"/>
                <a:gd name="connsiteX66" fmla="*/ 723482 w 855022"/>
                <a:gd name="connsiteY66" fmla="*/ 326571 h 836807"/>
                <a:gd name="connsiteX67" fmla="*/ 708409 w 855022"/>
                <a:gd name="connsiteY67" fmla="*/ 356716 h 836807"/>
                <a:gd name="connsiteX68" fmla="*/ 708409 w 855022"/>
                <a:gd name="connsiteY68" fmla="*/ 417006 h 836807"/>
                <a:gd name="connsiteX69" fmla="*/ 718457 w 855022"/>
                <a:gd name="connsiteY69" fmla="*/ 447151 h 836807"/>
                <a:gd name="connsiteX70" fmla="*/ 723482 w 855022"/>
                <a:gd name="connsiteY70" fmla="*/ 462224 h 836807"/>
                <a:gd name="connsiteX71" fmla="*/ 708409 w 855022"/>
                <a:gd name="connsiteY71" fmla="*/ 582804 h 836807"/>
                <a:gd name="connsiteX72" fmla="*/ 698361 w 855022"/>
                <a:gd name="connsiteY72" fmla="*/ 592853 h 836807"/>
                <a:gd name="connsiteX73" fmla="*/ 668216 w 855022"/>
                <a:gd name="connsiteY73" fmla="*/ 683288 h 836807"/>
                <a:gd name="connsiteX74" fmla="*/ 658167 w 855022"/>
                <a:gd name="connsiteY74" fmla="*/ 713433 h 836807"/>
                <a:gd name="connsiteX75" fmla="*/ 653143 w 855022"/>
                <a:gd name="connsiteY75" fmla="*/ 728505 h 836807"/>
                <a:gd name="connsiteX76" fmla="*/ 643095 w 855022"/>
                <a:gd name="connsiteY76" fmla="*/ 743578 h 836807"/>
                <a:gd name="connsiteX77" fmla="*/ 628022 w 855022"/>
                <a:gd name="connsiteY77" fmla="*/ 768699 h 836807"/>
                <a:gd name="connsiteX78" fmla="*/ 617974 w 855022"/>
                <a:gd name="connsiteY78" fmla="*/ 783771 h 836807"/>
                <a:gd name="connsiteX79" fmla="*/ 602901 w 855022"/>
                <a:gd name="connsiteY79" fmla="*/ 788795 h 836807"/>
                <a:gd name="connsiteX80" fmla="*/ 597877 w 855022"/>
                <a:gd name="connsiteY80" fmla="*/ 803868 h 836807"/>
                <a:gd name="connsiteX81" fmla="*/ 567732 w 855022"/>
                <a:gd name="connsiteY81" fmla="*/ 813916 h 836807"/>
                <a:gd name="connsiteX82" fmla="*/ 517490 w 855022"/>
                <a:gd name="connsiteY82" fmla="*/ 823965 h 836807"/>
                <a:gd name="connsiteX83" fmla="*/ 376814 w 855022"/>
                <a:gd name="connsiteY83" fmla="*/ 828989 h 836807"/>
                <a:gd name="connsiteX84" fmla="*/ 341644 w 855022"/>
                <a:gd name="connsiteY84" fmla="*/ 823965 h 836807"/>
                <a:gd name="connsiteX85" fmla="*/ 306475 w 855022"/>
                <a:gd name="connsiteY85" fmla="*/ 813916 h 836807"/>
                <a:gd name="connsiteX86" fmla="*/ 296427 w 855022"/>
                <a:gd name="connsiteY86" fmla="*/ 798844 h 836807"/>
                <a:gd name="connsiteX87" fmla="*/ 281354 w 855022"/>
                <a:gd name="connsiteY87" fmla="*/ 793820 h 836807"/>
                <a:gd name="connsiteX88" fmla="*/ 271306 w 855022"/>
                <a:gd name="connsiteY88" fmla="*/ 783771 h 836807"/>
                <a:gd name="connsiteX89" fmla="*/ 266282 w 855022"/>
                <a:gd name="connsiteY89" fmla="*/ 768699 h 836807"/>
                <a:gd name="connsiteX90" fmla="*/ 256233 w 855022"/>
                <a:gd name="connsiteY90" fmla="*/ 758650 h 836807"/>
                <a:gd name="connsiteX91" fmla="*/ 231112 w 855022"/>
                <a:gd name="connsiteY91" fmla="*/ 713433 h 836807"/>
                <a:gd name="connsiteX92" fmla="*/ 216040 w 855022"/>
                <a:gd name="connsiteY92" fmla="*/ 683288 h 836807"/>
                <a:gd name="connsiteX93" fmla="*/ 205992 w 855022"/>
                <a:gd name="connsiteY93" fmla="*/ 653143 h 836807"/>
                <a:gd name="connsiteX94" fmla="*/ 190919 w 855022"/>
                <a:gd name="connsiteY94" fmla="*/ 607925 h 836807"/>
                <a:gd name="connsiteX95" fmla="*/ 180871 w 855022"/>
                <a:gd name="connsiteY95" fmla="*/ 577780 h 836807"/>
                <a:gd name="connsiteX96" fmla="*/ 175847 w 855022"/>
                <a:gd name="connsiteY96" fmla="*/ 562708 h 836807"/>
                <a:gd name="connsiteX97" fmla="*/ 160774 w 855022"/>
                <a:gd name="connsiteY97" fmla="*/ 366765 h 836807"/>
                <a:gd name="connsiteX98" fmla="*/ 150726 w 855022"/>
                <a:gd name="connsiteY98" fmla="*/ 356716 h 836807"/>
                <a:gd name="connsiteX99" fmla="*/ 135653 w 855022"/>
                <a:gd name="connsiteY99" fmla="*/ 331595 h 836807"/>
                <a:gd name="connsiteX100" fmla="*/ 130629 w 855022"/>
                <a:gd name="connsiteY100" fmla="*/ 316523 h 836807"/>
                <a:gd name="connsiteX101" fmla="*/ 110532 w 855022"/>
                <a:gd name="connsiteY101" fmla="*/ 291402 h 836807"/>
                <a:gd name="connsiteX102" fmla="*/ 100484 w 855022"/>
                <a:gd name="connsiteY102" fmla="*/ 276330 h 836807"/>
                <a:gd name="connsiteX103" fmla="*/ 90436 w 855022"/>
                <a:gd name="connsiteY103" fmla="*/ 266281 h 836807"/>
                <a:gd name="connsiteX104" fmla="*/ 70339 w 855022"/>
                <a:gd name="connsiteY104" fmla="*/ 241160 h 836807"/>
                <a:gd name="connsiteX105" fmla="*/ 55266 w 855022"/>
                <a:gd name="connsiteY105" fmla="*/ 236136 h 836807"/>
                <a:gd name="connsiteX106" fmla="*/ 40194 w 855022"/>
                <a:gd name="connsiteY106" fmla="*/ 226088 h 836807"/>
                <a:gd name="connsiteX107" fmla="*/ 15073 w 855022"/>
                <a:gd name="connsiteY107" fmla="*/ 211015 h 836807"/>
                <a:gd name="connsiteX108" fmla="*/ 0 w 855022"/>
                <a:gd name="connsiteY108" fmla="*/ 190919 h 83680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</a:cxnLst>
              <a:rect l="l" t="t" r="r" b="b"/>
              <a:pathLst>
                <a:path w="855022" h="836807">
                  <a:moveTo>
                    <a:pt x="0" y="190919"/>
                  </a:moveTo>
                  <a:cubicBezTo>
                    <a:pt x="35508" y="183816"/>
                    <a:pt x="17019" y="188595"/>
                    <a:pt x="55266" y="175846"/>
                  </a:cubicBezTo>
                  <a:lnTo>
                    <a:pt x="70339" y="170822"/>
                  </a:lnTo>
                  <a:cubicBezTo>
                    <a:pt x="73688" y="167472"/>
                    <a:pt x="76150" y="162891"/>
                    <a:pt x="80387" y="160773"/>
                  </a:cubicBezTo>
                  <a:cubicBezTo>
                    <a:pt x="89861" y="156036"/>
                    <a:pt x="110532" y="150725"/>
                    <a:pt x="110532" y="150725"/>
                  </a:cubicBezTo>
                  <a:cubicBezTo>
                    <a:pt x="135999" y="125260"/>
                    <a:pt x="103037" y="155224"/>
                    <a:pt x="135653" y="135653"/>
                  </a:cubicBezTo>
                  <a:cubicBezTo>
                    <a:pt x="139715" y="133216"/>
                    <a:pt x="142352" y="128954"/>
                    <a:pt x="145701" y="125604"/>
                  </a:cubicBezTo>
                  <a:lnTo>
                    <a:pt x="160774" y="80387"/>
                  </a:lnTo>
                  <a:cubicBezTo>
                    <a:pt x="162449" y="75363"/>
                    <a:pt x="162053" y="69059"/>
                    <a:pt x="165798" y="65314"/>
                  </a:cubicBezTo>
                  <a:cubicBezTo>
                    <a:pt x="172497" y="58615"/>
                    <a:pt x="180640" y="53100"/>
                    <a:pt x="185895" y="45217"/>
                  </a:cubicBezTo>
                  <a:cubicBezTo>
                    <a:pt x="189244" y="40193"/>
                    <a:pt x="191673" y="34414"/>
                    <a:pt x="195943" y="30145"/>
                  </a:cubicBezTo>
                  <a:cubicBezTo>
                    <a:pt x="200213" y="25875"/>
                    <a:pt x="206301" y="23869"/>
                    <a:pt x="211016" y="20097"/>
                  </a:cubicBezTo>
                  <a:cubicBezTo>
                    <a:pt x="214715" y="17138"/>
                    <a:pt x="216827" y="12166"/>
                    <a:pt x="221064" y="10048"/>
                  </a:cubicBezTo>
                  <a:cubicBezTo>
                    <a:pt x="230538" y="5311"/>
                    <a:pt x="251209" y="0"/>
                    <a:pt x="251209" y="0"/>
                  </a:cubicBezTo>
                  <a:cubicBezTo>
                    <a:pt x="278005" y="1675"/>
                    <a:pt x="305387" y="-800"/>
                    <a:pt x="331596" y="5024"/>
                  </a:cubicBezTo>
                  <a:cubicBezTo>
                    <a:pt x="337491" y="6334"/>
                    <a:pt x="337872" y="15382"/>
                    <a:pt x="341644" y="20097"/>
                  </a:cubicBezTo>
                  <a:cubicBezTo>
                    <a:pt x="344603" y="23796"/>
                    <a:pt x="348734" y="26446"/>
                    <a:pt x="351693" y="30145"/>
                  </a:cubicBezTo>
                  <a:cubicBezTo>
                    <a:pt x="355465" y="34860"/>
                    <a:pt x="357811" y="40633"/>
                    <a:pt x="361741" y="45217"/>
                  </a:cubicBezTo>
                  <a:cubicBezTo>
                    <a:pt x="367906" y="52410"/>
                    <a:pt x="381838" y="65314"/>
                    <a:pt x="381838" y="65314"/>
                  </a:cubicBezTo>
                  <a:cubicBezTo>
                    <a:pt x="394466" y="103201"/>
                    <a:pt x="377431" y="56501"/>
                    <a:pt x="396910" y="95459"/>
                  </a:cubicBezTo>
                  <a:cubicBezTo>
                    <a:pt x="399278" y="100196"/>
                    <a:pt x="400259" y="105508"/>
                    <a:pt x="401934" y="110532"/>
                  </a:cubicBezTo>
                  <a:cubicBezTo>
                    <a:pt x="400259" y="125604"/>
                    <a:pt x="400900" y="141118"/>
                    <a:pt x="396910" y="155749"/>
                  </a:cubicBezTo>
                  <a:cubicBezTo>
                    <a:pt x="395664" y="160319"/>
                    <a:pt x="389821" y="162099"/>
                    <a:pt x="386862" y="165798"/>
                  </a:cubicBezTo>
                  <a:cubicBezTo>
                    <a:pt x="383090" y="170513"/>
                    <a:pt x="379266" y="175352"/>
                    <a:pt x="376814" y="180870"/>
                  </a:cubicBezTo>
                  <a:cubicBezTo>
                    <a:pt x="372512" y="190549"/>
                    <a:pt x="370115" y="200967"/>
                    <a:pt x="366765" y="211015"/>
                  </a:cubicBezTo>
                  <a:lnTo>
                    <a:pt x="361741" y="226088"/>
                  </a:lnTo>
                  <a:cubicBezTo>
                    <a:pt x="360066" y="231112"/>
                    <a:pt x="357756" y="235967"/>
                    <a:pt x="356717" y="241160"/>
                  </a:cubicBezTo>
                  <a:cubicBezTo>
                    <a:pt x="355822" y="245638"/>
                    <a:pt x="349331" y="280165"/>
                    <a:pt x="346668" y="286378"/>
                  </a:cubicBezTo>
                  <a:cubicBezTo>
                    <a:pt x="344289" y="291928"/>
                    <a:pt x="339969" y="296426"/>
                    <a:pt x="336620" y="301450"/>
                  </a:cubicBezTo>
                  <a:cubicBezTo>
                    <a:pt x="338295" y="309824"/>
                    <a:pt x="335606" y="320533"/>
                    <a:pt x="341644" y="326571"/>
                  </a:cubicBezTo>
                  <a:cubicBezTo>
                    <a:pt x="349134" y="334061"/>
                    <a:pt x="361741" y="333270"/>
                    <a:pt x="371789" y="336620"/>
                  </a:cubicBezTo>
                  <a:lnTo>
                    <a:pt x="386862" y="341644"/>
                  </a:lnTo>
                  <a:cubicBezTo>
                    <a:pt x="420356" y="339969"/>
                    <a:pt x="453935" y="339525"/>
                    <a:pt x="487345" y="336620"/>
                  </a:cubicBezTo>
                  <a:cubicBezTo>
                    <a:pt x="492621" y="336161"/>
                    <a:pt x="498673" y="335340"/>
                    <a:pt x="502418" y="331595"/>
                  </a:cubicBezTo>
                  <a:cubicBezTo>
                    <a:pt x="506163" y="327850"/>
                    <a:pt x="505074" y="321260"/>
                    <a:pt x="507442" y="316523"/>
                  </a:cubicBezTo>
                  <a:cubicBezTo>
                    <a:pt x="510142" y="311122"/>
                    <a:pt x="514141" y="306474"/>
                    <a:pt x="517490" y="301450"/>
                  </a:cubicBezTo>
                  <a:cubicBezTo>
                    <a:pt x="523031" y="257134"/>
                    <a:pt x="526175" y="255206"/>
                    <a:pt x="517490" y="205991"/>
                  </a:cubicBezTo>
                  <a:cubicBezTo>
                    <a:pt x="515649" y="195560"/>
                    <a:pt x="516255" y="181721"/>
                    <a:pt x="507442" y="175846"/>
                  </a:cubicBezTo>
                  <a:cubicBezTo>
                    <a:pt x="463965" y="146861"/>
                    <a:pt x="493351" y="161570"/>
                    <a:pt x="457200" y="150725"/>
                  </a:cubicBezTo>
                  <a:cubicBezTo>
                    <a:pt x="447055" y="147682"/>
                    <a:pt x="427055" y="140677"/>
                    <a:pt x="427055" y="140677"/>
                  </a:cubicBezTo>
                  <a:cubicBezTo>
                    <a:pt x="428730" y="128954"/>
                    <a:pt x="429756" y="117120"/>
                    <a:pt x="432079" y="105508"/>
                  </a:cubicBezTo>
                  <a:cubicBezTo>
                    <a:pt x="433118" y="100315"/>
                    <a:pt x="432794" y="93513"/>
                    <a:pt x="437104" y="90435"/>
                  </a:cubicBezTo>
                  <a:cubicBezTo>
                    <a:pt x="445723" y="84279"/>
                    <a:pt x="467249" y="80387"/>
                    <a:pt x="467249" y="80387"/>
                  </a:cubicBezTo>
                  <a:cubicBezTo>
                    <a:pt x="481182" y="38586"/>
                    <a:pt x="459977" y="105199"/>
                    <a:pt x="477297" y="30145"/>
                  </a:cubicBezTo>
                  <a:cubicBezTo>
                    <a:pt x="479679" y="19824"/>
                    <a:pt x="487345" y="0"/>
                    <a:pt x="487345" y="0"/>
                  </a:cubicBezTo>
                  <a:cubicBezTo>
                    <a:pt x="525864" y="1675"/>
                    <a:pt x="564460" y="2067"/>
                    <a:pt x="602901" y="5024"/>
                  </a:cubicBezTo>
                  <a:cubicBezTo>
                    <a:pt x="617827" y="6172"/>
                    <a:pt x="620267" y="13707"/>
                    <a:pt x="633047" y="20097"/>
                  </a:cubicBezTo>
                  <a:cubicBezTo>
                    <a:pt x="658318" y="32733"/>
                    <a:pt x="646581" y="13534"/>
                    <a:pt x="678264" y="45217"/>
                  </a:cubicBezTo>
                  <a:cubicBezTo>
                    <a:pt x="702631" y="69584"/>
                    <a:pt x="690478" y="60059"/>
                    <a:pt x="713433" y="75362"/>
                  </a:cubicBezTo>
                  <a:cubicBezTo>
                    <a:pt x="715108" y="80386"/>
                    <a:pt x="714712" y="86690"/>
                    <a:pt x="718457" y="90435"/>
                  </a:cubicBezTo>
                  <a:cubicBezTo>
                    <a:pt x="722202" y="94180"/>
                    <a:pt x="728234" y="95459"/>
                    <a:pt x="733530" y="95459"/>
                  </a:cubicBezTo>
                  <a:cubicBezTo>
                    <a:pt x="750152" y="95459"/>
                    <a:pt x="776183" y="90702"/>
                    <a:pt x="793820" y="85411"/>
                  </a:cubicBezTo>
                  <a:cubicBezTo>
                    <a:pt x="803965" y="82367"/>
                    <a:pt x="813917" y="78712"/>
                    <a:pt x="823965" y="75362"/>
                  </a:cubicBezTo>
                  <a:lnTo>
                    <a:pt x="839038" y="70338"/>
                  </a:lnTo>
                  <a:cubicBezTo>
                    <a:pt x="844062" y="72013"/>
                    <a:pt x="853305" y="70128"/>
                    <a:pt x="854110" y="75362"/>
                  </a:cubicBezTo>
                  <a:cubicBezTo>
                    <a:pt x="857176" y="95294"/>
                    <a:pt x="851751" y="115663"/>
                    <a:pt x="849086" y="135653"/>
                  </a:cubicBezTo>
                  <a:cubicBezTo>
                    <a:pt x="848386" y="140902"/>
                    <a:pt x="847807" y="146980"/>
                    <a:pt x="844062" y="150725"/>
                  </a:cubicBezTo>
                  <a:cubicBezTo>
                    <a:pt x="840317" y="154470"/>
                    <a:pt x="834013" y="154074"/>
                    <a:pt x="828989" y="155749"/>
                  </a:cubicBezTo>
                  <a:cubicBezTo>
                    <a:pt x="825640" y="159099"/>
                    <a:pt x="821378" y="161736"/>
                    <a:pt x="818941" y="165798"/>
                  </a:cubicBezTo>
                  <a:cubicBezTo>
                    <a:pt x="816216" y="170339"/>
                    <a:pt x="817662" y="177125"/>
                    <a:pt x="813917" y="180870"/>
                  </a:cubicBezTo>
                  <a:cubicBezTo>
                    <a:pt x="810172" y="184615"/>
                    <a:pt x="803868" y="184219"/>
                    <a:pt x="798844" y="185894"/>
                  </a:cubicBezTo>
                  <a:cubicBezTo>
                    <a:pt x="795495" y="189244"/>
                    <a:pt x="790914" y="191706"/>
                    <a:pt x="788796" y="195943"/>
                  </a:cubicBezTo>
                  <a:cubicBezTo>
                    <a:pt x="784059" y="205417"/>
                    <a:pt x="782098" y="216040"/>
                    <a:pt x="778748" y="226088"/>
                  </a:cubicBezTo>
                  <a:lnTo>
                    <a:pt x="773723" y="241160"/>
                  </a:lnTo>
                  <a:lnTo>
                    <a:pt x="763675" y="271305"/>
                  </a:lnTo>
                  <a:cubicBezTo>
                    <a:pt x="745088" y="289894"/>
                    <a:pt x="756254" y="277413"/>
                    <a:pt x="733530" y="311499"/>
                  </a:cubicBezTo>
                  <a:cubicBezTo>
                    <a:pt x="730181" y="316523"/>
                    <a:pt x="725392" y="320843"/>
                    <a:pt x="723482" y="326571"/>
                  </a:cubicBezTo>
                  <a:cubicBezTo>
                    <a:pt x="716547" y="347372"/>
                    <a:pt x="721395" y="337237"/>
                    <a:pt x="708409" y="356716"/>
                  </a:cubicBezTo>
                  <a:cubicBezTo>
                    <a:pt x="699569" y="383238"/>
                    <a:pt x="699996" y="374939"/>
                    <a:pt x="708409" y="417006"/>
                  </a:cubicBezTo>
                  <a:cubicBezTo>
                    <a:pt x="710486" y="427392"/>
                    <a:pt x="715108" y="437103"/>
                    <a:pt x="718457" y="447151"/>
                  </a:cubicBezTo>
                  <a:lnTo>
                    <a:pt x="723482" y="462224"/>
                  </a:lnTo>
                  <a:cubicBezTo>
                    <a:pt x="720353" y="527923"/>
                    <a:pt x="737613" y="546297"/>
                    <a:pt x="708409" y="582804"/>
                  </a:cubicBezTo>
                  <a:cubicBezTo>
                    <a:pt x="705450" y="586503"/>
                    <a:pt x="701710" y="589503"/>
                    <a:pt x="698361" y="592853"/>
                  </a:cubicBezTo>
                  <a:lnTo>
                    <a:pt x="668216" y="683288"/>
                  </a:lnTo>
                  <a:lnTo>
                    <a:pt x="658167" y="713433"/>
                  </a:lnTo>
                  <a:cubicBezTo>
                    <a:pt x="656492" y="718457"/>
                    <a:pt x="656080" y="724099"/>
                    <a:pt x="653143" y="728505"/>
                  </a:cubicBezTo>
                  <a:cubicBezTo>
                    <a:pt x="649794" y="733529"/>
                    <a:pt x="645795" y="738177"/>
                    <a:pt x="643095" y="743578"/>
                  </a:cubicBezTo>
                  <a:cubicBezTo>
                    <a:pt x="622739" y="784291"/>
                    <a:pt x="654190" y="735989"/>
                    <a:pt x="628022" y="768699"/>
                  </a:cubicBezTo>
                  <a:cubicBezTo>
                    <a:pt x="624250" y="773414"/>
                    <a:pt x="622689" y="779999"/>
                    <a:pt x="617974" y="783771"/>
                  </a:cubicBezTo>
                  <a:cubicBezTo>
                    <a:pt x="613838" y="787079"/>
                    <a:pt x="607925" y="787120"/>
                    <a:pt x="602901" y="788795"/>
                  </a:cubicBezTo>
                  <a:cubicBezTo>
                    <a:pt x="601226" y="793819"/>
                    <a:pt x="602187" y="800790"/>
                    <a:pt x="597877" y="803868"/>
                  </a:cubicBezTo>
                  <a:cubicBezTo>
                    <a:pt x="589258" y="810024"/>
                    <a:pt x="577780" y="810566"/>
                    <a:pt x="567732" y="813916"/>
                  </a:cubicBezTo>
                  <a:cubicBezTo>
                    <a:pt x="541418" y="822688"/>
                    <a:pt x="557919" y="818190"/>
                    <a:pt x="517490" y="823965"/>
                  </a:cubicBezTo>
                  <a:cubicBezTo>
                    <a:pt x="452356" y="845676"/>
                    <a:pt x="497926" y="834494"/>
                    <a:pt x="376814" y="828989"/>
                  </a:cubicBezTo>
                  <a:cubicBezTo>
                    <a:pt x="365091" y="827314"/>
                    <a:pt x="353295" y="826083"/>
                    <a:pt x="341644" y="823965"/>
                  </a:cubicBezTo>
                  <a:cubicBezTo>
                    <a:pt x="327763" y="821441"/>
                    <a:pt x="319391" y="818222"/>
                    <a:pt x="306475" y="813916"/>
                  </a:cubicBezTo>
                  <a:cubicBezTo>
                    <a:pt x="303126" y="808892"/>
                    <a:pt x="301142" y="802616"/>
                    <a:pt x="296427" y="798844"/>
                  </a:cubicBezTo>
                  <a:cubicBezTo>
                    <a:pt x="292291" y="795536"/>
                    <a:pt x="285895" y="796545"/>
                    <a:pt x="281354" y="793820"/>
                  </a:cubicBezTo>
                  <a:cubicBezTo>
                    <a:pt x="277292" y="791383"/>
                    <a:pt x="274655" y="787121"/>
                    <a:pt x="271306" y="783771"/>
                  </a:cubicBezTo>
                  <a:cubicBezTo>
                    <a:pt x="269631" y="778747"/>
                    <a:pt x="269007" y="773240"/>
                    <a:pt x="266282" y="768699"/>
                  </a:cubicBezTo>
                  <a:cubicBezTo>
                    <a:pt x="263845" y="764637"/>
                    <a:pt x="258352" y="762887"/>
                    <a:pt x="256233" y="758650"/>
                  </a:cubicBezTo>
                  <a:cubicBezTo>
                    <a:pt x="231643" y="709470"/>
                    <a:pt x="261923" y="744242"/>
                    <a:pt x="231112" y="713433"/>
                  </a:cubicBezTo>
                  <a:cubicBezTo>
                    <a:pt x="212790" y="658464"/>
                    <a:pt x="242010" y="741721"/>
                    <a:pt x="216040" y="683288"/>
                  </a:cubicBezTo>
                  <a:cubicBezTo>
                    <a:pt x="211738" y="673609"/>
                    <a:pt x="209341" y="663191"/>
                    <a:pt x="205992" y="653143"/>
                  </a:cubicBezTo>
                  <a:lnTo>
                    <a:pt x="190919" y="607925"/>
                  </a:lnTo>
                  <a:lnTo>
                    <a:pt x="180871" y="577780"/>
                  </a:lnTo>
                  <a:lnTo>
                    <a:pt x="175847" y="562708"/>
                  </a:lnTo>
                  <a:cubicBezTo>
                    <a:pt x="173781" y="488326"/>
                    <a:pt x="203965" y="420756"/>
                    <a:pt x="160774" y="366765"/>
                  </a:cubicBezTo>
                  <a:cubicBezTo>
                    <a:pt x="157815" y="363066"/>
                    <a:pt x="154075" y="360066"/>
                    <a:pt x="150726" y="356716"/>
                  </a:cubicBezTo>
                  <a:cubicBezTo>
                    <a:pt x="136489" y="314014"/>
                    <a:pt x="156345" y="366083"/>
                    <a:pt x="135653" y="331595"/>
                  </a:cubicBezTo>
                  <a:cubicBezTo>
                    <a:pt x="132928" y="327054"/>
                    <a:pt x="132997" y="321260"/>
                    <a:pt x="130629" y="316523"/>
                  </a:cubicBezTo>
                  <a:cubicBezTo>
                    <a:pt x="120318" y="295900"/>
                    <a:pt x="122996" y="306982"/>
                    <a:pt x="110532" y="291402"/>
                  </a:cubicBezTo>
                  <a:cubicBezTo>
                    <a:pt x="106760" y="286687"/>
                    <a:pt x="104256" y="281045"/>
                    <a:pt x="100484" y="276330"/>
                  </a:cubicBezTo>
                  <a:cubicBezTo>
                    <a:pt x="97525" y="272631"/>
                    <a:pt x="93395" y="269980"/>
                    <a:pt x="90436" y="266281"/>
                  </a:cubicBezTo>
                  <a:cubicBezTo>
                    <a:pt x="84120" y="258386"/>
                    <a:pt x="79666" y="246757"/>
                    <a:pt x="70339" y="241160"/>
                  </a:cubicBezTo>
                  <a:cubicBezTo>
                    <a:pt x="65798" y="238435"/>
                    <a:pt x="60290" y="237811"/>
                    <a:pt x="55266" y="236136"/>
                  </a:cubicBezTo>
                  <a:cubicBezTo>
                    <a:pt x="50242" y="232787"/>
                    <a:pt x="45595" y="228788"/>
                    <a:pt x="40194" y="226088"/>
                  </a:cubicBezTo>
                  <a:cubicBezTo>
                    <a:pt x="31659" y="221821"/>
                    <a:pt x="18999" y="222793"/>
                    <a:pt x="15073" y="211015"/>
                  </a:cubicBezTo>
                  <a:cubicBezTo>
                    <a:pt x="12955" y="204660"/>
                    <a:pt x="15073" y="197618"/>
                    <a:pt x="0" y="190919"/>
                  </a:cubicBezTo>
                  <a:close/>
                </a:path>
              </a:pathLst>
            </a:custGeom>
            <a:noFill/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3225521" y="4034413"/>
              <a:ext cx="2552281" cy="487345"/>
              <a:chOff x="3225521" y="4034413"/>
              <a:chExt cx="2552281" cy="487345"/>
            </a:xfrm>
          </p:grpSpPr>
          <p:sp>
            <p:nvSpPr>
              <p:cNvPr id="13" name="Freeform 12"/>
              <p:cNvSpPr/>
              <p:nvPr/>
            </p:nvSpPr>
            <p:spPr>
              <a:xfrm>
                <a:off x="3225521" y="4089679"/>
                <a:ext cx="572936" cy="175846"/>
              </a:xfrm>
              <a:custGeom>
                <a:avLst/>
                <a:gdLst>
                  <a:gd name="connsiteX0" fmla="*/ 0 w 572936"/>
                  <a:gd name="connsiteY0" fmla="*/ 120580 h 175846"/>
                  <a:gd name="connsiteX1" fmla="*/ 25121 w 572936"/>
                  <a:gd name="connsiteY1" fmla="*/ 125605 h 175846"/>
                  <a:gd name="connsiteX2" fmla="*/ 65314 w 572936"/>
                  <a:gd name="connsiteY2" fmla="*/ 160774 h 175846"/>
                  <a:gd name="connsiteX3" fmla="*/ 145701 w 572936"/>
                  <a:gd name="connsiteY3" fmla="*/ 170822 h 175846"/>
                  <a:gd name="connsiteX4" fmla="*/ 160774 w 572936"/>
                  <a:gd name="connsiteY4" fmla="*/ 175846 h 175846"/>
                  <a:gd name="connsiteX5" fmla="*/ 205991 w 572936"/>
                  <a:gd name="connsiteY5" fmla="*/ 170822 h 175846"/>
                  <a:gd name="connsiteX6" fmla="*/ 236136 w 572936"/>
                  <a:gd name="connsiteY6" fmla="*/ 160774 h 175846"/>
                  <a:gd name="connsiteX7" fmla="*/ 266281 w 572936"/>
                  <a:gd name="connsiteY7" fmla="*/ 150725 h 175846"/>
                  <a:gd name="connsiteX8" fmla="*/ 281354 w 572936"/>
                  <a:gd name="connsiteY8" fmla="*/ 145701 h 175846"/>
                  <a:gd name="connsiteX9" fmla="*/ 296426 w 572936"/>
                  <a:gd name="connsiteY9" fmla="*/ 140677 h 175846"/>
                  <a:gd name="connsiteX10" fmla="*/ 386861 w 572936"/>
                  <a:gd name="connsiteY10" fmla="*/ 135653 h 175846"/>
                  <a:gd name="connsiteX11" fmla="*/ 462224 w 572936"/>
                  <a:gd name="connsiteY11" fmla="*/ 110532 h 175846"/>
                  <a:gd name="connsiteX12" fmla="*/ 477297 w 572936"/>
                  <a:gd name="connsiteY12" fmla="*/ 105508 h 175846"/>
                  <a:gd name="connsiteX13" fmla="*/ 492369 w 572936"/>
                  <a:gd name="connsiteY13" fmla="*/ 100484 h 175846"/>
                  <a:gd name="connsiteX14" fmla="*/ 502417 w 572936"/>
                  <a:gd name="connsiteY14" fmla="*/ 90435 h 175846"/>
                  <a:gd name="connsiteX15" fmla="*/ 517490 w 572936"/>
                  <a:gd name="connsiteY15" fmla="*/ 85411 h 175846"/>
                  <a:gd name="connsiteX16" fmla="*/ 527538 w 572936"/>
                  <a:gd name="connsiteY16" fmla="*/ 70339 h 175846"/>
                  <a:gd name="connsiteX17" fmla="*/ 537587 w 572936"/>
                  <a:gd name="connsiteY17" fmla="*/ 60290 h 175846"/>
                  <a:gd name="connsiteX18" fmla="*/ 557683 w 572936"/>
                  <a:gd name="connsiteY18" fmla="*/ 35169 h 175846"/>
                  <a:gd name="connsiteX19" fmla="*/ 562708 w 572936"/>
                  <a:gd name="connsiteY19" fmla="*/ 20097 h 175846"/>
                  <a:gd name="connsiteX20" fmla="*/ 572756 w 572936"/>
                  <a:gd name="connsiteY20" fmla="*/ 0 h 175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572936" h="175846">
                    <a:moveTo>
                      <a:pt x="0" y="120580"/>
                    </a:moveTo>
                    <a:cubicBezTo>
                      <a:pt x="8374" y="122255"/>
                      <a:pt x="17798" y="121211"/>
                      <a:pt x="25121" y="125605"/>
                    </a:cubicBezTo>
                    <a:cubicBezTo>
                      <a:pt x="90579" y="164880"/>
                      <a:pt x="21998" y="139115"/>
                      <a:pt x="65314" y="160774"/>
                    </a:cubicBezTo>
                    <a:cubicBezTo>
                      <a:pt x="87001" y="171618"/>
                      <a:pt x="133245" y="169864"/>
                      <a:pt x="145701" y="170822"/>
                    </a:cubicBezTo>
                    <a:cubicBezTo>
                      <a:pt x="150725" y="172497"/>
                      <a:pt x="155478" y="175846"/>
                      <a:pt x="160774" y="175846"/>
                    </a:cubicBezTo>
                    <a:cubicBezTo>
                      <a:pt x="175939" y="175846"/>
                      <a:pt x="191120" y="173796"/>
                      <a:pt x="205991" y="170822"/>
                    </a:cubicBezTo>
                    <a:cubicBezTo>
                      <a:pt x="216377" y="168745"/>
                      <a:pt x="226088" y="164123"/>
                      <a:pt x="236136" y="160774"/>
                    </a:cubicBezTo>
                    <a:lnTo>
                      <a:pt x="266281" y="150725"/>
                    </a:lnTo>
                    <a:lnTo>
                      <a:pt x="281354" y="145701"/>
                    </a:lnTo>
                    <a:cubicBezTo>
                      <a:pt x="286378" y="144026"/>
                      <a:pt x="291138" y="140971"/>
                      <a:pt x="296426" y="140677"/>
                    </a:cubicBezTo>
                    <a:lnTo>
                      <a:pt x="386861" y="135653"/>
                    </a:lnTo>
                    <a:lnTo>
                      <a:pt x="462224" y="110532"/>
                    </a:lnTo>
                    <a:lnTo>
                      <a:pt x="477297" y="105508"/>
                    </a:lnTo>
                    <a:lnTo>
                      <a:pt x="492369" y="100484"/>
                    </a:lnTo>
                    <a:cubicBezTo>
                      <a:pt x="495718" y="97134"/>
                      <a:pt x="498355" y="92872"/>
                      <a:pt x="502417" y="90435"/>
                    </a:cubicBezTo>
                    <a:cubicBezTo>
                      <a:pt x="506958" y="87710"/>
                      <a:pt x="513354" y="88719"/>
                      <a:pt x="517490" y="85411"/>
                    </a:cubicBezTo>
                    <a:cubicBezTo>
                      <a:pt x="522205" y="81639"/>
                      <a:pt x="523766" y="75054"/>
                      <a:pt x="527538" y="70339"/>
                    </a:cubicBezTo>
                    <a:cubicBezTo>
                      <a:pt x="530497" y="66640"/>
                      <a:pt x="534628" y="63989"/>
                      <a:pt x="537587" y="60290"/>
                    </a:cubicBezTo>
                    <a:cubicBezTo>
                      <a:pt x="562944" y="28594"/>
                      <a:pt x="533417" y="59438"/>
                      <a:pt x="557683" y="35169"/>
                    </a:cubicBezTo>
                    <a:cubicBezTo>
                      <a:pt x="559358" y="30145"/>
                      <a:pt x="559983" y="24638"/>
                      <a:pt x="562708" y="20097"/>
                    </a:cubicBezTo>
                    <a:cubicBezTo>
                      <a:pt x="575124" y="-596"/>
                      <a:pt x="572756" y="20636"/>
                      <a:pt x="572756" y="0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Freeform 13"/>
              <p:cNvSpPr/>
              <p:nvPr/>
            </p:nvSpPr>
            <p:spPr>
              <a:xfrm>
                <a:off x="3622431" y="4230356"/>
                <a:ext cx="170822" cy="281354"/>
              </a:xfrm>
              <a:custGeom>
                <a:avLst/>
                <a:gdLst>
                  <a:gd name="connsiteX0" fmla="*/ 0 w 170822"/>
                  <a:gd name="connsiteY0" fmla="*/ 0 h 281354"/>
                  <a:gd name="connsiteX1" fmla="*/ 25121 w 170822"/>
                  <a:gd name="connsiteY1" fmla="*/ 15073 h 281354"/>
                  <a:gd name="connsiteX2" fmla="*/ 30145 w 170822"/>
                  <a:gd name="connsiteY2" fmla="*/ 30145 h 281354"/>
                  <a:gd name="connsiteX3" fmla="*/ 50242 w 170822"/>
                  <a:gd name="connsiteY3" fmla="*/ 55266 h 281354"/>
                  <a:gd name="connsiteX4" fmla="*/ 60290 w 170822"/>
                  <a:gd name="connsiteY4" fmla="*/ 85411 h 281354"/>
                  <a:gd name="connsiteX5" fmla="*/ 70338 w 170822"/>
                  <a:gd name="connsiteY5" fmla="*/ 130629 h 281354"/>
                  <a:gd name="connsiteX6" fmla="*/ 90435 w 170822"/>
                  <a:gd name="connsiteY6" fmla="*/ 160774 h 281354"/>
                  <a:gd name="connsiteX7" fmla="*/ 95459 w 170822"/>
                  <a:gd name="connsiteY7" fmla="*/ 175846 h 281354"/>
                  <a:gd name="connsiteX8" fmla="*/ 115556 w 170822"/>
                  <a:gd name="connsiteY8" fmla="*/ 195943 h 281354"/>
                  <a:gd name="connsiteX9" fmla="*/ 120580 w 170822"/>
                  <a:gd name="connsiteY9" fmla="*/ 211015 h 281354"/>
                  <a:gd name="connsiteX10" fmla="*/ 140677 w 170822"/>
                  <a:gd name="connsiteY10" fmla="*/ 231112 h 281354"/>
                  <a:gd name="connsiteX11" fmla="*/ 150725 w 170822"/>
                  <a:gd name="connsiteY11" fmla="*/ 261257 h 281354"/>
                  <a:gd name="connsiteX12" fmla="*/ 170822 w 170822"/>
                  <a:gd name="connsiteY12" fmla="*/ 281354 h 281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170822" h="281354">
                    <a:moveTo>
                      <a:pt x="0" y="0"/>
                    </a:moveTo>
                    <a:cubicBezTo>
                      <a:pt x="8374" y="5024"/>
                      <a:pt x="18216" y="8168"/>
                      <a:pt x="25121" y="15073"/>
                    </a:cubicBezTo>
                    <a:cubicBezTo>
                      <a:pt x="28866" y="18818"/>
                      <a:pt x="27777" y="25408"/>
                      <a:pt x="30145" y="30145"/>
                    </a:cubicBezTo>
                    <a:cubicBezTo>
                      <a:pt x="36484" y="42824"/>
                      <a:pt x="40894" y="45919"/>
                      <a:pt x="50242" y="55266"/>
                    </a:cubicBezTo>
                    <a:cubicBezTo>
                      <a:pt x="53591" y="65314"/>
                      <a:pt x="58549" y="74963"/>
                      <a:pt x="60290" y="85411"/>
                    </a:cubicBezTo>
                    <a:cubicBezTo>
                      <a:pt x="61653" y="93588"/>
                      <a:pt x="64449" y="120028"/>
                      <a:pt x="70338" y="130629"/>
                    </a:cubicBezTo>
                    <a:cubicBezTo>
                      <a:pt x="76203" y="141186"/>
                      <a:pt x="86616" y="149317"/>
                      <a:pt x="90435" y="160774"/>
                    </a:cubicBezTo>
                    <a:cubicBezTo>
                      <a:pt x="92110" y="165798"/>
                      <a:pt x="92381" y="171537"/>
                      <a:pt x="95459" y="175846"/>
                    </a:cubicBezTo>
                    <a:cubicBezTo>
                      <a:pt x="100966" y="183555"/>
                      <a:pt x="115556" y="195943"/>
                      <a:pt x="115556" y="195943"/>
                    </a:cubicBezTo>
                    <a:cubicBezTo>
                      <a:pt x="117231" y="200967"/>
                      <a:pt x="117502" y="206706"/>
                      <a:pt x="120580" y="211015"/>
                    </a:cubicBezTo>
                    <a:cubicBezTo>
                      <a:pt x="126087" y="218724"/>
                      <a:pt x="140677" y="231112"/>
                      <a:pt x="140677" y="231112"/>
                    </a:cubicBezTo>
                    <a:cubicBezTo>
                      <a:pt x="144026" y="241160"/>
                      <a:pt x="143235" y="253767"/>
                      <a:pt x="150725" y="261257"/>
                    </a:cubicBezTo>
                    <a:lnTo>
                      <a:pt x="170822" y="281354"/>
                    </a:ln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Freeform 14"/>
              <p:cNvSpPr/>
              <p:nvPr/>
            </p:nvSpPr>
            <p:spPr>
              <a:xfrm>
                <a:off x="5290457" y="4034413"/>
                <a:ext cx="487345" cy="226088"/>
              </a:xfrm>
              <a:custGeom>
                <a:avLst/>
                <a:gdLst>
                  <a:gd name="connsiteX0" fmla="*/ 0 w 487345"/>
                  <a:gd name="connsiteY0" fmla="*/ 0 h 226088"/>
                  <a:gd name="connsiteX1" fmla="*/ 5024 w 487345"/>
                  <a:gd name="connsiteY1" fmla="*/ 25121 h 226088"/>
                  <a:gd name="connsiteX2" fmla="*/ 25121 w 487345"/>
                  <a:gd name="connsiteY2" fmla="*/ 45218 h 226088"/>
                  <a:gd name="connsiteX3" fmla="*/ 40194 w 487345"/>
                  <a:gd name="connsiteY3" fmla="*/ 75363 h 226088"/>
                  <a:gd name="connsiteX4" fmla="*/ 45218 w 487345"/>
                  <a:gd name="connsiteY4" fmla="*/ 145701 h 226088"/>
                  <a:gd name="connsiteX5" fmla="*/ 50242 w 487345"/>
                  <a:gd name="connsiteY5" fmla="*/ 160774 h 226088"/>
                  <a:gd name="connsiteX6" fmla="*/ 80387 w 487345"/>
                  <a:gd name="connsiteY6" fmla="*/ 175846 h 226088"/>
                  <a:gd name="connsiteX7" fmla="*/ 100484 w 487345"/>
                  <a:gd name="connsiteY7" fmla="*/ 195943 h 226088"/>
                  <a:gd name="connsiteX8" fmla="*/ 110532 w 487345"/>
                  <a:gd name="connsiteY8" fmla="*/ 211016 h 226088"/>
                  <a:gd name="connsiteX9" fmla="*/ 125605 w 487345"/>
                  <a:gd name="connsiteY9" fmla="*/ 221064 h 226088"/>
                  <a:gd name="connsiteX10" fmla="*/ 185895 w 487345"/>
                  <a:gd name="connsiteY10" fmla="*/ 200967 h 226088"/>
                  <a:gd name="connsiteX11" fmla="*/ 200967 w 487345"/>
                  <a:gd name="connsiteY11" fmla="*/ 195943 h 226088"/>
                  <a:gd name="connsiteX12" fmla="*/ 216040 w 487345"/>
                  <a:gd name="connsiteY12" fmla="*/ 190919 h 226088"/>
                  <a:gd name="connsiteX13" fmla="*/ 251209 w 487345"/>
                  <a:gd name="connsiteY13" fmla="*/ 205991 h 226088"/>
                  <a:gd name="connsiteX14" fmla="*/ 266281 w 487345"/>
                  <a:gd name="connsiteY14" fmla="*/ 211016 h 226088"/>
                  <a:gd name="connsiteX15" fmla="*/ 281354 w 487345"/>
                  <a:gd name="connsiteY15" fmla="*/ 221064 h 226088"/>
                  <a:gd name="connsiteX16" fmla="*/ 306475 w 487345"/>
                  <a:gd name="connsiteY16" fmla="*/ 226088 h 226088"/>
                  <a:gd name="connsiteX17" fmla="*/ 411983 w 487345"/>
                  <a:gd name="connsiteY17" fmla="*/ 221064 h 226088"/>
                  <a:gd name="connsiteX18" fmla="*/ 457200 w 487345"/>
                  <a:gd name="connsiteY18" fmla="*/ 205991 h 226088"/>
                  <a:gd name="connsiteX19" fmla="*/ 472273 w 487345"/>
                  <a:gd name="connsiteY19" fmla="*/ 200967 h 226088"/>
                  <a:gd name="connsiteX20" fmla="*/ 487345 w 487345"/>
                  <a:gd name="connsiteY20" fmla="*/ 195943 h 2260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87345" h="226088">
                    <a:moveTo>
                      <a:pt x="0" y="0"/>
                    </a:moveTo>
                    <a:cubicBezTo>
                      <a:pt x="1675" y="8374"/>
                      <a:pt x="877" y="17656"/>
                      <a:pt x="5024" y="25121"/>
                    </a:cubicBezTo>
                    <a:cubicBezTo>
                      <a:pt x="9625" y="33403"/>
                      <a:pt x="19866" y="37335"/>
                      <a:pt x="25121" y="45218"/>
                    </a:cubicBezTo>
                    <a:cubicBezTo>
                      <a:pt x="38107" y="64697"/>
                      <a:pt x="33259" y="54562"/>
                      <a:pt x="40194" y="75363"/>
                    </a:cubicBezTo>
                    <a:cubicBezTo>
                      <a:pt x="41869" y="98809"/>
                      <a:pt x="42472" y="122356"/>
                      <a:pt x="45218" y="145701"/>
                    </a:cubicBezTo>
                    <a:cubicBezTo>
                      <a:pt x="45837" y="150961"/>
                      <a:pt x="46934" y="156638"/>
                      <a:pt x="50242" y="160774"/>
                    </a:cubicBezTo>
                    <a:cubicBezTo>
                      <a:pt x="57325" y="169628"/>
                      <a:pt x="70458" y="172537"/>
                      <a:pt x="80387" y="175846"/>
                    </a:cubicBezTo>
                    <a:cubicBezTo>
                      <a:pt x="87086" y="182545"/>
                      <a:pt x="95229" y="188060"/>
                      <a:pt x="100484" y="195943"/>
                    </a:cubicBezTo>
                    <a:cubicBezTo>
                      <a:pt x="103833" y="200967"/>
                      <a:pt x="106262" y="206746"/>
                      <a:pt x="110532" y="211016"/>
                    </a:cubicBezTo>
                    <a:cubicBezTo>
                      <a:pt x="114802" y="215286"/>
                      <a:pt x="120581" y="217715"/>
                      <a:pt x="125605" y="221064"/>
                    </a:cubicBezTo>
                    <a:lnTo>
                      <a:pt x="185895" y="200967"/>
                    </a:lnTo>
                    <a:lnTo>
                      <a:pt x="200967" y="195943"/>
                    </a:lnTo>
                    <a:lnTo>
                      <a:pt x="216040" y="190919"/>
                    </a:lnTo>
                    <a:cubicBezTo>
                      <a:pt x="257858" y="201373"/>
                      <a:pt x="216518" y="188645"/>
                      <a:pt x="251209" y="205991"/>
                    </a:cubicBezTo>
                    <a:cubicBezTo>
                      <a:pt x="255946" y="208359"/>
                      <a:pt x="261544" y="208648"/>
                      <a:pt x="266281" y="211016"/>
                    </a:cubicBezTo>
                    <a:cubicBezTo>
                      <a:pt x="271682" y="213717"/>
                      <a:pt x="275700" y="218944"/>
                      <a:pt x="281354" y="221064"/>
                    </a:cubicBezTo>
                    <a:cubicBezTo>
                      <a:pt x="289350" y="224062"/>
                      <a:pt x="298101" y="224413"/>
                      <a:pt x="306475" y="226088"/>
                    </a:cubicBezTo>
                    <a:cubicBezTo>
                      <a:pt x="341644" y="224413"/>
                      <a:pt x="376989" y="224952"/>
                      <a:pt x="411983" y="221064"/>
                    </a:cubicBezTo>
                    <a:cubicBezTo>
                      <a:pt x="411998" y="221062"/>
                      <a:pt x="449657" y="208506"/>
                      <a:pt x="457200" y="205991"/>
                    </a:cubicBezTo>
                    <a:lnTo>
                      <a:pt x="472273" y="200967"/>
                    </a:lnTo>
                    <a:lnTo>
                      <a:pt x="487345" y="195943"/>
                    </a:ln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Freeform 15"/>
              <p:cNvSpPr/>
              <p:nvPr/>
            </p:nvSpPr>
            <p:spPr>
              <a:xfrm>
                <a:off x="5325626" y="4260501"/>
                <a:ext cx="95460" cy="221064"/>
              </a:xfrm>
              <a:custGeom>
                <a:avLst/>
                <a:gdLst>
                  <a:gd name="connsiteX0" fmla="*/ 95460 w 95460"/>
                  <a:gd name="connsiteY0" fmla="*/ 0 h 221064"/>
                  <a:gd name="connsiteX1" fmla="*/ 90436 w 95460"/>
                  <a:gd name="connsiteY1" fmla="*/ 30145 h 221064"/>
                  <a:gd name="connsiteX2" fmla="*/ 85411 w 95460"/>
                  <a:gd name="connsiteY2" fmla="*/ 45218 h 221064"/>
                  <a:gd name="connsiteX3" fmla="*/ 70339 w 95460"/>
                  <a:gd name="connsiteY3" fmla="*/ 50242 h 221064"/>
                  <a:gd name="connsiteX4" fmla="*/ 50242 w 95460"/>
                  <a:gd name="connsiteY4" fmla="*/ 90435 h 221064"/>
                  <a:gd name="connsiteX5" fmla="*/ 30145 w 95460"/>
                  <a:gd name="connsiteY5" fmla="*/ 160774 h 221064"/>
                  <a:gd name="connsiteX6" fmla="*/ 20097 w 95460"/>
                  <a:gd name="connsiteY6" fmla="*/ 175846 h 221064"/>
                  <a:gd name="connsiteX7" fmla="*/ 10049 w 95460"/>
                  <a:gd name="connsiteY7" fmla="*/ 205991 h 221064"/>
                  <a:gd name="connsiteX8" fmla="*/ 5025 w 95460"/>
                  <a:gd name="connsiteY8" fmla="*/ 221064 h 221064"/>
                  <a:gd name="connsiteX9" fmla="*/ 0 w 95460"/>
                  <a:gd name="connsiteY9" fmla="*/ 221064 h 22106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95460" h="221064">
                    <a:moveTo>
                      <a:pt x="95460" y="0"/>
                    </a:moveTo>
                    <a:cubicBezTo>
                      <a:pt x="93785" y="10048"/>
                      <a:pt x="92646" y="20201"/>
                      <a:pt x="90436" y="30145"/>
                    </a:cubicBezTo>
                    <a:cubicBezTo>
                      <a:pt x="89287" y="35315"/>
                      <a:pt x="89156" y="41473"/>
                      <a:pt x="85411" y="45218"/>
                    </a:cubicBezTo>
                    <a:cubicBezTo>
                      <a:pt x="81666" y="48963"/>
                      <a:pt x="75363" y="48567"/>
                      <a:pt x="70339" y="50242"/>
                    </a:cubicBezTo>
                    <a:cubicBezTo>
                      <a:pt x="54521" y="66058"/>
                      <a:pt x="57939" y="59644"/>
                      <a:pt x="50242" y="90435"/>
                    </a:cubicBezTo>
                    <a:cubicBezTo>
                      <a:pt x="48901" y="95800"/>
                      <a:pt x="35913" y="152121"/>
                      <a:pt x="30145" y="160774"/>
                    </a:cubicBezTo>
                    <a:lnTo>
                      <a:pt x="20097" y="175846"/>
                    </a:lnTo>
                    <a:lnTo>
                      <a:pt x="10049" y="205991"/>
                    </a:lnTo>
                    <a:cubicBezTo>
                      <a:pt x="8374" y="211015"/>
                      <a:pt x="10321" y="221064"/>
                      <a:pt x="5025" y="221064"/>
                    </a:cubicBezTo>
                    <a:lnTo>
                      <a:pt x="0" y="221064"/>
                    </a:ln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Freeform 16"/>
              <p:cNvSpPr/>
              <p:nvPr/>
            </p:nvSpPr>
            <p:spPr>
              <a:xfrm>
                <a:off x="3788229" y="4451420"/>
                <a:ext cx="135692" cy="70338"/>
              </a:xfrm>
              <a:custGeom>
                <a:avLst/>
                <a:gdLst>
                  <a:gd name="connsiteX0" fmla="*/ 0 w 135692"/>
                  <a:gd name="connsiteY0" fmla="*/ 70338 h 70338"/>
                  <a:gd name="connsiteX1" fmla="*/ 25120 w 135692"/>
                  <a:gd name="connsiteY1" fmla="*/ 55266 h 70338"/>
                  <a:gd name="connsiteX2" fmla="*/ 40193 w 135692"/>
                  <a:gd name="connsiteY2" fmla="*/ 50242 h 70338"/>
                  <a:gd name="connsiteX3" fmla="*/ 50241 w 135692"/>
                  <a:gd name="connsiteY3" fmla="*/ 40193 h 70338"/>
                  <a:gd name="connsiteX4" fmla="*/ 80386 w 135692"/>
                  <a:gd name="connsiteY4" fmla="*/ 30145 h 70338"/>
                  <a:gd name="connsiteX5" fmla="*/ 120580 w 135692"/>
                  <a:gd name="connsiteY5" fmla="*/ 10048 h 70338"/>
                  <a:gd name="connsiteX6" fmla="*/ 135652 w 135692"/>
                  <a:gd name="connsiteY6" fmla="*/ 0 h 703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35692" h="70338">
                    <a:moveTo>
                      <a:pt x="0" y="70338"/>
                    </a:moveTo>
                    <a:cubicBezTo>
                      <a:pt x="8373" y="65314"/>
                      <a:pt x="16386" y="59633"/>
                      <a:pt x="25120" y="55266"/>
                    </a:cubicBezTo>
                    <a:cubicBezTo>
                      <a:pt x="29857" y="52898"/>
                      <a:pt x="35652" y="52967"/>
                      <a:pt x="40193" y="50242"/>
                    </a:cubicBezTo>
                    <a:cubicBezTo>
                      <a:pt x="44255" y="47805"/>
                      <a:pt x="46004" y="42311"/>
                      <a:pt x="50241" y="40193"/>
                    </a:cubicBezTo>
                    <a:cubicBezTo>
                      <a:pt x="59715" y="35456"/>
                      <a:pt x="80386" y="30145"/>
                      <a:pt x="80386" y="30145"/>
                    </a:cubicBezTo>
                    <a:cubicBezTo>
                      <a:pt x="97925" y="12606"/>
                      <a:pt x="85941" y="21594"/>
                      <a:pt x="120580" y="10048"/>
                    </a:cubicBezTo>
                    <a:cubicBezTo>
                      <a:pt x="137241" y="4495"/>
                      <a:pt x="135652" y="10320"/>
                      <a:pt x="135652" y="0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Freeform 17"/>
              <p:cNvSpPr/>
              <p:nvPr/>
            </p:nvSpPr>
            <p:spPr>
              <a:xfrm>
                <a:off x="5215095" y="4451420"/>
                <a:ext cx="125604" cy="30145"/>
              </a:xfrm>
              <a:custGeom>
                <a:avLst/>
                <a:gdLst>
                  <a:gd name="connsiteX0" fmla="*/ 0 w 125604"/>
                  <a:gd name="connsiteY0" fmla="*/ 0 h 30145"/>
                  <a:gd name="connsiteX1" fmla="*/ 70338 w 125604"/>
                  <a:gd name="connsiteY1" fmla="*/ 5024 h 30145"/>
                  <a:gd name="connsiteX2" fmla="*/ 85410 w 125604"/>
                  <a:gd name="connsiteY2" fmla="*/ 10048 h 30145"/>
                  <a:gd name="connsiteX3" fmla="*/ 95459 w 125604"/>
                  <a:gd name="connsiteY3" fmla="*/ 20096 h 30145"/>
                  <a:gd name="connsiteX4" fmla="*/ 125604 w 125604"/>
                  <a:gd name="connsiteY4" fmla="*/ 30145 h 301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25604" h="30145">
                    <a:moveTo>
                      <a:pt x="0" y="0"/>
                    </a:moveTo>
                    <a:cubicBezTo>
                      <a:pt x="23446" y="1675"/>
                      <a:pt x="46993" y="2278"/>
                      <a:pt x="70338" y="5024"/>
                    </a:cubicBezTo>
                    <a:cubicBezTo>
                      <a:pt x="75597" y="5643"/>
                      <a:pt x="80869" y="7323"/>
                      <a:pt x="85410" y="10048"/>
                    </a:cubicBezTo>
                    <a:cubicBezTo>
                      <a:pt x="89472" y="12485"/>
                      <a:pt x="91222" y="17978"/>
                      <a:pt x="95459" y="20096"/>
                    </a:cubicBezTo>
                    <a:cubicBezTo>
                      <a:pt x="104933" y="24833"/>
                      <a:pt x="125604" y="30145"/>
                      <a:pt x="125604" y="30145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Freeform 10"/>
            <p:cNvSpPr/>
            <p:nvPr/>
          </p:nvSpPr>
          <p:spPr>
            <a:xfrm>
              <a:off x="3537020" y="3933930"/>
              <a:ext cx="266281" cy="170822"/>
            </a:xfrm>
            <a:custGeom>
              <a:avLst/>
              <a:gdLst>
                <a:gd name="connsiteX0" fmla="*/ 0 w 266281"/>
                <a:gd name="connsiteY0" fmla="*/ 0 h 170822"/>
                <a:gd name="connsiteX1" fmla="*/ 25121 w 266281"/>
                <a:gd name="connsiteY1" fmla="*/ 10048 h 170822"/>
                <a:gd name="connsiteX2" fmla="*/ 40193 w 266281"/>
                <a:gd name="connsiteY2" fmla="*/ 15072 h 170822"/>
                <a:gd name="connsiteX3" fmla="*/ 50242 w 266281"/>
                <a:gd name="connsiteY3" fmla="*/ 25121 h 170822"/>
                <a:gd name="connsiteX4" fmla="*/ 95459 w 266281"/>
                <a:gd name="connsiteY4" fmla="*/ 50241 h 170822"/>
                <a:gd name="connsiteX5" fmla="*/ 120580 w 266281"/>
                <a:gd name="connsiteY5" fmla="*/ 65314 h 170822"/>
                <a:gd name="connsiteX6" fmla="*/ 150725 w 266281"/>
                <a:gd name="connsiteY6" fmla="*/ 85411 h 170822"/>
                <a:gd name="connsiteX7" fmla="*/ 180870 w 266281"/>
                <a:gd name="connsiteY7" fmla="*/ 105507 h 170822"/>
                <a:gd name="connsiteX8" fmla="*/ 190918 w 266281"/>
                <a:gd name="connsiteY8" fmla="*/ 115556 h 170822"/>
                <a:gd name="connsiteX9" fmla="*/ 236136 w 266281"/>
                <a:gd name="connsiteY9" fmla="*/ 140677 h 170822"/>
                <a:gd name="connsiteX10" fmla="*/ 256233 w 266281"/>
                <a:gd name="connsiteY10" fmla="*/ 160773 h 170822"/>
                <a:gd name="connsiteX11" fmla="*/ 266281 w 266281"/>
                <a:gd name="connsiteY11" fmla="*/ 170822 h 1708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266281" h="170822">
                  <a:moveTo>
                    <a:pt x="0" y="0"/>
                  </a:moveTo>
                  <a:cubicBezTo>
                    <a:pt x="8374" y="3349"/>
                    <a:pt x="16677" y="6881"/>
                    <a:pt x="25121" y="10048"/>
                  </a:cubicBezTo>
                  <a:cubicBezTo>
                    <a:pt x="30080" y="11907"/>
                    <a:pt x="35652" y="12347"/>
                    <a:pt x="40193" y="15072"/>
                  </a:cubicBezTo>
                  <a:cubicBezTo>
                    <a:pt x="44255" y="17509"/>
                    <a:pt x="46452" y="22279"/>
                    <a:pt x="50242" y="25121"/>
                  </a:cubicBezTo>
                  <a:cubicBezTo>
                    <a:pt x="77882" y="45851"/>
                    <a:pt x="71961" y="42408"/>
                    <a:pt x="95459" y="50241"/>
                  </a:cubicBezTo>
                  <a:cubicBezTo>
                    <a:pt x="126744" y="81529"/>
                    <a:pt x="81456" y="39233"/>
                    <a:pt x="120580" y="65314"/>
                  </a:cubicBezTo>
                  <a:cubicBezTo>
                    <a:pt x="158221" y="90406"/>
                    <a:pt x="114883" y="73461"/>
                    <a:pt x="150725" y="85411"/>
                  </a:cubicBezTo>
                  <a:cubicBezTo>
                    <a:pt x="189061" y="123745"/>
                    <a:pt x="144510" y="83689"/>
                    <a:pt x="180870" y="105507"/>
                  </a:cubicBezTo>
                  <a:cubicBezTo>
                    <a:pt x="184932" y="107944"/>
                    <a:pt x="187128" y="112714"/>
                    <a:pt x="190918" y="115556"/>
                  </a:cubicBezTo>
                  <a:cubicBezTo>
                    <a:pt x="218556" y="136284"/>
                    <a:pt x="212639" y="132843"/>
                    <a:pt x="236136" y="140677"/>
                  </a:cubicBezTo>
                  <a:cubicBezTo>
                    <a:pt x="245068" y="167473"/>
                    <a:pt x="233903" y="147374"/>
                    <a:pt x="256233" y="160773"/>
                  </a:cubicBezTo>
                  <a:cubicBezTo>
                    <a:pt x="260295" y="163210"/>
                    <a:pt x="266281" y="170822"/>
                    <a:pt x="266281" y="170822"/>
                  </a:cubicBezTo>
                </a:path>
              </a:pathLst>
            </a:custGeom>
            <a:noFill/>
            <a:ln>
              <a:solidFill>
                <a:schemeClr val="accent3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Freeform 11"/>
            <p:cNvSpPr/>
            <p:nvPr/>
          </p:nvSpPr>
          <p:spPr>
            <a:xfrm>
              <a:off x="5290457" y="3943978"/>
              <a:ext cx="236136" cy="90435"/>
            </a:xfrm>
            <a:custGeom>
              <a:avLst/>
              <a:gdLst>
                <a:gd name="connsiteX0" fmla="*/ 0 w 236136"/>
                <a:gd name="connsiteY0" fmla="*/ 90435 h 90435"/>
                <a:gd name="connsiteX1" fmla="*/ 25121 w 236136"/>
                <a:gd name="connsiteY1" fmla="*/ 75363 h 90435"/>
                <a:gd name="connsiteX2" fmla="*/ 55266 w 236136"/>
                <a:gd name="connsiteY2" fmla="*/ 65314 h 90435"/>
                <a:gd name="connsiteX3" fmla="*/ 70339 w 236136"/>
                <a:gd name="connsiteY3" fmla="*/ 55266 h 90435"/>
                <a:gd name="connsiteX4" fmla="*/ 100484 w 236136"/>
                <a:gd name="connsiteY4" fmla="*/ 45218 h 90435"/>
                <a:gd name="connsiteX5" fmla="*/ 115556 w 236136"/>
                <a:gd name="connsiteY5" fmla="*/ 40193 h 90435"/>
                <a:gd name="connsiteX6" fmla="*/ 130629 w 236136"/>
                <a:gd name="connsiteY6" fmla="*/ 35169 h 90435"/>
                <a:gd name="connsiteX7" fmla="*/ 145701 w 236136"/>
                <a:gd name="connsiteY7" fmla="*/ 25121 h 90435"/>
                <a:gd name="connsiteX8" fmla="*/ 165798 w 236136"/>
                <a:gd name="connsiteY8" fmla="*/ 20097 h 90435"/>
                <a:gd name="connsiteX9" fmla="*/ 195943 w 236136"/>
                <a:gd name="connsiteY9" fmla="*/ 10048 h 90435"/>
                <a:gd name="connsiteX10" fmla="*/ 211016 w 236136"/>
                <a:gd name="connsiteY10" fmla="*/ 5024 h 90435"/>
                <a:gd name="connsiteX11" fmla="*/ 226088 w 236136"/>
                <a:gd name="connsiteY11" fmla="*/ 0 h 90435"/>
                <a:gd name="connsiteX12" fmla="*/ 236136 w 236136"/>
                <a:gd name="connsiteY12" fmla="*/ 0 h 904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236136" h="90435">
                  <a:moveTo>
                    <a:pt x="0" y="90435"/>
                  </a:moveTo>
                  <a:cubicBezTo>
                    <a:pt x="8374" y="85411"/>
                    <a:pt x="16231" y="79404"/>
                    <a:pt x="25121" y="75363"/>
                  </a:cubicBezTo>
                  <a:cubicBezTo>
                    <a:pt x="34764" y="70980"/>
                    <a:pt x="46453" y="71189"/>
                    <a:pt x="55266" y="65314"/>
                  </a:cubicBezTo>
                  <a:cubicBezTo>
                    <a:pt x="60290" y="61965"/>
                    <a:pt x="64821" y="57718"/>
                    <a:pt x="70339" y="55266"/>
                  </a:cubicBezTo>
                  <a:cubicBezTo>
                    <a:pt x="80018" y="50964"/>
                    <a:pt x="90436" y="48568"/>
                    <a:pt x="100484" y="45218"/>
                  </a:cubicBezTo>
                  <a:lnTo>
                    <a:pt x="115556" y="40193"/>
                  </a:lnTo>
                  <a:lnTo>
                    <a:pt x="130629" y="35169"/>
                  </a:lnTo>
                  <a:cubicBezTo>
                    <a:pt x="135653" y="31820"/>
                    <a:pt x="140151" y="27499"/>
                    <a:pt x="145701" y="25121"/>
                  </a:cubicBezTo>
                  <a:cubicBezTo>
                    <a:pt x="152048" y="22401"/>
                    <a:pt x="159184" y="22081"/>
                    <a:pt x="165798" y="20097"/>
                  </a:cubicBezTo>
                  <a:cubicBezTo>
                    <a:pt x="175943" y="17053"/>
                    <a:pt x="185895" y="13398"/>
                    <a:pt x="195943" y="10048"/>
                  </a:cubicBezTo>
                  <a:lnTo>
                    <a:pt x="211016" y="5024"/>
                  </a:lnTo>
                  <a:cubicBezTo>
                    <a:pt x="216040" y="3349"/>
                    <a:pt x="220792" y="0"/>
                    <a:pt x="226088" y="0"/>
                  </a:cubicBezTo>
                  <a:lnTo>
                    <a:pt x="236136" y="0"/>
                  </a:lnTo>
                </a:path>
              </a:pathLst>
            </a:custGeom>
            <a:noFill/>
            <a:ln>
              <a:solidFill>
                <a:schemeClr val="accent3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6477000" y="990600"/>
            <a:ext cx="2560320" cy="3657600"/>
            <a:chOff x="6328389" y="3212605"/>
            <a:chExt cx="1828800" cy="2651760"/>
          </a:xfrm>
        </p:grpSpPr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28389" y="3212605"/>
              <a:ext cx="1828800" cy="2651760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36" name="Group 35"/>
            <p:cNvGrpSpPr/>
            <p:nvPr/>
          </p:nvGrpSpPr>
          <p:grpSpPr>
            <a:xfrm>
              <a:off x="6976601" y="4263134"/>
              <a:ext cx="553447" cy="272210"/>
              <a:chOff x="6529388" y="3294812"/>
              <a:chExt cx="971550" cy="472326"/>
            </a:xfrm>
          </p:grpSpPr>
          <p:sp>
            <p:nvSpPr>
              <p:cNvPr id="37" name="Freeform 36"/>
              <p:cNvSpPr/>
              <p:nvPr/>
            </p:nvSpPr>
            <p:spPr>
              <a:xfrm>
                <a:off x="6529388" y="3309655"/>
                <a:ext cx="395643" cy="440653"/>
              </a:xfrm>
              <a:custGeom>
                <a:avLst/>
                <a:gdLst>
                  <a:gd name="connsiteX0" fmla="*/ 185737 w 395643"/>
                  <a:gd name="connsiteY0" fmla="*/ 5045 h 440653"/>
                  <a:gd name="connsiteX1" fmla="*/ 157162 w 395643"/>
                  <a:gd name="connsiteY1" fmla="*/ 283 h 440653"/>
                  <a:gd name="connsiteX2" fmla="*/ 61912 w 395643"/>
                  <a:gd name="connsiteY2" fmla="*/ 9808 h 440653"/>
                  <a:gd name="connsiteX3" fmla="*/ 47625 w 395643"/>
                  <a:gd name="connsiteY3" fmla="*/ 38383 h 440653"/>
                  <a:gd name="connsiteX4" fmla="*/ 38100 w 395643"/>
                  <a:gd name="connsiteY4" fmla="*/ 52670 h 440653"/>
                  <a:gd name="connsiteX5" fmla="*/ 28575 w 395643"/>
                  <a:gd name="connsiteY5" fmla="*/ 81245 h 440653"/>
                  <a:gd name="connsiteX6" fmla="*/ 19050 w 395643"/>
                  <a:gd name="connsiteY6" fmla="*/ 109820 h 440653"/>
                  <a:gd name="connsiteX7" fmla="*/ 4762 w 395643"/>
                  <a:gd name="connsiteY7" fmla="*/ 152683 h 440653"/>
                  <a:gd name="connsiteX8" fmla="*/ 0 w 395643"/>
                  <a:gd name="connsiteY8" fmla="*/ 166970 h 440653"/>
                  <a:gd name="connsiteX9" fmla="*/ 4762 w 395643"/>
                  <a:gd name="connsiteY9" fmla="*/ 224120 h 440653"/>
                  <a:gd name="connsiteX10" fmla="*/ 19050 w 395643"/>
                  <a:gd name="connsiteY10" fmla="*/ 286033 h 440653"/>
                  <a:gd name="connsiteX11" fmla="*/ 28575 w 395643"/>
                  <a:gd name="connsiteY11" fmla="*/ 314608 h 440653"/>
                  <a:gd name="connsiteX12" fmla="*/ 61912 w 395643"/>
                  <a:gd name="connsiteY12" fmla="*/ 357470 h 440653"/>
                  <a:gd name="connsiteX13" fmla="*/ 76200 w 395643"/>
                  <a:gd name="connsiteY13" fmla="*/ 362233 h 440653"/>
                  <a:gd name="connsiteX14" fmla="*/ 80962 w 395643"/>
                  <a:gd name="connsiteY14" fmla="*/ 376520 h 440653"/>
                  <a:gd name="connsiteX15" fmla="*/ 109537 w 395643"/>
                  <a:gd name="connsiteY15" fmla="*/ 390808 h 440653"/>
                  <a:gd name="connsiteX16" fmla="*/ 119062 w 395643"/>
                  <a:gd name="connsiteY16" fmla="*/ 405095 h 440653"/>
                  <a:gd name="connsiteX17" fmla="*/ 147637 w 395643"/>
                  <a:gd name="connsiteY17" fmla="*/ 414620 h 440653"/>
                  <a:gd name="connsiteX18" fmla="*/ 161925 w 395643"/>
                  <a:gd name="connsiteY18" fmla="*/ 419383 h 440653"/>
                  <a:gd name="connsiteX19" fmla="*/ 219075 w 395643"/>
                  <a:gd name="connsiteY19" fmla="*/ 428908 h 440653"/>
                  <a:gd name="connsiteX20" fmla="*/ 233362 w 395643"/>
                  <a:gd name="connsiteY20" fmla="*/ 438433 h 440653"/>
                  <a:gd name="connsiteX21" fmla="*/ 314325 w 395643"/>
                  <a:gd name="connsiteY21" fmla="*/ 424145 h 440653"/>
                  <a:gd name="connsiteX22" fmla="*/ 333375 w 395643"/>
                  <a:gd name="connsiteY22" fmla="*/ 400333 h 440653"/>
                  <a:gd name="connsiteX23" fmla="*/ 338137 w 395643"/>
                  <a:gd name="connsiteY23" fmla="*/ 386045 h 440653"/>
                  <a:gd name="connsiteX24" fmla="*/ 347662 w 395643"/>
                  <a:gd name="connsiteY24" fmla="*/ 371758 h 440653"/>
                  <a:gd name="connsiteX25" fmla="*/ 357187 w 395643"/>
                  <a:gd name="connsiteY25" fmla="*/ 343183 h 440653"/>
                  <a:gd name="connsiteX26" fmla="*/ 361950 w 395643"/>
                  <a:gd name="connsiteY26" fmla="*/ 328895 h 440653"/>
                  <a:gd name="connsiteX27" fmla="*/ 376237 w 395643"/>
                  <a:gd name="connsiteY27" fmla="*/ 286033 h 440653"/>
                  <a:gd name="connsiteX28" fmla="*/ 385762 w 395643"/>
                  <a:gd name="connsiteY28" fmla="*/ 257458 h 440653"/>
                  <a:gd name="connsiteX29" fmla="*/ 395287 w 395643"/>
                  <a:gd name="connsiteY29" fmla="*/ 205070 h 440653"/>
                  <a:gd name="connsiteX30" fmla="*/ 385762 w 395643"/>
                  <a:gd name="connsiteY30" fmla="*/ 105058 h 440653"/>
                  <a:gd name="connsiteX31" fmla="*/ 376237 w 395643"/>
                  <a:gd name="connsiteY31" fmla="*/ 90770 h 440653"/>
                  <a:gd name="connsiteX32" fmla="*/ 361950 w 395643"/>
                  <a:gd name="connsiteY32" fmla="*/ 86008 h 440653"/>
                  <a:gd name="connsiteX33" fmla="*/ 352425 w 395643"/>
                  <a:gd name="connsiteY33" fmla="*/ 71720 h 440653"/>
                  <a:gd name="connsiteX34" fmla="*/ 323850 w 395643"/>
                  <a:gd name="connsiteY34" fmla="*/ 52670 h 440653"/>
                  <a:gd name="connsiteX35" fmla="*/ 295275 w 395643"/>
                  <a:gd name="connsiteY35" fmla="*/ 38383 h 440653"/>
                  <a:gd name="connsiteX36" fmla="*/ 280987 w 395643"/>
                  <a:gd name="connsiteY36" fmla="*/ 28858 h 440653"/>
                  <a:gd name="connsiteX37" fmla="*/ 219075 w 395643"/>
                  <a:gd name="connsiteY37" fmla="*/ 14570 h 440653"/>
                  <a:gd name="connsiteX38" fmla="*/ 185737 w 395643"/>
                  <a:gd name="connsiteY38" fmla="*/ 5045 h 4406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</a:cxnLst>
                <a:rect l="l" t="t" r="r" b="b"/>
                <a:pathLst>
                  <a:path w="395643" h="440653">
                    <a:moveTo>
                      <a:pt x="185737" y="5045"/>
                    </a:moveTo>
                    <a:cubicBezTo>
                      <a:pt x="175418" y="2664"/>
                      <a:pt x="166818" y="283"/>
                      <a:pt x="157162" y="283"/>
                    </a:cubicBezTo>
                    <a:cubicBezTo>
                      <a:pt x="86358" y="283"/>
                      <a:pt x="99030" y="-2565"/>
                      <a:pt x="61912" y="9808"/>
                    </a:cubicBezTo>
                    <a:cubicBezTo>
                      <a:pt x="34615" y="50751"/>
                      <a:pt x="67342" y="-1052"/>
                      <a:pt x="47625" y="38383"/>
                    </a:cubicBezTo>
                    <a:cubicBezTo>
                      <a:pt x="45065" y="43502"/>
                      <a:pt x="40425" y="47440"/>
                      <a:pt x="38100" y="52670"/>
                    </a:cubicBezTo>
                    <a:cubicBezTo>
                      <a:pt x="34022" y="61845"/>
                      <a:pt x="31750" y="71720"/>
                      <a:pt x="28575" y="81245"/>
                    </a:cubicBezTo>
                    <a:lnTo>
                      <a:pt x="19050" y="109820"/>
                    </a:lnTo>
                    <a:lnTo>
                      <a:pt x="4762" y="152683"/>
                    </a:lnTo>
                    <a:lnTo>
                      <a:pt x="0" y="166970"/>
                    </a:lnTo>
                    <a:cubicBezTo>
                      <a:pt x="1587" y="186020"/>
                      <a:pt x="2761" y="205109"/>
                      <a:pt x="4762" y="224120"/>
                    </a:cubicBezTo>
                    <a:cubicBezTo>
                      <a:pt x="8566" y="260262"/>
                      <a:pt x="8103" y="253190"/>
                      <a:pt x="19050" y="286033"/>
                    </a:cubicBezTo>
                    <a:lnTo>
                      <a:pt x="28575" y="314608"/>
                    </a:lnTo>
                    <a:cubicBezTo>
                      <a:pt x="34604" y="332696"/>
                      <a:pt x="37816" y="349438"/>
                      <a:pt x="61912" y="357470"/>
                    </a:cubicBezTo>
                    <a:lnTo>
                      <a:pt x="76200" y="362233"/>
                    </a:lnTo>
                    <a:cubicBezTo>
                      <a:pt x="77787" y="366995"/>
                      <a:pt x="77826" y="372600"/>
                      <a:pt x="80962" y="376520"/>
                    </a:cubicBezTo>
                    <a:cubicBezTo>
                      <a:pt x="87676" y="384912"/>
                      <a:pt x="100126" y="387671"/>
                      <a:pt x="109537" y="390808"/>
                    </a:cubicBezTo>
                    <a:cubicBezTo>
                      <a:pt x="112712" y="395570"/>
                      <a:pt x="114208" y="402062"/>
                      <a:pt x="119062" y="405095"/>
                    </a:cubicBezTo>
                    <a:cubicBezTo>
                      <a:pt x="127576" y="410416"/>
                      <a:pt x="138112" y="411445"/>
                      <a:pt x="147637" y="414620"/>
                    </a:cubicBezTo>
                    <a:cubicBezTo>
                      <a:pt x="152400" y="416208"/>
                      <a:pt x="156973" y="418558"/>
                      <a:pt x="161925" y="419383"/>
                    </a:cubicBezTo>
                    <a:lnTo>
                      <a:pt x="219075" y="428908"/>
                    </a:lnTo>
                    <a:cubicBezTo>
                      <a:pt x="223837" y="432083"/>
                      <a:pt x="227648" y="438097"/>
                      <a:pt x="233362" y="438433"/>
                    </a:cubicBezTo>
                    <a:cubicBezTo>
                      <a:pt x="292750" y="441926"/>
                      <a:pt x="284836" y="443804"/>
                      <a:pt x="314325" y="424145"/>
                    </a:cubicBezTo>
                    <a:cubicBezTo>
                      <a:pt x="326295" y="388233"/>
                      <a:pt x="308755" y="431108"/>
                      <a:pt x="333375" y="400333"/>
                    </a:cubicBezTo>
                    <a:cubicBezTo>
                      <a:pt x="336511" y="396413"/>
                      <a:pt x="335892" y="390535"/>
                      <a:pt x="338137" y="386045"/>
                    </a:cubicBezTo>
                    <a:cubicBezTo>
                      <a:pt x="340697" y="380926"/>
                      <a:pt x="345337" y="376988"/>
                      <a:pt x="347662" y="371758"/>
                    </a:cubicBezTo>
                    <a:cubicBezTo>
                      <a:pt x="351740" y="362583"/>
                      <a:pt x="354012" y="352708"/>
                      <a:pt x="357187" y="343183"/>
                    </a:cubicBezTo>
                    <a:lnTo>
                      <a:pt x="361950" y="328895"/>
                    </a:lnTo>
                    <a:lnTo>
                      <a:pt x="376237" y="286033"/>
                    </a:lnTo>
                    <a:cubicBezTo>
                      <a:pt x="376238" y="286029"/>
                      <a:pt x="385761" y="257463"/>
                      <a:pt x="385762" y="257458"/>
                    </a:cubicBezTo>
                    <a:cubicBezTo>
                      <a:pt x="391856" y="220898"/>
                      <a:pt x="388631" y="238352"/>
                      <a:pt x="395287" y="205070"/>
                    </a:cubicBezTo>
                    <a:cubicBezTo>
                      <a:pt x="395166" y="202900"/>
                      <a:pt x="398713" y="130960"/>
                      <a:pt x="385762" y="105058"/>
                    </a:cubicBezTo>
                    <a:cubicBezTo>
                      <a:pt x="383202" y="99938"/>
                      <a:pt x="380707" y="94346"/>
                      <a:pt x="376237" y="90770"/>
                    </a:cubicBezTo>
                    <a:cubicBezTo>
                      <a:pt x="372317" y="87634"/>
                      <a:pt x="366712" y="87595"/>
                      <a:pt x="361950" y="86008"/>
                    </a:cubicBezTo>
                    <a:cubicBezTo>
                      <a:pt x="358775" y="81245"/>
                      <a:pt x="356733" y="75489"/>
                      <a:pt x="352425" y="71720"/>
                    </a:cubicBezTo>
                    <a:cubicBezTo>
                      <a:pt x="343810" y="64182"/>
                      <a:pt x="333375" y="59020"/>
                      <a:pt x="323850" y="52670"/>
                    </a:cubicBezTo>
                    <a:cubicBezTo>
                      <a:pt x="305386" y="40361"/>
                      <a:pt x="314991" y="44955"/>
                      <a:pt x="295275" y="38383"/>
                    </a:cubicBezTo>
                    <a:cubicBezTo>
                      <a:pt x="290512" y="35208"/>
                      <a:pt x="286218" y="31183"/>
                      <a:pt x="280987" y="28858"/>
                    </a:cubicBezTo>
                    <a:cubicBezTo>
                      <a:pt x="256214" y="17848"/>
                      <a:pt x="246194" y="18445"/>
                      <a:pt x="219075" y="14570"/>
                    </a:cubicBezTo>
                    <a:cubicBezTo>
                      <a:pt x="198763" y="7800"/>
                      <a:pt x="196056" y="7426"/>
                      <a:pt x="185737" y="5045"/>
                    </a:cubicBezTo>
                    <a:close/>
                  </a:path>
                </a:pathLst>
              </a:cu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Freeform 37"/>
              <p:cNvSpPr/>
              <p:nvPr/>
            </p:nvSpPr>
            <p:spPr>
              <a:xfrm>
                <a:off x="7100888" y="3294812"/>
                <a:ext cx="400050" cy="472326"/>
              </a:xfrm>
              <a:custGeom>
                <a:avLst/>
                <a:gdLst>
                  <a:gd name="connsiteX0" fmla="*/ 314325 w 400050"/>
                  <a:gd name="connsiteY0" fmla="*/ 19888 h 472326"/>
                  <a:gd name="connsiteX1" fmla="*/ 290512 w 400050"/>
                  <a:gd name="connsiteY1" fmla="*/ 15126 h 472326"/>
                  <a:gd name="connsiteX2" fmla="*/ 285750 w 400050"/>
                  <a:gd name="connsiteY2" fmla="*/ 838 h 472326"/>
                  <a:gd name="connsiteX3" fmla="*/ 133350 w 400050"/>
                  <a:gd name="connsiteY3" fmla="*/ 5601 h 472326"/>
                  <a:gd name="connsiteX4" fmla="*/ 119062 w 400050"/>
                  <a:gd name="connsiteY4" fmla="*/ 10363 h 472326"/>
                  <a:gd name="connsiteX5" fmla="*/ 109537 w 400050"/>
                  <a:gd name="connsiteY5" fmla="*/ 24651 h 472326"/>
                  <a:gd name="connsiteX6" fmla="*/ 80962 w 400050"/>
                  <a:gd name="connsiteY6" fmla="*/ 48463 h 472326"/>
                  <a:gd name="connsiteX7" fmla="*/ 66675 w 400050"/>
                  <a:gd name="connsiteY7" fmla="*/ 77038 h 472326"/>
                  <a:gd name="connsiteX8" fmla="*/ 61912 w 400050"/>
                  <a:gd name="connsiteY8" fmla="*/ 91326 h 472326"/>
                  <a:gd name="connsiteX9" fmla="*/ 28575 w 400050"/>
                  <a:gd name="connsiteY9" fmla="*/ 129426 h 472326"/>
                  <a:gd name="connsiteX10" fmla="*/ 9525 w 400050"/>
                  <a:gd name="connsiteY10" fmla="*/ 158001 h 472326"/>
                  <a:gd name="connsiteX11" fmla="*/ 0 w 400050"/>
                  <a:gd name="connsiteY11" fmla="*/ 186576 h 472326"/>
                  <a:gd name="connsiteX12" fmla="*/ 4762 w 400050"/>
                  <a:gd name="connsiteY12" fmla="*/ 253251 h 472326"/>
                  <a:gd name="connsiteX13" fmla="*/ 33337 w 400050"/>
                  <a:gd name="connsiteY13" fmla="*/ 310401 h 472326"/>
                  <a:gd name="connsiteX14" fmla="*/ 52387 w 400050"/>
                  <a:gd name="connsiteY14" fmla="*/ 338976 h 472326"/>
                  <a:gd name="connsiteX15" fmla="*/ 71437 w 400050"/>
                  <a:gd name="connsiteY15" fmla="*/ 367551 h 472326"/>
                  <a:gd name="connsiteX16" fmla="*/ 80962 w 400050"/>
                  <a:gd name="connsiteY16" fmla="*/ 381838 h 472326"/>
                  <a:gd name="connsiteX17" fmla="*/ 109537 w 400050"/>
                  <a:gd name="connsiteY17" fmla="*/ 410413 h 472326"/>
                  <a:gd name="connsiteX18" fmla="*/ 119062 w 400050"/>
                  <a:gd name="connsiteY18" fmla="*/ 424701 h 472326"/>
                  <a:gd name="connsiteX19" fmla="*/ 147637 w 400050"/>
                  <a:gd name="connsiteY19" fmla="*/ 443751 h 472326"/>
                  <a:gd name="connsiteX20" fmla="*/ 185737 w 400050"/>
                  <a:gd name="connsiteY20" fmla="*/ 467563 h 472326"/>
                  <a:gd name="connsiteX21" fmla="*/ 200025 w 400050"/>
                  <a:gd name="connsiteY21" fmla="*/ 472326 h 472326"/>
                  <a:gd name="connsiteX22" fmla="*/ 238125 w 400050"/>
                  <a:gd name="connsiteY22" fmla="*/ 462801 h 472326"/>
                  <a:gd name="connsiteX23" fmla="*/ 280987 w 400050"/>
                  <a:gd name="connsiteY23" fmla="*/ 434226 h 472326"/>
                  <a:gd name="connsiteX24" fmla="*/ 295275 w 400050"/>
                  <a:gd name="connsiteY24" fmla="*/ 424701 h 472326"/>
                  <a:gd name="connsiteX25" fmla="*/ 323850 w 400050"/>
                  <a:gd name="connsiteY25" fmla="*/ 400888 h 472326"/>
                  <a:gd name="connsiteX26" fmla="*/ 333375 w 400050"/>
                  <a:gd name="connsiteY26" fmla="*/ 386601 h 472326"/>
                  <a:gd name="connsiteX27" fmla="*/ 347662 w 400050"/>
                  <a:gd name="connsiteY27" fmla="*/ 377076 h 472326"/>
                  <a:gd name="connsiteX28" fmla="*/ 376237 w 400050"/>
                  <a:gd name="connsiteY28" fmla="*/ 334213 h 472326"/>
                  <a:gd name="connsiteX29" fmla="*/ 385762 w 400050"/>
                  <a:gd name="connsiteY29" fmla="*/ 319926 h 472326"/>
                  <a:gd name="connsiteX30" fmla="*/ 395287 w 400050"/>
                  <a:gd name="connsiteY30" fmla="*/ 291351 h 472326"/>
                  <a:gd name="connsiteX31" fmla="*/ 400050 w 400050"/>
                  <a:gd name="connsiteY31" fmla="*/ 277063 h 472326"/>
                  <a:gd name="connsiteX32" fmla="*/ 395287 w 400050"/>
                  <a:gd name="connsiteY32" fmla="*/ 143713 h 472326"/>
                  <a:gd name="connsiteX33" fmla="*/ 385762 w 400050"/>
                  <a:gd name="connsiteY33" fmla="*/ 115138 h 472326"/>
                  <a:gd name="connsiteX34" fmla="*/ 366712 w 400050"/>
                  <a:gd name="connsiteY34" fmla="*/ 86563 h 472326"/>
                  <a:gd name="connsiteX35" fmla="*/ 347662 w 400050"/>
                  <a:gd name="connsiteY35" fmla="*/ 67513 h 472326"/>
                  <a:gd name="connsiteX36" fmla="*/ 342900 w 400050"/>
                  <a:gd name="connsiteY36" fmla="*/ 53226 h 472326"/>
                  <a:gd name="connsiteX37" fmla="*/ 319087 w 400050"/>
                  <a:gd name="connsiteY37" fmla="*/ 34176 h 472326"/>
                  <a:gd name="connsiteX38" fmla="*/ 314325 w 400050"/>
                  <a:gd name="connsiteY38" fmla="*/ 19888 h 4723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</a:cxnLst>
                <a:rect l="l" t="t" r="r" b="b"/>
                <a:pathLst>
                  <a:path w="400050" h="472326">
                    <a:moveTo>
                      <a:pt x="314325" y="19888"/>
                    </a:moveTo>
                    <a:cubicBezTo>
                      <a:pt x="309563" y="16713"/>
                      <a:pt x="297247" y="19616"/>
                      <a:pt x="290512" y="15126"/>
                    </a:cubicBezTo>
                    <a:cubicBezTo>
                      <a:pt x="286335" y="12341"/>
                      <a:pt x="290761" y="1142"/>
                      <a:pt x="285750" y="838"/>
                    </a:cubicBezTo>
                    <a:cubicBezTo>
                      <a:pt x="235018" y="-2237"/>
                      <a:pt x="184150" y="4013"/>
                      <a:pt x="133350" y="5601"/>
                    </a:cubicBezTo>
                    <a:cubicBezTo>
                      <a:pt x="128587" y="7188"/>
                      <a:pt x="122982" y="7227"/>
                      <a:pt x="119062" y="10363"/>
                    </a:cubicBezTo>
                    <a:cubicBezTo>
                      <a:pt x="114592" y="13939"/>
                      <a:pt x="113201" y="20254"/>
                      <a:pt x="109537" y="24651"/>
                    </a:cubicBezTo>
                    <a:cubicBezTo>
                      <a:pt x="98078" y="38402"/>
                      <a:pt x="95010" y="39098"/>
                      <a:pt x="80962" y="48463"/>
                    </a:cubicBezTo>
                    <a:cubicBezTo>
                      <a:pt x="68995" y="84370"/>
                      <a:pt x="85136" y="40116"/>
                      <a:pt x="66675" y="77038"/>
                    </a:cubicBezTo>
                    <a:cubicBezTo>
                      <a:pt x="64430" y="81528"/>
                      <a:pt x="64350" y="86937"/>
                      <a:pt x="61912" y="91326"/>
                    </a:cubicBezTo>
                    <a:cubicBezTo>
                      <a:pt x="45570" y="120741"/>
                      <a:pt x="49445" y="115512"/>
                      <a:pt x="28575" y="129426"/>
                    </a:cubicBezTo>
                    <a:cubicBezTo>
                      <a:pt x="22225" y="138951"/>
                      <a:pt x="13145" y="147141"/>
                      <a:pt x="9525" y="158001"/>
                    </a:cubicBezTo>
                    <a:lnTo>
                      <a:pt x="0" y="186576"/>
                    </a:lnTo>
                    <a:cubicBezTo>
                      <a:pt x="1587" y="208801"/>
                      <a:pt x="1457" y="231216"/>
                      <a:pt x="4762" y="253251"/>
                    </a:cubicBezTo>
                    <a:cubicBezTo>
                      <a:pt x="8578" y="278693"/>
                      <a:pt x="19354" y="289427"/>
                      <a:pt x="33337" y="310401"/>
                    </a:cubicBezTo>
                    <a:lnTo>
                      <a:pt x="52387" y="338976"/>
                    </a:lnTo>
                    <a:lnTo>
                      <a:pt x="71437" y="367551"/>
                    </a:lnTo>
                    <a:cubicBezTo>
                      <a:pt x="74612" y="372313"/>
                      <a:pt x="76915" y="377791"/>
                      <a:pt x="80962" y="381838"/>
                    </a:cubicBezTo>
                    <a:cubicBezTo>
                      <a:pt x="90487" y="391363"/>
                      <a:pt x="102065" y="399205"/>
                      <a:pt x="109537" y="410413"/>
                    </a:cubicBezTo>
                    <a:cubicBezTo>
                      <a:pt x="112712" y="415176"/>
                      <a:pt x="114754" y="420932"/>
                      <a:pt x="119062" y="424701"/>
                    </a:cubicBezTo>
                    <a:cubicBezTo>
                      <a:pt x="127677" y="432239"/>
                      <a:pt x="147637" y="443751"/>
                      <a:pt x="147637" y="443751"/>
                    </a:cubicBezTo>
                    <a:cubicBezTo>
                      <a:pt x="162732" y="466392"/>
                      <a:pt x="151732" y="456228"/>
                      <a:pt x="185737" y="467563"/>
                    </a:cubicBezTo>
                    <a:lnTo>
                      <a:pt x="200025" y="472326"/>
                    </a:lnTo>
                    <a:cubicBezTo>
                      <a:pt x="206617" y="471007"/>
                      <a:pt x="229891" y="467375"/>
                      <a:pt x="238125" y="462801"/>
                    </a:cubicBezTo>
                    <a:cubicBezTo>
                      <a:pt x="238135" y="462795"/>
                      <a:pt x="273838" y="438992"/>
                      <a:pt x="280987" y="434226"/>
                    </a:cubicBezTo>
                    <a:cubicBezTo>
                      <a:pt x="285750" y="431051"/>
                      <a:pt x="291228" y="428749"/>
                      <a:pt x="295275" y="424701"/>
                    </a:cubicBezTo>
                    <a:cubicBezTo>
                      <a:pt x="313609" y="406365"/>
                      <a:pt x="303958" y="414149"/>
                      <a:pt x="323850" y="400888"/>
                    </a:cubicBezTo>
                    <a:cubicBezTo>
                      <a:pt x="327025" y="396126"/>
                      <a:pt x="329328" y="390648"/>
                      <a:pt x="333375" y="386601"/>
                    </a:cubicBezTo>
                    <a:cubicBezTo>
                      <a:pt x="337422" y="382554"/>
                      <a:pt x="343893" y="381384"/>
                      <a:pt x="347662" y="377076"/>
                    </a:cubicBezTo>
                    <a:cubicBezTo>
                      <a:pt x="347667" y="377071"/>
                      <a:pt x="371473" y="341360"/>
                      <a:pt x="376237" y="334213"/>
                    </a:cubicBezTo>
                    <a:cubicBezTo>
                      <a:pt x="379412" y="329451"/>
                      <a:pt x="383952" y="325356"/>
                      <a:pt x="385762" y="319926"/>
                    </a:cubicBezTo>
                    <a:lnTo>
                      <a:pt x="395287" y="291351"/>
                    </a:lnTo>
                    <a:lnTo>
                      <a:pt x="400050" y="277063"/>
                    </a:lnTo>
                    <a:cubicBezTo>
                      <a:pt x="398462" y="232613"/>
                      <a:pt x="399197" y="188019"/>
                      <a:pt x="395287" y="143713"/>
                    </a:cubicBezTo>
                    <a:cubicBezTo>
                      <a:pt x="394404" y="133712"/>
                      <a:pt x="391331" y="123492"/>
                      <a:pt x="385762" y="115138"/>
                    </a:cubicBezTo>
                    <a:lnTo>
                      <a:pt x="366712" y="86563"/>
                    </a:lnTo>
                    <a:cubicBezTo>
                      <a:pt x="354014" y="48466"/>
                      <a:pt x="373061" y="92912"/>
                      <a:pt x="347662" y="67513"/>
                    </a:cubicBezTo>
                    <a:cubicBezTo>
                      <a:pt x="344112" y="63963"/>
                      <a:pt x="345145" y="57716"/>
                      <a:pt x="342900" y="53226"/>
                    </a:cubicBezTo>
                    <a:cubicBezTo>
                      <a:pt x="334283" y="35992"/>
                      <a:pt x="335567" y="39668"/>
                      <a:pt x="319087" y="34176"/>
                    </a:cubicBezTo>
                    <a:cubicBezTo>
                      <a:pt x="308682" y="18567"/>
                      <a:pt x="319087" y="23063"/>
                      <a:pt x="314325" y="19888"/>
                    </a:cubicBezTo>
                    <a:close/>
                  </a:path>
                </a:pathLst>
              </a:cu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3" name="Freeform 22"/>
            <p:cNvSpPr/>
            <p:nvPr/>
          </p:nvSpPr>
          <p:spPr>
            <a:xfrm>
              <a:off x="7227632" y="3611217"/>
              <a:ext cx="14486" cy="603779"/>
            </a:xfrm>
            <a:custGeom>
              <a:avLst/>
              <a:gdLst>
                <a:gd name="connsiteX0" fmla="*/ 0 w 19879"/>
                <a:gd name="connsiteY0" fmla="*/ 0 h 818984"/>
                <a:gd name="connsiteX1" fmla="*/ 11927 w 19879"/>
                <a:gd name="connsiteY1" fmla="*/ 67586 h 818984"/>
                <a:gd name="connsiteX2" fmla="*/ 7952 w 19879"/>
                <a:gd name="connsiteY2" fmla="*/ 246490 h 818984"/>
                <a:gd name="connsiteX3" fmla="*/ 3976 w 19879"/>
                <a:gd name="connsiteY3" fmla="*/ 258417 h 818984"/>
                <a:gd name="connsiteX4" fmla="*/ 0 w 19879"/>
                <a:gd name="connsiteY4" fmla="*/ 326003 h 818984"/>
                <a:gd name="connsiteX5" fmla="*/ 3976 w 19879"/>
                <a:gd name="connsiteY5" fmla="*/ 425394 h 818984"/>
                <a:gd name="connsiteX6" fmla="*/ 11927 w 19879"/>
                <a:gd name="connsiteY6" fmla="*/ 449248 h 818984"/>
                <a:gd name="connsiteX7" fmla="*/ 15903 w 19879"/>
                <a:gd name="connsiteY7" fmla="*/ 504908 h 818984"/>
                <a:gd name="connsiteX8" fmla="*/ 19879 w 19879"/>
                <a:gd name="connsiteY8" fmla="*/ 520810 h 818984"/>
                <a:gd name="connsiteX9" fmla="*/ 15903 w 19879"/>
                <a:gd name="connsiteY9" fmla="*/ 818984 h 8189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9879" h="818984">
                  <a:moveTo>
                    <a:pt x="0" y="0"/>
                  </a:moveTo>
                  <a:cubicBezTo>
                    <a:pt x="9790" y="48945"/>
                    <a:pt x="6041" y="26377"/>
                    <a:pt x="11927" y="67586"/>
                  </a:cubicBezTo>
                  <a:cubicBezTo>
                    <a:pt x="10602" y="127221"/>
                    <a:pt x="10435" y="186892"/>
                    <a:pt x="7952" y="246490"/>
                  </a:cubicBezTo>
                  <a:cubicBezTo>
                    <a:pt x="7778" y="250677"/>
                    <a:pt x="4393" y="254247"/>
                    <a:pt x="3976" y="258417"/>
                  </a:cubicBezTo>
                  <a:cubicBezTo>
                    <a:pt x="1730" y="280873"/>
                    <a:pt x="1325" y="303474"/>
                    <a:pt x="0" y="326003"/>
                  </a:cubicBezTo>
                  <a:cubicBezTo>
                    <a:pt x="1325" y="359133"/>
                    <a:pt x="782" y="392391"/>
                    <a:pt x="3976" y="425394"/>
                  </a:cubicBezTo>
                  <a:cubicBezTo>
                    <a:pt x="4783" y="433736"/>
                    <a:pt x="11927" y="449248"/>
                    <a:pt x="11927" y="449248"/>
                  </a:cubicBezTo>
                  <a:cubicBezTo>
                    <a:pt x="13252" y="467801"/>
                    <a:pt x="13849" y="486421"/>
                    <a:pt x="15903" y="504908"/>
                  </a:cubicBezTo>
                  <a:cubicBezTo>
                    <a:pt x="16506" y="510338"/>
                    <a:pt x="19879" y="515346"/>
                    <a:pt x="19879" y="520810"/>
                  </a:cubicBezTo>
                  <a:cubicBezTo>
                    <a:pt x="19879" y="620210"/>
                    <a:pt x="15903" y="719584"/>
                    <a:pt x="15903" y="818984"/>
                  </a:cubicBezTo>
                </a:path>
              </a:pathLst>
            </a:custGeom>
            <a:noFill/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6732232" y="3810522"/>
              <a:ext cx="1147243" cy="422059"/>
              <a:chOff x="6790414" y="4011433"/>
              <a:chExt cx="1574358" cy="572494"/>
            </a:xfrm>
          </p:grpSpPr>
          <p:sp>
            <p:nvSpPr>
              <p:cNvPr id="32" name="Freeform 31"/>
              <p:cNvSpPr/>
              <p:nvPr/>
            </p:nvSpPr>
            <p:spPr>
              <a:xfrm>
                <a:off x="6790414" y="4011433"/>
                <a:ext cx="198783" cy="290223"/>
              </a:xfrm>
              <a:custGeom>
                <a:avLst/>
                <a:gdLst>
                  <a:gd name="connsiteX0" fmla="*/ 0 w 198783"/>
                  <a:gd name="connsiteY0" fmla="*/ 0 h 290223"/>
                  <a:gd name="connsiteX1" fmla="*/ 7951 w 198783"/>
                  <a:gd name="connsiteY1" fmla="*/ 19878 h 290223"/>
                  <a:gd name="connsiteX2" fmla="*/ 15903 w 198783"/>
                  <a:gd name="connsiteY2" fmla="*/ 27830 h 290223"/>
                  <a:gd name="connsiteX3" fmla="*/ 19878 w 198783"/>
                  <a:gd name="connsiteY3" fmla="*/ 39757 h 290223"/>
                  <a:gd name="connsiteX4" fmla="*/ 35781 w 198783"/>
                  <a:gd name="connsiteY4" fmla="*/ 59635 h 290223"/>
                  <a:gd name="connsiteX5" fmla="*/ 39756 w 198783"/>
                  <a:gd name="connsiteY5" fmla="*/ 71562 h 290223"/>
                  <a:gd name="connsiteX6" fmla="*/ 59635 w 198783"/>
                  <a:gd name="connsiteY6" fmla="*/ 87464 h 290223"/>
                  <a:gd name="connsiteX7" fmla="*/ 71562 w 198783"/>
                  <a:gd name="connsiteY7" fmla="*/ 107343 h 290223"/>
                  <a:gd name="connsiteX8" fmla="*/ 75537 w 198783"/>
                  <a:gd name="connsiteY8" fmla="*/ 119270 h 290223"/>
                  <a:gd name="connsiteX9" fmla="*/ 83489 w 198783"/>
                  <a:gd name="connsiteY9" fmla="*/ 127221 h 290223"/>
                  <a:gd name="connsiteX10" fmla="*/ 91440 w 198783"/>
                  <a:gd name="connsiteY10" fmla="*/ 139148 h 290223"/>
                  <a:gd name="connsiteX11" fmla="*/ 99391 w 198783"/>
                  <a:gd name="connsiteY11" fmla="*/ 170953 h 290223"/>
                  <a:gd name="connsiteX12" fmla="*/ 103367 w 198783"/>
                  <a:gd name="connsiteY12" fmla="*/ 182880 h 290223"/>
                  <a:gd name="connsiteX13" fmla="*/ 119269 w 198783"/>
                  <a:gd name="connsiteY13" fmla="*/ 206734 h 290223"/>
                  <a:gd name="connsiteX14" fmla="*/ 135172 w 198783"/>
                  <a:gd name="connsiteY14" fmla="*/ 222637 h 290223"/>
                  <a:gd name="connsiteX15" fmla="*/ 151075 w 198783"/>
                  <a:gd name="connsiteY15" fmla="*/ 242515 h 290223"/>
                  <a:gd name="connsiteX16" fmla="*/ 163002 w 198783"/>
                  <a:gd name="connsiteY16" fmla="*/ 246490 h 290223"/>
                  <a:gd name="connsiteX17" fmla="*/ 170953 w 198783"/>
                  <a:gd name="connsiteY17" fmla="*/ 254442 h 290223"/>
                  <a:gd name="connsiteX18" fmla="*/ 174929 w 198783"/>
                  <a:gd name="connsiteY18" fmla="*/ 266369 h 290223"/>
                  <a:gd name="connsiteX19" fmla="*/ 186856 w 198783"/>
                  <a:gd name="connsiteY19" fmla="*/ 274320 h 290223"/>
                  <a:gd name="connsiteX20" fmla="*/ 198783 w 198783"/>
                  <a:gd name="connsiteY20" fmla="*/ 290223 h 2902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198783" h="290223">
                    <a:moveTo>
                      <a:pt x="0" y="0"/>
                    </a:moveTo>
                    <a:cubicBezTo>
                      <a:pt x="2650" y="6626"/>
                      <a:pt x="4410" y="13682"/>
                      <a:pt x="7951" y="19878"/>
                    </a:cubicBezTo>
                    <a:cubicBezTo>
                      <a:pt x="9811" y="23133"/>
                      <a:pt x="13974" y="24616"/>
                      <a:pt x="15903" y="27830"/>
                    </a:cubicBezTo>
                    <a:cubicBezTo>
                      <a:pt x="18059" y="31423"/>
                      <a:pt x="18004" y="36009"/>
                      <a:pt x="19878" y="39757"/>
                    </a:cubicBezTo>
                    <a:cubicBezTo>
                      <a:pt x="24894" y="49789"/>
                      <a:pt x="28384" y="52239"/>
                      <a:pt x="35781" y="59635"/>
                    </a:cubicBezTo>
                    <a:cubicBezTo>
                      <a:pt x="37106" y="63611"/>
                      <a:pt x="37600" y="67969"/>
                      <a:pt x="39756" y="71562"/>
                    </a:cubicBezTo>
                    <a:cubicBezTo>
                      <a:pt x="43532" y="77855"/>
                      <a:pt x="54220" y="83854"/>
                      <a:pt x="59635" y="87464"/>
                    </a:cubicBezTo>
                    <a:cubicBezTo>
                      <a:pt x="70895" y="121249"/>
                      <a:pt x="55191" y="80056"/>
                      <a:pt x="71562" y="107343"/>
                    </a:cubicBezTo>
                    <a:cubicBezTo>
                      <a:pt x="73718" y="110936"/>
                      <a:pt x="73381" y="115677"/>
                      <a:pt x="75537" y="119270"/>
                    </a:cubicBezTo>
                    <a:cubicBezTo>
                      <a:pt x="77466" y="122484"/>
                      <a:pt x="81147" y="124294"/>
                      <a:pt x="83489" y="127221"/>
                    </a:cubicBezTo>
                    <a:cubicBezTo>
                      <a:pt x="86474" y="130952"/>
                      <a:pt x="89303" y="134874"/>
                      <a:pt x="91440" y="139148"/>
                    </a:cubicBezTo>
                    <a:cubicBezTo>
                      <a:pt x="95986" y="148239"/>
                      <a:pt x="97121" y="161874"/>
                      <a:pt x="99391" y="170953"/>
                    </a:cubicBezTo>
                    <a:cubicBezTo>
                      <a:pt x="100407" y="175019"/>
                      <a:pt x="101332" y="179217"/>
                      <a:pt x="103367" y="182880"/>
                    </a:cubicBezTo>
                    <a:cubicBezTo>
                      <a:pt x="108008" y="191234"/>
                      <a:pt x="112512" y="199977"/>
                      <a:pt x="119269" y="206734"/>
                    </a:cubicBezTo>
                    <a:cubicBezTo>
                      <a:pt x="124570" y="212035"/>
                      <a:pt x="131014" y="216399"/>
                      <a:pt x="135172" y="222637"/>
                    </a:cubicBezTo>
                    <a:cubicBezTo>
                      <a:pt x="138785" y="228056"/>
                      <a:pt x="144779" y="238738"/>
                      <a:pt x="151075" y="242515"/>
                    </a:cubicBezTo>
                    <a:cubicBezTo>
                      <a:pt x="154669" y="244671"/>
                      <a:pt x="159026" y="245165"/>
                      <a:pt x="163002" y="246490"/>
                    </a:cubicBezTo>
                    <a:cubicBezTo>
                      <a:pt x="165652" y="249141"/>
                      <a:pt x="169025" y="251228"/>
                      <a:pt x="170953" y="254442"/>
                    </a:cubicBezTo>
                    <a:cubicBezTo>
                      <a:pt x="173109" y="258036"/>
                      <a:pt x="172311" y="263097"/>
                      <a:pt x="174929" y="266369"/>
                    </a:cubicBezTo>
                    <a:cubicBezTo>
                      <a:pt x="177914" y="270100"/>
                      <a:pt x="182880" y="271670"/>
                      <a:pt x="186856" y="274320"/>
                    </a:cubicBezTo>
                    <a:cubicBezTo>
                      <a:pt x="191768" y="289059"/>
                      <a:pt x="187083" y="284373"/>
                      <a:pt x="198783" y="290223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Freeform 32"/>
              <p:cNvSpPr/>
              <p:nvPr/>
            </p:nvSpPr>
            <p:spPr>
              <a:xfrm>
                <a:off x="6969318" y="4293704"/>
                <a:ext cx="1137037" cy="290223"/>
              </a:xfrm>
              <a:custGeom>
                <a:avLst/>
                <a:gdLst>
                  <a:gd name="connsiteX0" fmla="*/ 0 w 1137037"/>
                  <a:gd name="connsiteY0" fmla="*/ 0 h 290223"/>
                  <a:gd name="connsiteX1" fmla="*/ 19879 w 1137037"/>
                  <a:gd name="connsiteY1" fmla="*/ 11927 h 290223"/>
                  <a:gd name="connsiteX2" fmla="*/ 27830 w 1137037"/>
                  <a:gd name="connsiteY2" fmla="*/ 23854 h 290223"/>
                  <a:gd name="connsiteX3" fmla="*/ 35781 w 1137037"/>
                  <a:gd name="connsiteY3" fmla="*/ 31806 h 290223"/>
                  <a:gd name="connsiteX4" fmla="*/ 51684 w 1137037"/>
                  <a:gd name="connsiteY4" fmla="*/ 51684 h 290223"/>
                  <a:gd name="connsiteX5" fmla="*/ 75538 w 1137037"/>
                  <a:gd name="connsiteY5" fmla="*/ 83489 h 290223"/>
                  <a:gd name="connsiteX6" fmla="*/ 83489 w 1137037"/>
                  <a:gd name="connsiteY6" fmla="*/ 95416 h 290223"/>
                  <a:gd name="connsiteX7" fmla="*/ 95416 w 1137037"/>
                  <a:gd name="connsiteY7" fmla="*/ 99392 h 290223"/>
                  <a:gd name="connsiteX8" fmla="*/ 119270 w 1137037"/>
                  <a:gd name="connsiteY8" fmla="*/ 115294 h 290223"/>
                  <a:gd name="connsiteX9" fmla="*/ 151075 w 1137037"/>
                  <a:gd name="connsiteY9" fmla="*/ 139148 h 290223"/>
                  <a:gd name="connsiteX10" fmla="*/ 174929 w 1137037"/>
                  <a:gd name="connsiteY10" fmla="*/ 155051 h 290223"/>
                  <a:gd name="connsiteX11" fmla="*/ 198783 w 1137037"/>
                  <a:gd name="connsiteY11" fmla="*/ 170953 h 290223"/>
                  <a:gd name="connsiteX12" fmla="*/ 206734 w 1137037"/>
                  <a:gd name="connsiteY12" fmla="*/ 178905 h 290223"/>
                  <a:gd name="connsiteX13" fmla="*/ 230588 w 1137037"/>
                  <a:gd name="connsiteY13" fmla="*/ 186856 h 290223"/>
                  <a:gd name="connsiteX14" fmla="*/ 294199 w 1137037"/>
                  <a:gd name="connsiteY14" fmla="*/ 194807 h 290223"/>
                  <a:gd name="connsiteX15" fmla="*/ 318052 w 1137037"/>
                  <a:gd name="connsiteY15" fmla="*/ 202759 h 290223"/>
                  <a:gd name="connsiteX16" fmla="*/ 337931 w 1137037"/>
                  <a:gd name="connsiteY16" fmla="*/ 222637 h 290223"/>
                  <a:gd name="connsiteX17" fmla="*/ 361785 w 1137037"/>
                  <a:gd name="connsiteY17" fmla="*/ 230588 h 290223"/>
                  <a:gd name="connsiteX18" fmla="*/ 397565 w 1137037"/>
                  <a:gd name="connsiteY18" fmla="*/ 250466 h 290223"/>
                  <a:gd name="connsiteX19" fmla="*/ 405517 w 1137037"/>
                  <a:gd name="connsiteY19" fmla="*/ 258418 h 290223"/>
                  <a:gd name="connsiteX20" fmla="*/ 429371 w 1137037"/>
                  <a:gd name="connsiteY20" fmla="*/ 266369 h 290223"/>
                  <a:gd name="connsiteX21" fmla="*/ 441298 w 1137037"/>
                  <a:gd name="connsiteY21" fmla="*/ 270345 h 290223"/>
                  <a:gd name="connsiteX22" fmla="*/ 461176 w 1137037"/>
                  <a:gd name="connsiteY22" fmla="*/ 274320 h 290223"/>
                  <a:gd name="connsiteX23" fmla="*/ 485030 w 1137037"/>
                  <a:gd name="connsiteY23" fmla="*/ 282272 h 290223"/>
                  <a:gd name="connsiteX24" fmla="*/ 496957 w 1137037"/>
                  <a:gd name="connsiteY24" fmla="*/ 286247 h 290223"/>
                  <a:gd name="connsiteX25" fmla="*/ 508884 w 1137037"/>
                  <a:gd name="connsiteY25" fmla="*/ 290223 h 290223"/>
                  <a:gd name="connsiteX26" fmla="*/ 560567 w 1137037"/>
                  <a:gd name="connsiteY26" fmla="*/ 278296 h 290223"/>
                  <a:gd name="connsiteX27" fmla="*/ 572494 w 1137037"/>
                  <a:gd name="connsiteY27" fmla="*/ 270345 h 290223"/>
                  <a:gd name="connsiteX28" fmla="*/ 608275 w 1137037"/>
                  <a:gd name="connsiteY28" fmla="*/ 258418 h 290223"/>
                  <a:gd name="connsiteX29" fmla="*/ 620202 w 1137037"/>
                  <a:gd name="connsiteY29" fmla="*/ 254442 h 290223"/>
                  <a:gd name="connsiteX30" fmla="*/ 644056 w 1137037"/>
                  <a:gd name="connsiteY30" fmla="*/ 242515 h 290223"/>
                  <a:gd name="connsiteX31" fmla="*/ 667910 w 1137037"/>
                  <a:gd name="connsiteY31" fmla="*/ 226613 h 290223"/>
                  <a:gd name="connsiteX32" fmla="*/ 679837 w 1137037"/>
                  <a:gd name="connsiteY32" fmla="*/ 222637 h 290223"/>
                  <a:gd name="connsiteX33" fmla="*/ 691764 w 1137037"/>
                  <a:gd name="connsiteY33" fmla="*/ 214686 h 290223"/>
                  <a:gd name="connsiteX34" fmla="*/ 699715 w 1137037"/>
                  <a:gd name="connsiteY34" fmla="*/ 206734 h 290223"/>
                  <a:gd name="connsiteX35" fmla="*/ 723569 w 1137037"/>
                  <a:gd name="connsiteY35" fmla="*/ 198783 h 290223"/>
                  <a:gd name="connsiteX36" fmla="*/ 747423 w 1137037"/>
                  <a:gd name="connsiteY36" fmla="*/ 190832 h 290223"/>
                  <a:gd name="connsiteX37" fmla="*/ 759350 w 1137037"/>
                  <a:gd name="connsiteY37" fmla="*/ 186856 h 290223"/>
                  <a:gd name="connsiteX38" fmla="*/ 830912 w 1137037"/>
                  <a:gd name="connsiteY38" fmla="*/ 178905 h 290223"/>
                  <a:gd name="connsiteX39" fmla="*/ 878619 w 1137037"/>
                  <a:gd name="connsiteY39" fmla="*/ 170953 h 290223"/>
                  <a:gd name="connsiteX40" fmla="*/ 902473 w 1137037"/>
                  <a:gd name="connsiteY40" fmla="*/ 163002 h 290223"/>
                  <a:gd name="connsiteX41" fmla="*/ 922352 w 1137037"/>
                  <a:gd name="connsiteY41" fmla="*/ 151075 h 290223"/>
                  <a:gd name="connsiteX42" fmla="*/ 934279 w 1137037"/>
                  <a:gd name="connsiteY42" fmla="*/ 143124 h 290223"/>
                  <a:gd name="connsiteX43" fmla="*/ 958132 w 1137037"/>
                  <a:gd name="connsiteY43" fmla="*/ 135173 h 290223"/>
                  <a:gd name="connsiteX44" fmla="*/ 970059 w 1137037"/>
                  <a:gd name="connsiteY44" fmla="*/ 131197 h 290223"/>
                  <a:gd name="connsiteX45" fmla="*/ 997889 w 1137037"/>
                  <a:gd name="connsiteY45" fmla="*/ 119270 h 290223"/>
                  <a:gd name="connsiteX46" fmla="*/ 1021743 w 1137037"/>
                  <a:gd name="connsiteY46" fmla="*/ 111319 h 290223"/>
                  <a:gd name="connsiteX47" fmla="*/ 1033670 w 1137037"/>
                  <a:gd name="connsiteY47" fmla="*/ 107343 h 290223"/>
                  <a:gd name="connsiteX48" fmla="*/ 1053548 w 1137037"/>
                  <a:gd name="connsiteY48" fmla="*/ 103367 h 290223"/>
                  <a:gd name="connsiteX49" fmla="*/ 1077402 w 1137037"/>
                  <a:gd name="connsiteY49" fmla="*/ 95416 h 290223"/>
                  <a:gd name="connsiteX50" fmla="*/ 1129085 w 1137037"/>
                  <a:gd name="connsiteY50" fmla="*/ 83489 h 290223"/>
                  <a:gd name="connsiteX51" fmla="*/ 1137037 w 1137037"/>
                  <a:gd name="connsiteY51" fmla="*/ 83489 h 2902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</a:cxnLst>
                <a:rect l="l" t="t" r="r" b="b"/>
                <a:pathLst>
                  <a:path w="1137037" h="290223">
                    <a:moveTo>
                      <a:pt x="0" y="0"/>
                    </a:moveTo>
                    <a:cubicBezTo>
                      <a:pt x="6626" y="3976"/>
                      <a:pt x="14012" y="6898"/>
                      <a:pt x="19879" y="11927"/>
                    </a:cubicBezTo>
                    <a:cubicBezTo>
                      <a:pt x="23507" y="15037"/>
                      <a:pt x="24845" y="20123"/>
                      <a:pt x="27830" y="23854"/>
                    </a:cubicBezTo>
                    <a:cubicBezTo>
                      <a:pt x="30171" y="26781"/>
                      <a:pt x="33440" y="28879"/>
                      <a:pt x="35781" y="31806"/>
                    </a:cubicBezTo>
                    <a:cubicBezTo>
                      <a:pt x="55831" y="56871"/>
                      <a:pt x="32493" y="32495"/>
                      <a:pt x="51684" y="51684"/>
                    </a:cubicBezTo>
                    <a:cubicBezTo>
                      <a:pt x="62027" y="82717"/>
                      <a:pt x="45082" y="37803"/>
                      <a:pt x="75538" y="83489"/>
                    </a:cubicBezTo>
                    <a:cubicBezTo>
                      <a:pt x="78188" y="87465"/>
                      <a:pt x="79758" y="92431"/>
                      <a:pt x="83489" y="95416"/>
                    </a:cubicBezTo>
                    <a:cubicBezTo>
                      <a:pt x="86761" y="98034"/>
                      <a:pt x="91753" y="97357"/>
                      <a:pt x="95416" y="99392"/>
                    </a:cubicBezTo>
                    <a:cubicBezTo>
                      <a:pt x="103770" y="104033"/>
                      <a:pt x="112513" y="108536"/>
                      <a:pt x="119270" y="115294"/>
                    </a:cubicBezTo>
                    <a:cubicBezTo>
                      <a:pt x="133978" y="130004"/>
                      <a:pt x="124102" y="121167"/>
                      <a:pt x="151075" y="139148"/>
                    </a:cubicBezTo>
                    <a:cubicBezTo>
                      <a:pt x="151080" y="139151"/>
                      <a:pt x="174925" y="155047"/>
                      <a:pt x="174929" y="155051"/>
                    </a:cubicBezTo>
                    <a:cubicBezTo>
                      <a:pt x="189819" y="169941"/>
                      <a:pt x="181522" y="165200"/>
                      <a:pt x="198783" y="170953"/>
                    </a:cubicBezTo>
                    <a:cubicBezTo>
                      <a:pt x="201433" y="173604"/>
                      <a:pt x="203381" y="177229"/>
                      <a:pt x="206734" y="178905"/>
                    </a:cubicBezTo>
                    <a:cubicBezTo>
                      <a:pt x="214231" y="182653"/>
                      <a:pt x="222637" y="184206"/>
                      <a:pt x="230588" y="186856"/>
                    </a:cubicBezTo>
                    <a:cubicBezTo>
                      <a:pt x="258910" y="196297"/>
                      <a:pt x="238324" y="190510"/>
                      <a:pt x="294199" y="194807"/>
                    </a:cubicBezTo>
                    <a:cubicBezTo>
                      <a:pt x="302150" y="197458"/>
                      <a:pt x="312125" y="196833"/>
                      <a:pt x="318052" y="202759"/>
                    </a:cubicBezTo>
                    <a:cubicBezTo>
                      <a:pt x="324678" y="209385"/>
                      <a:pt x="329041" y="219674"/>
                      <a:pt x="337931" y="222637"/>
                    </a:cubicBezTo>
                    <a:lnTo>
                      <a:pt x="361785" y="230588"/>
                    </a:lnTo>
                    <a:cubicBezTo>
                      <a:pt x="389126" y="248815"/>
                      <a:pt x="376573" y="243469"/>
                      <a:pt x="397565" y="250466"/>
                    </a:cubicBezTo>
                    <a:cubicBezTo>
                      <a:pt x="400216" y="253117"/>
                      <a:pt x="402164" y="256742"/>
                      <a:pt x="405517" y="258418"/>
                    </a:cubicBezTo>
                    <a:cubicBezTo>
                      <a:pt x="413014" y="262166"/>
                      <a:pt x="421420" y="263719"/>
                      <a:pt x="429371" y="266369"/>
                    </a:cubicBezTo>
                    <a:cubicBezTo>
                      <a:pt x="433347" y="267694"/>
                      <a:pt x="437189" y="269523"/>
                      <a:pt x="441298" y="270345"/>
                    </a:cubicBezTo>
                    <a:cubicBezTo>
                      <a:pt x="447924" y="271670"/>
                      <a:pt x="454657" y="272542"/>
                      <a:pt x="461176" y="274320"/>
                    </a:cubicBezTo>
                    <a:cubicBezTo>
                      <a:pt x="469262" y="276525"/>
                      <a:pt x="477079" y="279622"/>
                      <a:pt x="485030" y="282272"/>
                    </a:cubicBezTo>
                    <a:lnTo>
                      <a:pt x="496957" y="286247"/>
                    </a:lnTo>
                    <a:lnTo>
                      <a:pt x="508884" y="290223"/>
                    </a:lnTo>
                    <a:cubicBezTo>
                      <a:pt x="521713" y="288390"/>
                      <a:pt x="548661" y="286233"/>
                      <a:pt x="560567" y="278296"/>
                    </a:cubicBezTo>
                    <a:cubicBezTo>
                      <a:pt x="564543" y="275646"/>
                      <a:pt x="568128" y="272286"/>
                      <a:pt x="572494" y="270345"/>
                    </a:cubicBezTo>
                    <a:cubicBezTo>
                      <a:pt x="572519" y="270334"/>
                      <a:pt x="602298" y="260410"/>
                      <a:pt x="608275" y="258418"/>
                    </a:cubicBezTo>
                    <a:cubicBezTo>
                      <a:pt x="612251" y="257093"/>
                      <a:pt x="616715" y="256767"/>
                      <a:pt x="620202" y="254442"/>
                    </a:cubicBezTo>
                    <a:cubicBezTo>
                      <a:pt x="673149" y="219145"/>
                      <a:pt x="594676" y="269948"/>
                      <a:pt x="644056" y="242515"/>
                    </a:cubicBezTo>
                    <a:cubicBezTo>
                      <a:pt x="652410" y="237874"/>
                      <a:pt x="658844" y="229635"/>
                      <a:pt x="667910" y="226613"/>
                    </a:cubicBezTo>
                    <a:cubicBezTo>
                      <a:pt x="671886" y="225288"/>
                      <a:pt x="676089" y="224511"/>
                      <a:pt x="679837" y="222637"/>
                    </a:cubicBezTo>
                    <a:cubicBezTo>
                      <a:pt x="684111" y="220500"/>
                      <a:pt x="688033" y="217671"/>
                      <a:pt x="691764" y="214686"/>
                    </a:cubicBezTo>
                    <a:cubicBezTo>
                      <a:pt x="694691" y="212344"/>
                      <a:pt x="696362" y="208410"/>
                      <a:pt x="699715" y="206734"/>
                    </a:cubicBezTo>
                    <a:cubicBezTo>
                      <a:pt x="707212" y="202986"/>
                      <a:pt x="715618" y="201433"/>
                      <a:pt x="723569" y="198783"/>
                    </a:cubicBezTo>
                    <a:lnTo>
                      <a:pt x="747423" y="190832"/>
                    </a:lnTo>
                    <a:cubicBezTo>
                      <a:pt x="751399" y="189507"/>
                      <a:pt x="755216" y="187545"/>
                      <a:pt x="759350" y="186856"/>
                    </a:cubicBezTo>
                    <a:cubicBezTo>
                      <a:pt x="798945" y="180256"/>
                      <a:pt x="775171" y="183549"/>
                      <a:pt x="830912" y="178905"/>
                    </a:cubicBezTo>
                    <a:cubicBezTo>
                      <a:pt x="863520" y="168035"/>
                      <a:pt x="812051" y="184267"/>
                      <a:pt x="878619" y="170953"/>
                    </a:cubicBezTo>
                    <a:cubicBezTo>
                      <a:pt x="886838" y="169309"/>
                      <a:pt x="902473" y="163002"/>
                      <a:pt x="902473" y="163002"/>
                    </a:cubicBezTo>
                    <a:cubicBezTo>
                      <a:pt x="918005" y="147472"/>
                      <a:pt x="901708" y="161397"/>
                      <a:pt x="922352" y="151075"/>
                    </a:cubicBezTo>
                    <a:cubicBezTo>
                      <a:pt x="926626" y="148938"/>
                      <a:pt x="929913" y="145065"/>
                      <a:pt x="934279" y="143124"/>
                    </a:cubicBezTo>
                    <a:cubicBezTo>
                      <a:pt x="941938" y="139720"/>
                      <a:pt x="950181" y="137823"/>
                      <a:pt x="958132" y="135173"/>
                    </a:cubicBezTo>
                    <a:cubicBezTo>
                      <a:pt x="962108" y="133848"/>
                      <a:pt x="966572" y="133522"/>
                      <a:pt x="970059" y="131197"/>
                    </a:cubicBezTo>
                    <a:cubicBezTo>
                      <a:pt x="988981" y="118583"/>
                      <a:pt x="974551" y="126271"/>
                      <a:pt x="997889" y="119270"/>
                    </a:cubicBezTo>
                    <a:cubicBezTo>
                      <a:pt x="1005917" y="116862"/>
                      <a:pt x="1013792" y="113969"/>
                      <a:pt x="1021743" y="111319"/>
                    </a:cubicBezTo>
                    <a:cubicBezTo>
                      <a:pt x="1025719" y="109994"/>
                      <a:pt x="1029561" y="108165"/>
                      <a:pt x="1033670" y="107343"/>
                    </a:cubicBezTo>
                    <a:cubicBezTo>
                      <a:pt x="1040296" y="106018"/>
                      <a:pt x="1047029" y="105145"/>
                      <a:pt x="1053548" y="103367"/>
                    </a:cubicBezTo>
                    <a:cubicBezTo>
                      <a:pt x="1061634" y="101162"/>
                      <a:pt x="1069271" y="97449"/>
                      <a:pt x="1077402" y="95416"/>
                    </a:cubicBezTo>
                    <a:cubicBezTo>
                      <a:pt x="1089366" y="92425"/>
                      <a:pt x="1114814" y="85528"/>
                      <a:pt x="1129085" y="83489"/>
                    </a:cubicBezTo>
                    <a:cubicBezTo>
                      <a:pt x="1131709" y="83114"/>
                      <a:pt x="1134386" y="83489"/>
                      <a:pt x="1137037" y="83489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Freeform 33"/>
              <p:cNvSpPr/>
              <p:nvPr/>
            </p:nvSpPr>
            <p:spPr>
              <a:xfrm>
                <a:off x="8086477" y="4170459"/>
                <a:ext cx="278295" cy="210710"/>
              </a:xfrm>
              <a:custGeom>
                <a:avLst/>
                <a:gdLst>
                  <a:gd name="connsiteX0" fmla="*/ 0 w 278295"/>
                  <a:gd name="connsiteY0" fmla="*/ 210710 h 210710"/>
                  <a:gd name="connsiteX1" fmla="*/ 19878 w 278295"/>
                  <a:gd name="connsiteY1" fmla="*/ 206734 h 210710"/>
                  <a:gd name="connsiteX2" fmla="*/ 43732 w 278295"/>
                  <a:gd name="connsiteY2" fmla="*/ 198783 h 210710"/>
                  <a:gd name="connsiteX3" fmla="*/ 55659 w 278295"/>
                  <a:gd name="connsiteY3" fmla="*/ 194807 h 210710"/>
                  <a:gd name="connsiteX4" fmla="*/ 71561 w 278295"/>
                  <a:gd name="connsiteY4" fmla="*/ 190831 h 210710"/>
                  <a:gd name="connsiteX5" fmla="*/ 107342 w 278295"/>
                  <a:gd name="connsiteY5" fmla="*/ 178904 h 210710"/>
                  <a:gd name="connsiteX6" fmla="*/ 119269 w 278295"/>
                  <a:gd name="connsiteY6" fmla="*/ 174929 h 210710"/>
                  <a:gd name="connsiteX7" fmla="*/ 131196 w 278295"/>
                  <a:gd name="connsiteY7" fmla="*/ 166978 h 210710"/>
                  <a:gd name="connsiteX8" fmla="*/ 143123 w 278295"/>
                  <a:gd name="connsiteY8" fmla="*/ 163002 h 210710"/>
                  <a:gd name="connsiteX9" fmla="*/ 163001 w 278295"/>
                  <a:gd name="connsiteY9" fmla="*/ 139148 h 210710"/>
                  <a:gd name="connsiteX10" fmla="*/ 178904 w 278295"/>
                  <a:gd name="connsiteY10" fmla="*/ 123245 h 210710"/>
                  <a:gd name="connsiteX11" fmla="*/ 190831 w 278295"/>
                  <a:gd name="connsiteY11" fmla="*/ 119270 h 210710"/>
                  <a:gd name="connsiteX12" fmla="*/ 198782 w 278295"/>
                  <a:gd name="connsiteY12" fmla="*/ 111318 h 210710"/>
                  <a:gd name="connsiteX13" fmla="*/ 210709 w 278295"/>
                  <a:gd name="connsiteY13" fmla="*/ 103367 h 210710"/>
                  <a:gd name="connsiteX14" fmla="*/ 218660 w 278295"/>
                  <a:gd name="connsiteY14" fmla="*/ 91440 h 210710"/>
                  <a:gd name="connsiteX15" fmla="*/ 226612 w 278295"/>
                  <a:gd name="connsiteY15" fmla="*/ 83489 h 210710"/>
                  <a:gd name="connsiteX16" fmla="*/ 250466 w 278295"/>
                  <a:gd name="connsiteY16" fmla="*/ 51684 h 210710"/>
                  <a:gd name="connsiteX17" fmla="*/ 254441 w 278295"/>
                  <a:gd name="connsiteY17" fmla="*/ 39757 h 210710"/>
                  <a:gd name="connsiteX18" fmla="*/ 262393 w 278295"/>
                  <a:gd name="connsiteY18" fmla="*/ 31805 h 210710"/>
                  <a:gd name="connsiteX19" fmla="*/ 270344 w 278295"/>
                  <a:gd name="connsiteY19" fmla="*/ 19878 h 210710"/>
                  <a:gd name="connsiteX20" fmla="*/ 274320 w 278295"/>
                  <a:gd name="connsiteY20" fmla="*/ 7951 h 210710"/>
                  <a:gd name="connsiteX21" fmla="*/ 278295 w 278295"/>
                  <a:gd name="connsiteY21" fmla="*/ 0 h 2107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278295" h="210710">
                    <a:moveTo>
                      <a:pt x="0" y="210710"/>
                    </a:moveTo>
                    <a:cubicBezTo>
                      <a:pt x="6626" y="209385"/>
                      <a:pt x="13359" y="208512"/>
                      <a:pt x="19878" y="206734"/>
                    </a:cubicBezTo>
                    <a:cubicBezTo>
                      <a:pt x="27964" y="204529"/>
                      <a:pt x="35781" y="201433"/>
                      <a:pt x="43732" y="198783"/>
                    </a:cubicBezTo>
                    <a:cubicBezTo>
                      <a:pt x="47708" y="197458"/>
                      <a:pt x="51593" y="195824"/>
                      <a:pt x="55659" y="194807"/>
                    </a:cubicBezTo>
                    <a:cubicBezTo>
                      <a:pt x="60960" y="193482"/>
                      <a:pt x="66328" y="192401"/>
                      <a:pt x="71561" y="190831"/>
                    </a:cubicBezTo>
                    <a:cubicBezTo>
                      <a:pt x="71611" y="190816"/>
                      <a:pt x="101354" y="180900"/>
                      <a:pt x="107342" y="178904"/>
                    </a:cubicBezTo>
                    <a:lnTo>
                      <a:pt x="119269" y="174929"/>
                    </a:lnTo>
                    <a:cubicBezTo>
                      <a:pt x="123245" y="172279"/>
                      <a:pt x="126922" y="169115"/>
                      <a:pt x="131196" y="166978"/>
                    </a:cubicBezTo>
                    <a:cubicBezTo>
                      <a:pt x="134944" y="165104"/>
                      <a:pt x="139636" y="165327"/>
                      <a:pt x="143123" y="163002"/>
                    </a:cubicBezTo>
                    <a:cubicBezTo>
                      <a:pt x="156910" y="153810"/>
                      <a:pt x="153221" y="150558"/>
                      <a:pt x="163001" y="139148"/>
                    </a:cubicBezTo>
                    <a:cubicBezTo>
                      <a:pt x="167880" y="133456"/>
                      <a:pt x="171792" y="125615"/>
                      <a:pt x="178904" y="123245"/>
                    </a:cubicBezTo>
                    <a:lnTo>
                      <a:pt x="190831" y="119270"/>
                    </a:lnTo>
                    <a:cubicBezTo>
                      <a:pt x="193481" y="116619"/>
                      <a:pt x="195855" y="113660"/>
                      <a:pt x="198782" y="111318"/>
                    </a:cubicBezTo>
                    <a:cubicBezTo>
                      <a:pt x="202513" y="108333"/>
                      <a:pt x="207330" y="106746"/>
                      <a:pt x="210709" y="103367"/>
                    </a:cubicBezTo>
                    <a:cubicBezTo>
                      <a:pt x="214088" y="99988"/>
                      <a:pt x="215675" y="95171"/>
                      <a:pt x="218660" y="91440"/>
                    </a:cubicBezTo>
                    <a:cubicBezTo>
                      <a:pt x="221002" y="88513"/>
                      <a:pt x="224363" y="86488"/>
                      <a:pt x="226612" y="83489"/>
                    </a:cubicBezTo>
                    <a:cubicBezTo>
                      <a:pt x="253585" y="47526"/>
                      <a:pt x="232229" y="69918"/>
                      <a:pt x="250466" y="51684"/>
                    </a:cubicBezTo>
                    <a:cubicBezTo>
                      <a:pt x="251791" y="47708"/>
                      <a:pt x="252285" y="43350"/>
                      <a:pt x="254441" y="39757"/>
                    </a:cubicBezTo>
                    <a:cubicBezTo>
                      <a:pt x="256370" y="36543"/>
                      <a:pt x="260051" y="34732"/>
                      <a:pt x="262393" y="31805"/>
                    </a:cubicBezTo>
                    <a:cubicBezTo>
                      <a:pt x="265378" y="28074"/>
                      <a:pt x="268207" y="24152"/>
                      <a:pt x="270344" y="19878"/>
                    </a:cubicBezTo>
                    <a:cubicBezTo>
                      <a:pt x="272218" y="16130"/>
                      <a:pt x="272764" y="11842"/>
                      <a:pt x="274320" y="7951"/>
                    </a:cubicBezTo>
                    <a:cubicBezTo>
                      <a:pt x="275420" y="5200"/>
                      <a:pt x="276970" y="2650"/>
                      <a:pt x="278295" y="0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6459906" y="4291201"/>
              <a:ext cx="1515172" cy="91112"/>
              <a:chOff x="6416703" y="4663440"/>
              <a:chExt cx="2079266" cy="123587"/>
            </a:xfrm>
          </p:grpSpPr>
          <p:sp>
            <p:nvSpPr>
              <p:cNvPr id="28" name="Freeform 27"/>
              <p:cNvSpPr/>
              <p:nvPr/>
            </p:nvSpPr>
            <p:spPr>
              <a:xfrm>
                <a:off x="6416703" y="4663440"/>
                <a:ext cx="596347" cy="119270"/>
              </a:xfrm>
              <a:custGeom>
                <a:avLst/>
                <a:gdLst>
                  <a:gd name="connsiteX0" fmla="*/ 0 w 596347"/>
                  <a:gd name="connsiteY0" fmla="*/ 15903 h 119270"/>
                  <a:gd name="connsiteX1" fmla="*/ 31805 w 596347"/>
                  <a:gd name="connsiteY1" fmla="*/ 3976 h 119270"/>
                  <a:gd name="connsiteX2" fmla="*/ 55659 w 596347"/>
                  <a:gd name="connsiteY2" fmla="*/ 0 h 119270"/>
                  <a:gd name="connsiteX3" fmla="*/ 99391 w 596347"/>
                  <a:gd name="connsiteY3" fmla="*/ 3976 h 119270"/>
                  <a:gd name="connsiteX4" fmla="*/ 123245 w 596347"/>
                  <a:gd name="connsiteY4" fmla="*/ 11927 h 119270"/>
                  <a:gd name="connsiteX5" fmla="*/ 135172 w 596347"/>
                  <a:gd name="connsiteY5" fmla="*/ 15903 h 119270"/>
                  <a:gd name="connsiteX6" fmla="*/ 147099 w 596347"/>
                  <a:gd name="connsiteY6" fmla="*/ 23854 h 119270"/>
                  <a:gd name="connsiteX7" fmla="*/ 198782 w 596347"/>
                  <a:gd name="connsiteY7" fmla="*/ 31805 h 119270"/>
                  <a:gd name="connsiteX8" fmla="*/ 222636 w 596347"/>
                  <a:gd name="connsiteY8" fmla="*/ 39757 h 119270"/>
                  <a:gd name="connsiteX9" fmla="*/ 234563 w 596347"/>
                  <a:gd name="connsiteY9" fmla="*/ 43732 h 119270"/>
                  <a:gd name="connsiteX10" fmla="*/ 242514 w 596347"/>
                  <a:gd name="connsiteY10" fmla="*/ 55659 h 119270"/>
                  <a:gd name="connsiteX11" fmla="*/ 266368 w 596347"/>
                  <a:gd name="connsiteY11" fmla="*/ 63610 h 119270"/>
                  <a:gd name="connsiteX12" fmla="*/ 278295 w 596347"/>
                  <a:gd name="connsiteY12" fmla="*/ 71562 h 119270"/>
                  <a:gd name="connsiteX13" fmla="*/ 310100 w 596347"/>
                  <a:gd name="connsiteY13" fmla="*/ 95416 h 119270"/>
                  <a:gd name="connsiteX14" fmla="*/ 333954 w 596347"/>
                  <a:gd name="connsiteY14" fmla="*/ 103367 h 119270"/>
                  <a:gd name="connsiteX15" fmla="*/ 341906 w 596347"/>
                  <a:gd name="connsiteY15" fmla="*/ 111318 h 119270"/>
                  <a:gd name="connsiteX16" fmla="*/ 365760 w 596347"/>
                  <a:gd name="connsiteY16" fmla="*/ 119270 h 119270"/>
                  <a:gd name="connsiteX17" fmla="*/ 381662 w 596347"/>
                  <a:gd name="connsiteY17" fmla="*/ 115294 h 119270"/>
                  <a:gd name="connsiteX18" fmla="*/ 405516 w 596347"/>
                  <a:gd name="connsiteY18" fmla="*/ 107343 h 119270"/>
                  <a:gd name="connsiteX19" fmla="*/ 413467 w 596347"/>
                  <a:gd name="connsiteY19" fmla="*/ 99391 h 119270"/>
                  <a:gd name="connsiteX20" fmla="*/ 417443 w 596347"/>
                  <a:gd name="connsiteY20" fmla="*/ 87464 h 119270"/>
                  <a:gd name="connsiteX21" fmla="*/ 429370 w 596347"/>
                  <a:gd name="connsiteY21" fmla="*/ 83489 h 119270"/>
                  <a:gd name="connsiteX22" fmla="*/ 461175 w 596347"/>
                  <a:gd name="connsiteY22" fmla="*/ 67586 h 119270"/>
                  <a:gd name="connsiteX23" fmla="*/ 473102 w 596347"/>
                  <a:gd name="connsiteY23" fmla="*/ 63610 h 119270"/>
                  <a:gd name="connsiteX24" fmla="*/ 481054 w 596347"/>
                  <a:gd name="connsiteY24" fmla="*/ 55659 h 119270"/>
                  <a:gd name="connsiteX25" fmla="*/ 544664 w 596347"/>
                  <a:gd name="connsiteY25" fmla="*/ 55659 h 119270"/>
                  <a:gd name="connsiteX26" fmla="*/ 556591 w 596347"/>
                  <a:gd name="connsiteY26" fmla="*/ 59635 h 119270"/>
                  <a:gd name="connsiteX27" fmla="*/ 568518 w 596347"/>
                  <a:gd name="connsiteY27" fmla="*/ 67586 h 119270"/>
                  <a:gd name="connsiteX28" fmla="*/ 584420 w 596347"/>
                  <a:gd name="connsiteY28" fmla="*/ 71562 h 119270"/>
                  <a:gd name="connsiteX29" fmla="*/ 596347 w 596347"/>
                  <a:gd name="connsiteY29" fmla="*/ 79513 h 119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</a:cxnLst>
                <a:rect l="l" t="t" r="r" b="b"/>
                <a:pathLst>
                  <a:path w="596347" h="119270">
                    <a:moveTo>
                      <a:pt x="0" y="15903"/>
                    </a:moveTo>
                    <a:cubicBezTo>
                      <a:pt x="3882" y="14350"/>
                      <a:pt x="24785" y="5536"/>
                      <a:pt x="31805" y="3976"/>
                    </a:cubicBezTo>
                    <a:cubicBezTo>
                      <a:pt x="39674" y="2227"/>
                      <a:pt x="47708" y="1325"/>
                      <a:pt x="55659" y="0"/>
                    </a:cubicBezTo>
                    <a:cubicBezTo>
                      <a:pt x="70236" y="1325"/>
                      <a:pt x="84976" y="1432"/>
                      <a:pt x="99391" y="3976"/>
                    </a:cubicBezTo>
                    <a:cubicBezTo>
                      <a:pt x="107645" y="5433"/>
                      <a:pt x="115294" y="9277"/>
                      <a:pt x="123245" y="11927"/>
                    </a:cubicBezTo>
                    <a:cubicBezTo>
                      <a:pt x="127221" y="13252"/>
                      <a:pt x="131685" y="13578"/>
                      <a:pt x="135172" y="15903"/>
                    </a:cubicBezTo>
                    <a:cubicBezTo>
                      <a:pt x="139148" y="18553"/>
                      <a:pt x="142825" y="21717"/>
                      <a:pt x="147099" y="23854"/>
                    </a:cubicBezTo>
                    <a:cubicBezTo>
                      <a:pt x="161429" y="31019"/>
                      <a:pt x="187373" y="30664"/>
                      <a:pt x="198782" y="31805"/>
                    </a:cubicBezTo>
                    <a:lnTo>
                      <a:pt x="222636" y="39757"/>
                    </a:lnTo>
                    <a:lnTo>
                      <a:pt x="234563" y="43732"/>
                    </a:lnTo>
                    <a:cubicBezTo>
                      <a:pt x="237213" y="47708"/>
                      <a:pt x="238462" y="53127"/>
                      <a:pt x="242514" y="55659"/>
                    </a:cubicBezTo>
                    <a:cubicBezTo>
                      <a:pt x="249621" y="60101"/>
                      <a:pt x="266368" y="63610"/>
                      <a:pt x="266368" y="63610"/>
                    </a:cubicBezTo>
                    <a:cubicBezTo>
                      <a:pt x="270344" y="66261"/>
                      <a:pt x="274564" y="68577"/>
                      <a:pt x="278295" y="71562"/>
                    </a:cubicBezTo>
                    <a:cubicBezTo>
                      <a:pt x="291747" y="82323"/>
                      <a:pt x="286335" y="87495"/>
                      <a:pt x="310100" y="95416"/>
                    </a:cubicBezTo>
                    <a:lnTo>
                      <a:pt x="333954" y="103367"/>
                    </a:lnTo>
                    <a:cubicBezTo>
                      <a:pt x="336605" y="106017"/>
                      <a:pt x="338553" y="109642"/>
                      <a:pt x="341906" y="111318"/>
                    </a:cubicBezTo>
                    <a:cubicBezTo>
                      <a:pt x="349403" y="115066"/>
                      <a:pt x="365760" y="119270"/>
                      <a:pt x="365760" y="119270"/>
                    </a:cubicBezTo>
                    <a:cubicBezTo>
                      <a:pt x="371061" y="117945"/>
                      <a:pt x="376429" y="116864"/>
                      <a:pt x="381662" y="115294"/>
                    </a:cubicBezTo>
                    <a:cubicBezTo>
                      <a:pt x="389690" y="112886"/>
                      <a:pt x="405516" y="107343"/>
                      <a:pt x="405516" y="107343"/>
                    </a:cubicBezTo>
                    <a:cubicBezTo>
                      <a:pt x="408166" y="104692"/>
                      <a:pt x="411539" y="102605"/>
                      <a:pt x="413467" y="99391"/>
                    </a:cubicBezTo>
                    <a:cubicBezTo>
                      <a:pt x="415623" y="95797"/>
                      <a:pt x="414480" y="90427"/>
                      <a:pt x="417443" y="87464"/>
                    </a:cubicBezTo>
                    <a:cubicBezTo>
                      <a:pt x="420406" y="84501"/>
                      <a:pt x="425394" y="84814"/>
                      <a:pt x="429370" y="83489"/>
                    </a:cubicBezTo>
                    <a:cubicBezTo>
                      <a:pt x="443247" y="69610"/>
                      <a:pt x="433764" y="76723"/>
                      <a:pt x="461175" y="67586"/>
                    </a:cubicBezTo>
                    <a:lnTo>
                      <a:pt x="473102" y="63610"/>
                    </a:lnTo>
                    <a:cubicBezTo>
                      <a:pt x="475753" y="60960"/>
                      <a:pt x="477840" y="57588"/>
                      <a:pt x="481054" y="55659"/>
                    </a:cubicBezTo>
                    <a:cubicBezTo>
                      <a:pt x="498219" y="45360"/>
                      <a:pt x="534792" y="54900"/>
                      <a:pt x="544664" y="55659"/>
                    </a:cubicBezTo>
                    <a:cubicBezTo>
                      <a:pt x="548640" y="56984"/>
                      <a:pt x="552843" y="57761"/>
                      <a:pt x="556591" y="59635"/>
                    </a:cubicBezTo>
                    <a:cubicBezTo>
                      <a:pt x="560865" y="61772"/>
                      <a:pt x="564126" y="65704"/>
                      <a:pt x="568518" y="67586"/>
                    </a:cubicBezTo>
                    <a:cubicBezTo>
                      <a:pt x="573540" y="69738"/>
                      <a:pt x="579119" y="70237"/>
                      <a:pt x="584420" y="71562"/>
                    </a:cubicBezTo>
                    <a:cubicBezTo>
                      <a:pt x="593309" y="80450"/>
                      <a:pt x="588624" y="79513"/>
                      <a:pt x="596347" y="79513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Freeform 28"/>
              <p:cNvSpPr/>
              <p:nvPr/>
            </p:nvSpPr>
            <p:spPr>
              <a:xfrm>
                <a:off x="6997148" y="4738977"/>
                <a:ext cx="127221" cy="31816"/>
              </a:xfrm>
              <a:custGeom>
                <a:avLst/>
                <a:gdLst>
                  <a:gd name="connsiteX0" fmla="*/ 0 w 127221"/>
                  <a:gd name="connsiteY0" fmla="*/ 0 h 31816"/>
                  <a:gd name="connsiteX1" fmla="*/ 31805 w 127221"/>
                  <a:gd name="connsiteY1" fmla="*/ 7952 h 31816"/>
                  <a:gd name="connsiteX2" fmla="*/ 43732 w 127221"/>
                  <a:gd name="connsiteY2" fmla="*/ 15903 h 31816"/>
                  <a:gd name="connsiteX3" fmla="*/ 63610 w 127221"/>
                  <a:gd name="connsiteY3" fmla="*/ 19879 h 31816"/>
                  <a:gd name="connsiteX4" fmla="*/ 111318 w 127221"/>
                  <a:gd name="connsiteY4" fmla="*/ 27830 h 31816"/>
                  <a:gd name="connsiteX5" fmla="*/ 127221 w 127221"/>
                  <a:gd name="connsiteY5" fmla="*/ 31806 h 318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27221" h="31816">
                    <a:moveTo>
                      <a:pt x="0" y="0"/>
                    </a:moveTo>
                    <a:cubicBezTo>
                      <a:pt x="7563" y="1513"/>
                      <a:pt x="23654" y="3877"/>
                      <a:pt x="31805" y="7952"/>
                    </a:cubicBezTo>
                    <a:cubicBezTo>
                      <a:pt x="36079" y="10089"/>
                      <a:pt x="39258" y="14225"/>
                      <a:pt x="43732" y="15903"/>
                    </a:cubicBezTo>
                    <a:cubicBezTo>
                      <a:pt x="50059" y="18276"/>
                      <a:pt x="57014" y="18413"/>
                      <a:pt x="63610" y="19879"/>
                    </a:cubicBezTo>
                    <a:cubicBezTo>
                      <a:pt x="97375" y="27382"/>
                      <a:pt x="59433" y="21344"/>
                      <a:pt x="111318" y="27830"/>
                    </a:cubicBezTo>
                    <a:cubicBezTo>
                      <a:pt x="124502" y="32225"/>
                      <a:pt x="119054" y="31806"/>
                      <a:pt x="127221" y="31806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Freeform 29"/>
              <p:cNvSpPr/>
              <p:nvPr/>
            </p:nvSpPr>
            <p:spPr>
              <a:xfrm>
                <a:off x="8054671" y="4691270"/>
                <a:ext cx="441298" cy="75537"/>
              </a:xfrm>
              <a:custGeom>
                <a:avLst/>
                <a:gdLst>
                  <a:gd name="connsiteX0" fmla="*/ 0 w 441298"/>
                  <a:gd name="connsiteY0" fmla="*/ 75537 h 75537"/>
                  <a:gd name="connsiteX1" fmla="*/ 27830 w 441298"/>
                  <a:gd name="connsiteY1" fmla="*/ 59634 h 75537"/>
                  <a:gd name="connsiteX2" fmla="*/ 51684 w 441298"/>
                  <a:gd name="connsiteY2" fmla="*/ 43732 h 75537"/>
                  <a:gd name="connsiteX3" fmla="*/ 67586 w 441298"/>
                  <a:gd name="connsiteY3" fmla="*/ 23853 h 75537"/>
                  <a:gd name="connsiteX4" fmla="*/ 79513 w 441298"/>
                  <a:gd name="connsiteY4" fmla="*/ 19878 h 75537"/>
                  <a:gd name="connsiteX5" fmla="*/ 166978 w 441298"/>
                  <a:gd name="connsiteY5" fmla="*/ 15902 h 75537"/>
                  <a:gd name="connsiteX6" fmla="*/ 190832 w 441298"/>
                  <a:gd name="connsiteY6" fmla="*/ 7951 h 75537"/>
                  <a:gd name="connsiteX7" fmla="*/ 202759 w 441298"/>
                  <a:gd name="connsiteY7" fmla="*/ 3975 h 75537"/>
                  <a:gd name="connsiteX8" fmla="*/ 218661 w 441298"/>
                  <a:gd name="connsiteY8" fmla="*/ 0 h 75537"/>
                  <a:gd name="connsiteX9" fmla="*/ 286247 w 441298"/>
                  <a:gd name="connsiteY9" fmla="*/ 3975 h 75537"/>
                  <a:gd name="connsiteX10" fmla="*/ 298174 w 441298"/>
                  <a:gd name="connsiteY10" fmla="*/ 11927 h 75537"/>
                  <a:gd name="connsiteX11" fmla="*/ 322028 w 441298"/>
                  <a:gd name="connsiteY11" fmla="*/ 19878 h 75537"/>
                  <a:gd name="connsiteX12" fmla="*/ 357809 w 441298"/>
                  <a:gd name="connsiteY12" fmla="*/ 31805 h 75537"/>
                  <a:gd name="connsiteX13" fmla="*/ 369736 w 441298"/>
                  <a:gd name="connsiteY13" fmla="*/ 35780 h 75537"/>
                  <a:gd name="connsiteX14" fmla="*/ 441298 w 441298"/>
                  <a:gd name="connsiteY14" fmla="*/ 31805 h 755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441298" h="75537">
                    <a:moveTo>
                      <a:pt x="0" y="75537"/>
                    </a:moveTo>
                    <a:cubicBezTo>
                      <a:pt x="41041" y="59122"/>
                      <a:pt x="5546" y="76347"/>
                      <a:pt x="27830" y="59634"/>
                    </a:cubicBezTo>
                    <a:cubicBezTo>
                      <a:pt x="35475" y="53900"/>
                      <a:pt x="51684" y="43732"/>
                      <a:pt x="51684" y="43732"/>
                    </a:cubicBezTo>
                    <a:cubicBezTo>
                      <a:pt x="55294" y="38317"/>
                      <a:pt x="61293" y="27629"/>
                      <a:pt x="67586" y="23853"/>
                    </a:cubicBezTo>
                    <a:cubicBezTo>
                      <a:pt x="71179" y="21697"/>
                      <a:pt x="75336" y="20212"/>
                      <a:pt x="79513" y="19878"/>
                    </a:cubicBezTo>
                    <a:cubicBezTo>
                      <a:pt x="108605" y="17551"/>
                      <a:pt x="137823" y="17227"/>
                      <a:pt x="166978" y="15902"/>
                    </a:cubicBezTo>
                    <a:lnTo>
                      <a:pt x="190832" y="7951"/>
                    </a:lnTo>
                    <a:cubicBezTo>
                      <a:pt x="194808" y="6626"/>
                      <a:pt x="198693" y="4991"/>
                      <a:pt x="202759" y="3975"/>
                    </a:cubicBezTo>
                    <a:lnTo>
                      <a:pt x="218661" y="0"/>
                    </a:lnTo>
                    <a:cubicBezTo>
                      <a:pt x="241190" y="1325"/>
                      <a:pt x="263929" y="627"/>
                      <a:pt x="286247" y="3975"/>
                    </a:cubicBezTo>
                    <a:cubicBezTo>
                      <a:pt x="290972" y="4684"/>
                      <a:pt x="293808" y="9986"/>
                      <a:pt x="298174" y="11927"/>
                    </a:cubicBezTo>
                    <a:cubicBezTo>
                      <a:pt x="305833" y="15331"/>
                      <a:pt x="314077" y="17228"/>
                      <a:pt x="322028" y="19878"/>
                    </a:cubicBezTo>
                    <a:lnTo>
                      <a:pt x="357809" y="31805"/>
                    </a:lnTo>
                    <a:lnTo>
                      <a:pt x="369736" y="35780"/>
                    </a:lnTo>
                    <a:cubicBezTo>
                      <a:pt x="438645" y="31727"/>
                      <a:pt x="414754" y="31805"/>
                      <a:pt x="441298" y="31805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Freeform 30"/>
              <p:cNvSpPr/>
              <p:nvPr/>
            </p:nvSpPr>
            <p:spPr>
              <a:xfrm>
                <a:off x="7887694" y="4770783"/>
                <a:ext cx="174929" cy="16244"/>
              </a:xfrm>
              <a:custGeom>
                <a:avLst/>
                <a:gdLst>
                  <a:gd name="connsiteX0" fmla="*/ 174929 w 174929"/>
                  <a:gd name="connsiteY0" fmla="*/ 0 h 16244"/>
                  <a:gd name="connsiteX1" fmla="*/ 131196 w 174929"/>
                  <a:gd name="connsiteY1" fmla="*/ 3975 h 16244"/>
                  <a:gd name="connsiteX2" fmla="*/ 79513 w 174929"/>
                  <a:gd name="connsiteY2" fmla="*/ 7951 h 16244"/>
                  <a:gd name="connsiteX3" fmla="*/ 47708 w 174929"/>
                  <a:gd name="connsiteY3" fmla="*/ 11927 h 16244"/>
                  <a:gd name="connsiteX4" fmla="*/ 27829 w 174929"/>
                  <a:gd name="connsiteY4" fmla="*/ 15902 h 16244"/>
                  <a:gd name="connsiteX5" fmla="*/ 0 w 174929"/>
                  <a:gd name="connsiteY5" fmla="*/ 15902 h 162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74929" h="16244">
                    <a:moveTo>
                      <a:pt x="174929" y="0"/>
                    </a:moveTo>
                    <a:lnTo>
                      <a:pt x="131196" y="3975"/>
                    </a:lnTo>
                    <a:lnTo>
                      <a:pt x="79513" y="7951"/>
                    </a:lnTo>
                    <a:cubicBezTo>
                      <a:pt x="68877" y="8964"/>
                      <a:pt x="58268" y="10302"/>
                      <a:pt x="47708" y="11927"/>
                    </a:cubicBezTo>
                    <a:cubicBezTo>
                      <a:pt x="41029" y="12954"/>
                      <a:pt x="34563" y="15341"/>
                      <a:pt x="27829" y="15902"/>
                    </a:cubicBezTo>
                    <a:cubicBezTo>
                      <a:pt x="18585" y="16672"/>
                      <a:pt x="9276" y="15902"/>
                      <a:pt x="0" y="15902"/>
                    </a:cubicBezTo>
                  </a:path>
                </a:pathLst>
              </a:custGeom>
              <a:noFill/>
              <a:ln>
                <a:solidFill>
                  <a:schemeClr val="accent6">
                    <a:lumMod val="60000"/>
                    <a:lumOff val="4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6" name="Freeform 25"/>
            <p:cNvSpPr/>
            <p:nvPr/>
          </p:nvSpPr>
          <p:spPr>
            <a:xfrm>
              <a:off x="6874495" y="4533694"/>
              <a:ext cx="803360" cy="680512"/>
            </a:xfrm>
            <a:custGeom>
              <a:avLst/>
              <a:gdLst>
                <a:gd name="connsiteX0" fmla="*/ 333892 w 1102448"/>
                <a:gd name="connsiteY0" fmla="*/ 0 h 923067"/>
                <a:gd name="connsiteX1" fmla="*/ 342559 w 1102448"/>
                <a:gd name="connsiteY1" fmla="*/ 21668 h 923067"/>
                <a:gd name="connsiteX2" fmla="*/ 351226 w 1102448"/>
                <a:gd name="connsiteY2" fmla="*/ 30336 h 923067"/>
                <a:gd name="connsiteX3" fmla="*/ 359894 w 1102448"/>
                <a:gd name="connsiteY3" fmla="*/ 43336 h 923067"/>
                <a:gd name="connsiteX4" fmla="*/ 381562 w 1102448"/>
                <a:gd name="connsiteY4" fmla="*/ 108341 h 923067"/>
                <a:gd name="connsiteX5" fmla="*/ 390229 w 1102448"/>
                <a:gd name="connsiteY5" fmla="*/ 134343 h 923067"/>
                <a:gd name="connsiteX6" fmla="*/ 394563 w 1102448"/>
                <a:gd name="connsiteY6" fmla="*/ 147344 h 923067"/>
                <a:gd name="connsiteX7" fmla="*/ 381562 w 1102448"/>
                <a:gd name="connsiteY7" fmla="*/ 286021 h 923067"/>
                <a:gd name="connsiteX8" fmla="*/ 372894 w 1102448"/>
                <a:gd name="connsiteY8" fmla="*/ 294688 h 923067"/>
                <a:gd name="connsiteX9" fmla="*/ 346893 w 1102448"/>
                <a:gd name="connsiteY9" fmla="*/ 290354 h 923067"/>
                <a:gd name="connsiteX10" fmla="*/ 342559 w 1102448"/>
                <a:gd name="connsiteY10" fmla="*/ 273020 h 923067"/>
                <a:gd name="connsiteX11" fmla="*/ 333892 w 1102448"/>
                <a:gd name="connsiteY11" fmla="*/ 260019 h 923067"/>
                <a:gd name="connsiteX12" fmla="*/ 346893 w 1102448"/>
                <a:gd name="connsiteY12" fmla="*/ 255685 h 923067"/>
                <a:gd name="connsiteX13" fmla="*/ 333892 w 1102448"/>
                <a:gd name="connsiteY13" fmla="*/ 251352 h 923067"/>
                <a:gd name="connsiteX14" fmla="*/ 303556 w 1102448"/>
                <a:gd name="connsiteY14" fmla="*/ 247018 h 923067"/>
                <a:gd name="connsiteX15" fmla="*/ 260220 w 1102448"/>
                <a:gd name="connsiteY15" fmla="*/ 251352 h 923067"/>
                <a:gd name="connsiteX16" fmla="*/ 251552 w 1102448"/>
                <a:gd name="connsiteY16" fmla="*/ 260019 h 923067"/>
                <a:gd name="connsiteX17" fmla="*/ 247219 w 1102448"/>
                <a:gd name="connsiteY17" fmla="*/ 277354 h 923067"/>
                <a:gd name="connsiteX18" fmla="*/ 234218 w 1102448"/>
                <a:gd name="connsiteY18" fmla="*/ 303355 h 923067"/>
                <a:gd name="connsiteX19" fmla="*/ 212549 w 1102448"/>
                <a:gd name="connsiteY19" fmla="*/ 320690 h 923067"/>
                <a:gd name="connsiteX20" fmla="*/ 186548 w 1102448"/>
                <a:gd name="connsiteY20" fmla="*/ 329357 h 923067"/>
                <a:gd name="connsiteX21" fmla="*/ 177880 w 1102448"/>
                <a:gd name="connsiteY21" fmla="*/ 338025 h 923067"/>
                <a:gd name="connsiteX22" fmla="*/ 169213 w 1102448"/>
                <a:gd name="connsiteY22" fmla="*/ 351026 h 923067"/>
                <a:gd name="connsiteX23" fmla="*/ 143211 w 1102448"/>
                <a:gd name="connsiteY23" fmla="*/ 359693 h 923067"/>
                <a:gd name="connsiteX24" fmla="*/ 117209 w 1102448"/>
                <a:gd name="connsiteY24" fmla="*/ 377027 h 923067"/>
                <a:gd name="connsiteX25" fmla="*/ 108542 w 1102448"/>
                <a:gd name="connsiteY25" fmla="*/ 385695 h 923067"/>
                <a:gd name="connsiteX26" fmla="*/ 95541 w 1102448"/>
                <a:gd name="connsiteY26" fmla="*/ 390028 h 923067"/>
                <a:gd name="connsiteX27" fmla="*/ 78206 w 1102448"/>
                <a:gd name="connsiteY27" fmla="*/ 407363 h 923067"/>
                <a:gd name="connsiteX28" fmla="*/ 52204 w 1102448"/>
                <a:gd name="connsiteY28" fmla="*/ 416030 h 923067"/>
                <a:gd name="connsiteX29" fmla="*/ 43537 w 1102448"/>
                <a:gd name="connsiteY29" fmla="*/ 424698 h 923067"/>
                <a:gd name="connsiteX30" fmla="*/ 17535 w 1102448"/>
                <a:gd name="connsiteY30" fmla="*/ 442032 h 923067"/>
                <a:gd name="connsiteX31" fmla="*/ 8868 w 1102448"/>
                <a:gd name="connsiteY31" fmla="*/ 450700 h 923067"/>
                <a:gd name="connsiteX32" fmla="*/ 201 w 1102448"/>
                <a:gd name="connsiteY32" fmla="*/ 476701 h 923067"/>
                <a:gd name="connsiteX33" fmla="*/ 8868 w 1102448"/>
                <a:gd name="connsiteY33" fmla="*/ 515704 h 923067"/>
                <a:gd name="connsiteX34" fmla="*/ 26203 w 1102448"/>
                <a:gd name="connsiteY34" fmla="*/ 533039 h 923067"/>
                <a:gd name="connsiteX35" fmla="*/ 65205 w 1102448"/>
                <a:gd name="connsiteY35" fmla="*/ 550373 h 923067"/>
                <a:gd name="connsiteX36" fmla="*/ 78206 w 1102448"/>
                <a:gd name="connsiteY36" fmla="*/ 554707 h 923067"/>
                <a:gd name="connsiteX37" fmla="*/ 91207 w 1102448"/>
                <a:gd name="connsiteY37" fmla="*/ 580709 h 923067"/>
                <a:gd name="connsiteX38" fmla="*/ 108542 w 1102448"/>
                <a:gd name="connsiteY38" fmla="*/ 598044 h 923067"/>
                <a:gd name="connsiteX39" fmla="*/ 112876 w 1102448"/>
                <a:gd name="connsiteY39" fmla="*/ 615378 h 923067"/>
                <a:gd name="connsiteX40" fmla="*/ 117209 w 1102448"/>
                <a:gd name="connsiteY40" fmla="*/ 628379 h 923067"/>
                <a:gd name="connsiteX41" fmla="*/ 112876 w 1102448"/>
                <a:gd name="connsiteY41" fmla="*/ 654381 h 923067"/>
                <a:gd name="connsiteX42" fmla="*/ 86874 w 1102448"/>
                <a:gd name="connsiteY42" fmla="*/ 706385 h 923067"/>
                <a:gd name="connsiteX43" fmla="*/ 73873 w 1102448"/>
                <a:gd name="connsiteY43" fmla="*/ 710718 h 923067"/>
                <a:gd name="connsiteX44" fmla="*/ 65205 w 1102448"/>
                <a:gd name="connsiteY44" fmla="*/ 719386 h 923067"/>
                <a:gd name="connsiteX45" fmla="*/ 52204 w 1102448"/>
                <a:gd name="connsiteY45" fmla="*/ 723719 h 923067"/>
                <a:gd name="connsiteX46" fmla="*/ 56538 w 1102448"/>
                <a:gd name="connsiteY46" fmla="*/ 745388 h 923067"/>
                <a:gd name="connsiteX47" fmla="*/ 60872 w 1102448"/>
                <a:gd name="connsiteY47" fmla="*/ 758389 h 923067"/>
                <a:gd name="connsiteX48" fmla="*/ 73873 w 1102448"/>
                <a:gd name="connsiteY48" fmla="*/ 762722 h 923067"/>
                <a:gd name="connsiteX49" fmla="*/ 95541 w 1102448"/>
                <a:gd name="connsiteY49" fmla="*/ 767056 h 923067"/>
                <a:gd name="connsiteX50" fmla="*/ 121543 w 1102448"/>
                <a:gd name="connsiteY50" fmla="*/ 775723 h 923067"/>
                <a:gd name="connsiteX51" fmla="*/ 134544 w 1102448"/>
                <a:gd name="connsiteY51" fmla="*/ 780057 h 923067"/>
                <a:gd name="connsiteX52" fmla="*/ 160546 w 1102448"/>
                <a:gd name="connsiteY52" fmla="*/ 797391 h 923067"/>
                <a:gd name="connsiteX53" fmla="*/ 186548 w 1102448"/>
                <a:gd name="connsiteY53" fmla="*/ 810392 h 923067"/>
                <a:gd name="connsiteX54" fmla="*/ 216883 w 1102448"/>
                <a:gd name="connsiteY54" fmla="*/ 806059 h 923067"/>
                <a:gd name="connsiteX55" fmla="*/ 229884 w 1102448"/>
                <a:gd name="connsiteY55" fmla="*/ 801725 h 923067"/>
                <a:gd name="connsiteX56" fmla="*/ 238551 w 1102448"/>
                <a:gd name="connsiteY56" fmla="*/ 788724 h 923067"/>
                <a:gd name="connsiteX57" fmla="*/ 260220 w 1102448"/>
                <a:gd name="connsiteY57" fmla="*/ 771390 h 923067"/>
                <a:gd name="connsiteX58" fmla="*/ 281888 w 1102448"/>
                <a:gd name="connsiteY58" fmla="*/ 758389 h 923067"/>
                <a:gd name="connsiteX59" fmla="*/ 273221 w 1102448"/>
                <a:gd name="connsiteY59" fmla="*/ 732387 h 923067"/>
                <a:gd name="connsiteX60" fmla="*/ 247219 w 1102448"/>
                <a:gd name="connsiteY60" fmla="*/ 697718 h 923067"/>
                <a:gd name="connsiteX61" fmla="*/ 242885 w 1102448"/>
                <a:gd name="connsiteY61" fmla="*/ 684717 h 923067"/>
                <a:gd name="connsiteX62" fmla="*/ 260220 w 1102448"/>
                <a:gd name="connsiteY62" fmla="*/ 667382 h 923067"/>
                <a:gd name="connsiteX63" fmla="*/ 286222 w 1102448"/>
                <a:gd name="connsiteY63" fmla="*/ 658715 h 923067"/>
                <a:gd name="connsiteX64" fmla="*/ 294889 w 1102448"/>
                <a:gd name="connsiteY64" fmla="*/ 650047 h 923067"/>
                <a:gd name="connsiteX65" fmla="*/ 307890 w 1102448"/>
                <a:gd name="connsiteY65" fmla="*/ 645714 h 923067"/>
                <a:gd name="connsiteX66" fmla="*/ 316557 w 1102448"/>
                <a:gd name="connsiteY66" fmla="*/ 619712 h 923067"/>
                <a:gd name="connsiteX67" fmla="*/ 320891 w 1102448"/>
                <a:gd name="connsiteY67" fmla="*/ 606711 h 923067"/>
                <a:gd name="connsiteX68" fmla="*/ 325224 w 1102448"/>
                <a:gd name="connsiteY68" fmla="*/ 593710 h 923067"/>
                <a:gd name="connsiteX69" fmla="*/ 333892 w 1102448"/>
                <a:gd name="connsiteY69" fmla="*/ 585043 h 923067"/>
                <a:gd name="connsiteX70" fmla="*/ 364227 w 1102448"/>
                <a:gd name="connsiteY70" fmla="*/ 589376 h 923067"/>
                <a:gd name="connsiteX71" fmla="*/ 368561 w 1102448"/>
                <a:gd name="connsiteY71" fmla="*/ 602377 h 923067"/>
                <a:gd name="connsiteX72" fmla="*/ 377228 w 1102448"/>
                <a:gd name="connsiteY72" fmla="*/ 611045 h 923067"/>
                <a:gd name="connsiteX73" fmla="*/ 381562 w 1102448"/>
                <a:gd name="connsiteY73" fmla="*/ 624045 h 923067"/>
                <a:gd name="connsiteX74" fmla="*/ 390229 w 1102448"/>
                <a:gd name="connsiteY74" fmla="*/ 632713 h 923067"/>
                <a:gd name="connsiteX75" fmla="*/ 407564 w 1102448"/>
                <a:gd name="connsiteY75" fmla="*/ 667382 h 923067"/>
                <a:gd name="connsiteX76" fmla="*/ 420565 w 1102448"/>
                <a:gd name="connsiteY76" fmla="*/ 706385 h 923067"/>
                <a:gd name="connsiteX77" fmla="*/ 424898 w 1102448"/>
                <a:gd name="connsiteY77" fmla="*/ 719386 h 923067"/>
                <a:gd name="connsiteX78" fmla="*/ 433566 w 1102448"/>
                <a:gd name="connsiteY78" fmla="*/ 754055 h 923067"/>
                <a:gd name="connsiteX79" fmla="*/ 450900 w 1102448"/>
                <a:gd name="connsiteY79" fmla="*/ 780057 h 923067"/>
                <a:gd name="connsiteX80" fmla="*/ 463901 w 1102448"/>
                <a:gd name="connsiteY80" fmla="*/ 806059 h 923067"/>
                <a:gd name="connsiteX81" fmla="*/ 472568 w 1102448"/>
                <a:gd name="connsiteY81" fmla="*/ 832061 h 923067"/>
                <a:gd name="connsiteX82" fmla="*/ 485569 w 1102448"/>
                <a:gd name="connsiteY82" fmla="*/ 897065 h 923067"/>
                <a:gd name="connsiteX83" fmla="*/ 498570 w 1102448"/>
                <a:gd name="connsiteY83" fmla="*/ 918734 h 923067"/>
                <a:gd name="connsiteX84" fmla="*/ 511571 w 1102448"/>
                <a:gd name="connsiteY84" fmla="*/ 923067 h 923067"/>
                <a:gd name="connsiteX85" fmla="*/ 563575 w 1102448"/>
                <a:gd name="connsiteY85" fmla="*/ 910066 h 923067"/>
                <a:gd name="connsiteX86" fmla="*/ 576576 w 1102448"/>
                <a:gd name="connsiteY86" fmla="*/ 905733 h 923067"/>
                <a:gd name="connsiteX87" fmla="*/ 650248 w 1102448"/>
                <a:gd name="connsiteY87" fmla="*/ 914400 h 923067"/>
                <a:gd name="connsiteX88" fmla="*/ 663249 w 1102448"/>
                <a:gd name="connsiteY88" fmla="*/ 923067 h 923067"/>
                <a:gd name="connsiteX89" fmla="*/ 702252 w 1102448"/>
                <a:gd name="connsiteY89" fmla="*/ 918734 h 923067"/>
                <a:gd name="connsiteX90" fmla="*/ 710919 w 1102448"/>
                <a:gd name="connsiteY90" fmla="*/ 892732 h 923067"/>
                <a:gd name="connsiteX91" fmla="*/ 715253 w 1102448"/>
                <a:gd name="connsiteY91" fmla="*/ 780057 h 923067"/>
                <a:gd name="connsiteX92" fmla="*/ 723920 w 1102448"/>
                <a:gd name="connsiteY92" fmla="*/ 697718 h 923067"/>
                <a:gd name="connsiteX93" fmla="*/ 728254 w 1102448"/>
                <a:gd name="connsiteY93" fmla="*/ 676049 h 923067"/>
                <a:gd name="connsiteX94" fmla="*/ 736921 w 1102448"/>
                <a:gd name="connsiteY94" fmla="*/ 619712 h 923067"/>
                <a:gd name="connsiteX95" fmla="*/ 745588 w 1102448"/>
                <a:gd name="connsiteY95" fmla="*/ 593710 h 923067"/>
                <a:gd name="connsiteX96" fmla="*/ 758589 w 1102448"/>
                <a:gd name="connsiteY96" fmla="*/ 589376 h 923067"/>
                <a:gd name="connsiteX97" fmla="*/ 819260 w 1102448"/>
                <a:gd name="connsiteY97" fmla="*/ 580709 h 923067"/>
                <a:gd name="connsiteX98" fmla="*/ 832261 w 1102448"/>
                <a:gd name="connsiteY98" fmla="*/ 576375 h 923067"/>
                <a:gd name="connsiteX99" fmla="*/ 827928 w 1102448"/>
                <a:gd name="connsiteY99" fmla="*/ 589376 h 923067"/>
                <a:gd name="connsiteX100" fmla="*/ 832261 w 1102448"/>
                <a:gd name="connsiteY100" fmla="*/ 680383 h 923067"/>
                <a:gd name="connsiteX101" fmla="*/ 840929 w 1102448"/>
                <a:gd name="connsiteY101" fmla="*/ 706385 h 923067"/>
                <a:gd name="connsiteX102" fmla="*/ 836595 w 1102448"/>
                <a:gd name="connsiteY102" fmla="*/ 758389 h 923067"/>
                <a:gd name="connsiteX103" fmla="*/ 827928 w 1102448"/>
                <a:gd name="connsiteY103" fmla="*/ 784391 h 923067"/>
                <a:gd name="connsiteX104" fmla="*/ 840929 w 1102448"/>
                <a:gd name="connsiteY104" fmla="*/ 819060 h 923067"/>
                <a:gd name="connsiteX105" fmla="*/ 866931 w 1102448"/>
                <a:gd name="connsiteY105" fmla="*/ 827727 h 923067"/>
                <a:gd name="connsiteX106" fmla="*/ 879931 w 1102448"/>
                <a:gd name="connsiteY106" fmla="*/ 819060 h 923067"/>
                <a:gd name="connsiteX107" fmla="*/ 901600 w 1102448"/>
                <a:gd name="connsiteY107" fmla="*/ 788724 h 923067"/>
                <a:gd name="connsiteX108" fmla="*/ 927602 w 1102448"/>
                <a:gd name="connsiteY108" fmla="*/ 780057 h 923067"/>
                <a:gd name="connsiteX109" fmla="*/ 940603 w 1102448"/>
                <a:gd name="connsiteY109" fmla="*/ 775723 h 923067"/>
                <a:gd name="connsiteX110" fmla="*/ 953603 w 1102448"/>
                <a:gd name="connsiteY110" fmla="*/ 767056 h 923067"/>
                <a:gd name="connsiteX111" fmla="*/ 962271 w 1102448"/>
                <a:gd name="connsiteY111" fmla="*/ 758389 h 923067"/>
                <a:gd name="connsiteX112" fmla="*/ 988273 w 1102448"/>
                <a:gd name="connsiteY112" fmla="*/ 749721 h 923067"/>
                <a:gd name="connsiteX113" fmla="*/ 1022942 w 1102448"/>
                <a:gd name="connsiteY113" fmla="*/ 723719 h 923067"/>
                <a:gd name="connsiteX114" fmla="*/ 1031609 w 1102448"/>
                <a:gd name="connsiteY114" fmla="*/ 710718 h 923067"/>
                <a:gd name="connsiteX115" fmla="*/ 1040276 w 1102448"/>
                <a:gd name="connsiteY115" fmla="*/ 684717 h 923067"/>
                <a:gd name="connsiteX116" fmla="*/ 1053277 w 1102448"/>
                <a:gd name="connsiteY116" fmla="*/ 598044 h 923067"/>
                <a:gd name="connsiteX117" fmla="*/ 1057611 w 1102448"/>
                <a:gd name="connsiteY117" fmla="*/ 585043 h 923067"/>
                <a:gd name="connsiteX118" fmla="*/ 1061945 w 1102448"/>
                <a:gd name="connsiteY118" fmla="*/ 572042 h 923067"/>
                <a:gd name="connsiteX119" fmla="*/ 1057611 w 1102448"/>
                <a:gd name="connsiteY119" fmla="*/ 546040 h 923067"/>
                <a:gd name="connsiteX120" fmla="*/ 1057611 w 1102448"/>
                <a:gd name="connsiteY120" fmla="*/ 489702 h 923067"/>
                <a:gd name="connsiteX121" fmla="*/ 1096614 w 1102448"/>
                <a:gd name="connsiteY121" fmla="*/ 485369 h 923067"/>
                <a:gd name="connsiteX122" fmla="*/ 1096614 w 1102448"/>
                <a:gd name="connsiteY122" fmla="*/ 424698 h 923067"/>
                <a:gd name="connsiteX123" fmla="*/ 1092280 w 1102448"/>
                <a:gd name="connsiteY123" fmla="*/ 411697 h 923067"/>
                <a:gd name="connsiteX124" fmla="*/ 1083613 w 1102448"/>
                <a:gd name="connsiteY124" fmla="*/ 403029 h 923067"/>
                <a:gd name="connsiteX125" fmla="*/ 1074946 w 1102448"/>
                <a:gd name="connsiteY125" fmla="*/ 390028 h 923067"/>
                <a:gd name="connsiteX126" fmla="*/ 1053277 w 1102448"/>
                <a:gd name="connsiteY126" fmla="*/ 372694 h 923067"/>
                <a:gd name="connsiteX127" fmla="*/ 1044610 w 1102448"/>
                <a:gd name="connsiteY127" fmla="*/ 359693 h 923067"/>
                <a:gd name="connsiteX128" fmla="*/ 1031609 w 1102448"/>
                <a:gd name="connsiteY128" fmla="*/ 351026 h 923067"/>
                <a:gd name="connsiteX129" fmla="*/ 1009941 w 1102448"/>
                <a:gd name="connsiteY129" fmla="*/ 333691 h 923067"/>
                <a:gd name="connsiteX130" fmla="*/ 1005607 w 1102448"/>
                <a:gd name="connsiteY130" fmla="*/ 320690 h 923067"/>
                <a:gd name="connsiteX131" fmla="*/ 992606 w 1102448"/>
                <a:gd name="connsiteY131" fmla="*/ 312023 h 923067"/>
                <a:gd name="connsiteX132" fmla="*/ 983939 w 1102448"/>
                <a:gd name="connsiteY132" fmla="*/ 303355 h 923067"/>
                <a:gd name="connsiteX133" fmla="*/ 966604 w 1102448"/>
                <a:gd name="connsiteY133" fmla="*/ 281687 h 923067"/>
                <a:gd name="connsiteX134" fmla="*/ 953603 w 1102448"/>
                <a:gd name="connsiteY134" fmla="*/ 277354 h 923067"/>
                <a:gd name="connsiteX135" fmla="*/ 931935 w 1102448"/>
                <a:gd name="connsiteY135" fmla="*/ 260019 h 923067"/>
                <a:gd name="connsiteX136" fmla="*/ 905933 w 1102448"/>
                <a:gd name="connsiteY136" fmla="*/ 251352 h 923067"/>
                <a:gd name="connsiteX137" fmla="*/ 892932 w 1102448"/>
                <a:gd name="connsiteY137" fmla="*/ 247018 h 923067"/>
                <a:gd name="connsiteX138" fmla="*/ 866931 w 1102448"/>
                <a:gd name="connsiteY138" fmla="*/ 225350 h 923067"/>
                <a:gd name="connsiteX139" fmla="*/ 853930 w 1102448"/>
                <a:gd name="connsiteY139" fmla="*/ 221016 h 923067"/>
                <a:gd name="connsiteX140" fmla="*/ 775924 w 1102448"/>
                <a:gd name="connsiteY140" fmla="*/ 225350 h 923067"/>
                <a:gd name="connsiteX141" fmla="*/ 771590 w 1102448"/>
                <a:gd name="connsiteY141" fmla="*/ 238351 h 923067"/>
                <a:gd name="connsiteX142" fmla="*/ 732587 w 1102448"/>
                <a:gd name="connsiteY142" fmla="*/ 260019 h 923067"/>
                <a:gd name="connsiteX143" fmla="*/ 723920 w 1102448"/>
                <a:gd name="connsiteY143" fmla="*/ 247018 h 923067"/>
                <a:gd name="connsiteX144" fmla="*/ 715253 w 1102448"/>
                <a:gd name="connsiteY144" fmla="*/ 221016 h 923067"/>
                <a:gd name="connsiteX145" fmla="*/ 706585 w 1102448"/>
                <a:gd name="connsiteY145" fmla="*/ 195014 h 923067"/>
                <a:gd name="connsiteX146" fmla="*/ 697918 w 1102448"/>
                <a:gd name="connsiteY146" fmla="*/ 169012 h 923067"/>
                <a:gd name="connsiteX147" fmla="*/ 693585 w 1102448"/>
                <a:gd name="connsiteY147" fmla="*/ 156011 h 923067"/>
                <a:gd name="connsiteX148" fmla="*/ 706585 w 1102448"/>
                <a:gd name="connsiteY148" fmla="*/ 52004 h 923067"/>
                <a:gd name="connsiteX149" fmla="*/ 710919 w 1102448"/>
                <a:gd name="connsiteY149" fmla="*/ 39003 h 923067"/>
                <a:gd name="connsiteX150" fmla="*/ 715253 w 1102448"/>
                <a:gd name="connsiteY150" fmla="*/ 26002 h 923067"/>
                <a:gd name="connsiteX151" fmla="*/ 728254 w 1102448"/>
                <a:gd name="connsiteY151" fmla="*/ 13001 h 9230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</a:cxnLst>
              <a:rect l="l" t="t" r="r" b="b"/>
              <a:pathLst>
                <a:path w="1102448" h="923067">
                  <a:moveTo>
                    <a:pt x="333892" y="0"/>
                  </a:moveTo>
                  <a:cubicBezTo>
                    <a:pt x="336781" y="7223"/>
                    <a:pt x="338700" y="14914"/>
                    <a:pt x="342559" y="21668"/>
                  </a:cubicBezTo>
                  <a:cubicBezTo>
                    <a:pt x="344586" y="25216"/>
                    <a:pt x="348674" y="27145"/>
                    <a:pt x="351226" y="30336"/>
                  </a:cubicBezTo>
                  <a:cubicBezTo>
                    <a:pt x="354480" y="34403"/>
                    <a:pt x="357005" y="39003"/>
                    <a:pt x="359894" y="43336"/>
                  </a:cubicBezTo>
                  <a:lnTo>
                    <a:pt x="381562" y="108341"/>
                  </a:lnTo>
                  <a:lnTo>
                    <a:pt x="390229" y="134343"/>
                  </a:lnTo>
                  <a:lnTo>
                    <a:pt x="394563" y="147344"/>
                  </a:lnTo>
                  <a:cubicBezTo>
                    <a:pt x="392365" y="211087"/>
                    <a:pt x="413192" y="246485"/>
                    <a:pt x="381562" y="286021"/>
                  </a:cubicBezTo>
                  <a:cubicBezTo>
                    <a:pt x="379010" y="289212"/>
                    <a:pt x="375783" y="291799"/>
                    <a:pt x="372894" y="294688"/>
                  </a:cubicBezTo>
                  <a:cubicBezTo>
                    <a:pt x="364227" y="293243"/>
                    <a:pt x="354043" y="295461"/>
                    <a:pt x="346893" y="290354"/>
                  </a:cubicBezTo>
                  <a:cubicBezTo>
                    <a:pt x="342047" y="286892"/>
                    <a:pt x="344905" y="278494"/>
                    <a:pt x="342559" y="273020"/>
                  </a:cubicBezTo>
                  <a:cubicBezTo>
                    <a:pt x="340507" y="268233"/>
                    <a:pt x="336781" y="264353"/>
                    <a:pt x="333892" y="260019"/>
                  </a:cubicBezTo>
                  <a:cubicBezTo>
                    <a:pt x="338226" y="258574"/>
                    <a:pt x="346893" y="260253"/>
                    <a:pt x="346893" y="255685"/>
                  </a:cubicBezTo>
                  <a:cubicBezTo>
                    <a:pt x="346893" y="251117"/>
                    <a:pt x="338371" y="252248"/>
                    <a:pt x="333892" y="251352"/>
                  </a:cubicBezTo>
                  <a:cubicBezTo>
                    <a:pt x="323876" y="249349"/>
                    <a:pt x="313668" y="248463"/>
                    <a:pt x="303556" y="247018"/>
                  </a:cubicBezTo>
                  <a:cubicBezTo>
                    <a:pt x="289111" y="248463"/>
                    <a:pt x="274304" y="247831"/>
                    <a:pt x="260220" y="251352"/>
                  </a:cubicBezTo>
                  <a:cubicBezTo>
                    <a:pt x="256256" y="252343"/>
                    <a:pt x="253379" y="256364"/>
                    <a:pt x="251552" y="260019"/>
                  </a:cubicBezTo>
                  <a:cubicBezTo>
                    <a:pt x="248888" y="265346"/>
                    <a:pt x="248855" y="271627"/>
                    <a:pt x="247219" y="277354"/>
                  </a:cubicBezTo>
                  <a:cubicBezTo>
                    <a:pt x="243660" y="289811"/>
                    <a:pt x="242657" y="292806"/>
                    <a:pt x="234218" y="303355"/>
                  </a:cubicBezTo>
                  <a:cubicBezTo>
                    <a:pt x="229249" y="309566"/>
                    <a:pt x="219540" y="317583"/>
                    <a:pt x="212549" y="320690"/>
                  </a:cubicBezTo>
                  <a:cubicBezTo>
                    <a:pt x="204201" y="324400"/>
                    <a:pt x="186548" y="329357"/>
                    <a:pt x="186548" y="329357"/>
                  </a:cubicBezTo>
                  <a:cubicBezTo>
                    <a:pt x="183659" y="332246"/>
                    <a:pt x="180433" y="334834"/>
                    <a:pt x="177880" y="338025"/>
                  </a:cubicBezTo>
                  <a:cubicBezTo>
                    <a:pt x="174626" y="342092"/>
                    <a:pt x="173630" y="348266"/>
                    <a:pt x="169213" y="351026"/>
                  </a:cubicBezTo>
                  <a:cubicBezTo>
                    <a:pt x="161466" y="355868"/>
                    <a:pt x="150813" y="354625"/>
                    <a:pt x="143211" y="359693"/>
                  </a:cubicBezTo>
                  <a:cubicBezTo>
                    <a:pt x="134544" y="365471"/>
                    <a:pt x="124574" y="369661"/>
                    <a:pt x="117209" y="377027"/>
                  </a:cubicBezTo>
                  <a:cubicBezTo>
                    <a:pt x="114320" y="379916"/>
                    <a:pt x="112046" y="383593"/>
                    <a:pt x="108542" y="385695"/>
                  </a:cubicBezTo>
                  <a:cubicBezTo>
                    <a:pt x="104625" y="388045"/>
                    <a:pt x="99875" y="388584"/>
                    <a:pt x="95541" y="390028"/>
                  </a:cubicBezTo>
                  <a:cubicBezTo>
                    <a:pt x="89763" y="395806"/>
                    <a:pt x="85958" y="404779"/>
                    <a:pt x="78206" y="407363"/>
                  </a:cubicBezTo>
                  <a:lnTo>
                    <a:pt x="52204" y="416030"/>
                  </a:lnTo>
                  <a:cubicBezTo>
                    <a:pt x="49315" y="418919"/>
                    <a:pt x="46806" y="422246"/>
                    <a:pt x="43537" y="424698"/>
                  </a:cubicBezTo>
                  <a:cubicBezTo>
                    <a:pt x="35204" y="430948"/>
                    <a:pt x="24900" y="434666"/>
                    <a:pt x="17535" y="442032"/>
                  </a:cubicBezTo>
                  <a:lnTo>
                    <a:pt x="8868" y="450700"/>
                  </a:lnTo>
                  <a:cubicBezTo>
                    <a:pt x="5979" y="459367"/>
                    <a:pt x="-1301" y="467689"/>
                    <a:pt x="201" y="476701"/>
                  </a:cubicBezTo>
                  <a:cubicBezTo>
                    <a:pt x="528" y="478661"/>
                    <a:pt x="4228" y="509209"/>
                    <a:pt x="8868" y="515704"/>
                  </a:cubicBezTo>
                  <a:cubicBezTo>
                    <a:pt x="13618" y="522354"/>
                    <a:pt x="19404" y="528506"/>
                    <a:pt x="26203" y="533039"/>
                  </a:cubicBezTo>
                  <a:cubicBezTo>
                    <a:pt x="46805" y="546774"/>
                    <a:pt x="34261" y="540058"/>
                    <a:pt x="65205" y="550373"/>
                  </a:cubicBezTo>
                  <a:lnTo>
                    <a:pt x="78206" y="554707"/>
                  </a:lnTo>
                  <a:cubicBezTo>
                    <a:pt x="82400" y="567289"/>
                    <a:pt x="82043" y="570018"/>
                    <a:pt x="91207" y="580709"/>
                  </a:cubicBezTo>
                  <a:cubicBezTo>
                    <a:pt x="96525" y="586914"/>
                    <a:pt x="108542" y="598044"/>
                    <a:pt x="108542" y="598044"/>
                  </a:cubicBezTo>
                  <a:cubicBezTo>
                    <a:pt x="109987" y="603822"/>
                    <a:pt x="111240" y="609651"/>
                    <a:pt x="112876" y="615378"/>
                  </a:cubicBezTo>
                  <a:cubicBezTo>
                    <a:pt x="114131" y="619770"/>
                    <a:pt x="117209" y="623811"/>
                    <a:pt x="117209" y="628379"/>
                  </a:cubicBezTo>
                  <a:cubicBezTo>
                    <a:pt x="117209" y="637166"/>
                    <a:pt x="115007" y="645857"/>
                    <a:pt x="112876" y="654381"/>
                  </a:cubicBezTo>
                  <a:cubicBezTo>
                    <a:pt x="110429" y="664169"/>
                    <a:pt x="98427" y="702535"/>
                    <a:pt x="86874" y="706385"/>
                  </a:cubicBezTo>
                  <a:lnTo>
                    <a:pt x="73873" y="710718"/>
                  </a:lnTo>
                  <a:cubicBezTo>
                    <a:pt x="70984" y="713607"/>
                    <a:pt x="68709" y="717284"/>
                    <a:pt x="65205" y="719386"/>
                  </a:cubicBezTo>
                  <a:cubicBezTo>
                    <a:pt x="61288" y="721736"/>
                    <a:pt x="53648" y="719385"/>
                    <a:pt x="52204" y="723719"/>
                  </a:cubicBezTo>
                  <a:cubicBezTo>
                    <a:pt x="49875" y="730707"/>
                    <a:pt x="54751" y="738242"/>
                    <a:pt x="56538" y="745388"/>
                  </a:cubicBezTo>
                  <a:cubicBezTo>
                    <a:pt x="57646" y="749820"/>
                    <a:pt x="57642" y="755159"/>
                    <a:pt x="60872" y="758389"/>
                  </a:cubicBezTo>
                  <a:cubicBezTo>
                    <a:pt x="64102" y="761619"/>
                    <a:pt x="69441" y="761614"/>
                    <a:pt x="73873" y="762722"/>
                  </a:cubicBezTo>
                  <a:cubicBezTo>
                    <a:pt x="81019" y="764508"/>
                    <a:pt x="88435" y="765118"/>
                    <a:pt x="95541" y="767056"/>
                  </a:cubicBezTo>
                  <a:cubicBezTo>
                    <a:pt x="104355" y="769460"/>
                    <a:pt x="112876" y="772834"/>
                    <a:pt x="121543" y="775723"/>
                  </a:cubicBezTo>
                  <a:cubicBezTo>
                    <a:pt x="125877" y="777168"/>
                    <a:pt x="130743" y="777523"/>
                    <a:pt x="134544" y="780057"/>
                  </a:cubicBezTo>
                  <a:cubicBezTo>
                    <a:pt x="143211" y="785835"/>
                    <a:pt x="150664" y="794097"/>
                    <a:pt x="160546" y="797391"/>
                  </a:cubicBezTo>
                  <a:cubicBezTo>
                    <a:pt x="178488" y="803372"/>
                    <a:pt x="169746" y="799191"/>
                    <a:pt x="186548" y="810392"/>
                  </a:cubicBezTo>
                  <a:cubicBezTo>
                    <a:pt x="196660" y="808948"/>
                    <a:pt x="206867" y="808062"/>
                    <a:pt x="216883" y="806059"/>
                  </a:cubicBezTo>
                  <a:cubicBezTo>
                    <a:pt x="221362" y="805163"/>
                    <a:pt x="226317" y="804579"/>
                    <a:pt x="229884" y="801725"/>
                  </a:cubicBezTo>
                  <a:cubicBezTo>
                    <a:pt x="233951" y="798471"/>
                    <a:pt x="235297" y="792791"/>
                    <a:pt x="238551" y="788724"/>
                  </a:cubicBezTo>
                  <a:cubicBezTo>
                    <a:pt x="247852" y="777099"/>
                    <a:pt x="247708" y="781400"/>
                    <a:pt x="260220" y="771390"/>
                  </a:cubicBezTo>
                  <a:cubicBezTo>
                    <a:pt x="277217" y="757792"/>
                    <a:pt x="259309" y="765914"/>
                    <a:pt x="281888" y="758389"/>
                  </a:cubicBezTo>
                  <a:cubicBezTo>
                    <a:pt x="278999" y="749722"/>
                    <a:pt x="279681" y="738847"/>
                    <a:pt x="273221" y="732387"/>
                  </a:cubicBezTo>
                  <a:cubicBezTo>
                    <a:pt x="262954" y="722120"/>
                    <a:pt x="252120" y="712419"/>
                    <a:pt x="247219" y="697718"/>
                  </a:cubicBezTo>
                  <a:lnTo>
                    <a:pt x="242885" y="684717"/>
                  </a:lnTo>
                  <a:cubicBezTo>
                    <a:pt x="248663" y="678939"/>
                    <a:pt x="252468" y="669966"/>
                    <a:pt x="260220" y="667382"/>
                  </a:cubicBezTo>
                  <a:lnTo>
                    <a:pt x="286222" y="658715"/>
                  </a:lnTo>
                  <a:cubicBezTo>
                    <a:pt x="289111" y="655826"/>
                    <a:pt x="291385" y="652149"/>
                    <a:pt x="294889" y="650047"/>
                  </a:cubicBezTo>
                  <a:cubicBezTo>
                    <a:pt x="298806" y="647697"/>
                    <a:pt x="305235" y="649431"/>
                    <a:pt x="307890" y="645714"/>
                  </a:cubicBezTo>
                  <a:cubicBezTo>
                    <a:pt x="313200" y="638280"/>
                    <a:pt x="313668" y="628379"/>
                    <a:pt x="316557" y="619712"/>
                  </a:cubicBezTo>
                  <a:lnTo>
                    <a:pt x="320891" y="606711"/>
                  </a:lnTo>
                  <a:cubicBezTo>
                    <a:pt x="322335" y="602377"/>
                    <a:pt x="321994" y="596940"/>
                    <a:pt x="325224" y="593710"/>
                  </a:cubicBezTo>
                  <a:lnTo>
                    <a:pt x="333892" y="585043"/>
                  </a:lnTo>
                  <a:cubicBezTo>
                    <a:pt x="344004" y="586487"/>
                    <a:pt x="355091" y="584808"/>
                    <a:pt x="364227" y="589376"/>
                  </a:cubicBezTo>
                  <a:cubicBezTo>
                    <a:pt x="368313" y="591419"/>
                    <a:pt x="366211" y="598460"/>
                    <a:pt x="368561" y="602377"/>
                  </a:cubicBezTo>
                  <a:cubicBezTo>
                    <a:pt x="370663" y="605881"/>
                    <a:pt x="374339" y="608156"/>
                    <a:pt x="377228" y="611045"/>
                  </a:cubicBezTo>
                  <a:cubicBezTo>
                    <a:pt x="378673" y="615378"/>
                    <a:pt x="379212" y="620128"/>
                    <a:pt x="381562" y="624045"/>
                  </a:cubicBezTo>
                  <a:cubicBezTo>
                    <a:pt x="383664" y="627549"/>
                    <a:pt x="388402" y="629058"/>
                    <a:pt x="390229" y="632713"/>
                  </a:cubicBezTo>
                  <a:cubicBezTo>
                    <a:pt x="410145" y="672547"/>
                    <a:pt x="387983" y="647803"/>
                    <a:pt x="407564" y="667382"/>
                  </a:cubicBezTo>
                  <a:lnTo>
                    <a:pt x="420565" y="706385"/>
                  </a:lnTo>
                  <a:cubicBezTo>
                    <a:pt x="422009" y="710719"/>
                    <a:pt x="424002" y="714907"/>
                    <a:pt x="424898" y="719386"/>
                  </a:cubicBezTo>
                  <a:cubicBezTo>
                    <a:pt x="426099" y="725391"/>
                    <a:pt x="429401" y="746558"/>
                    <a:pt x="433566" y="754055"/>
                  </a:cubicBezTo>
                  <a:cubicBezTo>
                    <a:pt x="438625" y="763161"/>
                    <a:pt x="447606" y="770175"/>
                    <a:pt x="450900" y="780057"/>
                  </a:cubicBezTo>
                  <a:cubicBezTo>
                    <a:pt x="466710" y="827482"/>
                    <a:pt x="441494" y="755642"/>
                    <a:pt x="463901" y="806059"/>
                  </a:cubicBezTo>
                  <a:cubicBezTo>
                    <a:pt x="467611" y="814408"/>
                    <a:pt x="472568" y="832061"/>
                    <a:pt x="472568" y="832061"/>
                  </a:cubicBezTo>
                  <a:cubicBezTo>
                    <a:pt x="477911" y="880140"/>
                    <a:pt x="472766" y="858656"/>
                    <a:pt x="485569" y="897065"/>
                  </a:cubicBezTo>
                  <a:cubicBezTo>
                    <a:pt x="488977" y="907290"/>
                    <a:pt x="488657" y="912786"/>
                    <a:pt x="498570" y="918734"/>
                  </a:cubicBezTo>
                  <a:cubicBezTo>
                    <a:pt x="502487" y="921084"/>
                    <a:pt x="507237" y="921623"/>
                    <a:pt x="511571" y="923067"/>
                  </a:cubicBezTo>
                  <a:cubicBezTo>
                    <a:pt x="546590" y="917231"/>
                    <a:pt x="529232" y="921514"/>
                    <a:pt x="563575" y="910066"/>
                  </a:cubicBezTo>
                  <a:lnTo>
                    <a:pt x="576576" y="905733"/>
                  </a:lnTo>
                  <a:cubicBezTo>
                    <a:pt x="586173" y="906418"/>
                    <a:pt x="630546" y="904549"/>
                    <a:pt x="650248" y="914400"/>
                  </a:cubicBezTo>
                  <a:cubicBezTo>
                    <a:pt x="654906" y="916729"/>
                    <a:pt x="658915" y="920178"/>
                    <a:pt x="663249" y="923067"/>
                  </a:cubicBezTo>
                  <a:cubicBezTo>
                    <a:pt x="676250" y="921623"/>
                    <a:pt x="691216" y="925757"/>
                    <a:pt x="702252" y="918734"/>
                  </a:cubicBezTo>
                  <a:cubicBezTo>
                    <a:pt x="709960" y="913829"/>
                    <a:pt x="710919" y="892732"/>
                    <a:pt x="710919" y="892732"/>
                  </a:cubicBezTo>
                  <a:cubicBezTo>
                    <a:pt x="712364" y="855174"/>
                    <a:pt x="713168" y="817585"/>
                    <a:pt x="715253" y="780057"/>
                  </a:cubicBezTo>
                  <a:cubicBezTo>
                    <a:pt x="715593" y="773940"/>
                    <a:pt x="722753" y="705886"/>
                    <a:pt x="723920" y="697718"/>
                  </a:cubicBezTo>
                  <a:cubicBezTo>
                    <a:pt x="724962" y="690426"/>
                    <a:pt x="727212" y="683341"/>
                    <a:pt x="728254" y="676049"/>
                  </a:cubicBezTo>
                  <a:cubicBezTo>
                    <a:pt x="732972" y="643019"/>
                    <a:pt x="729538" y="644321"/>
                    <a:pt x="736921" y="619712"/>
                  </a:cubicBezTo>
                  <a:cubicBezTo>
                    <a:pt x="739546" y="610961"/>
                    <a:pt x="736921" y="596599"/>
                    <a:pt x="745588" y="593710"/>
                  </a:cubicBezTo>
                  <a:cubicBezTo>
                    <a:pt x="749922" y="592265"/>
                    <a:pt x="754157" y="590484"/>
                    <a:pt x="758589" y="589376"/>
                  </a:cubicBezTo>
                  <a:cubicBezTo>
                    <a:pt x="780658" y="583859"/>
                    <a:pt x="795004" y="583404"/>
                    <a:pt x="819260" y="580709"/>
                  </a:cubicBezTo>
                  <a:cubicBezTo>
                    <a:pt x="823594" y="579264"/>
                    <a:pt x="829031" y="573145"/>
                    <a:pt x="832261" y="576375"/>
                  </a:cubicBezTo>
                  <a:cubicBezTo>
                    <a:pt x="835491" y="579605"/>
                    <a:pt x="827928" y="584808"/>
                    <a:pt x="827928" y="589376"/>
                  </a:cubicBezTo>
                  <a:cubicBezTo>
                    <a:pt x="827928" y="619746"/>
                    <a:pt x="828907" y="650199"/>
                    <a:pt x="832261" y="680383"/>
                  </a:cubicBezTo>
                  <a:cubicBezTo>
                    <a:pt x="833270" y="689463"/>
                    <a:pt x="840929" y="706385"/>
                    <a:pt x="840929" y="706385"/>
                  </a:cubicBezTo>
                  <a:cubicBezTo>
                    <a:pt x="839484" y="723720"/>
                    <a:pt x="839455" y="741231"/>
                    <a:pt x="836595" y="758389"/>
                  </a:cubicBezTo>
                  <a:cubicBezTo>
                    <a:pt x="835093" y="767401"/>
                    <a:pt x="827928" y="784391"/>
                    <a:pt x="827928" y="784391"/>
                  </a:cubicBezTo>
                  <a:cubicBezTo>
                    <a:pt x="830024" y="796969"/>
                    <a:pt x="827401" y="812296"/>
                    <a:pt x="840929" y="819060"/>
                  </a:cubicBezTo>
                  <a:cubicBezTo>
                    <a:pt x="849101" y="823146"/>
                    <a:pt x="866931" y="827727"/>
                    <a:pt x="866931" y="827727"/>
                  </a:cubicBezTo>
                  <a:cubicBezTo>
                    <a:pt x="871264" y="824838"/>
                    <a:pt x="876678" y="823127"/>
                    <a:pt x="879931" y="819060"/>
                  </a:cubicBezTo>
                  <a:cubicBezTo>
                    <a:pt x="891694" y="804356"/>
                    <a:pt x="872369" y="798467"/>
                    <a:pt x="901600" y="788724"/>
                  </a:cubicBezTo>
                  <a:lnTo>
                    <a:pt x="927602" y="780057"/>
                  </a:lnTo>
                  <a:cubicBezTo>
                    <a:pt x="931936" y="778612"/>
                    <a:pt x="936802" y="778257"/>
                    <a:pt x="940603" y="775723"/>
                  </a:cubicBezTo>
                  <a:cubicBezTo>
                    <a:pt x="944936" y="772834"/>
                    <a:pt x="949536" y="770309"/>
                    <a:pt x="953603" y="767056"/>
                  </a:cubicBezTo>
                  <a:cubicBezTo>
                    <a:pt x="956794" y="764504"/>
                    <a:pt x="958616" y="760216"/>
                    <a:pt x="962271" y="758389"/>
                  </a:cubicBezTo>
                  <a:cubicBezTo>
                    <a:pt x="970443" y="754303"/>
                    <a:pt x="980671" y="754789"/>
                    <a:pt x="988273" y="749721"/>
                  </a:cubicBezTo>
                  <a:cubicBezTo>
                    <a:pt x="1000163" y="741795"/>
                    <a:pt x="1013779" y="735174"/>
                    <a:pt x="1022942" y="723719"/>
                  </a:cubicBezTo>
                  <a:cubicBezTo>
                    <a:pt x="1026195" y="719652"/>
                    <a:pt x="1029494" y="715477"/>
                    <a:pt x="1031609" y="710718"/>
                  </a:cubicBezTo>
                  <a:cubicBezTo>
                    <a:pt x="1035319" y="702370"/>
                    <a:pt x="1040276" y="684717"/>
                    <a:pt x="1040276" y="684717"/>
                  </a:cubicBezTo>
                  <a:cubicBezTo>
                    <a:pt x="1045261" y="614936"/>
                    <a:pt x="1038198" y="643279"/>
                    <a:pt x="1053277" y="598044"/>
                  </a:cubicBezTo>
                  <a:lnTo>
                    <a:pt x="1057611" y="585043"/>
                  </a:lnTo>
                  <a:lnTo>
                    <a:pt x="1061945" y="572042"/>
                  </a:lnTo>
                  <a:cubicBezTo>
                    <a:pt x="1060500" y="563375"/>
                    <a:pt x="1059517" y="554618"/>
                    <a:pt x="1057611" y="546040"/>
                  </a:cubicBezTo>
                  <a:cubicBezTo>
                    <a:pt x="1053471" y="527412"/>
                    <a:pt x="1037614" y="511698"/>
                    <a:pt x="1057611" y="489702"/>
                  </a:cubicBezTo>
                  <a:cubicBezTo>
                    <a:pt x="1066410" y="480023"/>
                    <a:pt x="1083613" y="486813"/>
                    <a:pt x="1096614" y="485369"/>
                  </a:cubicBezTo>
                  <a:cubicBezTo>
                    <a:pt x="1105450" y="458862"/>
                    <a:pt x="1103261" y="471221"/>
                    <a:pt x="1096614" y="424698"/>
                  </a:cubicBezTo>
                  <a:cubicBezTo>
                    <a:pt x="1095968" y="420176"/>
                    <a:pt x="1094630" y="415614"/>
                    <a:pt x="1092280" y="411697"/>
                  </a:cubicBezTo>
                  <a:cubicBezTo>
                    <a:pt x="1090178" y="408193"/>
                    <a:pt x="1086165" y="406220"/>
                    <a:pt x="1083613" y="403029"/>
                  </a:cubicBezTo>
                  <a:cubicBezTo>
                    <a:pt x="1080360" y="398962"/>
                    <a:pt x="1078200" y="394095"/>
                    <a:pt x="1074946" y="390028"/>
                  </a:cubicBezTo>
                  <a:cubicBezTo>
                    <a:pt x="1067890" y="381208"/>
                    <a:pt x="1062928" y="379128"/>
                    <a:pt x="1053277" y="372694"/>
                  </a:cubicBezTo>
                  <a:cubicBezTo>
                    <a:pt x="1050388" y="368360"/>
                    <a:pt x="1048293" y="363376"/>
                    <a:pt x="1044610" y="359693"/>
                  </a:cubicBezTo>
                  <a:cubicBezTo>
                    <a:pt x="1040927" y="356010"/>
                    <a:pt x="1035676" y="354280"/>
                    <a:pt x="1031609" y="351026"/>
                  </a:cubicBezTo>
                  <a:cubicBezTo>
                    <a:pt x="1000734" y="326325"/>
                    <a:pt x="1049956" y="360367"/>
                    <a:pt x="1009941" y="333691"/>
                  </a:cubicBezTo>
                  <a:cubicBezTo>
                    <a:pt x="1008496" y="329357"/>
                    <a:pt x="1008461" y="324257"/>
                    <a:pt x="1005607" y="320690"/>
                  </a:cubicBezTo>
                  <a:cubicBezTo>
                    <a:pt x="1002353" y="316623"/>
                    <a:pt x="996673" y="315277"/>
                    <a:pt x="992606" y="312023"/>
                  </a:cubicBezTo>
                  <a:cubicBezTo>
                    <a:pt x="989415" y="309471"/>
                    <a:pt x="986491" y="306546"/>
                    <a:pt x="983939" y="303355"/>
                  </a:cubicBezTo>
                  <a:cubicBezTo>
                    <a:pt x="978487" y="296540"/>
                    <a:pt x="974655" y="286517"/>
                    <a:pt x="966604" y="281687"/>
                  </a:cubicBezTo>
                  <a:cubicBezTo>
                    <a:pt x="962687" y="279337"/>
                    <a:pt x="957937" y="278798"/>
                    <a:pt x="953603" y="277354"/>
                  </a:cubicBezTo>
                  <a:cubicBezTo>
                    <a:pt x="946398" y="270149"/>
                    <a:pt x="941777" y="264393"/>
                    <a:pt x="931935" y="260019"/>
                  </a:cubicBezTo>
                  <a:cubicBezTo>
                    <a:pt x="923586" y="256309"/>
                    <a:pt x="914600" y="254241"/>
                    <a:pt x="905933" y="251352"/>
                  </a:cubicBezTo>
                  <a:lnTo>
                    <a:pt x="892932" y="247018"/>
                  </a:lnTo>
                  <a:cubicBezTo>
                    <a:pt x="883348" y="237434"/>
                    <a:pt x="878997" y="231383"/>
                    <a:pt x="866931" y="225350"/>
                  </a:cubicBezTo>
                  <a:cubicBezTo>
                    <a:pt x="862845" y="223307"/>
                    <a:pt x="858264" y="222461"/>
                    <a:pt x="853930" y="221016"/>
                  </a:cubicBezTo>
                  <a:cubicBezTo>
                    <a:pt x="827928" y="222461"/>
                    <a:pt x="801407" y="219985"/>
                    <a:pt x="775924" y="225350"/>
                  </a:cubicBezTo>
                  <a:cubicBezTo>
                    <a:pt x="771454" y="226291"/>
                    <a:pt x="774820" y="235121"/>
                    <a:pt x="771590" y="238351"/>
                  </a:cubicBezTo>
                  <a:cubicBezTo>
                    <a:pt x="756690" y="253251"/>
                    <a:pt x="748935" y="254569"/>
                    <a:pt x="732587" y="260019"/>
                  </a:cubicBezTo>
                  <a:cubicBezTo>
                    <a:pt x="729698" y="255685"/>
                    <a:pt x="726035" y="251777"/>
                    <a:pt x="723920" y="247018"/>
                  </a:cubicBezTo>
                  <a:cubicBezTo>
                    <a:pt x="720210" y="238669"/>
                    <a:pt x="718142" y="229683"/>
                    <a:pt x="715253" y="221016"/>
                  </a:cubicBezTo>
                  <a:lnTo>
                    <a:pt x="706585" y="195014"/>
                  </a:lnTo>
                  <a:lnTo>
                    <a:pt x="697918" y="169012"/>
                  </a:lnTo>
                  <a:lnTo>
                    <a:pt x="693585" y="156011"/>
                  </a:lnTo>
                  <a:cubicBezTo>
                    <a:pt x="698424" y="68891"/>
                    <a:pt x="689683" y="102709"/>
                    <a:pt x="706585" y="52004"/>
                  </a:cubicBezTo>
                  <a:lnTo>
                    <a:pt x="710919" y="39003"/>
                  </a:lnTo>
                  <a:cubicBezTo>
                    <a:pt x="712364" y="34669"/>
                    <a:pt x="712023" y="29232"/>
                    <a:pt x="715253" y="26002"/>
                  </a:cubicBezTo>
                  <a:lnTo>
                    <a:pt x="728254" y="13001"/>
                  </a:lnTo>
                </a:path>
              </a:pathLst>
            </a:custGeom>
            <a:noFill/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Freeform 26"/>
            <p:cNvSpPr/>
            <p:nvPr/>
          </p:nvSpPr>
          <p:spPr>
            <a:xfrm>
              <a:off x="7190437" y="4418678"/>
              <a:ext cx="132634" cy="57859"/>
            </a:xfrm>
            <a:custGeom>
              <a:avLst/>
              <a:gdLst>
                <a:gd name="connsiteX0" fmla="*/ 0 w 182013"/>
                <a:gd name="connsiteY0" fmla="*/ 78005 h 78481"/>
                <a:gd name="connsiteX1" fmla="*/ 39002 w 182013"/>
                <a:gd name="connsiteY1" fmla="*/ 69338 h 78481"/>
                <a:gd name="connsiteX2" fmla="*/ 56337 w 182013"/>
                <a:gd name="connsiteY2" fmla="*/ 52003 h 78481"/>
                <a:gd name="connsiteX3" fmla="*/ 60671 w 182013"/>
                <a:gd name="connsiteY3" fmla="*/ 39002 h 78481"/>
                <a:gd name="connsiteX4" fmla="*/ 65004 w 182013"/>
                <a:gd name="connsiteY4" fmla="*/ 8667 h 78481"/>
                <a:gd name="connsiteX5" fmla="*/ 91006 w 182013"/>
                <a:gd name="connsiteY5" fmla="*/ 0 h 78481"/>
                <a:gd name="connsiteX6" fmla="*/ 117008 w 182013"/>
                <a:gd name="connsiteY6" fmla="*/ 4333 h 78481"/>
                <a:gd name="connsiteX7" fmla="*/ 130009 w 182013"/>
                <a:gd name="connsiteY7" fmla="*/ 47670 h 78481"/>
                <a:gd name="connsiteX8" fmla="*/ 134343 w 182013"/>
                <a:gd name="connsiteY8" fmla="*/ 60671 h 78481"/>
                <a:gd name="connsiteX9" fmla="*/ 160345 w 182013"/>
                <a:gd name="connsiteY9" fmla="*/ 69338 h 78481"/>
                <a:gd name="connsiteX10" fmla="*/ 173346 w 182013"/>
                <a:gd name="connsiteY10" fmla="*/ 78005 h 78481"/>
                <a:gd name="connsiteX11" fmla="*/ 182013 w 182013"/>
                <a:gd name="connsiteY11" fmla="*/ 78005 h 784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82013" h="78481">
                  <a:moveTo>
                    <a:pt x="0" y="78005"/>
                  </a:moveTo>
                  <a:cubicBezTo>
                    <a:pt x="1960" y="77678"/>
                    <a:pt x="32507" y="73977"/>
                    <a:pt x="39002" y="69338"/>
                  </a:cubicBezTo>
                  <a:cubicBezTo>
                    <a:pt x="45652" y="64588"/>
                    <a:pt x="56337" y="52003"/>
                    <a:pt x="56337" y="52003"/>
                  </a:cubicBezTo>
                  <a:cubicBezTo>
                    <a:pt x="57782" y="47669"/>
                    <a:pt x="59775" y="43481"/>
                    <a:pt x="60671" y="39002"/>
                  </a:cubicBezTo>
                  <a:cubicBezTo>
                    <a:pt x="62674" y="28986"/>
                    <a:pt x="58733" y="16730"/>
                    <a:pt x="65004" y="8667"/>
                  </a:cubicBezTo>
                  <a:cubicBezTo>
                    <a:pt x="70613" y="1455"/>
                    <a:pt x="91006" y="0"/>
                    <a:pt x="91006" y="0"/>
                  </a:cubicBezTo>
                  <a:cubicBezTo>
                    <a:pt x="99673" y="1444"/>
                    <a:pt x="110395" y="-1453"/>
                    <a:pt x="117008" y="4333"/>
                  </a:cubicBezTo>
                  <a:cubicBezTo>
                    <a:pt x="120930" y="7765"/>
                    <a:pt x="127780" y="39870"/>
                    <a:pt x="130009" y="47670"/>
                  </a:cubicBezTo>
                  <a:cubicBezTo>
                    <a:pt x="131264" y="52062"/>
                    <a:pt x="130626" y="58016"/>
                    <a:pt x="134343" y="60671"/>
                  </a:cubicBezTo>
                  <a:cubicBezTo>
                    <a:pt x="141777" y="65981"/>
                    <a:pt x="152743" y="64270"/>
                    <a:pt x="160345" y="69338"/>
                  </a:cubicBezTo>
                  <a:cubicBezTo>
                    <a:pt x="164679" y="72227"/>
                    <a:pt x="168510" y="76071"/>
                    <a:pt x="173346" y="78005"/>
                  </a:cubicBezTo>
                  <a:cubicBezTo>
                    <a:pt x="176028" y="79078"/>
                    <a:pt x="179124" y="78005"/>
                    <a:pt x="182013" y="78005"/>
                  </a:cubicBezTo>
                </a:path>
              </a:pathLst>
            </a:custGeom>
            <a:noFill/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0" y="914400"/>
            <a:ext cx="3657600" cy="3657600"/>
            <a:chOff x="-885766" y="2061904"/>
            <a:chExt cx="4782218" cy="4782218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885766" y="2061904"/>
              <a:ext cx="4782218" cy="4782218"/>
            </a:xfrm>
            <a:prstGeom prst="rect">
              <a:avLst/>
            </a:prstGeom>
          </p:spPr>
        </p:pic>
        <p:sp>
          <p:nvSpPr>
            <p:cNvPr id="41" name="Freeform 40"/>
            <p:cNvSpPr/>
            <p:nvPr/>
          </p:nvSpPr>
          <p:spPr>
            <a:xfrm>
              <a:off x="849086" y="3853543"/>
              <a:ext cx="1145512" cy="723481"/>
            </a:xfrm>
            <a:custGeom>
              <a:avLst/>
              <a:gdLst>
                <a:gd name="connsiteX0" fmla="*/ 954593 w 1145512"/>
                <a:gd name="connsiteY0" fmla="*/ 723481 h 723481"/>
                <a:gd name="connsiteX1" fmla="*/ 999811 w 1145512"/>
                <a:gd name="connsiteY1" fmla="*/ 713433 h 723481"/>
                <a:gd name="connsiteX2" fmla="*/ 1029956 w 1145512"/>
                <a:gd name="connsiteY2" fmla="*/ 698360 h 723481"/>
                <a:gd name="connsiteX3" fmla="*/ 1055077 w 1145512"/>
                <a:gd name="connsiteY3" fmla="*/ 678264 h 723481"/>
                <a:gd name="connsiteX4" fmla="*/ 1075173 w 1145512"/>
                <a:gd name="connsiteY4" fmla="*/ 653143 h 723481"/>
                <a:gd name="connsiteX5" fmla="*/ 1090246 w 1145512"/>
                <a:gd name="connsiteY5" fmla="*/ 622998 h 723481"/>
                <a:gd name="connsiteX6" fmla="*/ 1100294 w 1145512"/>
                <a:gd name="connsiteY6" fmla="*/ 612949 h 723481"/>
                <a:gd name="connsiteX7" fmla="*/ 1115367 w 1145512"/>
                <a:gd name="connsiteY7" fmla="*/ 607925 h 723481"/>
                <a:gd name="connsiteX8" fmla="*/ 1120391 w 1145512"/>
                <a:gd name="connsiteY8" fmla="*/ 592853 h 723481"/>
                <a:gd name="connsiteX9" fmla="*/ 1130439 w 1145512"/>
                <a:gd name="connsiteY9" fmla="*/ 582804 h 723481"/>
                <a:gd name="connsiteX10" fmla="*/ 1145512 w 1145512"/>
                <a:gd name="connsiteY10" fmla="*/ 532562 h 723481"/>
                <a:gd name="connsiteX11" fmla="*/ 1140488 w 1145512"/>
                <a:gd name="connsiteY11" fmla="*/ 366765 h 723481"/>
                <a:gd name="connsiteX12" fmla="*/ 1135463 w 1145512"/>
                <a:gd name="connsiteY12" fmla="*/ 351692 h 723481"/>
                <a:gd name="connsiteX13" fmla="*/ 1125415 w 1145512"/>
                <a:gd name="connsiteY13" fmla="*/ 316523 h 723481"/>
                <a:gd name="connsiteX14" fmla="*/ 1105318 w 1145512"/>
                <a:gd name="connsiteY14" fmla="*/ 291402 h 723481"/>
                <a:gd name="connsiteX15" fmla="*/ 1090246 w 1145512"/>
                <a:gd name="connsiteY15" fmla="*/ 266281 h 723481"/>
                <a:gd name="connsiteX16" fmla="*/ 1080198 w 1145512"/>
                <a:gd name="connsiteY16" fmla="*/ 251209 h 723481"/>
                <a:gd name="connsiteX17" fmla="*/ 1065125 w 1145512"/>
                <a:gd name="connsiteY17" fmla="*/ 246184 h 723481"/>
                <a:gd name="connsiteX18" fmla="*/ 1034980 w 1145512"/>
                <a:gd name="connsiteY18" fmla="*/ 211015 h 723481"/>
                <a:gd name="connsiteX19" fmla="*/ 1004835 w 1145512"/>
                <a:gd name="connsiteY19" fmla="*/ 190919 h 723481"/>
                <a:gd name="connsiteX20" fmla="*/ 979714 w 1145512"/>
                <a:gd name="connsiteY20" fmla="*/ 175846 h 723481"/>
                <a:gd name="connsiteX21" fmla="*/ 959617 w 1145512"/>
                <a:gd name="connsiteY21" fmla="*/ 150725 h 723481"/>
                <a:gd name="connsiteX22" fmla="*/ 944545 w 1145512"/>
                <a:gd name="connsiteY22" fmla="*/ 140677 h 723481"/>
                <a:gd name="connsiteX23" fmla="*/ 934496 w 1145512"/>
                <a:gd name="connsiteY23" fmla="*/ 130628 h 723481"/>
                <a:gd name="connsiteX24" fmla="*/ 904351 w 1145512"/>
                <a:gd name="connsiteY24" fmla="*/ 110532 h 723481"/>
                <a:gd name="connsiteX25" fmla="*/ 889279 w 1145512"/>
                <a:gd name="connsiteY25" fmla="*/ 100483 h 723481"/>
                <a:gd name="connsiteX26" fmla="*/ 879230 w 1145512"/>
                <a:gd name="connsiteY26" fmla="*/ 90435 h 723481"/>
                <a:gd name="connsiteX27" fmla="*/ 864158 w 1145512"/>
                <a:gd name="connsiteY27" fmla="*/ 85411 h 723481"/>
                <a:gd name="connsiteX28" fmla="*/ 839037 w 1145512"/>
                <a:gd name="connsiteY28" fmla="*/ 70338 h 723481"/>
                <a:gd name="connsiteX29" fmla="*/ 823965 w 1145512"/>
                <a:gd name="connsiteY29" fmla="*/ 60290 h 723481"/>
                <a:gd name="connsiteX30" fmla="*/ 793819 w 1145512"/>
                <a:gd name="connsiteY30" fmla="*/ 50242 h 723481"/>
                <a:gd name="connsiteX31" fmla="*/ 763674 w 1145512"/>
                <a:gd name="connsiteY31" fmla="*/ 40193 h 723481"/>
                <a:gd name="connsiteX32" fmla="*/ 748602 w 1145512"/>
                <a:gd name="connsiteY32" fmla="*/ 35169 h 723481"/>
                <a:gd name="connsiteX33" fmla="*/ 713433 w 1145512"/>
                <a:gd name="connsiteY33" fmla="*/ 30145 h 723481"/>
                <a:gd name="connsiteX34" fmla="*/ 678263 w 1145512"/>
                <a:gd name="connsiteY34" fmla="*/ 20097 h 723481"/>
                <a:gd name="connsiteX35" fmla="*/ 663191 w 1145512"/>
                <a:gd name="connsiteY35" fmla="*/ 15072 h 723481"/>
                <a:gd name="connsiteX36" fmla="*/ 617973 w 1145512"/>
                <a:gd name="connsiteY36" fmla="*/ 10048 h 723481"/>
                <a:gd name="connsiteX37" fmla="*/ 582804 w 1145512"/>
                <a:gd name="connsiteY37" fmla="*/ 5024 h 723481"/>
                <a:gd name="connsiteX38" fmla="*/ 542611 w 1145512"/>
                <a:gd name="connsiteY38" fmla="*/ 0 h 723481"/>
                <a:gd name="connsiteX39" fmla="*/ 336619 w 1145512"/>
                <a:gd name="connsiteY39" fmla="*/ 5024 h 723481"/>
                <a:gd name="connsiteX40" fmla="*/ 291402 w 1145512"/>
                <a:gd name="connsiteY40" fmla="*/ 20097 h 723481"/>
                <a:gd name="connsiteX41" fmla="*/ 276329 w 1145512"/>
                <a:gd name="connsiteY41" fmla="*/ 25121 h 723481"/>
                <a:gd name="connsiteX42" fmla="*/ 261257 w 1145512"/>
                <a:gd name="connsiteY42" fmla="*/ 35169 h 723481"/>
                <a:gd name="connsiteX43" fmla="*/ 246184 w 1145512"/>
                <a:gd name="connsiteY43" fmla="*/ 40193 h 723481"/>
                <a:gd name="connsiteX44" fmla="*/ 236136 w 1145512"/>
                <a:gd name="connsiteY44" fmla="*/ 50242 h 723481"/>
                <a:gd name="connsiteX45" fmla="*/ 205991 w 1145512"/>
                <a:gd name="connsiteY45" fmla="*/ 60290 h 723481"/>
                <a:gd name="connsiteX46" fmla="*/ 190918 w 1145512"/>
                <a:gd name="connsiteY46" fmla="*/ 70338 h 723481"/>
                <a:gd name="connsiteX47" fmla="*/ 180870 w 1145512"/>
                <a:gd name="connsiteY47" fmla="*/ 80387 h 723481"/>
                <a:gd name="connsiteX48" fmla="*/ 165798 w 1145512"/>
                <a:gd name="connsiteY48" fmla="*/ 85411 h 723481"/>
                <a:gd name="connsiteX49" fmla="*/ 145701 w 1145512"/>
                <a:gd name="connsiteY49" fmla="*/ 105508 h 723481"/>
                <a:gd name="connsiteX50" fmla="*/ 135652 w 1145512"/>
                <a:gd name="connsiteY50" fmla="*/ 115556 h 723481"/>
                <a:gd name="connsiteX51" fmla="*/ 120580 w 1145512"/>
                <a:gd name="connsiteY51" fmla="*/ 120580 h 723481"/>
                <a:gd name="connsiteX52" fmla="*/ 95459 w 1145512"/>
                <a:gd name="connsiteY52" fmla="*/ 140677 h 723481"/>
                <a:gd name="connsiteX53" fmla="*/ 85411 w 1145512"/>
                <a:gd name="connsiteY53" fmla="*/ 155749 h 723481"/>
                <a:gd name="connsiteX54" fmla="*/ 75362 w 1145512"/>
                <a:gd name="connsiteY54" fmla="*/ 165798 h 723481"/>
                <a:gd name="connsiteX55" fmla="*/ 60290 w 1145512"/>
                <a:gd name="connsiteY55" fmla="*/ 190919 h 723481"/>
                <a:gd name="connsiteX56" fmla="*/ 45217 w 1145512"/>
                <a:gd name="connsiteY56" fmla="*/ 216039 h 723481"/>
                <a:gd name="connsiteX57" fmla="*/ 25121 w 1145512"/>
                <a:gd name="connsiteY57" fmla="*/ 256233 h 723481"/>
                <a:gd name="connsiteX58" fmla="*/ 20096 w 1145512"/>
                <a:gd name="connsiteY58" fmla="*/ 271305 h 723481"/>
                <a:gd name="connsiteX59" fmla="*/ 10048 w 1145512"/>
                <a:gd name="connsiteY59" fmla="*/ 281354 h 723481"/>
                <a:gd name="connsiteX60" fmla="*/ 0 w 1145512"/>
                <a:gd name="connsiteY60" fmla="*/ 311499 h 723481"/>
                <a:gd name="connsiteX61" fmla="*/ 5024 w 1145512"/>
                <a:gd name="connsiteY61" fmla="*/ 361741 h 723481"/>
                <a:gd name="connsiteX62" fmla="*/ 20096 w 1145512"/>
                <a:gd name="connsiteY62" fmla="*/ 391886 h 723481"/>
                <a:gd name="connsiteX63" fmla="*/ 25121 w 1145512"/>
                <a:gd name="connsiteY63" fmla="*/ 406958 h 723481"/>
                <a:gd name="connsiteX64" fmla="*/ 35169 w 1145512"/>
                <a:gd name="connsiteY64" fmla="*/ 422031 h 723481"/>
                <a:gd name="connsiteX65" fmla="*/ 40193 w 1145512"/>
                <a:gd name="connsiteY65" fmla="*/ 437103 h 723481"/>
                <a:gd name="connsiteX66" fmla="*/ 60290 w 1145512"/>
                <a:gd name="connsiteY66" fmla="*/ 457200 h 723481"/>
                <a:gd name="connsiteX67" fmla="*/ 75362 w 1145512"/>
                <a:gd name="connsiteY67" fmla="*/ 472272 h 723481"/>
                <a:gd name="connsiteX68" fmla="*/ 105507 w 1145512"/>
                <a:gd name="connsiteY68" fmla="*/ 492369 h 723481"/>
                <a:gd name="connsiteX69" fmla="*/ 140677 w 1145512"/>
                <a:gd name="connsiteY69" fmla="*/ 517490 h 723481"/>
                <a:gd name="connsiteX70" fmla="*/ 155749 w 1145512"/>
                <a:gd name="connsiteY70" fmla="*/ 527538 h 723481"/>
                <a:gd name="connsiteX71" fmla="*/ 170822 w 1145512"/>
                <a:gd name="connsiteY71" fmla="*/ 532562 h 723481"/>
                <a:gd name="connsiteX72" fmla="*/ 195943 w 1145512"/>
                <a:gd name="connsiteY72" fmla="*/ 547635 h 723481"/>
                <a:gd name="connsiteX73" fmla="*/ 211015 w 1145512"/>
                <a:gd name="connsiteY73" fmla="*/ 557683 h 723481"/>
                <a:gd name="connsiteX74" fmla="*/ 231112 w 1145512"/>
                <a:gd name="connsiteY74" fmla="*/ 577780 h 723481"/>
                <a:gd name="connsiteX75" fmla="*/ 251209 w 1145512"/>
                <a:gd name="connsiteY75" fmla="*/ 597877 h 723481"/>
                <a:gd name="connsiteX76" fmla="*/ 261257 w 1145512"/>
                <a:gd name="connsiteY76" fmla="*/ 612949 h 723481"/>
                <a:gd name="connsiteX77" fmla="*/ 281354 w 1145512"/>
                <a:gd name="connsiteY77" fmla="*/ 633046 h 723481"/>
                <a:gd name="connsiteX78" fmla="*/ 311499 w 1145512"/>
                <a:gd name="connsiteY78" fmla="*/ 653143 h 723481"/>
                <a:gd name="connsiteX79" fmla="*/ 522514 w 1145512"/>
                <a:gd name="connsiteY79" fmla="*/ 648119 h 723481"/>
                <a:gd name="connsiteX80" fmla="*/ 562707 w 1145512"/>
                <a:gd name="connsiteY80" fmla="*/ 653143 h 723481"/>
                <a:gd name="connsiteX81" fmla="*/ 597877 w 1145512"/>
                <a:gd name="connsiteY81" fmla="*/ 663191 h 7234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</a:cxnLst>
              <a:rect l="l" t="t" r="r" b="b"/>
              <a:pathLst>
                <a:path w="1145512" h="723481">
                  <a:moveTo>
                    <a:pt x="954593" y="723481"/>
                  </a:moveTo>
                  <a:cubicBezTo>
                    <a:pt x="966167" y="721552"/>
                    <a:pt x="987444" y="719616"/>
                    <a:pt x="999811" y="713433"/>
                  </a:cubicBezTo>
                  <a:cubicBezTo>
                    <a:pt x="1038769" y="693953"/>
                    <a:pt x="992069" y="710988"/>
                    <a:pt x="1029956" y="698360"/>
                  </a:cubicBezTo>
                  <a:cubicBezTo>
                    <a:pt x="1036800" y="693797"/>
                    <a:pt x="1050305" y="686217"/>
                    <a:pt x="1055077" y="678264"/>
                  </a:cubicBezTo>
                  <a:cubicBezTo>
                    <a:pt x="1071257" y="651298"/>
                    <a:pt x="1045152" y="673157"/>
                    <a:pt x="1075173" y="653143"/>
                  </a:cubicBezTo>
                  <a:cubicBezTo>
                    <a:pt x="1080480" y="637223"/>
                    <a:pt x="1079115" y="636912"/>
                    <a:pt x="1090246" y="622998"/>
                  </a:cubicBezTo>
                  <a:cubicBezTo>
                    <a:pt x="1093205" y="619299"/>
                    <a:pt x="1096232" y="615386"/>
                    <a:pt x="1100294" y="612949"/>
                  </a:cubicBezTo>
                  <a:cubicBezTo>
                    <a:pt x="1104835" y="610224"/>
                    <a:pt x="1110343" y="609600"/>
                    <a:pt x="1115367" y="607925"/>
                  </a:cubicBezTo>
                  <a:cubicBezTo>
                    <a:pt x="1117042" y="602901"/>
                    <a:pt x="1117666" y="597394"/>
                    <a:pt x="1120391" y="592853"/>
                  </a:cubicBezTo>
                  <a:cubicBezTo>
                    <a:pt x="1122828" y="588791"/>
                    <a:pt x="1128321" y="587041"/>
                    <a:pt x="1130439" y="582804"/>
                  </a:cubicBezTo>
                  <a:cubicBezTo>
                    <a:pt x="1136557" y="570568"/>
                    <a:pt x="1141905" y="546989"/>
                    <a:pt x="1145512" y="532562"/>
                  </a:cubicBezTo>
                  <a:cubicBezTo>
                    <a:pt x="1143837" y="477296"/>
                    <a:pt x="1143555" y="421971"/>
                    <a:pt x="1140488" y="366765"/>
                  </a:cubicBezTo>
                  <a:cubicBezTo>
                    <a:pt x="1140194" y="361477"/>
                    <a:pt x="1136918" y="356784"/>
                    <a:pt x="1135463" y="351692"/>
                  </a:cubicBezTo>
                  <a:cubicBezTo>
                    <a:pt x="1133316" y="344178"/>
                    <a:pt x="1129431" y="324556"/>
                    <a:pt x="1125415" y="316523"/>
                  </a:cubicBezTo>
                  <a:cubicBezTo>
                    <a:pt x="1119076" y="303844"/>
                    <a:pt x="1114666" y="300749"/>
                    <a:pt x="1105318" y="291402"/>
                  </a:cubicBezTo>
                  <a:cubicBezTo>
                    <a:pt x="1096594" y="265229"/>
                    <a:pt x="1106009" y="285985"/>
                    <a:pt x="1090246" y="266281"/>
                  </a:cubicBezTo>
                  <a:cubicBezTo>
                    <a:pt x="1086474" y="261566"/>
                    <a:pt x="1084913" y="254981"/>
                    <a:pt x="1080198" y="251209"/>
                  </a:cubicBezTo>
                  <a:cubicBezTo>
                    <a:pt x="1076062" y="247900"/>
                    <a:pt x="1070149" y="247859"/>
                    <a:pt x="1065125" y="246184"/>
                  </a:cubicBezTo>
                  <a:cubicBezTo>
                    <a:pt x="1056034" y="232548"/>
                    <a:pt x="1049600" y="220761"/>
                    <a:pt x="1034980" y="211015"/>
                  </a:cubicBezTo>
                  <a:cubicBezTo>
                    <a:pt x="1024932" y="204316"/>
                    <a:pt x="1013374" y="199459"/>
                    <a:pt x="1004835" y="190919"/>
                  </a:cubicBezTo>
                  <a:cubicBezTo>
                    <a:pt x="991042" y="177125"/>
                    <a:pt x="999281" y="182368"/>
                    <a:pt x="979714" y="175846"/>
                  </a:cubicBezTo>
                  <a:cubicBezTo>
                    <a:pt x="972251" y="164651"/>
                    <a:pt x="969847" y="158909"/>
                    <a:pt x="959617" y="150725"/>
                  </a:cubicBezTo>
                  <a:cubicBezTo>
                    <a:pt x="954902" y="146953"/>
                    <a:pt x="949260" y="144449"/>
                    <a:pt x="944545" y="140677"/>
                  </a:cubicBezTo>
                  <a:cubicBezTo>
                    <a:pt x="940846" y="137718"/>
                    <a:pt x="938286" y="133470"/>
                    <a:pt x="934496" y="130628"/>
                  </a:cubicBezTo>
                  <a:cubicBezTo>
                    <a:pt x="924835" y="123382"/>
                    <a:pt x="914399" y="117231"/>
                    <a:pt x="904351" y="110532"/>
                  </a:cubicBezTo>
                  <a:cubicBezTo>
                    <a:pt x="899327" y="107183"/>
                    <a:pt x="893549" y="104752"/>
                    <a:pt x="889279" y="100483"/>
                  </a:cubicBezTo>
                  <a:cubicBezTo>
                    <a:pt x="885929" y="97134"/>
                    <a:pt x="883292" y="92872"/>
                    <a:pt x="879230" y="90435"/>
                  </a:cubicBezTo>
                  <a:cubicBezTo>
                    <a:pt x="874689" y="87710"/>
                    <a:pt x="869182" y="87086"/>
                    <a:pt x="864158" y="85411"/>
                  </a:cubicBezTo>
                  <a:cubicBezTo>
                    <a:pt x="844533" y="65784"/>
                    <a:pt x="865125" y="83381"/>
                    <a:pt x="839037" y="70338"/>
                  </a:cubicBezTo>
                  <a:cubicBezTo>
                    <a:pt x="833636" y="67638"/>
                    <a:pt x="829483" y="62742"/>
                    <a:pt x="823965" y="60290"/>
                  </a:cubicBezTo>
                  <a:cubicBezTo>
                    <a:pt x="814286" y="55988"/>
                    <a:pt x="803868" y="53592"/>
                    <a:pt x="793819" y="50242"/>
                  </a:cubicBezTo>
                  <a:lnTo>
                    <a:pt x="763674" y="40193"/>
                  </a:lnTo>
                  <a:cubicBezTo>
                    <a:pt x="758650" y="38518"/>
                    <a:pt x="753845" y="35918"/>
                    <a:pt x="748602" y="35169"/>
                  </a:cubicBezTo>
                  <a:lnTo>
                    <a:pt x="713433" y="30145"/>
                  </a:lnTo>
                  <a:cubicBezTo>
                    <a:pt x="677267" y="18090"/>
                    <a:pt x="722458" y="32725"/>
                    <a:pt x="678263" y="20097"/>
                  </a:cubicBezTo>
                  <a:cubicBezTo>
                    <a:pt x="673171" y="18642"/>
                    <a:pt x="668415" y="15943"/>
                    <a:pt x="663191" y="15072"/>
                  </a:cubicBezTo>
                  <a:cubicBezTo>
                    <a:pt x="648232" y="12579"/>
                    <a:pt x="633021" y="11929"/>
                    <a:pt x="617973" y="10048"/>
                  </a:cubicBezTo>
                  <a:cubicBezTo>
                    <a:pt x="606222" y="8579"/>
                    <a:pt x="594542" y="6589"/>
                    <a:pt x="582804" y="5024"/>
                  </a:cubicBezTo>
                  <a:lnTo>
                    <a:pt x="542611" y="0"/>
                  </a:lnTo>
                  <a:cubicBezTo>
                    <a:pt x="473947" y="1675"/>
                    <a:pt x="405164" y="649"/>
                    <a:pt x="336619" y="5024"/>
                  </a:cubicBezTo>
                  <a:cubicBezTo>
                    <a:pt x="336606" y="5025"/>
                    <a:pt x="298944" y="17583"/>
                    <a:pt x="291402" y="20097"/>
                  </a:cubicBezTo>
                  <a:lnTo>
                    <a:pt x="276329" y="25121"/>
                  </a:lnTo>
                  <a:cubicBezTo>
                    <a:pt x="271305" y="28470"/>
                    <a:pt x="266658" y="32469"/>
                    <a:pt x="261257" y="35169"/>
                  </a:cubicBezTo>
                  <a:cubicBezTo>
                    <a:pt x="256520" y="37537"/>
                    <a:pt x="250725" y="37468"/>
                    <a:pt x="246184" y="40193"/>
                  </a:cubicBezTo>
                  <a:cubicBezTo>
                    <a:pt x="242122" y="42630"/>
                    <a:pt x="240373" y="48124"/>
                    <a:pt x="236136" y="50242"/>
                  </a:cubicBezTo>
                  <a:cubicBezTo>
                    <a:pt x="226662" y="54979"/>
                    <a:pt x="214804" y="54415"/>
                    <a:pt x="205991" y="60290"/>
                  </a:cubicBezTo>
                  <a:cubicBezTo>
                    <a:pt x="200967" y="63639"/>
                    <a:pt x="195633" y="66566"/>
                    <a:pt x="190918" y="70338"/>
                  </a:cubicBezTo>
                  <a:cubicBezTo>
                    <a:pt x="187219" y="73297"/>
                    <a:pt x="184932" y="77950"/>
                    <a:pt x="180870" y="80387"/>
                  </a:cubicBezTo>
                  <a:cubicBezTo>
                    <a:pt x="176329" y="83112"/>
                    <a:pt x="170822" y="83736"/>
                    <a:pt x="165798" y="85411"/>
                  </a:cubicBezTo>
                  <a:lnTo>
                    <a:pt x="145701" y="105508"/>
                  </a:lnTo>
                  <a:cubicBezTo>
                    <a:pt x="142351" y="108857"/>
                    <a:pt x="140146" y="114058"/>
                    <a:pt x="135652" y="115556"/>
                  </a:cubicBezTo>
                  <a:lnTo>
                    <a:pt x="120580" y="120580"/>
                  </a:lnTo>
                  <a:cubicBezTo>
                    <a:pt x="91786" y="163773"/>
                    <a:pt x="130125" y="112945"/>
                    <a:pt x="95459" y="140677"/>
                  </a:cubicBezTo>
                  <a:cubicBezTo>
                    <a:pt x="90744" y="144449"/>
                    <a:pt x="89183" y="151034"/>
                    <a:pt x="85411" y="155749"/>
                  </a:cubicBezTo>
                  <a:cubicBezTo>
                    <a:pt x="82452" y="159448"/>
                    <a:pt x="78712" y="162448"/>
                    <a:pt x="75362" y="165798"/>
                  </a:cubicBezTo>
                  <a:cubicBezTo>
                    <a:pt x="61130" y="208493"/>
                    <a:pt x="80979" y="156436"/>
                    <a:pt x="60290" y="190919"/>
                  </a:cubicBezTo>
                  <a:cubicBezTo>
                    <a:pt x="40728" y="223524"/>
                    <a:pt x="70675" y="190584"/>
                    <a:pt x="45217" y="216039"/>
                  </a:cubicBezTo>
                  <a:cubicBezTo>
                    <a:pt x="33671" y="250678"/>
                    <a:pt x="42658" y="238694"/>
                    <a:pt x="25121" y="256233"/>
                  </a:cubicBezTo>
                  <a:cubicBezTo>
                    <a:pt x="23446" y="261257"/>
                    <a:pt x="22821" y="266764"/>
                    <a:pt x="20096" y="271305"/>
                  </a:cubicBezTo>
                  <a:cubicBezTo>
                    <a:pt x="17659" y="275367"/>
                    <a:pt x="12166" y="277117"/>
                    <a:pt x="10048" y="281354"/>
                  </a:cubicBezTo>
                  <a:cubicBezTo>
                    <a:pt x="5311" y="290828"/>
                    <a:pt x="0" y="311499"/>
                    <a:pt x="0" y="311499"/>
                  </a:cubicBezTo>
                  <a:cubicBezTo>
                    <a:pt x="1675" y="328246"/>
                    <a:pt x="2465" y="345106"/>
                    <a:pt x="5024" y="361741"/>
                  </a:cubicBezTo>
                  <a:cubicBezTo>
                    <a:pt x="7830" y="379978"/>
                    <a:pt x="11817" y="375329"/>
                    <a:pt x="20096" y="391886"/>
                  </a:cubicBezTo>
                  <a:cubicBezTo>
                    <a:pt x="22464" y="396623"/>
                    <a:pt x="22753" y="402221"/>
                    <a:pt x="25121" y="406958"/>
                  </a:cubicBezTo>
                  <a:cubicBezTo>
                    <a:pt x="27822" y="412359"/>
                    <a:pt x="32469" y="416630"/>
                    <a:pt x="35169" y="422031"/>
                  </a:cubicBezTo>
                  <a:cubicBezTo>
                    <a:pt x="37537" y="426768"/>
                    <a:pt x="37115" y="432794"/>
                    <a:pt x="40193" y="437103"/>
                  </a:cubicBezTo>
                  <a:cubicBezTo>
                    <a:pt x="45700" y="444812"/>
                    <a:pt x="53591" y="450501"/>
                    <a:pt x="60290" y="457200"/>
                  </a:cubicBezTo>
                  <a:cubicBezTo>
                    <a:pt x="65314" y="462224"/>
                    <a:pt x="69450" y="468331"/>
                    <a:pt x="75362" y="472272"/>
                  </a:cubicBezTo>
                  <a:cubicBezTo>
                    <a:pt x="85410" y="478971"/>
                    <a:pt x="96968" y="483830"/>
                    <a:pt x="105507" y="492369"/>
                  </a:cubicBezTo>
                  <a:cubicBezTo>
                    <a:pt x="129349" y="516211"/>
                    <a:pt x="116616" y="509470"/>
                    <a:pt x="140677" y="517490"/>
                  </a:cubicBezTo>
                  <a:cubicBezTo>
                    <a:pt x="145701" y="520839"/>
                    <a:pt x="150348" y="524838"/>
                    <a:pt x="155749" y="527538"/>
                  </a:cubicBezTo>
                  <a:cubicBezTo>
                    <a:pt x="160486" y="529906"/>
                    <a:pt x="166281" y="529837"/>
                    <a:pt x="170822" y="532562"/>
                  </a:cubicBezTo>
                  <a:cubicBezTo>
                    <a:pt x="205305" y="553252"/>
                    <a:pt x="153243" y="533403"/>
                    <a:pt x="195943" y="547635"/>
                  </a:cubicBezTo>
                  <a:cubicBezTo>
                    <a:pt x="200967" y="550984"/>
                    <a:pt x="206431" y="553753"/>
                    <a:pt x="211015" y="557683"/>
                  </a:cubicBezTo>
                  <a:cubicBezTo>
                    <a:pt x="218208" y="563848"/>
                    <a:pt x="231112" y="577780"/>
                    <a:pt x="231112" y="577780"/>
                  </a:cubicBezTo>
                  <a:cubicBezTo>
                    <a:pt x="242073" y="610666"/>
                    <a:pt x="226849" y="578390"/>
                    <a:pt x="251209" y="597877"/>
                  </a:cubicBezTo>
                  <a:cubicBezTo>
                    <a:pt x="255924" y="601649"/>
                    <a:pt x="257327" y="608365"/>
                    <a:pt x="261257" y="612949"/>
                  </a:cubicBezTo>
                  <a:cubicBezTo>
                    <a:pt x="267422" y="620142"/>
                    <a:pt x="273471" y="627791"/>
                    <a:pt x="281354" y="633046"/>
                  </a:cubicBezTo>
                  <a:lnTo>
                    <a:pt x="311499" y="653143"/>
                  </a:lnTo>
                  <a:cubicBezTo>
                    <a:pt x="381837" y="651468"/>
                    <a:pt x="452156" y="648119"/>
                    <a:pt x="522514" y="648119"/>
                  </a:cubicBezTo>
                  <a:cubicBezTo>
                    <a:pt x="536016" y="648119"/>
                    <a:pt x="549505" y="650314"/>
                    <a:pt x="562707" y="653143"/>
                  </a:cubicBezTo>
                  <a:cubicBezTo>
                    <a:pt x="612071" y="663721"/>
                    <a:pt x="579472" y="663191"/>
                    <a:pt x="597877" y="663191"/>
                  </a:cubicBezTo>
                </a:path>
              </a:pathLst>
            </a:cu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1451987" y="4426299"/>
              <a:ext cx="1562518" cy="1316334"/>
              <a:chOff x="1451987" y="4426299"/>
              <a:chExt cx="1562518" cy="1316334"/>
            </a:xfrm>
          </p:grpSpPr>
          <p:sp>
            <p:nvSpPr>
              <p:cNvPr id="53" name="Freeform 52"/>
              <p:cNvSpPr/>
              <p:nvPr/>
            </p:nvSpPr>
            <p:spPr>
              <a:xfrm>
                <a:off x="1457011" y="4426299"/>
                <a:ext cx="482321" cy="577780"/>
              </a:xfrm>
              <a:custGeom>
                <a:avLst/>
                <a:gdLst>
                  <a:gd name="connsiteX0" fmla="*/ 0 w 482321"/>
                  <a:gd name="connsiteY0" fmla="*/ 40193 h 577780"/>
                  <a:gd name="connsiteX1" fmla="*/ 15073 w 482321"/>
                  <a:gd name="connsiteY1" fmla="*/ 15072 h 577780"/>
                  <a:gd name="connsiteX2" fmla="*/ 30145 w 482321"/>
                  <a:gd name="connsiteY2" fmla="*/ 10048 h 577780"/>
                  <a:gd name="connsiteX3" fmla="*/ 65314 w 482321"/>
                  <a:gd name="connsiteY3" fmla="*/ 0 h 577780"/>
                  <a:gd name="connsiteX4" fmla="*/ 115556 w 482321"/>
                  <a:gd name="connsiteY4" fmla="*/ 5024 h 577780"/>
                  <a:gd name="connsiteX5" fmla="*/ 160774 w 482321"/>
                  <a:gd name="connsiteY5" fmla="*/ 20097 h 577780"/>
                  <a:gd name="connsiteX6" fmla="*/ 190919 w 482321"/>
                  <a:gd name="connsiteY6" fmla="*/ 30145 h 577780"/>
                  <a:gd name="connsiteX7" fmla="*/ 205991 w 482321"/>
                  <a:gd name="connsiteY7" fmla="*/ 35169 h 577780"/>
                  <a:gd name="connsiteX8" fmla="*/ 231112 w 482321"/>
                  <a:gd name="connsiteY8" fmla="*/ 50242 h 577780"/>
                  <a:gd name="connsiteX9" fmla="*/ 261257 w 482321"/>
                  <a:gd name="connsiteY9" fmla="*/ 65314 h 577780"/>
                  <a:gd name="connsiteX10" fmla="*/ 271305 w 482321"/>
                  <a:gd name="connsiteY10" fmla="*/ 75363 h 577780"/>
                  <a:gd name="connsiteX11" fmla="*/ 301451 w 482321"/>
                  <a:gd name="connsiteY11" fmla="*/ 85411 h 577780"/>
                  <a:gd name="connsiteX12" fmla="*/ 311499 w 482321"/>
                  <a:gd name="connsiteY12" fmla="*/ 100483 h 577780"/>
                  <a:gd name="connsiteX13" fmla="*/ 321547 w 482321"/>
                  <a:gd name="connsiteY13" fmla="*/ 110532 h 577780"/>
                  <a:gd name="connsiteX14" fmla="*/ 331596 w 482321"/>
                  <a:gd name="connsiteY14" fmla="*/ 155749 h 577780"/>
                  <a:gd name="connsiteX15" fmla="*/ 326571 w 482321"/>
                  <a:gd name="connsiteY15" fmla="*/ 205991 h 577780"/>
                  <a:gd name="connsiteX16" fmla="*/ 316523 w 482321"/>
                  <a:gd name="connsiteY16" fmla="*/ 236136 h 577780"/>
                  <a:gd name="connsiteX17" fmla="*/ 311499 w 482321"/>
                  <a:gd name="connsiteY17" fmla="*/ 251209 h 577780"/>
                  <a:gd name="connsiteX18" fmla="*/ 306475 w 482321"/>
                  <a:gd name="connsiteY18" fmla="*/ 276330 h 577780"/>
                  <a:gd name="connsiteX19" fmla="*/ 311499 w 482321"/>
                  <a:gd name="connsiteY19" fmla="*/ 361741 h 577780"/>
                  <a:gd name="connsiteX20" fmla="*/ 321547 w 482321"/>
                  <a:gd name="connsiteY20" fmla="*/ 391886 h 577780"/>
                  <a:gd name="connsiteX21" fmla="*/ 331596 w 482321"/>
                  <a:gd name="connsiteY21" fmla="*/ 401934 h 577780"/>
                  <a:gd name="connsiteX22" fmla="*/ 346668 w 482321"/>
                  <a:gd name="connsiteY22" fmla="*/ 427055 h 577780"/>
                  <a:gd name="connsiteX23" fmla="*/ 366765 w 482321"/>
                  <a:gd name="connsiteY23" fmla="*/ 457200 h 577780"/>
                  <a:gd name="connsiteX24" fmla="*/ 376813 w 482321"/>
                  <a:gd name="connsiteY24" fmla="*/ 472272 h 577780"/>
                  <a:gd name="connsiteX25" fmla="*/ 396910 w 482321"/>
                  <a:gd name="connsiteY25" fmla="*/ 497393 h 577780"/>
                  <a:gd name="connsiteX26" fmla="*/ 432079 w 482321"/>
                  <a:gd name="connsiteY26" fmla="*/ 527538 h 577780"/>
                  <a:gd name="connsiteX27" fmla="*/ 437103 w 482321"/>
                  <a:gd name="connsiteY27" fmla="*/ 542611 h 577780"/>
                  <a:gd name="connsiteX28" fmla="*/ 472273 w 482321"/>
                  <a:gd name="connsiteY28" fmla="*/ 572756 h 577780"/>
                  <a:gd name="connsiteX29" fmla="*/ 482321 w 482321"/>
                  <a:gd name="connsiteY29" fmla="*/ 577780 h 5777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</a:cxnLst>
                <a:rect l="l" t="t" r="r" b="b"/>
                <a:pathLst>
                  <a:path w="482321" h="577780">
                    <a:moveTo>
                      <a:pt x="0" y="40193"/>
                    </a:moveTo>
                    <a:cubicBezTo>
                      <a:pt x="5024" y="31819"/>
                      <a:pt x="8168" y="21977"/>
                      <a:pt x="15073" y="15072"/>
                    </a:cubicBezTo>
                    <a:cubicBezTo>
                      <a:pt x="18818" y="11327"/>
                      <a:pt x="25053" y="11503"/>
                      <a:pt x="30145" y="10048"/>
                    </a:cubicBezTo>
                    <a:cubicBezTo>
                      <a:pt x="74305" y="-2569"/>
                      <a:pt x="29177" y="12046"/>
                      <a:pt x="65314" y="0"/>
                    </a:cubicBezTo>
                    <a:cubicBezTo>
                      <a:pt x="82061" y="1675"/>
                      <a:pt x="99013" y="1922"/>
                      <a:pt x="115556" y="5024"/>
                    </a:cubicBezTo>
                    <a:cubicBezTo>
                      <a:pt x="115572" y="5027"/>
                      <a:pt x="153231" y="17582"/>
                      <a:pt x="160774" y="20097"/>
                    </a:cubicBezTo>
                    <a:lnTo>
                      <a:pt x="190919" y="30145"/>
                    </a:lnTo>
                    <a:lnTo>
                      <a:pt x="205991" y="35169"/>
                    </a:lnTo>
                    <a:cubicBezTo>
                      <a:pt x="225618" y="54794"/>
                      <a:pt x="205025" y="37198"/>
                      <a:pt x="231112" y="50242"/>
                    </a:cubicBezTo>
                    <a:cubicBezTo>
                      <a:pt x="270062" y="69718"/>
                      <a:pt x="223381" y="52689"/>
                      <a:pt x="261257" y="65314"/>
                    </a:cubicBezTo>
                    <a:cubicBezTo>
                      <a:pt x="264606" y="68664"/>
                      <a:pt x="267068" y="73245"/>
                      <a:pt x="271305" y="75363"/>
                    </a:cubicBezTo>
                    <a:cubicBezTo>
                      <a:pt x="280779" y="80100"/>
                      <a:pt x="301451" y="85411"/>
                      <a:pt x="301451" y="85411"/>
                    </a:cubicBezTo>
                    <a:cubicBezTo>
                      <a:pt x="304800" y="90435"/>
                      <a:pt x="307727" y="95768"/>
                      <a:pt x="311499" y="100483"/>
                    </a:cubicBezTo>
                    <a:cubicBezTo>
                      <a:pt x="314458" y="104182"/>
                      <a:pt x="319110" y="106470"/>
                      <a:pt x="321547" y="110532"/>
                    </a:cubicBezTo>
                    <a:cubicBezTo>
                      <a:pt x="327255" y="120045"/>
                      <a:pt x="330581" y="149663"/>
                      <a:pt x="331596" y="155749"/>
                    </a:cubicBezTo>
                    <a:cubicBezTo>
                      <a:pt x="329921" y="172496"/>
                      <a:pt x="329673" y="189448"/>
                      <a:pt x="326571" y="205991"/>
                    </a:cubicBezTo>
                    <a:cubicBezTo>
                      <a:pt x="324619" y="216401"/>
                      <a:pt x="319872" y="226088"/>
                      <a:pt x="316523" y="236136"/>
                    </a:cubicBezTo>
                    <a:cubicBezTo>
                      <a:pt x="314848" y="241160"/>
                      <a:pt x="312538" y="246016"/>
                      <a:pt x="311499" y="251209"/>
                    </a:cubicBezTo>
                    <a:lnTo>
                      <a:pt x="306475" y="276330"/>
                    </a:lnTo>
                    <a:cubicBezTo>
                      <a:pt x="308150" y="304800"/>
                      <a:pt x="307810" y="333461"/>
                      <a:pt x="311499" y="361741"/>
                    </a:cubicBezTo>
                    <a:cubicBezTo>
                      <a:pt x="312869" y="372244"/>
                      <a:pt x="314057" y="384397"/>
                      <a:pt x="321547" y="391886"/>
                    </a:cubicBezTo>
                    <a:lnTo>
                      <a:pt x="331596" y="401934"/>
                    </a:lnTo>
                    <a:cubicBezTo>
                      <a:pt x="341201" y="430750"/>
                      <a:pt x="330118" y="404987"/>
                      <a:pt x="346668" y="427055"/>
                    </a:cubicBezTo>
                    <a:cubicBezTo>
                      <a:pt x="353914" y="436716"/>
                      <a:pt x="360066" y="447152"/>
                      <a:pt x="366765" y="457200"/>
                    </a:cubicBezTo>
                    <a:cubicBezTo>
                      <a:pt x="370114" y="462224"/>
                      <a:pt x="372543" y="468002"/>
                      <a:pt x="376813" y="472272"/>
                    </a:cubicBezTo>
                    <a:cubicBezTo>
                      <a:pt x="411022" y="506481"/>
                      <a:pt x="358882" y="453027"/>
                      <a:pt x="396910" y="497393"/>
                    </a:cubicBezTo>
                    <a:cubicBezTo>
                      <a:pt x="413155" y="516345"/>
                      <a:pt x="414301" y="515686"/>
                      <a:pt x="432079" y="527538"/>
                    </a:cubicBezTo>
                    <a:cubicBezTo>
                      <a:pt x="433754" y="532562"/>
                      <a:pt x="434025" y="538301"/>
                      <a:pt x="437103" y="542611"/>
                    </a:cubicBezTo>
                    <a:cubicBezTo>
                      <a:pt x="446286" y="555468"/>
                      <a:pt x="458995" y="564789"/>
                      <a:pt x="472273" y="572756"/>
                    </a:cubicBezTo>
                    <a:cubicBezTo>
                      <a:pt x="475484" y="574683"/>
                      <a:pt x="478972" y="576105"/>
                      <a:pt x="482321" y="577780"/>
                    </a:cubicBezTo>
                  </a:path>
                </a:pathLst>
              </a:custGeom>
              <a:noFill/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Freeform 53"/>
              <p:cNvSpPr/>
              <p:nvPr/>
            </p:nvSpPr>
            <p:spPr>
              <a:xfrm>
                <a:off x="1451987" y="4456444"/>
                <a:ext cx="1562518" cy="1286189"/>
              </a:xfrm>
              <a:custGeom>
                <a:avLst/>
                <a:gdLst>
                  <a:gd name="connsiteX0" fmla="*/ 482321 w 1562518"/>
                  <a:gd name="connsiteY0" fmla="*/ 552659 h 1286189"/>
                  <a:gd name="connsiteX1" fmla="*/ 477297 w 1562518"/>
                  <a:gd name="connsiteY1" fmla="*/ 507442 h 1286189"/>
                  <a:gd name="connsiteX2" fmla="*/ 467248 w 1562518"/>
                  <a:gd name="connsiteY2" fmla="*/ 497393 h 1286189"/>
                  <a:gd name="connsiteX3" fmla="*/ 457200 w 1562518"/>
                  <a:gd name="connsiteY3" fmla="*/ 467248 h 1286189"/>
                  <a:gd name="connsiteX4" fmla="*/ 452176 w 1562518"/>
                  <a:gd name="connsiteY4" fmla="*/ 452176 h 1286189"/>
                  <a:gd name="connsiteX5" fmla="*/ 457200 w 1562518"/>
                  <a:gd name="connsiteY5" fmla="*/ 351692 h 1286189"/>
                  <a:gd name="connsiteX6" fmla="*/ 467248 w 1562518"/>
                  <a:gd name="connsiteY6" fmla="*/ 321547 h 1286189"/>
                  <a:gd name="connsiteX7" fmla="*/ 497393 w 1562518"/>
                  <a:gd name="connsiteY7" fmla="*/ 311499 h 1286189"/>
                  <a:gd name="connsiteX8" fmla="*/ 562708 w 1562518"/>
                  <a:gd name="connsiteY8" fmla="*/ 301451 h 1286189"/>
                  <a:gd name="connsiteX9" fmla="*/ 612949 w 1562518"/>
                  <a:gd name="connsiteY9" fmla="*/ 286378 h 1286189"/>
                  <a:gd name="connsiteX10" fmla="*/ 628022 w 1562518"/>
                  <a:gd name="connsiteY10" fmla="*/ 281354 h 1286189"/>
                  <a:gd name="connsiteX11" fmla="*/ 788795 w 1562518"/>
                  <a:gd name="connsiteY11" fmla="*/ 271305 h 1286189"/>
                  <a:gd name="connsiteX12" fmla="*/ 914400 w 1562518"/>
                  <a:gd name="connsiteY12" fmla="*/ 276330 h 1286189"/>
                  <a:gd name="connsiteX13" fmla="*/ 944545 w 1562518"/>
                  <a:gd name="connsiteY13" fmla="*/ 286378 h 1286189"/>
                  <a:gd name="connsiteX14" fmla="*/ 959617 w 1562518"/>
                  <a:gd name="connsiteY14" fmla="*/ 291402 h 1286189"/>
                  <a:gd name="connsiteX15" fmla="*/ 999811 w 1562518"/>
                  <a:gd name="connsiteY15" fmla="*/ 311499 h 1286189"/>
                  <a:gd name="connsiteX16" fmla="*/ 1029956 w 1562518"/>
                  <a:gd name="connsiteY16" fmla="*/ 321547 h 1286189"/>
                  <a:gd name="connsiteX17" fmla="*/ 1045028 w 1562518"/>
                  <a:gd name="connsiteY17" fmla="*/ 326571 h 1286189"/>
                  <a:gd name="connsiteX18" fmla="*/ 1075173 w 1562518"/>
                  <a:gd name="connsiteY18" fmla="*/ 331596 h 1286189"/>
                  <a:gd name="connsiteX19" fmla="*/ 1090246 w 1562518"/>
                  <a:gd name="connsiteY19" fmla="*/ 341644 h 1286189"/>
                  <a:gd name="connsiteX20" fmla="*/ 1105318 w 1562518"/>
                  <a:gd name="connsiteY20" fmla="*/ 346668 h 1286189"/>
                  <a:gd name="connsiteX21" fmla="*/ 1130439 w 1562518"/>
                  <a:gd name="connsiteY21" fmla="*/ 361741 h 1286189"/>
                  <a:gd name="connsiteX22" fmla="*/ 1170633 w 1562518"/>
                  <a:gd name="connsiteY22" fmla="*/ 391886 h 1286189"/>
                  <a:gd name="connsiteX23" fmla="*/ 1200778 w 1562518"/>
                  <a:gd name="connsiteY23" fmla="*/ 427055 h 1286189"/>
                  <a:gd name="connsiteX24" fmla="*/ 1215850 w 1562518"/>
                  <a:gd name="connsiteY24" fmla="*/ 437103 h 1286189"/>
                  <a:gd name="connsiteX25" fmla="*/ 1225899 w 1562518"/>
                  <a:gd name="connsiteY25" fmla="*/ 447152 h 1286189"/>
                  <a:gd name="connsiteX26" fmla="*/ 1240971 w 1562518"/>
                  <a:gd name="connsiteY26" fmla="*/ 457200 h 1286189"/>
                  <a:gd name="connsiteX27" fmla="*/ 1276140 w 1562518"/>
                  <a:gd name="connsiteY27" fmla="*/ 482321 h 1286189"/>
                  <a:gd name="connsiteX28" fmla="*/ 1296237 w 1562518"/>
                  <a:gd name="connsiteY28" fmla="*/ 502418 h 1286189"/>
                  <a:gd name="connsiteX29" fmla="*/ 1306286 w 1562518"/>
                  <a:gd name="connsiteY29" fmla="*/ 512466 h 1286189"/>
                  <a:gd name="connsiteX30" fmla="*/ 1326382 w 1562518"/>
                  <a:gd name="connsiteY30" fmla="*/ 537587 h 1286189"/>
                  <a:gd name="connsiteX31" fmla="*/ 1341455 w 1562518"/>
                  <a:gd name="connsiteY31" fmla="*/ 562708 h 1286189"/>
                  <a:gd name="connsiteX32" fmla="*/ 1371600 w 1562518"/>
                  <a:gd name="connsiteY32" fmla="*/ 597877 h 1286189"/>
                  <a:gd name="connsiteX33" fmla="*/ 1386672 w 1562518"/>
                  <a:gd name="connsiteY33" fmla="*/ 607925 h 1286189"/>
                  <a:gd name="connsiteX34" fmla="*/ 1396721 w 1562518"/>
                  <a:gd name="connsiteY34" fmla="*/ 617974 h 1286189"/>
                  <a:gd name="connsiteX35" fmla="*/ 1426866 w 1562518"/>
                  <a:gd name="connsiteY35" fmla="*/ 628022 h 1286189"/>
                  <a:gd name="connsiteX36" fmla="*/ 1441938 w 1562518"/>
                  <a:gd name="connsiteY36" fmla="*/ 638070 h 1286189"/>
                  <a:gd name="connsiteX37" fmla="*/ 1472083 w 1562518"/>
                  <a:gd name="connsiteY37" fmla="*/ 648119 h 1286189"/>
                  <a:gd name="connsiteX38" fmla="*/ 1502228 w 1562518"/>
                  <a:gd name="connsiteY38" fmla="*/ 663191 h 1286189"/>
                  <a:gd name="connsiteX39" fmla="*/ 1522325 w 1562518"/>
                  <a:gd name="connsiteY39" fmla="*/ 688312 h 1286189"/>
                  <a:gd name="connsiteX40" fmla="*/ 1537398 w 1562518"/>
                  <a:gd name="connsiteY40" fmla="*/ 713433 h 1286189"/>
                  <a:gd name="connsiteX41" fmla="*/ 1547446 w 1562518"/>
                  <a:gd name="connsiteY41" fmla="*/ 748602 h 1286189"/>
                  <a:gd name="connsiteX42" fmla="*/ 1552470 w 1562518"/>
                  <a:gd name="connsiteY42" fmla="*/ 763675 h 1286189"/>
                  <a:gd name="connsiteX43" fmla="*/ 1562518 w 1562518"/>
                  <a:gd name="connsiteY43" fmla="*/ 803868 h 1286189"/>
                  <a:gd name="connsiteX44" fmla="*/ 1547446 w 1562518"/>
                  <a:gd name="connsiteY44" fmla="*/ 899327 h 1286189"/>
                  <a:gd name="connsiteX45" fmla="*/ 1537398 w 1562518"/>
                  <a:gd name="connsiteY45" fmla="*/ 909376 h 1286189"/>
                  <a:gd name="connsiteX46" fmla="*/ 1532373 w 1562518"/>
                  <a:gd name="connsiteY46" fmla="*/ 924448 h 1286189"/>
                  <a:gd name="connsiteX47" fmla="*/ 1522325 w 1562518"/>
                  <a:gd name="connsiteY47" fmla="*/ 934497 h 1286189"/>
                  <a:gd name="connsiteX48" fmla="*/ 1512277 w 1562518"/>
                  <a:gd name="connsiteY48" fmla="*/ 949569 h 1286189"/>
                  <a:gd name="connsiteX49" fmla="*/ 1502228 w 1562518"/>
                  <a:gd name="connsiteY49" fmla="*/ 959618 h 1286189"/>
                  <a:gd name="connsiteX50" fmla="*/ 1492180 w 1562518"/>
                  <a:gd name="connsiteY50" fmla="*/ 974690 h 1286189"/>
                  <a:gd name="connsiteX51" fmla="*/ 1477108 w 1562518"/>
                  <a:gd name="connsiteY51" fmla="*/ 984738 h 1286189"/>
                  <a:gd name="connsiteX52" fmla="*/ 1467059 w 1562518"/>
                  <a:gd name="connsiteY52" fmla="*/ 994787 h 1286189"/>
                  <a:gd name="connsiteX53" fmla="*/ 1451987 w 1562518"/>
                  <a:gd name="connsiteY53" fmla="*/ 1004835 h 1286189"/>
                  <a:gd name="connsiteX54" fmla="*/ 1416817 w 1562518"/>
                  <a:gd name="connsiteY54" fmla="*/ 1029956 h 1286189"/>
                  <a:gd name="connsiteX55" fmla="*/ 1371600 w 1562518"/>
                  <a:gd name="connsiteY55" fmla="*/ 1055077 h 1286189"/>
                  <a:gd name="connsiteX56" fmla="*/ 1361551 w 1562518"/>
                  <a:gd name="connsiteY56" fmla="*/ 1065125 h 1286189"/>
                  <a:gd name="connsiteX57" fmla="*/ 1316334 w 1562518"/>
                  <a:gd name="connsiteY57" fmla="*/ 1080198 h 1286189"/>
                  <a:gd name="connsiteX58" fmla="*/ 1301261 w 1562518"/>
                  <a:gd name="connsiteY58" fmla="*/ 1085222 h 1286189"/>
                  <a:gd name="connsiteX59" fmla="*/ 1286189 w 1562518"/>
                  <a:gd name="connsiteY59" fmla="*/ 1090246 h 1286189"/>
                  <a:gd name="connsiteX60" fmla="*/ 1266092 w 1562518"/>
                  <a:gd name="connsiteY60" fmla="*/ 1095270 h 1286189"/>
                  <a:gd name="connsiteX61" fmla="*/ 1251020 w 1562518"/>
                  <a:gd name="connsiteY61" fmla="*/ 1100294 h 1286189"/>
                  <a:gd name="connsiteX62" fmla="*/ 1215850 w 1562518"/>
                  <a:gd name="connsiteY62" fmla="*/ 1105319 h 1286189"/>
                  <a:gd name="connsiteX63" fmla="*/ 1185705 w 1562518"/>
                  <a:gd name="connsiteY63" fmla="*/ 1110343 h 1286189"/>
                  <a:gd name="connsiteX64" fmla="*/ 1155560 w 1562518"/>
                  <a:gd name="connsiteY64" fmla="*/ 1120391 h 1286189"/>
                  <a:gd name="connsiteX65" fmla="*/ 1140488 w 1562518"/>
                  <a:gd name="connsiteY65" fmla="*/ 1125415 h 1286189"/>
                  <a:gd name="connsiteX66" fmla="*/ 1120391 w 1562518"/>
                  <a:gd name="connsiteY66" fmla="*/ 1130440 h 1286189"/>
                  <a:gd name="connsiteX67" fmla="*/ 1075173 w 1562518"/>
                  <a:gd name="connsiteY67" fmla="*/ 1145512 h 1286189"/>
                  <a:gd name="connsiteX68" fmla="*/ 999811 w 1562518"/>
                  <a:gd name="connsiteY68" fmla="*/ 1170633 h 1286189"/>
                  <a:gd name="connsiteX69" fmla="*/ 939521 w 1562518"/>
                  <a:gd name="connsiteY69" fmla="*/ 1190730 h 1286189"/>
                  <a:gd name="connsiteX70" fmla="*/ 924448 w 1562518"/>
                  <a:gd name="connsiteY70" fmla="*/ 1195754 h 1286189"/>
                  <a:gd name="connsiteX71" fmla="*/ 909376 w 1562518"/>
                  <a:gd name="connsiteY71" fmla="*/ 1200778 h 1286189"/>
                  <a:gd name="connsiteX72" fmla="*/ 899327 w 1562518"/>
                  <a:gd name="connsiteY72" fmla="*/ 1210826 h 1286189"/>
                  <a:gd name="connsiteX73" fmla="*/ 813916 w 1562518"/>
                  <a:gd name="connsiteY73" fmla="*/ 1225899 h 1286189"/>
                  <a:gd name="connsiteX74" fmla="*/ 793820 w 1562518"/>
                  <a:gd name="connsiteY74" fmla="*/ 1230923 h 1286189"/>
                  <a:gd name="connsiteX75" fmla="*/ 763675 w 1562518"/>
                  <a:gd name="connsiteY75" fmla="*/ 1240971 h 1286189"/>
                  <a:gd name="connsiteX76" fmla="*/ 733529 w 1562518"/>
                  <a:gd name="connsiteY76" fmla="*/ 1251020 h 1286189"/>
                  <a:gd name="connsiteX77" fmla="*/ 703384 w 1562518"/>
                  <a:gd name="connsiteY77" fmla="*/ 1261068 h 1286189"/>
                  <a:gd name="connsiteX78" fmla="*/ 628022 w 1562518"/>
                  <a:gd name="connsiteY78" fmla="*/ 1271116 h 1286189"/>
                  <a:gd name="connsiteX79" fmla="*/ 597877 w 1562518"/>
                  <a:gd name="connsiteY79" fmla="*/ 1281165 h 1286189"/>
                  <a:gd name="connsiteX80" fmla="*/ 582804 w 1562518"/>
                  <a:gd name="connsiteY80" fmla="*/ 1286189 h 1286189"/>
                  <a:gd name="connsiteX81" fmla="*/ 512466 w 1562518"/>
                  <a:gd name="connsiteY81" fmla="*/ 1281165 h 1286189"/>
                  <a:gd name="connsiteX82" fmla="*/ 497393 w 1562518"/>
                  <a:gd name="connsiteY82" fmla="*/ 1256044 h 1286189"/>
                  <a:gd name="connsiteX83" fmla="*/ 487345 w 1562518"/>
                  <a:gd name="connsiteY83" fmla="*/ 1240971 h 1286189"/>
                  <a:gd name="connsiteX84" fmla="*/ 472272 w 1562518"/>
                  <a:gd name="connsiteY84" fmla="*/ 1190730 h 1286189"/>
                  <a:gd name="connsiteX85" fmla="*/ 467248 w 1562518"/>
                  <a:gd name="connsiteY85" fmla="*/ 1175657 h 1286189"/>
                  <a:gd name="connsiteX86" fmla="*/ 462224 w 1562518"/>
                  <a:gd name="connsiteY86" fmla="*/ 1055077 h 1286189"/>
                  <a:gd name="connsiteX87" fmla="*/ 457200 w 1562518"/>
                  <a:gd name="connsiteY87" fmla="*/ 1034980 h 1286189"/>
                  <a:gd name="connsiteX88" fmla="*/ 447151 w 1562518"/>
                  <a:gd name="connsiteY88" fmla="*/ 999811 h 1286189"/>
                  <a:gd name="connsiteX89" fmla="*/ 437103 w 1562518"/>
                  <a:gd name="connsiteY89" fmla="*/ 954593 h 1286189"/>
                  <a:gd name="connsiteX90" fmla="*/ 427055 w 1562518"/>
                  <a:gd name="connsiteY90" fmla="*/ 924448 h 1286189"/>
                  <a:gd name="connsiteX91" fmla="*/ 417006 w 1562518"/>
                  <a:gd name="connsiteY91" fmla="*/ 894303 h 1286189"/>
                  <a:gd name="connsiteX92" fmla="*/ 406958 w 1562518"/>
                  <a:gd name="connsiteY92" fmla="*/ 879231 h 1286189"/>
                  <a:gd name="connsiteX93" fmla="*/ 386861 w 1562518"/>
                  <a:gd name="connsiteY93" fmla="*/ 859134 h 1286189"/>
                  <a:gd name="connsiteX94" fmla="*/ 376813 w 1562518"/>
                  <a:gd name="connsiteY94" fmla="*/ 844061 h 1286189"/>
                  <a:gd name="connsiteX95" fmla="*/ 331595 w 1562518"/>
                  <a:gd name="connsiteY95" fmla="*/ 818941 h 1286189"/>
                  <a:gd name="connsiteX96" fmla="*/ 321547 w 1562518"/>
                  <a:gd name="connsiteY96" fmla="*/ 808892 h 1286189"/>
                  <a:gd name="connsiteX97" fmla="*/ 306475 w 1562518"/>
                  <a:gd name="connsiteY97" fmla="*/ 803868 h 1286189"/>
                  <a:gd name="connsiteX98" fmla="*/ 271305 w 1562518"/>
                  <a:gd name="connsiteY98" fmla="*/ 793820 h 1286189"/>
                  <a:gd name="connsiteX99" fmla="*/ 261257 w 1562518"/>
                  <a:gd name="connsiteY99" fmla="*/ 783771 h 1286189"/>
                  <a:gd name="connsiteX100" fmla="*/ 231112 w 1562518"/>
                  <a:gd name="connsiteY100" fmla="*/ 763675 h 1286189"/>
                  <a:gd name="connsiteX101" fmla="*/ 211015 w 1562518"/>
                  <a:gd name="connsiteY101" fmla="*/ 743578 h 1286189"/>
                  <a:gd name="connsiteX102" fmla="*/ 185894 w 1562518"/>
                  <a:gd name="connsiteY102" fmla="*/ 723481 h 1286189"/>
                  <a:gd name="connsiteX103" fmla="*/ 175846 w 1562518"/>
                  <a:gd name="connsiteY103" fmla="*/ 708409 h 1286189"/>
                  <a:gd name="connsiteX104" fmla="*/ 165798 w 1562518"/>
                  <a:gd name="connsiteY104" fmla="*/ 698360 h 1286189"/>
                  <a:gd name="connsiteX105" fmla="*/ 145701 w 1562518"/>
                  <a:gd name="connsiteY105" fmla="*/ 668215 h 1286189"/>
                  <a:gd name="connsiteX106" fmla="*/ 130628 w 1562518"/>
                  <a:gd name="connsiteY106" fmla="*/ 658167 h 1286189"/>
                  <a:gd name="connsiteX107" fmla="*/ 125604 w 1562518"/>
                  <a:gd name="connsiteY107" fmla="*/ 643094 h 1286189"/>
                  <a:gd name="connsiteX108" fmla="*/ 95459 w 1562518"/>
                  <a:gd name="connsiteY108" fmla="*/ 602901 h 1286189"/>
                  <a:gd name="connsiteX109" fmla="*/ 70338 w 1562518"/>
                  <a:gd name="connsiteY109" fmla="*/ 527538 h 1286189"/>
                  <a:gd name="connsiteX110" fmla="*/ 60290 w 1562518"/>
                  <a:gd name="connsiteY110" fmla="*/ 497393 h 1286189"/>
                  <a:gd name="connsiteX111" fmla="*/ 55266 w 1562518"/>
                  <a:gd name="connsiteY111" fmla="*/ 482321 h 1286189"/>
                  <a:gd name="connsiteX112" fmla="*/ 50242 w 1562518"/>
                  <a:gd name="connsiteY112" fmla="*/ 457200 h 1286189"/>
                  <a:gd name="connsiteX113" fmla="*/ 45217 w 1562518"/>
                  <a:gd name="connsiteY113" fmla="*/ 442127 h 1286189"/>
                  <a:gd name="connsiteX114" fmla="*/ 40193 w 1562518"/>
                  <a:gd name="connsiteY114" fmla="*/ 417007 h 1286189"/>
                  <a:gd name="connsiteX115" fmla="*/ 45217 w 1562518"/>
                  <a:gd name="connsiteY115" fmla="*/ 356716 h 1286189"/>
                  <a:gd name="connsiteX116" fmla="*/ 65314 w 1562518"/>
                  <a:gd name="connsiteY116" fmla="*/ 326571 h 1286189"/>
                  <a:gd name="connsiteX117" fmla="*/ 60290 w 1562518"/>
                  <a:gd name="connsiteY117" fmla="*/ 241160 h 1286189"/>
                  <a:gd name="connsiteX118" fmla="*/ 45217 w 1562518"/>
                  <a:gd name="connsiteY118" fmla="*/ 195943 h 1286189"/>
                  <a:gd name="connsiteX119" fmla="*/ 40193 w 1562518"/>
                  <a:gd name="connsiteY119" fmla="*/ 180870 h 1286189"/>
                  <a:gd name="connsiteX120" fmla="*/ 35169 w 1562518"/>
                  <a:gd name="connsiteY120" fmla="*/ 155749 h 1286189"/>
                  <a:gd name="connsiteX121" fmla="*/ 25121 w 1562518"/>
                  <a:gd name="connsiteY121" fmla="*/ 125604 h 1286189"/>
                  <a:gd name="connsiteX122" fmla="*/ 15072 w 1562518"/>
                  <a:gd name="connsiteY122" fmla="*/ 95459 h 1286189"/>
                  <a:gd name="connsiteX123" fmla="*/ 10048 w 1562518"/>
                  <a:gd name="connsiteY123" fmla="*/ 80387 h 1286189"/>
                  <a:gd name="connsiteX124" fmla="*/ 0 w 1562518"/>
                  <a:gd name="connsiteY124" fmla="*/ 25121 h 1286189"/>
                  <a:gd name="connsiteX125" fmla="*/ 10048 w 1562518"/>
                  <a:gd name="connsiteY125" fmla="*/ 0 h 128618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</a:cxnLst>
                <a:rect l="l" t="t" r="r" b="b"/>
                <a:pathLst>
                  <a:path w="1562518" h="1286189">
                    <a:moveTo>
                      <a:pt x="482321" y="552659"/>
                    </a:moveTo>
                    <a:cubicBezTo>
                      <a:pt x="480646" y="537587"/>
                      <a:pt x="481287" y="522073"/>
                      <a:pt x="477297" y="507442"/>
                    </a:cubicBezTo>
                    <a:cubicBezTo>
                      <a:pt x="476051" y="502872"/>
                      <a:pt x="469367" y="501630"/>
                      <a:pt x="467248" y="497393"/>
                    </a:cubicBezTo>
                    <a:cubicBezTo>
                      <a:pt x="462511" y="487919"/>
                      <a:pt x="460549" y="477296"/>
                      <a:pt x="457200" y="467248"/>
                    </a:cubicBezTo>
                    <a:lnTo>
                      <a:pt x="452176" y="452176"/>
                    </a:lnTo>
                    <a:cubicBezTo>
                      <a:pt x="453851" y="418681"/>
                      <a:pt x="453356" y="385007"/>
                      <a:pt x="457200" y="351692"/>
                    </a:cubicBezTo>
                    <a:cubicBezTo>
                      <a:pt x="458414" y="341170"/>
                      <a:pt x="457200" y="324896"/>
                      <a:pt x="467248" y="321547"/>
                    </a:cubicBezTo>
                    <a:cubicBezTo>
                      <a:pt x="477296" y="318198"/>
                      <a:pt x="486945" y="313240"/>
                      <a:pt x="497393" y="311499"/>
                    </a:cubicBezTo>
                    <a:cubicBezTo>
                      <a:pt x="539219" y="304528"/>
                      <a:pt x="517453" y="307916"/>
                      <a:pt x="562708" y="301451"/>
                    </a:cubicBezTo>
                    <a:cubicBezTo>
                      <a:pt x="634316" y="277580"/>
                      <a:pt x="559818" y="301558"/>
                      <a:pt x="612949" y="286378"/>
                    </a:cubicBezTo>
                    <a:cubicBezTo>
                      <a:pt x="618041" y="284923"/>
                      <a:pt x="622811" y="282301"/>
                      <a:pt x="628022" y="281354"/>
                    </a:cubicBezTo>
                    <a:cubicBezTo>
                      <a:pt x="675654" y="272694"/>
                      <a:pt x="751492" y="272860"/>
                      <a:pt x="788795" y="271305"/>
                    </a:cubicBezTo>
                    <a:cubicBezTo>
                      <a:pt x="830663" y="272980"/>
                      <a:pt x="872693" y="272294"/>
                      <a:pt x="914400" y="276330"/>
                    </a:cubicBezTo>
                    <a:cubicBezTo>
                      <a:pt x="924943" y="277350"/>
                      <a:pt x="934497" y="283029"/>
                      <a:pt x="944545" y="286378"/>
                    </a:cubicBezTo>
                    <a:lnTo>
                      <a:pt x="959617" y="291402"/>
                    </a:lnTo>
                    <a:cubicBezTo>
                      <a:pt x="977156" y="308941"/>
                      <a:pt x="965172" y="299953"/>
                      <a:pt x="999811" y="311499"/>
                    </a:cubicBezTo>
                    <a:lnTo>
                      <a:pt x="1029956" y="321547"/>
                    </a:lnTo>
                    <a:cubicBezTo>
                      <a:pt x="1034980" y="323222"/>
                      <a:pt x="1039804" y="325700"/>
                      <a:pt x="1045028" y="326571"/>
                    </a:cubicBezTo>
                    <a:lnTo>
                      <a:pt x="1075173" y="331596"/>
                    </a:lnTo>
                    <a:cubicBezTo>
                      <a:pt x="1080197" y="334945"/>
                      <a:pt x="1084845" y="338944"/>
                      <a:pt x="1090246" y="341644"/>
                    </a:cubicBezTo>
                    <a:cubicBezTo>
                      <a:pt x="1094983" y="344012"/>
                      <a:pt x="1100777" y="343943"/>
                      <a:pt x="1105318" y="346668"/>
                    </a:cubicBezTo>
                    <a:cubicBezTo>
                      <a:pt x="1139806" y="367360"/>
                      <a:pt x="1087737" y="347504"/>
                      <a:pt x="1130439" y="361741"/>
                    </a:cubicBezTo>
                    <a:cubicBezTo>
                      <a:pt x="1159305" y="390606"/>
                      <a:pt x="1144326" y="383116"/>
                      <a:pt x="1170633" y="391886"/>
                    </a:cubicBezTo>
                    <a:cubicBezTo>
                      <a:pt x="1179724" y="405523"/>
                      <a:pt x="1186158" y="417308"/>
                      <a:pt x="1200778" y="427055"/>
                    </a:cubicBezTo>
                    <a:cubicBezTo>
                      <a:pt x="1205802" y="430404"/>
                      <a:pt x="1211135" y="433331"/>
                      <a:pt x="1215850" y="437103"/>
                    </a:cubicBezTo>
                    <a:cubicBezTo>
                      <a:pt x="1219549" y="440062"/>
                      <a:pt x="1222200" y="444193"/>
                      <a:pt x="1225899" y="447152"/>
                    </a:cubicBezTo>
                    <a:cubicBezTo>
                      <a:pt x="1230614" y="450924"/>
                      <a:pt x="1236387" y="453270"/>
                      <a:pt x="1240971" y="457200"/>
                    </a:cubicBezTo>
                    <a:cubicBezTo>
                      <a:pt x="1271315" y="483209"/>
                      <a:pt x="1248446" y="473090"/>
                      <a:pt x="1276140" y="482321"/>
                    </a:cubicBezTo>
                    <a:lnTo>
                      <a:pt x="1296237" y="502418"/>
                    </a:lnTo>
                    <a:cubicBezTo>
                      <a:pt x="1299587" y="505767"/>
                      <a:pt x="1303658" y="508525"/>
                      <a:pt x="1306286" y="512466"/>
                    </a:cubicBezTo>
                    <a:cubicBezTo>
                      <a:pt x="1318962" y="531479"/>
                      <a:pt x="1312065" y="523268"/>
                      <a:pt x="1326382" y="537587"/>
                    </a:cubicBezTo>
                    <a:cubicBezTo>
                      <a:pt x="1335107" y="563761"/>
                      <a:pt x="1325691" y="543003"/>
                      <a:pt x="1341455" y="562708"/>
                    </a:cubicBezTo>
                    <a:cubicBezTo>
                      <a:pt x="1354443" y="578942"/>
                      <a:pt x="1350866" y="584055"/>
                      <a:pt x="1371600" y="597877"/>
                    </a:cubicBezTo>
                    <a:cubicBezTo>
                      <a:pt x="1376624" y="601226"/>
                      <a:pt x="1381957" y="604153"/>
                      <a:pt x="1386672" y="607925"/>
                    </a:cubicBezTo>
                    <a:cubicBezTo>
                      <a:pt x="1390371" y="610884"/>
                      <a:pt x="1392484" y="615855"/>
                      <a:pt x="1396721" y="617974"/>
                    </a:cubicBezTo>
                    <a:cubicBezTo>
                      <a:pt x="1406195" y="622711"/>
                      <a:pt x="1426866" y="628022"/>
                      <a:pt x="1426866" y="628022"/>
                    </a:cubicBezTo>
                    <a:cubicBezTo>
                      <a:pt x="1431890" y="631371"/>
                      <a:pt x="1436420" y="635618"/>
                      <a:pt x="1441938" y="638070"/>
                    </a:cubicBezTo>
                    <a:cubicBezTo>
                      <a:pt x="1451617" y="642372"/>
                      <a:pt x="1463270" y="642244"/>
                      <a:pt x="1472083" y="648119"/>
                    </a:cubicBezTo>
                    <a:cubicBezTo>
                      <a:pt x="1491562" y="661104"/>
                      <a:pt x="1481427" y="656257"/>
                      <a:pt x="1502228" y="663191"/>
                    </a:cubicBezTo>
                    <a:cubicBezTo>
                      <a:pt x="1511574" y="672537"/>
                      <a:pt x="1515988" y="675637"/>
                      <a:pt x="1522325" y="688312"/>
                    </a:cubicBezTo>
                    <a:cubicBezTo>
                      <a:pt x="1535368" y="714400"/>
                      <a:pt x="1517771" y="693808"/>
                      <a:pt x="1537398" y="713433"/>
                    </a:cubicBezTo>
                    <a:cubicBezTo>
                      <a:pt x="1549442" y="749564"/>
                      <a:pt x="1534832" y="704450"/>
                      <a:pt x="1547446" y="748602"/>
                    </a:cubicBezTo>
                    <a:cubicBezTo>
                      <a:pt x="1548901" y="753694"/>
                      <a:pt x="1551077" y="758566"/>
                      <a:pt x="1552470" y="763675"/>
                    </a:cubicBezTo>
                    <a:cubicBezTo>
                      <a:pt x="1556104" y="776998"/>
                      <a:pt x="1562518" y="803868"/>
                      <a:pt x="1562518" y="803868"/>
                    </a:cubicBezTo>
                    <a:cubicBezTo>
                      <a:pt x="1562506" y="804019"/>
                      <a:pt x="1561573" y="885198"/>
                      <a:pt x="1547446" y="899327"/>
                    </a:cubicBezTo>
                    <a:lnTo>
                      <a:pt x="1537398" y="909376"/>
                    </a:lnTo>
                    <a:cubicBezTo>
                      <a:pt x="1535723" y="914400"/>
                      <a:pt x="1535098" y="919907"/>
                      <a:pt x="1532373" y="924448"/>
                    </a:cubicBezTo>
                    <a:cubicBezTo>
                      <a:pt x="1529936" y="928510"/>
                      <a:pt x="1525284" y="930798"/>
                      <a:pt x="1522325" y="934497"/>
                    </a:cubicBezTo>
                    <a:cubicBezTo>
                      <a:pt x="1518553" y="939212"/>
                      <a:pt x="1516049" y="944854"/>
                      <a:pt x="1512277" y="949569"/>
                    </a:cubicBezTo>
                    <a:cubicBezTo>
                      <a:pt x="1509318" y="953268"/>
                      <a:pt x="1505187" y="955919"/>
                      <a:pt x="1502228" y="959618"/>
                    </a:cubicBezTo>
                    <a:cubicBezTo>
                      <a:pt x="1498456" y="964333"/>
                      <a:pt x="1496450" y="970420"/>
                      <a:pt x="1492180" y="974690"/>
                    </a:cubicBezTo>
                    <a:cubicBezTo>
                      <a:pt x="1487910" y="978960"/>
                      <a:pt x="1481823" y="980966"/>
                      <a:pt x="1477108" y="984738"/>
                    </a:cubicBezTo>
                    <a:cubicBezTo>
                      <a:pt x="1473409" y="987697"/>
                      <a:pt x="1470758" y="991828"/>
                      <a:pt x="1467059" y="994787"/>
                    </a:cubicBezTo>
                    <a:cubicBezTo>
                      <a:pt x="1462344" y="998559"/>
                      <a:pt x="1456571" y="1000905"/>
                      <a:pt x="1451987" y="1004835"/>
                    </a:cubicBezTo>
                    <a:cubicBezTo>
                      <a:pt x="1421643" y="1030844"/>
                      <a:pt x="1444512" y="1020725"/>
                      <a:pt x="1416817" y="1029956"/>
                    </a:cubicBezTo>
                    <a:cubicBezTo>
                      <a:pt x="1382266" y="1052991"/>
                      <a:pt x="1398129" y="1046234"/>
                      <a:pt x="1371600" y="1055077"/>
                    </a:cubicBezTo>
                    <a:cubicBezTo>
                      <a:pt x="1368250" y="1058426"/>
                      <a:pt x="1365788" y="1063007"/>
                      <a:pt x="1361551" y="1065125"/>
                    </a:cubicBezTo>
                    <a:cubicBezTo>
                      <a:pt x="1361547" y="1065127"/>
                      <a:pt x="1323872" y="1077685"/>
                      <a:pt x="1316334" y="1080198"/>
                    </a:cubicBezTo>
                    <a:lnTo>
                      <a:pt x="1301261" y="1085222"/>
                    </a:lnTo>
                    <a:cubicBezTo>
                      <a:pt x="1296237" y="1086897"/>
                      <a:pt x="1291327" y="1088962"/>
                      <a:pt x="1286189" y="1090246"/>
                    </a:cubicBezTo>
                    <a:cubicBezTo>
                      <a:pt x="1279490" y="1091921"/>
                      <a:pt x="1272731" y="1093373"/>
                      <a:pt x="1266092" y="1095270"/>
                    </a:cubicBezTo>
                    <a:cubicBezTo>
                      <a:pt x="1261000" y="1096725"/>
                      <a:pt x="1256213" y="1099255"/>
                      <a:pt x="1251020" y="1100294"/>
                    </a:cubicBezTo>
                    <a:cubicBezTo>
                      <a:pt x="1239408" y="1102617"/>
                      <a:pt x="1227555" y="1103518"/>
                      <a:pt x="1215850" y="1105319"/>
                    </a:cubicBezTo>
                    <a:cubicBezTo>
                      <a:pt x="1205782" y="1106868"/>
                      <a:pt x="1195753" y="1108668"/>
                      <a:pt x="1185705" y="1110343"/>
                    </a:cubicBezTo>
                    <a:lnTo>
                      <a:pt x="1155560" y="1120391"/>
                    </a:lnTo>
                    <a:cubicBezTo>
                      <a:pt x="1150536" y="1122066"/>
                      <a:pt x="1145626" y="1124130"/>
                      <a:pt x="1140488" y="1125415"/>
                    </a:cubicBezTo>
                    <a:cubicBezTo>
                      <a:pt x="1133789" y="1127090"/>
                      <a:pt x="1127005" y="1128456"/>
                      <a:pt x="1120391" y="1130440"/>
                    </a:cubicBezTo>
                    <a:cubicBezTo>
                      <a:pt x="1105173" y="1135005"/>
                      <a:pt x="1090246" y="1140488"/>
                      <a:pt x="1075173" y="1145512"/>
                    </a:cubicBezTo>
                    <a:lnTo>
                      <a:pt x="999811" y="1170633"/>
                    </a:lnTo>
                    <a:lnTo>
                      <a:pt x="939521" y="1190730"/>
                    </a:lnTo>
                    <a:lnTo>
                      <a:pt x="924448" y="1195754"/>
                    </a:lnTo>
                    <a:lnTo>
                      <a:pt x="909376" y="1200778"/>
                    </a:lnTo>
                    <a:cubicBezTo>
                      <a:pt x="906026" y="1204127"/>
                      <a:pt x="903564" y="1208708"/>
                      <a:pt x="899327" y="1210826"/>
                    </a:cubicBezTo>
                    <a:cubicBezTo>
                      <a:pt x="871061" y="1224959"/>
                      <a:pt x="845801" y="1223000"/>
                      <a:pt x="813916" y="1225899"/>
                    </a:cubicBezTo>
                    <a:cubicBezTo>
                      <a:pt x="807217" y="1227574"/>
                      <a:pt x="800434" y="1228939"/>
                      <a:pt x="793820" y="1230923"/>
                    </a:cubicBezTo>
                    <a:cubicBezTo>
                      <a:pt x="783675" y="1233966"/>
                      <a:pt x="773723" y="1237622"/>
                      <a:pt x="763675" y="1240971"/>
                    </a:cubicBezTo>
                    <a:lnTo>
                      <a:pt x="733529" y="1251020"/>
                    </a:lnTo>
                    <a:cubicBezTo>
                      <a:pt x="733525" y="1251021"/>
                      <a:pt x="703387" y="1261067"/>
                      <a:pt x="703384" y="1261068"/>
                    </a:cubicBezTo>
                    <a:cubicBezTo>
                      <a:pt x="661760" y="1269393"/>
                      <a:pt x="686761" y="1265242"/>
                      <a:pt x="628022" y="1271116"/>
                    </a:cubicBezTo>
                    <a:lnTo>
                      <a:pt x="597877" y="1281165"/>
                    </a:lnTo>
                    <a:lnTo>
                      <a:pt x="582804" y="1286189"/>
                    </a:lnTo>
                    <a:cubicBezTo>
                      <a:pt x="559358" y="1284514"/>
                      <a:pt x="535569" y="1285497"/>
                      <a:pt x="512466" y="1281165"/>
                    </a:cubicBezTo>
                    <a:cubicBezTo>
                      <a:pt x="501637" y="1279135"/>
                      <a:pt x="500601" y="1262460"/>
                      <a:pt x="497393" y="1256044"/>
                    </a:cubicBezTo>
                    <a:cubicBezTo>
                      <a:pt x="494693" y="1250643"/>
                      <a:pt x="489797" y="1246489"/>
                      <a:pt x="487345" y="1240971"/>
                    </a:cubicBezTo>
                    <a:cubicBezTo>
                      <a:pt x="477798" y="1219490"/>
                      <a:pt x="478116" y="1211183"/>
                      <a:pt x="472272" y="1190730"/>
                    </a:cubicBezTo>
                    <a:cubicBezTo>
                      <a:pt x="470817" y="1185638"/>
                      <a:pt x="468923" y="1180681"/>
                      <a:pt x="467248" y="1175657"/>
                    </a:cubicBezTo>
                    <a:cubicBezTo>
                      <a:pt x="465573" y="1135464"/>
                      <a:pt x="465090" y="1095203"/>
                      <a:pt x="462224" y="1055077"/>
                    </a:cubicBezTo>
                    <a:cubicBezTo>
                      <a:pt x="461732" y="1048189"/>
                      <a:pt x="459097" y="1041619"/>
                      <a:pt x="457200" y="1034980"/>
                    </a:cubicBezTo>
                    <a:cubicBezTo>
                      <a:pt x="448809" y="1005609"/>
                      <a:pt x="455004" y="1035148"/>
                      <a:pt x="447151" y="999811"/>
                    </a:cubicBezTo>
                    <a:cubicBezTo>
                      <a:pt x="443052" y="981367"/>
                      <a:pt x="442355" y="972101"/>
                      <a:pt x="437103" y="954593"/>
                    </a:cubicBezTo>
                    <a:cubicBezTo>
                      <a:pt x="434060" y="944448"/>
                      <a:pt x="430404" y="934496"/>
                      <a:pt x="427055" y="924448"/>
                    </a:cubicBezTo>
                    <a:cubicBezTo>
                      <a:pt x="427054" y="924444"/>
                      <a:pt x="417008" y="894306"/>
                      <a:pt x="417006" y="894303"/>
                    </a:cubicBezTo>
                    <a:lnTo>
                      <a:pt x="406958" y="879231"/>
                    </a:lnTo>
                    <a:cubicBezTo>
                      <a:pt x="395996" y="846344"/>
                      <a:pt x="411221" y="878622"/>
                      <a:pt x="386861" y="859134"/>
                    </a:cubicBezTo>
                    <a:cubicBezTo>
                      <a:pt x="382146" y="855362"/>
                      <a:pt x="381357" y="848037"/>
                      <a:pt x="376813" y="844061"/>
                    </a:cubicBezTo>
                    <a:cubicBezTo>
                      <a:pt x="355551" y="825457"/>
                      <a:pt x="352297" y="825841"/>
                      <a:pt x="331595" y="818941"/>
                    </a:cubicBezTo>
                    <a:cubicBezTo>
                      <a:pt x="328246" y="815591"/>
                      <a:pt x="325609" y="811329"/>
                      <a:pt x="321547" y="808892"/>
                    </a:cubicBezTo>
                    <a:cubicBezTo>
                      <a:pt x="317006" y="806167"/>
                      <a:pt x="311567" y="805323"/>
                      <a:pt x="306475" y="803868"/>
                    </a:cubicBezTo>
                    <a:cubicBezTo>
                      <a:pt x="262306" y="791249"/>
                      <a:pt x="307451" y="805868"/>
                      <a:pt x="271305" y="793820"/>
                    </a:cubicBezTo>
                    <a:cubicBezTo>
                      <a:pt x="267956" y="790470"/>
                      <a:pt x="265047" y="786613"/>
                      <a:pt x="261257" y="783771"/>
                    </a:cubicBezTo>
                    <a:cubicBezTo>
                      <a:pt x="251596" y="776525"/>
                      <a:pt x="239651" y="772214"/>
                      <a:pt x="231112" y="763675"/>
                    </a:cubicBezTo>
                    <a:cubicBezTo>
                      <a:pt x="224413" y="756976"/>
                      <a:pt x="218898" y="748833"/>
                      <a:pt x="211015" y="743578"/>
                    </a:cubicBezTo>
                    <a:cubicBezTo>
                      <a:pt x="199823" y="736117"/>
                      <a:pt x="194076" y="733709"/>
                      <a:pt x="185894" y="723481"/>
                    </a:cubicBezTo>
                    <a:cubicBezTo>
                      <a:pt x="182122" y="718766"/>
                      <a:pt x="179618" y="713124"/>
                      <a:pt x="175846" y="708409"/>
                    </a:cubicBezTo>
                    <a:cubicBezTo>
                      <a:pt x="172887" y="704710"/>
                      <a:pt x="168640" y="702150"/>
                      <a:pt x="165798" y="698360"/>
                    </a:cubicBezTo>
                    <a:cubicBezTo>
                      <a:pt x="158552" y="688699"/>
                      <a:pt x="155750" y="674914"/>
                      <a:pt x="145701" y="668215"/>
                    </a:cubicBezTo>
                    <a:lnTo>
                      <a:pt x="130628" y="658167"/>
                    </a:lnTo>
                    <a:cubicBezTo>
                      <a:pt x="128953" y="653143"/>
                      <a:pt x="128176" y="647724"/>
                      <a:pt x="125604" y="643094"/>
                    </a:cubicBezTo>
                    <a:cubicBezTo>
                      <a:pt x="111401" y="617527"/>
                      <a:pt x="110706" y="618146"/>
                      <a:pt x="95459" y="602901"/>
                    </a:cubicBezTo>
                    <a:lnTo>
                      <a:pt x="70338" y="527538"/>
                    </a:lnTo>
                    <a:lnTo>
                      <a:pt x="60290" y="497393"/>
                    </a:lnTo>
                    <a:cubicBezTo>
                      <a:pt x="58615" y="492369"/>
                      <a:pt x="56305" y="487514"/>
                      <a:pt x="55266" y="482321"/>
                    </a:cubicBezTo>
                    <a:cubicBezTo>
                      <a:pt x="53591" y="473947"/>
                      <a:pt x="52313" y="465484"/>
                      <a:pt x="50242" y="457200"/>
                    </a:cubicBezTo>
                    <a:cubicBezTo>
                      <a:pt x="48957" y="452062"/>
                      <a:pt x="46502" y="447265"/>
                      <a:pt x="45217" y="442127"/>
                    </a:cubicBezTo>
                    <a:cubicBezTo>
                      <a:pt x="43146" y="433843"/>
                      <a:pt x="41868" y="425380"/>
                      <a:pt x="40193" y="417007"/>
                    </a:cubicBezTo>
                    <a:cubicBezTo>
                      <a:pt x="41868" y="396910"/>
                      <a:pt x="39820" y="376147"/>
                      <a:pt x="45217" y="356716"/>
                    </a:cubicBezTo>
                    <a:cubicBezTo>
                      <a:pt x="48449" y="345080"/>
                      <a:pt x="65314" y="326571"/>
                      <a:pt x="65314" y="326571"/>
                    </a:cubicBezTo>
                    <a:cubicBezTo>
                      <a:pt x="63639" y="298101"/>
                      <a:pt x="63979" y="269440"/>
                      <a:pt x="60290" y="241160"/>
                    </a:cubicBezTo>
                    <a:cubicBezTo>
                      <a:pt x="60288" y="241143"/>
                      <a:pt x="47732" y="203487"/>
                      <a:pt x="45217" y="195943"/>
                    </a:cubicBezTo>
                    <a:cubicBezTo>
                      <a:pt x="43542" y="190919"/>
                      <a:pt x="41232" y="186063"/>
                      <a:pt x="40193" y="180870"/>
                    </a:cubicBezTo>
                    <a:cubicBezTo>
                      <a:pt x="38518" y="172496"/>
                      <a:pt x="37416" y="163988"/>
                      <a:pt x="35169" y="155749"/>
                    </a:cubicBezTo>
                    <a:cubicBezTo>
                      <a:pt x="32382" y="145530"/>
                      <a:pt x="28470" y="135652"/>
                      <a:pt x="25121" y="125604"/>
                    </a:cubicBezTo>
                    <a:lnTo>
                      <a:pt x="15072" y="95459"/>
                    </a:lnTo>
                    <a:cubicBezTo>
                      <a:pt x="13397" y="90435"/>
                      <a:pt x="11332" y="85525"/>
                      <a:pt x="10048" y="80387"/>
                    </a:cubicBezTo>
                    <a:cubicBezTo>
                      <a:pt x="2152" y="48802"/>
                      <a:pt x="6001" y="67126"/>
                      <a:pt x="0" y="25121"/>
                    </a:cubicBezTo>
                    <a:cubicBezTo>
                      <a:pt x="5598" y="2726"/>
                      <a:pt x="141" y="9907"/>
                      <a:pt x="10048" y="0"/>
                    </a:cubicBezTo>
                  </a:path>
                </a:pathLst>
              </a:custGeom>
              <a:noFill/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3" name="Group 42"/>
            <p:cNvGrpSpPr/>
            <p:nvPr/>
          </p:nvGrpSpPr>
          <p:grpSpPr>
            <a:xfrm>
              <a:off x="2080009" y="4426299"/>
              <a:ext cx="808892" cy="276330"/>
              <a:chOff x="2080009" y="4426299"/>
              <a:chExt cx="808892" cy="276330"/>
            </a:xfrm>
          </p:grpSpPr>
          <p:sp>
            <p:nvSpPr>
              <p:cNvPr id="51" name="Freeform 50"/>
              <p:cNvSpPr/>
              <p:nvPr/>
            </p:nvSpPr>
            <p:spPr>
              <a:xfrm>
                <a:off x="2225710" y="4426299"/>
                <a:ext cx="663191" cy="130628"/>
              </a:xfrm>
              <a:custGeom>
                <a:avLst/>
                <a:gdLst>
                  <a:gd name="connsiteX0" fmla="*/ 0 w 663191"/>
                  <a:gd name="connsiteY0" fmla="*/ 130628 h 130628"/>
                  <a:gd name="connsiteX1" fmla="*/ 20097 w 663191"/>
                  <a:gd name="connsiteY1" fmla="*/ 105508 h 130628"/>
                  <a:gd name="connsiteX2" fmla="*/ 50242 w 663191"/>
                  <a:gd name="connsiteY2" fmla="*/ 95459 h 130628"/>
                  <a:gd name="connsiteX3" fmla="*/ 65314 w 663191"/>
                  <a:gd name="connsiteY3" fmla="*/ 85411 h 130628"/>
                  <a:gd name="connsiteX4" fmla="*/ 80387 w 663191"/>
                  <a:gd name="connsiteY4" fmla="*/ 80387 h 130628"/>
                  <a:gd name="connsiteX5" fmla="*/ 90435 w 663191"/>
                  <a:gd name="connsiteY5" fmla="*/ 70338 h 130628"/>
                  <a:gd name="connsiteX6" fmla="*/ 120580 w 663191"/>
                  <a:gd name="connsiteY6" fmla="*/ 60290 h 130628"/>
                  <a:gd name="connsiteX7" fmla="*/ 150725 w 663191"/>
                  <a:gd name="connsiteY7" fmla="*/ 45217 h 130628"/>
                  <a:gd name="connsiteX8" fmla="*/ 165798 w 663191"/>
                  <a:gd name="connsiteY8" fmla="*/ 35169 h 130628"/>
                  <a:gd name="connsiteX9" fmla="*/ 281354 w 663191"/>
                  <a:gd name="connsiteY9" fmla="*/ 40193 h 130628"/>
                  <a:gd name="connsiteX10" fmla="*/ 296426 w 663191"/>
                  <a:gd name="connsiteY10" fmla="*/ 45217 h 130628"/>
                  <a:gd name="connsiteX11" fmla="*/ 316523 w 663191"/>
                  <a:gd name="connsiteY11" fmla="*/ 50242 h 130628"/>
                  <a:gd name="connsiteX12" fmla="*/ 361741 w 663191"/>
                  <a:gd name="connsiteY12" fmla="*/ 65314 h 130628"/>
                  <a:gd name="connsiteX13" fmla="*/ 376813 w 663191"/>
                  <a:gd name="connsiteY13" fmla="*/ 70338 h 130628"/>
                  <a:gd name="connsiteX14" fmla="*/ 427055 w 663191"/>
                  <a:gd name="connsiteY14" fmla="*/ 60290 h 130628"/>
                  <a:gd name="connsiteX15" fmla="*/ 457200 w 663191"/>
                  <a:gd name="connsiteY15" fmla="*/ 50242 h 130628"/>
                  <a:gd name="connsiteX16" fmla="*/ 482321 w 663191"/>
                  <a:gd name="connsiteY16" fmla="*/ 35169 h 130628"/>
                  <a:gd name="connsiteX17" fmla="*/ 497393 w 663191"/>
                  <a:gd name="connsiteY17" fmla="*/ 25121 h 130628"/>
                  <a:gd name="connsiteX18" fmla="*/ 507442 w 663191"/>
                  <a:gd name="connsiteY18" fmla="*/ 15072 h 130628"/>
                  <a:gd name="connsiteX19" fmla="*/ 547635 w 663191"/>
                  <a:gd name="connsiteY19" fmla="*/ 5024 h 130628"/>
                  <a:gd name="connsiteX20" fmla="*/ 562708 w 663191"/>
                  <a:gd name="connsiteY20" fmla="*/ 0 h 130628"/>
                  <a:gd name="connsiteX21" fmla="*/ 663191 w 663191"/>
                  <a:gd name="connsiteY21" fmla="*/ 5024 h 1306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663191" h="130628">
                    <a:moveTo>
                      <a:pt x="0" y="130628"/>
                    </a:moveTo>
                    <a:cubicBezTo>
                      <a:pt x="6699" y="122255"/>
                      <a:pt x="11312" y="111657"/>
                      <a:pt x="20097" y="105508"/>
                    </a:cubicBezTo>
                    <a:cubicBezTo>
                      <a:pt x="28774" y="99434"/>
                      <a:pt x="50242" y="95459"/>
                      <a:pt x="50242" y="95459"/>
                    </a:cubicBezTo>
                    <a:cubicBezTo>
                      <a:pt x="55266" y="92110"/>
                      <a:pt x="59913" y="88111"/>
                      <a:pt x="65314" y="85411"/>
                    </a:cubicBezTo>
                    <a:cubicBezTo>
                      <a:pt x="70051" y="83043"/>
                      <a:pt x="75846" y="83112"/>
                      <a:pt x="80387" y="80387"/>
                    </a:cubicBezTo>
                    <a:cubicBezTo>
                      <a:pt x="84449" y="77950"/>
                      <a:pt x="86198" y="72456"/>
                      <a:pt x="90435" y="70338"/>
                    </a:cubicBezTo>
                    <a:cubicBezTo>
                      <a:pt x="99909" y="65601"/>
                      <a:pt x="111767" y="66165"/>
                      <a:pt x="120580" y="60290"/>
                    </a:cubicBezTo>
                    <a:cubicBezTo>
                      <a:pt x="163778" y="31493"/>
                      <a:pt x="109123" y="66019"/>
                      <a:pt x="150725" y="45217"/>
                    </a:cubicBezTo>
                    <a:cubicBezTo>
                      <a:pt x="156126" y="42516"/>
                      <a:pt x="160774" y="38518"/>
                      <a:pt x="165798" y="35169"/>
                    </a:cubicBezTo>
                    <a:cubicBezTo>
                      <a:pt x="204317" y="36844"/>
                      <a:pt x="242913" y="37236"/>
                      <a:pt x="281354" y="40193"/>
                    </a:cubicBezTo>
                    <a:cubicBezTo>
                      <a:pt x="286634" y="40599"/>
                      <a:pt x="291334" y="43762"/>
                      <a:pt x="296426" y="45217"/>
                    </a:cubicBezTo>
                    <a:cubicBezTo>
                      <a:pt x="303066" y="47114"/>
                      <a:pt x="309909" y="48258"/>
                      <a:pt x="316523" y="50242"/>
                    </a:cubicBezTo>
                    <a:cubicBezTo>
                      <a:pt x="331741" y="54807"/>
                      <a:pt x="346668" y="60290"/>
                      <a:pt x="361741" y="65314"/>
                    </a:cubicBezTo>
                    <a:lnTo>
                      <a:pt x="376813" y="70338"/>
                    </a:lnTo>
                    <a:cubicBezTo>
                      <a:pt x="397183" y="66943"/>
                      <a:pt x="408318" y="65911"/>
                      <a:pt x="427055" y="60290"/>
                    </a:cubicBezTo>
                    <a:cubicBezTo>
                      <a:pt x="437200" y="57247"/>
                      <a:pt x="457200" y="50242"/>
                      <a:pt x="457200" y="50242"/>
                    </a:cubicBezTo>
                    <a:cubicBezTo>
                      <a:pt x="476825" y="30615"/>
                      <a:pt x="456233" y="48212"/>
                      <a:pt x="482321" y="35169"/>
                    </a:cubicBezTo>
                    <a:cubicBezTo>
                      <a:pt x="487722" y="32469"/>
                      <a:pt x="492678" y="28893"/>
                      <a:pt x="497393" y="25121"/>
                    </a:cubicBezTo>
                    <a:cubicBezTo>
                      <a:pt x="501092" y="22162"/>
                      <a:pt x="503380" y="17509"/>
                      <a:pt x="507442" y="15072"/>
                    </a:cubicBezTo>
                    <a:cubicBezTo>
                      <a:pt x="515645" y="10150"/>
                      <a:pt x="541461" y="6567"/>
                      <a:pt x="547635" y="5024"/>
                    </a:cubicBezTo>
                    <a:cubicBezTo>
                      <a:pt x="552773" y="3740"/>
                      <a:pt x="557684" y="1675"/>
                      <a:pt x="562708" y="0"/>
                    </a:cubicBezTo>
                    <a:cubicBezTo>
                      <a:pt x="639710" y="5923"/>
                      <a:pt x="606186" y="5024"/>
                      <a:pt x="663191" y="5024"/>
                    </a:cubicBezTo>
                  </a:path>
                </a:pathLst>
              </a:custGeom>
              <a:noFill/>
              <a:ln>
                <a:solidFill>
                  <a:srgbClr val="FFCC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Freeform 51"/>
              <p:cNvSpPr/>
              <p:nvPr/>
            </p:nvSpPr>
            <p:spPr>
              <a:xfrm>
                <a:off x="2080009" y="4556927"/>
                <a:ext cx="150725" cy="145702"/>
              </a:xfrm>
              <a:custGeom>
                <a:avLst/>
                <a:gdLst>
                  <a:gd name="connsiteX0" fmla="*/ 150725 w 150725"/>
                  <a:gd name="connsiteY0" fmla="*/ 0 h 145702"/>
                  <a:gd name="connsiteX1" fmla="*/ 140677 w 150725"/>
                  <a:gd name="connsiteY1" fmla="*/ 25121 h 145702"/>
                  <a:gd name="connsiteX2" fmla="*/ 125604 w 150725"/>
                  <a:gd name="connsiteY2" fmla="*/ 30146 h 145702"/>
                  <a:gd name="connsiteX3" fmla="*/ 110532 w 150725"/>
                  <a:gd name="connsiteY3" fmla="*/ 45218 h 145702"/>
                  <a:gd name="connsiteX4" fmla="*/ 85411 w 150725"/>
                  <a:gd name="connsiteY4" fmla="*/ 65315 h 145702"/>
                  <a:gd name="connsiteX5" fmla="*/ 65314 w 150725"/>
                  <a:gd name="connsiteY5" fmla="*/ 85411 h 145702"/>
                  <a:gd name="connsiteX6" fmla="*/ 45217 w 150725"/>
                  <a:gd name="connsiteY6" fmla="*/ 105508 h 145702"/>
                  <a:gd name="connsiteX7" fmla="*/ 35169 w 150725"/>
                  <a:gd name="connsiteY7" fmla="*/ 115557 h 145702"/>
                  <a:gd name="connsiteX8" fmla="*/ 0 w 150725"/>
                  <a:gd name="connsiteY8" fmla="*/ 145702 h 14570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150725" h="145702">
                    <a:moveTo>
                      <a:pt x="150725" y="0"/>
                    </a:moveTo>
                    <a:cubicBezTo>
                      <a:pt x="147376" y="8374"/>
                      <a:pt x="146451" y="18193"/>
                      <a:pt x="140677" y="25121"/>
                    </a:cubicBezTo>
                    <a:cubicBezTo>
                      <a:pt x="137287" y="29190"/>
                      <a:pt x="130011" y="27208"/>
                      <a:pt x="125604" y="30146"/>
                    </a:cubicBezTo>
                    <a:cubicBezTo>
                      <a:pt x="119692" y="34087"/>
                      <a:pt x="115990" y="40670"/>
                      <a:pt x="110532" y="45218"/>
                    </a:cubicBezTo>
                    <a:cubicBezTo>
                      <a:pt x="72516" y="76897"/>
                      <a:pt x="114635" y="36088"/>
                      <a:pt x="85411" y="65315"/>
                    </a:cubicBezTo>
                    <a:cubicBezTo>
                      <a:pt x="75363" y="95459"/>
                      <a:pt x="88761" y="68664"/>
                      <a:pt x="65314" y="85411"/>
                    </a:cubicBezTo>
                    <a:cubicBezTo>
                      <a:pt x="57605" y="90917"/>
                      <a:pt x="51916" y="98809"/>
                      <a:pt x="45217" y="105508"/>
                    </a:cubicBezTo>
                    <a:cubicBezTo>
                      <a:pt x="41868" y="108858"/>
                      <a:pt x="39110" y="112929"/>
                      <a:pt x="35169" y="115557"/>
                    </a:cubicBezTo>
                    <a:cubicBezTo>
                      <a:pt x="1908" y="137730"/>
                      <a:pt x="10424" y="124851"/>
                      <a:pt x="0" y="145702"/>
                    </a:cubicBezTo>
                  </a:path>
                </a:pathLst>
              </a:custGeom>
              <a:noFill/>
              <a:ln>
                <a:solidFill>
                  <a:srgbClr val="FFCCFF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1939332" y="3079820"/>
              <a:ext cx="316523" cy="834013"/>
              <a:chOff x="1939332" y="3079820"/>
              <a:chExt cx="316523" cy="834013"/>
            </a:xfrm>
          </p:grpSpPr>
          <p:sp>
            <p:nvSpPr>
              <p:cNvPr id="49" name="Freeform 48"/>
              <p:cNvSpPr/>
              <p:nvPr/>
            </p:nvSpPr>
            <p:spPr>
              <a:xfrm>
                <a:off x="2205613" y="3079820"/>
                <a:ext cx="50242" cy="381837"/>
              </a:xfrm>
              <a:custGeom>
                <a:avLst/>
                <a:gdLst>
                  <a:gd name="connsiteX0" fmla="*/ 30145 w 50242"/>
                  <a:gd name="connsiteY0" fmla="*/ 0 h 381837"/>
                  <a:gd name="connsiteX1" fmla="*/ 45218 w 50242"/>
                  <a:gd name="connsiteY1" fmla="*/ 40193 h 381837"/>
                  <a:gd name="connsiteX2" fmla="*/ 50242 w 50242"/>
                  <a:gd name="connsiteY2" fmla="*/ 80387 h 381837"/>
                  <a:gd name="connsiteX3" fmla="*/ 45218 w 50242"/>
                  <a:gd name="connsiteY3" fmla="*/ 180870 h 381837"/>
                  <a:gd name="connsiteX4" fmla="*/ 40194 w 50242"/>
                  <a:gd name="connsiteY4" fmla="*/ 211015 h 381837"/>
                  <a:gd name="connsiteX5" fmla="*/ 25121 w 50242"/>
                  <a:gd name="connsiteY5" fmla="*/ 331595 h 381837"/>
                  <a:gd name="connsiteX6" fmla="*/ 15073 w 50242"/>
                  <a:gd name="connsiteY6" fmla="*/ 361740 h 381837"/>
                  <a:gd name="connsiteX7" fmla="*/ 10049 w 50242"/>
                  <a:gd name="connsiteY7" fmla="*/ 376813 h 381837"/>
                  <a:gd name="connsiteX8" fmla="*/ 0 w 50242"/>
                  <a:gd name="connsiteY8" fmla="*/ 381837 h 3818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0242" h="381837">
                    <a:moveTo>
                      <a:pt x="30145" y="0"/>
                    </a:moveTo>
                    <a:cubicBezTo>
                      <a:pt x="30984" y="2097"/>
                      <a:pt x="43905" y="32972"/>
                      <a:pt x="45218" y="40193"/>
                    </a:cubicBezTo>
                    <a:cubicBezTo>
                      <a:pt x="47633" y="53477"/>
                      <a:pt x="48567" y="66989"/>
                      <a:pt x="50242" y="80387"/>
                    </a:cubicBezTo>
                    <a:cubicBezTo>
                      <a:pt x="48567" y="113881"/>
                      <a:pt x="47790" y="147433"/>
                      <a:pt x="45218" y="180870"/>
                    </a:cubicBezTo>
                    <a:cubicBezTo>
                      <a:pt x="44437" y="191027"/>
                      <a:pt x="41116" y="200870"/>
                      <a:pt x="40194" y="211015"/>
                    </a:cubicBezTo>
                    <a:cubicBezTo>
                      <a:pt x="34654" y="271952"/>
                      <a:pt x="41502" y="282450"/>
                      <a:pt x="25121" y="331595"/>
                    </a:cubicBezTo>
                    <a:lnTo>
                      <a:pt x="15073" y="361740"/>
                    </a:lnTo>
                    <a:cubicBezTo>
                      <a:pt x="13398" y="366764"/>
                      <a:pt x="14786" y="374445"/>
                      <a:pt x="10049" y="376813"/>
                    </a:cubicBezTo>
                    <a:lnTo>
                      <a:pt x="0" y="381837"/>
                    </a:lnTo>
                  </a:path>
                </a:pathLst>
              </a:custGeom>
              <a:noFill/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Freeform 49"/>
              <p:cNvSpPr/>
              <p:nvPr/>
            </p:nvSpPr>
            <p:spPr>
              <a:xfrm>
                <a:off x="1939332" y="3441560"/>
                <a:ext cx="276330" cy="472273"/>
              </a:xfrm>
              <a:custGeom>
                <a:avLst/>
                <a:gdLst>
                  <a:gd name="connsiteX0" fmla="*/ 276330 w 276330"/>
                  <a:gd name="connsiteY0" fmla="*/ 0 h 472273"/>
                  <a:gd name="connsiteX1" fmla="*/ 271305 w 276330"/>
                  <a:gd name="connsiteY1" fmla="*/ 35170 h 472273"/>
                  <a:gd name="connsiteX2" fmla="*/ 261257 w 276330"/>
                  <a:gd name="connsiteY2" fmla="*/ 50242 h 472273"/>
                  <a:gd name="connsiteX3" fmla="*/ 251209 w 276330"/>
                  <a:gd name="connsiteY3" fmla="*/ 80387 h 472273"/>
                  <a:gd name="connsiteX4" fmla="*/ 246184 w 276330"/>
                  <a:gd name="connsiteY4" fmla="*/ 95460 h 472273"/>
                  <a:gd name="connsiteX5" fmla="*/ 236136 w 276330"/>
                  <a:gd name="connsiteY5" fmla="*/ 125605 h 472273"/>
                  <a:gd name="connsiteX6" fmla="*/ 231112 w 276330"/>
                  <a:gd name="connsiteY6" fmla="*/ 140677 h 472273"/>
                  <a:gd name="connsiteX7" fmla="*/ 221064 w 276330"/>
                  <a:gd name="connsiteY7" fmla="*/ 150726 h 472273"/>
                  <a:gd name="connsiteX8" fmla="*/ 205991 w 276330"/>
                  <a:gd name="connsiteY8" fmla="*/ 180871 h 472273"/>
                  <a:gd name="connsiteX9" fmla="*/ 200967 w 276330"/>
                  <a:gd name="connsiteY9" fmla="*/ 195943 h 472273"/>
                  <a:gd name="connsiteX10" fmla="*/ 190919 w 276330"/>
                  <a:gd name="connsiteY10" fmla="*/ 205992 h 472273"/>
                  <a:gd name="connsiteX11" fmla="*/ 180870 w 276330"/>
                  <a:gd name="connsiteY11" fmla="*/ 221064 h 472273"/>
                  <a:gd name="connsiteX12" fmla="*/ 165798 w 276330"/>
                  <a:gd name="connsiteY12" fmla="*/ 251209 h 472273"/>
                  <a:gd name="connsiteX13" fmla="*/ 155749 w 276330"/>
                  <a:gd name="connsiteY13" fmla="*/ 261258 h 472273"/>
                  <a:gd name="connsiteX14" fmla="*/ 130628 w 276330"/>
                  <a:gd name="connsiteY14" fmla="*/ 286378 h 472273"/>
                  <a:gd name="connsiteX15" fmla="*/ 105508 w 276330"/>
                  <a:gd name="connsiteY15" fmla="*/ 331596 h 472273"/>
                  <a:gd name="connsiteX16" fmla="*/ 75363 w 276330"/>
                  <a:gd name="connsiteY16" fmla="*/ 371789 h 472273"/>
                  <a:gd name="connsiteX17" fmla="*/ 55266 w 276330"/>
                  <a:gd name="connsiteY17" fmla="*/ 417007 h 472273"/>
                  <a:gd name="connsiteX18" fmla="*/ 45217 w 276330"/>
                  <a:gd name="connsiteY18" fmla="*/ 427055 h 472273"/>
                  <a:gd name="connsiteX19" fmla="*/ 40193 w 276330"/>
                  <a:gd name="connsiteY19" fmla="*/ 442128 h 472273"/>
                  <a:gd name="connsiteX20" fmla="*/ 25121 w 276330"/>
                  <a:gd name="connsiteY20" fmla="*/ 452176 h 472273"/>
                  <a:gd name="connsiteX21" fmla="*/ 15072 w 276330"/>
                  <a:gd name="connsiteY21" fmla="*/ 462225 h 472273"/>
                  <a:gd name="connsiteX22" fmla="*/ 0 w 276330"/>
                  <a:gd name="connsiteY22" fmla="*/ 472273 h 472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276330" h="472273">
                    <a:moveTo>
                      <a:pt x="276330" y="0"/>
                    </a:moveTo>
                    <a:cubicBezTo>
                      <a:pt x="274655" y="11723"/>
                      <a:pt x="274708" y="23827"/>
                      <a:pt x="271305" y="35170"/>
                    </a:cubicBezTo>
                    <a:cubicBezTo>
                      <a:pt x="269570" y="40953"/>
                      <a:pt x="263709" y="44724"/>
                      <a:pt x="261257" y="50242"/>
                    </a:cubicBezTo>
                    <a:cubicBezTo>
                      <a:pt x="256955" y="59921"/>
                      <a:pt x="254558" y="70339"/>
                      <a:pt x="251209" y="80387"/>
                    </a:cubicBezTo>
                    <a:lnTo>
                      <a:pt x="246184" y="95460"/>
                    </a:lnTo>
                    <a:lnTo>
                      <a:pt x="236136" y="125605"/>
                    </a:lnTo>
                    <a:cubicBezTo>
                      <a:pt x="234461" y="130629"/>
                      <a:pt x="234856" y="136932"/>
                      <a:pt x="231112" y="140677"/>
                    </a:cubicBezTo>
                    <a:lnTo>
                      <a:pt x="221064" y="150726"/>
                    </a:lnTo>
                    <a:cubicBezTo>
                      <a:pt x="208431" y="188616"/>
                      <a:pt x="225473" y="141906"/>
                      <a:pt x="205991" y="180871"/>
                    </a:cubicBezTo>
                    <a:cubicBezTo>
                      <a:pt x="203623" y="185608"/>
                      <a:pt x="203692" y="191402"/>
                      <a:pt x="200967" y="195943"/>
                    </a:cubicBezTo>
                    <a:cubicBezTo>
                      <a:pt x="198530" y="200005"/>
                      <a:pt x="193878" y="202293"/>
                      <a:pt x="190919" y="205992"/>
                    </a:cubicBezTo>
                    <a:cubicBezTo>
                      <a:pt x="187147" y="210707"/>
                      <a:pt x="184220" y="216040"/>
                      <a:pt x="180870" y="221064"/>
                    </a:cubicBezTo>
                    <a:cubicBezTo>
                      <a:pt x="175564" y="236984"/>
                      <a:pt x="176929" y="237296"/>
                      <a:pt x="165798" y="251209"/>
                    </a:cubicBezTo>
                    <a:cubicBezTo>
                      <a:pt x="162839" y="254908"/>
                      <a:pt x="158708" y="257559"/>
                      <a:pt x="155749" y="261258"/>
                    </a:cubicBezTo>
                    <a:cubicBezTo>
                      <a:pt x="136610" y="285182"/>
                      <a:pt x="156467" y="269153"/>
                      <a:pt x="130628" y="286378"/>
                    </a:cubicBezTo>
                    <a:cubicBezTo>
                      <a:pt x="124311" y="305330"/>
                      <a:pt x="122782" y="314323"/>
                      <a:pt x="105508" y="331596"/>
                    </a:cubicBezTo>
                    <a:cubicBezTo>
                      <a:pt x="93603" y="343499"/>
                      <a:pt x="81046" y="354742"/>
                      <a:pt x="75363" y="371789"/>
                    </a:cubicBezTo>
                    <a:cubicBezTo>
                      <a:pt x="67396" y="395689"/>
                      <a:pt x="68914" y="399948"/>
                      <a:pt x="55266" y="417007"/>
                    </a:cubicBezTo>
                    <a:cubicBezTo>
                      <a:pt x="52307" y="420706"/>
                      <a:pt x="48567" y="423706"/>
                      <a:pt x="45217" y="427055"/>
                    </a:cubicBezTo>
                    <a:cubicBezTo>
                      <a:pt x="43542" y="432079"/>
                      <a:pt x="43501" y="437992"/>
                      <a:pt x="40193" y="442128"/>
                    </a:cubicBezTo>
                    <a:cubicBezTo>
                      <a:pt x="36421" y="446843"/>
                      <a:pt x="29836" y="448404"/>
                      <a:pt x="25121" y="452176"/>
                    </a:cubicBezTo>
                    <a:cubicBezTo>
                      <a:pt x="21422" y="455135"/>
                      <a:pt x="18771" y="459266"/>
                      <a:pt x="15072" y="462225"/>
                    </a:cubicBezTo>
                    <a:cubicBezTo>
                      <a:pt x="10357" y="465997"/>
                      <a:pt x="0" y="472273"/>
                      <a:pt x="0" y="472273"/>
                    </a:cubicBezTo>
                  </a:path>
                </a:pathLst>
              </a:custGeom>
              <a:noFill/>
              <a:ln>
                <a:solidFill>
                  <a:schemeClr val="accent3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2220686" y="3893736"/>
              <a:ext cx="989762" cy="582805"/>
              <a:chOff x="2220686" y="3893736"/>
              <a:chExt cx="989762" cy="582805"/>
            </a:xfrm>
          </p:grpSpPr>
          <p:sp>
            <p:nvSpPr>
              <p:cNvPr id="46" name="Freeform 45"/>
              <p:cNvSpPr/>
              <p:nvPr/>
            </p:nvSpPr>
            <p:spPr>
              <a:xfrm>
                <a:off x="2466870" y="3893736"/>
                <a:ext cx="743578" cy="401934"/>
              </a:xfrm>
              <a:custGeom>
                <a:avLst/>
                <a:gdLst>
                  <a:gd name="connsiteX0" fmla="*/ 0 w 743578"/>
                  <a:gd name="connsiteY0" fmla="*/ 401934 h 401934"/>
                  <a:gd name="connsiteX1" fmla="*/ 60290 w 743578"/>
                  <a:gd name="connsiteY1" fmla="*/ 386862 h 401934"/>
                  <a:gd name="connsiteX2" fmla="*/ 75363 w 743578"/>
                  <a:gd name="connsiteY2" fmla="*/ 381838 h 401934"/>
                  <a:gd name="connsiteX3" fmla="*/ 90435 w 743578"/>
                  <a:gd name="connsiteY3" fmla="*/ 376813 h 401934"/>
                  <a:gd name="connsiteX4" fmla="*/ 100484 w 743578"/>
                  <a:gd name="connsiteY4" fmla="*/ 366765 h 401934"/>
                  <a:gd name="connsiteX5" fmla="*/ 120581 w 743578"/>
                  <a:gd name="connsiteY5" fmla="*/ 341644 h 401934"/>
                  <a:gd name="connsiteX6" fmla="*/ 180871 w 743578"/>
                  <a:gd name="connsiteY6" fmla="*/ 331596 h 401934"/>
                  <a:gd name="connsiteX7" fmla="*/ 477297 w 743578"/>
                  <a:gd name="connsiteY7" fmla="*/ 326572 h 401934"/>
                  <a:gd name="connsiteX8" fmla="*/ 507442 w 743578"/>
                  <a:gd name="connsiteY8" fmla="*/ 316523 h 401934"/>
                  <a:gd name="connsiteX9" fmla="*/ 537587 w 743578"/>
                  <a:gd name="connsiteY9" fmla="*/ 301451 h 401934"/>
                  <a:gd name="connsiteX10" fmla="*/ 557684 w 743578"/>
                  <a:gd name="connsiteY10" fmla="*/ 281354 h 401934"/>
                  <a:gd name="connsiteX11" fmla="*/ 582805 w 743578"/>
                  <a:gd name="connsiteY11" fmla="*/ 261257 h 401934"/>
                  <a:gd name="connsiteX12" fmla="*/ 607926 w 743578"/>
                  <a:gd name="connsiteY12" fmla="*/ 241161 h 401934"/>
                  <a:gd name="connsiteX13" fmla="*/ 622998 w 743578"/>
                  <a:gd name="connsiteY13" fmla="*/ 211016 h 401934"/>
                  <a:gd name="connsiteX14" fmla="*/ 638071 w 743578"/>
                  <a:gd name="connsiteY14" fmla="*/ 185895 h 401934"/>
                  <a:gd name="connsiteX15" fmla="*/ 648119 w 743578"/>
                  <a:gd name="connsiteY15" fmla="*/ 145701 h 401934"/>
                  <a:gd name="connsiteX16" fmla="*/ 653143 w 743578"/>
                  <a:gd name="connsiteY16" fmla="*/ 125605 h 401934"/>
                  <a:gd name="connsiteX17" fmla="*/ 663192 w 743578"/>
                  <a:gd name="connsiteY17" fmla="*/ 95460 h 401934"/>
                  <a:gd name="connsiteX18" fmla="*/ 668216 w 743578"/>
                  <a:gd name="connsiteY18" fmla="*/ 80387 h 401934"/>
                  <a:gd name="connsiteX19" fmla="*/ 678264 w 743578"/>
                  <a:gd name="connsiteY19" fmla="*/ 65315 h 401934"/>
                  <a:gd name="connsiteX20" fmla="*/ 683288 w 743578"/>
                  <a:gd name="connsiteY20" fmla="*/ 50242 h 401934"/>
                  <a:gd name="connsiteX21" fmla="*/ 718457 w 743578"/>
                  <a:gd name="connsiteY21" fmla="*/ 25121 h 401934"/>
                  <a:gd name="connsiteX22" fmla="*/ 743578 w 743578"/>
                  <a:gd name="connsiteY22" fmla="*/ 0 h 4019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743578" h="401934">
                    <a:moveTo>
                      <a:pt x="0" y="401934"/>
                    </a:moveTo>
                    <a:cubicBezTo>
                      <a:pt x="40594" y="395169"/>
                      <a:pt x="20480" y="400131"/>
                      <a:pt x="60290" y="386862"/>
                    </a:cubicBezTo>
                    <a:lnTo>
                      <a:pt x="75363" y="381838"/>
                    </a:lnTo>
                    <a:lnTo>
                      <a:pt x="90435" y="376813"/>
                    </a:lnTo>
                    <a:cubicBezTo>
                      <a:pt x="93785" y="373464"/>
                      <a:pt x="97525" y="370464"/>
                      <a:pt x="100484" y="366765"/>
                    </a:cubicBezTo>
                    <a:cubicBezTo>
                      <a:pt x="106805" y="358865"/>
                      <a:pt x="111248" y="347244"/>
                      <a:pt x="120581" y="341644"/>
                    </a:cubicBezTo>
                    <a:cubicBezTo>
                      <a:pt x="133748" y="333744"/>
                      <a:pt x="177045" y="331709"/>
                      <a:pt x="180871" y="331596"/>
                    </a:cubicBezTo>
                    <a:cubicBezTo>
                      <a:pt x="279651" y="328691"/>
                      <a:pt x="378488" y="328247"/>
                      <a:pt x="477297" y="326572"/>
                    </a:cubicBezTo>
                    <a:cubicBezTo>
                      <a:pt x="487345" y="323222"/>
                      <a:pt x="498629" y="322398"/>
                      <a:pt x="507442" y="316523"/>
                    </a:cubicBezTo>
                    <a:cubicBezTo>
                      <a:pt x="526921" y="303538"/>
                      <a:pt x="516786" y="308385"/>
                      <a:pt x="537587" y="301451"/>
                    </a:cubicBezTo>
                    <a:cubicBezTo>
                      <a:pt x="544286" y="294752"/>
                      <a:pt x="549801" y="286609"/>
                      <a:pt x="557684" y="281354"/>
                    </a:cubicBezTo>
                    <a:cubicBezTo>
                      <a:pt x="604071" y="250429"/>
                      <a:pt x="547011" y="289893"/>
                      <a:pt x="582805" y="261257"/>
                    </a:cubicBezTo>
                    <a:cubicBezTo>
                      <a:pt x="614501" y="235900"/>
                      <a:pt x="583657" y="265427"/>
                      <a:pt x="607926" y="241161"/>
                    </a:cubicBezTo>
                    <a:cubicBezTo>
                      <a:pt x="620554" y="203274"/>
                      <a:pt x="603519" y="249974"/>
                      <a:pt x="622998" y="211016"/>
                    </a:cubicBezTo>
                    <a:cubicBezTo>
                      <a:pt x="636041" y="184928"/>
                      <a:pt x="618444" y="205520"/>
                      <a:pt x="638071" y="185895"/>
                    </a:cubicBezTo>
                    <a:lnTo>
                      <a:pt x="648119" y="145701"/>
                    </a:lnTo>
                    <a:cubicBezTo>
                      <a:pt x="649794" y="139002"/>
                      <a:pt x="650959" y="132155"/>
                      <a:pt x="653143" y="125605"/>
                    </a:cubicBezTo>
                    <a:lnTo>
                      <a:pt x="663192" y="95460"/>
                    </a:lnTo>
                    <a:cubicBezTo>
                      <a:pt x="664867" y="90436"/>
                      <a:pt x="665278" y="84794"/>
                      <a:pt x="668216" y="80387"/>
                    </a:cubicBezTo>
                    <a:lnTo>
                      <a:pt x="678264" y="65315"/>
                    </a:lnTo>
                    <a:cubicBezTo>
                      <a:pt x="679939" y="60291"/>
                      <a:pt x="680210" y="54552"/>
                      <a:pt x="683288" y="50242"/>
                    </a:cubicBezTo>
                    <a:cubicBezTo>
                      <a:pt x="698189" y="29381"/>
                      <a:pt x="699395" y="31475"/>
                      <a:pt x="718457" y="25121"/>
                    </a:cubicBezTo>
                    <a:lnTo>
                      <a:pt x="743578" y="0"/>
                    </a:lnTo>
                  </a:path>
                </a:pathLst>
              </a:custGeom>
              <a:noFill/>
              <a:ln>
                <a:solidFill>
                  <a:srgbClr val="FF33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Freeform 46"/>
              <p:cNvSpPr/>
              <p:nvPr/>
            </p:nvSpPr>
            <p:spPr>
              <a:xfrm>
                <a:off x="2381459" y="4300695"/>
                <a:ext cx="95460" cy="175846"/>
              </a:xfrm>
              <a:custGeom>
                <a:avLst/>
                <a:gdLst>
                  <a:gd name="connsiteX0" fmla="*/ 95460 w 95460"/>
                  <a:gd name="connsiteY0" fmla="*/ 0 h 175846"/>
                  <a:gd name="connsiteX1" fmla="*/ 75363 w 95460"/>
                  <a:gd name="connsiteY1" fmla="*/ 25120 h 175846"/>
                  <a:gd name="connsiteX2" fmla="*/ 70339 w 95460"/>
                  <a:gd name="connsiteY2" fmla="*/ 40193 h 175846"/>
                  <a:gd name="connsiteX3" fmla="*/ 50242 w 95460"/>
                  <a:gd name="connsiteY3" fmla="*/ 60290 h 175846"/>
                  <a:gd name="connsiteX4" fmla="*/ 35170 w 95460"/>
                  <a:gd name="connsiteY4" fmla="*/ 90435 h 175846"/>
                  <a:gd name="connsiteX5" fmla="*/ 30145 w 95460"/>
                  <a:gd name="connsiteY5" fmla="*/ 105507 h 175846"/>
                  <a:gd name="connsiteX6" fmla="*/ 20097 w 95460"/>
                  <a:gd name="connsiteY6" fmla="*/ 120580 h 175846"/>
                  <a:gd name="connsiteX7" fmla="*/ 10049 w 95460"/>
                  <a:gd name="connsiteY7" fmla="*/ 150725 h 175846"/>
                  <a:gd name="connsiteX8" fmla="*/ 5025 w 95460"/>
                  <a:gd name="connsiteY8" fmla="*/ 165797 h 175846"/>
                  <a:gd name="connsiteX9" fmla="*/ 0 w 95460"/>
                  <a:gd name="connsiteY9" fmla="*/ 175846 h 175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95460" h="175846">
                    <a:moveTo>
                      <a:pt x="95460" y="0"/>
                    </a:moveTo>
                    <a:cubicBezTo>
                      <a:pt x="88761" y="8373"/>
                      <a:pt x="81046" y="16027"/>
                      <a:pt x="75363" y="25120"/>
                    </a:cubicBezTo>
                    <a:cubicBezTo>
                      <a:pt x="72556" y="29611"/>
                      <a:pt x="73417" y="35883"/>
                      <a:pt x="70339" y="40193"/>
                    </a:cubicBezTo>
                    <a:cubicBezTo>
                      <a:pt x="64833" y="47902"/>
                      <a:pt x="50242" y="60290"/>
                      <a:pt x="50242" y="60290"/>
                    </a:cubicBezTo>
                    <a:cubicBezTo>
                      <a:pt x="37617" y="98166"/>
                      <a:pt x="54646" y="51485"/>
                      <a:pt x="35170" y="90435"/>
                    </a:cubicBezTo>
                    <a:cubicBezTo>
                      <a:pt x="32802" y="95172"/>
                      <a:pt x="32513" y="100770"/>
                      <a:pt x="30145" y="105507"/>
                    </a:cubicBezTo>
                    <a:cubicBezTo>
                      <a:pt x="27444" y="110908"/>
                      <a:pt x="22549" y="115062"/>
                      <a:pt x="20097" y="120580"/>
                    </a:cubicBezTo>
                    <a:cubicBezTo>
                      <a:pt x="15795" y="130259"/>
                      <a:pt x="13398" y="140677"/>
                      <a:pt x="10049" y="150725"/>
                    </a:cubicBezTo>
                    <a:cubicBezTo>
                      <a:pt x="8374" y="155749"/>
                      <a:pt x="7394" y="161060"/>
                      <a:pt x="5025" y="165797"/>
                    </a:cubicBezTo>
                    <a:lnTo>
                      <a:pt x="0" y="175846"/>
                    </a:lnTo>
                  </a:path>
                </a:pathLst>
              </a:custGeom>
              <a:noFill/>
              <a:ln>
                <a:solidFill>
                  <a:srgbClr val="FF33CC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Freeform 47"/>
              <p:cNvSpPr/>
              <p:nvPr/>
            </p:nvSpPr>
            <p:spPr>
              <a:xfrm>
                <a:off x="2220686" y="4340888"/>
                <a:ext cx="170822" cy="90437"/>
              </a:xfrm>
              <a:custGeom>
                <a:avLst/>
                <a:gdLst>
                  <a:gd name="connsiteX0" fmla="*/ 0 w 170822"/>
                  <a:gd name="connsiteY0" fmla="*/ 0 h 90437"/>
                  <a:gd name="connsiteX1" fmla="*/ 25121 w 170822"/>
                  <a:gd name="connsiteY1" fmla="*/ 20097 h 90437"/>
                  <a:gd name="connsiteX2" fmla="*/ 35169 w 170822"/>
                  <a:gd name="connsiteY2" fmla="*/ 35169 h 90437"/>
                  <a:gd name="connsiteX3" fmla="*/ 65314 w 170822"/>
                  <a:gd name="connsiteY3" fmla="*/ 50242 h 90437"/>
                  <a:gd name="connsiteX4" fmla="*/ 80387 w 170822"/>
                  <a:gd name="connsiteY4" fmla="*/ 60290 h 90437"/>
                  <a:gd name="connsiteX5" fmla="*/ 110532 w 170822"/>
                  <a:gd name="connsiteY5" fmla="*/ 70338 h 90437"/>
                  <a:gd name="connsiteX6" fmla="*/ 120580 w 170822"/>
                  <a:gd name="connsiteY6" fmla="*/ 80387 h 90437"/>
                  <a:gd name="connsiteX7" fmla="*/ 135652 w 170822"/>
                  <a:gd name="connsiteY7" fmla="*/ 85411 h 90437"/>
                  <a:gd name="connsiteX8" fmla="*/ 170822 w 170822"/>
                  <a:gd name="connsiteY8" fmla="*/ 90435 h 904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170822" h="90437">
                    <a:moveTo>
                      <a:pt x="0" y="0"/>
                    </a:moveTo>
                    <a:cubicBezTo>
                      <a:pt x="8374" y="6699"/>
                      <a:pt x="17538" y="12514"/>
                      <a:pt x="25121" y="20097"/>
                    </a:cubicBezTo>
                    <a:cubicBezTo>
                      <a:pt x="29391" y="24367"/>
                      <a:pt x="30899" y="30899"/>
                      <a:pt x="35169" y="35169"/>
                    </a:cubicBezTo>
                    <a:cubicBezTo>
                      <a:pt x="49565" y="49565"/>
                      <a:pt x="48971" y="42071"/>
                      <a:pt x="65314" y="50242"/>
                    </a:cubicBezTo>
                    <a:cubicBezTo>
                      <a:pt x="70715" y="52942"/>
                      <a:pt x="74869" y="57838"/>
                      <a:pt x="80387" y="60290"/>
                    </a:cubicBezTo>
                    <a:cubicBezTo>
                      <a:pt x="90066" y="64592"/>
                      <a:pt x="110532" y="70338"/>
                      <a:pt x="110532" y="70338"/>
                    </a:cubicBezTo>
                    <a:cubicBezTo>
                      <a:pt x="113881" y="73688"/>
                      <a:pt x="116518" y="77950"/>
                      <a:pt x="120580" y="80387"/>
                    </a:cubicBezTo>
                    <a:cubicBezTo>
                      <a:pt x="125121" y="83112"/>
                      <a:pt x="130482" y="84262"/>
                      <a:pt x="135652" y="85411"/>
                    </a:cubicBezTo>
                    <a:cubicBezTo>
                      <a:pt x="159500" y="90710"/>
                      <a:pt x="156918" y="90435"/>
                      <a:pt x="170822" y="90435"/>
                    </a:cubicBezTo>
                  </a:path>
                </a:pathLst>
              </a:custGeom>
              <a:noFill/>
              <a:ln>
                <a:solidFill>
                  <a:srgbClr val="FF33CC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56" name="Content Placeholder 2"/>
          <p:cNvSpPr txBox="1">
            <a:spLocks/>
          </p:cNvSpPr>
          <p:nvPr/>
        </p:nvSpPr>
        <p:spPr>
          <a:xfrm>
            <a:off x="685800" y="4191000"/>
            <a:ext cx="4648200" cy="26670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oloured</a:t>
            </a: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lines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accent5">
                    <a:lumMod val="60000"/>
                    <a:lumOff val="40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lx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accent5">
                  <a:lumMod val="60000"/>
                  <a:lumOff val="40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dirty="0" smtClean="0">
                <a:solidFill>
                  <a:schemeClr val="accent3"/>
                </a:solidFill>
              </a:rPr>
              <a:t>Central </a:t>
            </a:r>
            <a:r>
              <a:rPr lang="en-US" dirty="0" err="1" smtClean="0">
                <a:solidFill>
                  <a:schemeClr val="accent3"/>
                </a:solidFill>
              </a:rPr>
              <a:t>sulcus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Sylvian</a:t>
            </a:r>
            <a:r>
              <a:rPr lang="en-US" dirty="0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 fissure</a:t>
            </a: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rgbClr val="FFCCFF"/>
                </a:solidFill>
              </a:rPr>
              <a:t>Calcarine</a:t>
            </a:r>
            <a:r>
              <a:rPr lang="en-US" dirty="0" smtClean="0">
                <a:solidFill>
                  <a:srgbClr val="FFCCFF"/>
                </a:solidFill>
              </a:rPr>
              <a:t> </a:t>
            </a:r>
            <a:r>
              <a:rPr lang="en-US" dirty="0" err="1" smtClean="0">
                <a:solidFill>
                  <a:srgbClr val="FFCCFF"/>
                </a:solidFill>
              </a:rPr>
              <a:t>sulcus</a:t>
            </a:r>
            <a:r>
              <a:rPr lang="en-US" dirty="0" smtClean="0">
                <a:solidFill>
                  <a:srgbClr val="FFCCFF"/>
                </a:solidFill>
              </a:rPr>
              <a:t> </a:t>
            </a:r>
            <a:endParaRPr lang="en-US" dirty="0" smtClean="0">
              <a:solidFill>
                <a:schemeClr val="bg1"/>
              </a:solidFill>
            </a:endParaRPr>
          </a:p>
          <a:p>
            <a:pPr marL="285750" lvl="0" indent="-285750">
              <a:spcBef>
                <a:spcPct val="20000"/>
              </a:spcBef>
              <a:buFont typeface="Arial" panose="020B0604020202020204" pitchFamily="34" charset="0"/>
              <a:buChar char="•"/>
              <a:defRPr/>
            </a:pPr>
            <a:r>
              <a:rPr lang="en-US" dirty="0" err="1" smtClean="0">
                <a:solidFill>
                  <a:srgbClr val="FF33CC"/>
                </a:solidFill>
              </a:rPr>
              <a:t>Parietooccipital</a:t>
            </a:r>
            <a:r>
              <a:rPr lang="en-US" dirty="0" smtClean="0">
                <a:solidFill>
                  <a:srgbClr val="FF33CC"/>
                </a:solidFill>
              </a:rPr>
              <a:t> </a:t>
            </a:r>
            <a:r>
              <a:rPr lang="en-US" dirty="0" smtClean="0">
                <a:solidFill>
                  <a:srgbClr val="FF33CC"/>
                </a:solidFill>
              </a:rPr>
              <a:t>sulcus</a:t>
            </a:r>
            <a:endParaRPr lang="en-US" dirty="0" smtClean="0">
              <a:solidFill>
                <a:srgbClr val="FF33CC"/>
              </a:solidFill>
            </a:endParaRPr>
          </a:p>
        </p:txBody>
      </p:sp>
      <p:cxnSp>
        <p:nvCxnSpPr>
          <p:cNvPr id="63" name="Straight Connector 62"/>
          <p:cNvCxnSpPr/>
          <p:nvPr/>
        </p:nvCxnSpPr>
        <p:spPr>
          <a:xfrm flipH="1">
            <a:off x="685800" y="2667000"/>
            <a:ext cx="914400" cy="0"/>
          </a:xfrm>
          <a:prstGeom prst="line">
            <a:avLst/>
          </a:prstGeom>
          <a:ln w="285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1371600" y="22976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590800" y="2743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762000" y="2602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V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-2362200" y="2831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905000" y="2602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981200" y="3124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B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343400" y="2362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876800" y="23622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810000" y="22976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486400" y="22976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267200" y="1752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953000" y="1752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962400" y="2831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334000" y="2831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648200" y="29834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B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7239000" y="2450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7696200" y="24500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S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553200" y="2133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8229600" y="2133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010400" y="1752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7696200" y="1752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6705600" y="2667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L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8077200" y="2667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7467600" y="30596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B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762000" y="1992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D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2209800" y="2133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PO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3" name="Content Placeholder 2"/>
          <p:cNvSpPr txBox="1">
            <a:spLocks/>
          </p:cNvSpPr>
          <p:nvPr/>
        </p:nvSpPr>
        <p:spPr>
          <a:xfrm>
            <a:off x="3282575" y="4243289"/>
            <a:ext cx="3662402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DF = left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en-US" b="0" i="0" u="none" strike="noStrike" kern="1200" cap="none" spc="0" normalizeH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dorsofrontal</a:t>
            </a:r>
            <a:endParaRPr kumimoji="0" lang="en-US" b="0" i="0" u="none" strike="noStrike" kern="1200" cap="none" spc="0" normalizeH="0" noProof="0" dirty="0" smtClean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baseline="0" dirty="0" smtClean="0">
                <a:solidFill>
                  <a:schemeClr val="bg1"/>
                </a:solidFill>
              </a:rPr>
              <a:t>RD</a:t>
            </a:r>
            <a:r>
              <a:rPr lang="en-US" dirty="0" smtClean="0">
                <a:solidFill>
                  <a:schemeClr val="bg1"/>
                </a:solidFill>
              </a:rPr>
              <a:t>F = right </a:t>
            </a:r>
            <a:r>
              <a:rPr lang="en-US" dirty="0" err="1" smtClean="0">
                <a:solidFill>
                  <a:schemeClr val="bg1"/>
                </a:solidFill>
              </a:rPr>
              <a:t>dorsofrontal</a:t>
            </a:r>
            <a:endParaRPr kumimoji="0" lang="en-US" b="0" i="0" u="none" strike="noStrike" kern="1200" cap="none" spc="0" normalizeH="0" baseline="0" noProof="0" dirty="0" smtClean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dirty="0" smtClean="0">
                <a:solidFill>
                  <a:schemeClr val="bg1"/>
                </a:solidFill>
              </a:rPr>
              <a:t>RVF = right ventral fron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LP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= left </a:t>
            </a:r>
            <a:r>
              <a:rPr kumimoji="0" lang="en-US" b="0" i="0" u="none" strike="noStrike" kern="1200" cap="none" spc="0" normalizeH="0" noProof="0" dirty="0" err="1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arieto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-occipital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baseline="0" dirty="0" smtClean="0">
                <a:solidFill>
                  <a:schemeClr val="bg1"/>
                </a:solidFill>
              </a:rPr>
              <a:t>RPO</a:t>
            </a:r>
            <a:r>
              <a:rPr lang="en-US" dirty="0" smtClean="0">
                <a:solidFill>
                  <a:schemeClr val="bg1"/>
                </a:solidFill>
              </a:rPr>
              <a:t> = right </a:t>
            </a:r>
            <a:r>
              <a:rPr lang="en-US" dirty="0" err="1" smtClean="0">
                <a:solidFill>
                  <a:schemeClr val="bg1"/>
                </a:solidFill>
              </a:rPr>
              <a:t>pareto</a:t>
            </a:r>
            <a:r>
              <a:rPr lang="en-US" dirty="0" smtClean="0">
                <a:solidFill>
                  <a:schemeClr val="bg1"/>
                </a:solidFill>
              </a:rPr>
              <a:t>-occipital</a:t>
            </a:r>
          </a:p>
        </p:txBody>
      </p:sp>
      <p:sp>
        <p:nvSpPr>
          <p:cNvPr id="84" name="Content Placeholder 2"/>
          <p:cNvSpPr txBox="1">
            <a:spLocks/>
          </p:cNvSpPr>
          <p:nvPr/>
        </p:nvSpPr>
        <p:spPr>
          <a:xfrm>
            <a:off x="6211506" y="4243289"/>
            <a:ext cx="3662402" cy="2362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b="0" i="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BC = brainstem</a:t>
            </a:r>
            <a:r>
              <a:rPr kumimoji="0" lang="en-US" b="0" i="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&amp; cerebellum</a:t>
            </a:r>
          </a:p>
          <a:p>
            <a:pPr>
              <a:spcBef>
                <a:spcPct val="20000"/>
              </a:spcBef>
              <a:defRPr/>
            </a:pPr>
            <a:r>
              <a:rPr lang="en-US" dirty="0">
                <a:solidFill>
                  <a:schemeClr val="bg1"/>
                </a:solidFill>
              </a:rPr>
              <a:t>SC = subcortical</a:t>
            </a:r>
          </a:p>
          <a:p>
            <a:pPr lvl="0">
              <a:spcBef>
                <a:spcPct val="20000"/>
              </a:spcBef>
              <a:defRPr/>
            </a:pPr>
            <a:r>
              <a:rPr lang="en-US" dirty="0" smtClean="0">
                <a:solidFill>
                  <a:schemeClr val="bg1"/>
                </a:solidFill>
              </a:rPr>
              <a:t>LT </a:t>
            </a:r>
            <a:r>
              <a:rPr lang="en-US" dirty="0">
                <a:solidFill>
                  <a:schemeClr val="bg1"/>
                </a:solidFill>
              </a:rPr>
              <a:t>= left temporal</a:t>
            </a:r>
          </a:p>
          <a:p>
            <a:pPr lvl="0">
              <a:spcBef>
                <a:spcPct val="20000"/>
              </a:spcBef>
              <a:defRPr/>
            </a:pPr>
            <a:r>
              <a:rPr lang="en-US" dirty="0">
                <a:solidFill>
                  <a:schemeClr val="bg1"/>
                </a:solidFill>
              </a:rPr>
              <a:t>RT = right temporal</a:t>
            </a:r>
            <a:endParaRPr lang="en-US" dirty="0">
              <a:solidFill>
                <a:schemeClr val="accent3"/>
              </a:solidFill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tabLst/>
              <a:defRPr/>
            </a:pP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schemeClr val="accent3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77647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0</TotalTime>
  <Words>235</Words>
  <Application>Microsoft Office PowerPoint</Application>
  <PresentationFormat>On-screen Show (4:3)</PresentationFormat>
  <Paragraphs>12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H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, Nadine</dc:creator>
  <cp:lastModifiedBy>Tsang, Derek Dr. – Radiation Oncology</cp:lastModifiedBy>
  <cp:revision>64</cp:revision>
  <dcterms:created xsi:type="dcterms:W3CDTF">2017-05-15T19:32:09Z</dcterms:created>
  <dcterms:modified xsi:type="dcterms:W3CDTF">2020-11-02T15:14:52Z</dcterms:modified>
</cp:coreProperties>
</file>